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74" d="100"/>
          <a:sy n="74" d="100"/>
        </p:scale>
        <p:origin x="3114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7AFE-1344-4FDF-88AA-BCE8D5241A09}" type="datetimeFigureOut">
              <a:rPr lang="en-GB" smtClean="0"/>
              <a:t>16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68E9-7C41-4472-BD44-9D7DE9E925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5594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7AFE-1344-4FDF-88AA-BCE8D5241A09}" type="datetimeFigureOut">
              <a:rPr lang="en-GB" smtClean="0"/>
              <a:t>16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68E9-7C41-4472-BD44-9D7DE9E925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3539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29697"/>
            <a:ext cx="3357563" cy="112680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7AFE-1344-4FDF-88AA-BCE8D5241A09}" type="datetimeFigureOut">
              <a:rPr lang="en-GB" smtClean="0"/>
              <a:t>16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68E9-7C41-4472-BD44-9D7DE9E925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8982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7AFE-1344-4FDF-88AA-BCE8D5241A09}" type="datetimeFigureOut">
              <a:rPr lang="en-GB" smtClean="0"/>
              <a:t>16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68E9-7C41-4472-BD44-9D7DE9E925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84928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7AFE-1344-4FDF-88AA-BCE8D5241A09}" type="datetimeFigureOut">
              <a:rPr lang="en-GB" smtClean="0"/>
              <a:t>16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68E9-7C41-4472-BD44-9D7DE9E925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5757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7AFE-1344-4FDF-88AA-BCE8D5241A09}" type="datetimeFigureOut">
              <a:rPr lang="en-GB" smtClean="0"/>
              <a:t>16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68E9-7C41-4472-BD44-9D7DE9E925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9404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7AFE-1344-4FDF-88AA-BCE8D5241A09}" type="datetimeFigureOut">
              <a:rPr lang="en-GB" smtClean="0"/>
              <a:t>16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68E9-7C41-4472-BD44-9D7DE9E925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79470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7AFE-1344-4FDF-88AA-BCE8D5241A09}" type="datetimeFigureOut">
              <a:rPr lang="en-GB" smtClean="0"/>
              <a:t>16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68E9-7C41-4472-BD44-9D7DE9E925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69642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7AFE-1344-4FDF-88AA-BCE8D5241A09}" type="datetimeFigureOut">
              <a:rPr lang="en-GB" smtClean="0"/>
              <a:t>16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68E9-7C41-4472-BD44-9D7DE9E925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0550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7AFE-1344-4FDF-88AA-BCE8D5241A09}" type="datetimeFigureOut">
              <a:rPr lang="en-GB" smtClean="0"/>
              <a:t>16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68E9-7C41-4472-BD44-9D7DE9E925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6676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7AFE-1344-4FDF-88AA-BCE8D5241A09}" type="datetimeFigureOut">
              <a:rPr lang="en-GB" smtClean="0"/>
              <a:t>16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268E9-7C41-4472-BD44-9D7DE9E925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92244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BA7AFE-1344-4FDF-88AA-BCE8D5241A09}" type="datetimeFigureOut">
              <a:rPr lang="en-GB" smtClean="0"/>
              <a:t>16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0268E9-7C41-4472-BD44-9D7DE9E925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5072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049426" y="128464"/>
            <a:ext cx="4751900" cy="2048314"/>
            <a:chOff x="1049426" y="128464"/>
            <a:chExt cx="4751900" cy="2327749"/>
          </a:xfrm>
        </p:grpSpPr>
        <p:grpSp>
          <p:nvGrpSpPr>
            <p:cNvPr id="100" name="Group 99"/>
            <p:cNvGrpSpPr/>
            <p:nvPr/>
          </p:nvGrpSpPr>
          <p:grpSpPr>
            <a:xfrm>
              <a:off x="1049426" y="128464"/>
              <a:ext cx="4751900" cy="2008233"/>
              <a:chOff x="1045654" y="7275885"/>
              <a:chExt cx="4893314" cy="1795746"/>
            </a:xfrm>
          </p:grpSpPr>
          <p:grpSp>
            <p:nvGrpSpPr>
              <p:cNvPr id="101" name="Group 100"/>
              <p:cNvGrpSpPr/>
              <p:nvPr/>
            </p:nvGrpSpPr>
            <p:grpSpPr>
              <a:xfrm>
                <a:off x="1318851" y="7275885"/>
                <a:ext cx="4620117" cy="1795746"/>
                <a:chOff x="1220823" y="4346576"/>
                <a:chExt cx="10168467" cy="2481057"/>
              </a:xfrm>
            </p:grpSpPr>
            <p:sp>
              <p:nvSpPr>
                <p:cNvPr id="104" name="Rectangle 155"/>
                <p:cNvSpPr>
                  <a:spLocks noChangeArrowheads="1"/>
                </p:cNvSpPr>
                <p:nvPr/>
              </p:nvSpPr>
              <p:spPr bwMode="auto">
                <a:xfrm>
                  <a:off x="1609725" y="6694488"/>
                  <a:ext cx="326975" cy="133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en-US" sz="800" b="0" i="0" u="none" strike="noStrike" kern="0" cap="none" spc="0" normalizeH="0" baseline="0" noProof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cs typeface="Arial" pitchFamily="34" charset="0"/>
                    </a:rPr>
                    <a:t>0.0</a:t>
                  </a:r>
                  <a:endParaRPr kumimoji="0" lang="en-US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cs typeface="Arial" pitchFamily="34" charset="0"/>
                  </a:endParaRPr>
                </a:p>
              </p:txBody>
            </p:sp>
            <p:sp>
              <p:nvSpPr>
                <p:cNvPr id="105" name="Line 156"/>
                <p:cNvSpPr>
                  <a:spLocks noChangeShapeType="1"/>
                </p:cNvSpPr>
                <p:nvPr/>
              </p:nvSpPr>
              <p:spPr bwMode="auto">
                <a:xfrm>
                  <a:off x="1703388" y="6632576"/>
                  <a:ext cx="0" cy="6191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6" name="Rectangle 179"/>
                <p:cNvSpPr>
                  <a:spLocks noChangeArrowheads="1"/>
                </p:cNvSpPr>
                <p:nvPr/>
              </p:nvSpPr>
              <p:spPr bwMode="auto">
                <a:xfrm>
                  <a:off x="3633787" y="6694488"/>
                  <a:ext cx="326975" cy="133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en-US" sz="800" b="0" i="0" u="none" strike="noStrike" kern="0" cap="none" spc="0" normalizeH="0" baseline="0" noProof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cs typeface="Arial" pitchFamily="34" charset="0"/>
                    </a:rPr>
                    <a:t>5.0</a:t>
                  </a:r>
                  <a:endParaRPr kumimoji="0" lang="en-US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cs typeface="Arial" pitchFamily="34" charset="0"/>
                  </a:endParaRPr>
                </a:p>
              </p:txBody>
            </p:sp>
            <p:sp>
              <p:nvSpPr>
                <p:cNvPr id="107" name="Line 180"/>
                <p:cNvSpPr>
                  <a:spLocks noChangeShapeType="1"/>
                </p:cNvSpPr>
                <p:nvPr/>
              </p:nvSpPr>
              <p:spPr bwMode="auto">
                <a:xfrm>
                  <a:off x="3727450" y="6632576"/>
                  <a:ext cx="0" cy="6191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8" name="Rectangle 203"/>
                <p:cNvSpPr>
                  <a:spLocks noChangeArrowheads="1"/>
                </p:cNvSpPr>
                <p:nvPr/>
              </p:nvSpPr>
              <p:spPr bwMode="auto">
                <a:xfrm>
                  <a:off x="5629274" y="6694488"/>
                  <a:ext cx="457765" cy="133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en-US" sz="800" b="0" i="0" u="none" strike="noStrike" kern="0" cap="none" spc="0" normalizeH="0" baseline="0" noProof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cs typeface="Arial" pitchFamily="34" charset="0"/>
                    </a:rPr>
                    <a:t>10.0</a:t>
                  </a:r>
                  <a:endParaRPr kumimoji="0" lang="en-US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cs typeface="Arial" pitchFamily="34" charset="0"/>
                  </a:endParaRPr>
                </a:p>
              </p:txBody>
            </p:sp>
            <p:sp>
              <p:nvSpPr>
                <p:cNvPr id="109" name="Line 204"/>
                <p:cNvSpPr>
                  <a:spLocks noChangeShapeType="1"/>
                </p:cNvSpPr>
                <p:nvPr/>
              </p:nvSpPr>
              <p:spPr bwMode="auto">
                <a:xfrm>
                  <a:off x="5751513" y="6632576"/>
                  <a:ext cx="0" cy="6191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0" name="Rectangle 227"/>
                <p:cNvSpPr>
                  <a:spLocks noChangeArrowheads="1"/>
                </p:cNvSpPr>
                <p:nvPr/>
              </p:nvSpPr>
              <p:spPr bwMode="auto">
                <a:xfrm>
                  <a:off x="7651750" y="6694488"/>
                  <a:ext cx="457765" cy="133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en-US" sz="800" b="0" i="0" u="none" strike="noStrike" kern="0" cap="none" spc="0" normalizeH="0" baseline="0" noProof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cs typeface="Arial" pitchFamily="34" charset="0"/>
                    </a:rPr>
                    <a:t>15.0</a:t>
                  </a:r>
                  <a:endParaRPr kumimoji="0" lang="en-US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cs typeface="Arial" pitchFamily="34" charset="0"/>
                  </a:endParaRPr>
                </a:p>
              </p:txBody>
            </p:sp>
            <p:sp>
              <p:nvSpPr>
                <p:cNvPr id="111" name="Line 228"/>
                <p:cNvSpPr>
                  <a:spLocks noChangeShapeType="1"/>
                </p:cNvSpPr>
                <p:nvPr/>
              </p:nvSpPr>
              <p:spPr bwMode="auto">
                <a:xfrm>
                  <a:off x="7773988" y="6632576"/>
                  <a:ext cx="0" cy="6191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2" name="Rectangle 251"/>
                <p:cNvSpPr>
                  <a:spLocks noChangeArrowheads="1"/>
                </p:cNvSpPr>
                <p:nvPr/>
              </p:nvSpPr>
              <p:spPr bwMode="auto">
                <a:xfrm>
                  <a:off x="9675814" y="6694488"/>
                  <a:ext cx="457765" cy="133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en-US" sz="800" b="0" i="0" u="none" strike="noStrike" kern="0" cap="none" spc="0" normalizeH="0" baseline="0" noProof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cs typeface="Arial" pitchFamily="34" charset="0"/>
                    </a:rPr>
                    <a:t>20.0</a:t>
                  </a:r>
                  <a:endParaRPr kumimoji="0" lang="en-US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cs typeface="Arial" pitchFamily="34" charset="0"/>
                  </a:endParaRPr>
                </a:p>
              </p:txBody>
            </p:sp>
            <p:sp>
              <p:nvSpPr>
                <p:cNvPr id="113" name="Line 252"/>
                <p:cNvSpPr>
                  <a:spLocks noChangeShapeType="1"/>
                </p:cNvSpPr>
                <p:nvPr/>
              </p:nvSpPr>
              <p:spPr bwMode="auto">
                <a:xfrm>
                  <a:off x="9798050" y="6632576"/>
                  <a:ext cx="0" cy="6191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4" name="Rectangle 266"/>
                <p:cNvSpPr>
                  <a:spLocks noChangeArrowheads="1"/>
                </p:cNvSpPr>
                <p:nvPr/>
              </p:nvSpPr>
              <p:spPr bwMode="auto">
                <a:xfrm>
                  <a:off x="10931525" y="6694488"/>
                  <a:ext cx="457765" cy="133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en-US" sz="800" b="0" i="0" u="none" strike="noStrike" kern="0" cap="none" spc="0" normalizeH="0" baseline="0" noProof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cs typeface="Arial" pitchFamily="34" charset="0"/>
                    </a:rPr>
                    <a:t>23.1</a:t>
                  </a:r>
                  <a:endParaRPr kumimoji="0" lang="en-US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cs typeface="Arial" pitchFamily="34" charset="0"/>
                  </a:endParaRPr>
                </a:p>
              </p:txBody>
            </p:sp>
            <p:sp>
              <p:nvSpPr>
                <p:cNvPr id="115" name="Line 267"/>
                <p:cNvSpPr>
                  <a:spLocks noChangeShapeType="1"/>
                </p:cNvSpPr>
                <p:nvPr/>
              </p:nvSpPr>
              <p:spPr bwMode="auto">
                <a:xfrm>
                  <a:off x="11053763" y="6632576"/>
                  <a:ext cx="0" cy="6191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6" name="Rectangle 268"/>
                <p:cNvSpPr>
                  <a:spLocks noChangeArrowheads="1"/>
                </p:cNvSpPr>
                <p:nvPr/>
              </p:nvSpPr>
              <p:spPr bwMode="auto">
                <a:xfrm>
                  <a:off x="1703388" y="4413251"/>
                  <a:ext cx="9350375" cy="2219325"/>
                </a:xfrm>
                <a:prstGeom prst="rect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7" name="Rectangle 269"/>
                <p:cNvSpPr>
                  <a:spLocks noChangeArrowheads="1"/>
                </p:cNvSpPr>
                <p:nvPr/>
              </p:nvSpPr>
              <p:spPr bwMode="auto">
                <a:xfrm>
                  <a:off x="1449388" y="6570663"/>
                  <a:ext cx="337876" cy="133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en-US" sz="800" b="0" i="0" u="none" strike="noStrike" kern="0" cap="none" spc="0" normalizeH="0" baseline="0" noProof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cs typeface="Arial" pitchFamily="34" charset="0"/>
                    </a:rPr>
                    <a:t>-20</a:t>
                  </a:r>
                  <a:endParaRPr kumimoji="0" lang="en-US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cs typeface="Arial" pitchFamily="34" charset="0"/>
                  </a:endParaRPr>
                </a:p>
              </p:txBody>
            </p:sp>
            <p:sp>
              <p:nvSpPr>
                <p:cNvPr id="118" name="Line 270"/>
                <p:cNvSpPr>
                  <a:spLocks noChangeShapeType="1"/>
                </p:cNvSpPr>
                <p:nvPr/>
              </p:nvSpPr>
              <p:spPr bwMode="auto">
                <a:xfrm flipH="1">
                  <a:off x="1641475" y="6632576"/>
                  <a:ext cx="61913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9" name="Line 272"/>
                <p:cNvSpPr>
                  <a:spLocks noChangeShapeType="1"/>
                </p:cNvSpPr>
                <p:nvPr/>
              </p:nvSpPr>
              <p:spPr bwMode="auto">
                <a:xfrm flipH="1">
                  <a:off x="1641475" y="6446838"/>
                  <a:ext cx="61913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0" name="Rectangle 277"/>
                <p:cNvSpPr>
                  <a:spLocks noChangeArrowheads="1"/>
                </p:cNvSpPr>
                <p:nvPr/>
              </p:nvSpPr>
              <p:spPr bwMode="auto">
                <a:xfrm>
                  <a:off x="1482725" y="5922962"/>
                  <a:ext cx="261580" cy="133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en-US" sz="800" b="0" i="0" u="none" strike="noStrike" kern="0" cap="none" spc="0" normalizeH="0" baseline="0" noProof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cs typeface="Arial" pitchFamily="34" charset="0"/>
                    </a:rPr>
                    <a:t>50</a:t>
                  </a:r>
                  <a:endParaRPr kumimoji="0" lang="en-US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cs typeface="Arial" pitchFamily="34" charset="0"/>
                  </a:endParaRPr>
                </a:p>
              </p:txBody>
            </p:sp>
            <p:sp>
              <p:nvSpPr>
                <p:cNvPr id="121" name="Line 278"/>
                <p:cNvSpPr>
                  <a:spLocks noChangeShapeType="1"/>
                </p:cNvSpPr>
                <p:nvPr/>
              </p:nvSpPr>
              <p:spPr bwMode="auto">
                <a:xfrm flipH="1">
                  <a:off x="1641475" y="5984876"/>
                  <a:ext cx="61913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2" name="Rectangle 283"/>
                <p:cNvSpPr>
                  <a:spLocks noChangeArrowheads="1"/>
                </p:cNvSpPr>
                <p:nvPr/>
              </p:nvSpPr>
              <p:spPr bwMode="auto">
                <a:xfrm>
                  <a:off x="1425575" y="5461001"/>
                  <a:ext cx="392370" cy="133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en-US" sz="800" b="0" i="0" u="none" strike="noStrike" kern="0" cap="none" spc="0" normalizeH="0" baseline="0" noProof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cs typeface="Arial" pitchFamily="34" charset="0"/>
                    </a:rPr>
                    <a:t>100</a:t>
                  </a:r>
                  <a:endParaRPr kumimoji="0" lang="en-US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cs typeface="Arial" pitchFamily="34" charset="0"/>
                  </a:endParaRPr>
                </a:p>
              </p:txBody>
            </p:sp>
            <p:sp>
              <p:nvSpPr>
                <p:cNvPr id="123" name="Line 284"/>
                <p:cNvSpPr>
                  <a:spLocks noChangeShapeType="1"/>
                </p:cNvSpPr>
                <p:nvPr/>
              </p:nvSpPr>
              <p:spPr bwMode="auto">
                <a:xfrm flipH="1">
                  <a:off x="1641475" y="5522913"/>
                  <a:ext cx="61913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4" name="Rectangle 289"/>
                <p:cNvSpPr>
                  <a:spLocks noChangeArrowheads="1"/>
                </p:cNvSpPr>
                <p:nvPr/>
              </p:nvSpPr>
              <p:spPr bwMode="auto">
                <a:xfrm>
                  <a:off x="1220823" y="4997451"/>
                  <a:ext cx="392370" cy="133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en-US" sz="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cs typeface="Arial" pitchFamily="34" charset="0"/>
                    </a:rPr>
                    <a:t>150</a:t>
                  </a:r>
                  <a:endParaRPr kumimoji="0" lang="en-US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cs typeface="Arial" pitchFamily="34" charset="0"/>
                  </a:endParaRPr>
                </a:p>
              </p:txBody>
            </p:sp>
            <p:sp>
              <p:nvSpPr>
                <p:cNvPr id="125" name="Line 290"/>
                <p:cNvSpPr>
                  <a:spLocks noChangeShapeType="1"/>
                </p:cNvSpPr>
                <p:nvPr/>
              </p:nvSpPr>
              <p:spPr bwMode="auto">
                <a:xfrm flipH="1">
                  <a:off x="1641475" y="5059363"/>
                  <a:ext cx="61913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6" name="Rectangle 297"/>
                <p:cNvSpPr>
                  <a:spLocks noChangeArrowheads="1"/>
                </p:cNvSpPr>
                <p:nvPr/>
              </p:nvSpPr>
              <p:spPr bwMode="auto">
                <a:xfrm>
                  <a:off x="1220823" y="4351338"/>
                  <a:ext cx="392370" cy="133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en-US" sz="800" b="0" i="0" u="none" strike="noStrike" kern="0" cap="none" spc="0" normalizeH="0" baseline="0" noProof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cs typeface="Arial" pitchFamily="34" charset="0"/>
                    </a:rPr>
                    <a:t>220</a:t>
                  </a:r>
                  <a:endParaRPr kumimoji="0" lang="en-US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cs typeface="Arial" pitchFamily="34" charset="0"/>
                  </a:endParaRPr>
                </a:p>
              </p:txBody>
            </p:sp>
            <p:pic>
              <p:nvPicPr>
                <p:cNvPr id="127" name="Picture 298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703388" y="4346576"/>
                  <a:ext cx="6350" cy="63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28" name="Picture 299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703388" y="4346576"/>
                  <a:ext cx="6350" cy="63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30" name="Line 305"/>
                <p:cNvSpPr>
                  <a:spLocks noChangeShapeType="1"/>
                </p:cNvSpPr>
                <p:nvPr/>
              </p:nvSpPr>
              <p:spPr bwMode="auto">
                <a:xfrm flipH="1">
                  <a:off x="1641475" y="4413251"/>
                  <a:ext cx="61913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1" name="Freeform 306"/>
                <p:cNvSpPr>
                  <a:spLocks/>
                </p:cNvSpPr>
                <p:nvPr/>
              </p:nvSpPr>
              <p:spPr bwMode="auto">
                <a:xfrm>
                  <a:off x="1703388" y="6283326"/>
                  <a:ext cx="476250" cy="163513"/>
                </a:xfrm>
                <a:custGeom>
                  <a:avLst/>
                  <a:gdLst>
                    <a:gd name="T0" fmla="*/ 14 w 300"/>
                    <a:gd name="T1" fmla="*/ 103 h 103"/>
                    <a:gd name="T2" fmla="*/ 50 w 300"/>
                    <a:gd name="T3" fmla="*/ 103 h 103"/>
                    <a:gd name="T4" fmla="*/ 91 w 300"/>
                    <a:gd name="T5" fmla="*/ 103 h 103"/>
                    <a:gd name="T6" fmla="*/ 109 w 300"/>
                    <a:gd name="T7" fmla="*/ 103 h 103"/>
                    <a:gd name="T8" fmla="*/ 127 w 300"/>
                    <a:gd name="T9" fmla="*/ 103 h 103"/>
                    <a:gd name="T10" fmla="*/ 132 w 300"/>
                    <a:gd name="T11" fmla="*/ 103 h 103"/>
                    <a:gd name="T12" fmla="*/ 134 w 300"/>
                    <a:gd name="T13" fmla="*/ 103 h 103"/>
                    <a:gd name="T14" fmla="*/ 137 w 300"/>
                    <a:gd name="T15" fmla="*/ 103 h 103"/>
                    <a:gd name="T16" fmla="*/ 140 w 300"/>
                    <a:gd name="T17" fmla="*/ 103 h 103"/>
                    <a:gd name="T18" fmla="*/ 143 w 300"/>
                    <a:gd name="T19" fmla="*/ 102 h 103"/>
                    <a:gd name="T20" fmla="*/ 145 w 300"/>
                    <a:gd name="T21" fmla="*/ 102 h 103"/>
                    <a:gd name="T22" fmla="*/ 147 w 300"/>
                    <a:gd name="T23" fmla="*/ 101 h 103"/>
                    <a:gd name="T24" fmla="*/ 149 w 300"/>
                    <a:gd name="T25" fmla="*/ 101 h 103"/>
                    <a:gd name="T26" fmla="*/ 150 w 300"/>
                    <a:gd name="T27" fmla="*/ 100 h 103"/>
                    <a:gd name="T28" fmla="*/ 152 w 300"/>
                    <a:gd name="T29" fmla="*/ 99 h 103"/>
                    <a:gd name="T30" fmla="*/ 154 w 300"/>
                    <a:gd name="T31" fmla="*/ 97 h 103"/>
                    <a:gd name="T32" fmla="*/ 155 w 300"/>
                    <a:gd name="T33" fmla="*/ 96 h 103"/>
                    <a:gd name="T34" fmla="*/ 156 w 300"/>
                    <a:gd name="T35" fmla="*/ 94 h 103"/>
                    <a:gd name="T36" fmla="*/ 158 w 300"/>
                    <a:gd name="T37" fmla="*/ 91 h 103"/>
                    <a:gd name="T38" fmla="*/ 161 w 300"/>
                    <a:gd name="T39" fmla="*/ 87 h 103"/>
                    <a:gd name="T40" fmla="*/ 165 w 300"/>
                    <a:gd name="T41" fmla="*/ 78 h 103"/>
                    <a:gd name="T42" fmla="*/ 169 w 300"/>
                    <a:gd name="T43" fmla="*/ 72 h 103"/>
                    <a:gd name="T44" fmla="*/ 172 w 300"/>
                    <a:gd name="T45" fmla="*/ 68 h 103"/>
                    <a:gd name="T46" fmla="*/ 174 w 300"/>
                    <a:gd name="T47" fmla="*/ 66 h 103"/>
                    <a:gd name="T48" fmla="*/ 176 w 300"/>
                    <a:gd name="T49" fmla="*/ 65 h 103"/>
                    <a:gd name="T50" fmla="*/ 179 w 300"/>
                    <a:gd name="T51" fmla="*/ 64 h 103"/>
                    <a:gd name="T52" fmla="*/ 183 w 300"/>
                    <a:gd name="T53" fmla="*/ 63 h 103"/>
                    <a:gd name="T54" fmla="*/ 186 w 300"/>
                    <a:gd name="T55" fmla="*/ 61 h 103"/>
                    <a:gd name="T56" fmla="*/ 188 w 300"/>
                    <a:gd name="T57" fmla="*/ 58 h 103"/>
                    <a:gd name="T58" fmla="*/ 190 w 300"/>
                    <a:gd name="T59" fmla="*/ 52 h 103"/>
                    <a:gd name="T60" fmla="*/ 192 w 300"/>
                    <a:gd name="T61" fmla="*/ 43 h 103"/>
                    <a:gd name="T62" fmla="*/ 196 w 300"/>
                    <a:gd name="T63" fmla="*/ 24 h 103"/>
                    <a:gd name="T64" fmla="*/ 199 w 300"/>
                    <a:gd name="T65" fmla="*/ 9 h 103"/>
                    <a:gd name="T66" fmla="*/ 202 w 300"/>
                    <a:gd name="T67" fmla="*/ 2 h 103"/>
                    <a:gd name="T68" fmla="*/ 205 w 300"/>
                    <a:gd name="T69" fmla="*/ 0 h 103"/>
                    <a:gd name="T70" fmla="*/ 209 w 300"/>
                    <a:gd name="T71" fmla="*/ 3 h 103"/>
                    <a:gd name="T72" fmla="*/ 217 w 300"/>
                    <a:gd name="T73" fmla="*/ 18 h 103"/>
                    <a:gd name="T74" fmla="*/ 219 w 300"/>
                    <a:gd name="T75" fmla="*/ 22 h 103"/>
                    <a:gd name="T76" fmla="*/ 222 w 300"/>
                    <a:gd name="T77" fmla="*/ 28 h 103"/>
                    <a:gd name="T78" fmla="*/ 232 w 300"/>
                    <a:gd name="T79" fmla="*/ 47 h 103"/>
                    <a:gd name="T80" fmla="*/ 238 w 300"/>
                    <a:gd name="T81" fmla="*/ 55 h 103"/>
                    <a:gd name="T82" fmla="*/ 244 w 300"/>
                    <a:gd name="T83" fmla="*/ 61 h 103"/>
                    <a:gd name="T84" fmla="*/ 248 w 300"/>
                    <a:gd name="T85" fmla="*/ 64 h 103"/>
                    <a:gd name="T86" fmla="*/ 251 w 300"/>
                    <a:gd name="T87" fmla="*/ 65 h 103"/>
                    <a:gd name="T88" fmla="*/ 254 w 300"/>
                    <a:gd name="T89" fmla="*/ 65 h 103"/>
                    <a:gd name="T90" fmla="*/ 255 w 300"/>
                    <a:gd name="T91" fmla="*/ 64 h 103"/>
                    <a:gd name="T92" fmla="*/ 257 w 300"/>
                    <a:gd name="T93" fmla="*/ 62 h 103"/>
                    <a:gd name="T94" fmla="*/ 259 w 300"/>
                    <a:gd name="T95" fmla="*/ 58 h 103"/>
                    <a:gd name="T96" fmla="*/ 261 w 300"/>
                    <a:gd name="T97" fmla="*/ 50 h 103"/>
                    <a:gd name="T98" fmla="*/ 262 w 300"/>
                    <a:gd name="T99" fmla="*/ 44 h 103"/>
                    <a:gd name="T100" fmla="*/ 266 w 300"/>
                    <a:gd name="T101" fmla="*/ 28 h 103"/>
                    <a:gd name="T102" fmla="*/ 267 w 300"/>
                    <a:gd name="T103" fmla="*/ 22 h 103"/>
                    <a:gd name="T104" fmla="*/ 269 w 300"/>
                    <a:gd name="T105" fmla="*/ 18 h 103"/>
                    <a:gd name="T106" fmla="*/ 271 w 300"/>
                    <a:gd name="T107" fmla="*/ 19 h 103"/>
                    <a:gd name="T108" fmla="*/ 273 w 300"/>
                    <a:gd name="T109" fmla="*/ 24 h 103"/>
                    <a:gd name="T110" fmla="*/ 276 w 300"/>
                    <a:gd name="T111" fmla="*/ 34 h 103"/>
                    <a:gd name="T112" fmla="*/ 280 w 300"/>
                    <a:gd name="T113" fmla="*/ 53 h 103"/>
                    <a:gd name="T114" fmla="*/ 283 w 300"/>
                    <a:gd name="T115" fmla="*/ 63 h 103"/>
                    <a:gd name="T116" fmla="*/ 285 w 300"/>
                    <a:gd name="T117" fmla="*/ 68 h 103"/>
                    <a:gd name="T118" fmla="*/ 287 w 300"/>
                    <a:gd name="T119" fmla="*/ 73 h 103"/>
                    <a:gd name="T120" fmla="*/ 290 w 300"/>
                    <a:gd name="T121" fmla="*/ 76 h 103"/>
                    <a:gd name="T122" fmla="*/ 293 w 300"/>
                    <a:gd name="T123" fmla="*/ 79 h 103"/>
                    <a:gd name="T124" fmla="*/ 297 w 300"/>
                    <a:gd name="T125" fmla="*/ 82 h 10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  <a:cxn ang="0">
                      <a:pos x="T116" y="T117"/>
                    </a:cxn>
                    <a:cxn ang="0">
                      <a:pos x="T118" y="T119"/>
                    </a:cxn>
                    <a:cxn ang="0">
                      <a:pos x="T120" y="T121"/>
                    </a:cxn>
                    <a:cxn ang="0">
                      <a:pos x="T122" y="T123"/>
                    </a:cxn>
                    <a:cxn ang="0">
                      <a:pos x="T124" y="T125"/>
                    </a:cxn>
                  </a:cxnLst>
                  <a:rect l="0" t="0" r="r" b="b"/>
                  <a:pathLst>
                    <a:path w="300" h="103">
                      <a:moveTo>
                        <a:pt x="0" y="103"/>
                      </a:moveTo>
                      <a:lnTo>
                        <a:pt x="1" y="103"/>
                      </a:lnTo>
                      <a:lnTo>
                        <a:pt x="3" y="103"/>
                      </a:lnTo>
                      <a:lnTo>
                        <a:pt x="6" y="103"/>
                      </a:lnTo>
                      <a:lnTo>
                        <a:pt x="8" y="103"/>
                      </a:lnTo>
                      <a:lnTo>
                        <a:pt x="10" y="103"/>
                      </a:lnTo>
                      <a:lnTo>
                        <a:pt x="12" y="103"/>
                      </a:lnTo>
                      <a:lnTo>
                        <a:pt x="14" y="103"/>
                      </a:lnTo>
                      <a:lnTo>
                        <a:pt x="16" y="103"/>
                      </a:lnTo>
                      <a:lnTo>
                        <a:pt x="18" y="103"/>
                      </a:lnTo>
                      <a:lnTo>
                        <a:pt x="20" y="103"/>
                      </a:lnTo>
                      <a:lnTo>
                        <a:pt x="26" y="103"/>
                      </a:lnTo>
                      <a:lnTo>
                        <a:pt x="34" y="103"/>
                      </a:lnTo>
                      <a:lnTo>
                        <a:pt x="39" y="103"/>
                      </a:lnTo>
                      <a:lnTo>
                        <a:pt x="45" y="103"/>
                      </a:lnTo>
                      <a:lnTo>
                        <a:pt x="50" y="103"/>
                      </a:lnTo>
                      <a:lnTo>
                        <a:pt x="54" y="103"/>
                      </a:lnTo>
                      <a:lnTo>
                        <a:pt x="57" y="103"/>
                      </a:lnTo>
                      <a:lnTo>
                        <a:pt x="63" y="103"/>
                      </a:lnTo>
                      <a:lnTo>
                        <a:pt x="71" y="103"/>
                      </a:lnTo>
                      <a:lnTo>
                        <a:pt x="78" y="103"/>
                      </a:lnTo>
                      <a:lnTo>
                        <a:pt x="82" y="103"/>
                      </a:lnTo>
                      <a:lnTo>
                        <a:pt x="87" y="103"/>
                      </a:lnTo>
                      <a:lnTo>
                        <a:pt x="91" y="103"/>
                      </a:lnTo>
                      <a:lnTo>
                        <a:pt x="93" y="103"/>
                      </a:lnTo>
                      <a:lnTo>
                        <a:pt x="96" y="103"/>
                      </a:lnTo>
                      <a:lnTo>
                        <a:pt x="98" y="103"/>
                      </a:lnTo>
                      <a:lnTo>
                        <a:pt x="100" y="103"/>
                      </a:lnTo>
                      <a:lnTo>
                        <a:pt x="103" y="103"/>
                      </a:lnTo>
                      <a:lnTo>
                        <a:pt x="105" y="103"/>
                      </a:lnTo>
                      <a:lnTo>
                        <a:pt x="107" y="103"/>
                      </a:lnTo>
                      <a:lnTo>
                        <a:pt x="109" y="103"/>
                      </a:lnTo>
                      <a:lnTo>
                        <a:pt x="111" y="103"/>
                      </a:lnTo>
                      <a:lnTo>
                        <a:pt x="113" y="103"/>
                      </a:lnTo>
                      <a:lnTo>
                        <a:pt x="116" y="103"/>
                      </a:lnTo>
                      <a:lnTo>
                        <a:pt x="119" y="103"/>
                      </a:lnTo>
                      <a:lnTo>
                        <a:pt x="121" y="103"/>
                      </a:lnTo>
                      <a:lnTo>
                        <a:pt x="124" y="103"/>
                      </a:lnTo>
                      <a:lnTo>
                        <a:pt x="125" y="103"/>
                      </a:lnTo>
                      <a:lnTo>
                        <a:pt x="127" y="103"/>
                      </a:lnTo>
                      <a:lnTo>
                        <a:pt x="129" y="103"/>
                      </a:lnTo>
                      <a:lnTo>
                        <a:pt x="130" y="103"/>
                      </a:lnTo>
                      <a:lnTo>
                        <a:pt x="131" y="103"/>
                      </a:lnTo>
                      <a:lnTo>
                        <a:pt x="131" y="103"/>
                      </a:lnTo>
                      <a:lnTo>
                        <a:pt x="131" y="103"/>
                      </a:lnTo>
                      <a:lnTo>
                        <a:pt x="131" y="103"/>
                      </a:lnTo>
                      <a:lnTo>
                        <a:pt x="132" y="103"/>
                      </a:lnTo>
                      <a:lnTo>
                        <a:pt x="132" y="103"/>
                      </a:lnTo>
                      <a:lnTo>
                        <a:pt x="132" y="103"/>
                      </a:lnTo>
                      <a:lnTo>
                        <a:pt x="132" y="103"/>
                      </a:lnTo>
                      <a:lnTo>
                        <a:pt x="133" y="103"/>
                      </a:lnTo>
                      <a:lnTo>
                        <a:pt x="133" y="103"/>
                      </a:lnTo>
                      <a:lnTo>
                        <a:pt x="133" y="103"/>
                      </a:lnTo>
                      <a:lnTo>
                        <a:pt x="133" y="103"/>
                      </a:lnTo>
                      <a:lnTo>
                        <a:pt x="134" y="103"/>
                      </a:lnTo>
                      <a:lnTo>
                        <a:pt x="134" y="103"/>
                      </a:lnTo>
                      <a:lnTo>
                        <a:pt x="134" y="103"/>
                      </a:lnTo>
                      <a:lnTo>
                        <a:pt x="134" y="103"/>
                      </a:lnTo>
                      <a:lnTo>
                        <a:pt x="134" y="103"/>
                      </a:lnTo>
                      <a:lnTo>
                        <a:pt x="135" y="103"/>
                      </a:lnTo>
                      <a:lnTo>
                        <a:pt x="136" y="103"/>
                      </a:lnTo>
                      <a:lnTo>
                        <a:pt x="136" y="103"/>
                      </a:lnTo>
                      <a:lnTo>
                        <a:pt x="136" y="103"/>
                      </a:lnTo>
                      <a:lnTo>
                        <a:pt x="137" y="103"/>
                      </a:lnTo>
                      <a:lnTo>
                        <a:pt x="137" y="103"/>
                      </a:lnTo>
                      <a:lnTo>
                        <a:pt x="138" y="103"/>
                      </a:lnTo>
                      <a:lnTo>
                        <a:pt x="138" y="103"/>
                      </a:lnTo>
                      <a:lnTo>
                        <a:pt x="139" y="103"/>
                      </a:lnTo>
                      <a:lnTo>
                        <a:pt x="139" y="103"/>
                      </a:lnTo>
                      <a:lnTo>
                        <a:pt x="139" y="103"/>
                      </a:lnTo>
                      <a:lnTo>
                        <a:pt x="140" y="103"/>
                      </a:lnTo>
                      <a:lnTo>
                        <a:pt x="140" y="103"/>
                      </a:lnTo>
                      <a:lnTo>
                        <a:pt x="140" y="103"/>
                      </a:lnTo>
                      <a:lnTo>
                        <a:pt x="141" y="103"/>
                      </a:lnTo>
                      <a:lnTo>
                        <a:pt x="141" y="103"/>
                      </a:lnTo>
                      <a:lnTo>
                        <a:pt x="141" y="103"/>
                      </a:lnTo>
                      <a:lnTo>
                        <a:pt x="142" y="102"/>
                      </a:lnTo>
                      <a:lnTo>
                        <a:pt x="142" y="102"/>
                      </a:lnTo>
                      <a:lnTo>
                        <a:pt x="142" y="102"/>
                      </a:lnTo>
                      <a:lnTo>
                        <a:pt x="143" y="102"/>
                      </a:lnTo>
                      <a:lnTo>
                        <a:pt x="143" y="102"/>
                      </a:lnTo>
                      <a:lnTo>
                        <a:pt x="143" y="102"/>
                      </a:lnTo>
                      <a:lnTo>
                        <a:pt x="144" y="102"/>
                      </a:lnTo>
                      <a:lnTo>
                        <a:pt x="144" y="102"/>
                      </a:lnTo>
                      <a:lnTo>
                        <a:pt x="144" y="102"/>
                      </a:lnTo>
                      <a:lnTo>
                        <a:pt x="144" y="102"/>
                      </a:lnTo>
                      <a:lnTo>
                        <a:pt x="145" y="102"/>
                      </a:lnTo>
                      <a:lnTo>
                        <a:pt x="145" y="102"/>
                      </a:lnTo>
                      <a:lnTo>
                        <a:pt x="145" y="102"/>
                      </a:lnTo>
                      <a:lnTo>
                        <a:pt x="145" y="102"/>
                      </a:lnTo>
                      <a:lnTo>
                        <a:pt x="146" y="102"/>
                      </a:lnTo>
                      <a:lnTo>
                        <a:pt x="146" y="102"/>
                      </a:lnTo>
                      <a:lnTo>
                        <a:pt x="146" y="101"/>
                      </a:lnTo>
                      <a:lnTo>
                        <a:pt x="146" y="101"/>
                      </a:lnTo>
                      <a:lnTo>
                        <a:pt x="146" y="101"/>
                      </a:lnTo>
                      <a:lnTo>
                        <a:pt x="147" y="101"/>
                      </a:lnTo>
                      <a:lnTo>
                        <a:pt x="147" y="101"/>
                      </a:lnTo>
                      <a:lnTo>
                        <a:pt x="147" y="101"/>
                      </a:lnTo>
                      <a:lnTo>
                        <a:pt x="147" y="101"/>
                      </a:lnTo>
                      <a:lnTo>
                        <a:pt x="148" y="101"/>
                      </a:lnTo>
                      <a:lnTo>
                        <a:pt x="148" y="101"/>
                      </a:lnTo>
                      <a:lnTo>
                        <a:pt x="148" y="101"/>
                      </a:lnTo>
                      <a:lnTo>
                        <a:pt x="148" y="101"/>
                      </a:lnTo>
                      <a:lnTo>
                        <a:pt x="149" y="101"/>
                      </a:lnTo>
                      <a:lnTo>
                        <a:pt x="149" y="101"/>
                      </a:lnTo>
                      <a:lnTo>
                        <a:pt x="149" y="100"/>
                      </a:lnTo>
                      <a:lnTo>
                        <a:pt x="149" y="100"/>
                      </a:lnTo>
                      <a:lnTo>
                        <a:pt x="149" y="100"/>
                      </a:lnTo>
                      <a:lnTo>
                        <a:pt x="150" y="100"/>
                      </a:lnTo>
                      <a:lnTo>
                        <a:pt x="150" y="100"/>
                      </a:lnTo>
                      <a:lnTo>
                        <a:pt x="150" y="100"/>
                      </a:lnTo>
                      <a:lnTo>
                        <a:pt x="150" y="100"/>
                      </a:lnTo>
                      <a:lnTo>
                        <a:pt x="151" y="100"/>
                      </a:lnTo>
                      <a:lnTo>
                        <a:pt x="151" y="99"/>
                      </a:lnTo>
                      <a:lnTo>
                        <a:pt x="151" y="99"/>
                      </a:lnTo>
                      <a:lnTo>
                        <a:pt x="151" y="99"/>
                      </a:lnTo>
                      <a:lnTo>
                        <a:pt x="151" y="99"/>
                      </a:lnTo>
                      <a:lnTo>
                        <a:pt x="151" y="99"/>
                      </a:lnTo>
                      <a:lnTo>
                        <a:pt x="152" y="99"/>
                      </a:lnTo>
                      <a:lnTo>
                        <a:pt x="152" y="99"/>
                      </a:lnTo>
                      <a:lnTo>
                        <a:pt x="152" y="99"/>
                      </a:lnTo>
                      <a:lnTo>
                        <a:pt x="152" y="98"/>
                      </a:lnTo>
                      <a:lnTo>
                        <a:pt x="152" y="98"/>
                      </a:lnTo>
                      <a:lnTo>
                        <a:pt x="153" y="98"/>
                      </a:lnTo>
                      <a:lnTo>
                        <a:pt x="153" y="98"/>
                      </a:lnTo>
                      <a:lnTo>
                        <a:pt x="153" y="98"/>
                      </a:lnTo>
                      <a:lnTo>
                        <a:pt x="153" y="98"/>
                      </a:lnTo>
                      <a:lnTo>
                        <a:pt x="154" y="97"/>
                      </a:lnTo>
                      <a:lnTo>
                        <a:pt x="154" y="97"/>
                      </a:lnTo>
                      <a:lnTo>
                        <a:pt x="154" y="97"/>
                      </a:lnTo>
                      <a:lnTo>
                        <a:pt x="154" y="97"/>
                      </a:lnTo>
                      <a:lnTo>
                        <a:pt x="154" y="96"/>
                      </a:lnTo>
                      <a:lnTo>
                        <a:pt x="155" y="96"/>
                      </a:lnTo>
                      <a:lnTo>
                        <a:pt x="155" y="96"/>
                      </a:lnTo>
                      <a:lnTo>
                        <a:pt x="155" y="96"/>
                      </a:lnTo>
                      <a:lnTo>
                        <a:pt x="155" y="96"/>
                      </a:lnTo>
                      <a:lnTo>
                        <a:pt x="155" y="96"/>
                      </a:lnTo>
                      <a:lnTo>
                        <a:pt x="155" y="95"/>
                      </a:lnTo>
                      <a:lnTo>
                        <a:pt x="156" y="95"/>
                      </a:lnTo>
                      <a:lnTo>
                        <a:pt x="156" y="95"/>
                      </a:lnTo>
                      <a:lnTo>
                        <a:pt x="156" y="95"/>
                      </a:lnTo>
                      <a:lnTo>
                        <a:pt x="156" y="94"/>
                      </a:lnTo>
                      <a:lnTo>
                        <a:pt x="156" y="94"/>
                      </a:lnTo>
                      <a:lnTo>
                        <a:pt x="156" y="94"/>
                      </a:lnTo>
                      <a:lnTo>
                        <a:pt x="157" y="94"/>
                      </a:lnTo>
                      <a:lnTo>
                        <a:pt x="157" y="93"/>
                      </a:lnTo>
                      <a:lnTo>
                        <a:pt x="157" y="93"/>
                      </a:lnTo>
                      <a:lnTo>
                        <a:pt x="157" y="93"/>
                      </a:lnTo>
                      <a:lnTo>
                        <a:pt x="157" y="93"/>
                      </a:lnTo>
                      <a:lnTo>
                        <a:pt x="158" y="92"/>
                      </a:lnTo>
                      <a:lnTo>
                        <a:pt x="158" y="92"/>
                      </a:lnTo>
                      <a:lnTo>
                        <a:pt x="158" y="91"/>
                      </a:lnTo>
                      <a:lnTo>
                        <a:pt x="159" y="91"/>
                      </a:lnTo>
                      <a:lnTo>
                        <a:pt x="159" y="91"/>
                      </a:lnTo>
                      <a:lnTo>
                        <a:pt x="159" y="90"/>
                      </a:lnTo>
                      <a:lnTo>
                        <a:pt x="159" y="89"/>
                      </a:lnTo>
                      <a:lnTo>
                        <a:pt x="160" y="89"/>
                      </a:lnTo>
                      <a:lnTo>
                        <a:pt x="160" y="88"/>
                      </a:lnTo>
                      <a:lnTo>
                        <a:pt x="160" y="88"/>
                      </a:lnTo>
                      <a:lnTo>
                        <a:pt x="161" y="87"/>
                      </a:lnTo>
                      <a:lnTo>
                        <a:pt x="161" y="86"/>
                      </a:lnTo>
                      <a:lnTo>
                        <a:pt x="161" y="86"/>
                      </a:lnTo>
                      <a:lnTo>
                        <a:pt x="162" y="85"/>
                      </a:lnTo>
                      <a:lnTo>
                        <a:pt x="162" y="84"/>
                      </a:lnTo>
                      <a:lnTo>
                        <a:pt x="163" y="83"/>
                      </a:lnTo>
                      <a:lnTo>
                        <a:pt x="164" y="81"/>
                      </a:lnTo>
                      <a:lnTo>
                        <a:pt x="164" y="80"/>
                      </a:lnTo>
                      <a:lnTo>
                        <a:pt x="165" y="78"/>
                      </a:lnTo>
                      <a:lnTo>
                        <a:pt x="166" y="77"/>
                      </a:lnTo>
                      <a:lnTo>
                        <a:pt x="166" y="76"/>
                      </a:lnTo>
                      <a:lnTo>
                        <a:pt x="166" y="75"/>
                      </a:lnTo>
                      <a:lnTo>
                        <a:pt x="167" y="75"/>
                      </a:lnTo>
                      <a:lnTo>
                        <a:pt x="167" y="74"/>
                      </a:lnTo>
                      <a:lnTo>
                        <a:pt x="168" y="73"/>
                      </a:lnTo>
                      <a:lnTo>
                        <a:pt x="168" y="73"/>
                      </a:lnTo>
                      <a:lnTo>
                        <a:pt x="169" y="72"/>
                      </a:lnTo>
                      <a:lnTo>
                        <a:pt x="169" y="71"/>
                      </a:lnTo>
                      <a:lnTo>
                        <a:pt x="169" y="71"/>
                      </a:lnTo>
                      <a:lnTo>
                        <a:pt x="170" y="70"/>
                      </a:lnTo>
                      <a:lnTo>
                        <a:pt x="170" y="70"/>
                      </a:lnTo>
                      <a:lnTo>
                        <a:pt x="171" y="69"/>
                      </a:lnTo>
                      <a:lnTo>
                        <a:pt x="171" y="69"/>
                      </a:lnTo>
                      <a:lnTo>
                        <a:pt x="171" y="68"/>
                      </a:lnTo>
                      <a:lnTo>
                        <a:pt x="172" y="68"/>
                      </a:lnTo>
                      <a:lnTo>
                        <a:pt x="172" y="68"/>
                      </a:lnTo>
                      <a:lnTo>
                        <a:pt x="172" y="67"/>
                      </a:lnTo>
                      <a:lnTo>
                        <a:pt x="173" y="67"/>
                      </a:lnTo>
                      <a:lnTo>
                        <a:pt x="173" y="66"/>
                      </a:lnTo>
                      <a:lnTo>
                        <a:pt x="174" y="66"/>
                      </a:lnTo>
                      <a:lnTo>
                        <a:pt x="174" y="66"/>
                      </a:lnTo>
                      <a:lnTo>
                        <a:pt x="174" y="66"/>
                      </a:lnTo>
                      <a:lnTo>
                        <a:pt x="174" y="66"/>
                      </a:lnTo>
                      <a:lnTo>
                        <a:pt x="175" y="65"/>
                      </a:lnTo>
                      <a:lnTo>
                        <a:pt x="175" y="65"/>
                      </a:lnTo>
                      <a:lnTo>
                        <a:pt x="175" y="65"/>
                      </a:lnTo>
                      <a:lnTo>
                        <a:pt x="175" y="65"/>
                      </a:lnTo>
                      <a:lnTo>
                        <a:pt x="175" y="65"/>
                      </a:lnTo>
                      <a:lnTo>
                        <a:pt x="176" y="65"/>
                      </a:lnTo>
                      <a:lnTo>
                        <a:pt x="176" y="65"/>
                      </a:lnTo>
                      <a:lnTo>
                        <a:pt x="176" y="65"/>
                      </a:lnTo>
                      <a:lnTo>
                        <a:pt x="176" y="65"/>
                      </a:lnTo>
                      <a:lnTo>
                        <a:pt x="176" y="65"/>
                      </a:lnTo>
                      <a:lnTo>
                        <a:pt x="176" y="64"/>
                      </a:lnTo>
                      <a:lnTo>
                        <a:pt x="177" y="64"/>
                      </a:lnTo>
                      <a:lnTo>
                        <a:pt x="177" y="64"/>
                      </a:lnTo>
                      <a:lnTo>
                        <a:pt x="178" y="64"/>
                      </a:lnTo>
                      <a:lnTo>
                        <a:pt x="179" y="64"/>
                      </a:lnTo>
                      <a:lnTo>
                        <a:pt x="179" y="64"/>
                      </a:lnTo>
                      <a:lnTo>
                        <a:pt x="180" y="64"/>
                      </a:lnTo>
                      <a:lnTo>
                        <a:pt x="181" y="63"/>
                      </a:lnTo>
                      <a:lnTo>
                        <a:pt x="181" y="63"/>
                      </a:lnTo>
                      <a:lnTo>
                        <a:pt x="182" y="63"/>
                      </a:lnTo>
                      <a:lnTo>
                        <a:pt x="182" y="63"/>
                      </a:lnTo>
                      <a:lnTo>
                        <a:pt x="182" y="63"/>
                      </a:lnTo>
                      <a:lnTo>
                        <a:pt x="183" y="63"/>
                      </a:lnTo>
                      <a:lnTo>
                        <a:pt x="183" y="63"/>
                      </a:lnTo>
                      <a:lnTo>
                        <a:pt x="184" y="63"/>
                      </a:lnTo>
                      <a:lnTo>
                        <a:pt x="184" y="63"/>
                      </a:lnTo>
                      <a:lnTo>
                        <a:pt x="184" y="63"/>
                      </a:lnTo>
                      <a:lnTo>
                        <a:pt x="184" y="62"/>
                      </a:lnTo>
                      <a:lnTo>
                        <a:pt x="185" y="62"/>
                      </a:lnTo>
                      <a:lnTo>
                        <a:pt x="185" y="62"/>
                      </a:lnTo>
                      <a:lnTo>
                        <a:pt x="185" y="62"/>
                      </a:lnTo>
                      <a:lnTo>
                        <a:pt x="186" y="61"/>
                      </a:lnTo>
                      <a:lnTo>
                        <a:pt x="186" y="61"/>
                      </a:lnTo>
                      <a:lnTo>
                        <a:pt x="186" y="61"/>
                      </a:lnTo>
                      <a:lnTo>
                        <a:pt x="186" y="60"/>
                      </a:lnTo>
                      <a:lnTo>
                        <a:pt x="187" y="60"/>
                      </a:lnTo>
                      <a:lnTo>
                        <a:pt x="187" y="59"/>
                      </a:lnTo>
                      <a:lnTo>
                        <a:pt x="187" y="59"/>
                      </a:lnTo>
                      <a:lnTo>
                        <a:pt x="188" y="58"/>
                      </a:lnTo>
                      <a:lnTo>
                        <a:pt x="188" y="58"/>
                      </a:lnTo>
                      <a:lnTo>
                        <a:pt x="188" y="57"/>
                      </a:lnTo>
                      <a:lnTo>
                        <a:pt x="188" y="56"/>
                      </a:lnTo>
                      <a:lnTo>
                        <a:pt x="189" y="56"/>
                      </a:lnTo>
                      <a:lnTo>
                        <a:pt x="189" y="55"/>
                      </a:lnTo>
                      <a:lnTo>
                        <a:pt x="189" y="54"/>
                      </a:lnTo>
                      <a:lnTo>
                        <a:pt x="189" y="54"/>
                      </a:lnTo>
                      <a:lnTo>
                        <a:pt x="190" y="53"/>
                      </a:lnTo>
                      <a:lnTo>
                        <a:pt x="190" y="52"/>
                      </a:lnTo>
                      <a:lnTo>
                        <a:pt x="190" y="51"/>
                      </a:lnTo>
                      <a:lnTo>
                        <a:pt x="190" y="50"/>
                      </a:lnTo>
                      <a:lnTo>
                        <a:pt x="191" y="49"/>
                      </a:lnTo>
                      <a:lnTo>
                        <a:pt x="191" y="48"/>
                      </a:lnTo>
                      <a:lnTo>
                        <a:pt x="191" y="47"/>
                      </a:lnTo>
                      <a:lnTo>
                        <a:pt x="191" y="46"/>
                      </a:lnTo>
                      <a:lnTo>
                        <a:pt x="192" y="44"/>
                      </a:lnTo>
                      <a:lnTo>
                        <a:pt x="192" y="43"/>
                      </a:lnTo>
                      <a:lnTo>
                        <a:pt x="192" y="41"/>
                      </a:lnTo>
                      <a:lnTo>
                        <a:pt x="193" y="40"/>
                      </a:lnTo>
                      <a:lnTo>
                        <a:pt x="193" y="38"/>
                      </a:lnTo>
                      <a:lnTo>
                        <a:pt x="194" y="36"/>
                      </a:lnTo>
                      <a:lnTo>
                        <a:pt x="194" y="33"/>
                      </a:lnTo>
                      <a:lnTo>
                        <a:pt x="195" y="30"/>
                      </a:lnTo>
                      <a:lnTo>
                        <a:pt x="195" y="26"/>
                      </a:lnTo>
                      <a:lnTo>
                        <a:pt x="196" y="24"/>
                      </a:lnTo>
                      <a:lnTo>
                        <a:pt x="196" y="21"/>
                      </a:lnTo>
                      <a:lnTo>
                        <a:pt x="197" y="19"/>
                      </a:lnTo>
                      <a:lnTo>
                        <a:pt x="197" y="17"/>
                      </a:lnTo>
                      <a:lnTo>
                        <a:pt x="198" y="15"/>
                      </a:lnTo>
                      <a:lnTo>
                        <a:pt x="198" y="13"/>
                      </a:lnTo>
                      <a:lnTo>
                        <a:pt x="198" y="12"/>
                      </a:lnTo>
                      <a:lnTo>
                        <a:pt x="199" y="10"/>
                      </a:lnTo>
                      <a:lnTo>
                        <a:pt x="199" y="9"/>
                      </a:lnTo>
                      <a:lnTo>
                        <a:pt x="199" y="8"/>
                      </a:lnTo>
                      <a:lnTo>
                        <a:pt x="200" y="7"/>
                      </a:lnTo>
                      <a:lnTo>
                        <a:pt x="200" y="5"/>
                      </a:lnTo>
                      <a:lnTo>
                        <a:pt x="200" y="5"/>
                      </a:lnTo>
                      <a:lnTo>
                        <a:pt x="201" y="4"/>
                      </a:lnTo>
                      <a:lnTo>
                        <a:pt x="201" y="3"/>
                      </a:lnTo>
                      <a:lnTo>
                        <a:pt x="201" y="2"/>
                      </a:lnTo>
                      <a:lnTo>
                        <a:pt x="202" y="2"/>
                      </a:lnTo>
                      <a:lnTo>
                        <a:pt x="202" y="1"/>
                      </a:lnTo>
                      <a:lnTo>
                        <a:pt x="202" y="1"/>
                      </a:lnTo>
                      <a:lnTo>
                        <a:pt x="203" y="0"/>
                      </a:lnTo>
                      <a:lnTo>
                        <a:pt x="203" y="0"/>
                      </a:lnTo>
                      <a:lnTo>
                        <a:pt x="204" y="0"/>
                      </a:lnTo>
                      <a:lnTo>
                        <a:pt x="204" y="0"/>
                      </a:lnTo>
                      <a:lnTo>
                        <a:pt x="204" y="0"/>
                      </a:lnTo>
                      <a:lnTo>
                        <a:pt x="205" y="0"/>
                      </a:lnTo>
                      <a:lnTo>
                        <a:pt x="205" y="0"/>
                      </a:lnTo>
                      <a:lnTo>
                        <a:pt x="206" y="0"/>
                      </a:lnTo>
                      <a:lnTo>
                        <a:pt x="206" y="0"/>
                      </a:lnTo>
                      <a:lnTo>
                        <a:pt x="206" y="0"/>
                      </a:lnTo>
                      <a:lnTo>
                        <a:pt x="207" y="1"/>
                      </a:lnTo>
                      <a:lnTo>
                        <a:pt x="208" y="1"/>
                      </a:lnTo>
                      <a:lnTo>
                        <a:pt x="208" y="2"/>
                      </a:lnTo>
                      <a:lnTo>
                        <a:pt x="209" y="3"/>
                      </a:lnTo>
                      <a:lnTo>
                        <a:pt x="209" y="4"/>
                      </a:lnTo>
                      <a:lnTo>
                        <a:pt x="210" y="5"/>
                      </a:lnTo>
                      <a:lnTo>
                        <a:pt x="211" y="6"/>
                      </a:lnTo>
                      <a:lnTo>
                        <a:pt x="211" y="8"/>
                      </a:lnTo>
                      <a:lnTo>
                        <a:pt x="213" y="9"/>
                      </a:lnTo>
                      <a:lnTo>
                        <a:pt x="214" y="12"/>
                      </a:lnTo>
                      <a:lnTo>
                        <a:pt x="215" y="15"/>
                      </a:lnTo>
                      <a:lnTo>
                        <a:pt x="217" y="18"/>
                      </a:lnTo>
                      <a:lnTo>
                        <a:pt x="218" y="19"/>
                      </a:lnTo>
                      <a:lnTo>
                        <a:pt x="218" y="20"/>
                      </a:lnTo>
                      <a:lnTo>
                        <a:pt x="219" y="20"/>
                      </a:lnTo>
                      <a:lnTo>
                        <a:pt x="219" y="21"/>
                      </a:lnTo>
                      <a:lnTo>
                        <a:pt x="219" y="21"/>
                      </a:lnTo>
                      <a:lnTo>
                        <a:pt x="219" y="22"/>
                      </a:lnTo>
                      <a:lnTo>
                        <a:pt x="219" y="22"/>
                      </a:lnTo>
                      <a:lnTo>
                        <a:pt x="219" y="22"/>
                      </a:lnTo>
                      <a:lnTo>
                        <a:pt x="219" y="22"/>
                      </a:lnTo>
                      <a:lnTo>
                        <a:pt x="220" y="23"/>
                      </a:lnTo>
                      <a:lnTo>
                        <a:pt x="220" y="23"/>
                      </a:lnTo>
                      <a:lnTo>
                        <a:pt x="220" y="23"/>
                      </a:lnTo>
                      <a:lnTo>
                        <a:pt x="220" y="23"/>
                      </a:lnTo>
                      <a:lnTo>
                        <a:pt x="220" y="23"/>
                      </a:lnTo>
                      <a:lnTo>
                        <a:pt x="221" y="25"/>
                      </a:lnTo>
                      <a:lnTo>
                        <a:pt x="222" y="28"/>
                      </a:lnTo>
                      <a:lnTo>
                        <a:pt x="224" y="31"/>
                      </a:lnTo>
                      <a:lnTo>
                        <a:pt x="226" y="35"/>
                      </a:lnTo>
                      <a:lnTo>
                        <a:pt x="228" y="38"/>
                      </a:lnTo>
                      <a:lnTo>
                        <a:pt x="229" y="40"/>
                      </a:lnTo>
                      <a:lnTo>
                        <a:pt x="230" y="42"/>
                      </a:lnTo>
                      <a:lnTo>
                        <a:pt x="231" y="44"/>
                      </a:lnTo>
                      <a:lnTo>
                        <a:pt x="231" y="45"/>
                      </a:lnTo>
                      <a:lnTo>
                        <a:pt x="232" y="47"/>
                      </a:lnTo>
                      <a:lnTo>
                        <a:pt x="233" y="48"/>
                      </a:lnTo>
                      <a:lnTo>
                        <a:pt x="234" y="49"/>
                      </a:lnTo>
                      <a:lnTo>
                        <a:pt x="234" y="50"/>
                      </a:lnTo>
                      <a:lnTo>
                        <a:pt x="235" y="51"/>
                      </a:lnTo>
                      <a:lnTo>
                        <a:pt x="236" y="52"/>
                      </a:lnTo>
                      <a:lnTo>
                        <a:pt x="237" y="53"/>
                      </a:lnTo>
                      <a:lnTo>
                        <a:pt x="237" y="54"/>
                      </a:lnTo>
                      <a:lnTo>
                        <a:pt x="238" y="55"/>
                      </a:lnTo>
                      <a:lnTo>
                        <a:pt x="239" y="56"/>
                      </a:lnTo>
                      <a:lnTo>
                        <a:pt x="239" y="57"/>
                      </a:lnTo>
                      <a:lnTo>
                        <a:pt x="240" y="58"/>
                      </a:lnTo>
                      <a:lnTo>
                        <a:pt x="241" y="59"/>
                      </a:lnTo>
                      <a:lnTo>
                        <a:pt x="242" y="59"/>
                      </a:lnTo>
                      <a:lnTo>
                        <a:pt x="242" y="60"/>
                      </a:lnTo>
                      <a:lnTo>
                        <a:pt x="243" y="61"/>
                      </a:lnTo>
                      <a:lnTo>
                        <a:pt x="244" y="61"/>
                      </a:lnTo>
                      <a:lnTo>
                        <a:pt x="244" y="62"/>
                      </a:lnTo>
                      <a:lnTo>
                        <a:pt x="245" y="62"/>
                      </a:lnTo>
                      <a:lnTo>
                        <a:pt x="246" y="63"/>
                      </a:lnTo>
                      <a:lnTo>
                        <a:pt x="246" y="63"/>
                      </a:lnTo>
                      <a:lnTo>
                        <a:pt x="247" y="63"/>
                      </a:lnTo>
                      <a:lnTo>
                        <a:pt x="247" y="64"/>
                      </a:lnTo>
                      <a:lnTo>
                        <a:pt x="248" y="64"/>
                      </a:lnTo>
                      <a:lnTo>
                        <a:pt x="248" y="64"/>
                      </a:lnTo>
                      <a:lnTo>
                        <a:pt x="249" y="64"/>
                      </a:lnTo>
                      <a:lnTo>
                        <a:pt x="249" y="64"/>
                      </a:lnTo>
                      <a:lnTo>
                        <a:pt x="249" y="65"/>
                      </a:lnTo>
                      <a:lnTo>
                        <a:pt x="250" y="65"/>
                      </a:lnTo>
                      <a:lnTo>
                        <a:pt x="250" y="65"/>
                      </a:lnTo>
                      <a:lnTo>
                        <a:pt x="251" y="65"/>
                      </a:lnTo>
                      <a:lnTo>
                        <a:pt x="251" y="65"/>
                      </a:lnTo>
                      <a:lnTo>
                        <a:pt x="251" y="65"/>
                      </a:lnTo>
                      <a:lnTo>
                        <a:pt x="252" y="65"/>
                      </a:lnTo>
                      <a:lnTo>
                        <a:pt x="252" y="65"/>
                      </a:lnTo>
                      <a:lnTo>
                        <a:pt x="252" y="65"/>
                      </a:lnTo>
                      <a:lnTo>
                        <a:pt x="252" y="65"/>
                      </a:lnTo>
                      <a:lnTo>
                        <a:pt x="253" y="65"/>
                      </a:lnTo>
                      <a:lnTo>
                        <a:pt x="253" y="65"/>
                      </a:lnTo>
                      <a:lnTo>
                        <a:pt x="253" y="65"/>
                      </a:lnTo>
                      <a:lnTo>
                        <a:pt x="254" y="65"/>
                      </a:lnTo>
                      <a:lnTo>
                        <a:pt x="254" y="65"/>
                      </a:lnTo>
                      <a:lnTo>
                        <a:pt x="254" y="65"/>
                      </a:lnTo>
                      <a:lnTo>
                        <a:pt x="254" y="65"/>
                      </a:lnTo>
                      <a:lnTo>
                        <a:pt x="254" y="65"/>
                      </a:lnTo>
                      <a:lnTo>
                        <a:pt x="255" y="65"/>
                      </a:lnTo>
                      <a:lnTo>
                        <a:pt x="255" y="64"/>
                      </a:lnTo>
                      <a:lnTo>
                        <a:pt x="255" y="64"/>
                      </a:lnTo>
                      <a:lnTo>
                        <a:pt x="255" y="64"/>
                      </a:lnTo>
                      <a:lnTo>
                        <a:pt x="256" y="64"/>
                      </a:lnTo>
                      <a:lnTo>
                        <a:pt x="256" y="64"/>
                      </a:lnTo>
                      <a:lnTo>
                        <a:pt x="256" y="63"/>
                      </a:lnTo>
                      <a:lnTo>
                        <a:pt x="256" y="63"/>
                      </a:lnTo>
                      <a:lnTo>
                        <a:pt x="257" y="63"/>
                      </a:lnTo>
                      <a:lnTo>
                        <a:pt x="257" y="63"/>
                      </a:lnTo>
                      <a:lnTo>
                        <a:pt x="257" y="63"/>
                      </a:lnTo>
                      <a:lnTo>
                        <a:pt x="257" y="62"/>
                      </a:lnTo>
                      <a:lnTo>
                        <a:pt x="257" y="62"/>
                      </a:lnTo>
                      <a:lnTo>
                        <a:pt x="258" y="61"/>
                      </a:lnTo>
                      <a:lnTo>
                        <a:pt x="258" y="61"/>
                      </a:lnTo>
                      <a:lnTo>
                        <a:pt x="258" y="60"/>
                      </a:lnTo>
                      <a:lnTo>
                        <a:pt x="258" y="60"/>
                      </a:lnTo>
                      <a:lnTo>
                        <a:pt x="259" y="59"/>
                      </a:lnTo>
                      <a:lnTo>
                        <a:pt x="259" y="58"/>
                      </a:lnTo>
                      <a:lnTo>
                        <a:pt x="259" y="58"/>
                      </a:lnTo>
                      <a:lnTo>
                        <a:pt x="259" y="57"/>
                      </a:lnTo>
                      <a:lnTo>
                        <a:pt x="260" y="56"/>
                      </a:lnTo>
                      <a:lnTo>
                        <a:pt x="260" y="55"/>
                      </a:lnTo>
                      <a:lnTo>
                        <a:pt x="260" y="54"/>
                      </a:lnTo>
                      <a:lnTo>
                        <a:pt x="260" y="53"/>
                      </a:lnTo>
                      <a:lnTo>
                        <a:pt x="261" y="52"/>
                      </a:lnTo>
                      <a:lnTo>
                        <a:pt x="261" y="51"/>
                      </a:lnTo>
                      <a:lnTo>
                        <a:pt x="261" y="50"/>
                      </a:lnTo>
                      <a:lnTo>
                        <a:pt x="261" y="49"/>
                      </a:lnTo>
                      <a:lnTo>
                        <a:pt x="262" y="48"/>
                      </a:lnTo>
                      <a:lnTo>
                        <a:pt x="262" y="48"/>
                      </a:lnTo>
                      <a:lnTo>
                        <a:pt x="262" y="47"/>
                      </a:lnTo>
                      <a:lnTo>
                        <a:pt x="262" y="46"/>
                      </a:lnTo>
                      <a:lnTo>
                        <a:pt x="262" y="45"/>
                      </a:lnTo>
                      <a:lnTo>
                        <a:pt x="262" y="45"/>
                      </a:lnTo>
                      <a:lnTo>
                        <a:pt x="262" y="44"/>
                      </a:lnTo>
                      <a:lnTo>
                        <a:pt x="263" y="42"/>
                      </a:lnTo>
                      <a:lnTo>
                        <a:pt x="263" y="39"/>
                      </a:lnTo>
                      <a:lnTo>
                        <a:pt x="264" y="37"/>
                      </a:lnTo>
                      <a:lnTo>
                        <a:pt x="264" y="34"/>
                      </a:lnTo>
                      <a:lnTo>
                        <a:pt x="265" y="33"/>
                      </a:lnTo>
                      <a:lnTo>
                        <a:pt x="265" y="31"/>
                      </a:lnTo>
                      <a:lnTo>
                        <a:pt x="265" y="30"/>
                      </a:lnTo>
                      <a:lnTo>
                        <a:pt x="266" y="28"/>
                      </a:lnTo>
                      <a:lnTo>
                        <a:pt x="266" y="28"/>
                      </a:lnTo>
                      <a:lnTo>
                        <a:pt x="266" y="27"/>
                      </a:lnTo>
                      <a:lnTo>
                        <a:pt x="266" y="26"/>
                      </a:lnTo>
                      <a:lnTo>
                        <a:pt x="267" y="25"/>
                      </a:lnTo>
                      <a:lnTo>
                        <a:pt x="267" y="24"/>
                      </a:lnTo>
                      <a:lnTo>
                        <a:pt x="267" y="23"/>
                      </a:lnTo>
                      <a:lnTo>
                        <a:pt x="267" y="23"/>
                      </a:lnTo>
                      <a:lnTo>
                        <a:pt x="267" y="22"/>
                      </a:lnTo>
                      <a:lnTo>
                        <a:pt x="267" y="21"/>
                      </a:lnTo>
                      <a:lnTo>
                        <a:pt x="268" y="21"/>
                      </a:lnTo>
                      <a:lnTo>
                        <a:pt x="268" y="20"/>
                      </a:lnTo>
                      <a:lnTo>
                        <a:pt x="268" y="19"/>
                      </a:lnTo>
                      <a:lnTo>
                        <a:pt x="269" y="19"/>
                      </a:lnTo>
                      <a:lnTo>
                        <a:pt x="269" y="19"/>
                      </a:lnTo>
                      <a:lnTo>
                        <a:pt x="269" y="18"/>
                      </a:lnTo>
                      <a:lnTo>
                        <a:pt x="269" y="18"/>
                      </a:lnTo>
                      <a:lnTo>
                        <a:pt x="269" y="18"/>
                      </a:lnTo>
                      <a:lnTo>
                        <a:pt x="270" y="18"/>
                      </a:lnTo>
                      <a:lnTo>
                        <a:pt x="270" y="18"/>
                      </a:lnTo>
                      <a:lnTo>
                        <a:pt x="270" y="18"/>
                      </a:lnTo>
                      <a:lnTo>
                        <a:pt x="271" y="18"/>
                      </a:lnTo>
                      <a:lnTo>
                        <a:pt x="271" y="18"/>
                      </a:lnTo>
                      <a:lnTo>
                        <a:pt x="271" y="19"/>
                      </a:lnTo>
                      <a:lnTo>
                        <a:pt x="271" y="19"/>
                      </a:lnTo>
                      <a:lnTo>
                        <a:pt x="272" y="20"/>
                      </a:lnTo>
                      <a:lnTo>
                        <a:pt x="272" y="20"/>
                      </a:lnTo>
                      <a:lnTo>
                        <a:pt x="272" y="21"/>
                      </a:lnTo>
                      <a:lnTo>
                        <a:pt x="272" y="22"/>
                      </a:lnTo>
                      <a:lnTo>
                        <a:pt x="273" y="22"/>
                      </a:lnTo>
                      <a:lnTo>
                        <a:pt x="273" y="23"/>
                      </a:lnTo>
                      <a:lnTo>
                        <a:pt x="273" y="24"/>
                      </a:lnTo>
                      <a:lnTo>
                        <a:pt x="273" y="24"/>
                      </a:lnTo>
                      <a:lnTo>
                        <a:pt x="274" y="25"/>
                      </a:lnTo>
                      <a:lnTo>
                        <a:pt x="274" y="26"/>
                      </a:lnTo>
                      <a:lnTo>
                        <a:pt x="274" y="27"/>
                      </a:lnTo>
                      <a:lnTo>
                        <a:pt x="274" y="28"/>
                      </a:lnTo>
                      <a:lnTo>
                        <a:pt x="275" y="30"/>
                      </a:lnTo>
                      <a:lnTo>
                        <a:pt x="275" y="31"/>
                      </a:lnTo>
                      <a:lnTo>
                        <a:pt x="275" y="33"/>
                      </a:lnTo>
                      <a:lnTo>
                        <a:pt x="276" y="34"/>
                      </a:lnTo>
                      <a:lnTo>
                        <a:pt x="276" y="36"/>
                      </a:lnTo>
                      <a:lnTo>
                        <a:pt x="277" y="38"/>
                      </a:lnTo>
                      <a:lnTo>
                        <a:pt x="277" y="41"/>
                      </a:lnTo>
                      <a:lnTo>
                        <a:pt x="278" y="45"/>
                      </a:lnTo>
                      <a:lnTo>
                        <a:pt x="279" y="47"/>
                      </a:lnTo>
                      <a:lnTo>
                        <a:pt x="279" y="49"/>
                      </a:lnTo>
                      <a:lnTo>
                        <a:pt x="280" y="51"/>
                      </a:lnTo>
                      <a:lnTo>
                        <a:pt x="280" y="53"/>
                      </a:lnTo>
                      <a:lnTo>
                        <a:pt x="281" y="54"/>
                      </a:lnTo>
                      <a:lnTo>
                        <a:pt x="281" y="56"/>
                      </a:lnTo>
                      <a:lnTo>
                        <a:pt x="281" y="57"/>
                      </a:lnTo>
                      <a:lnTo>
                        <a:pt x="282" y="58"/>
                      </a:lnTo>
                      <a:lnTo>
                        <a:pt x="282" y="60"/>
                      </a:lnTo>
                      <a:lnTo>
                        <a:pt x="282" y="61"/>
                      </a:lnTo>
                      <a:lnTo>
                        <a:pt x="283" y="62"/>
                      </a:lnTo>
                      <a:lnTo>
                        <a:pt x="283" y="63"/>
                      </a:lnTo>
                      <a:lnTo>
                        <a:pt x="283" y="64"/>
                      </a:lnTo>
                      <a:lnTo>
                        <a:pt x="284" y="65"/>
                      </a:lnTo>
                      <a:lnTo>
                        <a:pt x="284" y="65"/>
                      </a:lnTo>
                      <a:lnTo>
                        <a:pt x="284" y="66"/>
                      </a:lnTo>
                      <a:lnTo>
                        <a:pt x="284" y="66"/>
                      </a:lnTo>
                      <a:lnTo>
                        <a:pt x="285" y="67"/>
                      </a:lnTo>
                      <a:lnTo>
                        <a:pt x="285" y="68"/>
                      </a:lnTo>
                      <a:lnTo>
                        <a:pt x="285" y="68"/>
                      </a:lnTo>
                      <a:lnTo>
                        <a:pt x="285" y="69"/>
                      </a:lnTo>
                      <a:lnTo>
                        <a:pt x="286" y="70"/>
                      </a:lnTo>
                      <a:lnTo>
                        <a:pt x="286" y="70"/>
                      </a:lnTo>
                      <a:lnTo>
                        <a:pt x="286" y="71"/>
                      </a:lnTo>
                      <a:lnTo>
                        <a:pt x="287" y="71"/>
                      </a:lnTo>
                      <a:lnTo>
                        <a:pt x="287" y="72"/>
                      </a:lnTo>
                      <a:lnTo>
                        <a:pt x="287" y="72"/>
                      </a:lnTo>
                      <a:lnTo>
                        <a:pt x="287" y="73"/>
                      </a:lnTo>
                      <a:lnTo>
                        <a:pt x="288" y="73"/>
                      </a:lnTo>
                      <a:lnTo>
                        <a:pt x="288" y="74"/>
                      </a:lnTo>
                      <a:lnTo>
                        <a:pt x="288" y="74"/>
                      </a:lnTo>
                      <a:lnTo>
                        <a:pt x="289" y="75"/>
                      </a:lnTo>
                      <a:lnTo>
                        <a:pt x="289" y="75"/>
                      </a:lnTo>
                      <a:lnTo>
                        <a:pt x="289" y="76"/>
                      </a:lnTo>
                      <a:lnTo>
                        <a:pt x="289" y="76"/>
                      </a:lnTo>
                      <a:lnTo>
                        <a:pt x="290" y="76"/>
                      </a:lnTo>
                      <a:lnTo>
                        <a:pt x="290" y="77"/>
                      </a:lnTo>
                      <a:lnTo>
                        <a:pt x="291" y="77"/>
                      </a:lnTo>
                      <a:lnTo>
                        <a:pt x="291" y="77"/>
                      </a:lnTo>
                      <a:lnTo>
                        <a:pt x="291" y="78"/>
                      </a:lnTo>
                      <a:lnTo>
                        <a:pt x="292" y="78"/>
                      </a:lnTo>
                      <a:lnTo>
                        <a:pt x="292" y="78"/>
                      </a:lnTo>
                      <a:lnTo>
                        <a:pt x="292" y="79"/>
                      </a:lnTo>
                      <a:lnTo>
                        <a:pt x="293" y="79"/>
                      </a:lnTo>
                      <a:lnTo>
                        <a:pt x="293" y="80"/>
                      </a:lnTo>
                      <a:lnTo>
                        <a:pt x="294" y="80"/>
                      </a:lnTo>
                      <a:lnTo>
                        <a:pt x="294" y="80"/>
                      </a:lnTo>
                      <a:lnTo>
                        <a:pt x="295" y="81"/>
                      </a:lnTo>
                      <a:lnTo>
                        <a:pt x="295" y="81"/>
                      </a:lnTo>
                      <a:lnTo>
                        <a:pt x="296" y="81"/>
                      </a:lnTo>
                      <a:lnTo>
                        <a:pt x="296" y="82"/>
                      </a:lnTo>
                      <a:lnTo>
                        <a:pt x="297" y="82"/>
                      </a:lnTo>
                      <a:lnTo>
                        <a:pt x="297" y="82"/>
                      </a:lnTo>
                      <a:lnTo>
                        <a:pt x="298" y="83"/>
                      </a:lnTo>
                      <a:lnTo>
                        <a:pt x="299" y="83"/>
                      </a:lnTo>
                      <a:lnTo>
                        <a:pt x="299" y="83"/>
                      </a:lnTo>
                      <a:lnTo>
                        <a:pt x="299" y="83"/>
                      </a:lnTo>
                      <a:lnTo>
                        <a:pt x="300" y="84"/>
                      </a:lnTo>
                      <a:lnTo>
                        <a:pt x="300" y="84"/>
                      </a:lnTo>
                    </a:path>
                  </a:pathLst>
                </a:cu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2" name="Freeform 307"/>
                <p:cNvSpPr>
                  <a:spLocks/>
                </p:cNvSpPr>
                <p:nvPr/>
              </p:nvSpPr>
              <p:spPr bwMode="auto">
                <a:xfrm>
                  <a:off x="2179638" y="6416676"/>
                  <a:ext cx="2846388" cy="25400"/>
                </a:xfrm>
                <a:custGeom>
                  <a:avLst/>
                  <a:gdLst>
                    <a:gd name="T0" fmla="*/ 4 w 1793"/>
                    <a:gd name="T1" fmla="*/ 1 h 16"/>
                    <a:gd name="T2" fmla="*/ 9 w 1793"/>
                    <a:gd name="T3" fmla="*/ 2 h 16"/>
                    <a:gd name="T4" fmla="*/ 14 w 1793"/>
                    <a:gd name="T5" fmla="*/ 3 h 16"/>
                    <a:gd name="T6" fmla="*/ 23 w 1793"/>
                    <a:gd name="T7" fmla="*/ 4 h 16"/>
                    <a:gd name="T8" fmla="*/ 31 w 1793"/>
                    <a:gd name="T9" fmla="*/ 5 h 16"/>
                    <a:gd name="T10" fmla="*/ 43 w 1793"/>
                    <a:gd name="T11" fmla="*/ 8 h 16"/>
                    <a:gd name="T12" fmla="*/ 53 w 1793"/>
                    <a:gd name="T13" fmla="*/ 9 h 16"/>
                    <a:gd name="T14" fmla="*/ 60 w 1793"/>
                    <a:gd name="T15" fmla="*/ 10 h 16"/>
                    <a:gd name="T16" fmla="*/ 70 w 1793"/>
                    <a:gd name="T17" fmla="*/ 11 h 16"/>
                    <a:gd name="T18" fmla="*/ 86 w 1793"/>
                    <a:gd name="T19" fmla="*/ 11 h 16"/>
                    <a:gd name="T20" fmla="*/ 97 w 1793"/>
                    <a:gd name="T21" fmla="*/ 12 h 16"/>
                    <a:gd name="T22" fmla="*/ 106 w 1793"/>
                    <a:gd name="T23" fmla="*/ 12 h 16"/>
                    <a:gd name="T24" fmla="*/ 122 w 1793"/>
                    <a:gd name="T25" fmla="*/ 13 h 16"/>
                    <a:gd name="T26" fmla="*/ 139 w 1793"/>
                    <a:gd name="T27" fmla="*/ 14 h 16"/>
                    <a:gd name="T28" fmla="*/ 152 w 1793"/>
                    <a:gd name="T29" fmla="*/ 14 h 16"/>
                    <a:gd name="T30" fmla="*/ 176 w 1793"/>
                    <a:gd name="T31" fmla="*/ 15 h 16"/>
                    <a:gd name="T32" fmla="*/ 187 w 1793"/>
                    <a:gd name="T33" fmla="*/ 15 h 16"/>
                    <a:gd name="T34" fmla="*/ 208 w 1793"/>
                    <a:gd name="T35" fmla="*/ 16 h 16"/>
                    <a:gd name="T36" fmla="*/ 228 w 1793"/>
                    <a:gd name="T37" fmla="*/ 16 h 16"/>
                    <a:gd name="T38" fmla="*/ 254 w 1793"/>
                    <a:gd name="T39" fmla="*/ 16 h 16"/>
                    <a:gd name="T40" fmla="*/ 273 w 1793"/>
                    <a:gd name="T41" fmla="*/ 16 h 16"/>
                    <a:gd name="T42" fmla="*/ 292 w 1793"/>
                    <a:gd name="T43" fmla="*/ 16 h 16"/>
                    <a:gd name="T44" fmla="*/ 316 w 1793"/>
                    <a:gd name="T45" fmla="*/ 16 h 16"/>
                    <a:gd name="T46" fmla="*/ 344 w 1793"/>
                    <a:gd name="T47" fmla="*/ 15 h 16"/>
                    <a:gd name="T48" fmla="*/ 370 w 1793"/>
                    <a:gd name="T49" fmla="*/ 15 h 16"/>
                    <a:gd name="T50" fmla="*/ 400 w 1793"/>
                    <a:gd name="T51" fmla="*/ 15 h 16"/>
                    <a:gd name="T52" fmla="*/ 433 w 1793"/>
                    <a:gd name="T53" fmla="*/ 15 h 16"/>
                    <a:gd name="T54" fmla="*/ 459 w 1793"/>
                    <a:gd name="T55" fmla="*/ 15 h 16"/>
                    <a:gd name="T56" fmla="*/ 487 w 1793"/>
                    <a:gd name="T57" fmla="*/ 15 h 16"/>
                    <a:gd name="T58" fmla="*/ 515 w 1793"/>
                    <a:gd name="T59" fmla="*/ 15 h 16"/>
                    <a:gd name="T60" fmla="*/ 546 w 1793"/>
                    <a:gd name="T61" fmla="*/ 14 h 16"/>
                    <a:gd name="T62" fmla="*/ 582 w 1793"/>
                    <a:gd name="T63" fmla="*/ 14 h 16"/>
                    <a:gd name="T64" fmla="*/ 627 w 1793"/>
                    <a:gd name="T65" fmla="*/ 14 h 16"/>
                    <a:gd name="T66" fmla="*/ 665 w 1793"/>
                    <a:gd name="T67" fmla="*/ 14 h 16"/>
                    <a:gd name="T68" fmla="*/ 696 w 1793"/>
                    <a:gd name="T69" fmla="*/ 14 h 16"/>
                    <a:gd name="T70" fmla="*/ 753 w 1793"/>
                    <a:gd name="T71" fmla="*/ 14 h 16"/>
                    <a:gd name="T72" fmla="*/ 804 w 1793"/>
                    <a:gd name="T73" fmla="*/ 14 h 16"/>
                    <a:gd name="T74" fmla="*/ 841 w 1793"/>
                    <a:gd name="T75" fmla="*/ 14 h 16"/>
                    <a:gd name="T76" fmla="*/ 882 w 1793"/>
                    <a:gd name="T77" fmla="*/ 14 h 16"/>
                    <a:gd name="T78" fmla="*/ 920 w 1793"/>
                    <a:gd name="T79" fmla="*/ 14 h 16"/>
                    <a:gd name="T80" fmla="*/ 967 w 1793"/>
                    <a:gd name="T81" fmla="*/ 13 h 16"/>
                    <a:gd name="T82" fmla="*/ 1010 w 1793"/>
                    <a:gd name="T83" fmla="*/ 13 h 16"/>
                    <a:gd name="T84" fmla="*/ 1052 w 1793"/>
                    <a:gd name="T85" fmla="*/ 13 h 16"/>
                    <a:gd name="T86" fmla="*/ 1087 w 1793"/>
                    <a:gd name="T87" fmla="*/ 13 h 16"/>
                    <a:gd name="T88" fmla="*/ 1133 w 1793"/>
                    <a:gd name="T89" fmla="*/ 13 h 16"/>
                    <a:gd name="T90" fmla="*/ 1169 w 1793"/>
                    <a:gd name="T91" fmla="*/ 12 h 16"/>
                    <a:gd name="T92" fmla="*/ 1198 w 1793"/>
                    <a:gd name="T93" fmla="*/ 12 h 16"/>
                    <a:gd name="T94" fmla="*/ 1237 w 1793"/>
                    <a:gd name="T95" fmla="*/ 12 h 16"/>
                    <a:gd name="T96" fmla="*/ 1276 w 1793"/>
                    <a:gd name="T97" fmla="*/ 12 h 16"/>
                    <a:gd name="T98" fmla="*/ 1310 w 1793"/>
                    <a:gd name="T99" fmla="*/ 12 h 16"/>
                    <a:gd name="T100" fmla="*/ 1331 w 1793"/>
                    <a:gd name="T101" fmla="*/ 12 h 16"/>
                    <a:gd name="T102" fmla="*/ 1378 w 1793"/>
                    <a:gd name="T103" fmla="*/ 12 h 16"/>
                    <a:gd name="T104" fmla="*/ 1416 w 1793"/>
                    <a:gd name="T105" fmla="*/ 11 h 16"/>
                    <a:gd name="T106" fmla="*/ 1457 w 1793"/>
                    <a:gd name="T107" fmla="*/ 11 h 16"/>
                    <a:gd name="T108" fmla="*/ 1494 w 1793"/>
                    <a:gd name="T109" fmla="*/ 11 h 16"/>
                    <a:gd name="T110" fmla="*/ 1537 w 1793"/>
                    <a:gd name="T111" fmla="*/ 10 h 16"/>
                    <a:gd name="T112" fmla="*/ 1578 w 1793"/>
                    <a:gd name="T113" fmla="*/ 10 h 16"/>
                    <a:gd name="T114" fmla="*/ 1602 w 1793"/>
                    <a:gd name="T115" fmla="*/ 10 h 16"/>
                    <a:gd name="T116" fmla="*/ 1635 w 1793"/>
                    <a:gd name="T117" fmla="*/ 10 h 16"/>
                    <a:gd name="T118" fmla="*/ 1663 w 1793"/>
                    <a:gd name="T119" fmla="*/ 9 h 16"/>
                    <a:gd name="T120" fmla="*/ 1704 w 1793"/>
                    <a:gd name="T121" fmla="*/ 9 h 16"/>
                    <a:gd name="T122" fmla="*/ 1738 w 1793"/>
                    <a:gd name="T123" fmla="*/ 9 h 16"/>
                    <a:gd name="T124" fmla="*/ 1765 w 1793"/>
                    <a:gd name="T125" fmla="*/ 8 h 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  <a:cxn ang="0">
                      <a:pos x="T116" y="T117"/>
                    </a:cxn>
                    <a:cxn ang="0">
                      <a:pos x="T118" y="T119"/>
                    </a:cxn>
                    <a:cxn ang="0">
                      <a:pos x="T120" y="T121"/>
                    </a:cxn>
                    <a:cxn ang="0">
                      <a:pos x="T122" y="T123"/>
                    </a:cxn>
                    <a:cxn ang="0">
                      <a:pos x="T124" y="T125"/>
                    </a:cxn>
                  </a:cxnLst>
                  <a:rect l="0" t="0" r="r" b="b"/>
                  <a:pathLst>
                    <a:path w="1793" h="16">
                      <a:moveTo>
                        <a:pt x="0" y="0"/>
                      </a:moveTo>
                      <a:lnTo>
                        <a:pt x="1" y="0"/>
                      </a:lnTo>
                      <a:lnTo>
                        <a:pt x="2" y="0"/>
                      </a:lnTo>
                      <a:lnTo>
                        <a:pt x="2" y="1"/>
                      </a:lnTo>
                      <a:lnTo>
                        <a:pt x="2" y="1"/>
                      </a:lnTo>
                      <a:lnTo>
                        <a:pt x="3" y="1"/>
                      </a:lnTo>
                      <a:lnTo>
                        <a:pt x="4" y="1"/>
                      </a:lnTo>
                      <a:lnTo>
                        <a:pt x="4" y="1"/>
                      </a:lnTo>
                      <a:lnTo>
                        <a:pt x="5" y="2"/>
                      </a:lnTo>
                      <a:lnTo>
                        <a:pt x="5" y="2"/>
                      </a:lnTo>
                      <a:lnTo>
                        <a:pt x="6" y="2"/>
                      </a:lnTo>
                      <a:lnTo>
                        <a:pt x="7" y="2"/>
                      </a:lnTo>
                      <a:lnTo>
                        <a:pt x="7" y="2"/>
                      </a:lnTo>
                      <a:lnTo>
                        <a:pt x="8" y="2"/>
                      </a:lnTo>
                      <a:lnTo>
                        <a:pt x="8" y="2"/>
                      </a:lnTo>
                      <a:lnTo>
                        <a:pt x="9" y="2"/>
                      </a:lnTo>
                      <a:lnTo>
                        <a:pt x="9" y="3"/>
                      </a:lnTo>
                      <a:lnTo>
                        <a:pt x="10" y="3"/>
                      </a:lnTo>
                      <a:lnTo>
                        <a:pt x="11" y="3"/>
                      </a:lnTo>
                      <a:lnTo>
                        <a:pt x="11" y="3"/>
                      </a:lnTo>
                      <a:lnTo>
                        <a:pt x="12" y="3"/>
                      </a:lnTo>
                      <a:lnTo>
                        <a:pt x="13" y="3"/>
                      </a:lnTo>
                      <a:lnTo>
                        <a:pt x="13" y="3"/>
                      </a:lnTo>
                      <a:lnTo>
                        <a:pt x="14" y="3"/>
                      </a:lnTo>
                      <a:lnTo>
                        <a:pt x="15" y="3"/>
                      </a:lnTo>
                      <a:lnTo>
                        <a:pt x="16" y="3"/>
                      </a:lnTo>
                      <a:lnTo>
                        <a:pt x="17" y="3"/>
                      </a:lnTo>
                      <a:lnTo>
                        <a:pt x="19" y="3"/>
                      </a:lnTo>
                      <a:lnTo>
                        <a:pt x="20" y="4"/>
                      </a:lnTo>
                      <a:lnTo>
                        <a:pt x="22" y="4"/>
                      </a:lnTo>
                      <a:lnTo>
                        <a:pt x="22" y="4"/>
                      </a:lnTo>
                      <a:lnTo>
                        <a:pt x="23" y="4"/>
                      </a:lnTo>
                      <a:lnTo>
                        <a:pt x="24" y="4"/>
                      </a:lnTo>
                      <a:lnTo>
                        <a:pt x="25" y="4"/>
                      </a:lnTo>
                      <a:lnTo>
                        <a:pt x="26" y="4"/>
                      </a:lnTo>
                      <a:lnTo>
                        <a:pt x="27" y="4"/>
                      </a:lnTo>
                      <a:lnTo>
                        <a:pt x="28" y="4"/>
                      </a:lnTo>
                      <a:lnTo>
                        <a:pt x="29" y="4"/>
                      </a:lnTo>
                      <a:lnTo>
                        <a:pt x="30" y="4"/>
                      </a:lnTo>
                      <a:lnTo>
                        <a:pt x="31" y="5"/>
                      </a:lnTo>
                      <a:lnTo>
                        <a:pt x="32" y="5"/>
                      </a:lnTo>
                      <a:lnTo>
                        <a:pt x="33" y="5"/>
                      </a:lnTo>
                      <a:lnTo>
                        <a:pt x="34" y="6"/>
                      </a:lnTo>
                      <a:lnTo>
                        <a:pt x="35" y="6"/>
                      </a:lnTo>
                      <a:lnTo>
                        <a:pt x="38" y="6"/>
                      </a:lnTo>
                      <a:lnTo>
                        <a:pt x="40" y="7"/>
                      </a:lnTo>
                      <a:lnTo>
                        <a:pt x="41" y="7"/>
                      </a:lnTo>
                      <a:lnTo>
                        <a:pt x="43" y="8"/>
                      </a:lnTo>
                      <a:lnTo>
                        <a:pt x="44" y="8"/>
                      </a:lnTo>
                      <a:lnTo>
                        <a:pt x="45" y="8"/>
                      </a:lnTo>
                      <a:lnTo>
                        <a:pt x="47" y="8"/>
                      </a:lnTo>
                      <a:lnTo>
                        <a:pt x="48" y="9"/>
                      </a:lnTo>
                      <a:lnTo>
                        <a:pt x="50" y="9"/>
                      </a:lnTo>
                      <a:lnTo>
                        <a:pt x="51" y="9"/>
                      </a:lnTo>
                      <a:lnTo>
                        <a:pt x="52" y="9"/>
                      </a:lnTo>
                      <a:lnTo>
                        <a:pt x="53" y="9"/>
                      </a:lnTo>
                      <a:lnTo>
                        <a:pt x="54" y="9"/>
                      </a:lnTo>
                      <a:lnTo>
                        <a:pt x="54" y="9"/>
                      </a:lnTo>
                      <a:lnTo>
                        <a:pt x="54" y="9"/>
                      </a:lnTo>
                      <a:lnTo>
                        <a:pt x="55" y="9"/>
                      </a:lnTo>
                      <a:lnTo>
                        <a:pt x="57" y="10"/>
                      </a:lnTo>
                      <a:lnTo>
                        <a:pt x="57" y="10"/>
                      </a:lnTo>
                      <a:lnTo>
                        <a:pt x="59" y="10"/>
                      </a:lnTo>
                      <a:lnTo>
                        <a:pt x="60" y="10"/>
                      </a:lnTo>
                      <a:lnTo>
                        <a:pt x="61" y="10"/>
                      </a:lnTo>
                      <a:lnTo>
                        <a:pt x="62" y="10"/>
                      </a:lnTo>
                      <a:lnTo>
                        <a:pt x="64" y="10"/>
                      </a:lnTo>
                      <a:lnTo>
                        <a:pt x="65" y="10"/>
                      </a:lnTo>
                      <a:lnTo>
                        <a:pt x="66" y="10"/>
                      </a:lnTo>
                      <a:lnTo>
                        <a:pt x="67" y="11"/>
                      </a:lnTo>
                      <a:lnTo>
                        <a:pt x="69" y="11"/>
                      </a:lnTo>
                      <a:lnTo>
                        <a:pt x="70" y="11"/>
                      </a:lnTo>
                      <a:lnTo>
                        <a:pt x="71" y="11"/>
                      </a:lnTo>
                      <a:lnTo>
                        <a:pt x="73" y="11"/>
                      </a:lnTo>
                      <a:lnTo>
                        <a:pt x="74" y="11"/>
                      </a:lnTo>
                      <a:lnTo>
                        <a:pt x="76" y="11"/>
                      </a:lnTo>
                      <a:lnTo>
                        <a:pt x="78" y="11"/>
                      </a:lnTo>
                      <a:lnTo>
                        <a:pt x="80" y="11"/>
                      </a:lnTo>
                      <a:lnTo>
                        <a:pt x="84" y="11"/>
                      </a:lnTo>
                      <a:lnTo>
                        <a:pt x="86" y="11"/>
                      </a:lnTo>
                      <a:lnTo>
                        <a:pt x="89" y="11"/>
                      </a:lnTo>
                      <a:lnTo>
                        <a:pt x="91" y="12"/>
                      </a:lnTo>
                      <a:lnTo>
                        <a:pt x="92" y="12"/>
                      </a:lnTo>
                      <a:lnTo>
                        <a:pt x="93" y="12"/>
                      </a:lnTo>
                      <a:lnTo>
                        <a:pt x="94" y="12"/>
                      </a:lnTo>
                      <a:lnTo>
                        <a:pt x="95" y="12"/>
                      </a:lnTo>
                      <a:lnTo>
                        <a:pt x="96" y="12"/>
                      </a:lnTo>
                      <a:lnTo>
                        <a:pt x="97" y="12"/>
                      </a:lnTo>
                      <a:lnTo>
                        <a:pt x="98" y="12"/>
                      </a:lnTo>
                      <a:lnTo>
                        <a:pt x="99" y="12"/>
                      </a:lnTo>
                      <a:lnTo>
                        <a:pt x="99" y="12"/>
                      </a:lnTo>
                      <a:lnTo>
                        <a:pt x="100" y="12"/>
                      </a:lnTo>
                      <a:lnTo>
                        <a:pt x="101" y="12"/>
                      </a:lnTo>
                      <a:lnTo>
                        <a:pt x="103" y="12"/>
                      </a:lnTo>
                      <a:lnTo>
                        <a:pt x="105" y="12"/>
                      </a:lnTo>
                      <a:lnTo>
                        <a:pt x="106" y="12"/>
                      </a:lnTo>
                      <a:lnTo>
                        <a:pt x="108" y="12"/>
                      </a:lnTo>
                      <a:lnTo>
                        <a:pt x="110" y="12"/>
                      </a:lnTo>
                      <a:lnTo>
                        <a:pt x="112" y="13"/>
                      </a:lnTo>
                      <a:lnTo>
                        <a:pt x="115" y="13"/>
                      </a:lnTo>
                      <a:lnTo>
                        <a:pt x="117" y="13"/>
                      </a:lnTo>
                      <a:lnTo>
                        <a:pt x="119" y="13"/>
                      </a:lnTo>
                      <a:lnTo>
                        <a:pt x="120" y="13"/>
                      </a:lnTo>
                      <a:lnTo>
                        <a:pt x="122" y="13"/>
                      </a:lnTo>
                      <a:lnTo>
                        <a:pt x="124" y="13"/>
                      </a:lnTo>
                      <a:lnTo>
                        <a:pt x="126" y="13"/>
                      </a:lnTo>
                      <a:lnTo>
                        <a:pt x="127" y="14"/>
                      </a:lnTo>
                      <a:lnTo>
                        <a:pt x="130" y="14"/>
                      </a:lnTo>
                      <a:lnTo>
                        <a:pt x="132" y="14"/>
                      </a:lnTo>
                      <a:lnTo>
                        <a:pt x="134" y="14"/>
                      </a:lnTo>
                      <a:lnTo>
                        <a:pt x="137" y="14"/>
                      </a:lnTo>
                      <a:lnTo>
                        <a:pt x="139" y="14"/>
                      </a:lnTo>
                      <a:lnTo>
                        <a:pt x="140" y="14"/>
                      </a:lnTo>
                      <a:lnTo>
                        <a:pt x="141" y="14"/>
                      </a:lnTo>
                      <a:lnTo>
                        <a:pt x="142" y="14"/>
                      </a:lnTo>
                      <a:lnTo>
                        <a:pt x="144" y="14"/>
                      </a:lnTo>
                      <a:lnTo>
                        <a:pt x="146" y="14"/>
                      </a:lnTo>
                      <a:lnTo>
                        <a:pt x="148" y="14"/>
                      </a:lnTo>
                      <a:lnTo>
                        <a:pt x="150" y="14"/>
                      </a:lnTo>
                      <a:lnTo>
                        <a:pt x="152" y="14"/>
                      </a:lnTo>
                      <a:lnTo>
                        <a:pt x="154" y="14"/>
                      </a:lnTo>
                      <a:lnTo>
                        <a:pt x="156" y="14"/>
                      </a:lnTo>
                      <a:lnTo>
                        <a:pt x="159" y="14"/>
                      </a:lnTo>
                      <a:lnTo>
                        <a:pt x="163" y="14"/>
                      </a:lnTo>
                      <a:lnTo>
                        <a:pt x="167" y="15"/>
                      </a:lnTo>
                      <a:lnTo>
                        <a:pt x="170" y="15"/>
                      </a:lnTo>
                      <a:lnTo>
                        <a:pt x="172" y="15"/>
                      </a:lnTo>
                      <a:lnTo>
                        <a:pt x="176" y="15"/>
                      </a:lnTo>
                      <a:lnTo>
                        <a:pt x="178" y="15"/>
                      </a:lnTo>
                      <a:lnTo>
                        <a:pt x="180" y="15"/>
                      </a:lnTo>
                      <a:lnTo>
                        <a:pt x="181" y="15"/>
                      </a:lnTo>
                      <a:lnTo>
                        <a:pt x="182" y="15"/>
                      </a:lnTo>
                      <a:lnTo>
                        <a:pt x="183" y="15"/>
                      </a:lnTo>
                      <a:lnTo>
                        <a:pt x="184" y="15"/>
                      </a:lnTo>
                      <a:lnTo>
                        <a:pt x="185" y="15"/>
                      </a:lnTo>
                      <a:lnTo>
                        <a:pt x="187" y="15"/>
                      </a:lnTo>
                      <a:lnTo>
                        <a:pt x="191" y="15"/>
                      </a:lnTo>
                      <a:lnTo>
                        <a:pt x="194" y="15"/>
                      </a:lnTo>
                      <a:lnTo>
                        <a:pt x="197" y="15"/>
                      </a:lnTo>
                      <a:lnTo>
                        <a:pt x="199" y="16"/>
                      </a:lnTo>
                      <a:lnTo>
                        <a:pt x="201" y="16"/>
                      </a:lnTo>
                      <a:lnTo>
                        <a:pt x="203" y="16"/>
                      </a:lnTo>
                      <a:lnTo>
                        <a:pt x="206" y="16"/>
                      </a:lnTo>
                      <a:lnTo>
                        <a:pt x="208" y="16"/>
                      </a:lnTo>
                      <a:lnTo>
                        <a:pt x="210" y="16"/>
                      </a:lnTo>
                      <a:lnTo>
                        <a:pt x="213" y="16"/>
                      </a:lnTo>
                      <a:lnTo>
                        <a:pt x="216" y="16"/>
                      </a:lnTo>
                      <a:lnTo>
                        <a:pt x="218" y="16"/>
                      </a:lnTo>
                      <a:lnTo>
                        <a:pt x="221" y="16"/>
                      </a:lnTo>
                      <a:lnTo>
                        <a:pt x="224" y="16"/>
                      </a:lnTo>
                      <a:lnTo>
                        <a:pt x="226" y="16"/>
                      </a:lnTo>
                      <a:lnTo>
                        <a:pt x="228" y="16"/>
                      </a:lnTo>
                      <a:lnTo>
                        <a:pt x="230" y="16"/>
                      </a:lnTo>
                      <a:lnTo>
                        <a:pt x="233" y="16"/>
                      </a:lnTo>
                      <a:lnTo>
                        <a:pt x="236" y="16"/>
                      </a:lnTo>
                      <a:lnTo>
                        <a:pt x="239" y="16"/>
                      </a:lnTo>
                      <a:lnTo>
                        <a:pt x="242" y="16"/>
                      </a:lnTo>
                      <a:lnTo>
                        <a:pt x="246" y="16"/>
                      </a:lnTo>
                      <a:lnTo>
                        <a:pt x="250" y="16"/>
                      </a:lnTo>
                      <a:lnTo>
                        <a:pt x="254" y="16"/>
                      </a:lnTo>
                      <a:lnTo>
                        <a:pt x="258" y="16"/>
                      </a:lnTo>
                      <a:lnTo>
                        <a:pt x="261" y="16"/>
                      </a:lnTo>
                      <a:lnTo>
                        <a:pt x="264" y="16"/>
                      </a:lnTo>
                      <a:lnTo>
                        <a:pt x="267" y="16"/>
                      </a:lnTo>
                      <a:lnTo>
                        <a:pt x="269" y="16"/>
                      </a:lnTo>
                      <a:lnTo>
                        <a:pt x="270" y="16"/>
                      </a:lnTo>
                      <a:lnTo>
                        <a:pt x="272" y="16"/>
                      </a:lnTo>
                      <a:lnTo>
                        <a:pt x="273" y="16"/>
                      </a:lnTo>
                      <a:lnTo>
                        <a:pt x="276" y="16"/>
                      </a:lnTo>
                      <a:lnTo>
                        <a:pt x="278" y="16"/>
                      </a:lnTo>
                      <a:lnTo>
                        <a:pt x="280" y="16"/>
                      </a:lnTo>
                      <a:lnTo>
                        <a:pt x="282" y="16"/>
                      </a:lnTo>
                      <a:lnTo>
                        <a:pt x="284" y="16"/>
                      </a:lnTo>
                      <a:lnTo>
                        <a:pt x="287" y="16"/>
                      </a:lnTo>
                      <a:lnTo>
                        <a:pt x="289" y="16"/>
                      </a:lnTo>
                      <a:lnTo>
                        <a:pt x="292" y="16"/>
                      </a:lnTo>
                      <a:lnTo>
                        <a:pt x="296" y="16"/>
                      </a:lnTo>
                      <a:lnTo>
                        <a:pt x="300" y="16"/>
                      </a:lnTo>
                      <a:lnTo>
                        <a:pt x="303" y="16"/>
                      </a:lnTo>
                      <a:lnTo>
                        <a:pt x="305" y="16"/>
                      </a:lnTo>
                      <a:lnTo>
                        <a:pt x="308" y="16"/>
                      </a:lnTo>
                      <a:lnTo>
                        <a:pt x="311" y="16"/>
                      </a:lnTo>
                      <a:lnTo>
                        <a:pt x="314" y="16"/>
                      </a:lnTo>
                      <a:lnTo>
                        <a:pt x="316" y="16"/>
                      </a:lnTo>
                      <a:lnTo>
                        <a:pt x="318" y="16"/>
                      </a:lnTo>
                      <a:lnTo>
                        <a:pt x="321" y="16"/>
                      </a:lnTo>
                      <a:lnTo>
                        <a:pt x="324" y="16"/>
                      </a:lnTo>
                      <a:lnTo>
                        <a:pt x="328" y="16"/>
                      </a:lnTo>
                      <a:lnTo>
                        <a:pt x="332" y="16"/>
                      </a:lnTo>
                      <a:lnTo>
                        <a:pt x="336" y="16"/>
                      </a:lnTo>
                      <a:lnTo>
                        <a:pt x="339" y="15"/>
                      </a:lnTo>
                      <a:lnTo>
                        <a:pt x="344" y="15"/>
                      </a:lnTo>
                      <a:lnTo>
                        <a:pt x="349" y="15"/>
                      </a:lnTo>
                      <a:lnTo>
                        <a:pt x="353" y="15"/>
                      </a:lnTo>
                      <a:lnTo>
                        <a:pt x="357" y="15"/>
                      </a:lnTo>
                      <a:lnTo>
                        <a:pt x="359" y="15"/>
                      </a:lnTo>
                      <a:lnTo>
                        <a:pt x="361" y="15"/>
                      </a:lnTo>
                      <a:lnTo>
                        <a:pt x="363" y="15"/>
                      </a:lnTo>
                      <a:lnTo>
                        <a:pt x="366" y="15"/>
                      </a:lnTo>
                      <a:lnTo>
                        <a:pt x="370" y="15"/>
                      </a:lnTo>
                      <a:lnTo>
                        <a:pt x="374" y="15"/>
                      </a:lnTo>
                      <a:lnTo>
                        <a:pt x="377" y="15"/>
                      </a:lnTo>
                      <a:lnTo>
                        <a:pt x="380" y="15"/>
                      </a:lnTo>
                      <a:lnTo>
                        <a:pt x="383" y="15"/>
                      </a:lnTo>
                      <a:lnTo>
                        <a:pt x="386" y="15"/>
                      </a:lnTo>
                      <a:lnTo>
                        <a:pt x="391" y="15"/>
                      </a:lnTo>
                      <a:lnTo>
                        <a:pt x="397" y="15"/>
                      </a:lnTo>
                      <a:lnTo>
                        <a:pt x="400" y="15"/>
                      </a:lnTo>
                      <a:lnTo>
                        <a:pt x="402" y="15"/>
                      </a:lnTo>
                      <a:lnTo>
                        <a:pt x="405" y="15"/>
                      </a:lnTo>
                      <a:lnTo>
                        <a:pt x="408" y="15"/>
                      </a:lnTo>
                      <a:lnTo>
                        <a:pt x="412" y="15"/>
                      </a:lnTo>
                      <a:lnTo>
                        <a:pt x="417" y="15"/>
                      </a:lnTo>
                      <a:lnTo>
                        <a:pt x="423" y="15"/>
                      </a:lnTo>
                      <a:lnTo>
                        <a:pt x="428" y="15"/>
                      </a:lnTo>
                      <a:lnTo>
                        <a:pt x="433" y="15"/>
                      </a:lnTo>
                      <a:lnTo>
                        <a:pt x="436" y="15"/>
                      </a:lnTo>
                      <a:lnTo>
                        <a:pt x="440" y="15"/>
                      </a:lnTo>
                      <a:lnTo>
                        <a:pt x="443" y="15"/>
                      </a:lnTo>
                      <a:lnTo>
                        <a:pt x="447" y="15"/>
                      </a:lnTo>
                      <a:lnTo>
                        <a:pt x="451" y="15"/>
                      </a:lnTo>
                      <a:lnTo>
                        <a:pt x="454" y="15"/>
                      </a:lnTo>
                      <a:lnTo>
                        <a:pt x="457" y="15"/>
                      </a:lnTo>
                      <a:lnTo>
                        <a:pt x="459" y="15"/>
                      </a:lnTo>
                      <a:lnTo>
                        <a:pt x="462" y="15"/>
                      </a:lnTo>
                      <a:lnTo>
                        <a:pt x="465" y="15"/>
                      </a:lnTo>
                      <a:lnTo>
                        <a:pt x="468" y="15"/>
                      </a:lnTo>
                      <a:lnTo>
                        <a:pt x="472" y="15"/>
                      </a:lnTo>
                      <a:lnTo>
                        <a:pt x="476" y="15"/>
                      </a:lnTo>
                      <a:lnTo>
                        <a:pt x="480" y="15"/>
                      </a:lnTo>
                      <a:lnTo>
                        <a:pt x="484" y="15"/>
                      </a:lnTo>
                      <a:lnTo>
                        <a:pt x="487" y="15"/>
                      </a:lnTo>
                      <a:lnTo>
                        <a:pt x="489" y="15"/>
                      </a:lnTo>
                      <a:lnTo>
                        <a:pt x="491" y="15"/>
                      </a:lnTo>
                      <a:lnTo>
                        <a:pt x="494" y="15"/>
                      </a:lnTo>
                      <a:lnTo>
                        <a:pt x="496" y="15"/>
                      </a:lnTo>
                      <a:lnTo>
                        <a:pt x="499" y="15"/>
                      </a:lnTo>
                      <a:lnTo>
                        <a:pt x="504" y="15"/>
                      </a:lnTo>
                      <a:lnTo>
                        <a:pt x="509" y="15"/>
                      </a:lnTo>
                      <a:lnTo>
                        <a:pt x="515" y="15"/>
                      </a:lnTo>
                      <a:lnTo>
                        <a:pt x="522" y="15"/>
                      </a:lnTo>
                      <a:lnTo>
                        <a:pt x="529" y="15"/>
                      </a:lnTo>
                      <a:lnTo>
                        <a:pt x="531" y="15"/>
                      </a:lnTo>
                      <a:lnTo>
                        <a:pt x="533" y="14"/>
                      </a:lnTo>
                      <a:lnTo>
                        <a:pt x="536" y="14"/>
                      </a:lnTo>
                      <a:lnTo>
                        <a:pt x="539" y="14"/>
                      </a:lnTo>
                      <a:lnTo>
                        <a:pt x="542" y="14"/>
                      </a:lnTo>
                      <a:lnTo>
                        <a:pt x="546" y="14"/>
                      </a:lnTo>
                      <a:lnTo>
                        <a:pt x="550" y="14"/>
                      </a:lnTo>
                      <a:lnTo>
                        <a:pt x="554" y="14"/>
                      </a:lnTo>
                      <a:lnTo>
                        <a:pt x="558" y="14"/>
                      </a:lnTo>
                      <a:lnTo>
                        <a:pt x="563" y="14"/>
                      </a:lnTo>
                      <a:lnTo>
                        <a:pt x="569" y="14"/>
                      </a:lnTo>
                      <a:lnTo>
                        <a:pt x="574" y="14"/>
                      </a:lnTo>
                      <a:lnTo>
                        <a:pt x="579" y="14"/>
                      </a:lnTo>
                      <a:lnTo>
                        <a:pt x="582" y="14"/>
                      </a:lnTo>
                      <a:lnTo>
                        <a:pt x="586" y="14"/>
                      </a:lnTo>
                      <a:lnTo>
                        <a:pt x="589" y="14"/>
                      </a:lnTo>
                      <a:lnTo>
                        <a:pt x="595" y="14"/>
                      </a:lnTo>
                      <a:lnTo>
                        <a:pt x="602" y="14"/>
                      </a:lnTo>
                      <a:lnTo>
                        <a:pt x="611" y="14"/>
                      </a:lnTo>
                      <a:lnTo>
                        <a:pt x="618" y="14"/>
                      </a:lnTo>
                      <a:lnTo>
                        <a:pt x="623" y="14"/>
                      </a:lnTo>
                      <a:lnTo>
                        <a:pt x="627" y="14"/>
                      </a:lnTo>
                      <a:lnTo>
                        <a:pt x="632" y="14"/>
                      </a:lnTo>
                      <a:lnTo>
                        <a:pt x="637" y="14"/>
                      </a:lnTo>
                      <a:lnTo>
                        <a:pt x="642" y="14"/>
                      </a:lnTo>
                      <a:lnTo>
                        <a:pt x="646" y="14"/>
                      </a:lnTo>
                      <a:lnTo>
                        <a:pt x="651" y="14"/>
                      </a:lnTo>
                      <a:lnTo>
                        <a:pt x="657" y="14"/>
                      </a:lnTo>
                      <a:lnTo>
                        <a:pt x="662" y="14"/>
                      </a:lnTo>
                      <a:lnTo>
                        <a:pt x="665" y="14"/>
                      </a:lnTo>
                      <a:lnTo>
                        <a:pt x="668" y="14"/>
                      </a:lnTo>
                      <a:lnTo>
                        <a:pt x="671" y="14"/>
                      </a:lnTo>
                      <a:lnTo>
                        <a:pt x="674" y="14"/>
                      </a:lnTo>
                      <a:lnTo>
                        <a:pt x="677" y="14"/>
                      </a:lnTo>
                      <a:lnTo>
                        <a:pt x="679" y="14"/>
                      </a:lnTo>
                      <a:lnTo>
                        <a:pt x="683" y="14"/>
                      </a:lnTo>
                      <a:lnTo>
                        <a:pt x="689" y="14"/>
                      </a:lnTo>
                      <a:lnTo>
                        <a:pt x="696" y="14"/>
                      </a:lnTo>
                      <a:lnTo>
                        <a:pt x="702" y="14"/>
                      </a:lnTo>
                      <a:lnTo>
                        <a:pt x="708" y="14"/>
                      </a:lnTo>
                      <a:lnTo>
                        <a:pt x="715" y="14"/>
                      </a:lnTo>
                      <a:lnTo>
                        <a:pt x="723" y="14"/>
                      </a:lnTo>
                      <a:lnTo>
                        <a:pt x="735" y="14"/>
                      </a:lnTo>
                      <a:lnTo>
                        <a:pt x="743" y="14"/>
                      </a:lnTo>
                      <a:lnTo>
                        <a:pt x="748" y="14"/>
                      </a:lnTo>
                      <a:lnTo>
                        <a:pt x="753" y="14"/>
                      </a:lnTo>
                      <a:lnTo>
                        <a:pt x="757" y="14"/>
                      </a:lnTo>
                      <a:lnTo>
                        <a:pt x="761" y="14"/>
                      </a:lnTo>
                      <a:lnTo>
                        <a:pt x="765" y="14"/>
                      </a:lnTo>
                      <a:lnTo>
                        <a:pt x="770" y="14"/>
                      </a:lnTo>
                      <a:lnTo>
                        <a:pt x="779" y="14"/>
                      </a:lnTo>
                      <a:lnTo>
                        <a:pt x="788" y="14"/>
                      </a:lnTo>
                      <a:lnTo>
                        <a:pt x="796" y="14"/>
                      </a:lnTo>
                      <a:lnTo>
                        <a:pt x="804" y="14"/>
                      </a:lnTo>
                      <a:lnTo>
                        <a:pt x="809" y="14"/>
                      </a:lnTo>
                      <a:lnTo>
                        <a:pt x="814" y="14"/>
                      </a:lnTo>
                      <a:lnTo>
                        <a:pt x="818" y="14"/>
                      </a:lnTo>
                      <a:lnTo>
                        <a:pt x="823" y="14"/>
                      </a:lnTo>
                      <a:lnTo>
                        <a:pt x="828" y="14"/>
                      </a:lnTo>
                      <a:lnTo>
                        <a:pt x="834" y="14"/>
                      </a:lnTo>
                      <a:lnTo>
                        <a:pt x="837" y="14"/>
                      </a:lnTo>
                      <a:lnTo>
                        <a:pt x="841" y="14"/>
                      </a:lnTo>
                      <a:lnTo>
                        <a:pt x="846" y="14"/>
                      </a:lnTo>
                      <a:lnTo>
                        <a:pt x="852" y="14"/>
                      </a:lnTo>
                      <a:lnTo>
                        <a:pt x="858" y="14"/>
                      </a:lnTo>
                      <a:lnTo>
                        <a:pt x="865" y="14"/>
                      </a:lnTo>
                      <a:lnTo>
                        <a:pt x="872" y="14"/>
                      </a:lnTo>
                      <a:lnTo>
                        <a:pt x="876" y="14"/>
                      </a:lnTo>
                      <a:lnTo>
                        <a:pt x="879" y="14"/>
                      </a:lnTo>
                      <a:lnTo>
                        <a:pt x="882" y="14"/>
                      </a:lnTo>
                      <a:lnTo>
                        <a:pt x="885" y="14"/>
                      </a:lnTo>
                      <a:lnTo>
                        <a:pt x="888" y="14"/>
                      </a:lnTo>
                      <a:lnTo>
                        <a:pt x="892" y="14"/>
                      </a:lnTo>
                      <a:lnTo>
                        <a:pt x="896" y="14"/>
                      </a:lnTo>
                      <a:lnTo>
                        <a:pt x="901" y="14"/>
                      </a:lnTo>
                      <a:lnTo>
                        <a:pt x="907" y="14"/>
                      </a:lnTo>
                      <a:lnTo>
                        <a:pt x="914" y="14"/>
                      </a:lnTo>
                      <a:lnTo>
                        <a:pt x="920" y="14"/>
                      </a:lnTo>
                      <a:lnTo>
                        <a:pt x="925" y="14"/>
                      </a:lnTo>
                      <a:lnTo>
                        <a:pt x="930" y="14"/>
                      </a:lnTo>
                      <a:lnTo>
                        <a:pt x="935" y="14"/>
                      </a:lnTo>
                      <a:lnTo>
                        <a:pt x="942" y="13"/>
                      </a:lnTo>
                      <a:lnTo>
                        <a:pt x="951" y="13"/>
                      </a:lnTo>
                      <a:lnTo>
                        <a:pt x="959" y="13"/>
                      </a:lnTo>
                      <a:lnTo>
                        <a:pt x="964" y="13"/>
                      </a:lnTo>
                      <a:lnTo>
                        <a:pt x="967" y="13"/>
                      </a:lnTo>
                      <a:lnTo>
                        <a:pt x="969" y="13"/>
                      </a:lnTo>
                      <a:lnTo>
                        <a:pt x="972" y="13"/>
                      </a:lnTo>
                      <a:lnTo>
                        <a:pt x="977" y="13"/>
                      </a:lnTo>
                      <a:lnTo>
                        <a:pt x="981" y="13"/>
                      </a:lnTo>
                      <a:lnTo>
                        <a:pt x="989" y="13"/>
                      </a:lnTo>
                      <a:lnTo>
                        <a:pt x="999" y="13"/>
                      </a:lnTo>
                      <a:lnTo>
                        <a:pt x="1006" y="13"/>
                      </a:lnTo>
                      <a:lnTo>
                        <a:pt x="1010" y="13"/>
                      </a:lnTo>
                      <a:lnTo>
                        <a:pt x="1012" y="13"/>
                      </a:lnTo>
                      <a:lnTo>
                        <a:pt x="1015" y="13"/>
                      </a:lnTo>
                      <a:lnTo>
                        <a:pt x="1019" y="13"/>
                      </a:lnTo>
                      <a:lnTo>
                        <a:pt x="1025" y="13"/>
                      </a:lnTo>
                      <a:lnTo>
                        <a:pt x="1034" y="13"/>
                      </a:lnTo>
                      <a:lnTo>
                        <a:pt x="1041" y="13"/>
                      </a:lnTo>
                      <a:lnTo>
                        <a:pt x="1048" y="13"/>
                      </a:lnTo>
                      <a:lnTo>
                        <a:pt x="1052" y="13"/>
                      </a:lnTo>
                      <a:lnTo>
                        <a:pt x="1055" y="13"/>
                      </a:lnTo>
                      <a:lnTo>
                        <a:pt x="1058" y="13"/>
                      </a:lnTo>
                      <a:lnTo>
                        <a:pt x="1061" y="13"/>
                      </a:lnTo>
                      <a:lnTo>
                        <a:pt x="1065" y="13"/>
                      </a:lnTo>
                      <a:lnTo>
                        <a:pt x="1068" y="13"/>
                      </a:lnTo>
                      <a:lnTo>
                        <a:pt x="1071" y="13"/>
                      </a:lnTo>
                      <a:lnTo>
                        <a:pt x="1077" y="13"/>
                      </a:lnTo>
                      <a:lnTo>
                        <a:pt x="1087" y="13"/>
                      </a:lnTo>
                      <a:lnTo>
                        <a:pt x="1094" y="13"/>
                      </a:lnTo>
                      <a:lnTo>
                        <a:pt x="1097" y="13"/>
                      </a:lnTo>
                      <a:lnTo>
                        <a:pt x="1101" y="13"/>
                      </a:lnTo>
                      <a:lnTo>
                        <a:pt x="1105" y="13"/>
                      </a:lnTo>
                      <a:lnTo>
                        <a:pt x="1110" y="13"/>
                      </a:lnTo>
                      <a:lnTo>
                        <a:pt x="1116" y="13"/>
                      </a:lnTo>
                      <a:lnTo>
                        <a:pt x="1125" y="13"/>
                      </a:lnTo>
                      <a:lnTo>
                        <a:pt x="1133" y="13"/>
                      </a:lnTo>
                      <a:lnTo>
                        <a:pt x="1138" y="13"/>
                      </a:lnTo>
                      <a:lnTo>
                        <a:pt x="1142" y="13"/>
                      </a:lnTo>
                      <a:lnTo>
                        <a:pt x="1146" y="13"/>
                      </a:lnTo>
                      <a:lnTo>
                        <a:pt x="1151" y="13"/>
                      </a:lnTo>
                      <a:lnTo>
                        <a:pt x="1156" y="12"/>
                      </a:lnTo>
                      <a:lnTo>
                        <a:pt x="1159" y="12"/>
                      </a:lnTo>
                      <a:lnTo>
                        <a:pt x="1164" y="12"/>
                      </a:lnTo>
                      <a:lnTo>
                        <a:pt x="1169" y="12"/>
                      </a:lnTo>
                      <a:lnTo>
                        <a:pt x="1175" y="12"/>
                      </a:lnTo>
                      <a:lnTo>
                        <a:pt x="1181" y="12"/>
                      </a:lnTo>
                      <a:lnTo>
                        <a:pt x="1185" y="12"/>
                      </a:lnTo>
                      <a:lnTo>
                        <a:pt x="1187" y="12"/>
                      </a:lnTo>
                      <a:lnTo>
                        <a:pt x="1189" y="12"/>
                      </a:lnTo>
                      <a:lnTo>
                        <a:pt x="1191" y="12"/>
                      </a:lnTo>
                      <a:lnTo>
                        <a:pt x="1194" y="12"/>
                      </a:lnTo>
                      <a:lnTo>
                        <a:pt x="1198" y="12"/>
                      </a:lnTo>
                      <a:lnTo>
                        <a:pt x="1201" y="12"/>
                      </a:lnTo>
                      <a:lnTo>
                        <a:pt x="1206" y="12"/>
                      </a:lnTo>
                      <a:lnTo>
                        <a:pt x="1212" y="12"/>
                      </a:lnTo>
                      <a:lnTo>
                        <a:pt x="1218" y="12"/>
                      </a:lnTo>
                      <a:lnTo>
                        <a:pt x="1223" y="12"/>
                      </a:lnTo>
                      <a:lnTo>
                        <a:pt x="1227" y="12"/>
                      </a:lnTo>
                      <a:lnTo>
                        <a:pt x="1231" y="12"/>
                      </a:lnTo>
                      <a:lnTo>
                        <a:pt x="1237" y="12"/>
                      </a:lnTo>
                      <a:lnTo>
                        <a:pt x="1242" y="12"/>
                      </a:lnTo>
                      <a:lnTo>
                        <a:pt x="1248" y="12"/>
                      </a:lnTo>
                      <a:lnTo>
                        <a:pt x="1254" y="12"/>
                      </a:lnTo>
                      <a:lnTo>
                        <a:pt x="1259" y="12"/>
                      </a:lnTo>
                      <a:lnTo>
                        <a:pt x="1263" y="12"/>
                      </a:lnTo>
                      <a:lnTo>
                        <a:pt x="1268" y="12"/>
                      </a:lnTo>
                      <a:lnTo>
                        <a:pt x="1272" y="12"/>
                      </a:lnTo>
                      <a:lnTo>
                        <a:pt x="1276" y="12"/>
                      </a:lnTo>
                      <a:lnTo>
                        <a:pt x="1280" y="12"/>
                      </a:lnTo>
                      <a:lnTo>
                        <a:pt x="1283" y="12"/>
                      </a:lnTo>
                      <a:lnTo>
                        <a:pt x="1288" y="12"/>
                      </a:lnTo>
                      <a:lnTo>
                        <a:pt x="1292" y="12"/>
                      </a:lnTo>
                      <a:lnTo>
                        <a:pt x="1296" y="12"/>
                      </a:lnTo>
                      <a:lnTo>
                        <a:pt x="1301" y="12"/>
                      </a:lnTo>
                      <a:lnTo>
                        <a:pt x="1305" y="12"/>
                      </a:lnTo>
                      <a:lnTo>
                        <a:pt x="1310" y="12"/>
                      </a:lnTo>
                      <a:lnTo>
                        <a:pt x="1314" y="12"/>
                      </a:lnTo>
                      <a:lnTo>
                        <a:pt x="1317" y="12"/>
                      </a:lnTo>
                      <a:lnTo>
                        <a:pt x="1318" y="12"/>
                      </a:lnTo>
                      <a:lnTo>
                        <a:pt x="1321" y="12"/>
                      </a:lnTo>
                      <a:lnTo>
                        <a:pt x="1323" y="12"/>
                      </a:lnTo>
                      <a:lnTo>
                        <a:pt x="1326" y="12"/>
                      </a:lnTo>
                      <a:lnTo>
                        <a:pt x="1328" y="12"/>
                      </a:lnTo>
                      <a:lnTo>
                        <a:pt x="1331" y="12"/>
                      </a:lnTo>
                      <a:lnTo>
                        <a:pt x="1334" y="12"/>
                      </a:lnTo>
                      <a:lnTo>
                        <a:pt x="1339" y="12"/>
                      </a:lnTo>
                      <a:lnTo>
                        <a:pt x="1346" y="12"/>
                      </a:lnTo>
                      <a:lnTo>
                        <a:pt x="1354" y="12"/>
                      </a:lnTo>
                      <a:lnTo>
                        <a:pt x="1359" y="12"/>
                      </a:lnTo>
                      <a:lnTo>
                        <a:pt x="1364" y="12"/>
                      </a:lnTo>
                      <a:lnTo>
                        <a:pt x="1370" y="12"/>
                      </a:lnTo>
                      <a:lnTo>
                        <a:pt x="1378" y="12"/>
                      </a:lnTo>
                      <a:lnTo>
                        <a:pt x="1386" y="12"/>
                      </a:lnTo>
                      <a:lnTo>
                        <a:pt x="1394" y="11"/>
                      </a:lnTo>
                      <a:lnTo>
                        <a:pt x="1399" y="11"/>
                      </a:lnTo>
                      <a:lnTo>
                        <a:pt x="1402" y="11"/>
                      </a:lnTo>
                      <a:lnTo>
                        <a:pt x="1405" y="11"/>
                      </a:lnTo>
                      <a:lnTo>
                        <a:pt x="1408" y="11"/>
                      </a:lnTo>
                      <a:lnTo>
                        <a:pt x="1411" y="11"/>
                      </a:lnTo>
                      <a:lnTo>
                        <a:pt x="1416" y="11"/>
                      </a:lnTo>
                      <a:lnTo>
                        <a:pt x="1420" y="11"/>
                      </a:lnTo>
                      <a:lnTo>
                        <a:pt x="1425" y="11"/>
                      </a:lnTo>
                      <a:lnTo>
                        <a:pt x="1430" y="11"/>
                      </a:lnTo>
                      <a:lnTo>
                        <a:pt x="1437" y="11"/>
                      </a:lnTo>
                      <a:lnTo>
                        <a:pt x="1443" y="11"/>
                      </a:lnTo>
                      <a:lnTo>
                        <a:pt x="1446" y="11"/>
                      </a:lnTo>
                      <a:lnTo>
                        <a:pt x="1450" y="11"/>
                      </a:lnTo>
                      <a:lnTo>
                        <a:pt x="1457" y="11"/>
                      </a:lnTo>
                      <a:lnTo>
                        <a:pt x="1463" y="11"/>
                      </a:lnTo>
                      <a:lnTo>
                        <a:pt x="1468" y="11"/>
                      </a:lnTo>
                      <a:lnTo>
                        <a:pt x="1473" y="11"/>
                      </a:lnTo>
                      <a:lnTo>
                        <a:pt x="1479" y="11"/>
                      </a:lnTo>
                      <a:lnTo>
                        <a:pt x="1484" y="11"/>
                      </a:lnTo>
                      <a:lnTo>
                        <a:pt x="1488" y="11"/>
                      </a:lnTo>
                      <a:lnTo>
                        <a:pt x="1491" y="11"/>
                      </a:lnTo>
                      <a:lnTo>
                        <a:pt x="1494" y="11"/>
                      </a:lnTo>
                      <a:lnTo>
                        <a:pt x="1498" y="11"/>
                      </a:lnTo>
                      <a:lnTo>
                        <a:pt x="1507" y="11"/>
                      </a:lnTo>
                      <a:lnTo>
                        <a:pt x="1520" y="11"/>
                      </a:lnTo>
                      <a:lnTo>
                        <a:pt x="1529" y="10"/>
                      </a:lnTo>
                      <a:lnTo>
                        <a:pt x="1532" y="10"/>
                      </a:lnTo>
                      <a:lnTo>
                        <a:pt x="1534" y="10"/>
                      </a:lnTo>
                      <a:lnTo>
                        <a:pt x="1535" y="10"/>
                      </a:lnTo>
                      <a:lnTo>
                        <a:pt x="1537" y="10"/>
                      </a:lnTo>
                      <a:lnTo>
                        <a:pt x="1541" y="10"/>
                      </a:lnTo>
                      <a:lnTo>
                        <a:pt x="1545" y="10"/>
                      </a:lnTo>
                      <a:lnTo>
                        <a:pt x="1551" y="10"/>
                      </a:lnTo>
                      <a:lnTo>
                        <a:pt x="1562" y="10"/>
                      </a:lnTo>
                      <a:lnTo>
                        <a:pt x="1571" y="10"/>
                      </a:lnTo>
                      <a:lnTo>
                        <a:pt x="1573" y="10"/>
                      </a:lnTo>
                      <a:lnTo>
                        <a:pt x="1576" y="10"/>
                      </a:lnTo>
                      <a:lnTo>
                        <a:pt x="1578" y="10"/>
                      </a:lnTo>
                      <a:lnTo>
                        <a:pt x="1580" y="10"/>
                      </a:lnTo>
                      <a:lnTo>
                        <a:pt x="1583" y="10"/>
                      </a:lnTo>
                      <a:lnTo>
                        <a:pt x="1587" y="10"/>
                      </a:lnTo>
                      <a:lnTo>
                        <a:pt x="1590" y="10"/>
                      </a:lnTo>
                      <a:lnTo>
                        <a:pt x="1593" y="10"/>
                      </a:lnTo>
                      <a:lnTo>
                        <a:pt x="1596" y="10"/>
                      </a:lnTo>
                      <a:lnTo>
                        <a:pt x="1599" y="10"/>
                      </a:lnTo>
                      <a:lnTo>
                        <a:pt x="1602" y="10"/>
                      </a:lnTo>
                      <a:lnTo>
                        <a:pt x="1605" y="10"/>
                      </a:lnTo>
                      <a:lnTo>
                        <a:pt x="1611" y="10"/>
                      </a:lnTo>
                      <a:lnTo>
                        <a:pt x="1616" y="10"/>
                      </a:lnTo>
                      <a:lnTo>
                        <a:pt x="1620" y="10"/>
                      </a:lnTo>
                      <a:lnTo>
                        <a:pt x="1622" y="10"/>
                      </a:lnTo>
                      <a:lnTo>
                        <a:pt x="1626" y="10"/>
                      </a:lnTo>
                      <a:lnTo>
                        <a:pt x="1630" y="10"/>
                      </a:lnTo>
                      <a:lnTo>
                        <a:pt x="1635" y="10"/>
                      </a:lnTo>
                      <a:lnTo>
                        <a:pt x="1640" y="10"/>
                      </a:lnTo>
                      <a:lnTo>
                        <a:pt x="1645" y="10"/>
                      </a:lnTo>
                      <a:lnTo>
                        <a:pt x="1650" y="9"/>
                      </a:lnTo>
                      <a:lnTo>
                        <a:pt x="1653" y="9"/>
                      </a:lnTo>
                      <a:lnTo>
                        <a:pt x="1657" y="9"/>
                      </a:lnTo>
                      <a:lnTo>
                        <a:pt x="1659" y="9"/>
                      </a:lnTo>
                      <a:lnTo>
                        <a:pt x="1661" y="9"/>
                      </a:lnTo>
                      <a:lnTo>
                        <a:pt x="1663" y="9"/>
                      </a:lnTo>
                      <a:lnTo>
                        <a:pt x="1666" y="9"/>
                      </a:lnTo>
                      <a:lnTo>
                        <a:pt x="1671" y="9"/>
                      </a:lnTo>
                      <a:lnTo>
                        <a:pt x="1676" y="9"/>
                      </a:lnTo>
                      <a:lnTo>
                        <a:pt x="1683" y="9"/>
                      </a:lnTo>
                      <a:lnTo>
                        <a:pt x="1689" y="9"/>
                      </a:lnTo>
                      <a:lnTo>
                        <a:pt x="1695" y="9"/>
                      </a:lnTo>
                      <a:lnTo>
                        <a:pt x="1700" y="9"/>
                      </a:lnTo>
                      <a:lnTo>
                        <a:pt x="1704" y="9"/>
                      </a:lnTo>
                      <a:lnTo>
                        <a:pt x="1707" y="9"/>
                      </a:lnTo>
                      <a:lnTo>
                        <a:pt x="1710" y="9"/>
                      </a:lnTo>
                      <a:lnTo>
                        <a:pt x="1714" y="9"/>
                      </a:lnTo>
                      <a:lnTo>
                        <a:pt x="1718" y="9"/>
                      </a:lnTo>
                      <a:lnTo>
                        <a:pt x="1722" y="9"/>
                      </a:lnTo>
                      <a:lnTo>
                        <a:pt x="1727" y="9"/>
                      </a:lnTo>
                      <a:lnTo>
                        <a:pt x="1733" y="9"/>
                      </a:lnTo>
                      <a:lnTo>
                        <a:pt x="1738" y="9"/>
                      </a:lnTo>
                      <a:lnTo>
                        <a:pt x="1743" y="9"/>
                      </a:lnTo>
                      <a:lnTo>
                        <a:pt x="1747" y="9"/>
                      </a:lnTo>
                      <a:lnTo>
                        <a:pt x="1749" y="9"/>
                      </a:lnTo>
                      <a:lnTo>
                        <a:pt x="1751" y="9"/>
                      </a:lnTo>
                      <a:lnTo>
                        <a:pt x="1752" y="8"/>
                      </a:lnTo>
                      <a:lnTo>
                        <a:pt x="1756" y="8"/>
                      </a:lnTo>
                      <a:lnTo>
                        <a:pt x="1761" y="8"/>
                      </a:lnTo>
                      <a:lnTo>
                        <a:pt x="1765" y="8"/>
                      </a:lnTo>
                      <a:lnTo>
                        <a:pt x="1768" y="8"/>
                      </a:lnTo>
                      <a:lnTo>
                        <a:pt x="1772" y="8"/>
                      </a:lnTo>
                      <a:lnTo>
                        <a:pt x="1776" y="8"/>
                      </a:lnTo>
                      <a:lnTo>
                        <a:pt x="1781" y="8"/>
                      </a:lnTo>
                      <a:lnTo>
                        <a:pt x="1786" y="7"/>
                      </a:lnTo>
                      <a:lnTo>
                        <a:pt x="1790" y="7"/>
                      </a:lnTo>
                      <a:lnTo>
                        <a:pt x="1793" y="7"/>
                      </a:lnTo>
                    </a:path>
                  </a:pathLst>
                </a:cu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3" name="Freeform 308"/>
                <p:cNvSpPr>
                  <a:spLocks/>
                </p:cNvSpPr>
                <p:nvPr/>
              </p:nvSpPr>
              <p:spPr bwMode="auto">
                <a:xfrm>
                  <a:off x="5026025" y="4670426"/>
                  <a:ext cx="719138" cy="1757363"/>
                </a:xfrm>
                <a:custGeom>
                  <a:avLst/>
                  <a:gdLst>
                    <a:gd name="T0" fmla="*/ 15 w 453"/>
                    <a:gd name="T1" fmla="*/ 1107 h 1107"/>
                    <a:gd name="T2" fmla="*/ 43 w 453"/>
                    <a:gd name="T3" fmla="*/ 1107 h 1107"/>
                    <a:gd name="T4" fmla="*/ 66 w 453"/>
                    <a:gd name="T5" fmla="*/ 1107 h 1107"/>
                    <a:gd name="T6" fmla="*/ 94 w 453"/>
                    <a:gd name="T7" fmla="*/ 1107 h 1107"/>
                    <a:gd name="T8" fmla="*/ 130 w 453"/>
                    <a:gd name="T9" fmla="*/ 1106 h 1107"/>
                    <a:gd name="T10" fmla="*/ 160 w 453"/>
                    <a:gd name="T11" fmla="*/ 1105 h 1107"/>
                    <a:gd name="T12" fmla="*/ 174 w 453"/>
                    <a:gd name="T13" fmla="*/ 1104 h 1107"/>
                    <a:gd name="T14" fmla="*/ 189 w 453"/>
                    <a:gd name="T15" fmla="*/ 1103 h 1107"/>
                    <a:gd name="T16" fmla="*/ 211 w 453"/>
                    <a:gd name="T17" fmla="*/ 1102 h 1107"/>
                    <a:gd name="T18" fmla="*/ 225 w 453"/>
                    <a:gd name="T19" fmla="*/ 1102 h 1107"/>
                    <a:gd name="T20" fmla="*/ 237 w 453"/>
                    <a:gd name="T21" fmla="*/ 1101 h 1107"/>
                    <a:gd name="T22" fmla="*/ 247 w 453"/>
                    <a:gd name="T23" fmla="*/ 1100 h 1107"/>
                    <a:gd name="T24" fmla="*/ 259 w 453"/>
                    <a:gd name="T25" fmla="*/ 1099 h 1107"/>
                    <a:gd name="T26" fmla="*/ 278 w 453"/>
                    <a:gd name="T27" fmla="*/ 1096 h 1107"/>
                    <a:gd name="T28" fmla="*/ 293 w 453"/>
                    <a:gd name="T29" fmla="*/ 1095 h 1107"/>
                    <a:gd name="T30" fmla="*/ 304 w 453"/>
                    <a:gd name="T31" fmla="*/ 1095 h 1107"/>
                    <a:gd name="T32" fmla="*/ 326 w 453"/>
                    <a:gd name="T33" fmla="*/ 1092 h 1107"/>
                    <a:gd name="T34" fmla="*/ 345 w 453"/>
                    <a:gd name="T35" fmla="*/ 1089 h 1107"/>
                    <a:gd name="T36" fmla="*/ 347 w 453"/>
                    <a:gd name="T37" fmla="*/ 1089 h 1107"/>
                    <a:gd name="T38" fmla="*/ 356 w 453"/>
                    <a:gd name="T39" fmla="*/ 1087 h 1107"/>
                    <a:gd name="T40" fmla="*/ 362 w 453"/>
                    <a:gd name="T41" fmla="*/ 1085 h 1107"/>
                    <a:gd name="T42" fmla="*/ 365 w 453"/>
                    <a:gd name="T43" fmla="*/ 1083 h 1107"/>
                    <a:gd name="T44" fmla="*/ 368 w 453"/>
                    <a:gd name="T45" fmla="*/ 1081 h 1107"/>
                    <a:gd name="T46" fmla="*/ 370 w 453"/>
                    <a:gd name="T47" fmla="*/ 1076 h 1107"/>
                    <a:gd name="T48" fmla="*/ 373 w 453"/>
                    <a:gd name="T49" fmla="*/ 1069 h 1107"/>
                    <a:gd name="T50" fmla="*/ 376 w 453"/>
                    <a:gd name="T51" fmla="*/ 1060 h 1107"/>
                    <a:gd name="T52" fmla="*/ 379 w 453"/>
                    <a:gd name="T53" fmla="*/ 1047 h 1107"/>
                    <a:gd name="T54" fmla="*/ 382 w 453"/>
                    <a:gd name="T55" fmla="*/ 1029 h 1107"/>
                    <a:gd name="T56" fmla="*/ 386 w 453"/>
                    <a:gd name="T57" fmla="*/ 1008 h 1107"/>
                    <a:gd name="T58" fmla="*/ 387 w 453"/>
                    <a:gd name="T59" fmla="*/ 994 h 1107"/>
                    <a:gd name="T60" fmla="*/ 388 w 453"/>
                    <a:gd name="T61" fmla="*/ 987 h 1107"/>
                    <a:gd name="T62" fmla="*/ 390 w 453"/>
                    <a:gd name="T63" fmla="*/ 970 h 1107"/>
                    <a:gd name="T64" fmla="*/ 391 w 453"/>
                    <a:gd name="T65" fmla="*/ 948 h 1107"/>
                    <a:gd name="T66" fmla="*/ 393 w 453"/>
                    <a:gd name="T67" fmla="*/ 916 h 1107"/>
                    <a:gd name="T68" fmla="*/ 395 w 453"/>
                    <a:gd name="T69" fmla="*/ 876 h 1107"/>
                    <a:gd name="T70" fmla="*/ 396 w 453"/>
                    <a:gd name="T71" fmla="*/ 835 h 1107"/>
                    <a:gd name="T72" fmla="*/ 397 w 453"/>
                    <a:gd name="T73" fmla="*/ 785 h 1107"/>
                    <a:gd name="T74" fmla="*/ 399 w 453"/>
                    <a:gd name="T75" fmla="*/ 713 h 1107"/>
                    <a:gd name="T76" fmla="*/ 401 w 453"/>
                    <a:gd name="T77" fmla="*/ 625 h 1107"/>
                    <a:gd name="T78" fmla="*/ 404 w 453"/>
                    <a:gd name="T79" fmla="*/ 465 h 1107"/>
                    <a:gd name="T80" fmla="*/ 407 w 453"/>
                    <a:gd name="T81" fmla="*/ 310 h 1107"/>
                    <a:gd name="T82" fmla="*/ 408 w 453"/>
                    <a:gd name="T83" fmla="*/ 222 h 1107"/>
                    <a:gd name="T84" fmla="*/ 410 w 453"/>
                    <a:gd name="T85" fmla="*/ 155 h 1107"/>
                    <a:gd name="T86" fmla="*/ 411 w 453"/>
                    <a:gd name="T87" fmla="*/ 105 h 1107"/>
                    <a:gd name="T88" fmla="*/ 413 w 453"/>
                    <a:gd name="T89" fmla="*/ 64 h 1107"/>
                    <a:gd name="T90" fmla="*/ 414 w 453"/>
                    <a:gd name="T91" fmla="*/ 33 h 1107"/>
                    <a:gd name="T92" fmla="*/ 415 w 453"/>
                    <a:gd name="T93" fmla="*/ 12 h 1107"/>
                    <a:gd name="T94" fmla="*/ 417 w 453"/>
                    <a:gd name="T95" fmla="*/ 1 h 1107"/>
                    <a:gd name="T96" fmla="*/ 418 w 453"/>
                    <a:gd name="T97" fmla="*/ 0 h 1107"/>
                    <a:gd name="T98" fmla="*/ 420 w 453"/>
                    <a:gd name="T99" fmla="*/ 9 h 1107"/>
                    <a:gd name="T100" fmla="*/ 421 w 453"/>
                    <a:gd name="T101" fmla="*/ 26 h 1107"/>
                    <a:gd name="T102" fmla="*/ 422 w 453"/>
                    <a:gd name="T103" fmla="*/ 57 h 1107"/>
                    <a:gd name="T104" fmla="*/ 425 w 453"/>
                    <a:gd name="T105" fmla="*/ 101 h 1107"/>
                    <a:gd name="T106" fmla="*/ 427 w 453"/>
                    <a:gd name="T107" fmla="*/ 166 h 1107"/>
                    <a:gd name="T108" fmla="*/ 430 w 453"/>
                    <a:gd name="T109" fmla="*/ 285 h 1107"/>
                    <a:gd name="T110" fmla="*/ 432 w 453"/>
                    <a:gd name="T111" fmla="*/ 321 h 1107"/>
                    <a:gd name="T112" fmla="*/ 433 w 453"/>
                    <a:gd name="T113" fmla="*/ 364 h 1107"/>
                    <a:gd name="T114" fmla="*/ 436 w 453"/>
                    <a:gd name="T115" fmla="*/ 469 h 1107"/>
                    <a:gd name="T116" fmla="*/ 439 w 453"/>
                    <a:gd name="T117" fmla="*/ 550 h 1107"/>
                    <a:gd name="T118" fmla="*/ 442 w 453"/>
                    <a:gd name="T119" fmla="*/ 615 h 1107"/>
                    <a:gd name="T120" fmla="*/ 445 w 453"/>
                    <a:gd name="T121" fmla="*/ 671 h 1107"/>
                    <a:gd name="T122" fmla="*/ 447 w 453"/>
                    <a:gd name="T123" fmla="*/ 718 h 1107"/>
                    <a:gd name="T124" fmla="*/ 450 w 453"/>
                    <a:gd name="T125" fmla="*/ 759 h 11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  <a:cxn ang="0">
                      <a:pos x="T116" y="T117"/>
                    </a:cxn>
                    <a:cxn ang="0">
                      <a:pos x="T118" y="T119"/>
                    </a:cxn>
                    <a:cxn ang="0">
                      <a:pos x="T120" y="T121"/>
                    </a:cxn>
                    <a:cxn ang="0">
                      <a:pos x="T122" y="T123"/>
                    </a:cxn>
                    <a:cxn ang="0">
                      <a:pos x="T124" y="T125"/>
                    </a:cxn>
                  </a:cxnLst>
                  <a:rect l="0" t="0" r="r" b="b"/>
                  <a:pathLst>
                    <a:path w="453" h="1107">
                      <a:moveTo>
                        <a:pt x="0" y="1107"/>
                      </a:moveTo>
                      <a:lnTo>
                        <a:pt x="2" y="1107"/>
                      </a:lnTo>
                      <a:lnTo>
                        <a:pt x="4" y="1107"/>
                      </a:lnTo>
                      <a:lnTo>
                        <a:pt x="6" y="1107"/>
                      </a:lnTo>
                      <a:lnTo>
                        <a:pt x="8" y="1107"/>
                      </a:lnTo>
                      <a:lnTo>
                        <a:pt x="11" y="1107"/>
                      </a:lnTo>
                      <a:lnTo>
                        <a:pt x="13" y="1107"/>
                      </a:lnTo>
                      <a:lnTo>
                        <a:pt x="15" y="1107"/>
                      </a:lnTo>
                      <a:lnTo>
                        <a:pt x="17" y="1107"/>
                      </a:lnTo>
                      <a:lnTo>
                        <a:pt x="20" y="1107"/>
                      </a:lnTo>
                      <a:lnTo>
                        <a:pt x="23" y="1107"/>
                      </a:lnTo>
                      <a:lnTo>
                        <a:pt x="26" y="1107"/>
                      </a:lnTo>
                      <a:lnTo>
                        <a:pt x="29" y="1107"/>
                      </a:lnTo>
                      <a:lnTo>
                        <a:pt x="34" y="1107"/>
                      </a:lnTo>
                      <a:lnTo>
                        <a:pt x="39" y="1107"/>
                      </a:lnTo>
                      <a:lnTo>
                        <a:pt x="43" y="1107"/>
                      </a:lnTo>
                      <a:lnTo>
                        <a:pt x="46" y="1107"/>
                      </a:lnTo>
                      <a:lnTo>
                        <a:pt x="48" y="1107"/>
                      </a:lnTo>
                      <a:lnTo>
                        <a:pt x="51" y="1107"/>
                      </a:lnTo>
                      <a:lnTo>
                        <a:pt x="54" y="1107"/>
                      </a:lnTo>
                      <a:lnTo>
                        <a:pt x="57" y="1107"/>
                      </a:lnTo>
                      <a:lnTo>
                        <a:pt x="60" y="1107"/>
                      </a:lnTo>
                      <a:lnTo>
                        <a:pt x="63" y="1107"/>
                      </a:lnTo>
                      <a:lnTo>
                        <a:pt x="66" y="1107"/>
                      </a:lnTo>
                      <a:lnTo>
                        <a:pt x="70" y="1107"/>
                      </a:lnTo>
                      <a:lnTo>
                        <a:pt x="77" y="1107"/>
                      </a:lnTo>
                      <a:lnTo>
                        <a:pt x="83" y="1107"/>
                      </a:lnTo>
                      <a:lnTo>
                        <a:pt x="86" y="1107"/>
                      </a:lnTo>
                      <a:lnTo>
                        <a:pt x="87" y="1107"/>
                      </a:lnTo>
                      <a:lnTo>
                        <a:pt x="88" y="1107"/>
                      </a:lnTo>
                      <a:lnTo>
                        <a:pt x="91" y="1107"/>
                      </a:lnTo>
                      <a:lnTo>
                        <a:pt x="94" y="1107"/>
                      </a:lnTo>
                      <a:lnTo>
                        <a:pt x="98" y="1107"/>
                      </a:lnTo>
                      <a:lnTo>
                        <a:pt x="101" y="1106"/>
                      </a:lnTo>
                      <a:lnTo>
                        <a:pt x="106" y="1106"/>
                      </a:lnTo>
                      <a:lnTo>
                        <a:pt x="112" y="1106"/>
                      </a:lnTo>
                      <a:lnTo>
                        <a:pt x="120" y="1106"/>
                      </a:lnTo>
                      <a:lnTo>
                        <a:pt x="126" y="1106"/>
                      </a:lnTo>
                      <a:lnTo>
                        <a:pt x="128" y="1106"/>
                      </a:lnTo>
                      <a:lnTo>
                        <a:pt x="130" y="1106"/>
                      </a:lnTo>
                      <a:lnTo>
                        <a:pt x="131" y="1106"/>
                      </a:lnTo>
                      <a:lnTo>
                        <a:pt x="133" y="1106"/>
                      </a:lnTo>
                      <a:lnTo>
                        <a:pt x="136" y="1105"/>
                      </a:lnTo>
                      <a:lnTo>
                        <a:pt x="141" y="1105"/>
                      </a:lnTo>
                      <a:lnTo>
                        <a:pt x="148" y="1105"/>
                      </a:lnTo>
                      <a:lnTo>
                        <a:pt x="154" y="1105"/>
                      </a:lnTo>
                      <a:lnTo>
                        <a:pt x="157" y="1105"/>
                      </a:lnTo>
                      <a:lnTo>
                        <a:pt x="160" y="1105"/>
                      </a:lnTo>
                      <a:lnTo>
                        <a:pt x="163" y="1105"/>
                      </a:lnTo>
                      <a:lnTo>
                        <a:pt x="165" y="1105"/>
                      </a:lnTo>
                      <a:lnTo>
                        <a:pt x="167" y="1105"/>
                      </a:lnTo>
                      <a:lnTo>
                        <a:pt x="169" y="1105"/>
                      </a:lnTo>
                      <a:lnTo>
                        <a:pt x="171" y="1105"/>
                      </a:lnTo>
                      <a:lnTo>
                        <a:pt x="172" y="1104"/>
                      </a:lnTo>
                      <a:lnTo>
                        <a:pt x="173" y="1104"/>
                      </a:lnTo>
                      <a:lnTo>
                        <a:pt x="174" y="1104"/>
                      </a:lnTo>
                      <a:lnTo>
                        <a:pt x="174" y="1104"/>
                      </a:lnTo>
                      <a:lnTo>
                        <a:pt x="175" y="1104"/>
                      </a:lnTo>
                      <a:lnTo>
                        <a:pt x="176" y="1104"/>
                      </a:lnTo>
                      <a:lnTo>
                        <a:pt x="179" y="1104"/>
                      </a:lnTo>
                      <a:lnTo>
                        <a:pt x="181" y="1104"/>
                      </a:lnTo>
                      <a:lnTo>
                        <a:pt x="183" y="1104"/>
                      </a:lnTo>
                      <a:lnTo>
                        <a:pt x="186" y="1104"/>
                      </a:lnTo>
                      <a:lnTo>
                        <a:pt x="189" y="1103"/>
                      </a:lnTo>
                      <a:lnTo>
                        <a:pt x="194" y="1103"/>
                      </a:lnTo>
                      <a:lnTo>
                        <a:pt x="197" y="1103"/>
                      </a:lnTo>
                      <a:lnTo>
                        <a:pt x="200" y="1102"/>
                      </a:lnTo>
                      <a:lnTo>
                        <a:pt x="202" y="1102"/>
                      </a:lnTo>
                      <a:lnTo>
                        <a:pt x="205" y="1102"/>
                      </a:lnTo>
                      <a:lnTo>
                        <a:pt x="207" y="1102"/>
                      </a:lnTo>
                      <a:lnTo>
                        <a:pt x="209" y="1102"/>
                      </a:lnTo>
                      <a:lnTo>
                        <a:pt x="211" y="1102"/>
                      </a:lnTo>
                      <a:lnTo>
                        <a:pt x="213" y="1102"/>
                      </a:lnTo>
                      <a:lnTo>
                        <a:pt x="215" y="1102"/>
                      </a:lnTo>
                      <a:lnTo>
                        <a:pt x="217" y="1102"/>
                      </a:lnTo>
                      <a:lnTo>
                        <a:pt x="218" y="1102"/>
                      </a:lnTo>
                      <a:lnTo>
                        <a:pt x="219" y="1102"/>
                      </a:lnTo>
                      <a:lnTo>
                        <a:pt x="221" y="1102"/>
                      </a:lnTo>
                      <a:lnTo>
                        <a:pt x="223" y="1102"/>
                      </a:lnTo>
                      <a:lnTo>
                        <a:pt x="225" y="1102"/>
                      </a:lnTo>
                      <a:lnTo>
                        <a:pt x="227" y="1102"/>
                      </a:lnTo>
                      <a:lnTo>
                        <a:pt x="229" y="1102"/>
                      </a:lnTo>
                      <a:lnTo>
                        <a:pt x="231" y="1102"/>
                      </a:lnTo>
                      <a:lnTo>
                        <a:pt x="232" y="1102"/>
                      </a:lnTo>
                      <a:lnTo>
                        <a:pt x="233" y="1102"/>
                      </a:lnTo>
                      <a:lnTo>
                        <a:pt x="235" y="1102"/>
                      </a:lnTo>
                      <a:lnTo>
                        <a:pt x="236" y="1101"/>
                      </a:lnTo>
                      <a:lnTo>
                        <a:pt x="237" y="1101"/>
                      </a:lnTo>
                      <a:lnTo>
                        <a:pt x="238" y="1101"/>
                      </a:lnTo>
                      <a:lnTo>
                        <a:pt x="239" y="1101"/>
                      </a:lnTo>
                      <a:lnTo>
                        <a:pt x="241" y="1101"/>
                      </a:lnTo>
                      <a:lnTo>
                        <a:pt x="242" y="1101"/>
                      </a:lnTo>
                      <a:lnTo>
                        <a:pt x="243" y="1101"/>
                      </a:lnTo>
                      <a:lnTo>
                        <a:pt x="244" y="1101"/>
                      </a:lnTo>
                      <a:lnTo>
                        <a:pt x="246" y="1101"/>
                      </a:lnTo>
                      <a:lnTo>
                        <a:pt x="247" y="1100"/>
                      </a:lnTo>
                      <a:lnTo>
                        <a:pt x="248" y="1100"/>
                      </a:lnTo>
                      <a:lnTo>
                        <a:pt x="250" y="1100"/>
                      </a:lnTo>
                      <a:lnTo>
                        <a:pt x="251" y="1100"/>
                      </a:lnTo>
                      <a:lnTo>
                        <a:pt x="254" y="1099"/>
                      </a:lnTo>
                      <a:lnTo>
                        <a:pt x="256" y="1099"/>
                      </a:lnTo>
                      <a:lnTo>
                        <a:pt x="257" y="1099"/>
                      </a:lnTo>
                      <a:lnTo>
                        <a:pt x="258" y="1099"/>
                      </a:lnTo>
                      <a:lnTo>
                        <a:pt x="259" y="1099"/>
                      </a:lnTo>
                      <a:lnTo>
                        <a:pt x="259" y="1099"/>
                      </a:lnTo>
                      <a:lnTo>
                        <a:pt x="260" y="1099"/>
                      </a:lnTo>
                      <a:lnTo>
                        <a:pt x="262" y="1098"/>
                      </a:lnTo>
                      <a:lnTo>
                        <a:pt x="265" y="1098"/>
                      </a:lnTo>
                      <a:lnTo>
                        <a:pt x="269" y="1097"/>
                      </a:lnTo>
                      <a:lnTo>
                        <a:pt x="273" y="1097"/>
                      </a:lnTo>
                      <a:lnTo>
                        <a:pt x="275" y="1096"/>
                      </a:lnTo>
                      <a:lnTo>
                        <a:pt x="278" y="1096"/>
                      </a:lnTo>
                      <a:lnTo>
                        <a:pt x="279" y="1096"/>
                      </a:lnTo>
                      <a:lnTo>
                        <a:pt x="281" y="1096"/>
                      </a:lnTo>
                      <a:lnTo>
                        <a:pt x="283" y="1096"/>
                      </a:lnTo>
                      <a:lnTo>
                        <a:pt x="285" y="1095"/>
                      </a:lnTo>
                      <a:lnTo>
                        <a:pt x="287" y="1095"/>
                      </a:lnTo>
                      <a:lnTo>
                        <a:pt x="288" y="1095"/>
                      </a:lnTo>
                      <a:lnTo>
                        <a:pt x="290" y="1095"/>
                      </a:lnTo>
                      <a:lnTo>
                        <a:pt x="293" y="1095"/>
                      </a:lnTo>
                      <a:lnTo>
                        <a:pt x="295" y="1095"/>
                      </a:lnTo>
                      <a:lnTo>
                        <a:pt x="297" y="1095"/>
                      </a:lnTo>
                      <a:lnTo>
                        <a:pt x="299" y="1095"/>
                      </a:lnTo>
                      <a:lnTo>
                        <a:pt x="301" y="1095"/>
                      </a:lnTo>
                      <a:lnTo>
                        <a:pt x="302" y="1095"/>
                      </a:lnTo>
                      <a:lnTo>
                        <a:pt x="302" y="1095"/>
                      </a:lnTo>
                      <a:lnTo>
                        <a:pt x="303" y="1095"/>
                      </a:lnTo>
                      <a:lnTo>
                        <a:pt x="304" y="1095"/>
                      </a:lnTo>
                      <a:lnTo>
                        <a:pt x="304" y="1094"/>
                      </a:lnTo>
                      <a:lnTo>
                        <a:pt x="307" y="1094"/>
                      </a:lnTo>
                      <a:lnTo>
                        <a:pt x="309" y="1094"/>
                      </a:lnTo>
                      <a:lnTo>
                        <a:pt x="311" y="1094"/>
                      </a:lnTo>
                      <a:lnTo>
                        <a:pt x="313" y="1094"/>
                      </a:lnTo>
                      <a:lnTo>
                        <a:pt x="316" y="1093"/>
                      </a:lnTo>
                      <a:lnTo>
                        <a:pt x="321" y="1092"/>
                      </a:lnTo>
                      <a:lnTo>
                        <a:pt x="326" y="1092"/>
                      </a:lnTo>
                      <a:lnTo>
                        <a:pt x="330" y="1091"/>
                      </a:lnTo>
                      <a:lnTo>
                        <a:pt x="332" y="1091"/>
                      </a:lnTo>
                      <a:lnTo>
                        <a:pt x="335" y="1090"/>
                      </a:lnTo>
                      <a:lnTo>
                        <a:pt x="338" y="1090"/>
                      </a:lnTo>
                      <a:lnTo>
                        <a:pt x="341" y="1090"/>
                      </a:lnTo>
                      <a:lnTo>
                        <a:pt x="343" y="1089"/>
                      </a:lnTo>
                      <a:lnTo>
                        <a:pt x="344" y="1089"/>
                      </a:lnTo>
                      <a:lnTo>
                        <a:pt x="345" y="1089"/>
                      </a:lnTo>
                      <a:lnTo>
                        <a:pt x="345" y="1089"/>
                      </a:lnTo>
                      <a:lnTo>
                        <a:pt x="346" y="1089"/>
                      </a:lnTo>
                      <a:lnTo>
                        <a:pt x="346" y="1089"/>
                      </a:lnTo>
                      <a:lnTo>
                        <a:pt x="346" y="1089"/>
                      </a:lnTo>
                      <a:lnTo>
                        <a:pt x="347" y="1089"/>
                      </a:lnTo>
                      <a:lnTo>
                        <a:pt x="347" y="1089"/>
                      </a:lnTo>
                      <a:lnTo>
                        <a:pt x="347" y="1089"/>
                      </a:lnTo>
                      <a:lnTo>
                        <a:pt x="347" y="1089"/>
                      </a:lnTo>
                      <a:lnTo>
                        <a:pt x="347" y="1089"/>
                      </a:lnTo>
                      <a:lnTo>
                        <a:pt x="348" y="1089"/>
                      </a:lnTo>
                      <a:lnTo>
                        <a:pt x="349" y="1088"/>
                      </a:lnTo>
                      <a:lnTo>
                        <a:pt x="351" y="1088"/>
                      </a:lnTo>
                      <a:lnTo>
                        <a:pt x="352" y="1088"/>
                      </a:lnTo>
                      <a:lnTo>
                        <a:pt x="354" y="1087"/>
                      </a:lnTo>
                      <a:lnTo>
                        <a:pt x="355" y="1087"/>
                      </a:lnTo>
                      <a:lnTo>
                        <a:pt x="356" y="1087"/>
                      </a:lnTo>
                      <a:lnTo>
                        <a:pt x="357" y="1087"/>
                      </a:lnTo>
                      <a:lnTo>
                        <a:pt x="358" y="1086"/>
                      </a:lnTo>
                      <a:lnTo>
                        <a:pt x="359" y="1086"/>
                      </a:lnTo>
                      <a:lnTo>
                        <a:pt x="360" y="1086"/>
                      </a:lnTo>
                      <a:lnTo>
                        <a:pt x="361" y="1086"/>
                      </a:lnTo>
                      <a:lnTo>
                        <a:pt x="361" y="1085"/>
                      </a:lnTo>
                      <a:lnTo>
                        <a:pt x="362" y="1085"/>
                      </a:lnTo>
                      <a:lnTo>
                        <a:pt x="362" y="1085"/>
                      </a:lnTo>
                      <a:lnTo>
                        <a:pt x="363" y="1085"/>
                      </a:lnTo>
                      <a:lnTo>
                        <a:pt x="363" y="1085"/>
                      </a:lnTo>
                      <a:lnTo>
                        <a:pt x="363" y="1084"/>
                      </a:lnTo>
                      <a:lnTo>
                        <a:pt x="364" y="1084"/>
                      </a:lnTo>
                      <a:lnTo>
                        <a:pt x="364" y="1084"/>
                      </a:lnTo>
                      <a:lnTo>
                        <a:pt x="365" y="1084"/>
                      </a:lnTo>
                      <a:lnTo>
                        <a:pt x="365" y="1083"/>
                      </a:lnTo>
                      <a:lnTo>
                        <a:pt x="365" y="1083"/>
                      </a:lnTo>
                      <a:lnTo>
                        <a:pt x="366" y="1083"/>
                      </a:lnTo>
                      <a:lnTo>
                        <a:pt x="366" y="1083"/>
                      </a:lnTo>
                      <a:lnTo>
                        <a:pt x="366" y="1082"/>
                      </a:lnTo>
                      <a:lnTo>
                        <a:pt x="367" y="1082"/>
                      </a:lnTo>
                      <a:lnTo>
                        <a:pt x="367" y="1082"/>
                      </a:lnTo>
                      <a:lnTo>
                        <a:pt x="367" y="1081"/>
                      </a:lnTo>
                      <a:lnTo>
                        <a:pt x="367" y="1081"/>
                      </a:lnTo>
                      <a:lnTo>
                        <a:pt x="368" y="1081"/>
                      </a:lnTo>
                      <a:lnTo>
                        <a:pt x="368" y="1080"/>
                      </a:lnTo>
                      <a:lnTo>
                        <a:pt x="368" y="1080"/>
                      </a:lnTo>
                      <a:lnTo>
                        <a:pt x="369" y="1079"/>
                      </a:lnTo>
                      <a:lnTo>
                        <a:pt x="369" y="1079"/>
                      </a:lnTo>
                      <a:lnTo>
                        <a:pt x="369" y="1078"/>
                      </a:lnTo>
                      <a:lnTo>
                        <a:pt x="369" y="1078"/>
                      </a:lnTo>
                      <a:lnTo>
                        <a:pt x="370" y="1077"/>
                      </a:lnTo>
                      <a:lnTo>
                        <a:pt x="370" y="1076"/>
                      </a:lnTo>
                      <a:lnTo>
                        <a:pt x="371" y="1075"/>
                      </a:lnTo>
                      <a:lnTo>
                        <a:pt x="371" y="1075"/>
                      </a:lnTo>
                      <a:lnTo>
                        <a:pt x="371" y="1074"/>
                      </a:lnTo>
                      <a:lnTo>
                        <a:pt x="372" y="1073"/>
                      </a:lnTo>
                      <a:lnTo>
                        <a:pt x="372" y="1072"/>
                      </a:lnTo>
                      <a:lnTo>
                        <a:pt x="372" y="1071"/>
                      </a:lnTo>
                      <a:lnTo>
                        <a:pt x="373" y="1070"/>
                      </a:lnTo>
                      <a:lnTo>
                        <a:pt x="373" y="1069"/>
                      </a:lnTo>
                      <a:lnTo>
                        <a:pt x="373" y="1068"/>
                      </a:lnTo>
                      <a:lnTo>
                        <a:pt x="374" y="1067"/>
                      </a:lnTo>
                      <a:lnTo>
                        <a:pt x="374" y="1066"/>
                      </a:lnTo>
                      <a:lnTo>
                        <a:pt x="374" y="1065"/>
                      </a:lnTo>
                      <a:lnTo>
                        <a:pt x="375" y="1064"/>
                      </a:lnTo>
                      <a:lnTo>
                        <a:pt x="375" y="1063"/>
                      </a:lnTo>
                      <a:lnTo>
                        <a:pt x="375" y="1061"/>
                      </a:lnTo>
                      <a:lnTo>
                        <a:pt x="376" y="1060"/>
                      </a:lnTo>
                      <a:lnTo>
                        <a:pt x="376" y="1059"/>
                      </a:lnTo>
                      <a:lnTo>
                        <a:pt x="377" y="1057"/>
                      </a:lnTo>
                      <a:lnTo>
                        <a:pt x="377" y="1056"/>
                      </a:lnTo>
                      <a:lnTo>
                        <a:pt x="377" y="1054"/>
                      </a:lnTo>
                      <a:lnTo>
                        <a:pt x="378" y="1052"/>
                      </a:lnTo>
                      <a:lnTo>
                        <a:pt x="378" y="1051"/>
                      </a:lnTo>
                      <a:lnTo>
                        <a:pt x="378" y="1049"/>
                      </a:lnTo>
                      <a:lnTo>
                        <a:pt x="379" y="1047"/>
                      </a:lnTo>
                      <a:lnTo>
                        <a:pt x="379" y="1045"/>
                      </a:lnTo>
                      <a:lnTo>
                        <a:pt x="379" y="1044"/>
                      </a:lnTo>
                      <a:lnTo>
                        <a:pt x="380" y="1042"/>
                      </a:lnTo>
                      <a:lnTo>
                        <a:pt x="380" y="1040"/>
                      </a:lnTo>
                      <a:lnTo>
                        <a:pt x="381" y="1038"/>
                      </a:lnTo>
                      <a:lnTo>
                        <a:pt x="381" y="1035"/>
                      </a:lnTo>
                      <a:lnTo>
                        <a:pt x="382" y="1032"/>
                      </a:lnTo>
                      <a:lnTo>
                        <a:pt x="382" y="1029"/>
                      </a:lnTo>
                      <a:lnTo>
                        <a:pt x="383" y="1026"/>
                      </a:lnTo>
                      <a:lnTo>
                        <a:pt x="383" y="1024"/>
                      </a:lnTo>
                      <a:lnTo>
                        <a:pt x="384" y="1021"/>
                      </a:lnTo>
                      <a:lnTo>
                        <a:pt x="384" y="1018"/>
                      </a:lnTo>
                      <a:lnTo>
                        <a:pt x="385" y="1016"/>
                      </a:lnTo>
                      <a:lnTo>
                        <a:pt x="385" y="1013"/>
                      </a:lnTo>
                      <a:lnTo>
                        <a:pt x="385" y="1010"/>
                      </a:lnTo>
                      <a:lnTo>
                        <a:pt x="386" y="1008"/>
                      </a:lnTo>
                      <a:lnTo>
                        <a:pt x="386" y="1006"/>
                      </a:lnTo>
                      <a:lnTo>
                        <a:pt x="386" y="1004"/>
                      </a:lnTo>
                      <a:lnTo>
                        <a:pt x="387" y="1001"/>
                      </a:lnTo>
                      <a:lnTo>
                        <a:pt x="387" y="999"/>
                      </a:lnTo>
                      <a:lnTo>
                        <a:pt x="387" y="997"/>
                      </a:lnTo>
                      <a:lnTo>
                        <a:pt x="387" y="996"/>
                      </a:lnTo>
                      <a:lnTo>
                        <a:pt x="387" y="995"/>
                      </a:lnTo>
                      <a:lnTo>
                        <a:pt x="387" y="994"/>
                      </a:lnTo>
                      <a:lnTo>
                        <a:pt x="387" y="993"/>
                      </a:lnTo>
                      <a:lnTo>
                        <a:pt x="388" y="993"/>
                      </a:lnTo>
                      <a:lnTo>
                        <a:pt x="388" y="992"/>
                      </a:lnTo>
                      <a:lnTo>
                        <a:pt x="388" y="991"/>
                      </a:lnTo>
                      <a:lnTo>
                        <a:pt x="388" y="990"/>
                      </a:lnTo>
                      <a:lnTo>
                        <a:pt x="388" y="989"/>
                      </a:lnTo>
                      <a:lnTo>
                        <a:pt x="388" y="989"/>
                      </a:lnTo>
                      <a:lnTo>
                        <a:pt x="388" y="987"/>
                      </a:lnTo>
                      <a:lnTo>
                        <a:pt x="388" y="985"/>
                      </a:lnTo>
                      <a:lnTo>
                        <a:pt x="389" y="983"/>
                      </a:lnTo>
                      <a:lnTo>
                        <a:pt x="389" y="981"/>
                      </a:lnTo>
                      <a:lnTo>
                        <a:pt x="389" y="978"/>
                      </a:lnTo>
                      <a:lnTo>
                        <a:pt x="389" y="976"/>
                      </a:lnTo>
                      <a:lnTo>
                        <a:pt x="390" y="974"/>
                      </a:lnTo>
                      <a:lnTo>
                        <a:pt x="390" y="972"/>
                      </a:lnTo>
                      <a:lnTo>
                        <a:pt x="390" y="970"/>
                      </a:lnTo>
                      <a:lnTo>
                        <a:pt x="390" y="968"/>
                      </a:lnTo>
                      <a:lnTo>
                        <a:pt x="390" y="966"/>
                      </a:lnTo>
                      <a:lnTo>
                        <a:pt x="390" y="963"/>
                      </a:lnTo>
                      <a:lnTo>
                        <a:pt x="390" y="961"/>
                      </a:lnTo>
                      <a:lnTo>
                        <a:pt x="391" y="958"/>
                      </a:lnTo>
                      <a:lnTo>
                        <a:pt x="391" y="955"/>
                      </a:lnTo>
                      <a:lnTo>
                        <a:pt x="391" y="952"/>
                      </a:lnTo>
                      <a:lnTo>
                        <a:pt x="391" y="948"/>
                      </a:lnTo>
                      <a:lnTo>
                        <a:pt x="392" y="945"/>
                      </a:lnTo>
                      <a:lnTo>
                        <a:pt x="392" y="941"/>
                      </a:lnTo>
                      <a:lnTo>
                        <a:pt x="392" y="937"/>
                      </a:lnTo>
                      <a:lnTo>
                        <a:pt x="392" y="933"/>
                      </a:lnTo>
                      <a:lnTo>
                        <a:pt x="392" y="929"/>
                      </a:lnTo>
                      <a:lnTo>
                        <a:pt x="392" y="925"/>
                      </a:lnTo>
                      <a:lnTo>
                        <a:pt x="393" y="921"/>
                      </a:lnTo>
                      <a:lnTo>
                        <a:pt x="393" y="916"/>
                      </a:lnTo>
                      <a:lnTo>
                        <a:pt x="393" y="911"/>
                      </a:lnTo>
                      <a:lnTo>
                        <a:pt x="393" y="906"/>
                      </a:lnTo>
                      <a:lnTo>
                        <a:pt x="394" y="901"/>
                      </a:lnTo>
                      <a:lnTo>
                        <a:pt x="394" y="896"/>
                      </a:lnTo>
                      <a:lnTo>
                        <a:pt x="394" y="891"/>
                      </a:lnTo>
                      <a:lnTo>
                        <a:pt x="394" y="886"/>
                      </a:lnTo>
                      <a:lnTo>
                        <a:pt x="395" y="881"/>
                      </a:lnTo>
                      <a:lnTo>
                        <a:pt x="395" y="876"/>
                      </a:lnTo>
                      <a:lnTo>
                        <a:pt x="395" y="872"/>
                      </a:lnTo>
                      <a:lnTo>
                        <a:pt x="395" y="867"/>
                      </a:lnTo>
                      <a:lnTo>
                        <a:pt x="395" y="862"/>
                      </a:lnTo>
                      <a:lnTo>
                        <a:pt x="395" y="856"/>
                      </a:lnTo>
                      <a:lnTo>
                        <a:pt x="395" y="851"/>
                      </a:lnTo>
                      <a:lnTo>
                        <a:pt x="396" y="846"/>
                      </a:lnTo>
                      <a:lnTo>
                        <a:pt x="396" y="840"/>
                      </a:lnTo>
                      <a:lnTo>
                        <a:pt x="396" y="835"/>
                      </a:lnTo>
                      <a:lnTo>
                        <a:pt x="396" y="829"/>
                      </a:lnTo>
                      <a:lnTo>
                        <a:pt x="396" y="823"/>
                      </a:lnTo>
                      <a:lnTo>
                        <a:pt x="397" y="817"/>
                      </a:lnTo>
                      <a:lnTo>
                        <a:pt x="397" y="811"/>
                      </a:lnTo>
                      <a:lnTo>
                        <a:pt x="397" y="804"/>
                      </a:lnTo>
                      <a:lnTo>
                        <a:pt x="397" y="798"/>
                      </a:lnTo>
                      <a:lnTo>
                        <a:pt x="397" y="791"/>
                      </a:lnTo>
                      <a:lnTo>
                        <a:pt x="397" y="785"/>
                      </a:lnTo>
                      <a:lnTo>
                        <a:pt x="397" y="777"/>
                      </a:lnTo>
                      <a:lnTo>
                        <a:pt x="398" y="769"/>
                      </a:lnTo>
                      <a:lnTo>
                        <a:pt x="398" y="760"/>
                      </a:lnTo>
                      <a:lnTo>
                        <a:pt x="398" y="751"/>
                      </a:lnTo>
                      <a:lnTo>
                        <a:pt x="398" y="742"/>
                      </a:lnTo>
                      <a:lnTo>
                        <a:pt x="399" y="732"/>
                      </a:lnTo>
                      <a:lnTo>
                        <a:pt x="399" y="723"/>
                      </a:lnTo>
                      <a:lnTo>
                        <a:pt x="399" y="713"/>
                      </a:lnTo>
                      <a:lnTo>
                        <a:pt x="399" y="703"/>
                      </a:lnTo>
                      <a:lnTo>
                        <a:pt x="399" y="693"/>
                      </a:lnTo>
                      <a:lnTo>
                        <a:pt x="400" y="683"/>
                      </a:lnTo>
                      <a:lnTo>
                        <a:pt x="400" y="673"/>
                      </a:lnTo>
                      <a:lnTo>
                        <a:pt x="400" y="663"/>
                      </a:lnTo>
                      <a:lnTo>
                        <a:pt x="400" y="651"/>
                      </a:lnTo>
                      <a:lnTo>
                        <a:pt x="400" y="638"/>
                      </a:lnTo>
                      <a:lnTo>
                        <a:pt x="401" y="625"/>
                      </a:lnTo>
                      <a:lnTo>
                        <a:pt x="401" y="612"/>
                      </a:lnTo>
                      <a:lnTo>
                        <a:pt x="401" y="598"/>
                      </a:lnTo>
                      <a:lnTo>
                        <a:pt x="402" y="582"/>
                      </a:lnTo>
                      <a:lnTo>
                        <a:pt x="402" y="565"/>
                      </a:lnTo>
                      <a:lnTo>
                        <a:pt x="402" y="547"/>
                      </a:lnTo>
                      <a:lnTo>
                        <a:pt x="403" y="527"/>
                      </a:lnTo>
                      <a:lnTo>
                        <a:pt x="403" y="500"/>
                      </a:lnTo>
                      <a:lnTo>
                        <a:pt x="404" y="465"/>
                      </a:lnTo>
                      <a:lnTo>
                        <a:pt x="404" y="432"/>
                      </a:lnTo>
                      <a:lnTo>
                        <a:pt x="405" y="408"/>
                      </a:lnTo>
                      <a:lnTo>
                        <a:pt x="405" y="388"/>
                      </a:lnTo>
                      <a:lnTo>
                        <a:pt x="406" y="370"/>
                      </a:lnTo>
                      <a:lnTo>
                        <a:pt x="406" y="353"/>
                      </a:lnTo>
                      <a:lnTo>
                        <a:pt x="406" y="337"/>
                      </a:lnTo>
                      <a:lnTo>
                        <a:pt x="406" y="323"/>
                      </a:lnTo>
                      <a:lnTo>
                        <a:pt x="407" y="310"/>
                      </a:lnTo>
                      <a:lnTo>
                        <a:pt x="407" y="297"/>
                      </a:lnTo>
                      <a:lnTo>
                        <a:pt x="407" y="284"/>
                      </a:lnTo>
                      <a:lnTo>
                        <a:pt x="407" y="273"/>
                      </a:lnTo>
                      <a:lnTo>
                        <a:pt x="408" y="262"/>
                      </a:lnTo>
                      <a:lnTo>
                        <a:pt x="408" y="252"/>
                      </a:lnTo>
                      <a:lnTo>
                        <a:pt x="408" y="242"/>
                      </a:lnTo>
                      <a:lnTo>
                        <a:pt x="408" y="232"/>
                      </a:lnTo>
                      <a:lnTo>
                        <a:pt x="408" y="222"/>
                      </a:lnTo>
                      <a:lnTo>
                        <a:pt x="409" y="212"/>
                      </a:lnTo>
                      <a:lnTo>
                        <a:pt x="409" y="203"/>
                      </a:lnTo>
                      <a:lnTo>
                        <a:pt x="409" y="194"/>
                      </a:lnTo>
                      <a:lnTo>
                        <a:pt x="409" y="184"/>
                      </a:lnTo>
                      <a:lnTo>
                        <a:pt x="410" y="176"/>
                      </a:lnTo>
                      <a:lnTo>
                        <a:pt x="410" y="169"/>
                      </a:lnTo>
                      <a:lnTo>
                        <a:pt x="410" y="162"/>
                      </a:lnTo>
                      <a:lnTo>
                        <a:pt x="410" y="155"/>
                      </a:lnTo>
                      <a:lnTo>
                        <a:pt x="410" y="149"/>
                      </a:lnTo>
                      <a:lnTo>
                        <a:pt x="410" y="142"/>
                      </a:lnTo>
                      <a:lnTo>
                        <a:pt x="411" y="136"/>
                      </a:lnTo>
                      <a:lnTo>
                        <a:pt x="411" y="129"/>
                      </a:lnTo>
                      <a:lnTo>
                        <a:pt x="411" y="123"/>
                      </a:lnTo>
                      <a:lnTo>
                        <a:pt x="411" y="117"/>
                      </a:lnTo>
                      <a:lnTo>
                        <a:pt x="411" y="111"/>
                      </a:lnTo>
                      <a:lnTo>
                        <a:pt x="411" y="105"/>
                      </a:lnTo>
                      <a:lnTo>
                        <a:pt x="412" y="100"/>
                      </a:lnTo>
                      <a:lnTo>
                        <a:pt x="412" y="94"/>
                      </a:lnTo>
                      <a:lnTo>
                        <a:pt x="412" y="89"/>
                      </a:lnTo>
                      <a:lnTo>
                        <a:pt x="412" y="83"/>
                      </a:lnTo>
                      <a:lnTo>
                        <a:pt x="412" y="78"/>
                      </a:lnTo>
                      <a:lnTo>
                        <a:pt x="412" y="73"/>
                      </a:lnTo>
                      <a:lnTo>
                        <a:pt x="413" y="69"/>
                      </a:lnTo>
                      <a:lnTo>
                        <a:pt x="413" y="64"/>
                      </a:lnTo>
                      <a:lnTo>
                        <a:pt x="413" y="60"/>
                      </a:lnTo>
                      <a:lnTo>
                        <a:pt x="413" y="55"/>
                      </a:lnTo>
                      <a:lnTo>
                        <a:pt x="413" y="51"/>
                      </a:lnTo>
                      <a:lnTo>
                        <a:pt x="413" y="47"/>
                      </a:lnTo>
                      <a:lnTo>
                        <a:pt x="414" y="43"/>
                      </a:lnTo>
                      <a:lnTo>
                        <a:pt x="414" y="40"/>
                      </a:lnTo>
                      <a:lnTo>
                        <a:pt x="414" y="36"/>
                      </a:lnTo>
                      <a:lnTo>
                        <a:pt x="414" y="33"/>
                      </a:lnTo>
                      <a:lnTo>
                        <a:pt x="414" y="30"/>
                      </a:lnTo>
                      <a:lnTo>
                        <a:pt x="415" y="27"/>
                      </a:lnTo>
                      <a:lnTo>
                        <a:pt x="415" y="24"/>
                      </a:lnTo>
                      <a:lnTo>
                        <a:pt x="415" y="21"/>
                      </a:lnTo>
                      <a:lnTo>
                        <a:pt x="415" y="18"/>
                      </a:lnTo>
                      <a:lnTo>
                        <a:pt x="415" y="16"/>
                      </a:lnTo>
                      <a:lnTo>
                        <a:pt x="415" y="14"/>
                      </a:lnTo>
                      <a:lnTo>
                        <a:pt x="415" y="12"/>
                      </a:lnTo>
                      <a:lnTo>
                        <a:pt x="416" y="10"/>
                      </a:lnTo>
                      <a:lnTo>
                        <a:pt x="416" y="8"/>
                      </a:lnTo>
                      <a:lnTo>
                        <a:pt x="416" y="7"/>
                      </a:lnTo>
                      <a:lnTo>
                        <a:pt x="416" y="5"/>
                      </a:lnTo>
                      <a:lnTo>
                        <a:pt x="416" y="4"/>
                      </a:lnTo>
                      <a:lnTo>
                        <a:pt x="417" y="3"/>
                      </a:lnTo>
                      <a:lnTo>
                        <a:pt x="417" y="2"/>
                      </a:lnTo>
                      <a:lnTo>
                        <a:pt x="417" y="1"/>
                      </a:lnTo>
                      <a:lnTo>
                        <a:pt x="417" y="0"/>
                      </a:lnTo>
                      <a:lnTo>
                        <a:pt x="417" y="0"/>
                      </a:lnTo>
                      <a:lnTo>
                        <a:pt x="417" y="0"/>
                      </a:lnTo>
                      <a:lnTo>
                        <a:pt x="417" y="0"/>
                      </a:lnTo>
                      <a:lnTo>
                        <a:pt x="418" y="0"/>
                      </a:lnTo>
                      <a:lnTo>
                        <a:pt x="418" y="0"/>
                      </a:lnTo>
                      <a:lnTo>
                        <a:pt x="418" y="0"/>
                      </a:lnTo>
                      <a:lnTo>
                        <a:pt x="418" y="0"/>
                      </a:lnTo>
                      <a:lnTo>
                        <a:pt x="418" y="1"/>
                      </a:lnTo>
                      <a:lnTo>
                        <a:pt x="419" y="2"/>
                      </a:lnTo>
                      <a:lnTo>
                        <a:pt x="419" y="3"/>
                      </a:lnTo>
                      <a:lnTo>
                        <a:pt x="419" y="4"/>
                      </a:lnTo>
                      <a:lnTo>
                        <a:pt x="419" y="5"/>
                      </a:lnTo>
                      <a:lnTo>
                        <a:pt x="419" y="6"/>
                      </a:lnTo>
                      <a:lnTo>
                        <a:pt x="419" y="8"/>
                      </a:lnTo>
                      <a:lnTo>
                        <a:pt x="420" y="9"/>
                      </a:lnTo>
                      <a:lnTo>
                        <a:pt x="420" y="11"/>
                      </a:lnTo>
                      <a:lnTo>
                        <a:pt x="420" y="13"/>
                      </a:lnTo>
                      <a:lnTo>
                        <a:pt x="420" y="14"/>
                      </a:lnTo>
                      <a:lnTo>
                        <a:pt x="420" y="16"/>
                      </a:lnTo>
                      <a:lnTo>
                        <a:pt x="420" y="19"/>
                      </a:lnTo>
                      <a:lnTo>
                        <a:pt x="421" y="21"/>
                      </a:lnTo>
                      <a:lnTo>
                        <a:pt x="421" y="23"/>
                      </a:lnTo>
                      <a:lnTo>
                        <a:pt x="421" y="26"/>
                      </a:lnTo>
                      <a:lnTo>
                        <a:pt x="421" y="29"/>
                      </a:lnTo>
                      <a:lnTo>
                        <a:pt x="421" y="33"/>
                      </a:lnTo>
                      <a:lnTo>
                        <a:pt x="422" y="36"/>
                      </a:lnTo>
                      <a:lnTo>
                        <a:pt x="422" y="40"/>
                      </a:lnTo>
                      <a:lnTo>
                        <a:pt x="422" y="44"/>
                      </a:lnTo>
                      <a:lnTo>
                        <a:pt x="422" y="48"/>
                      </a:lnTo>
                      <a:lnTo>
                        <a:pt x="422" y="52"/>
                      </a:lnTo>
                      <a:lnTo>
                        <a:pt x="422" y="57"/>
                      </a:lnTo>
                      <a:lnTo>
                        <a:pt x="423" y="61"/>
                      </a:lnTo>
                      <a:lnTo>
                        <a:pt x="423" y="66"/>
                      </a:lnTo>
                      <a:lnTo>
                        <a:pt x="423" y="71"/>
                      </a:lnTo>
                      <a:lnTo>
                        <a:pt x="423" y="76"/>
                      </a:lnTo>
                      <a:lnTo>
                        <a:pt x="424" y="82"/>
                      </a:lnTo>
                      <a:lnTo>
                        <a:pt x="424" y="88"/>
                      </a:lnTo>
                      <a:lnTo>
                        <a:pt x="424" y="94"/>
                      </a:lnTo>
                      <a:lnTo>
                        <a:pt x="425" y="101"/>
                      </a:lnTo>
                      <a:lnTo>
                        <a:pt x="425" y="108"/>
                      </a:lnTo>
                      <a:lnTo>
                        <a:pt x="425" y="115"/>
                      </a:lnTo>
                      <a:lnTo>
                        <a:pt x="425" y="122"/>
                      </a:lnTo>
                      <a:lnTo>
                        <a:pt x="425" y="130"/>
                      </a:lnTo>
                      <a:lnTo>
                        <a:pt x="426" y="138"/>
                      </a:lnTo>
                      <a:lnTo>
                        <a:pt x="426" y="147"/>
                      </a:lnTo>
                      <a:lnTo>
                        <a:pt x="426" y="156"/>
                      </a:lnTo>
                      <a:lnTo>
                        <a:pt x="427" y="166"/>
                      </a:lnTo>
                      <a:lnTo>
                        <a:pt x="427" y="176"/>
                      </a:lnTo>
                      <a:lnTo>
                        <a:pt x="427" y="187"/>
                      </a:lnTo>
                      <a:lnTo>
                        <a:pt x="428" y="198"/>
                      </a:lnTo>
                      <a:lnTo>
                        <a:pt x="428" y="211"/>
                      </a:lnTo>
                      <a:lnTo>
                        <a:pt x="429" y="226"/>
                      </a:lnTo>
                      <a:lnTo>
                        <a:pt x="429" y="242"/>
                      </a:lnTo>
                      <a:lnTo>
                        <a:pt x="430" y="261"/>
                      </a:lnTo>
                      <a:lnTo>
                        <a:pt x="430" y="285"/>
                      </a:lnTo>
                      <a:lnTo>
                        <a:pt x="431" y="301"/>
                      </a:lnTo>
                      <a:lnTo>
                        <a:pt x="431" y="304"/>
                      </a:lnTo>
                      <a:lnTo>
                        <a:pt x="431" y="307"/>
                      </a:lnTo>
                      <a:lnTo>
                        <a:pt x="431" y="309"/>
                      </a:lnTo>
                      <a:lnTo>
                        <a:pt x="431" y="312"/>
                      </a:lnTo>
                      <a:lnTo>
                        <a:pt x="431" y="315"/>
                      </a:lnTo>
                      <a:lnTo>
                        <a:pt x="431" y="318"/>
                      </a:lnTo>
                      <a:lnTo>
                        <a:pt x="432" y="321"/>
                      </a:lnTo>
                      <a:lnTo>
                        <a:pt x="432" y="323"/>
                      </a:lnTo>
                      <a:lnTo>
                        <a:pt x="432" y="326"/>
                      </a:lnTo>
                      <a:lnTo>
                        <a:pt x="432" y="329"/>
                      </a:lnTo>
                      <a:lnTo>
                        <a:pt x="432" y="332"/>
                      </a:lnTo>
                      <a:lnTo>
                        <a:pt x="432" y="335"/>
                      </a:lnTo>
                      <a:lnTo>
                        <a:pt x="432" y="337"/>
                      </a:lnTo>
                      <a:lnTo>
                        <a:pt x="432" y="347"/>
                      </a:lnTo>
                      <a:lnTo>
                        <a:pt x="433" y="364"/>
                      </a:lnTo>
                      <a:lnTo>
                        <a:pt x="433" y="380"/>
                      </a:lnTo>
                      <a:lnTo>
                        <a:pt x="434" y="395"/>
                      </a:lnTo>
                      <a:lnTo>
                        <a:pt x="434" y="409"/>
                      </a:lnTo>
                      <a:lnTo>
                        <a:pt x="435" y="422"/>
                      </a:lnTo>
                      <a:lnTo>
                        <a:pt x="435" y="434"/>
                      </a:lnTo>
                      <a:lnTo>
                        <a:pt x="435" y="446"/>
                      </a:lnTo>
                      <a:lnTo>
                        <a:pt x="436" y="458"/>
                      </a:lnTo>
                      <a:lnTo>
                        <a:pt x="436" y="469"/>
                      </a:lnTo>
                      <a:lnTo>
                        <a:pt x="437" y="480"/>
                      </a:lnTo>
                      <a:lnTo>
                        <a:pt x="437" y="491"/>
                      </a:lnTo>
                      <a:lnTo>
                        <a:pt x="437" y="502"/>
                      </a:lnTo>
                      <a:lnTo>
                        <a:pt x="438" y="513"/>
                      </a:lnTo>
                      <a:lnTo>
                        <a:pt x="438" y="523"/>
                      </a:lnTo>
                      <a:lnTo>
                        <a:pt x="438" y="532"/>
                      </a:lnTo>
                      <a:lnTo>
                        <a:pt x="439" y="541"/>
                      </a:lnTo>
                      <a:lnTo>
                        <a:pt x="439" y="550"/>
                      </a:lnTo>
                      <a:lnTo>
                        <a:pt x="439" y="558"/>
                      </a:lnTo>
                      <a:lnTo>
                        <a:pt x="440" y="567"/>
                      </a:lnTo>
                      <a:lnTo>
                        <a:pt x="440" y="576"/>
                      </a:lnTo>
                      <a:lnTo>
                        <a:pt x="440" y="584"/>
                      </a:lnTo>
                      <a:lnTo>
                        <a:pt x="441" y="592"/>
                      </a:lnTo>
                      <a:lnTo>
                        <a:pt x="441" y="600"/>
                      </a:lnTo>
                      <a:lnTo>
                        <a:pt x="441" y="608"/>
                      </a:lnTo>
                      <a:lnTo>
                        <a:pt x="442" y="615"/>
                      </a:lnTo>
                      <a:lnTo>
                        <a:pt x="442" y="623"/>
                      </a:lnTo>
                      <a:lnTo>
                        <a:pt x="442" y="630"/>
                      </a:lnTo>
                      <a:lnTo>
                        <a:pt x="443" y="637"/>
                      </a:lnTo>
                      <a:lnTo>
                        <a:pt x="443" y="644"/>
                      </a:lnTo>
                      <a:lnTo>
                        <a:pt x="443" y="651"/>
                      </a:lnTo>
                      <a:lnTo>
                        <a:pt x="444" y="658"/>
                      </a:lnTo>
                      <a:lnTo>
                        <a:pt x="444" y="664"/>
                      </a:lnTo>
                      <a:lnTo>
                        <a:pt x="445" y="671"/>
                      </a:lnTo>
                      <a:lnTo>
                        <a:pt x="445" y="677"/>
                      </a:lnTo>
                      <a:lnTo>
                        <a:pt x="445" y="683"/>
                      </a:lnTo>
                      <a:lnTo>
                        <a:pt x="445" y="689"/>
                      </a:lnTo>
                      <a:lnTo>
                        <a:pt x="446" y="695"/>
                      </a:lnTo>
                      <a:lnTo>
                        <a:pt x="446" y="701"/>
                      </a:lnTo>
                      <a:lnTo>
                        <a:pt x="447" y="706"/>
                      </a:lnTo>
                      <a:lnTo>
                        <a:pt x="447" y="712"/>
                      </a:lnTo>
                      <a:lnTo>
                        <a:pt x="447" y="718"/>
                      </a:lnTo>
                      <a:lnTo>
                        <a:pt x="448" y="724"/>
                      </a:lnTo>
                      <a:lnTo>
                        <a:pt x="448" y="729"/>
                      </a:lnTo>
                      <a:lnTo>
                        <a:pt x="448" y="735"/>
                      </a:lnTo>
                      <a:lnTo>
                        <a:pt x="449" y="740"/>
                      </a:lnTo>
                      <a:lnTo>
                        <a:pt x="449" y="745"/>
                      </a:lnTo>
                      <a:lnTo>
                        <a:pt x="450" y="750"/>
                      </a:lnTo>
                      <a:lnTo>
                        <a:pt x="450" y="755"/>
                      </a:lnTo>
                      <a:lnTo>
                        <a:pt x="450" y="759"/>
                      </a:lnTo>
                      <a:lnTo>
                        <a:pt x="451" y="763"/>
                      </a:lnTo>
                      <a:lnTo>
                        <a:pt x="451" y="768"/>
                      </a:lnTo>
                      <a:lnTo>
                        <a:pt x="452" y="772"/>
                      </a:lnTo>
                      <a:lnTo>
                        <a:pt x="452" y="776"/>
                      </a:lnTo>
                      <a:lnTo>
                        <a:pt x="452" y="781"/>
                      </a:lnTo>
                      <a:lnTo>
                        <a:pt x="453" y="785"/>
                      </a:lnTo>
                      <a:lnTo>
                        <a:pt x="453" y="788"/>
                      </a:lnTo>
                    </a:path>
                  </a:pathLst>
                </a:cu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4" name="Freeform 309"/>
                <p:cNvSpPr>
                  <a:spLocks/>
                </p:cNvSpPr>
                <p:nvPr/>
              </p:nvSpPr>
              <p:spPr bwMode="auto">
                <a:xfrm>
                  <a:off x="5745163" y="5921376"/>
                  <a:ext cx="2476500" cy="498475"/>
                </a:xfrm>
                <a:custGeom>
                  <a:avLst/>
                  <a:gdLst>
                    <a:gd name="T0" fmla="*/ 3 w 1560"/>
                    <a:gd name="T1" fmla="*/ 24 h 314"/>
                    <a:gd name="T2" fmla="*/ 7 w 1560"/>
                    <a:gd name="T3" fmla="*/ 45 h 314"/>
                    <a:gd name="T4" fmla="*/ 12 w 1560"/>
                    <a:gd name="T5" fmla="*/ 58 h 314"/>
                    <a:gd name="T6" fmla="*/ 22 w 1560"/>
                    <a:gd name="T7" fmla="*/ 67 h 314"/>
                    <a:gd name="T8" fmla="*/ 24 w 1560"/>
                    <a:gd name="T9" fmla="*/ 71 h 314"/>
                    <a:gd name="T10" fmla="*/ 34 w 1560"/>
                    <a:gd name="T11" fmla="*/ 87 h 314"/>
                    <a:gd name="T12" fmla="*/ 49 w 1560"/>
                    <a:gd name="T13" fmla="*/ 129 h 314"/>
                    <a:gd name="T14" fmla="*/ 61 w 1560"/>
                    <a:gd name="T15" fmla="*/ 155 h 314"/>
                    <a:gd name="T16" fmla="*/ 70 w 1560"/>
                    <a:gd name="T17" fmla="*/ 167 h 314"/>
                    <a:gd name="T18" fmla="*/ 86 w 1560"/>
                    <a:gd name="T19" fmla="*/ 180 h 314"/>
                    <a:gd name="T20" fmla="*/ 97 w 1560"/>
                    <a:gd name="T21" fmla="*/ 191 h 314"/>
                    <a:gd name="T22" fmla="*/ 108 w 1560"/>
                    <a:gd name="T23" fmla="*/ 208 h 314"/>
                    <a:gd name="T24" fmla="*/ 112 w 1560"/>
                    <a:gd name="T25" fmla="*/ 215 h 314"/>
                    <a:gd name="T26" fmla="*/ 122 w 1560"/>
                    <a:gd name="T27" fmla="*/ 232 h 314"/>
                    <a:gd name="T28" fmla="*/ 137 w 1560"/>
                    <a:gd name="T29" fmla="*/ 251 h 314"/>
                    <a:gd name="T30" fmla="*/ 148 w 1560"/>
                    <a:gd name="T31" fmla="*/ 262 h 314"/>
                    <a:gd name="T32" fmla="*/ 156 w 1560"/>
                    <a:gd name="T33" fmla="*/ 268 h 314"/>
                    <a:gd name="T34" fmla="*/ 167 w 1560"/>
                    <a:gd name="T35" fmla="*/ 274 h 314"/>
                    <a:gd name="T36" fmla="*/ 187 w 1560"/>
                    <a:gd name="T37" fmla="*/ 283 h 314"/>
                    <a:gd name="T38" fmla="*/ 200 w 1560"/>
                    <a:gd name="T39" fmla="*/ 287 h 314"/>
                    <a:gd name="T40" fmla="*/ 220 w 1560"/>
                    <a:gd name="T41" fmla="*/ 292 h 314"/>
                    <a:gd name="T42" fmla="*/ 232 w 1560"/>
                    <a:gd name="T43" fmla="*/ 295 h 314"/>
                    <a:gd name="T44" fmla="*/ 242 w 1560"/>
                    <a:gd name="T45" fmla="*/ 295 h 314"/>
                    <a:gd name="T46" fmla="*/ 254 w 1560"/>
                    <a:gd name="T47" fmla="*/ 294 h 314"/>
                    <a:gd name="T48" fmla="*/ 262 w 1560"/>
                    <a:gd name="T49" fmla="*/ 294 h 314"/>
                    <a:gd name="T50" fmla="*/ 271 w 1560"/>
                    <a:gd name="T51" fmla="*/ 295 h 314"/>
                    <a:gd name="T52" fmla="*/ 284 w 1560"/>
                    <a:gd name="T53" fmla="*/ 299 h 314"/>
                    <a:gd name="T54" fmla="*/ 292 w 1560"/>
                    <a:gd name="T55" fmla="*/ 301 h 314"/>
                    <a:gd name="T56" fmla="*/ 308 w 1560"/>
                    <a:gd name="T57" fmla="*/ 305 h 314"/>
                    <a:gd name="T58" fmla="*/ 327 w 1560"/>
                    <a:gd name="T59" fmla="*/ 308 h 314"/>
                    <a:gd name="T60" fmla="*/ 346 w 1560"/>
                    <a:gd name="T61" fmla="*/ 309 h 314"/>
                    <a:gd name="T62" fmla="*/ 378 w 1560"/>
                    <a:gd name="T63" fmla="*/ 311 h 314"/>
                    <a:gd name="T64" fmla="*/ 402 w 1560"/>
                    <a:gd name="T65" fmla="*/ 311 h 314"/>
                    <a:gd name="T66" fmla="*/ 421 w 1560"/>
                    <a:gd name="T67" fmla="*/ 311 h 314"/>
                    <a:gd name="T68" fmla="*/ 442 w 1560"/>
                    <a:gd name="T69" fmla="*/ 311 h 314"/>
                    <a:gd name="T70" fmla="*/ 462 w 1560"/>
                    <a:gd name="T71" fmla="*/ 312 h 314"/>
                    <a:gd name="T72" fmla="*/ 484 w 1560"/>
                    <a:gd name="T73" fmla="*/ 313 h 314"/>
                    <a:gd name="T74" fmla="*/ 509 w 1560"/>
                    <a:gd name="T75" fmla="*/ 313 h 314"/>
                    <a:gd name="T76" fmla="*/ 546 w 1560"/>
                    <a:gd name="T77" fmla="*/ 313 h 314"/>
                    <a:gd name="T78" fmla="*/ 574 w 1560"/>
                    <a:gd name="T79" fmla="*/ 313 h 314"/>
                    <a:gd name="T80" fmla="*/ 598 w 1560"/>
                    <a:gd name="T81" fmla="*/ 313 h 314"/>
                    <a:gd name="T82" fmla="*/ 634 w 1560"/>
                    <a:gd name="T83" fmla="*/ 311 h 314"/>
                    <a:gd name="T84" fmla="*/ 657 w 1560"/>
                    <a:gd name="T85" fmla="*/ 310 h 314"/>
                    <a:gd name="T86" fmla="*/ 682 w 1560"/>
                    <a:gd name="T87" fmla="*/ 309 h 314"/>
                    <a:gd name="T88" fmla="*/ 697 w 1560"/>
                    <a:gd name="T89" fmla="*/ 309 h 314"/>
                    <a:gd name="T90" fmla="*/ 722 w 1560"/>
                    <a:gd name="T91" fmla="*/ 311 h 314"/>
                    <a:gd name="T92" fmla="*/ 741 w 1560"/>
                    <a:gd name="T93" fmla="*/ 312 h 314"/>
                    <a:gd name="T94" fmla="*/ 767 w 1560"/>
                    <a:gd name="T95" fmla="*/ 313 h 314"/>
                    <a:gd name="T96" fmla="*/ 807 w 1560"/>
                    <a:gd name="T97" fmla="*/ 313 h 314"/>
                    <a:gd name="T98" fmla="*/ 847 w 1560"/>
                    <a:gd name="T99" fmla="*/ 314 h 314"/>
                    <a:gd name="T100" fmla="*/ 895 w 1560"/>
                    <a:gd name="T101" fmla="*/ 314 h 314"/>
                    <a:gd name="T102" fmla="*/ 972 w 1560"/>
                    <a:gd name="T103" fmla="*/ 314 h 314"/>
                    <a:gd name="T104" fmla="*/ 1062 w 1560"/>
                    <a:gd name="T105" fmla="*/ 314 h 314"/>
                    <a:gd name="T106" fmla="*/ 1120 w 1560"/>
                    <a:gd name="T107" fmla="*/ 313 h 314"/>
                    <a:gd name="T108" fmla="*/ 1188 w 1560"/>
                    <a:gd name="T109" fmla="*/ 313 h 314"/>
                    <a:gd name="T110" fmla="*/ 1242 w 1560"/>
                    <a:gd name="T111" fmla="*/ 313 h 314"/>
                    <a:gd name="T112" fmla="*/ 1280 w 1560"/>
                    <a:gd name="T113" fmla="*/ 313 h 314"/>
                    <a:gd name="T114" fmla="*/ 1322 w 1560"/>
                    <a:gd name="T115" fmla="*/ 312 h 314"/>
                    <a:gd name="T116" fmla="*/ 1370 w 1560"/>
                    <a:gd name="T117" fmla="*/ 312 h 314"/>
                    <a:gd name="T118" fmla="*/ 1399 w 1560"/>
                    <a:gd name="T119" fmla="*/ 311 h 314"/>
                    <a:gd name="T120" fmla="*/ 1427 w 1560"/>
                    <a:gd name="T121" fmla="*/ 311 h 314"/>
                    <a:gd name="T122" fmla="*/ 1476 w 1560"/>
                    <a:gd name="T123" fmla="*/ 311 h 314"/>
                    <a:gd name="T124" fmla="*/ 1515 w 1560"/>
                    <a:gd name="T125" fmla="*/ 311 h 31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  <a:cxn ang="0">
                      <a:pos x="T116" y="T117"/>
                    </a:cxn>
                    <a:cxn ang="0">
                      <a:pos x="T118" y="T119"/>
                    </a:cxn>
                    <a:cxn ang="0">
                      <a:pos x="T120" y="T121"/>
                    </a:cxn>
                    <a:cxn ang="0">
                      <a:pos x="T122" y="T123"/>
                    </a:cxn>
                    <a:cxn ang="0">
                      <a:pos x="T124" y="T125"/>
                    </a:cxn>
                  </a:cxnLst>
                  <a:rect l="0" t="0" r="r" b="b"/>
                  <a:pathLst>
                    <a:path w="1560" h="314">
                      <a:moveTo>
                        <a:pt x="0" y="0"/>
                      </a:moveTo>
                      <a:lnTo>
                        <a:pt x="1" y="4"/>
                      </a:lnTo>
                      <a:lnTo>
                        <a:pt x="1" y="8"/>
                      </a:lnTo>
                      <a:lnTo>
                        <a:pt x="2" y="11"/>
                      </a:lnTo>
                      <a:lnTo>
                        <a:pt x="2" y="15"/>
                      </a:lnTo>
                      <a:lnTo>
                        <a:pt x="2" y="18"/>
                      </a:lnTo>
                      <a:lnTo>
                        <a:pt x="3" y="21"/>
                      </a:lnTo>
                      <a:lnTo>
                        <a:pt x="3" y="24"/>
                      </a:lnTo>
                      <a:lnTo>
                        <a:pt x="4" y="27"/>
                      </a:lnTo>
                      <a:lnTo>
                        <a:pt x="4" y="30"/>
                      </a:lnTo>
                      <a:lnTo>
                        <a:pt x="5" y="33"/>
                      </a:lnTo>
                      <a:lnTo>
                        <a:pt x="5" y="35"/>
                      </a:lnTo>
                      <a:lnTo>
                        <a:pt x="6" y="38"/>
                      </a:lnTo>
                      <a:lnTo>
                        <a:pt x="6" y="40"/>
                      </a:lnTo>
                      <a:lnTo>
                        <a:pt x="7" y="42"/>
                      </a:lnTo>
                      <a:lnTo>
                        <a:pt x="7" y="45"/>
                      </a:lnTo>
                      <a:lnTo>
                        <a:pt x="8" y="47"/>
                      </a:lnTo>
                      <a:lnTo>
                        <a:pt x="9" y="48"/>
                      </a:lnTo>
                      <a:lnTo>
                        <a:pt x="9" y="50"/>
                      </a:lnTo>
                      <a:lnTo>
                        <a:pt x="10" y="52"/>
                      </a:lnTo>
                      <a:lnTo>
                        <a:pt x="10" y="54"/>
                      </a:lnTo>
                      <a:lnTo>
                        <a:pt x="11" y="55"/>
                      </a:lnTo>
                      <a:lnTo>
                        <a:pt x="12" y="56"/>
                      </a:lnTo>
                      <a:lnTo>
                        <a:pt x="12" y="58"/>
                      </a:lnTo>
                      <a:lnTo>
                        <a:pt x="13" y="59"/>
                      </a:lnTo>
                      <a:lnTo>
                        <a:pt x="14" y="60"/>
                      </a:lnTo>
                      <a:lnTo>
                        <a:pt x="15" y="61"/>
                      </a:lnTo>
                      <a:lnTo>
                        <a:pt x="16" y="62"/>
                      </a:lnTo>
                      <a:lnTo>
                        <a:pt x="17" y="64"/>
                      </a:lnTo>
                      <a:lnTo>
                        <a:pt x="19" y="65"/>
                      </a:lnTo>
                      <a:lnTo>
                        <a:pt x="20" y="67"/>
                      </a:lnTo>
                      <a:lnTo>
                        <a:pt x="22" y="67"/>
                      </a:lnTo>
                      <a:lnTo>
                        <a:pt x="22" y="68"/>
                      </a:lnTo>
                      <a:lnTo>
                        <a:pt x="22" y="68"/>
                      </a:lnTo>
                      <a:lnTo>
                        <a:pt x="23" y="69"/>
                      </a:lnTo>
                      <a:lnTo>
                        <a:pt x="23" y="69"/>
                      </a:lnTo>
                      <a:lnTo>
                        <a:pt x="23" y="69"/>
                      </a:lnTo>
                      <a:lnTo>
                        <a:pt x="24" y="70"/>
                      </a:lnTo>
                      <a:lnTo>
                        <a:pt x="24" y="70"/>
                      </a:lnTo>
                      <a:lnTo>
                        <a:pt x="24" y="71"/>
                      </a:lnTo>
                      <a:lnTo>
                        <a:pt x="26" y="72"/>
                      </a:lnTo>
                      <a:lnTo>
                        <a:pt x="27" y="74"/>
                      </a:lnTo>
                      <a:lnTo>
                        <a:pt x="28" y="75"/>
                      </a:lnTo>
                      <a:lnTo>
                        <a:pt x="29" y="77"/>
                      </a:lnTo>
                      <a:lnTo>
                        <a:pt x="30" y="79"/>
                      </a:lnTo>
                      <a:lnTo>
                        <a:pt x="31" y="82"/>
                      </a:lnTo>
                      <a:lnTo>
                        <a:pt x="32" y="84"/>
                      </a:lnTo>
                      <a:lnTo>
                        <a:pt x="34" y="87"/>
                      </a:lnTo>
                      <a:lnTo>
                        <a:pt x="35" y="91"/>
                      </a:lnTo>
                      <a:lnTo>
                        <a:pt x="36" y="94"/>
                      </a:lnTo>
                      <a:lnTo>
                        <a:pt x="38" y="99"/>
                      </a:lnTo>
                      <a:lnTo>
                        <a:pt x="40" y="104"/>
                      </a:lnTo>
                      <a:lnTo>
                        <a:pt x="42" y="112"/>
                      </a:lnTo>
                      <a:lnTo>
                        <a:pt x="45" y="119"/>
                      </a:lnTo>
                      <a:lnTo>
                        <a:pt x="47" y="124"/>
                      </a:lnTo>
                      <a:lnTo>
                        <a:pt x="49" y="129"/>
                      </a:lnTo>
                      <a:lnTo>
                        <a:pt x="50" y="133"/>
                      </a:lnTo>
                      <a:lnTo>
                        <a:pt x="52" y="137"/>
                      </a:lnTo>
                      <a:lnTo>
                        <a:pt x="53" y="140"/>
                      </a:lnTo>
                      <a:lnTo>
                        <a:pt x="55" y="144"/>
                      </a:lnTo>
                      <a:lnTo>
                        <a:pt x="56" y="147"/>
                      </a:lnTo>
                      <a:lnTo>
                        <a:pt x="58" y="150"/>
                      </a:lnTo>
                      <a:lnTo>
                        <a:pt x="59" y="153"/>
                      </a:lnTo>
                      <a:lnTo>
                        <a:pt x="61" y="155"/>
                      </a:lnTo>
                      <a:lnTo>
                        <a:pt x="62" y="158"/>
                      </a:lnTo>
                      <a:lnTo>
                        <a:pt x="64" y="160"/>
                      </a:lnTo>
                      <a:lnTo>
                        <a:pt x="66" y="162"/>
                      </a:lnTo>
                      <a:lnTo>
                        <a:pt x="67" y="164"/>
                      </a:lnTo>
                      <a:lnTo>
                        <a:pt x="68" y="165"/>
                      </a:lnTo>
                      <a:lnTo>
                        <a:pt x="69" y="165"/>
                      </a:lnTo>
                      <a:lnTo>
                        <a:pt x="69" y="166"/>
                      </a:lnTo>
                      <a:lnTo>
                        <a:pt x="70" y="167"/>
                      </a:lnTo>
                      <a:lnTo>
                        <a:pt x="72" y="169"/>
                      </a:lnTo>
                      <a:lnTo>
                        <a:pt x="73" y="170"/>
                      </a:lnTo>
                      <a:lnTo>
                        <a:pt x="75" y="172"/>
                      </a:lnTo>
                      <a:lnTo>
                        <a:pt x="77" y="173"/>
                      </a:lnTo>
                      <a:lnTo>
                        <a:pt x="79" y="175"/>
                      </a:lnTo>
                      <a:lnTo>
                        <a:pt x="81" y="176"/>
                      </a:lnTo>
                      <a:lnTo>
                        <a:pt x="84" y="178"/>
                      </a:lnTo>
                      <a:lnTo>
                        <a:pt x="86" y="180"/>
                      </a:lnTo>
                      <a:lnTo>
                        <a:pt x="88" y="181"/>
                      </a:lnTo>
                      <a:lnTo>
                        <a:pt x="90" y="182"/>
                      </a:lnTo>
                      <a:lnTo>
                        <a:pt x="91" y="184"/>
                      </a:lnTo>
                      <a:lnTo>
                        <a:pt x="92" y="185"/>
                      </a:lnTo>
                      <a:lnTo>
                        <a:pt x="94" y="186"/>
                      </a:lnTo>
                      <a:lnTo>
                        <a:pt x="95" y="188"/>
                      </a:lnTo>
                      <a:lnTo>
                        <a:pt x="96" y="189"/>
                      </a:lnTo>
                      <a:lnTo>
                        <a:pt x="97" y="191"/>
                      </a:lnTo>
                      <a:lnTo>
                        <a:pt x="99" y="192"/>
                      </a:lnTo>
                      <a:lnTo>
                        <a:pt x="100" y="194"/>
                      </a:lnTo>
                      <a:lnTo>
                        <a:pt x="101" y="196"/>
                      </a:lnTo>
                      <a:lnTo>
                        <a:pt x="102" y="198"/>
                      </a:lnTo>
                      <a:lnTo>
                        <a:pt x="104" y="200"/>
                      </a:lnTo>
                      <a:lnTo>
                        <a:pt x="105" y="203"/>
                      </a:lnTo>
                      <a:lnTo>
                        <a:pt x="107" y="206"/>
                      </a:lnTo>
                      <a:lnTo>
                        <a:pt x="108" y="208"/>
                      </a:lnTo>
                      <a:lnTo>
                        <a:pt x="109" y="209"/>
                      </a:lnTo>
                      <a:lnTo>
                        <a:pt x="109" y="210"/>
                      </a:lnTo>
                      <a:lnTo>
                        <a:pt x="110" y="211"/>
                      </a:lnTo>
                      <a:lnTo>
                        <a:pt x="110" y="212"/>
                      </a:lnTo>
                      <a:lnTo>
                        <a:pt x="111" y="213"/>
                      </a:lnTo>
                      <a:lnTo>
                        <a:pt x="111" y="214"/>
                      </a:lnTo>
                      <a:lnTo>
                        <a:pt x="112" y="214"/>
                      </a:lnTo>
                      <a:lnTo>
                        <a:pt x="112" y="215"/>
                      </a:lnTo>
                      <a:lnTo>
                        <a:pt x="112" y="216"/>
                      </a:lnTo>
                      <a:lnTo>
                        <a:pt x="113" y="217"/>
                      </a:lnTo>
                      <a:lnTo>
                        <a:pt x="115" y="221"/>
                      </a:lnTo>
                      <a:lnTo>
                        <a:pt x="117" y="223"/>
                      </a:lnTo>
                      <a:lnTo>
                        <a:pt x="118" y="226"/>
                      </a:lnTo>
                      <a:lnTo>
                        <a:pt x="120" y="228"/>
                      </a:lnTo>
                      <a:lnTo>
                        <a:pt x="121" y="230"/>
                      </a:lnTo>
                      <a:lnTo>
                        <a:pt x="122" y="232"/>
                      </a:lnTo>
                      <a:lnTo>
                        <a:pt x="124" y="234"/>
                      </a:lnTo>
                      <a:lnTo>
                        <a:pt x="125" y="236"/>
                      </a:lnTo>
                      <a:lnTo>
                        <a:pt x="127" y="239"/>
                      </a:lnTo>
                      <a:lnTo>
                        <a:pt x="129" y="241"/>
                      </a:lnTo>
                      <a:lnTo>
                        <a:pt x="131" y="243"/>
                      </a:lnTo>
                      <a:lnTo>
                        <a:pt x="133" y="246"/>
                      </a:lnTo>
                      <a:lnTo>
                        <a:pt x="135" y="249"/>
                      </a:lnTo>
                      <a:lnTo>
                        <a:pt x="137" y="251"/>
                      </a:lnTo>
                      <a:lnTo>
                        <a:pt x="139" y="253"/>
                      </a:lnTo>
                      <a:lnTo>
                        <a:pt x="140" y="254"/>
                      </a:lnTo>
                      <a:lnTo>
                        <a:pt x="142" y="256"/>
                      </a:lnTo>
                      <a:lnTo>
                        <a:pt x="143" y="257"/>
                      </a:lnTo>
                      <a:lnTo>
                        <a:pt x="145" y="259"/>
                      </a:lnTo>
                      <a:lnTo>
                        <a:pt x="146" y="260"/>
                      </a:lnTo>
                      <a:lnTo>
                        <a:pt x="147" y="261"/>
                      </a:lnTo>
                      <a:lnTo>
                        <a:pt x="148" y="262"/>
                      </a:lnTo>
                      <a:lnTo>
                        <a:pt x="150" y="263"/>
                      </a:lnTo>
                      <a:lnTo>
                        <a:pt x="151" y="264"/>
                      </a:lnTo>
                      <a:lnTo>
                        <a:pt x="152" y="265"/>
                      </a:lnTo>
                      <a:lnTo>
                        <a:pt x="153" y="266"/>
                      </a:lnTo>
                      <a:lnTo>
                        <a:pt x="154" y="267"/>
                      </a:lnTo>
                      <a:lnTo>
                        <a:pt x="155" y="267"/>
                      </a:lnTo>
                      <a:lnTo>
                        <a:pt x="155" y="268"/>
                      </a:lnTo>
                      <a:lnTo>
                        <a:pt x="156" y="268"/>
                      </a:lnTo>
                      <a:lnTo>
                        <a:pt x="156" y="268"/>
                      </a:lnTo>
                      <a:lnTo>
                        <a:pt x="157" y="268"/>
                      </a:lnTo>
                      <a:lnTo>
                        <a:pt x="157" y="269"/>
                      </a:lnTo>
                      <a:lnTo>
                        <a:pt x="159" y="270"/>
                      </a:lnTo>
                      <a:lnTo>
                        <a:pt x="160" y="271"/>
                      </a:lnTo>
                      <a:lnTo>
                        <a:pt x="162" y="271"/>
                      </a:lnTo>
                      <a:lnTo>
                        <a:pt x="164" y="272"/>
                      </a:lnTo>
                      <a:lnTo>
                        <a:pt x="167" y="274"/>
                      </a:lnTo>
                      <a:lnTo>
                        <a:pt x="170" y="275"/>
                      </a:lnTo>
                      <a:lnTo>
                        <a:pt x="174" y="277"/>
                      </a:lnTo>
                      <a:lnTo>
                        <a:pt x="177" y="279"/>
                      </a:lnTo>
                      <a:lnTo>
                        <a:pt x="179" y="279"/>
                      </a:lnTo>
                      <a:lnTo>
                        <a:pt x="181" y="281"/>
                      </a:lnTo>
                      <a:lnTo>
                        <a:pt x="183" y="281"/>
                      </a:lnTo>
                      <a:lnTo>
                        <a:pt x="185" y="282"/>
                      </a:lnTo>
                      <a:lnTo>
                        <a:pt x="187" y="283"/>
                      </a:lnTo>
                      <a:lnTo>
                        <a:pt x="190" y="284"/>
                      </a:lnTo>
                      <a:lnTo>
                        <a:pt x="192" y="284"/>
                      </a:lnTo>
                      <a:lnTo>
                        <a:pt x="195" y="285"/>
                      </a:lnTo>
                      <a:lnTo>
                        <a:pt x="196" y="286"/>
                      </a:lnTo>
                      <a:lnTo>
                        <a:pt x="198" y="286"/>
                      </a:lnTo>
                      <a:lnTo>
                        <a:pt x="199" y="286"/>
                      </a:lnTo>
                      <a:lnTo>
                        <a:pt x="200" y="286"/>
                      </a:lnTo>
                      <a:lnTo>
                        <a:pt x="200" y="287"/>
                      </a:lnTo>
                      <a:lnTo>
                        <a:pt x="201" y="287"/>
                      </a:lnTo>
                      <a:lnTo>
                        <a:pt x="204" y="288"/>
                      </a:lnTo>
                      <a:lnTo>
                        <a:pt x="209" y="289"/>
                      </a:lnTo>
                      <a:lnTo>
                        <a:pt x="213" y="290"/>
                      </a:lnTo>
                      <a:lnTo>
                        <a:pt x="215" y="291"/>
                      </a:lnTo>
                      <a:lnTo>
                        <a:pt x="217" y="291"/>
                      </a:lnTo>
                      <a:lnTo>
                        <a:pt x="219" y="292"/>
                      </a:lnTo>
                      <a:lnTo>
                        <a:pt x="220" y="292"/>
                      </a:lnTo>
                      <a:lnTo>
                        <a:pt x="222" y="293"/>
                      </a:lnTo>
                      <a:lnTo>
                        <a:pt x="224" y="293"/>
                      </a:lnTo>
                      <a:lnTo>
                        <a:pt x="225" y="294"/>
                      </a:lnTo>
                      <a:lnTo>
                        <a:pt x="227" y="294"/>
                      </a:lnTo>
                      <a:lnTo>
                        <a:pt x="228" y="294"/>
                      </a:lnTo>
                      <a:lnTo>
                        <a:pt x="230" y="294"/>
                      </a:lnTo>
                      <a:lnTo>
                        <a:pt x="231" y="294"/>
                      </a:lnTo>
                      <a:lnTo>
                        <a:pt x="232" y="295"/>
                      </a:lnTo>
                      <a:lnTo>
                        <a:pt x="234" y="295"/>
                      </a:lnTo>
                      <a:lnTo>
                        <a:pt x="235" y="295"/>
                      </a:lnTo>
                      <a:lnTo>
                        <a:pt x="236" y="295"/>
                      </a:lnTo>
                      <a:lnTo>
                        <a:pt x="238" y="295"/>
                      </a:lnTo>
                      <a:lnTo>
                        <a:pt x="239" y="295"/>
                      </a:lnTo>
                      <a:lnTo>
                        <a:pt x="240" y="295"/>
                      </a:lnTo>
                      <a:lnTo>
                        <a:pt x="241" y="295"/>
                      </a:lnTo>
                      <a:lnTo>
                        <a:pt x="242" y="295"/>
                      </a:lnTo>
                      <a:lnTo>
                        <a:pt x="243" y="295"/>
                      </a:lnTo>
                      <a:lnTo>
                        <a:pt x="245" y="295"/>
                      </a:lnTo>
                      <a:lnTo>
                        <a:pt x="246" y="295"/>
                      </a:lnTo>
                      <a:lnTo>
                        <a:pt x="247" y="295"/>
                      </a:lnTo>
                      <a:lnTo>
                        <a:pt x="249" y="295"/>
                      </a:lnTo>
                      <a:lnTo>
                        <a:pt x="250" y="294"/>
                      </a:lnTo>
                      <a:lnTo>
                        <a:pt x="253" y="294"/>
                      </a:lnTo>
                      <a:lnTo>
                        <a:pt x="254" y="294"/>
                      </a:lnTo>
                      <a:lnTo>
                        <a:pt x="255" y="294"/>
                      </a:lnTo>
                      <a:lnTo>
                        <a:pt x="257" y="294"/>
                      </a:lnTo>
                      <a:lnTo>
                        <a:pt x="258" y="294"/>
                      </a:lnTo>
                      <a:lnTo>
                        <a:pt x="259" y="294"/>
                      </a:lnTo>
                      <a:lnTo>
                        <a:pt x="260" y="294"/>
                      </a:lnTo>
                      <a:lnTo>
                        <a:pt x="260" y="294"/>
                      </a:lnTo>
                      <a:lnTo>
                        <a:pt x="261" y="294"/>
                      </a:lnTo>
                      <a:lnTo>
                        <a:pt x="262" y="294"/>
                      </a:lnTo>
                      <a:lnTo>
                        <a:pt x="263" y="294"/>
                      </a:lnTo>
                      <a:lnTo>
                        <a:pt x="264" y="294"/>
                      </a:lnTo>
                      <a:lnTo>
                        <a:pt x="265" y="294"/>
                      </a:lnTo>
                      <a:lnTo>
                        <a:pt x="266" y="294"/>
                      </a:lnTo>
                      <a:lnTo>
                        <a:pt x="267" y="294"/>
                      </a:lnTo>
                      <a:lnTo>
                        <a:pt x="268" y="295"/>
                      </a:lnTo>
                      <a:lnTo>
                        <a:pt x="270" y="295"/>
                      </a:lnTo>
                      <a:lnTo>
                        <a:pt x="271" y="295"/>
                      </a:lnTo>
                      <a:lnTo>
                        <a:pt x="272" y="296"/>
                      </a:lnTo>
                      <a:lnTo>
                        <a:pt x="273" y="296"/>
                      </a:lnTo>
                      <a:lnTo>
                        <a:pt x="275" y="296"/>
                      </a:lnTo>
                      <a:lnTo>
                        <a:pt x="276" y="297"/>
                      </a:lnTo>
                      <a:lnTo>
                        <a:pt x="278" y="298"/>
                      </a:lnTo>
                      <a:lnTo>
                        <a:pt x="281" y="298"/>
                      </a:lnTo>
                      <a:lnTo>
                        <a:pt x="283" y="299"/>
                      </a:lnTo>
                      <a:lnTo>
                        <a:pt x="284" y="299"/>
                      </a:lnTo>
                      <a:lnTo>
                        <a:pt x="285" y="300"/>
                      </a:lnTo>
                      <a:lnTo>
                        <a:pt x="286" y="300"/>
                      </a:lnTo>
                      <a:lnTo>
                        <a:pt x="287" y="300"/>
                      </a:lnTo>
                      <a:lnTo>
                        <a:pt x="288" y="300"/>
                      </a:lnTo>
                      <a:lnTo>
                        <a:pt x="288" y="301"/>
                      </a:lnTo>
                      <a:lnTo>
                        <a:pt x="288" y="301"/>
                      </a:lnTo>
                      <a:lnTo>
                        <a:pt x="290" y="301"/>
                      </a:lnTo>
                      <a:lnTo>
                        <a:pt x="292" y="301"/>
                      </a:lnTo>
                      <a:lnTo>
                        <a:pt x="294" y="302"/>
                      </a:lnTo>
                      <a:lnTo>
                        <a:pt x="296" y="303"/>
                      </a:lnTo>
                      <a:lnTo>
                        <a:pt x="298" y="303"/>
                      </a:lnTo>
                      <a:lnTo>
                        <a:pt x="300" y="304"/>
                      </a:lnTo>
                      <a:lnTo>
                        <a:pt x="302" y="304"/>
                      </a:lnTo>
                      <a:lnTo>
                        <a:pt x="304" y="304"/>
                      </a:lnTo>
                      <a:lnTo>
                        <a:pt x="306" y="305"/>
                      </a:lnTo>
                      <a:lnTo>
                        <a:pt x="308" y="305"/>
                      </a:lnTo>
                      <a:lnTo>
                        <a:pt x="310" y="306"/>
                      </a:lnTo>
                      <a:lnTo>
                        <a:pt x="313" y="306"/>
                      </a:lnTo>
                      <a:lnTo>
                        <a:pt x="315" y="306"/>
                      </a:lnTo>
                      <a:lnTo>
                        <a:pt x="317" y="307"/>
                      </a:lnTo>
                      <a:lnTo>
                        <a:pt x="320" y="307"/>
                      </a:lnTo>
                      <a:lnTo>
                        <a:pt x="322" y="307"/>
                      </a:lnTo>
                      <a:lnTo>
                        <a:pt x="325" y="308"/>
                      </a:lnTo>
                      <a:lnTo>
                        <a:pt x="327" y="308"/>
                      </a:lnTo>
                      <a:lnTo>
                        <a:pt x="329" y="308"/>
                      </a:lnTo>
                      <a:lnTo>
                        <a:pt x="331" y="308"/>
                      </a:lnTo>
                      <a:lnTo>
                        <a:pt x="332" y="308"/>
                      </a:lnTo>
                      <a:lnTo>
                        <a:pt x="333" y="309"/>
                      </a:lnTo>
                      <a:lnTo>
                        <a:pt x="336" y="309"/>
                      </a:lnTo>
                      <a:lnTo>
                        <a:pt x="340" y="309"/>
                      </a:lnTo>
                      <a:lnTo>
                        <a:pt x="343" y="309"/>
                      </a:lnTo>
                      <a:lnTo>
                        <a:pt x="346" y="309"/>
                      </a:lnTo>
                      <a:lnTo>
                        <a:pt x="350" y="310"/>
                      </a:lnTo>
                      <a:lnTo>
                        <a:pt x="354" y="310"/>
                      </a:lnTo>
                      <a:lnTo>
                        <a:pt x="358" y="310"/>
                      </a:lnTo>
                      <a:lnTo>
                        <a:pt x="363" y="310"/>
                      </a:lnTo>
                      <a:lnTo>
                        <a:pt x="368" y="311"/>
                      </a:lnTo>
                      <a:lnTo>
                        <a:pt x="373" y="311"/>
                      </a:lnTo>
                      <a:lnTo>
                        <a:pt x="375" y="311"/>
                      </a:lnTo>
                      <a:lnTo>
                        <a:pt x="378" y="311"/>
                      </a:lnTo>
                      <a:lnTo>
                        <a:pt x="381" y="311"/>
                      </a:lnTo>
                      <a:lnTo>
                        <a:pt x="384" y="311"/>
                      </a:lnTo>
                      <a:lnTo>
                        <a:pt x="388" y="311"/>
                      </a:lnTo>
                      <a:lnTo>
                        <a:pt x="391" y="311"/>
                      </a:lnTo>
                      <a:lnTo>
                        <a:pt x="394" y="311"/>
                      </a:lnTo>
                      <a:lnTo>
                        <a:pt x="397" y="311"/>
                      </a:lnTo>
                      <a:lnTo>
                        <a:pt x="399" y="311"/>
                      </a:lnTo>
                      <a:lnTo>
                        <a:pt x="402" y="311"/>
                      </a:lnTo>
                      <a:lnTo>
                        <a:pt x="404" y="311"/>
                      </a:lnTo>
                      <a:lnTo>
                        <a:pt x="406" y="311"/>
                      </a:lnTo>
                      <a:lnTo>
                        <a:pt x="408" y="311"/>
                      </a:lnTo>
                      <a:lnTo>
                        <a:pt x="411" y="311"/>
                      </a:lnTo>
                      <a:lnTo>
                        <a:pt x="413" y="311"/>
                      </a:lnTo>
                      <a:lnTo>
                        <a:pt x="415" y="311"/>
                      </a:lnTo>
                      <a:lnTo>
                        <a:pt x="418" y="311"/>
                      </a:lnTo>
                      <a:lnTo>
                        <a:pt x="421" y="311"/>
                      </a:lnTo>
                      <a:lnTo>
                        <a:pt x="424" y="311"/>
                      </a:lnTo>
                      <a:lnTo>
                        <a:pt x="427" y="311"/>
                      </a:lnTo>
                      <a:lnTo>
                        <a:pt x="429" y="311"/>
                      </a:lnTo>
                      <a:lnTo>
                        <a:pt x="431" y="311"/>
                      </a:lnTo>
                      <a:lnTo>
                        <a:pt x="434" y="311"/>
                      </a:lnTo>
                      <a:lnTo>
                        <a:pt x="436" y="311"/>
                      </a:lnTo>
                      <a:lnTo>
                        <a:pt x="439" y="311"/>
                      </a:lnTo>
                      <a:lnTo>
                        <a:pt x="442" y="311"/>
                      </a:lnTo>
                      <a:lnTo>
                        <a:pt x="445" y="311"/>
                      </a:lnTo>
                      <a:lnTo>
                        <a:pt x="447" y="311"/>
                      </a:lnTo>
                      <a:lnTo>
                        <a:pt x="450" y="311"/>
                      </a:lnTo>
                      <a:lnTo>
                        <a:pt x="454" y="311"/>
                      </a:lnTo>
                      <a:lnTo>
                        <a:pt x="457" y="312"/>
                      </a:lnTo>
                      <a:lnTo>
                        <a:pt x="459" y="312"/>
                      </a:lnTo>
                      <a:lnTo>
                        <a:pt x="461" y="312"/>
                      </a:lnTo>
                      <a:lnTo>
                        <a:pt x="462" y="312"/>
                      </a:lnTo>
                      <a:lnTo>
                        <a:pt x="463" y="312"/>
                      </a:lnTo>
                      <a:lnTo>
                        <a:pt x="465" y="312"/>
                      </a:lnTo>
                      <a:lnTo>
                        <a:pt x="468" y="312"/>
                      </a:lnTo>
                      <a:lnTo>
                        <a:pt x="471" y="312"/>
                      </a:lnTo>
                      <a:lnTo>
                        <a:pt x="475" y="313"/>
                      </a:lnTo>
                      <a:lnTo>
                        <a:pt x="478" y="313"/>
                      </a:lnTo>
                      <a:lnTo>
                        <a:pt x="481" y="313"/>
                      </a:lnTo>
                      <a:lnTo>
                        <a:pt x="484" y="313"/>
                      </a:lnTo>
                      <a:lnTo>
                        <a:pt x="487" y="313"/>
                      </a:lnTo>
                      <a:lnTo>
                        <a:pt x="491" y="313"/>
                      </a:lnTo>
                      <a:lnTo>
                        <a:pt x="494" y="313"/>
                      </a:lnTo>
                      <a:lnTo>
                        <a:pt x="497" y="313"/>
                      </a:lnTo>
                      <a:lnTo>
                        <a:pt x="501" y="313"/>
                      </a:lnTo>
                      <a:lnTo>
                        <a:pt x="504" y="313"/>
                      </a:lnTo>
                      <a:lnTo>
                        <a:pt x="506" y="313"/>
                      </a:lnTo>
                      <a:lnTo>
                        <a:pt x="509" y="313"/>
                      </a:lnTo>
                      <a:lnTo>
                        <a:pt x="513" y="313"/>
                      </a:lnTo>
                      <a:lnTo>
                        <a:pt x="517" y="313"/>
                      </a:lnTo>
                      <a:lnTo>
                        <a:pt x="522" y="313"/>
                      </a:lnTo>
                      <a:lnTo>
                        <a:pt x="528" y="313"/>
                      </a:lnTo>
                      <a:lnTo>
                        <a:pt x="533" y="313"/>
                      </a:lnTo>
                      <a:lnTo>
                        <a:pt x="538" y="313"/>
                      </a:lnTo>
                      <a:lnTo>
                        <a:pt x="542" y="313"/>
                      </a:lnTo>
                      <a:lnTo>
                        <a:pt x="546" y="313"/>
                      </a:lnTo>
                      <a:lnTo>
                        <a:pt x="548" y="313"/>
                      </a:lnTo>
                      <a:lnTo>
                        <a:pt x="551" y="313"/>
                      </a:lnTo>
                      <a:lnTo>
                        <a:pt x="554" y="313"/>
                      </a:lnTo>
                      <a:lnTo>
                        <a:pt x="558" y="313"/>
                      </a:lnTo>
                      <a:lnTo>
                        <a:pt x="561" y="313"/>
                      </a:lnTo>
                      <a:lnTo>
                        <a:pt x="565" y="313"/>
                      </a:lnTo>
                      <a:lnTo>
                        <a:pt x="569" y="313"/>
                      </a:lnTo>
                      <a:lnTo>
                        <a:pt x="574" y="313"/>
                      </a:lnTo>
                      <a:lnTo>
                        <a:pt x="579" y="313"/>
                      </a:lnTo>
                      <a:lnTo>
                        <a:pt x="584" y="313"/>
                      </a:lnTo>
                      <a:lnTo>
                        <a:pt x="588" y="313"/>
                      </a:lnTo>
                      <a:lnTo>
                        <a:pt x="590" y="313"/>
                      </a:lnTo>
                      <a:lnTo>
                        <a:pt x="591" y="313"/>
                      </a:lnTo>
                      <a:lnTo>
                        <a:pt x="593" y="313"/>
                      </a:lnTo>
                      <a:lnTo>
                        <a:pt x="595" y="313"/>
                      </a:lnTo>
                      <a:lnTo>
                        <a:pt x="598" y="313"/>
                      </a:lnTo>
                      <a:lnTo>
                        <a:pt x="601" y="312"/>
                      </a:lnTo>
                      <a:lnTo>
                        <a:pt x="605" y="312"/>
                      </a:lnTo>
                      <a:lnTo>
                        <a:pt x="609" y="312"/>
                      </a:lnTo>
                      <a:lnTo>
                        <a:pt x="615" y="312"/>
                      </a:lnTo>
                      <a:lnTo>
                        <a:pt x="622" y="312"/>
                      </a:lnTo>
                      <a:lnTo>
                        <a:pt x="628" y="311"/>
                      </a:lnTo>
                      <a:lnTo>
                        <a:pt x="632" y="311"/>
                      </a:lnTo>
                      <a:lnTo>
                        <a:pt x="634" y="311"/>
                      </a:lnTo>
                      <a:lnTo>
                        <a:pt x="635" y="311"/>
                      </a:lnTo>
                      <a:lnTo>
                        <a:pt x="636" y="311"/>
                      </a:lnTo>
                      <a:lnTo>
                        <a:pt x="637" y="311"/>
                      </a:lnTo>
                      <a:lnTo>
                        <a:pt x="639" y="311"/>
                      </a:lnTo>
                      <a:lnTo>
                        <a:pt x="644" y="311"/>
                      </a:lnTo>
                      <a:lnTo>
                        <a:pt x="649" y="311"/>
                      </a:lnTo>
                      <a:lnTo>
                        <a:pt x="653" y="311"/>
                      </a:lnTo>
                      <a:lnTo>
                        <a:pt x="657" y="310"/>
                      </a:lnTo>
                      <a:lnTo>
                        <a:pt x="660" y="310"/>
                      </a:lnTo>
                      <a:lnTo>
                        <a:pt x="664" y="310"/>
                      </a:lnTo>
                      <a:lnTo>
                        <a:pt x="669" y="310"/>
                      </a:lnTo>
                      <a:lnTo>
                        <a:pt x="673" y="309"/>
                      </a:lnTo>
                      <a:lnTo>
                        <a:pt x="675" y="309"/>
                      </a:lnTo>
                      <a:lnTo>
                        <a:pt x="678" y="309"/>
                      </a:lnTo>
                      <a:lnTo>
                        <a:pt x="680" y="309"/>
                      </a:lnTo>
                      <a:lnTo>
                        <a:pt x="682" y="309"/>
                      </a:lnTo>
                      <a:lnTo>
                        <a:pt x="683" y="309"/>
                      </a:lnTo>
                      <a:lnTo>
                        <a:pt x="685" y="309"/>
                      </a:lnTo>
                      <a:lnTo>
                        <a:pt x="687" y="309"/>
                      </a:lnTo>
                      <a:lnTo>
                        <a:pt x="689" y="309"/>
                      </a:lnTo>
                      <a:lnTo>
                        <a:pt x="691" y="309"/>
                      </a:lnTo>
                      <a:lnTo>
                        <a:pt x="693" y="309"/>
                      </a:lnTo>
                      <a:lnTo>
                        <a:pt x="695" y="309"/>
                      </a:lnTo>
                      <a:lnTo>
                        <a:pt x="697" y="309"/>
                      </a:lnTo>
                      <a:lnTo>
                        <a:pt x="699" y="309"/>
                      </a:lnTo>
                      <a:lnTo>
                        <a:pt x="702" y="310"/>
                      </a:lnTo>
                      <a:lnTo>
                        <a:pt x="706" y="310"/>
                      </a:lnTo>
                      <a:lnTo>
                        <a:pt x="711" y="310"/>
                      </a:lnTo>
                      <a:lnTo>
                        <a:pt x="716" y="311"/>
                      </a:lnTo>
                      <a:lnTo>
                        <a:pt x="719" y="311"/>
                      </a:lnTo>
                      <a:lnTo>
                        <a:pt x="721" y="311"/>
                      </a:lnTo>
                      <a:lnTo>
                        <a:pt x="722" y="311"/>
                      </a:lnTo>
                      <a:lnTo>
                        <a:pt x="723" y="311"/>
                      </a:lnTo>
                      <a:lnTo>
                        <a:pt x="725" y="311"/>
                      </a:lnTo>
                      <a:lnTo>
                        <a:pt x="728" y="312"/>
                      </a:lnTo>
                      <a:lnTo>
                        <a:pt x="730" y="312"/>
                      </a:lnTo>
                      <a:lnTo>
                        <a:pt x="733" y="312"/>
                      </a:lnTo>
                      <a:lnTo>
                        <a:pt x="736" y="312"/>
                      </a:lnTo>
                      <a:lnTo>
                        <a:pt x="738" y="312"/>
                      </a:lnTo>
                      <a:lnTo>
                        <a:pt x="741" y="312"/>
                      </a:lnTo>
                      <a:lnTo>
                        <a:pt x="744" y="312"/>
                      </a:lnTo>
                      <a:lnTo>
                        <a:pt x="747" y="313"/>
                      </a:lnTo>
                      <a:lnTo>
                        <a:pt x="750" y="313"/>
                      </a:lnTo>
                      <a:lnTo>
                        <a:pt x="753" y="313"/>
                      </a:lnTo>
                      <a:lnTo>
                        <a:pt x="757" y="313"/>
                      </a:lnTo>
                      <a:lnTo>
                        <a:pt x="760" y="313"/>
                      </a:lnTo>
                      <a:lnTo>
                        <a:pt x="764" y="313"/>
                      </a:lnTo>
                      <a:lnTo>
                        <a:pt x="767" y="313"/>
                      </a:lnTo>
                      <a:lnTo>
                        <a:pt x="770" y="313"/>
                      </a:lnTo>
                      <a:lnTo>
                        <a:pt x="774" y="313"/>
                      </a:lnTo>
                      <a:lnTo>
                        <a:pt x="780" y="313"/>
                      </a:lnTo>
                      <a:lnTo>
                        <a:pt x="785" y="313"/>
                      </a:lnTo>
                      <a:lnTo>
                        <a:pt x="790" y="313"/>
                      </a:lnTo>
                      <a:lnTo>
                        <a:pt x="797" y="313"/>
                      </a:lnTo>
                      <a:lnTo>
                        <a:pt x="803" y="313"/>
                      </a:lnTo>
                      <a:lnTo>
                        <a:pt x="807" y="313"/>
                      </a:lnTo>
                      <a:lnTo>
                        <a:pt x="810" y="313"/>
                      </a:lnTo>
                      <a:lnTo>
                        <a:pt x="813" y="313"/>
                      </a:lnTo>
                      <a:lnTo>
                        <a:pt x="817" y="313"/>
                      </a:lnTo>
                      <a:lnTo>
                        <a:pt x="821" y="313"/>
                      </a:lnTo>
                      <a:lnTo>
                        <a:pt x="827" y="313"/>
                      </a:lnTo>
                      <a:lnTo>
                        <a:pt x="833" y="313"/>
                      </a:lnTo>
                      <a:lnTo>
                        <a:pt x="840" y="314"/>
                      </a:lnTo>
                      <a:lnTo>
                        <a:pt x="847" y="314"/>
                      </a:lnTo>
                      <a:lnTo>
                        <a:pt x="852" y="314"/>
                      </a:lnTo>
                      <a:lnTo>
                        <a:pt x="855" y="314"/>
                      </a:lnTo>
                      <a:lnTo>
                        <a:pt x="859" y="314"/>
                      </a:lnTo>
                      <a:lnTo>
                        <a:pt x="863" y="314"/>
                      </a:lnTo>
                      <a:lnTo>
                        <a:pt x="868" y="314"/>
                      </a:lnTo>
                      <a:lnTo>
                        <a:pt x="875" y="314"/>
                      </a:lnTo>
                      <a:lnTo>
                        <a:pt x="885" y="314"/>
                      </a:lnTo>
                      <a:lnTo>
                        <a:pt x="895" y="314"/>
                      </a:lnTo>
                      <a:lnTo>
                        <a:pt x="905" y="314"/>
                      </a:lnTo>
                      <a:lnTo>
                        <a:pt x="912" y="314"/>
                      </a:lnTo>
                      <a:lnTo>
                        <a:pt x="920" y="314"/>
                      </a:lnTo>
                      <a:lnTo>
                        <a:pt x="932" y="314"/>
                      </a:lnTo>
                      <a:lnTo>
                        <a:pt x="944" y="314"/>
                      </a:lnTo>
                      <a:lnTo>
                        <a:pt x="953" y="314"/>
                      </a:lnTo>
                      <a:lnTo>
                        <a:pt x="962" y="314"/>
                      </a:lnTo>
                      <a:lnTo>
                        <a:pt x="972" y="314"/>
                      </a:lnTo>
                      <a:lnTo>
                        <a:pt x="984" y="314"/>
                      </a:lnTo>
                      <a:lnTo>
                        <a:pt x="999" y="314"/>
                      </a:lnTo>
                      <a:lnTo>
                        <a:pt x="1013" y="314"/>
                      </a:lnTo>
                      <a:lnTo>
                        <a:pt x="1025" y="314"/>
                      </a:lnTo>
                      <a:lnTo>
                        <a:pt x="1035" y="314"/>
                      </a:lnTo>
                      <a:lnTo>
                        <a:pt x="1045" y="313"/>
                      </a:lnTo>
                      <a:lnTo>
                        <a:pt x="1053" y="314"/>
                      </a:lnTo>
                      <a:lnTo>
                        <a:pt x="1062" y="314"/>
                      </a:lnTo>
                      <a:lnTo>
                        <a:pt x="1072" y="314"/>
                      </a:lnTo>
                      <a:lnTo>
                        <a:pt x="1079" y="314"/>
                      </a:lnTo>
                      <a:lnTo>
                        <a:pt x="1087" y="314"/>
                      </a:lnTo>
                      <a:lnTo>
                        <a:pt x="1095" y="313"/>
                      </a:lnTo>
                      <a:lnTo>
                        <a:pt x="1103" y="313"/>
                      </a:lnTo>
                      <a:lnTo>
                        <a:pt x="1110" y="313"/>
                      </a:lnTo>
                      <a:lnTo>
                        <a:pt x="1115" y="313"/>
                      </a:lnTo>
                      <a:lnTo>
                        <a:pt x="1120" y="313"/>
                      </a:lnTo>
                      <a:lnTo>
                        <a:pt x="1125" y="313"/>
                      </a:lnTo>
                      <a:lnTo>
                        <a:pt x="1132" y="313"/>
                      </a:lnTo>
                      <a:lnTo>
                        <a:pt x="1141" y="313"/>
                      </a:lnTo>
                      <a:lnTo>
                        <a:pt x="1149" y="313"/>
                      </a:lnTo>
                      <a:lnTo>
                        <a:pt x="1160" y="313"/>
                      </a:lnTo>
                      <a:lnTo>
                        <a:pt x="1170" y="313"/>
                      </a:lnTo>
                      <a:lnTo>
                        <a:pt x="1179" y="313"/>
                      </a:lnTo>
                      <a:lnTo>
                        <a:pt x="1188" y="313"/>
                      </a:lnTo>
                      <a:lnTo>
                        <a:pt x="1198" y="313"/>
                      </a:lnTo>
                      <a:lnTo>
                        <a:pt x="1208" y="313"/>
                      </a:lnTo>
                      <a:lnTo>
                        <a:pt x="1214" y="313"/>
                      </a:lnTo>
                      <a:lnTo>
                        <a:pt x="1220" y="313"/>
                      </a:lnTo>
                      <a:lnTo>
                        <a:pt x="1227" y="313"/>
                      </a:lnTo>
                      <a:lnTo>
                        <a:pt x="1234" y="313"/>
                      </a:lnTo>
                      <a:lnTo>
                        <a:pt x="1238" y="313"/>
                      </a:lnTo>
                      <a:lnTo>
                        <a:pt x="1242" y="313"/>
                      </a:lnTo>
                      <a:lnTo>
                        <a:pt x="1245" y="313"/>
                      </a:lnTo>
                      <a:lnTo>
                        <a:pt x="1247" y="313"/>
                      </a:lnTo>
                      <a:lnTo>
                        <a:pt x="1249" y="313"/>
                      </a:lnTo>
                      <a:lnTo>
                        <a:pt x="1253" y="313"/>
                      </a:lnTo>
                      <a:lnTo>
                        <a:pt x="1258" y="313"/>
                      </a:lnTo>
                      <a:lnTo>
                        <a:pt x="1263" y="313"/>
                      </a:lnTo>
                      <a:lnTo>
                        <a:pt x="1271" y="313"/>
                      </a:lnTo>
                      <a:lnTo>
                        <a:pt x="1280" y="313"/>
                      </a:lnTo>
                      <a:lnTo>
                        <a:pt x="1285" y="312"/>
                      </a:lnTo>
                      <a:lnTo>
                        <a:pt x="1288" y="312"/>
                      </a:lnTo>
                      <a:lnTo>
                        <a:pt x="1290" y="312"/>
                      </a:lnTo>
                      <a:lnTo>
                        <a:pt x="1294" y="312"/>
                      </a:lnTo>
                      <a:lnTo>
                        <a:pt x="1303" y="312"/>
                      </a:lnTo>
                      <a:lnTo>
                        <a:pt x="1310" y="312"/>
                      </a:lnTo>
                      <a:lnTo>
                        <a:pt x="1316" y="312"/>
                      </a:lnTo>
                      <a:lnTo>
                        <a:pt x="1322" y="312"/>
                      </a:lnTo>
                      <a:lnTo>
                        <a:pt x="1328" y="312"/>
                      </a:lnTo>
                      <a:lnTo>
                        <a:pt x="1332" y="312"/>
                      </a:lnTo>
                      <a:lnTo>
                        <a:pt x="1337" y="312"/>
                      </a:lnTo>
                      <a:lnTo>
                        <a:pt x="1344" y="312"/>
                      </a:lnTo>
                      <a:lnTo>
                        <a:pt x="1352" y="312"/>
                      </a:lnTo>
                      <a:lnTo>
                        <a:pt x="1359" y="312"/>
                      </a:lnTo>
                      <a:lnTo>
                        <a:pt x="1365" y="312"/>
                      </a:lnTo>
                      <a:lnTo>
                        <a:pt x="1370" y="312"/>
                      </a:lnTo>
                      <a:lnTo>
                        <a:pt x="1373" y="312"/>
                      </a:lnTo>
                      <a:lnTo>
                        <a:pt x="1375" y="312"/>
                      </a:lnTo>
                      <a:lnTo>
                        <a:pt x="1378" y="312"/>
                      </a:lnTo>
                      <a:lnTo>
                        <a:pt x="1381" y="312"/>
                      </a:lnTo>
                      <a:lnTo>
                        <a:pt x="1385" y="312"/>
                      </a:lnTo>
                      <a:lnTo>
                        <a:pt x="1389" y="312"/>
                      </a:lnTo>
                      <a:lnTo>
                        <a:pt x="1394" y="312"/>
                      </a:lnTo>
                      <a:lnTo>
                        <a:pt x="1399" y="311"/>
                      </a:lnTo>
                      <a:lnTo>
                        <a:pt x="1404" y="311"/>
                      </a:lnTo>
                      <a:lnTo>
                        <a:pt x="1409" y="311"/>
                      </a:lnTo>
                      <a:lnTo>
                        <a:pt x="1413" y="311"/>
                      </a:lnTo>
                      <a:lnTo>
                        <a:pt x="1416" y="311"/>
                      </a:lnTo>
                      <a:lnTo>
                        <a:pt x="1418" y="311"/>
                      </a:lnTo>
                      <a:lnTo>
                        <a:pt x="1420" y="311"/>
                      </a:lnTo>
                      <a:lnTo>
                        <a:pt x="1424" y="311"/>
                      </a:lnTo>
                      <a:lnTo>
                        <a:pt x="1427" y="311"/>
                      </a:lnTo>
                      <a:lnTo>
                        <a:pt x="1434" y="311"/>
                      </a:lnTo>
                      <a:lnTo>
                        <a:pt x="1442" y="311"/>
                      </a:lnTo>
                      <a:lnTo>
                        <a:pt x="1451" y="311"/>
                      </a:lnTo>
                      <a:lnTo>
                        <a:pt x="1459" y="311"/>
                      </a:lnTo>
                      <a:lnTo>
                        <a:pt x="1463" y="311"/>
                      </a:lnTo>
                      <a:lnTo>
                        <a:pt x="1466" y="311"/>
                      </a:lnTo>
                      <a:lnTo>
                        <a:pt x="1471" y="311"/>
                      </a:lnTo>
                      <a:lnTo>
                        <a:pt x="1476" y="311"/>
                      </a:lnTo>
                      <a:lnTo>
                        <a:pt x="1481" y="311"/>
                      </a:lnTo>
                      <a:lnTo>
                        <a:pt x="1487" y="311"/>
                      </a:lnTo>
                      <a:lnTo>
                        <a:pt x="1494" y="311"/>
                      </a:lnTo>
                      <a:lnTo>
                        <a:pt x="1500" y="311"/>
                      </a:lnTo>
                      <a:lnTo>
                        <a:pt x="1505" y="311"/>
                      </a:lnTo>
                      <a:lnTo>
                        <a:pt x="1507" y="311"/>
                      </a:lnTo>
                      <a:lnTo>
                        <a:pt x="1511" y="311"/>
                      </a:lnTo>
                      <a:lnTo>
                        <a:pt x="1515" y="311"/>
                      </a:lnTo>
                      <a:lnTo>
                        <a:pt x="1519" y="311"/>
                      </a:lnTo>
                      <a:lnTo>
                        <a:pt x="1526" y="311"/>
                      </a:lnTo>
                      <a:lnTo>
                        <a:pt x="1535" y="311"/>
                      </a:lnTo>
                      <a:lnTo>
                        <a:pt x="1542" y="311"/>
                      </a:lnTo>
                      <a:lnTo>
                        <a:pt x="1550" y="311"/>
                      </a:lnTo>
                      <a:lnTo>
                        <a:pt x="1555" y="311"/>
                      </a:lnTo>
                      <a:lnTo>
                        <a:pt x="1560" y="311"/>
                      </a:lnTo>
                    </a:path>
                  </a:pathLst>
                </a:cu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5" name="Freeform 311"/>
                <p:cNvSpPr>
                  <a:spLocks/>
                </p:cNvSpPr>
                <p:nvPr/>
              </p:nvSpPr>
              <p:spPr bwMode="auto">
                <a:xfrm>
                  <a:off x="8221663" y="6367463"/>
                  <a:ext cx="2832100" cy="79375"/>
                </a:xfrm>
                <a:custGeom>
                  <a:avLst/>
                  <a:gdLst>
                    <a:gd name="T0" fmla="*/ 33 w 1784"/>
                    <a:gd name="T1" fmla="*/ 30 h 50"/>
                    <a:gd name="T2" fmla="*/ 79 w 1784"/>
                    <a:gd name="T3" fmla="*/ 30 h 50"/>
                    <a:gd name="T4" fmla="*/ 127 w 1784"/>
                    <a:gd name="T5" fmla="*/ 29 h 50"/>
                    <a:gd name="T6" fmla="*/ 168 w 1784"/>
                    <a:gd name="T7" fmla="*/ 29 h 50"/>
                    <a:gd name="T8" fmla="*/ 213 w 1784"/>
                    <a:gd name="T9" fmla="*/ 28 h 50"/>
                    <a:gd name="T10" fmla="*/ 268 w 1784"/>
                    <a:gd name="T11" fmla="*/ 28 h 50"/>
                    <a:gd name="T12" fmla="*/ 364 w 1784"/>
                    <a:gd name="T13" fmla="*/ 28 h 50"/>
                    <a:gd name="T14" fmla="*/ 481 w 1784"/>
                    <a:gd name="T15" fmla="*/ 28 h 50"/>
                    <a:gd name="T16" fmla="*/ 575 w 1784"/>
                    <a:gd name="T17" fmla="*/ 28 h 50"/>
                    <a:gd name="T18" fmla="*/ 631 w 1784"/>
                    <a:gd name="T19" fmla="*/ 27 h 50"/>
                    <a:gd name="T20" fmla="*/ 704 w 1784"/>
                    <a:gd name="T21" fmla="*/ 27 h 50"/>
                    <a:gd name="T22" fmla="*/ 782 w 1784"/>
                    <a:gd name="T23" fmla="*/ 27 h 50"/>
                    <a:gd name="T24" fmla="*/ 834 w 1784"/>
                    <a:gd name="T25" fmla="*/ 27 h 50"/>
                    <a:gd name="T26" fmla="*/ 885 w 1784"/>
                    <a:gd name="T27" fmla="*/ 26 h 50"/>
                    <a:gd name="T28" fmla="*/ 944 w 1784"/>
                    <a:gd name="T29" fmla="*/ 26 h 50"/>
                    <a:gd name="T30" fmla="*/ 988 w 1784"/>
                    <a:gd name="T31" fmla="*/ 25 h 50"/>
                    <a:gd name="T32" fmla="*/ 1026 w 1784"/>
                    <a:gd name="T33" fmla="*/ 25 h 50"/>
                    <a:gd name="T34" fmla="*/ 1075 w 1784"/>
                    <a:gd name="T35" fmla="*/ 25 h 50"/>
                    <a:gd name="T36" fmla="*/ 1119 w 1784"/>
                    <a:gd name="T37" fmla="*/ 24 h 50"/>
                    <a:gd name="T38" fmla="*/ 1171 w 1784"/>
                    <a:gd name="T39" fmla="*/ 24 h 50"/>
                    <a:gd name="T40" fmla="*/ 1211 w 1784"/>
                    <a:gd name="T41" fmla="*/ 24 h 50"/>
                    <a:gd name="T42" fmla="*/ 1255 w 1784"/>
                    <a:gd name="T43" fmla="*/ 23 h 50"/>
                    <a:gd name="T44" fmla="*/ 1298 w 1784"/>
                    <a:gd name="T45" fmla="*/ 23 h 50"/>
                    <a:gd name="T46" fmla="*/ 1342 w 1784"/>
                    <a:gd name="T47" fmla="*/ 22 h 50"/>
                    <a:gd name="T48" fmla="*/ 1380 w 1784"/>
                    <a:gd name="T49" fmla="*/ 22 h 50"/>
                    <a:gd name="T50" fmla="*/ 1412 w 1784"/>
                    <a:gd name="T51" fmla="*/ 21 h 50"/>
                    <a:gd name="T52" fmla="*/ 1436 w 1784"/>
                    <a:gd name="T53" fmla="*/ 20 h 50"/>
                    <a:gd name="T54" fmla="*/ 1457 w 1784"/>
                    <a:gd name="T55" fmla="*/ 20 h 50"/>
                    <a:gd name="T56" fmla="*/ 1467 w 1784"/>
                    <a:gd name="T57" fmla="*/ 19 h 50"/>
                    <a:gd name="T58" fmla="*/ 1473 w 1784"/>
                    <a:gd name="T59" fmla="*/ 18 h 50"/>
                    <a:gd name="T60" fmla="*/ 1483 w 1784"/>
                    <a:gd name="T61" fmla="*/ 16 h 50"/>
                    <a:gd name="T62" fmla="*/ 1494 w 1784"/>
                    <a:gd name="T63" fmla="*/ 13 h 50"/>
                    <a:gd name="T64" fmla="*/ 1508 w 1784"/>
                    <a:gd name="T65" fmla="*/ 9 h 50"/>
                    <a:gd name="T66" fmla="*/ 1511 w 1784"/>
                    <a:gd name="T67" fmla="*/ 7 h 50"/>
                    <a:gd name="T68" fmla="*/ 1527 w 1784"/>
                    <a:gd name="T69" fmla="*/ 3 h 50"/>
                    <a:gd name="T70" fmla="*/ 1538 w 1784"/>
                    <a:gd name="T71" fmla="*/ 0 h 50"/>
                    <a:gd name="T72" fmla="*/ 1549 w 1784"/>
                    <a:gd name="T73" fmla="*/ 0 h 50"/>
                    <a:gd name="T74" fmla="*/ 1553 w 1784"/>
                    <a:gd name="T75" fmla="*/ 0 h 50"/>
                    <a:gd name="T76" fmla="*/ 1562 w 1784"/>
                    <a:gd name="T77" fmla="*/ 2 h 50"/>
                    <a:gd name="T78" fmla="*/ 1574 w 1784"/>
                    <a:gd name="T79" fmla="*/ 5 h 50"/>
                    <a:gd name="T80" fmla="*/ 1590 w 1784"/>
                    <a:gd name="T81" fmla="*/ 12 h 50"/>
                    <a:gd name="T82" fmla="*/ 1596 w 1784"/>
                    <a:gd name="T83" fmla="*/ 15 h 50"/>
                    <a:gd name="T84" fmla="*/ 1598 w 1784"/>
                    <a:gd name="T85" fmla="*/ 15 h 50"/>
                    <a:gd name="T86" fmla="*/ 1612 w 1784"/>
                    <a:gd name="T87" fmla="*/ 22 h 50"/>
                    <a:gd name="T88" fmla="*/ 1627 w 1784"/>
                    <a:gd name="T89" fmla="*/ 27 h 50"/>
                    <a:gd name="T90" fmla="*/ 1638 w 1784"/>
                    <a:gd name="T91" fmla="*/ 31 h 50"/>
                    <a:gd name="T92" fmla="*/ 1642 w 1784"/>
                    <a:gd name="T93" fmla="*/ 32 h 50"/>
                    <a:gd name="T94" fmla="*/ 1646 w 1784"/>
                    <a:gd name="T95" fmla="*/ 33 h 50"/>
                    <a:gd name="T96" fmla="*/ 1656 w 1784"/>
                    <a:gd name="T97" fmla="*/ 36 h 50"/>
                    <a:gd name="T98" fmla="*/ 1667 w 1784"/>
                    <a:gd name="T99" fmla="*/ 39 h 50"/>
                    <a:gd name="T100" fmla="*/ 1677 w 1784"/>
                    <a:gd name="T101" fmla="*/ 41 h 50"/>
                    <a:gd name="T102" fmla="*/ 1683 w 1784"/>
                    <a:gd name="T103" fmla="*/ 42 h 50"/>
                    <a:gd name="T104" fmla="*/ 1687 w 1784"/>
                    <a:gd name="T105" fmla="*/ 42 h 50"/>
                    <a:gd name="T106" fmla="*/ 1692 w 1784"/>
                    <a:gd name="T107" fmla="*/ 43 h 50"/>
                    <a:gd name="T108" fmla="*/ 1702 w 1784"/>
                    <a:gd name="T109" fmla="*/ 44 h 50"/>
                    <a:gd name="T110" fmla="*/ 1713 w 1784"/>
                    <a:gd name="T111" fmla="*/ 45 h 50"/>
                    <a:gd name="T112" fmla="*/ 1722 w 1784"/>
                    <a:gd name="T113" fmla="*/ 46 h 50"/>
                    <a:gd name="T114" fmla="*/ 1729 w 1784"/>
                    <a:gd name="T115" fmla="*/ 47 h 50"/>
                    <a:gd name="T116" fmla="*/ 1734 w 1784"/>
                    <a:gd name="T117" fmla="*/ 47 h 50"/>
                    <a:gd name="T118" fmla="*/ 1747 w 1784"/>
                    <a:gd name="T119" fmla="*/ 48 h 50"/>
                    <a:gd name="T120" fmla="*/ 1760 w 1784"/>
                    <a:gd name="T121" fmla="*/ 49 h 50"/>
                    <a:gd name="T122" fmla="*/ 1772 w 1784"/>
                    <a:gd name="T123" fmla="*/ 49 h 50"/>
                    <a:gd name="T124" fmla="*/ 1784 w 1784"/>
                    <a:gd name="T125" fmla="*/ 50 h 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  <a:cxn ang="0">
                      <a:pos x="T116" y="T117"/>
                    </a:cxn>
                    <a:cxn ang="0">
                      <a:pos x="T118" y="T119"/>
                    </a:cxn>
                    <a:cxn ang="0">
                      <a:pos x="T120" y="T121"/>
                    </a:cxn>
                    <a:cxn ang="0">
                      <a:pos x="T122" y="T123"/>
                    </a:cxn>
                    <a:cxn ang="0">
                      <a:pos x="T124" y="T125"/>
                    </a:cxn>
                  </a:cxnLst>
                  <a:rect l="0" t="0" r="r" b="b"/>
                  <a:pathLst>
                    <a:path w="1784" h="50">
                      <a:moveTo>
                        <a:pt x="0" y="30"/>
                      </a:moveTo>
                      <a:lnTo>
                        <a:pt x="5" y="30"/>
                      </a:lnTo>
                      <a:lnTo>
                        <a:pt x="12" y="30"/>
                      </a:lnTo>
                      <a:lnTo>
                        <a:pt x="18" y="30"/>
                      </a:lnTo>
                      <a:lnTo>
                        <a:pt x="25" y="30"/>
                      </a:lnTo>
                      <a:lnTo>
                        <a:pt x="33" y="30"/>
                      </a:lnTo>
                      <a:lnTo>
                        <a:pt x="41" y="30"/>
                      </a:lnTo>
                      <a:lnTo>
                        <a:pt x="54" y="30"/>
                      </a:lnTo>
                      <a:lnTo>
                        <a:pt x="65" y="30"/>
                      </a:lnTo>
                      <a:lnTo>
                        <a:pt x="71" y="30"/>
                      </a:lnTo>
                      <a:lnTo>
                        <a:pt x="76" y="30"/>
                      </a:lnTo>
                      <a:lnTo>
                        <a:pt x="79" y="30"/>
                      </a:lnTo>
                      <a:lnTo>
                        <a:pt x="85" y="30"/>
                      </a:lnTo>
                      <a:lnTo>
                        <a:pt x="95" y="30"/>
                      </a:lnTo>
                      <a:lnTo>
                        <a:pt x="108" y="29"/>
                      </a:lnTo>
                      <a:lnTo>
                        <a:pt x="117" y="29"/>
                      </a:lnTo>
                      <a:lnTo>
                        <a:pt x="122" y="29"/>
                      </a:lnTo>
                      <a:lnTo>
                        <a:pt x="127" y="29"/>
                      </a:lnTo>
                      <a:lnTo>
                        <a:pt x="134" y="29"/>
                      </a:lnTo>
                      <a:lnTo>
                        <a:pt x="143" y="29"/>
                      </a:lnTo>
                      <a:lnTo>
                        <a:pt x="153" y="29"/>
                      </a:lnTo>
                      <a:lnTo>
                        <a:pt x="161" y="29"/>
                      </a:lnTo>
                      <a:lnTo>
                        <a:pt x="163" y="29"/>
                      </a:lnTo>
                      <a:lnTo>
                        <a:pt x="168" y="29"/>
                      </a:lnTo>
                      <a:lnTo>
                        <a:pt x="177" y="29"/>
                      </a:lnTo>
                      <a:lnTo>
                        <a:pt x="188" y="28"/>
                      </a:lnTo>
                      <a:lnTo>
                        <a:pt x="199" y="28"/>
                      </a:lnTo>
                      <a:lnTo>
                        <a:pt x="204" y="28"/>
                      </a:lnTo>
                      <a:lnTo>
                        <a:pt x="207" y="28"/>
                      </a:lnTo>
                      <a:lnTo>
                        <a:pt x="213" y="28"/>
                      </a:lnTo>
                      <a:lnTo>
                        <a:pt x="221" y="28"/>
                      </a:lnTo>
                      <a:lnTo>
                        <a:pt x="230" y="28"/>
                      </a:lnTo>
                      <a:lnTo>
                        <a:pt x="240" y="28"/>
                      </a:lnTo>
                      <a:lnTo>
                        <a:pt x="249" y="28"/>
                      </a:lnTo>
                      <a:lnTo>
                        <a:pt x="259" y="28"/>
                      </a:lnTo>
                      <a:lnTo>
                        <a:pt x="268" y="28"/>
                      </a:lnTo>
                      <a:lnTo>
                        <a:pt x="281" y="28"/>
                      </a:lnTo>
                      <a:lnTo>
                        <a:pt x="297" y="28"/>
                      </a:lnTo>
                      <a:lnTo>
                        <a:pt x="312" y="28"/>
                      </a:lnTo>
                      <a:lnTo>
                        <a:pt x="331" y="28"/>
                      </a:lnTo>
                      <a:lnTo>
                        <a:pt x="348" y="28"/>
                      </a:lnTo>
                      <a:lnTo>
                        <a:pt x="364" y="28"/>
                      </a:lnTo>
                      <a:lnTo>
                        <a:pt x="381" y="28"/>
                      </a:lnTo>
                      <a:lnTo>
                        <a:pt x="401" y="28"/>
                      </a:lnTo>
                      <a:lnTo>
                        <a:pt x="423" y="28"/>
                      </a:lnTo>
                      <a:lnTo>
                        <a:pt x="446" y="28"/>
                      </a:lnTo>
                      <a:lnTo>
                        <a:pt x="465" y="28"/>
                      </a:lnTo>
                      <a:lnTo>
                        <a:pt x="481" y="28"/>
                      </a:lnTo>
                      <a:lnTo>
                        <a:pt x="496" y="28"/>
                      </a:lnTo>
                      <a:lnTo>
                        <a:pt x="510" y="28"/>
                      </a:lnTo>
                      <a:lnTo>
                        <a:pt x="524" y="28"/>
                      </a:lnTo>
                      <a:lnTo>
                        <a:pt x="541" y="28"/>
                      </a:lnTo>
                      <a:lnTo>
                        <a:pt x="559" y="28"/>
                      </a:lnTo>
                      <a:lnTo>
                        <a:pt x="575" y="28"/>
                      </a:lnTo>
                      <a:lnTo>
                        <a:pt x="589" y="28"/>
                      </a:lnTo>
                      <a:lnTo>
                        <a:pt x="598" y="28"/>
                      </a:lnTo>
                      <a:lnTo>
                        <a:pt x="602" y="27"/>
                      </a:lnTo>
                      <a:lnTo>
                        <a:pt x="608" y="27"/>
                      </a:lnTo>
                      <a:lnTo>
                        <a:pt x="619" y="27"/>
                      </a:lnTo>
                      <a:lnTo>
                        <a:pt x="631" y="27"/>
                      </a:lnTo>
                      <a:lnTo>
                        <a:pt x="643" y="27"/>
                      </a:lnTo>
                      <a:lnTo>
                        <a:pt x="654" y="27"/>
                      </a:lnTo>
                      <a:lnTo>
                        <a:pt x="664" y="27"/>
                      </a:lnTo>
                      <a:lnTo>
                        <a:pt x="677" y="27"/>
                      </a:lnTo>
                      <a:lnTo>
                        <a:pt x="690" y="27"/>
                      </a:lnTo>
                      <a:lnTo>
                        <a:pt x="704" y="27"/>
                      </a:lnTo>
                      <a:lnTo>
                        <a:pt x="715" y="27"/>
                      </a:lnTo>
                      <a:lnTo>
                        <a:pt x="727" y="27"/>
                      </a:lnTo>
                      <a:lnTo>
                        <a:pt x="740" y="27"/>
                      </a:lnTo>
                      <a:lnTo>
                        <a:pt x="752" y="27"/>
                      </a:lnTo>
                      <a:lnTo>
                        <a:pt x="766" y="27"/>
                      </a:lnTo>
                      <a:lnTo>
                        <a:pt x="782" y="27"/>
                      </a:lnTo>
                      <a:lnTo>
                        <a:pt x="796" y="27"/>
                      </a:lnTo>
                      <a:lnTo>
                        <a:pt x="808" y="27"/>
                      </a:lnTo>
                      <a:lnTo>
                        <a:pt x="815" y="27"/>
                      </a:lnTo>
                      <a:lnTo>
                        <a:pt x="819" y="27"/>
                      </a:lnTo>
                      <a:lnTo>
                        <a:pt x="826" y="27"/>
                      </a:lnTo>
                      <a:lnTo>
                        <a:pt x="834" y="27"/>
                      </a:lnTo>
                      <a:lnTo>
                        <a:pt x="846" y="26"/>
                      </a:lnTo>
                      <a:lnTo>
                        <a:pt x="856" y="26"/>
                      </a:lnTo>
                      <a:lnTo>
                        <a:pt x="861" y="26"/>
                      </a:lnTo>
                      <a:lnTo>
                        <a:pt x="868" y="26"/>
                      </a:lnTo>
                      <a:lnTo>
                        <a:pt x="876" y="26"/>
                      </a:lnTo>
                      <a:lnTo>
                        <a:pt x="885" y="26"/>
                      </a:lnTo>
                      <a:lnTo>
                        <a:pt x="895" y="26"/>
                      </a:lnTo>
                      <a:lnTo>
                        <a:pt x="902" y="26"/>
                      </a:lnTo>
                      <a:lnTo>
                        <a:pt x="911" y="26"/>
                      </a:lnTo>
                      <a:lnTo>
                        <a:pt x="926" y="26"/>
                      </a:lnTo>
                      <a:lnTo>
                        <a:pt x="939" y="26"/>
                      </a:lnTo>
                      <a:lnTo>
                        <a:pt x="944" y="26"/>
                      </a:lnTo>
                      <a:lnTo>
                        <a:pt x="948" y="26"/>
                      </a:lnTo>
                      <a:lnTo>
                        <a:pt x="955" y="26"/>
                      </a:lnTo>
                      <a:lnTo>
                        <a:pt x="964" y="25"/>
                      </a:lnTo>
                      <a:lnTo>
                        <a:pt x="974" y="25"/>
                      </a:lnTo>
                      <a:lnTo>
                        <a:pt x="982" y="25"/>
                      </a:lnTo>
                      <a:lnTo>
                        <a:pt x="988" y="25"/>
                      </a:lnTo>
                      <a:lnTo>
                        <a:pt x="992" y="25"/>
                      </a:lnTo>
                      <a:lnTo>
                        <a:pt x="997" y="25"/>
                      </a:lnTo>
                      <a:lnTo>
                        <a:pt x="1004" y="25"/>
                      </a:lnTo>
                      <a:lnTo>
                        <a:pt x="1010" y="25"/>
                      </a:lnTo>
                      <a:lnTo>
                        <a:pt x="1018" y="25"/>
                      </a:lnTo>
                      <a:lnTo>
                        <a:pt x="1026" y="25"/>
                      </a:lnTo>
                      <a:lnTo>
                        <a:pt x="1032" y="25"/>
                      </a:lnTo>
                      <a:lnTo>
                        <a:pt x="1036" y="25"/>
                      </a:lnTo>
                      <a:lnTo>
                        <a:pt x="1041" y="25"/>
                      </a:lnTo>
                      <a:lnTo>
                        <a:pt x="1052" y="25"/>
                      </a:lnTo>
                      <a:lnTo>
                        <a:pt x="1065" y="25"/>
                      </a:lnTo>
                      <a:lnTo>
                        <a:pt x="1075" y="25"/>
                      </a:lnTo>
                      <a:lnTo>
                        <a:pt x="1079" y="25"/>
                      </a:lnTo>
                      <a:lnTo>
                        <a:pt x="1084" y="25"/>
                      </a:lnTo>
                      <a:lnTo>
                        <a:pt x="1092" y="25"/>
                      </a:lnTo>
                      <a:lnTo>
                        <a:pt x="1101" y="25"/>
                      </a:lnTo>
                      <a:lnTo>
                        <a:pt x="1111" y="24"/>
                      </a:lnTo>
                      <a:lnTo>
                        <a:pt x="1119" y="24"/>
                      </a:lnTo>
                      <a:lnTo>
                        <a:pt x="1127" y="24"/>
                      </a:lnTo>
                      <a:lnTo>
                        <a:pt x="1136" y="24"/>
                      </a:lnTo>
                      <a:lnTo>
                        <a:pt x="1149" y="24"/>
                      </a:lnTo>
                      <a:lnTo>
                        <a:pt x="1160" y="24"/>
                      </a:lnTo>
                      <a:lnTo>
                        <a:pt x="1165" y="24"/>
                      </a:lnTo>
                      <a:lnTo>
                        <a:pt x="1171" y="24"/>
                      </a:lnTo>
                      <a:lnTo>
                        <a:pt x="1180" y="24"/>
                      </a:lnTo>
                      <a:lnTo>
                        <a:pt x="1187" y="24"/>
                      </a:lnTo>
                      <a:lnTo>
                        <a:pt x="1197" y="24"/>
                      </a:lnTo>
                      <a:lnTo>
                        <a:pt x="1204" y="24"/>
                      </a:lnTo>
                      <a:lnTo>
                        <a:pt x="1207" y="24"/>
                      </a:lnTo>
                      <a:lnTo>
                        <a:pt x="1211" y="24"/>
                      </a:lnTo>
                      <a:lnTo>
                        <a:pt x="1219" y="23"/>
                      </a:lnTo>
                      <a:lnTo>
                        <a:pt x="1231" y="23"/>
                      </a:lnTo>
                      <a:lnTo>
                        <a:pt x="1242" y="23"/>
                      </a:lnTo>
                      <a:lnTo>
                        <a:pt x="1248" y="23"/>
                      </a:lnTo>
                      <a:lnTo>
                        <a:pt x="1251" y="23"/>
                      </a:lnTo>
                      <a:lnTo>
                        <a:pt x="1255" y="23"/>
                      </a:lnTo>
                      <a:lnTo>
                        <a:pt x="1262" y="23"/>
                      </a:lnTo>
                      <a:lnTo>
                        <a:pt x="1270" y="23"/>
                      </a:lnTo>
                      <a:lnTo>
                        <a:pt x="1280" y="23"/>
                      </a:lnTo>
                      <a:lnTo>
                        <a:pt x="1289" y="23"/>
                      </a:lnTo>
                      <a:lnTo>
                        <a:pt x="1294" y="23"/>
                      </a:lnTo>
                      <a:lnTo>
                        <a:pt x="1298" y="23"/>
                      </a:lnTo>
                      <a:lnTo>
                        <a:pt x="1303" y="22"/>
                      </a:lnTo>
                      <a:lnTo>
                        <a:pt x="1308" y="22"/>
                      </a:lnTo>
                      <a:lnTo>
                        <a:pt x="1315" y="22"/>
                      </a:lnTo>
                      <a:lnTo>
                        <a:pt x="1326" y="22"/>
                      </a:lnTo>
                      <a:lnTo>
                        <a:pt x="1335" y="22"/>
                      </a:lnTo>
                      <a:lnTo>
                        <a:pt x="1342" y="22"/>
                      </a:lnTo>
                      <a:lnTo>
                        <a:pt x="1349" y="22"/>
                      </a:lnTo>
                      <a:lnTo>
                        <a:pt x="1357" y="22"/>
                      </a:lnTo>
                      <a:lnTo>
                        <a:pt x="1363" y="22"/>
                      </a:lnTo>
                      <a:lnTo>
                        <a:pt x="1370" y="22"/>
                      </a:lnTo>
                      <a:lnTo>
                        <a:pt x="1375" y="22"/>
                      </a:lnTo>
                      <a:lnTo>
                        <a:pt x="1380" y="22"/>
                      </a:lnTo>
                      <a:lnTo>
                        <a:pt x="1384" y="22"/>
                      </a:lnTo>
                      <a:lnTo>
                        <a:pt x="1387" y="22"/>
                      </a:lnTo>
                      <a:lnTo>
                        <a:pt x="1390" y="22"/>
                      </a:lnTo>
                      <a:lnTo>
                        <a:pt x="1394" y="22"/>
                      </a:lnTo>
                      <a:lnTo>
                        <a:pt x="1402" y="21"/>
                      </a:lnTo>
                      <a:lnTo>
                        <a:pt x="1412" y="21"/>
                      </a:lnTo>
                      <a:lnTo>
                        <a:pt x="1420" y="21"/>
                      </a:lnTo>
                      <a:lnTo>
                        <a:pt x="1423" y="21"/>
                      </a:lnTo>
                      <a:lnTo>
                        <a:pt x="1426" y="21"/>
                      </a:lnTo>
                      <a:lnTo>
                        <a:pt x="1427" y="21"/>
                      </a:lnTo>
                      <a:lnTo>
                        <a:pt x="1431" y="20"/>
                      </a:lnTo>
                      <a:lnTo>
                        <a:pt x="1436" y="20"/>
                      </a:lnTo>
                      <a:lnTo>
                        <a:pt x="1441" y="20"/>
                      </a:lnTo>
                      <a:lnTo>
                        <a:pt x="1445" y="20"/>
                      </a:lnTo>
                      <a:lnTo>
                        <a:pt x="1449" y="20"/>
                      </a:lnTo>
                      <a:lnTo>
                        <a:pt x="1452" y="20"/>
                      </a:lnTo>
                      <a:lnTo>
                        <a:pt x="1455" y="20"/>
                      </a:lnTo>
                      <a:lnTo>
                        <a:pt x="1457" y="20"/>
                      </a:lnTo>
                      <a:lnTo>
                        <a:pt x="1460" y="19"/>
                      </a:lnTo>
                      <a:lnTo>
                        <a:pt x="1462" y="19"/>
                      </a:lnTo>
                      <a:lnTo>
                        <a:pt x="1464" y="19"/>
                      </a:lnTo>
                      <a:lnTo>
                        <a:pt x="1465" y="19"/>
                      </a:lnTo>
                      <a:lnTo>
                        <a:pt x="1466" y="19"/>
                      </a:lnTo>
                      <a:lnTo>
                        <a:pt x="1467" y="19"/>
                      </a:lnTo>
                      <a:lnTo>
                        <a:pt x="1468" y="18"/>
                      </a:lnTo>
                      <a:lnTo>
                        <a:pt x="1469" y="18"/>
                      </a:lnTo>
                      <a:lnTo>
                        <a:pt x="1469" y="18"/>
                      </a:lnTo>
                      <a:lnTo>
                        <a:pt x="1470" y="18"/>
                      </a:lnTo>
                      <a:lnTo>
                        <a:pt x="1471" y="18"/>
                      </a:lnTo>
                      <a:lnTo>
                        <a:pt x="1473" y="18"/>
                      </a:lnTo>
                      <a:lnTo>
                        <a:pt x="1475" y="18"/>
                      </a:lnTo>
                      <a:lnTo>
                        <a:pt x="1477" y="17"/>
                      </a:lnTo>
                      <a:lnTo>
                        <a:pt x="1478" y="17"/>
                      </a:lnTo>
                      <a:lnTo>
                        <a:pt x="1480" y="17"/>
                      </a:lnTo>
                      <a:lnTo>
                        <a:pt x="1482" y="16"/>
                      </a:lnTo>
                      <a:lnTo>
                        <a:pt x="1483" y="16"/>
                      </a:lnTo>
                      <a:lnTo>
                        <a:pt x="1485" y="16"/>
                      </a:lnTo>
                      <a:lnTo>
                        <a:pt x="1487" y="15"/>
                      </a:lnTo>
                      <a:lnTo>
                        <a:pt x="1488" y="15"/>
                      </a:lnTo>
                      <a:lnTo>
                        <a:pt x="1490" y="14"/>
                      </a:lnTo>
                      <a:lnTo>
                        <a:pt x="1492" y="14"/>
                      </a:lnTo>
                      <a:lnTo>
                        <a:pt x="1494" y="13"/>
                      </a:lnTo>
                      <a:lnTo>
                        <a:pt x="1496" y="13"/>
                      </a:lnTo>
                      <a:lnTo>
                        <a:pt x="1498" y="12"/>
                      </a:lnTo>
                      <a:lnTo>
                        <a:pt x="1501" y="11"/>
                      </a:lnTo>
                      <a:lnTo>
                        <a:pt x="1503" y="10"/>
                      </a:lnTo>
                      <a:lnTo>
                        <a:pt x="1506" y="9"/>
                      </a:lnTo>
                      <a:lnTo>
                        <a:pt x="1508" y="9"/>
                      </a:lnTo>
                      <a:lnTo>
                        <a:pt x="1508" y="8"/>
                      </a:lnTo>
                      <a:lnTo>
                        <a:pt x="1509" y="8"/>
                      </a:lnTo>
                      <a:lnTo>
                        <a:pt x="1509" y="8"/>
                      </a:lnTo>
                      <a:lnTo>
                        <a:pt x="1509" y="8"/>
                      </a:lnTo>
                      <a:lnTo>
                        <a:pt x="1510" y="8"/>
                      </a:lnTo>
                      <a:lnTo>
                        <a:pt x="1511" y="7"/>
                      </a:lnTo>
                      <a:lnTo>
                        <a:pt x="1514" y="6"/>
                      </a:lnTo>
                      <a:lnTo>
                        <a:pt x="1517" y="5"/>
                      </a:lnTo>
                      <a:lnTo>
                        <a:pt x="1519" y="5"/>
                      </a:lnTo>
                      <a:lnTo>
                        <a:pt x="1522" y="4"/>
                      </a:lnTo>
                      <a:lnTo>
                        <a:pt x="1525" y="3"/>
                      </a:lnTo>
                      <a:lnTo>
                        <a:pt x="1527" y="3"/>
                      </a:lnTo>
                      <a:lnTo>
                        <a:pt x="1529" y="2"/>
                      </a:lnTo>
                      <a:lnTo>
                        <a:pt x="1531" y="2"/>
                      </a:lnTo>
                      <a:lnTo>
                        <a:pt x="1533" y="1"/>
                      </a:lnTo>
                      <a:lnTo>
                        <a:pt x="1535" y="1"/>
                      </a:lnTo>
                      <a:lnTo>
                        <a:pt x="1536" y="0"/>
                      </a:lnTo>
                      <a:lnTo>
                        <a:pt x="1538" y="0"/>
                      </a:lnTo>
                      <a:lnTo>
                        <a:pt x="1540" y="0"/>
                      </a:lnTo>
                      <a:lnTo>
                        <a:pt x="1542" y="0"/>
                      </a:lnTo>
                      <a:lnTo>
                        <a:pt x="1544" y="0"/>
                      </a:lnTo>
                      <a:lnTo>
                        <a:pt x="1545" y="0"/>
                      </a:lnTo>
                      <a:lnTo>
                        <a:pt x="1547" y="0"/>
                      </a:lnTo>
                      <a:lnTo>
                        <a:pt x="1549" y="0"/>
                      </a:lnTo>
                      <a:lnTo>
                        <a:pt x="1550" y="0"/>
                      </a:lnTo>
                      <a:lnTo>
                        <a:pt x="1551" y="0"/>
                      </a:lnTo>
                      <a:lnTo>
                        <a:pt x="1552" y="0"/>
                      </a:lnTo>
                      <a:lnTo>
                        <a:pt x="1552" y="0"/>
                      </a:lnTo>
                      <a:lnTo>
                        <a:pt x="1553" y="0"/>
                      </a:lnTo>
                      <a:lnTo>
                        <a:pt x="1553" y="0"/>
                      </a:lnTo>
                      <a:lnTo>
                        <a:pt x="1554" y="0"/>
                      </a:lnTo>
                      <a:lnTo>
                        <a:pt x="1555" y="0"/>
                      </a:lnTo>
                      <a:lnTo>
                        <a:pt x="1556" y="0"/>
                      </a:lnTo>
                      <a:lnTo>
                        <a:pt x="1558" y="1"/>
                      </a:lnTo>
                      <a:lnTo>
                        <a:pt x="1560" y="1"/>
                      </a:lnTo>
                      <a:lnTo>
                        <a:pt x="1562" y="2"/>
                      </a:lnTo>
                      <a:lnTo>
                        <a:pt x="1564" y="2"/>
                      </a:lnTo>
                      <a:lnTo>
                        <a:pt x="1565" y="3"/>
                      </a:lnTo>
                      <a:lnTo>
                        <a:pt x="1567" y="3"/>
                      </a:lnTo>
                      <a:lnTo>
                        <a:pt x="1569" y="4"/>
                      </a:lnTo>
                      <a:lnTo>
                        <a:pt x="1571" y="5"/>
                      </a:lnTo>
                      <a:lnTo>
                        <a:pt x="1574" y="5"/>
                      </a:lnTo>
                      <a:lnTo>
                        <a:pt x="1577" y="6"/>
                      </a:lnTo>
                      <a:lnTo>
                        <a:pt x="1580" y="8"/>
                      </a:lnTo>
                      <a:lnTo>
                        <a:pt x="1583" y="9"/>
                      </a:lnTo>
                      <a:lnTo>
                        <a:pt x="1585" y="10"/>
                      </a:lnTo>
                      <a:lnTo>
                        <a:pt x="1587" y="11"/>
                      </a:lnTo>
                      <a:lnTo>
                        <a:pt x="1590" y="12"/>
                      </a:lnTo>
                      <a:lnTo>
                        <a:pt x="1592" y="13"/>
                      </a:lnTo>
                      <a:lnTo>
                        <a:pt x="1594" y="14"/>
                      </a:lnTo>
                      <a:lnTo>
                        <a:pt x="1595" y="14"/>
                      </a:lnTo>
                      <a:lnTo>
                        <a:pt x="1595" y="14"/>
                      </a:lnTo>
                      <a:lnTo>
                        <a:pt x="1596" y="14"/>
                      </a:lnTo>
                      <a:lnTo>
                        <a:pt x="1596" y="15"/>
                      </a:lnTo>
                      <a:lnTo>
                        <a:pt x="1597" y="15"/>
                      </a:lnTo>
                      <a:lnTo>
                        <a:pt x="1597" y="15"/>
                      </a:lnTo>
                      <a:lnTo>
                        <a:pt x="1597" y="15"/>
                      </a:lnTo>
                      <a:lnTo>
                        <a:pt x="1598" y="15"/>
                      </a:lnTo>
                      <a:lnTo>
                        <a:pt x="1598" y="15"/>
                      </a:lnTo>
                      <a:lnTo>
                        <a:pt x="1598" y="15"/>
                      </a:lnTo>
                      <a:lnTo>
                        <a:pt x="1599" y="16"/>
                      </a:lnTo>
                      <a:lnTo>
                        <a:pt x="1601" y="17"/>
                      </a:lnTo>
                      <a:lnTo>
                        <a:pt x="1604" y="18"/>
                      </a:lnTo>
                      <a:lnTo>
                        <a:pt x="1607" y="19"/>
                      </a:lnTo>
                      <a:lnTo>
                        <a:pt x="1610" y="20"/>
                      </a:lnTo>
                      <a:lnTo>
                        <a:pt x="1612" y="22"/>
                      </a:lnTo>
                      <a:lnTo>
                        <a:pt x="1615" y="23"/>
                      </a:lnTo>
                      <a:lnTo>
                        <a:pt x="1618" y="24"/>
                      </a:lnTo>
                      <a:lnTo>
                        <a:pt x="1620" y="25"/>
                      </a:lnTo>
                      <a:lnTo>
                        <a:pt x="1622" y="26"/>
                      </a:lnTo>
                      <a:lnTo>
                        <a:pt x="1625" y="27"/>
                      </a:lnTo>
                      <a:lnTo>
                        <a:pt x="1627" y="27"/>
                      </a:lnTo>
                      <a:lnTo>
                        <a:pt x="1629" y="28"/>
                      </a:lnTo>
                      <a:lnTo>
                        <a:pt x="1632" y="29"/>
                      </a:lnTo>
                      <a:lnTo>
                        <a:pt x="1634" y="30"/>
                      </a:lnTo>
                      <a:lnTo>
                        <a:pt x="1636" y="30"/>
                      </a:lnTo>
                      <a:lnTo>
                        <a:pt x="1637" y="31"/>
                      </a:lnTo>
                      <a:lnTo>
                        <a:pt x="1638" y="31"/>
                      </a:lnTo>
                      <a:lnTo>
                        <a:pt x="1639" y="31"/>
                      </a:lnTo>
                      <a:lnTo>
                        <a:pt x="1640" y="32"/>
                      </a:lnTo>
                      <a:lnTo>
                        <a:pt x="1640" y="32"/>
                      </a:lnTo>
                      <a:lnTo>
                        <a:pt x="1641" y="32"/>
                      </a:lnTo>
                      <a:lnTo>
                        <a:pt x="1641" y="32"/>
                      </a:lnTo>
                      <a:lnTo>
                        <a:pt x="1642" y="32"/>
                      </a:lnTo>
                      <a:lnTo>
                        <a:pt x="1642" y="32"/>
                      </a:lnTo>
                      <a:lnTo>
                        <a:pt x="1642" y="33"/>
                      </a:lnTo>
                      <a:lnTo>
                        <a:pt x="1643" y="33"/>
                      </a:lnTo>
                      <a:lnTo>
                        <a:pt x="1643" y="33"/>
                      </a:lnTo>
                      <a:lnTo>
                        <a:pt x="1644" y="33"/>
                      </a:lnTo>
                      <a:lnTo>
                        <a:pt x="1646" y="33"/>
                      </a:lnTo>
                      <a:lnTo>
                        <a:pt x="1647" y="34"/>
                      </a:lnTo>
                      <a:lnTo>
                        <a:pt x="1649" y="34"/>
                      </a:lnTo>
                      <a:lnTo>
                        <a:pt x="1651" y="35"/>
                      </a:lnTo>
                      <a:lnTo>
                        <a:pt x="1652" y="35"/>
                      </a:lnTo>
                      <a:lnTo>
                        <a:pt x="1654" y="36"/>
                      </a:lnTo>
                      <a:lnTo>
                        <a:pt x="1656" y="36"/>
                      </a:lnTo>
                      <a:lnTo>
                        <a:pt x="1658" y="37"/>
                      </a:lnTo>
                      <a:lnTo>
                        <a:pt x="1660" y="37"/>
                      </a:lnTo>
                      <a:lnTo>
                        <a:pt x="1661" y="38"/>
                      </a:lnTo>
                      <a:lnTo>
                        <a:pt x="1663" y="38"/>
                      </a:lnTo>
                      <a:lnTo>
                        <a:pt x="1665" y="38"/>
                      </a:lnTo>
                      <a:lnTo>
                        <a:pt x="1667" y="39"/>
                      </a:lnTo>
                      <a:lnTo>
                        <a:pt x="1669" y="39"/>
                      </a:lnTo>
                      <a:lnTo>
                        <a:pt x="1670" y="40"/>
                      </a:lnTo>
                      <a:lnTo>
                        <a:pt x="1672" y="40"/>
                      </a:lnTo>
                      <a:lnTo>
                        <a:pt x="1674" y="40"/>
                      </a:lnTo>
                      <a:lnTo>
                        <a:pt x="1675" y="40"/>
                      </a:lnTo>
                      <a:lnTo>
                        <a:pt x="1677" y="41"/>
                      </a:lnTo>
                      <a:lnTo>
                        <a:pt x="1678" y="41"/>
                      </a:lnTo>
                      <a:lnTo>
                        <a:pt x="1679" y="41"/>
                      </a:lnTo>
                      <a:lnTo>
                        <a:pt x="1681" y="41"/>
                      </a:lnTo>
                      <a:lnTo>
                        <a:pt x="1682" y="42"/>
                      </a:lnTo>
                      <a:lnTo>
                        <a:pt x="1683" y="42"/>
                      </a:lnTo>
                      <a:lnTo>
                        <a:pt x="1683" y="42"/>
                      </a:lnTo>
                      <a:lnTo>
                        <a:pt x="1684" y="42"/>
                      </a:lnTo>
                      <a:lnTo>
                        <a:pt x="1685" y="42"/>
                      </a:lnTo>
                      <a:lnTo>
                        <a:pt x="1685" y="42"/>
                      </a:lnTo>
                      <a:lnTo>
                        <a:pt x="1686" y="42"/>
                      </a:lnTo>
                      <a:lnTo>
                        <a:pt x="1686" y="42"/>
                      </a:lnTo>
                      <a:lnTo>
                        <a:pt x="1687" y="42"/>
                      </a:lnTo>
                      <a:lnTo>
                        <a:pt x="1687" y="42"/>
                      </a:lnTo>
                      <a:lnTo>
                        <a:pt x="1687" y="43"/>
                      </a:lnTo>
                      <a:lnTo>
                        <a:pt x="1688" y="43"/>
                      </a:lnTo>
                      <a:lnTo>
                        <a:pt x="1689" y="43"/>
                      </a:lnTo>
                      <a:lnTo>
                        <a:pt x="1691" y="43"/>
                      </a:lnTo>
                      <a:lnTo>
                        <a:pt x="1692" y="43"/>
                      </a:lnTo>
                      <a:lnTo>
                        <a:pt x="1694" y="43"/>
                      </a:lnTo>
                      <a:lnTo>
                        <a:pt x="1695" y="44"/>
                      </a:lnTo>
                      <a:lnTo>
                        <a:pt x="1697" y="44"/>
                      </a:lnTo>
                      <a:lnTo>
                        <a:pt x="1698" y="44"/>
                      </a:lnTo>
                      <a:lnTo>
                        <a:pt x="1700" y="44"/>
                      </a:lnTo>
                      <a:lnTo>
                        <a:pt x="1702" y="44"/>
                      </a:lnTo>
                      <a:lnTo>
                        <a:pt x="1704" y="45"/>
                      </a:lnTo>
                      <a:lnTo>
                        <a:pt x="1705" y="45"/>
                      </a:lnTo>
                      <a:lnTo>
                        <a:pt x="1707" y="45"/>
                      </a:lnTo>
                      <a:lnTo>
                        <a:pt x="1709" y="45"/>
                      </a:lnTo>
                      <a:lnTo>
                        <a:pt x="1711" y="45"/>
                      </a:lnTo>
                      <a:lnTo>
                        <a:pt x="1713" y="45"/>
                      </a:lnTo>
                      <a:lnTo>
                        <a:pt x="1714" y="46"/>
                      </a:lnTo>
                      <a:lnTo>
                        <a:pt x="1716" y="46"/>
                      </a:lnTo>
                      <a:lnTo>
                        <a:pt x="1717" y="46"/>
                      </a:lnTo>
                      <a:lnTo>
                        <a:pt x="1719" y="46"/>
                      </a:lnTo>
                      <a:lnTo>
                        <a:pt x="1721" y="46"/>
                      </a:lnTo>
                      <a:lnTo>
                        <a:pt x="1722" y="46"/>
                      </a:lnTo>
                      <a:lnTo>
                        <a:pt x="1724" y="47"/>
                      </a:lnTo>
                      <a:lnTo>
                        <a:pt x="1725" y="47"/>
                      </a:lnTo>
                      <a:lnTo>
                        <a:pt x="1726" y="47"/>
                      </a:lnTo>
                      <a:lnTo>
                        <a:pt x="1727" y="47"/>
                      </a:lnTo>
                      <a:lnTo>
                        <a:pt x="1728" y="47"/>
                      </a:lnTo>
                      <a:lnTo>
                        <a:pt x="1729" y="47"/>
                      </a:lnTo>
                      <a:lnTo>
                        <a:pt x="1729" y="47"/>
                      </a:lnTo>
                      <a:lnTo>
                        <a:pt x="1730" y="47"/>
                      </a:lnTo>
                      <a:lnTo>
                        <a:pt x="1730" y="47"/>
                      </a:lnTo>
                      <a:lnTo>
                        <a:pt x="1731" y="47"/>
                      </a:lnTo>
                      <a:lnTo>
                        <a:pt x="1733" y="47"/>
                      </a:lnTo>
                      <a:lnTo>
                        <a:pt x="1734" y="47"/>
                      </a:lnTo>
                      <a:lnTo>
                        <a:pt x="1737" y="48"/>
                      </a:lnTo>
                      <a:lnTo>
                        <a:pt x="1739" y="48"/>
                      </a:lnTo>
                      <a:lnTo>
                        <a:pt x="1742" y="48"/>
                      </a:lnTo>
                      <a:lnTo>
                        <a:pt x="1744" y="48"/>
                      </a:lnTo>
                      <a:lnTo>
                        <a:pt x="1745" y="48"/>
                      </a:lnTo>
                      <a:lnTo>
                        <a:pt x="1747" y="48"/>
                      </a:lnTo>
                      <a:lnTo>
                        <a:pt x="1749" y="48"/>
                      </a:lnTo>
                      <a:lnTo>
                        <a:pt x="1751" y="48"/>
                      </a:lnTo>
                      <a:lnTo>
                        <a:pt x="1753" y="48"/>
                      </a:lnTo>
                      <a:lnTo>
                        <a:pt x="1755" y="48"/>
                      </a:lnTo>
                      <a:lnTo>
                        <a:pt x="1757" y="49"/>
                      </a:lnTo>
                      <a:lnTo>
                        <a:pt x="1760" y="49"/>
                      </a:lnTo>
                      <a:lnTo>
                        <a:pt x="1762" y="49"/>
                      </a:lnTo>
                      <a:lnTo>
                        <a:pt x="1764" y="49"/>
                      </a:lnTo>
                      <a:lnTo>
                        <a:pt x="1766" y="49"/>
                      </a:lnTo>
                      <a:lnTo>
                        <a:pt x="1768" y="49"/>
                      </a:lnTo>
                      <a:lnTo>
                        <a:pt x="1770" y="49"/>
                      </a:lnTo>
                      <a:lnTo>
                        <a:pt x="1772" y="49"/>
                      </a:lnTo>
                      <a:lnTo>
                        <a:pt x="1774" y="49"/>
                      </a:lnTo>
                      <a:lnTo>
                        <a:pt x="1777" y="49"/>
                      </a:lnTo>
                      <a:lnTo>
                        <a:pt x="1779" y="49"/>
                      </a:lnTo>
                      <a:lnTo>
                        <a:pt x="1781" y="49"/>
                      </a:lnTo>
                      <a:lnTo>
                        <a:pt x="1783" y="49"/>
                      </a:lnTo>
                      <a:lnTo>
                        <a:pt x="1784" y="50"/>
                      </a:lnTo>
                    </a:path>
                  </a:pathLst>
                </a:cu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02" name="TextBox 101"/>
              <p:cNvSpPr txBox="1"/>
              <p:nvPr/>
            </p:nvSpPr>
            <p:spPr>
              <a:xfrm rot="16200000">
                <a:off x="596037" y="7966451"/>
                <a:ext cx="1168630" cy="2693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Intensity (</a:t>
                </a:r>
                <a:r>
                  <a:rPr lang="en-US" sz="1100" dirty="0" err="1">
                    <a:latin typeface="Arial" pitchFamily="34" charset="0"/>
                    <a:cs typeface="Arial" pitchFamily="34" charset="0"/>
                  </a:rPr>
                  <a:t>mAU</a:t>
                </a:r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)</a:t>
                </a:r>
              </a:p>
            </p:txBody>
          </p:sp>
        </p:grpSp>
        <p:sp>
          <p:nvSpPr>
            <p:cNvPr id="237" name="TextBox 236"/>
            <p:cNvSpPr txBox="1"/>
            <p:nvPr/>
          </p:nvSpPr>
          <p:spPr>
            <a:xfrm>
              <a:off x="1534532" y="170275"/>
              <a:ext cx="17557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521 </a:t>
              </a:r>
              <a:r>
                <a:rPr lang="en-US" sz="1000" dirty="0" err="1">
                  <a:latin typeface="Arial" pitchFamily="34" charset="0"/>
                  <a:cs typeface="Arial" pitchFamily="34" charset="0"/>
                </a:rPr>
                <a:t>nt</a:t>
              </a:r>
              <a:r>
                <a:rPr lang="en-US" sz="1000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000" dirty="0" err="1">
                  <a:latin typeface="Arial" pitchFamily="34" charset="0"/>
                  <a:cs typeface="Arial" pitchFamily="34" charset="0"/>
                </a:rPr>
                <a:t>ssRNA</a:t>
              </a:r>
              <a:r>
                <a:rPr lang="en-US" sz="1000" dirty="0">
                  <a:latin typeface="Arial" pitchFamily="34" charset="0"/>
                  <a:cs typeface="Arial" pitchFamily="34" charset="0"/>
                </a:rPr>
                <a:t> (1)</a:t>
              </a:r>
            </a:p>
          </p:txBody>
        </p:sp>
        <p:sp>
          <p:nvSpPr>
            <p:cNvPr id="239" name="TextBox 238"/>
            <p:cNvSpPr txBox="1"/>
            <p:nvPr/>
          </p:nvSpPr>
          <p:spPr>
            <a:xfrm>
              <a:off x="2574023" y="2158914"/>
              <a:ext cx="1719995" cy="297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itchFamily="34" charset="0"/>
                  <a:cs typeface="Arial" pitchFamily="34" charset="0"/>
                </a:rPr>
                <a:t>Retention time (min)</a:t>
              </a: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1052737" y="2367264"/>
            <a:ext cx="4716243" cy="2349842"/>
            <a:chOff x="1039727" y="2659778"/>
            <a:chExt cx="4716243" cy="2349842"/>
          </a:xfrm>
        </p:grpSpPr>
        <p:grpSp>
          <p:nvGrpSpPr>
            <p:cNvPr id="66" name="Group 65"/>
            <p:cNvGrpSpPr/>
            <p:nvPr/>
          </p:nvGrpSpPr>
          <p:grpSpPr>
            <a:xfrm>
              <a:off x="1039727" y="2659778"/>
              <a:ext cx="4716243" cy="2072716"/>
              <a:chOff x="991107" y="5177812"/>
              <a:chExt cx="4787311" cy="1747850"/>
            </a:xfrm>
          </p:grpSpPr>
          <p:grpSp>
            <p:nvGrpSpPr>
              <p:cNvPr id="67" name="Group 66"/>
              <p:cNvGrpSpPr/>
              <p:nvPr/>
            </p:nvGrpSpPr>
            <p:grpSpPr>
              <a:xfrm>
                <a:off x="1270251" y="5177812"/>
                <a:ext cx="4508167" cy="1747850"/>
                <a:chOff x="1312536" y="1050926"/>
                <a:chExt cx="10093913" cy="2492799"/>
              </a:xfrm>
            </p:grpSpPr>
            <p:sp>
              <p:nvSpPr>
                <p:cNvPr id="70" name="Rectangle 6"/>
                <p:cNvSpPr>
                  <a:spLocks noChangeArrowheads="1"/>
                </p:cNvSpPr>
                <p:nvPr/>
              </p:nvSpPr>
              <p:spPr bwMode="auto">
                <a:xfrm>
                  <a:off x="1625601" y="3395663"/>
                  <a:ext cx="327892" cy="1480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itchFamily="34" charset="0"/>
                    </a:rPr>
                    <a:t>0.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71" name="Line 7"/>
                <p:cNvSpPr>
                  <a:spLocks noChangeShapeType="1"/>
                </p:cNvSpPr>
                <p:nvPr/>
              </p:nvSpPr>
              <p:spPr bwMode="auto">
                <a:xfrm>
                  <a:off x="1719263" y="3333751"/>
                  <a:ext cx="0" cy="6191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2" name="Rectangle 71"/>
                <p:cNvSpPr>
                  <a:spLocks noChangeArrowheads="1"/>
                </p:cNvSpPr>
                <p:nvPr/>
              </p:nvSpPr>
              <p:spPr bwMode="auto">
                <a:xfrm>
                  <a:off x="3649664" y="3395663"/>
                  <a:ext cx="327892" cy="1480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itchFamily="34" charset="0"/>
                    </a:rPr>
                    <a:t>5.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73" name="Line 31"/>
                <p:cNvSpPr>
                  <a:spLocks noChangeShapeType="1"/>
                </p:cNvSpPr>
                <p:nvPr/>
              </p:nvSpPr>
              <p:spPr bwMode="auto">
                <a:xfrm>
                  <a:off x="3743325" y="3333751"/>
                  <a:ext cx="0" cy="6191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4" name="Rectangle 73"/>
                <p:cNvSpPr>
                  <a:spLocks noChangeArrowheads="1"/>
                </p:cNvSpPr>
                <p:nvPr/>
              </p:nvSpPr>
              <p:spPr bwMode="auto">
                <a:xfrm>
                  <a:off x="5645149" y="3395663"/>
                  <a:ext cx="459049" cy="1480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itchFamily="34" charset="0"/>
                    </a:rPr>
                    <a:t>10.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75" name="Line 55"/>
                <p:cNvSpPr>
                  <a:spLocks noChangeShapeType="1"/>
                </p:cNvSpPr>
                <p:nvPr/>
              </p:nvSpPr>
              <p:spPr bwMode="auto">
                <a:xfrm>
                  <a:off x="5767388" y="3333751"/>
                  <a:ext cx="0" cy="6191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6" name="Rectangle 75"/>
                <p:cNvSpPr>
                  <a:spLocks noChangeArrowheads="1"/>
                </p:cNvSpPr>
                <p:nvPr/>
              </p:nvSpPr>
              <p:spPr bwMode="auto">
                <a:xfrm>
                  <a:off x="7667626" y="3395663"/>
                  <a:ext cx="459049" cy="1480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itchFamily="34" charset="0"/>
                    </a:rPr>
                    <a:t>15.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77" name="Line 79"/>
                <p:cNvSpPr>
                  <a:spLocks noChangeShapeType="1"/>
                </p:cNvSpPr>
                <p:nvPr/>
              </p:nvSpPr>
              <p:spPr bwMode="auto">
                <a:xfrm>
                  <a:off x="7789863" y="3333751"/>
                  <a:ext cx="0" cy="6191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8" name="Rectangle 77"/>
                <p:cNvSpPr>
                  <a:spLocks noChangeArrowheads="1"/>
                </p:cNvSpPr>
                <p:nvPr/>
              </p:nvSpPr>
              <p:spPr bwMode="auto">
                <a:xfrm>
                  <a:off x="9691687" y="3395663"/>
                  <a:ext cx="459049" cy="1480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itchFamily="34" charset="0"/>
                    </a:rPr>
                    <a:t>20.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79" name="Line 103"/>
                <p:cNvSpPr>
                  <a:spLocks noChangeShapeType="1"/>
                </p:cNvSpPr>
                <p:nvPr/>
              </p:nvSpPr>
              <p:spPr bwMode="auto">
                <a:xfrm>
                  <a:off x="9813925" y="3333751"/>
                  <a:ext cx="0" cy="6191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0" name="Rectangle 79"/>
                <p:cNvSpPr>
                  <a:spLocks noChangeArrowheads="1"/>
                </p:cNvSpPr>
                <p:nvPr/>
              </p:nvSpPr>
              <p:spPr bwMode="auto">
                <a:xfrm>
                  <a:off x="10947400" y="3395663"/>
                  <a:ext cx="459049" cy="1480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itchFamily="34" charset="0"/>
                    </a:rPr>
                    <a:t>23.1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81" name="Line 118"/>
                <p:cNvSpPr>
                  <a:spLocks noChangeShapeType="1"/>
                </p:cNvSpPr>
                <p:nvPr/>
              </p:nvSpPr>
              <p:spPr bwMode="auto">
                <a:xfrm>
                  <a:off x="11069638" y="3333751"/>
                  <a:ext cx="0" cy="61913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2" name="Rectangle 81"/>
                <p:cNvSpPr>
                  <a:spLocks noChangeArrowheads="1"/>
                </p:cNvSpPr>
                <p:nvPr/>
              </p:nvSpPr>
              <p:spPr bwMode="auto">
                <a:xfrm>
                  <a:off x="1719263" y="1112838"/>
                  <a:ext cx="9350375" cy="2220913"/>
                </a:xfrm>
                <a:prstGeom prst="rect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3" name="Rectangle 82"/>
                <p:cNvSpPr>
                  <a:spLocks noChangeArrowheads="1"/>
                </p:cNvSpPr>
                <p:nvPr/>
              </p:nvSpPr>
              <p:spPr bwMode="auto">
                <a:xfrm>
                  <a:off x="1465264" y="3271838"/>
                  <a:ext cx="338824" cy="1480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itchFamily="34" charset="0"/>
                    </a:rPr>
                    <a:t>-5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84" name="Line 121"/>
                <p:cNvSpPr>
                  <a:spLocks noChangeShapeType="1"/>
                </p:cNvSpPr>
                <p:nvPr/>
              </p:nvSpPr>
              <p:spPr bwMode="auto">
                <a:xfrm flipH="1">
                  <a:off x="1657350" y="3333751"/>
                  <a:ext cx="61913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5" name="Rectangle 84"/>
                <p:cNvSpPr>
                  <a:spLocks noChangeArrowheads="1"/>
                </p:cNvSpPr>
                <p:nvPr/>
              </p:nvSpPr>
              <p:spPr bwMode="auto">
                <a:xfrm>
                  <a:off x="1555749" y="2901951"/>
                  <a:ext cx="131157" cy="1480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itchFamily="34" charset="0"/>
                    </a:rPr>
                    <a:t>0</a:t>
                  </a:r>
                  <a:endParaRPr kumimoji="0" lang="en-US" altLang="en-US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86" name="Line 124"/>
                <p:cNvSpPr>
                  <a:spLocks noChangeShapeType="1"/>
                </p:cNvSpPr>
                <p:nvPr/>
              </p:nvSpPr>
              <p:spPr bwMode="auto">
                <a:xfrm flipH="1">
                  <a:off x="1657350" y="2963863"/>
                  <a:ext cx="61913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7" name="Rectangle 86"/>
                <p:cNvSpPr>
                  <a:spLocks noChangeArrowheads="1"/>
                </p:cNvSpPr>
                <p:nvPr/>
              </p:nvSpPr>
              <p:spPr bwMode="auto">
                <a:xfrm>
                  <a:off x="1312536" y="2162176"/>
                  <a:ext cx="393471" cy="1480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itchFamily="34" charset="0"/>
                    </a:rPr>
                    <a:t>100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88" name="Line 129"/>
                <p:cNvSpPr>
                  <a:spLocks noChangeShapeType="1"/>
                </p:cNvSpPr>
                <p:nvPr/>
              </p:nvSpPr>
              <p:spPr bwMode="auto">
                <a:xfrm flipH="1">
                  <a:off x="1657350" y="2224088"/>
                  <a:ext cx="61913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9" name="Rectangle 88"/>
                <p:cNvSpPr>
                  <a:spLocks noChangeArrowheads="1"/>
                </p:cNvSpPr>
                <p:nvPr/>
              </p:nvSpPr>
              <p:spPr bwMode="auto">
                <a:xfrm>
                  <a:off x="1312536" y="1422402"/>
                  <a:ext cx="393471" cy="1480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itchFamily="34" charset="0"/>
                    </a:rPr>
                    <a:t>200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90" name="Line 134"/>
                <p:cNvSpPr>
                  <a:spLocks noChangeShapeType="1"/>
                </p:cNvSpPr>
                <p:nvPr/>
              </p:nvSpPr>
              <p:spPr bwMode="auto">
                <a:xfrm flipH="1">
                  <a:off x="1657350" y="1484313"/>
                  <a:ext cx="61913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1" name="Rectangle 90"/>
                <p:cNvSpPr>
                  <a:spLocks noChangeArrowheads="1"/>
                </p:cNvSpPr>
                <p:nvPr/>
              </p:nvSpPr>
              <p:spPr bwMode="auto">
                <a:xfrm>
                  <a:off x="1312536" y="1050926"/>
                  <a:ext cx="393471" cy="14806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itchFamily="34" charset="0"/>
                    </a:rPr>
                    <a:t>250</a:t>
                  </a:r>
                  <a:endParaRPr kumimoji="0" lang="en-US" altLang="en-US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93" name="Line 144"/>
                <p:cNvSpPr>
                  <a:spLocks noChangeShapeType="1"/>
                </p:cNvSpPr>
                <p:nvPr/>
              </p:nvSpPr>
              <p:spPr bwMode="auto">
                <a:xfrm flipH="1">
                  <a:off x="1657350" y="1112838"/>
                  <a:ext cx="61913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" name="Freeform 145"/>
                <p:cNvSpPr>
                  <a:spLocks/>
                </p:cNvSpPr>
                <p:nvPr/>
              </p:nvSpPr>
              <p:spPr bwMode="auto">
                <a:xfrm>
                  <a:off x="1719263" y="2857501"/>
                  <a:ext cx="431800" cy="106363"/>
                </a:xfrm>
                <a:custGeom>
                  <a:avLst/>
                  <a:gdLst>
                    <a:gd name="T0" fmla="*/ 14 w 272"/>
                    <a:gd name="T1" fmla="*/ 67 h 67"/>
                    <a:gd name="T2" fmla="*/ 52 w 272"/>
                    <a:gd name="T3" fmla="*/ 67 h 67"/>
                    <a:gd name="T4" fmla="*/ 86 w 272"/>
                    <a:gd name="T5" fmla="*/ 67 h 67"/>
                    <a:gd name="T6" fmla="*/ 106 w 272"/>
                    <a:gd name="T7" fmla="*/ 67 h 67"/>
                    <a:gd name="T8" fmla="*/ 122 w 272"/>
                    <a:gd name="T9" fmla="*/ 67 h 67"/>
                    <a:gd name="T10" fmla="*/ 131 w 272"/>
                    <a:gd name="T11" fmla="*/ 67 h 67"/>
                    <a:gd name="T12" fmla="*/ 132 w 272"/>
                    <a:gd name="T13" fmla="*/ 67 h 67"/>
                    <a:gd name="T14" fmla="*/ 134 w 272"/>
                    <a:gd name="T15" fmla="*/ 66 h 67"/>
                    <a:gd name="T16" fmla="*/ 136 w 272"/>
                    <a:gd name="T17" fmla="*/ 66 h 67"/>
                    <a:gd name="T18" fmla="*/ 139 w 272"/>
                    <a:gd name="T19" fmla="*/ 66 h 67"/>
                    <a:gd name="T20" fmla="*/ 141 w 272"/>
                    <a:gd name="T21" fmla="*/ 66 h 67"/>
                    <a:gd name="T22" fmla="*/ 143 w 272"/>
                    <a:gd name="T23" fmla="*/ 65 h 67"/>
                    <a:gd name="T24" fmla="*/ 145 w 272"/>
                    <a:gd name="T25" fmla="*/ 65 h 67"/>
                    <a:gd name="T26" fmla="*/ 147 w 272"/>
                    <a:gd name="T27" fmla="*/ 64 h 67"/>
                    <a:gd name="T28" fmla="*/ 148 w 272"/>
                    <a:gd name="T29" fmla="*/ 63 h 67"/>
                    <a:gd name="T30" fmla="*/ 150 w 272"/>
                    <a:gd name="T31" fmla="*/ 62 h 67"/>
                    <a:gd name="T32" fmla="*/ 152 w 272"/>
                    <a:gd name="T33" fmla="*/ 60 h 67"/>
                    <a:gd name="T34" fmla="*/ 153 w 272"/>
                    <a:gd name="T35" fmla="*/ 59 h 67"/>
                    <a:gd name="T36" fmla="*/ 156 w 272"/>
                    <a:gd name="T37" fmla="*/ 56 h 67"/>
                    <a:gd name="T38" fmla="*/ 159 w 272"/>
                    <a:gd name="T39" fmla="*/ 50 h 67"/>
                    <a:gd name="T40" fmla="*/ 163 w 272"/>
                    <a:gd name="T41" fmla="*/ 46 h 67"/>
                    <a:gd name="T42" fmla="*/ 166 w 272"/>
                    <a:gd name="T43" fmla="*/ 43 h 67"/>
                    <a:gd name="T44" fmla="*/ 169 w 272"/>
                    <a:gd name="T45" fmla="*/ 42 h 67"/>
                    <a:gd name="T46" fmla="*/ 171 w 272"/>
                    <a:gd name="T47" fmla="*/ 42 h 67"/>
                    <a:gd name="T48" fmla="*/ 174 w 272"/>
                    <a:gd name="T49" fmla="*/ 42 h 67"/>
                    <a:gd name="T50" fmla="*/ 176 w 272"/>
                    <a:gd name="T51" fmla="*/ 43 h 67"/>
                    <a:gd name="T52" fmla="*/ 179 w 272"/>
                    <a:gd name="T53" fmla="*/ 44 h 67"/>
                    <a:gd name="T54" fmla="*/ 181 w 272"/>
                    <a:gd name="T55" fmla="*/ 44 h 67"/>
                    <a:gd name="T56" fmla="*/ 182 w 272"/>
                    <a:gd name="T57" fmla="*/ 43 h 67"/>
                    <a:gd name="T58" fmla="*/ 184 w 272"/>
                    <a:gd name="T59" fmla="*/ 41 h 67"/>
                    <a:gd name="T60" fmla="*/ 185 w 272"/>
                    <a:gd name="T61" fmla="*/ 38 h 67"/>
                    <a:gd name="T62" fmla="*/ 186 w 272"/>
                    <a:gd name="T63" fmla="*/ 33 h 67"/>
                    <a:gd name="T64" fmla="*/ 189 w 272"/>
                    <a:gd name="T65" fmla="*/ 24 h 67"/>
                    <a:gd name="T66" fmla="*/ 192 w 272"/>
                    <a:gd name="T67" fmla="*/ 10 h 67"/>
                    <a:gd name="T68" fmla="*/ 194 w 272"/>
                    <a:gd name="T69" fmla="*/ 4 h 67"/>
                    <a:gd name="T70" fmla="*/ 195 w 272"/>
                    <a:gd name="T71" fmla="*/ 1 h 67"/>
                    <a:gd name="T72" fmla="*/ 197 w 272"/>
                    <a:gd name="T73" fmla="*/ 0 h 67"/>
                    <a:gd name="T74" fmla="*/ 199 w 272"/>
                    <a:gd name="T75" fmla="*/ 3 h 67"/>
                    <a:gd name="T76" fmla="*/ 201 w 272"/>
                    <a:gd name="T77" fmla="*/ 8 h 67"/>
                    <a:gd name="T78" fmla="*/ 205 w 272"/>
                    <a:gd name="T79" fmla="*/ 20 h 67"/>
                    <a:gd name="T80" fmla="*/ 209 w 272"/>
                    <a:gd name="T81" fmla="*/ 33 h 67"/>
                    <a:gd name="T82" fmla="*/ 211 w 272"/>
                    <a:gd name="T83" fmla="*/ 39 h 67"/>
                    <a:gd name="T84" fmla="*/ 214 w 272"/>
                    <a:gd name="T85" fmla="*/ 43 h 67"/>
                    <a:gd name="T86" fmla="*/ 216 w 272"/>
                    <a:gd name="T87" fmla="*/ 47 h 67"/>
                    <a:gd name="T88" fmla="*/ 218 w 272"/>
                    <a:gd name="T89" fmla="*/ 50 h 67"/>
                    <a:gd name="T90" fmla="*/ 219 w 272"/>
                    <a:gd name="T91" fmla="*/ 51 h 67"/>
                    <a:gd name="T92" fmla="*/ 221 w 272"/>
                    <a:gd name="T93" fmla="*/ 52 h 67"/>
                    <a:gd name="T94" fmla="*/ 224 w 272"/>
                    <a:gd name="T95" fmla="*/ 54 h 67"/>
                    <a:gd name="T96" fmla="*/ 228 w 272"/>
                    <a:gd name="T97" fmla="*/ 56 h 67"/>
                    <a:gd name="T98" fmla="*/ 233 w 272"/>
                    <a:gd name="T99" fmla="*/ 58 h 67"/>
                    <a:gd name="T100" fmla="*/ 237 w 272"/>
                    <a:gd name="T101" fmla="*/ 59 h 67"/>
                    <a:gd name="T102" fmla="*/ 240 w 272"/>
                    <a:gd name="T103" fmla="*/ 59 h 67"/>
                    <a:gd name="T104" fmla="*/ 242 w 272"/>
                    <a:gd name="T105" fmla="*/ 59 h 67"/>
                    <a:gd name="T106" fmla="*/ 244 w 272"/>
                    <a:gd name="T107" fmla="*/ 59 h 67"/>
                    <a:gd name="T108" fmla="*/ 247 w 272"/>
                    <a:gd name="T109" fmla="*/ 59 h 67"/>
                    <a:gd name="T110" fmla="*/ 251 w 272"/>
                    <a:gd name="T111" fmla="*/ 58 h 67"/>
                    <a:gd name="T112" fmla="*/ 254 w 272"/>
                    <a:gd name="T113" fmla="*/ 56 h 67"/>
                    <a:gd name="T114" fmla="*/ 259 w 272"/>
                    <a:gd name="T115" fmla="*/ 54 h 67"/>
                    <a:gd name="T116" fmla="*/ 261 w 272"/>
                    <a:gd name="T117" fmla="*/ 52 h 67"/>
                    <a:gd name="T118" fmla="*/ 263 w 272"/>
                    <a:gd name="T119" fmla="*/ 52 h 67"/>
                    <a:gd name="T120" fmla="*/ 265 w 272"/>
                    <a:gd name="T121" fmla="*/ 52 h 67"/>
                    <a:gd name="T122" fmla="*/ 267 w 272"/>
                    <a:gd name="T123" fmla="*/ 53 h 67"/>
                    <a:gd name="T124" fmla="*/ 269 w 272"/>
                    <a:gd name="T125" fmla="*/ 55 h 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  <a:cxn ang="0">
                      <a:pos x="T116" y="T117"/>
                    </a:cxn>
                    <a:cxn ang="0">
                      <a:pos x="T118" y="T119"/>
                    </a:cxn>
                    <a:cxn ang="0">
                      <a:pos x="T120" y="T121"/>
                    </a:cxn>
                    <a:cxn ang="0">
                      <a:pos x="T122" y="T123"/>
                    </a:cxn>
                    <a:cxn ang="0">
                      <a:pos x="T124" y="T125"/>
                    </a:cxn>
                  </a:cxnLst>
                  <a:rect l="0" t="0" r="r" b="b"/>
                  <a:pathLst>
                    <a:path w="272" h="67">
                      <a:moveTo>
                        <a:pt x="0" y="67"/>
                      </a:moveTo>
                      <a:lnTo>
                        <a:pt x="1" y="67"/>
                      </a:lnTo>
                      <a:lnTo>
                        <a:pt x="3" y="67"/>
                      </a:lnTo>
                      <a:lnTo>
                        <a:pt x="6" y="67"/>
                      </a:lnTo>
                      <a:lnTo>
                        <a:pt x="8" y="67"/>
                      </a:lnTo>
                      <a:lnTo>
                        <a:pt x="10" y="67"/>
                      </a:lnTo>
                      <a:lnTo>
                        <a:pt x="12" y="67"/>
                      </a:lnTo>
                      <a:lnTo>
                        <a:pt x="14" y="67"/>
                      </a:lnTo>
                      <a:lnTo>
                        <a:pt x="16" y="67"/>
                      </a:lnTo>
                      <a:lnTo>
                        <a:pt x="18" y="67"/>
                      </a:lnTo>
                      <a:lnTo>
                        <a:pt x="20" y="67"/>
                      </a:lnTo>
                      <a:lnTo>
                        <a:pt x="25" y="67"/>
                      </a:lnTo>
                      <a:lnTo>
                        <a:pt x="32" y="67"/>
                      </a:lnTo>
                      <a:lnTo>
                        <a:pt x="39" y="67"/>
                      </a:lnTo>
                      <a:lnTo>
                        <a:pt x="46" y="67"/>
                      </a:lnTo>
                      <a:lnTo>
                        <a:pt x="52" y="67"/>
                      </a:lnTo>
                      <a:lnTo>
                        <a:pt x="55" y="67"/>
                      </a:lnTo>
                      <a:lnTo>
                        <a:pt x="60" y="67"/>
                      </a:lnTo>
                      <a:lnTo>
                        <a:pt x="64" y="67"/>
                      </a:lnTo>
                      <a:lnTo>
                        <a:pt x="68" y="67"/>
                      </a:lnTo>
                      <a:lnTo>
                        <a:pt x="71" y="67"/>
                      </a:lnTo>
                      <a:lnTo>
                        <a:pt x="76" y="67"/>
                      </a:lnTo>
                      <a:lnTo>
                        <a:pt x="82" y="67"/>
                      </a:lnTo>
                      <a:lnTo>
                        <a:pt x="86" y="67"/>
                      </a:lnTo>
                      <a:lnTo>
                        <a:pt x="89" y="67"/>
                      </a:lnTo>
                      <a:lnTo>
                        <a:pt x="92" y="67"/>
                      </a:lnTo>
                      <a:lnTo>
                        <a:pt x="95" y="67"/>
                      </a:lnTo>
                      <a:lnTo>
                        <a:pt x="97" y="67"/>
                      </a:lnTo>
                      <a:lnTo>
                        <a:pt x="100" y="67"/>
                      </a:lnTo>
                      <a:lnTo>
                        <a:pt x="102" y="67"/>
                      </a:lnTo>
                      <a:lnTo>
                        <a:pt x="105" y="67"/>
                      </a:lnTo>
                      <a:lnTo>
                        <a:pt x="106" y="67"/>
                      </a:lnTo>
                      <a:lnTo>
                        <a:pt x="108" y="67"/>
                      </a:lnTo>
                      <a:lnTo>
                        <a:pt x="110" y="67"/>
                      </a:lnTo>
                      <a:lnTo>
                        <a:pt x="111" y="67"/>
                      </a:lnTo>
                      <a:lnTo>
                        <a:pt x="113" y="67"/>
                      </a:lnTo>
                      <a:lnTo>
                        <a:pt x="114" y="67"/>
                      </a:lnTo>
                      <a:lnTo>
                        <a:pt x="116" y="67"/>
                      </a:lnTo>
                      <a:lnTo>
                        <a:pt x="119" y="67"/>
                      </a:lnTo>
                      <a:lnTo>
                        <a:pt x="122" y="67"/>
                      </a:lnTo>
                      <a:lnTo>
                        <a:pt x="124" y="67"/>
                      </a:lnTo>
                      <a:lnTo>
                        <a:pt x="126" y="67"/>
                      </a:lnTo>
                      <a:lnTo>
                        <a:pt x="127" y="67"/>
                      </a:lnTo>
                      <a:lnTo>
                        <a:pt x="128" y="67"/>
                      </a:lnTo>
                      <a:lnTo>
                        <a:pt x="129" y="67"/>
                      </a:lnTo>
                      <a:lnTo>
                        <a:pt x="130" y="67"/>
                      </a:lnTo>
                      <a:lnTo>
                        <a:pt x="130" y="67"/>
                      </a:lnTo>
                      <a:lnTo>
                        <a:pt x="131" y="67"/>
                      </a:lnTo>
                      <a:lnTo>
                        <a:pt x="131" y="67"/>
                      </a:lnTo>
                      <a:lnTo>
                        <a:pt x="131" y="67"/>
                      </a:lnTo>
                      <a:lnTo>
                        <a:pt x="131" y="67"/>
                      </a:lnTo>
                      <a:lnTo>
                        <a:pt x="131" y="67"/>
                      </a:lnTo>
                      <a:lnTo>
                        <a:pt x="132" y="67"/>
                      </a:lnTo>
                      <a:lnTo>
                        <a:pt x="132" y="67"/>
                      </a:lnTo>
                      <a:lnTo>
                        <a:pt x="132" y="67"/>
                      </a:lnTo>
                      <a:lnTo>
                        <a:pt x="132" y="67"/>
                      </a:lnTo>
                      <a:lnTo>
                        <a:pt x="133" y="67"/>
                      </a:lnTo>
                      <a:lnTo>
                        <a:pt x="133" y="67"/>
                      </a:lnTo>
                      <a:lnTo>
                        <a:pt x="133" y="66"/>
                      </a:lnTo>
                      <a:lnTo>
                        <a:pt x="133" y="66"/>
                      </a:lnTo>
                      <a:lnTo>
                        <a:pt x="133" y="66"/>
                      </a:lnTo>
                      <a:lnTo>
                        <a:pt x="134" y="66"/>
                      </a:lnTo>
                      <a:lnTo>
                        <a:pt x="134" y="66"/>
                      </a:lnTo>
                      <a:lnTo>
                        <a:pt x="134" y="66"/>
                      </a:lnTo>
                      <a:lnTo>
                        <a:pt x="134" y="66"/>
                      </a:lnTo>
                      <a:lnTo>
                        <a:pt x="134" y="66"/>
                      </a:lnTo>
                      <a:lnTo>
                        <a:pt x="135" y="66"/>
                      </a:lnTo>
                      <a:lnTo>
                        <a:pt x="135" y="66"/>
                      </a:lnTo>
                      <a:lnTo>
                        <a:pt x="136" y="66"/>
                      </a:lnTo>
                      <a:lnTo>
                        <a:pt x="136" y="66"/>
                      </a:lnTo>
                      <a:lnTo>
                        <a:pt x="136" y="66"/>
                      </a:lnTo>
                      <a:lnTo>
                        <a:pt x="136" y="66"/>
                      </a:lnTo>
                      <a:lnTo>
                        <a:pt x="137" y="66"/>
                      </a:lnTo>
                      <a:lnTo>
                        <a:pt x="137" y="66"/>
                      </a:lnTo>
                      <a:lnTo>
                        <a:pt x="138" y="66"/>
                      </a:lnTo>
                      <a:lnTo>
                        <a:pt x="138" y="66"/>
                      </a:lnTo>
                      <a:lnTo>
                        <a:pt x="138" y="66"/>
                      </a:lnTo>
                      <a:lnTo>
                        <a:pt x="138" y="66"/>
                      </a:lnTo>
                      <a:lnTo>
                        <a:pt x="139" y="66"/>
                      </a:lnTo>
                      <a:lnTo>
                        <a:pt x="139" y="66"/>
                      </a:lnTo>
                      <a:lnTo>
                        <a:pt x="139" y="66"/>
                      </a:lnTo>
                      <a:lnTo>
                        <a:pt x="140" y="66"/>
                      </a:lnTo>
                      <a:lnTo>
                        <a:pt x="140" y="66"/>
                      </a:lnTo>
                      <a:lnTo>
                        <a:pt x="140" y="66"/>
                      </a:lnTo>
                      <a:lnTo>
                        <a:pt x="140" y="66"/>
                      </a:lnTo>
                      <a:lnTo>
                        <a:pt x="141" y="66"/>
                      </a:lnTo>
                      <a:lnTo>
                        <a:pt x="141" y="66"/>
                      </a:lnTo>
                      <a:lnTo>
                        <a:pt x="141" y="66"/>
                      </a:lnTo>
                      <a:lnTo>
                        <a:pt x="141" y="65"/>
                      </a:lnTo>
                      <a:lnTo>
                        <a:pt x="142" y="65"/>
                      </a:lnTo>
                      <a:lnTo>
                        <a:pt x="142" y="65"/>
                      </a:lnTo>
                      <a:lnTo>
                        <a:pt x="142" y="65"/>
                      </a:lnTo>
                      <a:lnTo>
                        <a:pt x="142" y="65"/>
                      </a:lnTo>
                      <a:lnTo>
                        <a:pt x="143" y="65"/>
                      </a:lnTo>
                      <a:lnTo>
                        <a:pt x="143" y="65"/>
                      </a:lnTo>
                      <a:lnTo>
                        <a:pt x="143" y="65"/>
                      </a:lnTo>
                      <a:lnTo>
                        <a:pt x="143" y="65"/>
                      </a:lnTo>
                      <a:lnTo>
                        <a:pt x="144" y="65"/>
                      </a:lnTo>
                      <a:lnTo>
                        <a:pt x="144" y="65"/>
                      </a:lnTo>
                      <a:lnTo>
                        <a:pt x="144" y="65"/>
                      </a:lnTo>
                      <a:lnTo>
                        <a:pt x="144" y="65"/>
                      </a:lnTo>
                      <a:lnTo>
                        <a:pt x="144" y="65"/>
                      </a:lnTo>
                      <a:lnTo>
                        <a:pt x="145" y="65"/>
                      </a:lnTo>
                      <a:lnTo>
                        <a:pt x="145" y="65"/>
                      </a:lnTo>
                      <a:lnTo>
                        <a:pt x="145" y="65"/>
                      </a:lnTo>
                      <a:lnTo>
                        <a:pt x="145" y="64"/>
                      </a:lnTo>
                      <a:lnTo>
                        <a:pt x="146" y="64"/>
                      </a:lnTo>
                      <a:lnTo>
                        <a:pt x="146" y="64"/>
                      </a:lnTo>
                      <a:lnTo>
                        <a:pt x="146" y="64"/>
                      </a:lnTo>
                      <a:lnTo>
                        <a:pt x="146" y="64"/>
                      </a:lnTo>
                      <a:lnTo>
                        <a:pt x="146" y="64"/>
                      </a:lnTo>
                      <a:lnTo>
                        <a:pt x="147" y="64"/>
                      </a:lnTo>
                      <a:lnTo>
                        <a:pt x="147" y="64"/>
                      </a:lnTo>
                      <a:lnTo>
                        <a:pt x="147" y="64"/>
                      </a:lnTo>
                      <a:lnTo>
                        <a:pt x="147" y="63"/>
                      </a:lnTo>
                      <a:lnTo>
                        <a:pt x="148" y="63"/>
                      </a:lnTo>
                      <a:lnTo>
                        <a:pt x="148" y="63"/>
                      </a:lnTo>
                      <a:lnTo>
                        <a:pt x="148" y="63"/>
                      </a:lnTo>
                      <a:lnTo>
                        <a:pt x="148" y="63"/>
                      </a:lnTo>
                      <a:lnTo>
                        <a:pt x="148" y="63"/>
                      </a:lnTo>
                      <a:lnTo>
                        <a:pt x="149" y="63"/>
                      </a:lnTo>
                      <a:lnTo>
                        <a:pt x="149" y="63"/>
                      </a:lnTo>
                      <a:lnTo>
                        <a:pt x="149" y="63"/>
                      </a:lnTo>
                      <a:lnTo>
                        <a:pt x="149" y="62"/>
                      </a:lnTo>
                      <a:lnTo>
                        <a:pt x="149" y="62"/>
                      </a:lnTo>
                      <a:lnTo>
                        <a:pt x="150" y="62"/>
                      </a:lnTo>
                      <a:lnTo>
                        <a:pt x="150" y="62"/>
                      </a:lnTo>
                      <a:lnTo>
                        <a:pt x="150" y="62"/>
                      </a:lnTo>
                      <a:lnTo>
                        <a:pt x="150" y="62"/>
                      </a:lnTo>
                      <a:lnTo>
                        <a:pt x="150" y="61"/>
                      </a:lnTo>
                      <a:lnTo>
                        <a:pt x="151" y="61"/>
                      </a:lnTo>
                      <a:lnTo>
                        <a:pt x="151" y="61"/>
                      </a:lnTo>
                      <a:lnTo>
                        <a:pt x="151" y="61"/>
                      </a:lnTo>
                      <a:lnTo>
                        <a:pt x="151" y="61"/>
                      </a:lnTo>
                      <a:lnTo>
                        <a:pt x="151" y="60"/>
                      </a:lnTo>
                      <a:lnTo>
                        <a:pt x="152" y="60"/>
                      </a:lnTo>
                      <a:lnTo>
                        <a:pt x="152" y="60"/>
                      </a:lnTo>
                      <a:lnTo>
                        <a:pt x="152" y="60"/>
                      </a:lnTo>
                      <a:lnTo>
                        <a:pt x="152" y="60"/>
                      </a:lnTo>
                      <a:lnTo>
                        <a:pt x="152" y="60"/>
                      </a:lnTo>
                      <a:lnTo>
                        <a:pt x="153" y="60"/>
                      </a:lnTo>
                      <a:lnTo>
                        <a:pt x="153" y="59"/>
                      </a:lnTo>
                      <a:lnTo>
                        <a:pt x="153" y="59"/>
                      </a:lnTo>
                      <a:lnTo>
                        <a:pt x="153" y="59"/>
                      </a:lnTo>
                      <a:lnTo>
                        <a:pt x="153" y="59"/>
                      </a:lnTo>
                      <a:lnTo>
                        <a:pt x="154" y="58"/>
                      </a:lnTo>
                      <a:lnTo>
                        <a:pt x="154" y="58"/>
                      </a:lnTo>
                      <a:lnTo>
                        <a:pt x="154" y="58"/>
                      </a:lnTo>
                      <a:lnTo>
                        <a:pt x="154" y="57"/>
                      </a:lnTo>
                      <a:lnTo>
                        <a:pt x="155" y="57"/>
                      </a:lnTo>
                      <a:lnTo>
                        <a:pt x="155" y="56"/>
                      </a:lnTo>
                      <a:lnTo>
                        <a:pt x="156" y="56"/>
                      </a:lnTo>
                      <a:lnTo>
                        <a:pt x="156" y="55"/>
                      </a:lnTo>
                      <a:lnTo>
                        <a:pt x="156" y="55"/>
                      </a:lnTo>
                      <a:lnTo>
                        <a:pt x="157" y="54"/>
                      </a:lnTo>
                      <a:lnTo>
                        <a:pt x="157" y="54"/>
                      </a:lnTo>
                      <a:lnTo>
                        <a:pt x="158" y="53"/>
                      </a:lnTo>
                      <a:lnTo>
                        <a:pt x="158" y="52"/>
                      </a:lnTo>
                      <a:lnTo>
                        <a:pt x="159" y="51"/>
                      </a:lnTo>
                      <a:lnTo>
                        <a:pt x="159" y="50"/>
                      </a:lnTo>
                      <a:lnTo>
                        <a:pt x="160" y="50"/>
                      </a:lnTo>
                      <a:lnTo>
                        <a:pt x="161" y="49"/>
                      </a:lnTo>
                      <a:lnTo>
                        <a:pt x="161" y="48"/>
                      </a:lnTo>
                      <a:lnTo>
                        <a:pt x="161" y="48"/>
                      </a:lnTo>
                      <a:lnTo>
                        <a:pt x="162" y="47"/>
                      </a:lnTo>
                      <a:lnTo>
                        <a:pt x="162" y="47"/>
                      </a:lnTo>
                      <a:lnTo>
                        <a:pt x="163" y="46"/>
                      </a:lnTo>
                      <a:lnTo>
                        <a:pt x="163" y="46"/>
                      </a:lnTo>
                      <a:lnTo>
                        <a:pt x="163" y="45"/>
                      </a:lnTo>
                      <a:lnTo>
                        <a:pt x="164" y="45"/>
                      </a:lnTo>
                      <a:lnTo>
                        <a:pt x="164" y="45"/>
                      </a:lnTo>
                      <a:lnTo>
                        <a:pt x="164" y="44"/>
                      </a:lnTo>
                      <a:lnTo>
                        <a:pt x="165" y="44"/>
                      </a:lnTo>
                      <a:lnTo>
                        <a:pt x="165" y="44"/>
                      </a:lnTo>
                      <a:lnTo>
                        <a:pt x="165" y="43"/>
                      </a:lnTo>
                      <a:lnTo>
                        <a:pt x="166" y="43"/>
                      </a:lnTo>
                      <a:lnTo>
                        <a:pt x="166" y="43"/>
                      </a:lnTo>
                      <a:lnTo>
                        <a:pt x="166" y="43"/>
                      </a:lnTo>
                      <a:lnTo>
                        <a:pt x="167" y="42"/>
                      </a:lnTo>
                      <a:lnTo>
                        <a:pt x="167" y="42"/>
                      </a:lnTo>
                      <a:lnTo>
                        <a:pt x="167" y="42"/>
                      </a:lnTo>
                      <a:lnTo>
                        <a:pt x="168" y="42"/>
                      </a:lnTo>
                      <a:lnTo>
                        <a:pt x="168" y="42"/>
                      </a:lnTo>
                      <a:lnTo>
                        <a:pt x="169" y="42"/>
                      </a:lnTo>
                      <a:lnTo>
                        <a:pt x="169" y="42"/>
                      </a:lnTo>
                      <a:lnTo>
                        <a:pt x="169" y="42"/>
                      </a:lnTo>
                      <a:lnTo>
                        <a:pt x="169" y="42"/>
                      </a:lnTo>
                      <a:lnTo>
                        <a:pt x="170" y="42"/>
                      </a:lnTo>
                      <a:lnTo>
                        <a:pt x="170" y="42"/>
                      </a:lnTo>
                      <a:lnTo>
                        <a:pt x="171" y="42"/>
                      </a:lnTo>
                      <a:lnTo>
                        <a:pt x="171" y="42"/>
                      </a:lnTo>
                      <a:lnTo>
                        <a:pt x="171" y="42"/>
                      </a:lnTo>
                      <a:lnTo>
                        <a:pt x="172" y="42"/>
                      </a:lnTo>
                      <a:lnTo>
                        <a:pt x="172" y="42"/>
                      </a:lnTo>
                      <a:lnTo>
                        <a:pt x="173" y="42"/>
                      </a:lnTo>
                      <a:lnTo>
                        <a:pt x="173" y="42"/>
                      </a:lnTo>
                      <a:lnTo>
                        <a:pt x="174" y="42"/>
                      </a:lnTo>
                      <a:lnTo>
                        <a:pt x="174" y="42"/>
                      </a:lnTo>
                      <a:lnTo>
                        <a:pt x="174" y="42"/>
                      </a:lnTo>
                      <a:lnTo>
                        <a:pt x="174" y="42"/>
                      </a:lnTo>
                      <a:lnTo>
                        <a:pt x="175" y="42"/>
                      </a:lnTo>
                      <a:lnTo>
                        <a:pt x="175" y="43"/>
                      </a:lnTo>
                      <a:lnTo>
                        <a:pt x="175" y="43"/>
                      </a:lnTo>
                      <a:lnTo>
                        <a:pt x="175" y="43"/>
                      </a:lnTo>
                      <a:lnTo>
                        <a:pt x="175" y="43"/>
                      </a:lnTo>
                      <a:lnTo>
                        <a:pt x="176" y="43"/>
                      </a:lnTo>
                      <a:lnTo>
                        <a:pt x="176" y="43"/>
                      </a:lnTo>
                      <a:lnTo>
                        <a:pt x="176" y="43"/>
                      </a:lnTo>
                      <a:lnTo>
                        <a:pt x="176" y="43"/>
                      </a:lnTo>
                      <a:lnTo>
                        <a:pt x="177" y="43"/>
                      </a:lnTo>
                      <a:lnTo>
                        <a:pt x="177" y="44"/>
                      </a:lnTo>
                      <a:lnTo>
                        <a:pt x="178" y="44"/>
                      </a:lnTo>
                      <a:lnTo>
                        <a:pt x="178" y="44"/>
                      </a:lnTo>
                      <a:lnTo>
                        <a:pt x="178" y="44"/>
                      </a:lnTo>
                      <a:lnTo>
                        <a:pt x="179" y="44"/>
                      </a:lnTo>
                      <a:lnTo>
                        <a:pt x="179" y="44"/>
                      </a:lnTo>
                      <a:lnTo>
                        <a:pt x="179" y="44"/>
                      </a:lnTo>
                      <a:lnTo>
                        <a:pt x="179" y="44"/>
                      </a:lnTo>
                      <a:lnTo>
                        <a:pt x="180" y="44"/>
                      </a:lnTo>
                      <a:lnTo>
                        <a:pt x="180" y="44"/>
                      </a:lnTo>
                      <a:lnTo>
                        <a:pt x="180" y="44"/>
                      </a:lnTo>
                      <a:lnTo>
                        <a:pt x="180" y="44"/>
                      </a:lnTo>
                      <a:lnTo>
                        <a:pt x="181" y="44"/>
                      </a:lnTo>
                      <a:lnTo>
                        <a:pt x="181" y="44"/>
                      </a:lnTo>
                      <a:lnTo>
                        <a:pt x="181" y="44"/>
                      </a:lnTo>
                      <a:lnTo>
                        <a:pt x="181" y="44"/>
                      </a:lnTo>
                      <a:lnTo>
                        <a:pt x="181" y="44"/>
                      </a:lnTo>
                      <a:lnTo>
                        <a:pt x="181" y="43"/>
                      </a:lnTo>
                      <a:lnTo>
                        <a:pt x="182" y="43"/>
                      </a:lnTo>
                      <a:lnTo>
                        <a:pt x="182" y="43"/>
                      </a:lnTo>
                      <a:lnTo>
                        <a:pt x="182" y="43"/>
                      </a:lnTo>
                      <a:lnTo>
                        <a:pt x="182" y="43"/>
                      </a:lnTo>
                      <a:lnTo>
                        <a:pt x="183" y="42"/>
                      </a:lnTo>
                      <a:lnTo>
                        <a:pt x="183" y="42"/>
                      </a:lnTo>
                      <a:lnTo>
                        <a:pt x="183" y="42"/>
                      </a:lnTo>
                      <a:lnTo>
                        <a:pt x="183" y="42"/>
                      </a:lnTo>
                      <a:lnTo>
                        <a:pt x="183" y="42"/>
                      </a:lnTo>
                      <a:lnTo>
                        <a:pt x="184" y="41"/>
                      </a:lnTo>
                      <a:lnTo>
                        <a:pt x="184" y="41"/>
                      </a:lnTo>
                      <a:lnTo>
                        <a:pt x="184" y="41"/>
                      </a:lnTo>
                      <a:lnTo>
                        <a:pt x="184" y="40"/>
                      </a:lnTo>
                      <a:lnTo>
                        <a:pt x="184" y="40"/>
                      </a:lnTo>
                      <a:lnTo>
                        <a:pt x="184" y="40"/>
                      </a:lnTo>
                      <a:lnTo>
                        <a:pt x="184" y="39"/>
                      </a:lnTo>
                      <a:lnTo>
                        <a:pt x="185" y="39"/>
                      </a:lnTo>
                      <a:lnTo>
                        <a:pt x="185" y="38"/>
                      </a:lnTo>
                      <a:lnTo>
                        <a:pt x="185" y="38"/>
                      </a:lnTo>
                      <a:lnTo>
                        <a:pt x="185" y="38"/>
                      </a:lnTo>
                      <a:lnTo>
                        <a:pt x="185" y="37"/>
                      </a:lnTo>
                      <a:lnTo>
                        <a:pt x="186" y="37"/>
                      </a:lnTo>
                      <a:lnTo>
                        <a:pt x="186" y="36"/>
                      </a:lnTo>
                      <a:lnTo>
                        <a:pt x="186" y="36"/>
                      </a:lnTo>
                      <a:lnTo>
                        <a:pt x="186" y="35"/>
                      </a:lnTo>
                      <a:lnTo>
                        <a:pt x="186" y="35"/>
                      </a:lnTo>
                      <a:lnTo>
                        <a:pt x="186" y="34"/>
                      </a:lnTo>
                      <a:lnTo>
                        <a:pt x="186" y="33"/>
                      </a:lnTo>
                      <a:lnTo>
                        <a:pt x="187" y="32"/>
                      </a:lnTo>
                      <a:lnTo>
                        <a:pt x="187" y="31"/>
                      </a:lnTo>
                      <a:lnTo>
                        <a:pt x="187" y="30"/>
                      </a:lnTo>
                      <a:lnTo>
                        <a:pt x="188" y="29"/>
                      </a:lnTo>
                      <a:lnTo>
                        <a:pt x="188" y="28"/>
                      </a:lnTo>
                      <a:lnTo>
                        <a:pt x="188" y="27"/>
                      </a:lnTo>
                      <a:lnTo>
                        <a:pt x="189" y="25"/>
                      </a:lnTo>
                      <a:lnTo>
                        <a:pt x="189" y="24"/>
                      </a:lnTo>
                      <a:lnTo>
                        <a:pt x="189" y="21"/>
                      </a:lnTo>
                      <a:lnTo>
                        <a:pt x="190" y="19"/>
                      </a:lnTo>
                      <a:lnTo>
                        <a:pt x="190" y="17"/>
                      </a:lnTo>
                      <a:lnTo>
                        <a:pt x="191" y="15"/>
                      </a:lnTo>
                      <a:lnTo>
                        <a:pt x="191" y="14"/>
                      </a:lnTo>
                      <a:lnTo>
                        <a:pt x="191" y="12"/>
                      </a:lnTo>
                      <a:lnTo>
                        <a:pt x="192" y="11"/>
                      </a:lnTo>
                      <a:lnTo>
                        <a:pt x="192" y="10"/>
                      </a:lnTo>
                      <a:lnTo>
                        <a:pt x="192" y="9"/>
                      </a:lnTo>
                      <a:lnTo>
                        <a:pt x="192" y="8"/>
                      </a:lnTo>
                      <a:lnTo>
                        <a:pt x="193" y="7"/>
                      </a:lnTo>
                      <a:lnTo>
                        <a:pt x="193" y="7"/>
                      </a:lnTo>
                      <a:lnTo>
                        <a:pt x="193" y="6"/>
                      </a:lnTo>
                      <a:lnTo>
                        <a:pt x="193" y="5"/>
                      </a:lnTo>
                      <a:lnTo>
                        <a:pt x="194" y="5"/>
                      </a:lnTo>
                      <a:lnTo>
                        <a:pt x="194" y="4"/>
                      </a:lnTo>
                      <a:lnTo>
                        <a:pt x="194" y="4"/>
                      </a:lnTo>
                      <a:lnTo>
                        <a:pt x="194" y="3"/>
                      </a:lnTo>
                      <a:lnTo>
                        <a:pt x="194" y="3"/>
                      </a:lnTo>
                      <a:lnTo>
                        <a:pt x="194" y="2"/>
                      </a:lnTo>
                      <a:lnTo>
                        <a:pt x="195" y="2"/>
                      </a:lnTo>
                      <a:lnTo>
                        <a:pt x="195" y="2"/>
                      </a:lnTo>
                      <a:lnTo>
                        <a:pt x="195" y="1"/>
                      </a:lnTo>
                      <a:lnTo>
                        <a:pt x="195" y="1"/>
                      </a:lnTo>
                      <a:lnTo>
                        <a:pt x="196" y="1"/>
                      </a:lnTo>
                      <a:lnTo>
                        <a:pt x="196" y="0"/>
                      </a:lnTo>
                      <a:lnTo>
                        <a:pt x="196" y="0"/>
                      </a:lnTo>
                      <a:lnTo>
                        <a:pt x="196" y="0"/>
                      </a:lnTo>
                      <a:lnTo>
                        <a:pt x="196" y="0"/>
                      </a:lnTo>
                      <a:lnTo>
                        <a:pt x="197" y="0"/>
                      </a:lnTo>
                      <a:lnTo>
                        <a:pt x="197" y="0"/>
                      </a:lnTo>
                      <a:lnTo>
                        <a:pt x="197" y="0"/>
                      </a:lnTo>
                      <a:lnTo>
                        <a:pt x="198" y="0"/>
                      </a:lnTo>
                      <a:lnTo>
                        <a:pt x="198" y="0"/>
                      </a:lnTo>
                      <a:lnTo>
                        <a:pt x="198" y="1"/>
                      </a:lnTo>
                      <a:lnTo>
                        <a:pt x="199" y="1"/>
                      </a:lnTo>
                      <a:lnTo>
                        <a:pt x="199" y="2"/>
                      </a:lnTo>
                      <a:lnTo>
                        <a:pt x="199" y="2"/>
                      </a:lnTo>
                      <a:lnTo>
                        <a:pt x="199" y="2"/>
                      </a:lnTo>
                      <a:lnTo>
                        <a:pt x="199" y="3"/>
                      </a:lnTo>
                      <a:lnTo>
                        <a:pt x="200" y="3"/>
                      </a:lnTo>
                      <a:lnTo>
                        <a:pt x="200" y="4"/>
                      </a:lnTo>
                      <a:lnTo>
                        <a:pt x="200" y="4"/>
                      </a:lnTo>
                      <a:lnTo>
                        <a:pt x="200" y="5"/>
                      </a:lnTo>
                      <a:lnTo>
                        <a:pt x="201" y="5"/>
                      </a:lnTo>
                      <a:lnTo>
                        <a:pt x="201" y="6"/>
                      </a:lnTo>
                      <a:lnTo>
                        <a:pt x="201" y="7"/>
                      </a:lnTo>
                      <a:lnTo>
                        <a:pt x="201" y="8"/>
                      </a:lnTo>
                      <a:lnTo>
                        <a:pt x="202" y="9"/>
                      </a:lnTo>
                      <a:lnTo>
                        <a:pt x="202" y="10"/>
                      </a:lnTo>
                      <a:lnTo>
                        <a:pt x="202" y="11"/>
                      </a:lnTo>
                      <a:lnTo>
                        <a:pt x="203" y="12"/>
                      </a:lnTo>
                      <a:lnTo>
                        <a:pt x="203" y="13"/>
                      </a:lnTo>
                      <a:lnTo>
                        <a:pt x="204" y="15"/>
                      </a:lnTo>
                      <a:lnTo>
                        <a:pt x="204" y="17"/>
                      </a:lnTo>
                      <a:lnTo>
                        <a:pt x="205" y="20"/>
                      </a:lnTo>
                      <a:lnTo>
                        <a:pt x="206" y="22"/>
                      </a:lnTo>
                      <a:lnTo>
                        <a:pt x="206" y="24"/>
                      </a:lnTo>
                      <a:lnTo>
                        <a:pt x="207" y="26"/>
                      </a:lnTo>
                      <a:lnTo>
                        <a:pt x="207" y="28"/>
                      </a:lnTo>
                      <a:lnTo>
                        <a:pt x="208" y="29"/>
                      </a:lnTo>
                      <a:lnTo>
                        <a:pt x="208" y="30"/>
                      </a:lnTo>
                      <a:lnTo>
                        <a:pt x="209" y="32"/>
                      </a:lnTo>
                      <a:lnTo>
                        <a:pt x="209" y="33"/>
                      </a:lnTo>
                      <a:lnTo>
                        <a:pt x="210" y="34"/>
                      </a:lnTo>
                      <a:lnTo>
                        <a:pt x="210" y="35"/>
                      </a:lnTo>
                      <a:lnTo>
                        <a:pt x="210" y="35"/>
                      </a:lnTo>
                      <a:lnTo>
                        <a:pt x="210" y="36"/>
                      </a:lnTo>
                      <a:lnTo>
                        <a:pt x="211" y="37"/>
                      </a:lnTo>
                      <a:lnTo>
                        <a:pt x="211" y="37"/>
                      </a:lnTo>
                      <a:lnTo>
                        <a:pt x="211" y="38"/>
                      </a:lnTo>
                      <a:lnTo>
                        <a:pt x="211" y="39"/>
                      </a:lnTo>
                      <a:lnTo>
                        <a:pt x="212" y="39"/>
                      </a:lnTo>
                      <a:lnTo>
                        <a:pt x="212" y="40"/>
                      </a:lnTo>
                      <a:lnTo>
                        <a:pt x="212" y="40"/>
                      </a:lnTo>
                      <a:lnTo>
                        <a:pt x="212" y="41"/>
                      </a:lnTo>
                      <a:lnTo>
                        <a:pt x="213" y="42"/>
                      </a:lnTo>
                      <a:lnTo>
                        <a:pt x="213" y="42"/>
                      </a:lnTo>
                      <a:lnTo>
                        <a:pt x="213" y="42"/>
                      </a:lnTo>
                      <a:lnTo>
                        <a:pt x="214" y="43"/>
                      </a:lnTo>
                      <a:lnTo>
                        <a:pt x="214" y="43"/>
                      </a:lnTo>
                      <a:lnTo>
                        <a:pt x="214" y="44"/>
                      </a:lnTo>
                      <a:lnTo>
                        <a:pt x="214" y="45"/>
                      </a:lnTo>
                      <a:lnTo>
                        <a:pt x="215" y="45"/>
                      </a:lnTo>
                      <a:lnTo>
                        <a:pt x="215" y="45"/>
                      </a:lnTo>
                      <a:lnTo>
                        <a:pt x="215" y="46"/>
                      </a:lnTo>
                      <a:lnTo>
                        <a:pt x="216" y="46"/>
                      </a:lnTo>
                      <a:lnTo>
                        <a:pt x="216" y="47"/>
                      </a:lnTo>
                      <a:lnTo>
                        <a:pt x="216" y="47"/>
                      </a:lnTo>
                      <a:lnTo>
                        <a:pt x="216" y="48"/>
                      </a:lnTo>
                      <a:lnTo>
                        <a:pt x="217" y="48"/>
                      </a:lnTo>
                      <a:lnTo>
                        <a:pt x="217" y="48"/>
                      </a:lnTo>
                      <a:lnTo>
                        <a:pt x="217" y="49"/>
                      </a:lnTo>
                      <a:lnTo>
                        <a:pt x="218" y="49"/>
                      </a:lnTo>
                      <a:lnTo>
                        <a:pt x="218" y="49"/>
                      </a:lnTo>
                      <a:lnTo>
                        <a:pt x="218" y="50"/>
                      </a:lnTo>
                      <a:lnTo>
                        <a:pt x="218" y="50"/>
                      </a:lnTo>
                      <a:lnTo>
                        <a:pt x="219" y="50"/>
                      </a:lnTo>
                      <a:lnTo>
                        <a:pt x="219" y="50"/>
                      </a:lnTo>
                      <a:lnTo>
                        <a:pt x="219" y="50"/>
                      </a:lnTo>
                      <a:lnTo>
                        <a:pt x="219" y="50"/>
                      </a:lnTo>
                      <a:lnTo>
                        <a:pt x="219" y="51"/>
                      </a:lnTo>
                      <a:lnTo>
                        <a:pt x="219" y="51"/>
                      </a:lnTo>
                      <a:lnTo>
                        <a:pt x="219" y="51"/>
                      </a:lnTo>
                      <a:lnTo>
                        <a:pt x="220" y="51"/>
                      </a:lnTo>
                      <a:lnTo>
                        <a:pt x="220" y="51"/>
                      </a:lnTo>
                      <a:lnTo>
                        <a:pt x="220" y="51"/>
                      </a:lnTo>
                      <a:lnTo>
                        <a:pt x="220" y="51"/>
                      </a:lnTo>
                      <a:lnTo>
                        <a:pt x="220" y="51"/>
                      </a:lnTo>
                      <a:lnTo>
                        <a:pt x="221" y="52"/>
                      </a:lnTo>
                      <a:lnTo>
                        <a:pt x="221" y="52"/>
                      </a:lnTo>
                      <a:lnTo>
                        <a:pt x="221" y="52"/>
                      </a:lnTo>
                      <a:lnTo>
                        <a:pt x="221" y="52"/>
                      </a:lnTo>
                      <a:lnTo>
                        <a:pt x="222" y="53"/>
                      </a:lnTo>
                      <a:lnTo>
                        <a:pt x="222" y="53"/>
                      </a:lnTo>
                      <a:lnTo>
                        <a:pt x="223" y="53"/>
                      </a:lnTo>
                      <a:lnTo>
                        <a:pt x="223" y="53"/>
                      </a:lnTo>
                      <a:lnTo>
                        <a:pt x="223" y="53"/>
                      </a:lnTo>
                      <a:lnTo>
                        <a:pt x="224" y="54"/>
                      </a:lnTo>
                      <a:lnTo>
                        <a:pt x="224" y="54"/>
                      </a:lnTo>
                      <a:lnTo>
                        <a:pt x="224" y="54"/>
                      </a:lnTo>
                      <a:lnTo>
                        <a:pt x="225" y="54"/>
                      </a:lnTo>
                      <a:lnTo>
                        <a:pt x="225" y="55"/>
                      </a:lnTo>
                      <a:lnTo>
                        <a:pt x="226" y="55"/>
                      </a:lnTo>
                      <a:lnTo>
                        <a:pt x="226" y="55"/>
                      </a:lnTo>
                      <a:lnTo>
                        <a:pt x="227" y="55"/>
                      </a:lnTo>
                      <a:lnTo>
                        <a:pt x="228" y="55"/>
                      </a:lnTo>
                      <a:lnTo>
                        <a:pt x="228" y="56"/>
                      </a:lnTo>
                      <a:lnTo>
                        <a:pt x="229" y="56"/>
                      </a:lnTo>
                      <a:lnTo>
                        <a:pt x="229" y="56"/>
                      </a:lnTo>
                      <a:lnTo>
                        <a:pt x="230" y="57"/>
                      </a:lnTo>
                      <a:lnTo>
                        <a:pt x="231" y="57"/>
                      </a:lnTo>
                      <a:lnTo>
                        <a:pt x="232" y="57"/>
                      </a:lnTo>
                      <a:lnTo>
                        <a:pt x="232" y="57"/>
                      </a:lnTo>
                      <a:lnTo>
                        <a:pt x="233" y="58"/>
                      </a:lnTo>
                      <a:lnTo>
                        <a:pt x="233" y="58"/>
                      </a:lnTo>
                      <a:lnTo>
                        <a:pt x="234" y="58"/>
                      </a:lnTo>
                      <a:lnTo>
                        <a:pt x="234" y="58"/>
                      </a:lnTo>
                      <a:lnTo>
                        <a:pt x="235" y="58"/>
                      </a:lnTo>
                      <a:lnTo>
                        <a:pt x="235" y="58"/>
                      </a:lnTo>
                      <a:lnTo>
                        <a:pt x="236" y="58"/>
                      </a:lnTo>
                      <a:lnTo>
                        <a:pt x="237" y="59"/>
                      </a:lnTo>
                      <a:lnTo>
                        <a:pt x="237" y="59"/>
                      </a:lnTo>
                      <a:lnTo>
                        <a:pt x="237" y="59"/>
                      </a:lnTo>
                      <a:lnTo>
                        <a:pt x="238" y="59"/>
                      </a:lnTo>
                      <a:lnTo>
                        <a:pt x="238" y="59"/>
                      </a:lnTo>
                      <a:lnTo>
                        <a:pt x="238" y="59"/>
                      </a:lnTo>
                      <a:lnTo>
                        <a:pt x="239" y="59"/>
                      </a:lnTo>
                      <a:lnTo>
                        <a:pt x="239" y="59"/>
                      </a:lnTo>
                      <a:lnTo>
                        <a:pt x="239" y="59"/>
                      </a:lnTo>
                      <a:lnTo>
                        <a:pt x="239" y="59"/>
                      </a:lnTo>
                      <a:lnTo>
                        <a:pt x="240" y="59"/>
                      </a:lnTo>
                      <a:lnTo>
                        <a:pt x="240" y="59"/>
                      </a:lnTo>
                      <a:lnTo>
                        <a:pt x="240" y="59"/>
                      </a:lnTo>
                      <a:lnTo>
                        <a:pt x="241" y="59"/>
                      </a:lnTo>
                      <a:lnTo>
                        <a:pt x="241" y="59"/>
                      </a:lnTo>
                      <a:lnTo>
                        <a:pt x="241" y="59"/>
                      </a:lnTo>
                      <a:lnTo>
                        <a:pt x="242" y="59"/>
                      </a:lnTo>
                      <a:lnTo>
                        <a:pt x="242" y="59"/>
                      </a:lnTo>
                      <a:lnTo>
                        <a:pt x="242" y="59"/>
                      </a:lnTo>
                      <a:lnTo>
                        <a:pt x="242" y="59"/>
                      </a:lnTo>
                      <a:lnTo>
                        <a:pt x="243" y="59"/>
                      </a:lnTo>
                      <a:lnTo>
                        <a:pt x="243" y="59"/>
                      </a:lnTo>
                      <a:lnTo>
                        <a:pt x="243" y="59"/>
                      </a:lnTo>
                      <a:lnTo>
                        <a:pt x="244" y="59"/>
                      </a:lnTo>
                      <a:lnTo>
                        <a:pt x="244" y="59"/>
                      </a:lnTo>
                      <a:lnTo>
                        <a:pt x="244" y="59"/>
                      </a:lnTo>
                      <a:lnTo>
                        <a:pt x="244" y="59"/>
                      </a:lnTo>
                      <a:lnTo>
                        <a:pt x="245" y="59"/>
                      </a:lnTo>
                      <a:lnTo>
                        <a:pt x="245" y="59"/>
                      </a:lnTo>
                      <a:lnTo>
                        <a:pt x="245" y="59"/>
                      </a:lnTo>
                      <a:lnTo>
                        <a:pt x="246" y="59"/>
                      </a:lnTo>
                      <a:lnTo>
                        <a:pt x="246" y="59"/>
                      </a:lnTo>
                      <a:lnTo>
                        <a:pt x="246" y="59"/>
                      </a:lnTo>
                      <a:lnTo>
                        <a:pt x="247" y="59"/>
                      </a:lnTo>
                      <a:lnTo>
                        <a:pt x="247" y="59"/>
                      </a:lnTo>
                      <a:lnTo>
                        <a:pt x="247" y="59"/>
                      </a:lnTo>
                      <a:lnTo>
                        <a:pt x="248" y="58"/>
                      </a:lnTo>
                      <a:lnTo>
                        <a:pt x="248" y="58"/>
                      </a:lnTo>
                      <a:lnTo>
                        <a:pt x="249" y="58"/>
                      </a:lnTo>
                      <a:lnTo>
                        <a:pt x="249" y="58"/>
                      </a:lnTo>
                      <a:lnTo>
                        <a:pt x="250" y="58"/>
                      </a:lnTo>
                      <a:lnTo>
                        <a:pt x="250" y="58"/>
                      </a:lnTo>
                      <a:lnTo>
                        <a:pt x="251" y="58"/>
                      </a:lnTo>
                      <a:lnTo>
                        <a:pt x="251" y="58"/>
                      </a:lnTo>
                      <a:lnTo>
                        <a:pt x="252" y="58"/>
                      </a:lnTo>
                      <a:lnTo>
                        <a:pt x="252" y="57"/>
                      </a:lnTo>
                      <a:lnTo>
                        <a:pt x="253" y="57"/>
                      </a:lnTo>
                      <a:lnTo>
                        <a:pt x="253" y="57"/>
                      </a:lnTo>
                      <a:lnTo>
                        <a:pt x="254" y="57"/>
                      </a:lnTo>
                      <a:lnTo>
                        <a:pt x="254" y="56"/>
                      </a:lnTo>
                      <a:lnTo>
                        <a:pt x="254" y="56"/>
                      </a:lnTo>
                      <a:lnTo>
                        <a:pt x="255" y="56"/>
                      </a:lnTo>
                      <a:lnTo>
                        <a:pt x="255" y="56"/>
                      </a:lnTo>
                      <a:lnTo>
                        <a:pt x="256" y="55"/>
                      </a:lnTo>
                      <a:lnTo>
                        <a:pt x="257" y="55"/>
                      </a:lnTo>
                      <a:lnTo>
                        <a:pt x="257" y="55"/>
                      </a:lnTo>
                      <a:lnTo>
                        <a:pt x="258" y="54"/>
                      </a:lnTo>
                      <a:lnTo>
                        <a:pt x="259" y="54"/>
                      </a:lnTo>
                      <a:lnTo>
                        <a:pt x="259" y="54"/>
                      </a:lnTo>
                      <a:lnTo>
                        <a:pt x="259" y="53"/>
                      </a:lnTo>
                      <a:lnTo>
                        <a:pt x="260" y="53"/>
                      </a:lnTo>
                      <a:lnTo>
                        <a:pt x="260" y="53"/>
                      </a:lnTo>
                      <a:lnTo>
                        <a:pt x="260" y="53"/>
                      </a:lnTo>
                      <a:lnTo>
                        <a:pt x="261" y="53"/>
                      </a:lnTo>
                      <a:lnTo>
                        <a:pt x="261" y="53"/>
                      </a:lnTo>
                      <a:lnTo>
                        <a:pt x="261" y="53"/>
                      </a:lnTo>
                      <a:lnTo>
                        <a:pt x="261" y="52"/>
                      </a:lnTo>
                      <a:lnTo>
                        <a:pt x="262" y="52"/>
                      </a:lnTo>
                      <a:lnTo>
                        <a:pt x="262" y="52"/>
                      </a:lnTo>
                      <a:lnTo>
                        <a:pt x="262" y="52"/>
                      </a:lnTo>
                      <a:lnTo>
                        <a:pt x="262" y="52"/>
                      </a:lnTo>
                      <a:lnTo>
                        <a:pt x="263" y="52"/>
                      </a:lnTo>
                      <a:lnTo>
                        <a:pt x="263" y="52"/>
                      </a:lnTo>
                      <a:lnTo>
                        <a:pt x="263" y="52"/>
                      </a:lnTo>
                      <a:lnTo>
                        <a:pt x="263" y="52"/>
                      </a:lnTo>
                      <a:lnTo>
                        <a:pt x="264" y="52"/>
                      </a:lnTo>
                      <a:lnTo>
                        <a:pt x="264" y="52"/>
                      </a:lnTo>
                      <a:lnTo>
                        <a:pt x="264" y="52"/>
                      </a:lnTo>
                      <a:lnTo>
                        <a:pt x="264" y="52"/>
                      </a:lnTo>
                      <a:lnTo>
                        <a:pt x="264" y="52"/>
                      </a:lnTo>
                      <a:lnTo>
                        <a:pt x="265" y="52"/>
                      </a:lnTo>
                      <a:lnTo>
                        <a:pt x="265" y="52"/>
                      </a:lnTo>
                      <a:lnTo>
                        <a:pt x="265" y="52"/>
                      </a:lnTo>
                      <a:lnTo>
                        <a:pt x="265" y="52"/>
                      </a:lnTo>
                      <a:lnTo>
                        <a:pt x="266" y="52"/>
                      </a:lnTo>
                      <a:lnTo>
                        <a:pt x="266" y="52"/>
                      </a:lnTo>
                      <a:lnTo>
                        <a:pt x="266" y="52"/>
                      </a:lnTo>
                      <a:lnTo>
                        <a:pt x="266" y="53"/>
                      </a:lnTo>
                      <a:lnTo>
                        <a:pt x="266" y="53"/>
                      </a:lnTo>
                      <a:lnTo>
                        <a:pt x="267" y="53"/>
                      </a:lnTo>
                      <a:lnTo>
                        <a:pt x="267" y="53"/>
                      </a:lnTo>
                      <a:lnTo>
                        <a:pt x="267" y="53"/>
                      </a:lnTo>
                      <a:lnTo>
                        <a:pt x="267" y="53"/>
                      </a:lnTo>
                      <a:lnTo>
                        <a:pt x="267" y="53"/>
                      </a:lnTo>
                      <a:lnTo>
                        <a:pt x="268" y="53"/>
                      </a:lnTo>
                      <a:lnTo>
                        <a:pt x="268" y="54"/>
                      </a:lnTo>
                      <a:lnTo>
                        <a:pt x="268" y="54"/>
                      </a:lnTo>
                      <a:lnTo>
                        <a:pt x="269" y="54"/>
                      </a:lnTo>
                      <a:lnTo>
                        <a:pt x="269" y="55"/>
                      </a:lnTo>
                      <a:lnTo>
                        <a:pt x="269" y="55"/>
                      </a:lnTo>
                      <a:lnTo>
                        <a:pt x="269" y="55"/>
                      </a:lnTo>
                      <a:lnTo>
                        <a:pt x="270" y="55"/>
                      </a:lnTo>
                      <a:lnTo>
                        <a:pt x="270" y="56"/>
                      </a:lnTo>
                      <a:lnTo>
                        <a:pt x="271" y="57"/>
                      </a:lnTo>
                      <a:lnTo>
                        <a:pt x="272" y="57"/>
                      </a:lnTo>
                      <a:lnTo>
                        <a:pt x="272" y="58"/>
                      </a:lnTo>
                    </a:path>
                  </a:pathLst>
                </a:cu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5" name="Freeform 146"/>
                <p:cNvSpPr>
                  <a:spLocks/>
                </p:cNvSpPr>
                <p:nvPr/>
              </p:nvSpPr>
              <p:spPr bwMode="auto">
                <a:xfrm>
                  <a:off x="2151063" y="2949576"/>
                  <a:ext cx="2879725" cy="12700"/>
                </a:xfrm>
                <a:custGeom>
                  <a:avLst/>
                  <a:gdLst>
                    <a:gd name="T0" fmla="*/ 2 w 1814"/>
                    <a:gd name="T1" fmla="*/ 2 h 8"/>
                    <a:gd name="T2" fmla="*/ 5 w 1814"/>
                    <a:gd name="T3" fmla="*/ 3 h 8"/>
                    <a:gd name="T4" fmla="*/ 6 w 1814"/>
                    <a:gd name="T5" fmla="*/ 4 h 8"/>
                    <a:gd name="T6" fmla="*/ 8 w 1814"/>
                    <a:gd name="T7" fmla="*/ 5 h 8"/>
                    <a:gd name="T8" fmla="*/ 11 w 1814"/>
                    <a:gd name="T9" fmla="*/ 6 h 8"/>
                    <a:gd name="T10" fmla="*/ 13 w 1814"/>
                    <a:gd name="T11" fmla="*/ 6 h 8"/>
                    <a:gd name="T12" fmla="*/ 15 w 1814"/>
                    <a:gd name="T13" fmla="*/ 6 h 8"/>
                    <a:gd name="T14" fmla="*/ 18 w 1814"/>
                    <a:gd name="T15" fmla="*/ 6 h 8"/>
                    <a:gd name="T16" fmla="*/ 23 w 1814"/>
                    <a:gd name="T17" fmla="*/ 7 h 8"/>
                    <a:gd name="T18" fmla="*/ 35 w 1814"/>
                    <a:gd name="T19" fmla="*/ 7 h 8"/>
                    <a:gd name="T20" fmla="*/ 52 w 1814"/>
                    <a:gd name="T21" fmla="*/ 7 h 8"/>
                    <a:gd name="T22" fmla="*/ 70 w 1814"/>
                    <a:gd name="T23" fmla="*/ 7 h 8"/>
                    <a:gd name="T24" fmla="*/ 100 w 1814"/>
                    <a:gd name="T25" fmla="*/ 7 h 8"/>
                    <a:gd name="T26" fmla="*/ 128 w 1814"/>
                    <a:gd name="T27" fmla="*/ 8 h 8"/>
                    <a:gd name="T28" fmla="*/ 161 w 1814"/>
                    <a:gd name="T29" fmla="*/ 8 h 8"/>
                    <a:gd name="T30" fmla="*/ 196 w 1814"/>
                    <a:gd name="T31" fmla="*/ 8 h 8"/>
                    <a:gd name="T32" fmla="*/ 246 w 1814"/>
                    <a:gd name="T33" fmla="*/ 8 h 8"/>
                    <a:gd name="T34" fmla="*/ 286 w 1814"/>
                    <a:gd name="T35" fmla="*/ 8 h 8"/>
                    <a:gd name="T36" fmla="*/ 323 w 1814"/>
                    <a:gd name="T37" fmla="*/ 8 h 8"/>
                    <a:gd name="T38" fmla="*/ 353 w 1814"/>
                    <a:gd name="T39" fmla="*/ 8 h 8"/>
                    <a:gd name="T40" fmla="*/ 388 w 1814"/>
                    <a:gd name="T41" fmla="*/ 8 h 8"/>
                    <a:gd name="T42" fmla="*/ 416 w 1814"/>
                    <a:gd name="T43" fmla="*/ 7 h 8"/>
                    <a:gd name="T44" fmla="*/ 453 w 1814"/>
                    <a:gd name="T45" fmla="*/ 7 h 8"/>
                    <a:gd name="T46" fmla="*/ 494 w 1814"/>
                    <a:gd name="T47" fmla="*/ 7 h 8"/>
                    <a:gd name="T48" fmla="*/ 521 w 1814"/>
                    <a:gd name="T49" fmla="*/ 7 h 8"/>
                    <a:gd name="T50" fmla="*/ 560 w 1814"/>
                    <a:gd name="T51" fmla="*/ 7 h 8"/>
                    <a:gd name="T52" fmla="*/ 593 w 1814"/>
                    <a:gd name="T53" fmla="*/ 7 h 8"/>
                    <a:gd name="T54" fmla="*/ 629 w 1814"/>
                    <a:gd name="T55" fmla="*/ 7 h 8"/>
                    <a:gd name="T56" fmla="*/ 663 w 1814"/>
                    <a:gd name="T57" fmla="*/ 6 h 8"/>
                    <a:gd name="T58" fmla="*/ 693 w 1814"/>
                    <a:gd name="T59" fmla="*/ 6 h 8"/>
                    <a:gd name="T60" fmla="*/ 727 w 1814"/>
                    <a:gd name="T61" fmla="*/ 6 h 8"/>
                    <a:gd name="T62" fmla="*/ 750 w 1814"/>
                    <a:gd name="T63" fmla="*/ 6 h 8"/>
                    <a:gd name="T64" fmla="*/ 780 w 1814"/>
                    <a:gd name="T65" fmla="*/ 6 h 8"/>
                    <a:gd name="T66" fmla="*/ 812 w 1814"/>
                    <a:gd name="T67" fmla="*/ 6 h 8"/>
                    <a:gd name="T68" fmla="*/ 832 w 1814"/>
                    <a:gd name="T69" fmla="*/ 5 h 8"/>
                    <a:gd name="T70" fmla="*/ 863 w 1814"/>
                    <a:gd name="T71" fmla="*/ 5 h 8"/>
                    <a:gd name="T72" fmla="*/ 891 w 1814"/>
                    <a:gd name="T73" fmla="*/ 5 h 8"/>
                    <a:gd name="T74" fmla="*/ 919 w 1814"/>
                    <a:gd name="T75" fmla="*/ 5 h 8"/>
                    <a:gd name="T76" fmla="*/ 949 w 1814"/>
                    <a:gd name="T77" fmla="*/ 5 h 8"/>
                    <a:gd name="T78" fmla="*/ 970 w 1814"/>
                    <a:gd name="T79" fmla="*/ 5 h 8"/>
                    <a:gd name="T80" fmla="*/ 1002 w 1814"/>
                    <a:gd name="T81" fmla="*/ 5 h 8"/>
                    <a:gd name="T82" fmla="*/ 1039 w 1814"/>
                    <a:gd name="T83" fmla="*/ 5 h 8"/>
                    <a:gd name="T84" fmla="*/ 1079 w 1814"/>
                    <a:gd name="T85" fmla="*/ 4 h 8"/>
                    <a:gd name="T86" fmla="*/ 1117 w 1814"/>
                    <a:gd name="T87" fmla="*/ 4 h 8"/>
                    <a:gd name="T88" fmla="*/ 1154 w 1814"/>
                    <a:gd name="T89" fmla="*/ 4 h 8"/>
                    <a:gd name="T90" fmla="*/ 1186 w 1814"/>
                    <a:gd name="T91" fmla="*/ 4 h 8"/>
                    <a:gd name="T92" fmla="*/ 1222 w 1814"/>
                    <a:gd name="T93" fmla="*/ 4 h 8"/>
                    <a:gd name="T94" fmla="*/ 1265 w 1814"/>
                    <a:gd name="T95" fmla="*/ 4 h 8"/>
                    <a:gd name="T96" fmla="*/ 1302 w 1814"/>
                    <a:gd name="T97" fmla="*/ 3 h 8"/>
                    <a:gd name="T98" fmla="*/ 1347 w 1814"/>
                    <a:gd name="T99" fmla="*/ 3 h 8"/>
                    <a:gd name="T100" fmla="*/ 1385 w 1814"/>
                    <a:gd name="T101" fmla="*/ 3 h 8"/>
                    <a:gd name="T102" fmla="*/ 1416 w 1814"/>
                    <a:gd name="T103" fmla="*/ 3 h 8"/>
                    <a:gd name="T104" fmla="*/ 1469 w 1814"/>
                    <a:gd name="T105" fmla="*/ 2 h 8"/>
                    <a:gd name="T106" fmla="*/ 1493 w 1814"/>
                    <a:gd name="T107" fmla="*/ 2 h 8"/>
                    <a:gd name="T108" fmla="*/ 1521 w 1814"/>
                    <a:gd name="T109" fmla="*/ 2 h 8"/>
                    <a:gd name="T110" fmla="*/ 1556 w 1814"/>
                    <a:gd name="T111" fmla="*/ 2 h 8"/>
                    <a:gd name="T112" fmla="*/ 1587 w 1814"/>
                    <a:gd name="T113" fmla="*/ 2 h 8"/>
                    <a:gd name="T114" fmla="*/ 1614 w 1814"/>
                    <a:gd name="T115" fmla="*/ 2 h 8"/>
                    <a:gd name="T116" fmla="*/ 1660 w 1814"/>
                    <a:gd name="T117" fmla="*/ 2 h 8"/>
                    <a:gd name="T118" fmla="*/ 1693 w 1814"/>
                    <a:gd name="T119" fmla="*/ 1 h 8"/>
                    <a:gd name="T120" fmla="*/ 1721 w 1814"/>
                    <a:gd name="T121" fmla="*/ 1 h 8"/>
                    <a:gd name="T122" fmla="*/ 1749 w 1814"/>
                    <a:gd name="T123" fmla="*/ 1 h 8"/>
                    <a:gd name="T124" fmla="*/ 1780 w 1814"/>
                    <a:gd name="T125" fmla="*/ 1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  <a:cxn ang="0">
                      <a:pos x="T116" y="T117"/>
                    </a:cxn>
                    <a:cxn ang="0">
                      <a:pos x="T118" y="T119"/>
                    </a:cxn>
                    <a:cxn ang="0">
                      <a:pos x="T120" y="T121"/>
                    </a:cxn>
                    <a:cxn ang="0">
                      <a:pos x="T122" y="T123"/>
                    </a:cxn>
                    <a:cxn ang="0">
                      <a:pos x="T124" y="T125"/>
                    </a:cxn>
                  </a:cxnLst>
                  <a:rect l="0" t="0" r="r" b="b"/>
                  <a:pathLst>
                    <a:path w="1814" h="8">
                      <a:moveTo>
                        <a:pt x="0" y="0"/>
                      </a:moveTo>
                      <a:lnTo>
                        <a:pt x="1" y="0"/>
                      </a:lnTo>
                      <a:lnTo>
                        <a:pt x="1" y="1"/>
                      </a:lnTo>
                      <a:lnTo>
                        <a:pt x="2" y="1"/>
                      </a:lnTo>
                      <a:lnTo>
                        <a:pt x="2" y="1"/>
                      </a:lnTo>
                      <a:lnTo>
                        <a:pt x="2" y="1"/>
                      </a:lnTo>
                      <a:lnTo>
                        <a:pt x="2" y="2"/>
                      </a:lnTo>
                      <a:lnTo>
                        <a:pt x="2" y="2"/>
                      </a:lnTo>
                      <a:lnTo>
                        <a:pt x="3" y="2"/>
                      </a:lnTo>
                      <a:lnTo>
                        <a:pt x="3" y="2"/>
                      </a:lnTo>
                      <a:lnTo>
                        <a:pt x="3" y="2"/>
                      </a:lnTo>
                      <a:lnTo>
                        <a:pt x="4" y="2"/>
                      </a:lnTo>
                      <a:lnTo>
                        <a:pt x="4" y="3"/>
                      </a:lnTo>
                      <a:lnTo>
                        <a:pt x="4" y="3"/>
                      </a:lnTo>
                      <a:lnTo>
                        <a:pt x="4" y="3"/>
                      </a:lnTo>
                      <a:lnTo>
                        <a:pt x="5" y="3"/>
                      </a:lnTo>
                      <a:lnTo>
                        <a:pt x="5" y="3"/>
                      </a:lnTo>
                      <a:lnTo>
                        <a:pt x="5" y="3"/>
                      </a:lnTo>
                      <a:lnTo>
                        <a:pt x="5" y="4"/>
                      </a:lnTo>
                      <a:lnTo>
                        <a:pt x="5" y="4"/>
                      </a:lnTo>
                      <a:lnTo>
                        <a:pt x="6" y="4"/>
                      </a:lnTo>
                      <a:lnTo>
                        <a:pt x="6" y="4"/>
                      </a:lnTo>
                      <a:lnTo>
                        <a:pt x="6" y="4"/>
                      </a:lnTo>
                      <a:lnTo>
                        <a:pt x="6" y="4"/>
                      </a:lnTo>
                      <a:lnTo>
                        <a:pt x="7" y="4"/>
                      </a:lnTo>
                      <a:lnTo>
                        <a:pt x="7" y="4"/>
                      </a:lnTo>
                      <a:lnTo>
                        <a:pt x="7" y="5"/>
                      </a:lnTo>
                      <a:lnTo>
                        <a:pt x="7" y="5"/>
                      </a:lnTo>
                      <a:lnTo>
                        <a:pt x="8" y="5"/>
                      </a:lnTo>
                      <a:lnTo>
                        <a:pt x="8" y="5"/>
                      </a:lnTo>
                      <a:lnTo>
                        <a:pt x="8" y="5"/>
                      </a:lnTo>
                      <a:lnTo>
                        <a:pt x="8" y="5"/>
                      </a:lnTo>
                      <a:lnTo>
                        <a:pt x="9" y="5"/>
                      </a:lnTo>
                      <a:lnTo>
                        <a:pt x="9" y="5"/>
                      </a:lnTo>
                      <a:lnTo>
                        <a:pt x="9" y="5"/>
                      </a:lnTo>
                      <a:lnTo>
                        <a:pt x="9" y="5"/>
                      </a:lnTo>
                      <a:lnTo>
                        <a:pt x="10" y="5"/>
                      </a:lnTo>
                      <a:lnTo>
                        <a:pt x="10" y="5"/>
                      </a:lnTo>
                      <a:lnTo>
                        <a:pt x="10" y="6"/>
                      </a:lnTo>
                      <a:lnTo>
                        <a:pt x="11" y="6"/>
                      </a:lnTo>
                      <a:lnTo>
                        <a:pt x="11" y="6"/>
                      </a:lnTo>
                      <a:lnTo>
                        <a:pt x="11" y="6"/>
                      </a:lnTo>
                      <a:lnTo>
                        <a:pt x="11" y="6"/>
                      </a:lnTo>
                      <a:lnTo>
                        <a:pt x="12" y="6"/>
                      </a:lnTo>
                      <a:lnTo>
                        <a:pt x="12" y="6"/>
                      </a:lnTo>
                      <a:lnTo>
                        <a:pt x="12" y="6"/>
                      </a:lnTo>
                      <a:lnTo>
                        <a:pt x="12" y="6"/>
                      </a:lnTo>
                      <a:lnTo>
                        <a:pt x="13" y="6"/>
                      </a:lnTo>
                      <a:lnTo>
                        <a:pt x="13" y="6"/>
                      </a:lnTo>
                      <a:lnTo>
                        <a:pt x="13" y="6"/>
                      </a:lnTo>
                      <a:lnTo>
                        <a:pt x="14" y="6"/>
                      </a:lnTo>
                      <a:lnTo>
                        <a:pt x="14" y="6"/>
                      </a:lnTo>
                      <a:lnTo>
                        <a:pt x="14" y="6"/>
                      </a:lnTo>
                      <a:lnTo>
                        <a:pt x="15" y="6"/>
                      </a:lnTo>
                      <a:lnTo>
                        <a:pt x="15" y="6"/>
                      </a:lnTo>
                      <a:lnTo>
                        <a:pt x="15" y="6"/>
                      </a:lnTo>
                      <a:lnTo>
                        <a:pt x="15" y="6"/>
                      </a:lnTo>
                      <a:lnTo>
                        <a:pt x="16" y="6"/>
                      </a:lnTo>
                      <a:lnTo>
                        <a:pt x="16" y="6"/>
                      </a:lnTo>
                      <a:lnTo>
                        <a:pt x="17" y="6"/>
                      </a:lnTo>
                      <a:lnTo>
                        <a:pt x="17" y="6"/>
                      </a:lnTo>
                      <a:lnTo>
                        <a:pt x="17" y="6"/>
                      </a:lnTo>
                      <a:lnTo>
                        <a:pt x="18" y="6"/>
                      </a:lnTo>
                      <a:lnTo>
                        <a:pt x="18" y="6"/>
                      </a:lnTo>
                      <a:lnTo>
                        <a:pt x="19" y="6"/>
                      </a:lnTo>
                      <a:lnTo>
                        <a:pt x="19" y="6"/>
                      </a:lnTo>
                      <a:lnTo>
                        <a:pt x="20" y="6"/>
                      </a:lnTo>
                      <a:lnTo>
                        <a:pt x="20" y="6"/>
                      </a:lnTo>
                      <a:lnTo>
                        <a:pt x="21" y="7"/>
                      </a:lnTo>
                      <a:lnTo>
                        <a:pt x="22" y="7"/>
                      </a:lnTo>
                      <a:lnTo>
                        <a:pt x="22" y="7"/>
                      </a:lnTo>
                      <a:lnTo>
                        <a:pt x="23" y="7"/>
                      </a:lnTo>
                      <a:lnTo>
                        <a:pt x="24" y="7"/>
                      </a:lnTo>
                      <a:lnTo>
                        <a:pt x="25" y="7"/>
                      </a:lnTo>
                      <a:lnTo>
                        <a:pt x="26" y="7"/>
                      </a:lnTo>
                      <a:lnTo>
                        <a:pt x="27" y="7"/>
                      </a:lnTo>
                      <a:lnTo>
                        <a:pt x="29" y="7"/>
                      </a:lnTo>
                      <a:lnTo>
                        <a:pt x="31" y="7"/>
                      </a:lnTo>
                      <a:lnTo>
                        <a:pt x="33" y="7"/>
                      </a:lnTo>
                      <a:lnTo>
                        <a:pt x="35" y="7"/>
                      </a:lnTo>
                      <a:lnTo>
                        <a:pt x="36" y="7"/>
                      </a:lnTo>
                      <a:lnTo>
                        <a:pt x="37" y="7"/>
                      </a:lnTo>
                      <a:lnTo>
                        <a:pt x="38" y="7"/>
                      </a:lnTo>
                      <a:lnTo>
                        <a:pt x="40" y="7"/>
                      </a:lnTo>
                      <a:lnTo>
                        <a:pt x="42" y="7"/>
                      </a:lnTo>
                      <a:lnTo>
                        <a:pt x="45" y="7"/>
                      </a:lnTo>
                      <a:lnTo>
                        <a:pt x="48" y="7"/>
                      </a:lnTo>
                      <a:lnTo>
                        <a:pt x="52" y="7"/>
                      </a:lnTo>
                      <a:lnTo>
                        <a:pt x="54" y="7"/>
                      </a:lnTo>
                      <a:lnTo>
                        <a:pt x="56" y="7"/>
                      </a:lnTo>
                      <a:lnTo>
                        <a:pt x="58" y="7"/>
                      </a:lnTo>
                      <a:lnTo>
                        <a:pt x="60" y="7"/>
                      </a:lnTo>
                      <a:lnTo>
                        <a:pt x="62" y="7"/>
                      </a:lnTo>
                      <a:lnTo>
                        <a:pt x="64" y="7"/>
                      </a:lnTo>
                      <a:lnTo>
                        <a:pt x="67" y="7"/>
                      </a:lnTo>
                      <a:lnTo>
                        <a:pt x="70" y="7"/>
                      </a:lnTo>
                      <a:lnTo>
                        <a:pt x="74" y="7"/>
                      </a:lnTo>
                      <a:lnTo>
                        <a:pt x="78" y="7"/>
                      </a:lnTo>
                      <a:lnTo>
                        <a:pt x="82" y="7"/>
                      </a:lnTo>
                      <a:lnTo>
                        <a:pt x="86" y="7"/>
                      </a:lnTo>
                      <a:lnTo>
                        <a:pt x="89" y="7"/>
                      </a:lnTo>
                      <a:lnTo>
                        <a:pt x="92" y="7"/>
                      </a:lnTo>
                      <a:lnTo>
                        <a:pt x="96" y="7"/>
                      </a:lnTo>
                      <a:lnTo>
                        <a:pt x="100" y="7"/>
                      </a:lnTo>
                      <a:lnTo>
                        <a:pt x="105" y="7"/>
                      </a:lnTo>
                      <a:lnTo>
                        <a:pt x="108" y="7"/>
                      </a:lnTo>
                      <a:lnTo>
                        <a:pt x="111" y="7"/>
                      </a:lnTo>
                      <a:lnTo>
                        <a:pt x="116" y="7"/>
                      </a:lnTo>
                      <a:lnTo>
                        <a:pt x="121" y="7"/>
                      </a:lnTo>
                      <a:lnTo>
                        <a:pt x="124" y="8"/>
                      </a:lnTo>
                      <a:lnTo>
                        <a:pt x="126" y="8"/>
                      </a:lnTo>
                      <a:lnTo>
                        <a:pt x="128" y="8"/>
                      </a:lnTo>
                      <a:lnTo>
                        <a:pt x="131" y="8"/>
                      </a:lnTo>
                      <a:lnTo>
                        <a:pt x="134" y="8"/>
                      </a:lnTo>
                      <a:lnTo>
                        <a:pt x="138" y="8"/>
                      </a:lnTo>
                      <a:lnTo>
                        <a:pt x="142" y="8"/>
                      </a:lnTo>
                      <a:lnTo>
                        <a:pt x="145" y="8"/>
                      </a:lnTo>
                      <a:lnTo>
                        <a:pt x="150" y="8"/>
                      </a:lnTo>
                      <a:lnTo>
                        <a:pt x="156" y="8"/>
                      </a:lnTo>
                      <a:lnTo>
                        <a:pt x="161" y="8"/>
                      </a:lnTo>
                      <a:lnTo>
                        <a:pt x="165" y="8"/>
                      </a:lnTo>
                      <a:lnTo>
                        <a:pt x="170" y="8"/>
                      </a:lnTo>
                      <a:lnTo>
                        <a:pt x="175" y="8"/>
                      </a:lnTo>
                      <a:lnTo>
                        <a:pt x="179" y="8"/>
                      </a:lnTo>
                      <a:lnTo>
                        <a:pt x="183" y="8"/>
                      </a:lnTo>
                      <a:lnTo>
                        <a:pt x="186" y="8"/>
                      </a:lnTo>
                      <a:lnTo>
                        <a:pt x="190" y="8"/>
                      </a:lnTo>
                      <a:lnTo>
                        <a:pt x="196" y="8"/>
                      </a:lnTo>
                      <a:lnTo>
                        <a:pt x="201" y="8"/>
                      </a:lnTo>
                      <a:lnTo>
                        <a:pt x="206" y="8"/>
                      </a:lnTo>
                      <a:lnTo>
                        <a:pt x="212" y="8"/>
                      </a:lnTo>
                      <a:lnTo>
                        <a:pt x="217" y="8"/>
                      </a:lnTo>
                      <a:lnTo>
                        <a:pt x="224" y="8"/>
                      </a:lnTo>
                      <a:lnTo>
                        <a:pt x="233" y="8"/>
                      </a:lnTo>
                      <a:lnTo>
                        <a:pt x="240" y="8"/>
                      </a:lnTo>
                      <a:lnTo>
                        <a:pt x="246" y="8"/>
                      </a:lnTo>
                      <a:lnTo>
                        <a:pt x="252" y="8"/>
                      </a:lnTo>
                      <a:lnTo>
                        <a:pt x="257" y="8"/>
                      </a:lnTo>
                      <a:lnTo>
                        <a:pt x="261" y="8"/>
                      </a:lnTo>
                      <a:lnTo>
                        <a:pt x="266" y="8"/>
                      </a:lnTo>
                      <a:lnTo>
                        <a:pt x="271" y="8"/>
                      </a:lnTo>
                      <a:lnTo>
                        <a:pt x="276" y="8"/>
                      </a:lnTo>
                      <a:lnTo>
                        <a:pt x="281" y="8"/>
                      </a:lnTo>
                      <a:lnTo>
                        <a:pt x="286" y="8"/>
                      </a:lnTo>
                      <a:lnTo>
                        <a:pt x="290" y="8"/>
                      </a:lnTo>
                      <a:lnTo>
                        <a:pt x="295" y="8"/>
                      </a:lnTo>
                      <a:lnTo>
                        <a:pt x="299" y="8"/>
                      </a:lnTo>
                      <a:lnTo>
                        <a:pt x="303" y="8"/>
                      </a:lnTo>
                      <a:lnTo>
                        <a:pt x="308" y="8"/>
                      </a:lnTo>
                      <a:lnTo>
                        <a:pt x="313" y="8"/>
                      </a:lnTo>
                      <a:lnTo>
                        <a:pt x="318" y="8"/>
                      </a:lnTo>
                      <a:lnTo>
                        <a:pt x="323" y="8"/>
                      </a:lnTo>
                      <a:lnTo>
                        <a:pt x="327" y="8"/>
                      </a:lnTo>
                      <a:lnTo>
                        <a:pt x="330" y="8"/>
                      </a:lnTo>
                      <a:lnTo>
                        <a:pt x="334" y="8"/>
                      </a:lnTo>
                      <a:lnTo>
                        <a:pt x="338" y="8"/>
                      </a:lnTo>
                      <a:lnTo>
                        <a:pt x="342" y="8"/>
                      </a:lnTo>
                      <a:lnTo>
                        <a:pt x="347" y="8"/>
                      </a:lnTo>
                      <a:lnTo>
                        <a:pt x="350" y="8"/>
                      </a:lnTo>
                      <a:lnTo>
                        <a:pt x="353" y="8"/>
                      </a:lnTo>
                      <a:lnTo>
                        <a:pt x="356" y="8"/>
                      </a:lnTo>
                      <a:lnTo>
                        <a:pt x="362" y="8"/>
                      </a:lnTo>
                      <a:lnTo>
                        <a:pt x="368" y="8"/>
                      </a:lnTo>
                      <a:lnTo>
                        <a:pt x="375" y="8"/>
                      </a:lnTo>
                      <a:lnTo>
                        <a:pt x="380" y="8"/>
                      </a:lnTo>
                      <a:lnTo>
                        <a:pt x="384" y="8"/>
                      </a:lnTo>
                      <a:lnTo>
                        <a:pt x="386" y="8"/>
                      </a:lnTo>
                      <a:lnTo>
                        <a:pt x="388" y="8"/>
                      </a:lnTo>
                      <a:lnTo>
                        <a:pt x="390" y="8"/>
                      </a:lnTo>
                      <a:lnTo>
                        <a:pt x="393" y="8"/>
                      </a:lnTo>
                      <a:lnTo>
                        <a:pt x="396" y="7"/>
                      </a:lnTo>
                      <a:lnTo>
                        <a:pt x="399" y="7"/>
                      </a:lnTo>
                      <a:lnTo>
                        <a:pt x="404" y="7"/>
                      </a:lnTo>
                      <a:lnTo>
                        <a:pt x="408" y="7"/>
                      </a:lnTo>
                      <a:lnTo>
                        <a:pt x="412" y="7"/>
                      </a:lnTo>
                      <a:lnTo>
                        <a:pt x="416" y="7"/>
                      </a:lnTo>
                      <a:lnTo>
                        <a:pt x="421" y="7"/>
                      </a:lnTo>
                      <a:lnTo>
                        <a:pt x="427" y="7"/>
                      </a:lnTo>
                      <a:lnTo>
                        <a:pt x="431" y="7"/>
                      </a:lnTo>
                      <a:lnTo>
                        <a:pt x="436" y="7"/>
                      </a:lnTo>
                      <a:lnTo>
                        <a:pt x="439" y="7"/>
                      </a:lnTo>
                      <a:lnTo>
                        <a:pt x="442" y="7"/>
                      </a:lnTo>
                      <a:lnTo>
                        <a:pt x="447" y="7"/>
                      </a:lnTo>
                      <a:lnTo>
                        <a:pt x="453" y="7"/>
                      </a:lnTo>
                      <a:lnTo>
                        <a:pt x="459" y="7"/>
                      </a:lnTo>
                      <a:lnTo>
                        <a:pt x="465" y="7"/>
                      </a:lnTo>
                      <a:lnTo>
                        <a:pt x="470" y="7"/>
                      </a:lnTo>
                      <a:lnTo>
                        <a:pt x="475" y="7"/>
                      </a:lnTo>
                      <a:lnTo>
                        <a:pt x="479" y="7"/>
                      </a:lnTo>
                      <a:lnTo>
                        <a:pt x="481" y="7"/>
                      </a:lnTo>
                      <a:lnTo>
                        <a:pt x="486" y="7"/>
                      </a:lnTo>
                      <a:lnTo>
                        <a:pt x="494" y="7"/>
                      </a:lnTo>
                      <a:lnTo>
                        <a:pt x="501" y="7"/>
                      </a:lnTo>
                      <a:lnTo>
                        <a:pt x="506" y="7"/>
                      </a:lnTo>
                      <a:lnTo>
                        <a:pt x="509" y="7"/>
                      </a:lnTo>
                      <a:lnTo>
                        <a:pt x="513" y="7"/>
                      </a:lnTo>
                      <a:lnTo>
                        <a:pt x="516" y="7"/>
                      </a:lnTo>
                      <a:lnTo>
                        <a:pt x="518" y="7"/>
                      </a:lnTo>
                      <a:lnTo>
                        <a:pt x="519" y="7"/>
                      </a:lnTo>
                      <a:lnTo>
                        <a:pt x="521" y="7"/>
                      </a:lnTo>
                      <a:lnTo>
                        <a:pt x="525" y="7"/>
                      </a:lnTo>
                      <a:lnTo>
                        <a:pt x="529" y="7"/>
                      </a:lnTo>
                      <a:lnTo>
                        <a:pt x="534" y="7"/>
                      </a:lnTo>
                      <a:lnTo>
                        <a:pt x="539" y="7"/>
                      </a:lnTo>
                      <a:lnTo>
                        <a:pt x="546" y="7"/>
                      </a:lnTo>
                      <a:lnTo>
                        <a:pt x="551" y="7"/>
                      </a:lnTo>
                      <a:lnTo>
                        <a:pt x="556" y="7"/>
                      </a:lnTo>
                      <a:lnTo>
                        <a:pt x="560" y="7"/>
                      </a:lnTo>
                      <a:lnTo>
                        <a:pt x="561" y="7"/>
                      </a:lnTo>
                      <a:lnTo>
                        <a:pt x="564" y="7"/>
                      </a:lnTo>
                      <a:lnTo>
                        <a:pt x="569" y="7"/>
                      </a:lnTo>
                      <a:lnTo>
                        <a:pt x="574" y="7"/>
                      </a:lnTo>
                      <a:lnTo>
                        <a:pt x="579" y="7"/>
                      </a:lnTo>
                      <a:lnTo>
                        <a:pt x="583" y="7"/>
                      </a:lnTo>
                      <a:lnTo>
                        <a:pt x="587" y="7"/>
                      </a:lnTo>
                      <a:lnTo>
                        <a:pt x="593" y="7"/>
                      </a:lnTo>
                      <a:lnTo>
                        <a:pt x="598" y="7"/>
                      </a:lnTo>
                      <a:lnTo>
                        <a:pt x="602" y="7"/>
                      </a:lnTo>
                      <a:lnTo>
                        <a:pt x="605" y="7"/>
                      </a:lnTo>
                      <a:lnTo>
                        <a:pt x="608" y="7"/>
                      </a:lnTo>
                      <a:lnTo>
                        <a:pt x="612" y="7"/>
                      </a:lnTo>
                      <a:lnTo>
                        <a:pt x="618" y="7"/>
                      </a:lnTo>
                      <a:lnTo>
                        <a:pt x="624" y="7"/>
                      </a:lnTo>
                      <a:lnTo>
                        <a:pt x="629" y="7"/>
                      </a:lnTo>
                      <a:lnTo>
                        <a:pt x="634" y="6"/>
                      </a:lnTo>
                      <a:lnTo>
                        <a:pt x="639" y="6"/>
                      </a:lnTo>
                      <a:lnTo>
                        <a:pt x="644" y="6"/>
                      </a:lnTo>
                      <a:lnTo>
                        <a:pt x="646" y="6"/>
                      </a:lnTo>
                      <a:lnTo>
                        <a:pt x="648" y="6"/>
                      </a:lnTo>
                      <a:lnTo>
                        <a:pt x="651" y="6"/>
                      </a:lnTo>
                      <a:lnTo>
                        <a:pt x="657" y="6"/>
                      </a:lnTo>
                      <a:lnTo>
                        <a:pt x="663" y="6"/>
                      </a:lnTo>
                      <a:lnTo>
                        <a:pt x="668" y="6"/>
                      </a:lnTo>
                      <a:lnTo>
                        <a:pt x="672" y="6"/>
                      </a:lnTo>
                      <a:lnTo>
                        <a:pt x="678" y="6"/>
                      </a:lnTo>
                      <a:lnTo>
                        <a:pt x="683" y="6"/>
                      </a:lnTo>
                      <a:lnTo>
                        <a:pt x="687" y="6"/>
                      </a:lnTo>
                      <a:lnTo>
                        <a:pt x="689" y="6"/>
                      </a:lnTo>
                      <a:lnTo>
                        <a:pt x="691" y="6"/>
                      </a:lnTo>
                      <a:lnTo>
                        <a:pt x="693" y="6"/>
                      </a:lnTo>
                      <a:lnTo>
                        <a:pt x="696" y="6"/>
                      </a:lnTo>
                      <a:lnTo>
                        <a:pt x="701" y="6"/>
                      </a:lnTo>
                      <a:lnTo>
                        <a:pt x="705" y="6"/>
                      </a:lnTo>
                      <a:lnTo>
                        <a:pt x="710" y="6"/>
                      </a:lnTo>
                      <a:lnTo>
                        <a:pt x="714" y="6"/>
                      </a:lnTo>
                      <a:lnTo>
                        <a:pt x="719" y="6"/>
                      </a:lnTo>
                      <a:lnTo>
                        <a:pt x="723" y="6"/>
                      </a:lnTo>
                      <a:lnTo>
                        <a:pt x="727" y="6"/>
                      </a:lnTo>
                      <a:lnTo>
                        <a:pt x="731" y="6"/>
                      </a:lnTo>
                      <a:lnTo>
                        <a:pt x="733" y="6"/>
                      </a:lnTo>
                      <a:lnTo>
                        <a:pt x="735" y="6"/>
                      </a:lnTo>
                      <a:lnTo>
                        <a:pt x="737" y="6"/>
                      </a:lnTo>
                      <a:lnTo>
                        <a:pt x="740" y="6"/>
                      </a:lnTo>
                      <a:lnTo>
                        <a:pt x="743" y="6"/>
                      </a:lnTo>
                      <a:lnTo>
                        <a:pt x="747" y="6"/>
                      </a:lnTo>
                      <a:lnTo>
                        <a:pt x="750" y="6"/>
                      </a:lnTo>
                      <a:lnTo>
                        <a:pt x="753" y="6"/>
                      </a:lnTo>
                      <a:lnTo>
                        <a:pt x="757" y="6"/>
                      </a:lnTo>
                      <a:lnTo>
                        <a:pt x="762" y="6"/>
                      </a:lnTo>
                      <a:lnTo>
                        <a:pt x="766" y="6"/>
                      </a:lnTo>
                      <a:lnTo>
                        <a:pt x="770" y="6"/>
                      </a:lnTo>
                      <a:lnTo>
                        <a:pt x="775" y="6"/>
                      </a:lnTo>
                      <a:lnTo>
                        <a:pt x="778" y="6"/>
                      </a:lnTo>
                      <a:lnTo>
                        <a:pt x="780" y="6"/>
                      </a:lnTo>
                      <a:lnTo>
                        <a:pt x="782" y="6"/>
                      </a:lnTo>
                      <a:lnTo>
                        <a:pt x="785" y="6"/>
                      </a:lnTo>
                      <a:lnTo>
                        <a:pt x="789" y="6"/>
                      </a:lnTo>
                      <a:lnTo>
                        <a:pt x="793" y="6"/>
                      </a:lnTo>
                      <a:lnTo>
                        <a:pt x="797" y="6"/>
                      </a:lnTo>
                      <a:lnTo>
                        <a:pt x="802" y="6"/>
                      </a:lnTo>
                      <a:lnTo>
                        <a:pt x="807" y="6"/>
                      </a:lnTo>
                      <a:lnTo>
                        <a:pt x="812" y="6"/>
                      </a:lnTo>
                      <a:lnTo>
                        <a:pt x="816" y="5"/>
                      </a:lnTo>
                      <a:lnTo>
                        <a:pt x="818" y="5"/>
                      </a:lnTo>
                      <a:lnTo>
                        <a:pt x="820" y="5"/>
                      </a:lnTo>
                      <a:lnTo>
                        <a:pt x="823" y="5"/>
                      </a:lnTo>
                      <a:lnTo>
                        <a:pt x="825" y="5"/>
                      </a:lnTo>
                      <a:lnTo>
                        <a:pt x="828" y="5"/>
                      </a:lnTo>
                      <a:lnTo>
                        <a:pt x="830" y="5"/>
                      </a:lnTo>
                      <a:lnTo>
                        <a:pt x="832" y="5"/>
                      </a:lnTo>
                      <a:lnTo>
                        <a:pt x="835" y="5"/>
                      </a:lnTo>
                      <a:lnTo>
                        <a:pt x="838" y="5"/>
                      </a:lnTo>
                      <a:lnTo>
                        <a:pt x="842" y="5"/>
                      </a:lnTo>
                      <a:lnTo>
                        <a:pt x="847" y="5"/>
                      </a:lnTo>
                      <a:lnTo>
                        <a:pt x="852" y="5"/>
                      </a:lnTo>
                      <a:lnTo>
                        <a:pt x="857" y="5"/>
                      </a:lnTo>
                      <a:lnTo>
                        <a:pt x="861" y="5"/>
                      </a:lnTo>
                      <a:lnTo>
                        <a:pt x="863" y="5"/>
                      </a:lnTo>
                      <a:lnTo>
                        <a:pt x="864" y="5"/>
                      </a:lnTo>
                      <a:lnTo>
                        <a:pt x="865" y="5"/>
                      </a:lnTo>
                      <a:lnTo>
                        <a:pt x="867" y="5"/>
                      </a:lnTo>
                      <a:lnTo>
                        <a:pt x="870" y="5"/>
                      </a:lnTo>
                      <a:lnTo>
                        <a:pt x="875" y="5"/>
                      </a:lnTo>
                      <a:lnTo>
                        <a:pt x="879" y="5"/>
                      </a:lnTo>
                      <a:lnTo>
                        <a:pt x="885" y="5"/>
                      </a:lnTo>
                      <a:lnTo>
                        <a:pt x="891" y="5"/>
                      </a:lnTo>
                      <a:lnTo>
                        <a:pt x="896" y="5"/>
                      </a:lnTo>
                      <a:lnTo>
                        <a:pt x="901" y="5"/>
                      </a:lnTo>
                      <a:lnTo>
                        <a:pt x="905" y="5"/>
                      </a:lnTo>
                      <a:lnTo>
                        <a:pt x="908" y="5"/>
                      </a:lnTo>
                      <a:lnTo>
                        <a:pt x="910" y="5"/>
                      </a:lnTo>
                      <a:lnTo>
                        <a:pt x="912" y="5"/>
                      </a:lnTo>
                      <a:lnTo>
                        <a:pt x="916" y="5"/>
                      </a:lnTo>
                      <a:lnTo>
                        <a:pt x="919" y="5"/>
                      </a:lnTo>
                      <a:lnTo>
                        <a:pt x="923" y="5"/>
                      </a:lnTo>
                      <a:lnTo>
                        <a:pt x="927" y="5"/>
                      </a:lnTo>
                      <a:lnTo>
                        <a:pt x="932" y="5"/>
                      </a:lnTo>
                      <a:lnTo>
                        <a:pt x="937" y="5"/>
                      </a:lnTo>
                      <a:lnTo>
                        <a:pt x="942" y="5"/>
                      </a:lnTo>
                      <a:lnTo>
                        <a:pt x="946" y="5"/>
                      </a:lnTo>
                      <a:lnTo>
                        <a:pt x="948" y="5"/>
                      </a:lnTo>
                      <a:lnTo>
                        <a:pt x="949" y="5"/>
                      </a:lnTo>
                      <a:lnTo>
                        <a:pt x="950" y="5"/>
                      </a:lnTo>
                      <a:lnTo>
                        <a:pt x="953" y="5"/>
                      </a:lnTo>
                      <a:lnTo>
                        <a:pt x="956" y="5"/>
                      </a:lnTo>
                      <a:lnTo>
                        <a:pt x="959" y="5"/>
                      </a:lnTo>
                      <a:lnTo>
                        <a:pt x="962" y="5"/>
                      </a:lnTo>
                      <a:lnTo>
                        <a:pt x="964" y="5"/>
                      </a:lnTo>
                      <a:lnTo>
                        <a:pt x="967" y="5"/>
                      </a:lnTo>
                      <a:lnTo>
                        <a:pt x="970" y="5"/>
                      </a:lnTo>
                      <a:lnTo>
                        <a:pt x="975" y="5"/>
                      </a:lnTo>
                      <a:lnTo>
                        <a:pt x="980" y="5"/>
                      </a:lnTo>
                      <a:lnTo>
                        <a:pt x="987" y="5"/>
                      </a:lnTo>
                      <a:lnTo>
                        <a:pt x="992" y="5"/>
                      </a:lnTo>
                      <a:lnTo>
                        <a:pt x="994" y="5"/>
                      </a:lnTo>
                      <a:lnTo>
                        <a:pt x="996" y="5"/>
                      </a:lnTo>
                      <a:lnTo>
                        <a:pt x="998" y="5"/>
                      </a:lnTo>
                      <a:lnTo>
                        <a:pt x="1002" y="5"/>
                      </a:lnTo>
                      <a:lnTo>
                        <a:pt x="1006" y="5"/>
                      </a:lnTo>
                      <a:lnTo>
                        <a:pt x="1009" y="5"/>
                      </a:lnTo>
                      <a:lnTo>
                        <a:pt x="1014" y="5"/>
                      </a:lnTo>
                      <a:lnTo>
                        <a:pt x="1019" y="5"/>
                      </a:lnTo>
                      <a:lnTo>
                        <a:pt x="1025" y="5"/>
                      </a:lnTo>
                      <a:lnTo>
                        <a:pt x="1031" y="5"/>
                      </a:lnTo>
                      <a:lnTo>
                        <a:pt x="1036" y="5"/>
                      </a:lnTo>
                      <a:lnTo>
                        <a:pt x="1039" y="5"/>
                      </a:lnTo>
                      <a:lnTo>
                        <a:pt x="1043" y="5"/>
                      </a:lnTo>
                      <a:lnTo>
                        <a:pt x="1047" y="4"/>
                      </a:lnTo>
                      <a:lnTo>
                        <a:pt x="1051" y="4"/>
                      </a:lnTo>
                      <a:lnTo>
                        <a:pt x="1056" y="4"/>
                      </a:lnTo>
                      <a:lnTo>
                        <a:pt x="1061" y="4"/>
                      </a:lnTo>
                      <a:lnTo>
                        <a:pt x="1067" y="4"/>
                      </a:lnTo>
                      <a:lnTo>
                        <a:pt x="1073" y="4"/>
                      </a:lnTo>
                      <a:lnTo>
                        <a:pt x="1079" y="4"/>
                      </a:lnTo>
                      <a:lnTo>
                        <a:pt x="1082" y="4"/>
                      </a:lnTo>
                      <a:lnTo>
                        <a:pt x="1084" y="4"/>
                      </a:lnTo>
                      <a:lnTo>
                        <a:pt x="1086" y="4"/>
                      </a:lnTo>
                      <a:lnTo>
                        <a:pt x="1090" y="4"/>
                      </a:lnTo>
                      <a:lnTo>
                        <a:pt x="1095" y="4"/>
                      </a:lnTo>
                      <a:lnTo>
                        <a:pt x="1103" y="4"/>
                      </a:lnTo>
                      <a:lnTo>
                        <a:pt x="1110" y="4"/>
                      </a:lnTo>
                      <a:lnTo>
                        <a:pt x="1117" y="4"/>
                      </a:lnTo>
                      <a:lnTo>
                        <a:pt x="1123" y="4"/>
                      </a:lnTo>
                      <a:lnTo>
                        <a:pt x="1126" y="4"/>
                      </a:lnTo>
                      <a:lnTo>
                        <a:pt x="1130" y="4"/>
                      </a:lnTo>
                      <a:lnTo>
                        <a:pt x="1135" y="4"/>
                      </a:lnTo>
                      <a:lnTo>
                        <a:pt x="1140" y="4"/>
                      </a:lnTo>
                      <a:lnTo>
                        <a:pt x="1145" y="4"/>
                      </a:lnTo>
                      <a:lnTo>
                        <a:pt x="1149" y="4"/>
                      </a:lnTo>
                      <a:lnTo>
                        <a:pt x="1154" y="4"/>
                      </a:lnTo>
                      <a:lnTo>
                        <a:pt x="1159" y="4"/>
                      </a:lnTo>
                      <a:lnTo>
                        <a:pt x="1163" y="4"/>
                      </a:lnTo>
                      <a:lnTo>
                        <a:pt x="1166" y="4"/>
                      </a:lnTo>
                      <a:lnTo>
                        <a:pt x="1168" y="4"/>
                      </a:lnTo>
                      <a:lnTo>
                        <a:pt x="1169" y="4"/>
                      </a:lnTo>
                      <a:lnTo>
                        <a:pt x="1173" y="4"/>
                      </a:lnTo>
                      <a:lnTo>
                        <a:pt x="1180" y="4"/>
                      </a:lnTo>
                      <a:lnTo>
                        <a:pt x="1186" y="4"/>
                      </a:lnTo>
                      <a:lnTo>
                        <a:pt x="1192" y="4"/>
                      </a:lnTo>
                      <a:lnTo>
                        <a:pt x="1198" y="4"/>
                      </a:lnTo>
                      <a:lnTo>
                        <a:pt x="1204" y="4"/>
                      </a:lnTo>
                      <a:lnTo>
                        <a:pt x="1209" y="4"/>
                      </a:lnTo>
                      <a:lnTo>
                        <a:pt x="1212" y="4"/>
                      </a:lnTo>
                      <a:lnTo>
                        <a:pt x="1214" y="4"/>
                      </a:lnTo>
                      <a:lnTo>
                        <a:pt x="1217" y="4"/>
                      </a:lnTo>
                      <a:lnTo>
                        <a:pt x="1222" y="4"/>
                      </a:lnTo>
                      <a:lnTo>
                        <a:pt x="1226" y="4"/>
                      </a:lnTo>
                      <a:lnTo>
                        <a:pt x="1234" y="4"/>
                      </a:lnTo>
                      <a:lnTo>
                        <a:pt x="1246" y="4"/>
                      </a:lnTo>
                      <a:lnTo>
                        <a:pt x="1253" y="4"/>
                      </a:lnTo>
                      <a:lnTo>
                        <a:pt x="1256" y="4"/>
                      </a:lnTo>
                      <a:lnTo>
                        <a:pt x="1257" y="4"/>
                      </a:lnTo>
                      <a:lnTo>
                        <a:pt x="1260" y="4"/>
                      </a:lnTo>
                      <a:lnTo>
                        <a:pt x="1265" y="4"/>
                      </a:lnTo>
                      <a:lnTo>
                        <a:pt x="1269" y="4"/>
                      </a:lnTo>
                      <a:lnTo>
                        <a:pt x="1272" y="4"/>
                      </a:lnTo>
                      <a:lnTo>
                        <a:pt x="1278" y="3"/>
                      </a:lnTo>
                      <a:lnTo>
                        <a:pt x="1285" y="3"/>
                      </a:lnTo>
                      <a:lnTo>
                        <a:pt x="1291" y="3"/>
                      </a:lnTo>
                      <a:lnTo>
                        <a:pt x="1297" y="3"/>
                      </a:lnTo>
                      <a:lnTo>
                        <a:pt x="1300" y="3"/>
                      </a:lnTo>
                      <a:lnTo>
                        <a:pt x="1302" y="3"/>
                      </a:lnTo>
                      <a:lnTo>
                        <a:pt x="1307" y="3"/>
                      </a:lnTo>
                      <a:lnTo>
                        <a:pt x="1314" y="3"/>
                      </a:lnTo>
                      <a:lnTo>
                        <a:pt x="1321" y="3"/>
                      </a:lnTo>
                      <a:lnTo>
                        <a:pt x="1328" y="3"/>
                      </a:lnTo>
                      <a:lnTo>
                        <a:pt x="1335" y="3"/>
                      </a:lnTo>
                      <a:lnTo>
                        <a:pt x="1341" y="3"/>
                      </a:lnTo>
                      <a:lnTo>
                        <a:pt x="1344" y="3"/>
                      </a:lnTo>
                      <a:lnTo>
                        <a:pt x="1347" y="3"/>
                      </a:lnTo>
                      <a:lnTo>
                        <a:pt x="1351" y="3"/>
                      </a:lnTo>
                      <a:lnTo>
                        <a:pt x="1355" y="3"/>
                      </a:lnTo>
                      <a:lnTo>
                        <a:pt x="1358" y="3"/>
                      </a:lnTo>
                      <a:lnTo>
                        <a:pt x="1364" y="3"/>
                      </a:lnTo>
                      <a:lnTo>
                        <a:pt x="1370" y="3"/>
                      </a:lnTo>
                      <a:lnTo>
                        <a:pt x="1377" y="3"/>
                      </a:lnTo>
                      <a:lnTo>
                        <a:pt x="1382" y="3"/>
                      </a:lnTo>
                      <a:lnTo>
                        <a:pt x="1385" y="3"/>
                      </a:lnTo>
                      <a:lnTo>
                        <a:pt x="1388" y="3"/>
                      </a:lnTo>
                      <a:lnTo>
                        <a:pt x="1391" y="3"/>
                      </a:lnTo>
                      <a:lnTo>
                        <a:pt x="1395" y="3"/>
                      </a:lnTo>
                      <a:lnTo>
                        <a:pt x="1400" y="3"/>
                      </a:lnTo>
                      <a:lnTo>
                        <a:pt x="1405" y="3"/>
                      </a:lnTo>
                      <a:lnTo>
                        <a:pt x="1409" y="3"/>
                      </a:lnTo>
                      <a:lnTo>
                        <a:pt x="1412" y="3"/>
                      </a:lnTo>
                      <a:lnTo>
                        <a:pt x="1416" y="3"/>
                      </a:lnTo>
                      <a:lnTo>
                        <a:pt x="1422" y="3"/>
                      </a:lnTo>
                      <a:lnTo>
                        <a:pt x="1428" y="3"/>
                      </a:lnTo>
                      <a:lnTo>
                        <a:pt x="1436" y="3"/>
                      </a:lnTo>
                      <a:lnTo>
                        <a:pt x="1444" y="3"/>
                      </a:lnTo>
                      <a:lnTo>
                        <a:pt x="1451" y="3"/>
                      </a:lnTo>
                      <a:lnTo>
                        <a:pt x="1458" y="3"/>
                      </a:lnTo>
                      <a:lnTo>
                        <a:pt x="1464" y="3"/>
                      </a:lnTo>
                      <a:lnTo>
                        <a:pt x="1469" y="2"/>
                      </a:lnTo>
                      <a:lnTo>
                        <a:pt x="1472" y="2"/>
                      </a:lnTo>
                      <a:lnTo>
                        <a:pt x="1474" y="2"/>
                      </a:lnTo>
                      <a:lnTo>
                        <a:pt x="1476" y="2"/>
                      </a:lnTo>
                      <a:lnTo>
                        <a:pt x="1478" y="2"/>
                      </a:lnTo>
                      <a:lnTo>
                        <a:pt x="1481" y="2"/>
                      </a:lnTo>
                      <a:lnTo>
                        <a:pt x="1485" y="2"/>
                      </a:lnTo>
                      <a:lnTo>
                        <a:pt x="1489" y="2"/>
                      </a:lnTo>
                      <a:lnTo>
                        <a:pt x="1493" y="2"/>
                      </a:lnTo>
                      <a:lnTo>
                        <a:pt x="1497" y="2"/>
                      </a:lnTo>
                      <a:lnTo>
                        <a:pt x="1504" y="2"/>
                      </a:lnTo>
                      <a:lnTo>
                        <a:pt x="1510" y="2"/>
                      </a:lnTo>
                      <a:lnTo>
                        <a:pt x="1513" y="2"/>
                      </a:lnTo>
                      <a:lnTo>
                        <a:pt x="1516" y="2"/>
                      </a:lnTo>
                      <a:lnTo>
                        <a:pt x="1518" y="2"/>
                      </a:lnTo>
                      <a:lnTo>
                        <a:pt x="1519" y="2"/>
                      </a:lnTo>
                      <a:lnTo>
                        <a:pt x="1521" y="2"/>
                      </a:lnTo>
                      <a:lnTo>
                        <a:pt x="1527" y="2"/>
                      </a:lnTo>
                      <a:lnTo>
                        <a:pt x="1532" y="2"/>
                      </a:lnTo>
                      <a:lnTo>
                        <a:pt x="1537" y="2"/>
                      </a:lnTo>
                      <a:lnTo>
                        <a:pt x="1542" y="2"/>
                      </a:lnTo>
                      <a:lnTo>
                        <a:pt x="1546" y="2"/>
                      </a:lnTo>
                      <a:lnTo>
                        <a:pt x="1549" y="2"/>
                      </a:lnTo>
                      <a:lnTo>
                        <a:pt x="1553" y="2"/>
                      </a:lnTo>
                      <a:lnTo>
                        <a:pt x="1556" y="2"/>
                      </a:lnTo>
                      <a:lnTo>
                        <a:pt x="1559" y="2"/>
                      </a:lnTo>
                      <a:lnTo>
                        <a:pt x="1562" y="2"/>
                      </a:lnTo>
                      <a:lnTo>
                        <a:pt x="1565" y="2"/>
                      </a:lnTo>
                      <a:lnTo>
                        <a:pt x="1569" y="2"/>
                      </a:lnTo>
                      <a:lnTo>
                        <a:pt x="1574" y="2"/>
                      </a:lnTo>
                      <a:lnTo>
                        <a:pt x="1579" y="2"/>
                      </a:lnTo>
                      <a:lnTo>
                        <a:pt x="1583" y="2"/>
                      </a:lnTo>
                      <a:lnTo>
                        <a:pt x="1587" y="2"/>
                      </a:lnTo>
                      <a:lnTo>
                        <a:pt x="1590" y="2"/>
                      </a:lnTo>
                      <a:lnTo>
                        <a:pt x="1593" y="2"/>
                      </a:lnTo>
                      <a:lnTo>
                        <a:pt x="1598" y="2"/>
                      </a:lnTo>
                      <a:lnTo>
                        <a:pt x="1603" y="2"/>
                      </a:lnTo>
                      <a:lnTo>
                        <a:pt x="1606" y="2"/>
                      </a:lnTo>
                      <a:lnTo>
                        <a:pt x="1608" y="2"/>
                      </a:lnTo>
                      <a:lnTo>
                        <a:pt x="1611" y="2"/>
                      </a:lnTo>
                      <a:lnTo>
                        <a:pt x="1614" y="2"/>
                      </a:lnTo>
                      <a:lnTo>
                        <a:pt x="1618" y="2"/>
                      </a:lnTo>
                      <a:lnTo>
                        <a:pt x="1623" y="2"/>
                      </a:lnTo>
                      <a:lnTo>
                        <a:pt x="1628" y="2"/>
                      </a:lnTo>
                      <a:lnTo>
                        <a:pt x="1634" y="2"/>
                      </a:lnTo>
                      <a:lnTo>
                        <a:pt x="1638" y="2"/>
                      </a:lnTo>
                      <a:lnTo>
                        <a:pt x="1643" y="2"/>
                      </a:lnTo>
                      <a:lnTo>
                        <a:pt x="1651" y="2"/>
                      </a:lnTo>
                      <a:lnTo>
                        <a:pt x="1660" y="2"/>
                      </a:lnTo>
                      <a:lnTo>
                        <a:pt x="1666" y="2"/>
                      </a:lnTo>
                      <a:lnTo>
                        <a:pt x="1670" y="2"/>
                      </a:lnTo>
                      <a:lnTo>
                        <a:pt x="1674" y="2"/>
                      </a:lnTo>
                      <a:lnTo>
                        <a:pt x="1680" y="2"/>
                      </a:lnTo>
                      <a:lnTo>
                        <a:pt x="1686" y="1"/>
                      </a:lnTo>
                      <a:lnTo>
                        <a:pt x="1689" y="1"/>
                      </a:lnTo>
                      <a:lnTo>
                        <a:pt x="1691" y="1"/>
                      </a:lnTo>
                      <a:lnTo>
                        <a:pt x="1693" y="1"/>
                      </a:lnTo>
                      <a:lnTo>
                        <a:pt x="1696" y="1"/>
                      </a:lnTo>
                      <a:lnTo>
                        <a:pt x="1699" y="1"/>
                      </a:lnTo>
                      <a:lnTo>
                        <a:pt x="1703" y="1"/>
                      </a:lnTo>
                      <a:lnTo>
                        <a:pt x="1708" y="1"/>
                      </a:lnTo>
                      <a:lnTo>
                        <a:pt x="1711" y="1"/>
                      </a:lnTo>
                      <a:lnTo>
                        <a:pt x="1715" y="1"/>
                      </a:lnTo>
                      <a:lnTo>
                        <a:pt x="1718" y="1"/>
                      </a:lnTo>
                      <a:lnTo>
                        <a:pt x="1721" y="1"/>
                      </a:lnTo>
                      <a:lnTo>
                        <a:pt x="1725" y="1"/>
                      </a:lnTo>
                      <a:lnTo>
                        <a:pt x="1729" y="1"/>
                      </a:lnTo>
                      <a:lnTo>
                        <a:pt x="1732" y="1"/>
                      </a:lnTo>
                      <a:lnTo>
                        <a:pt x="1735" y="1"/>
                      </a:lnTo>
                      <a:lnTo>
                        <a:pt x="1739" y="1"/>
                      </a:lnTo>
                      <a:lnTo>
                        <a:pt x="1742" y="1"/>
                      </a:lnTo>
                      <a:lnTo>
                        <a:pt x="1745" y="1"/>
                      </a:lnTo>
                      <a:lnTo>
                        <a:pt x="1749" y="1"/>
                      </a:lnTo>
                      <a:lnTo>
                        <a:pt x="1753" y="1"/>
                      </a:lnTo>
                      <a:lnTo>
                        <a:pt x="1758" y="1"/>
                      </a:lnTo>
                      <a:lnTo>
                        <a:pt x="1763" y="1"/>
                      </a:lnTo>
                      <a:lnTo>
                        <a:pt x="1769" y="1"/>
                      </a:lnTo>
                      <a:lnTo>
                        <a:pt x="1773" y="1"/>
                      </a:lnTo>
                      <a:lnTo>
                        <a:pt x="1775" y="1"/>
                      </a:lnTo>
                      <a:lnTo>
                        <a:pt x="1778" y="1"/>
                      </a:lnTo>
                      <a:lnTo>
                        <a:pt x="1780" y="1"/>
                      </a:lnTo>
                      <a:lnTo>
                        <a:pt x="1782" y="1"/>
                      </a:lnTo>
                      <a:lnTo>
                        <a:pt x="1785" y="1"/>
                      </a:lnTo>
                      <a:lnTo>
                        <a:pt x="1790" y="1"/>
                      </a:lnTo>
                      <a:lnTo>
                        <a:pt x="1797" y="1"/>
                      </a:lnTo>
                      <a:lnTo>
                        <a:pt x="1804" y="1"/>
                      </a:lnTo>
                      <a:lnTo>
                        <a:pt x="1809" y="1"/>
                      </a:lnTo>
                      <a:lnTo>
                        <a:pt x="1814" y="0"/>
                      </a:lnTo>
                    </a:path>
                  </a:pathLst>
                </a:cu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6" name="Freeform 147"/>
                <p:cNvSpPr>
                  <a:spLocks/>
                </p:cNvSpPr>
                <p:nvPr/>
              </p:nvSpPr>
              <p:spPr bwMode="auto">
                <a:xfrm>
                  <a:off x="5030788" y="1309688"/>
                  <a:ext cx="831850" cy="1639888"/>
                </a:xfrm>
                <a:custGeom>
                  <a:avLst/>
                  <a:gdLst>
                    <a:gd name="T0" fmla="*/ 30 w 524"/>
                    <a:gd name="T1" fmla="*/ 1033 h 1033"/>
                    <a:gd name="T2" fmla="*/ 65 w 524"/>
                    <a:gd name="T3" fmla="*/ 1033 h 1033"/>
                    <a:gd name="T4" fmla="*/ 92 w 524"/>
                    <a:gd name="T5" fmla="*/ 1032 h 1033"/>
                    <a:gd name="T6" fmla="*/ 115 w 524"/>
                    <a:gd name="T7" fmla="*/ 1032 h 1033"/>
                    <a:gd name="T8" fmla="*/ 144 w 524"/>
                    <a:gd name="T9" fmla="*/ 1031 h 1033"/>
                    <a:gd name="T10" fmla="*/ 173 w 524"/>
                    <a:gd name="T11" fmla="*/ 1031 h 1033"/>
                    <a:gd name="T12" fmla="*/ 190 w 524"/>
                    <a:gd name="T13" fmla="*/ 1030 h 1033"/>
                    <a:gd name="T14" fmla="*/ 217 w 524"/>
                    <a:gd name="T15" fmla="*/ 1030 h 1033"/>
                    <a:gd name="T16" fmla="*/ 226 w 524"/>
                    <a:gd name="T17" fmla="*/ 1030 h 1033"/>
                    <a:gd name="T18" fmla="*/ 245 w 524"/>
                    <a:gd name="T19" fmla="*/ 1029 h 1033"/>
                    <a:gd name="T20" fmla="*/ 269 w 524"/>
                    <a:gd name="T21" fmla="*/ 1027 h 1033"/>
                    <a:gd name="T22" fmla="*/ 287 w 524"/>
                    <a:gd name="T23" fmla="*/ 1026 h 1033"/>
                    <a:gd name="T24" fmla="*/ 311 w 524"/>
                    <a:gd name="T25" fmla="*/ 1025 h 1033"/>
                    <a:gd name="T26" fmla="*/ 333 w 524"/>
                    <a:gd name="T27" fmla="*/ 1025 h 1033"/>
                    <a:gd name="T28" fmla="*/ 353 w 524"/>
                    <a:gd name="T29" fmla="*/ 1025 h 1033"/>
                    <a:gd name="T30" fmla="*/ 366 w 524"/>
                    <a:gd name="T31" fmla="*/ 1024 h 1033"/>
                    <a:gd name="T32" fmla="*/ 385 w 524"/>
                    <a:gd name="T33" fmla="*/ 1023 h 1033"/>
                    <a:gd name="T34" fmla="*/ 400 w 524"/>
                    <a:gd name="T35" fmla="*/ 1023 h 1033"/>
                    <a:gd name="T36" fmla="*/ 413 w 524"/>
                    <a:gd name="T37" fmla="*/ 1023 h 1033"/>
                    <a:gd name="T38" fmla="*/ 422 w 524"/>
                    <a:gd name="T39" fmla="*/ 1022 h 1033"/>
                    <a:gd name="T40" fmla="*/ 429 w 524"/>
                    <a:gd name="T41" fmla="*/ 1021 h 1033"/>
                    <a:gd name="T42" fmla="*/ 434 w 524"/>
                    <a:gd name="T43" fmla="*/ 1019 h 1033"/>
                    <a:gd name="T44" fmla="*/ 436 w 524"/>
                    <a:gd name="T45" fmla="*/ 1017 h 1033"/>
                    <a:gd name="T46" fmla="*/ 438 w 524"/>
                    <a:gd name="T47" fmla="*/ 1016 h 1033"/>
                    <a:gd name="T48" fmla="*/ 439 w 524"/>
                    <a:gd name="T49" fmla="*/ 1015 h 1033"/>
                    <a:gd name="T50" fmla="*/ 440 w 524"/>
                    <a:gd name="T51" fmla="*/ 1013 h 1033"/>
                    <a:gd name="T52" fmla="*/ 442 w 524"/>
                    <a:gd name="T53" fmla="*/ 1010 h 1033"/>
                    <a:gd name="T54" fmla="*/ 444 w 524"/>
                    <a:gd name="T55" fmla="*/ 1004 h 1033"/>
                    <a:gd name="T56" fmla="*/ 447 w 524"/>
                    <a:gd name="T57" fmla="*/ 996 h 1033"/>
                    <a:gd name="T58" fmla="*/ 450 w 524"/>
                    <a:gd name="T59" fmla="*/ 985 h 1033"/>
                    <a:gd name="T60" fmla="*/ 452 w 524"/>
                    <a:gd name="T61" fmla="*/ 973 h 1033"/>
                    <a:gd name="T62" fmla="*/ 455 w 524"/>
                    <a:gd name="T63" fmla="*/ 958 h 1033"/>
                    <a:gd name="T64" fmla="*/ 457 w 524"/>
                    <a:gd name="T65" fmla="*/ 944 h 1033"/>
                    <a:gd name="T66" fmla="*/ 459 w 524"/>
                    <a:gd name="T67" fmla="*/ 929 h 1033"/>
                    <a:gd name="T68" fmla="*/ 460 w 524"/>
                    <a:gd name="T69" fmla="*/ 913 h 1033"/>
                    <a:gd name="T70" fmla="*/ 462 w 524"/>
                    <a:gd name="T71" fmla="*/ 888 h 1033"/>
                    <a:gd name="T72" fmla="*/ 464 w 524"/>
                    <a:gd name="T73" fmla="*/ 855 h 1033"/>
                    <a:gd name="T74" fmla="*/ 465 w 524"/>
                    <a:gd name="T75" fmla="*/ 814 h 1033"/>
                    <a:gd name="T76" fmla="*/ 467 w 524"/>
                    <a:gd name="T77" fmla="*/ 764 h 1033"/>
                    <a:gd name="T78" fmla="*/ 469 w 524"/>
                    <a:gd name="T79" fmla="*/ 705 h 1033"/>
                    <a:gd name="T80" fmla="*/ 470 w 524"/>
                    <a:gd name="T81" fmla="*/ 634 h 1033"/>
                    <a:gd name="T82" fmla="*/ 473 w 524"/>
                    <a:gd name="T83" fmla="*/ 527 h 1033"/>
                    <a:gd name="T84" fmla="*/ 477 w 524"/>
                    <a:gd name="T85" fmla="*/ 358 h 1033"/>
                    <a:gd name="T86" fmla="*/ 479 w 524"/>
                    <a:gd name="T87" fmla="*/ 265 h 1033"/>
                    <a:gd name="T88" fmla="*/ 481 w 524"/>
                    <a:gd name="T89" fmla="*/ 196 h 1033"/>
                    <a:gd name="T90" fmla="*/ 482 w 524"/>
                    <a:gd name="T91" fmla="*/ 167 h 1033"/>
                    <a:gd name="T92" fmla="*/ 482 w 524"/>
                    <a:gd name="T93" fmla="*/ 146 h 1033"/>
                    <a:gd name="T94" fmla="*/ 484 w 524"/>
                    <a:gd name="T95" fmla="*/ 105 h 1033"/>
                    <a:gd name="T96" fmla="*/ 485 w 524"/>
                    <a:gd name="T97" fmla="*/ 72 h 1033"/>
                    <a:gd name="T98" fmla="*/ 487 w 524"/>
                    <a:gd name="T99" fmla="*/ 45 h 1033"/>
                    <a:gd name="T100" fmla="*/ 488 w 524"/>
                    <a:gd name="T101" fmla="*/ 24 h 1033"/>
                    <a:gd name="T102" fmla="*/ 489 w 524"/>
                    <a:gd name="T103" fmla="*/ 10 h 1033"/>
                    <a:gd name="T104" fmla="*/ 491 w 524"/>
                    <a:gd name="T105" fmla="*/ 2 h 1033"/>
                    <a:gd name="T106" fmla="*/ 492 w 524"/>
                    <a:gd name="T107" fmla="*/ 1 h 1033"/>
                    <a:gd name="T108" fmla="*/ 494 w 524"/>
                    <a:gd name="T109" fmla="*/ 8 h 1033"/>
                    <a:gd name="T110" fmla="*/ 496 w 524"/>
                    <a:gd name="T111" fmla="*/ 22 h 1033"/>
                    <a:gd name="T112" fmla="*/ 497 w 524"/>
                    <a:gd name="T113" fmla="*/ 47 h 1033"/>
                    <a:gd name="T114" fmla="*/ 500 w 524"/>
                    <a:gd name="T115" fmla="*/ 84 h 1033"/>
                    <a:gd name="T116" fmla="*/ 502 w 524"/>
                    <a:gd name="T117" fmla="*/ 137 h 1033"/>
                    <a:gd name="T118" fmla="*/ 506 w 524"/>
                    <a:gd name="T119" fmla="*/ 227 h 1033"/>
                    <a:gd name="T120" fmla="*/ 513 w 524"/>
                    <a:gd name="T121" fmla="*/ 384 h 1033"/>
                    <a:gd name="T122" fmla="*/ 517 w 524"/>
                    <a:gd name="T123" fmla="*/ 478 h 1033"/>
                    <a:gd name="T124" fmla="*/ 521 w 524"/>
                    <a:gd name="T125" fmla="*/ 553 h 103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  <a:cxn ang="0">
                      <a:pos x="T116" y="T117"/>
                    </a:cxn>
                    <a:cxn ang="0">
                      <a:pos x="T118" y="T119"/>
                    </a:cxn>
                    <a:cxn ang="0">
                      <a:pos x="T120" y="T121"/>
                    </a:cxn>
                    <a:cxn ang="0">
                      <a:pos x="T122" y="T123"/>
                    </a:cxn>
                    <a:cxn ang="0">
                      <a:pos x="T124" y="T125"/>
                    </a:cxn>
                  </a:cxnLst>
                  <a:rect l="0" t="0" r="r" b="b"/>
                  <a:pathLst>
                    <a:path w="524" h="1033">
                      <a:moveTo>
                        <a:pt x="0" y="1033"/>
                      </a:moveTo>
                      <a:lnTo>
                        <a:pt x="4" y="1033"/>
                      </a:lnTo>
                      <a:lnTo>
                        <a:pt x="7" y="1033"/>
                      </a:lnTo>
                      <a:lnTo>
                        <a:pt x="9" y="1033"/>
                      </a:lnTo>
                      <a:lnTo>
                        <a:pt x="12" y="1033"/>
                      </a:lnTo>
                      <a:lnTo>
                        <a:pt x="18" y="1033"/>
                      </a:lnTo>
                      <a:lnTo>
                        <a:pt x="23" y="1033"/>
                      </a:lnTo>
                      <a:lnTo>
                        <a:pt x="30" y="1033"/>
                      </a:lnTo>
                      <a:lnTo>
                        <a:pt x="36" y="1033"/>
                      </a:lnTo>
                      <a:lnTo>
                        <a:pt x="42" y="1033"/>
                      </a:lnTo>
                      <a:lnTo>
                        <a:pt x="48" y="1033"/>
                      </a:lnTo>
                      <a:lnTo>
                        <a:pt x="51" y="1033"/>
                      </a:lnTo>
                      <a:lnTo>
                        <a:pt x="53" y="1033"/>
                      </a:lnTo>
                      <a:lnTo>
                        <a:pt x="56" y="1033"/>
                      </a:lnTo>
                      <a:lnTo>
                        <a:pt x="60" y="1033"/>
                      </a:lnTo>
                      <a:lnTo>
                        <a:pt x="65" y="1033"/>
                      </a:lnTo>
                      <a:lnTo>
                        <a:pt x="69" y="1033"/>
                      </a:lnTo>
                      <a:lnTo>
                        <a:pt x="73" y="1033"/>
                      </a:lnTo>
                      <a:lnTo>
                        <a:pt x="76" y="1033"/>
                      </a:lnTo>
                      <a:lnTo>
                        <a:pt x="79" y="1033"/>
                      </a:lnTo>
                      <a:lnTo>
                        <a:pt x="83" y="1033"/>
                      </a:lnTo>
                      <a:lnTo>
                        <a:pt x="86" y="1033"/>
                      </a:lnTo>
                      <a:lnTo>
                        <a:pt x="89" y="1032"/>
                      </a:lnTo>
                      <a:lnTo>
                        <a:pt x="92" y="1032"/>
                      </a:lnTo>
                      <a:lnTo>
                        <a:pt x="94" y="1032"/>
                      </a:lnTo>
                      <a:lnTo>
                        <a:pt x="96" y="1032"/>
                      </a:lnTo>
                      <a:lnTo>
                        <a:pt x="98" y="1032"/>
                      </a:lnTo>
                      <a:lnTo>
                        <a:pt x="100" y="1032"/>
                      </a:lnTo>
                      <a:lnTo>
                        <a:pt x="104" y="1032"/>
                      </a:lnTo>
                      <a:lnTo>
                        <a:pt x="107" y="1032"/>
                      </a:lnTo>
                      <a:lnTo>
                        <a:pt x="111" y="1032"/>
                      </a:lnTo>
                      <a:lnTo>
                        <a:pt x="115" y="1032"/>
                      </a:lnTo>
                      <a:lnTo>
                        <a:pt x="120" y="1032"/>
                      </a:lnTo>
                      <a:lnTo>
                        <a:pt x="124" y="1031"/>
                      </a:lnTo>
                      <a:lnTo>
                        <a:pt x="129" y="1031"/>
                      </a:lnTo>
                      <a:lnTo>
                        <a:pt x="134" y="1031"/>
                      </a:lnTo>
                      <a:lnTo>
                        <a:pt x="137" y="1031"/>
                      </a:lnTo>
                      <a:lnTo>
                        <a:pt x="139" y="1031"/>
                      </a:lnTo>
                      <a:lnTo>
                        <a:pt x="141" y="1031"/>
                      </a:lnTo>
                      <a:lnTo>
                        <a:pt x="144" y="1031"/>
                      </a:lnTo>
                      <a:lnTo>
                        <a:pt x="147" y="1031"/>
                      </a:lnTo>
                      <a:lnTo>
                        <a:pt x="151" y="1031"/>
                      </a:lnTo>
                      <a:lnTo>
                        <a:pt x="155" y="1031"/>
                      </a:lnTo>
                      <a:lnTo>
                        <a:pt x="159" y="1031"/>
                      </a:lnTo>
                      <a:lnTo>
                        <a:pt x="164" y="1031"/>
                      </a:lnTo>
                      <a:lnTo>
                        <a:pt x="167" y="1031"/>
                      </a:lnTo>
                      <a:lnTo>
                        <a:pt x="170" y="1031"/>
                      </a:lnTo>
                      <a:lnTo>
                        <a:pt x="173" y="1031"/>
                      </a:lnTo>
                      <a:lnTo>
                        <a:pt x="176" y="1031"/>
                      </a:lnTo>
                      <a:lnTo>
                        <a:pt x="178" y="1030"/>
                      </a:lnTo>
                      <a:lnTo>
                        <a:pt x="181" y="1030"/>
                      </a:lnTo>
                      <a:lnTo>
                        <a:pt x="182" y="1030"/>
                      </a:lnTo>
                      <a:lnTo>
                        <a:pt x="183" y="1030"/>
                      </a:lnTo>
                      <a:lnTo>
                        <a:pt x="185" y="1030"/>
                      </a:lnTo>
                      <a:lnTo>
                        <a:pt x="188" y="1030"/>
                      </a:lnTo>
                      <a:lnTo>
                        <a:pt x="190" y="1030"/>
                      </a:lnTo>
                      <a:lnTo>
                        <a:pt x="193" y="1030"/>
                      </a:lnTo>
                      <a:lnTo>
                        <a:pt x="196" y="1030"/>
                      </a:lnTo>
                      <a:lnTo>
                        <a:pt x="200" y="1030"/>
                      </a:lnTo>
                      <a:lnTo>
                        <a:pt x="206" y="1030"/>
                      </a:lnTo>
                      <a:lnTo>
                        <a:pt x="209" y="1030"/>
                      </a:lnTo>
                      <a:lnTo>
                        <a:pt x="212" y="1030"/>
                      </a:lnTo>
                      <a:lnTo>
                        <a:pt x="214" y="1030"/>
                      </a:lnTo>
                      <a:lnTo>
                        <a:pt x="217" y="1030"/>
                      </a:lnTo>
                      <a:lnTo>
                        <a:pt x="219" y="1030"/>
                      </a:lnTo>
                      <a:lnTo>
                        <a:pt x="221" y="1030"/>
                      </a:lnTo>
                      <a:lnTo>
                        <a:pt x="222" y="1030"/>
                      </a:lnTo>
                      <a:lnTo>
                        <a:pt x="223" y="1030"/>
                      </a:lnTo>
                      <a:lnTo>
                        <a:pt x="224" y="1030"/>
                      </a:lnTo>
                      <a:lnTo>
                        <a:pt x="224" y="1030"/>
                      </a:lnTo>
                      <a:lnTo>
                        <a:pt x="225" y="1030"/>
                      </a:lnTo>
                      <a:lnTo>
                        <a:pt x="226" y="1030"/>
                      </a:lnTo>
                      <a:lnTo>
                        <a:pt x="228" y="1030"/>
                      </a:lnTo>
                      <a:lnTo>
                        <a:pt x="230" y="1030"/>
                      </a:lnTo>
                      <a:lnTo>
                        <a:pt x="232" y="1030"/>
                      </a:lnTo>
                      <a:lnTo>
                        <a:pt x="234" y="1029"/>
                      </a:lnTo>
                      <a:lnTo>
                        <a:pt x="236" y="1029"/>
                      </a:lnTo>
                      <a:lnTo>
                        <a:pt x="239" y="1029"/>
                      </a:lnTo>
                      <a:lnTo>
                        <a:pt x="241" y="1029"/>
                      </a:lnTo>
                      <a:lnTo>
                        <a:pt x="245" y="1029"/>
                      </a:lnTo>
                      <a:lnTo>
                        <a:pt x="250" y="1028"/>
                      </a:lnTo>
                      <a:lnTo>
                        <a:pt x="256" y="1028"/>
                      </a:lnTo>
                      <a:lnTo>
                        <a:pt x="261" y="1028"/>
                      </a:lnTo>
                      <a:lnTo>
                        <a:pt x="264" y="1028"/>
                      </a:lnTo>
                      <a:lnTo>
                        <a:pt x="266" y="1027"/>
                      </a:lnTo>
                      <a:lnTo>
                        <a:pt x="267" y="1027"/>
                      </a:lnTo>
                      <a:lnTo>
                        <a:pt x="268" y="1027"/>
                      </a:lnTo>
                      <a:lnTo>
                        <a:pt x="269" y="1027"/>
                      </a:lnTo>
                      <a:lnTo>
                        <a:pt x="269" y="1027"/>
                      </a:lnTo>
                      <a:lnTo>
                        <a:pt x="270" y="1027"/>
                      </a:lnTo>
                      <a:lnTo>
                        <a:pt x="271" y="1027"/>
                      </a:lnTo>
                      <a:lnTo>
                        <a:pt x="274" y="1027"/>
                      </a:lnTo>
                      <a:lnTo>
                        <a:pt x="278" y="1027"/>
                      </a:lnTo>
                      <a:lnTo>
                        <a:pt x="281" y="1027"/>
                      </a:lnTo>
                      <a:lnTo>
                        <a:pt x="284" y="1026"/>
                      </a:lnTo>
                      <a:lnTo>
                        <a:pt x="287" y="1026"/>
                      </a:lnTo>
                      <a:lnTo>
                        <a:pt x="290" y="1026"/>
                      </a:lnTo>
                      <a:lnTo>
                        <a:pt x="293" y="1026"/>
                      </a:lnTo>
                      <a:lnTo>
                        <a:pt x="297" y="1025"/>
                      </a:lnTo>
                      <a:lnTo>
                        <a:pt x="300" y="1025"/>
                      </a:lnTo>
                      <a:lnTo>
                        <a:pt x="303" y="1025"/>
                      </a:lnTo>
                      <a:lnTo>
                        <a:pt x="306" y="1025"/>
                      </a:lnTo>
                      <a:lnTo>
                        <a:pt x="308" y="1025"/>
                      </a:lnTo>
                      <a:lnTo>
                        <a:pt x="311" y="1025"/>
                      </a:lnTo>
                      <a:lnTo>
                        <a:pt x="313" y="1025"/>
                      </a:lnTo>
                      <a:lnTo>
                        <a:pt x="315" y="1025"/>
                      </a:lnTo>
                      <a:lnTo>
                        <a:pt x="317" y="1025"/>
                      </a:lnTo>
                      <a:lnTo>
                        <a:pt x="320" y="1025"/>
                      </a:lnTo>
                      <a:lnTo>
                        <a:pt x="322" y="1025"/>
                      </a:lnTo>
                      <a:lnTo>
                        <a:pt x="325" y="1025"/>
                      </a:lnTo>
                      <a:lnTo>
                        <a:pt x="329" y="1025"/>
                      </a:lnTo>
                      <a:lnTo>
                        <a:pt x="333" y="1025"/>
                      </a:lnTo>
                      <a:lnTo>
                        <a:pt x="337" y="1025"/>
                      </a:lnTo>
                      <a:lnTo>
                        <a:pt x="340" y="1025"/>
                      </a:lnTo>
                      <a:lnTo>
                        <a:pt x="343" y="1025"/>
                      </a:lnTo>
                      <a:lnTo>
                        <a:pt x="346" y="1025"/>
                      </a:lnTo>
                      <a:lnTo>
                        <a:pt x="348" y="1025"/>
                      </a:lnTo>
                      <a:lnTo>
                        <a:pt x="350" y="1025"/>
                      </a:lnTo>
                      <a:lnTo>
                        <a:pt x="352" y="1025"/>
                      </a:lnTo>
                      <a:lnTo>
                        <a:pt x="353" y="1025"/>
                      </a:lnTo>
                      <a:lnTo>
                        <a:pt x="355" y="1025"/>
                      </a:lnTo>
                      <a:lnTo>
                        <a:pt x="356" y="1025"/>
                      </a:lnTo>
                      <a:lnTo>
                        <a:pt x="357" y="1025"/>
                      </a:lnTo>
                      <a:lnTo>
                        <a:pt x="358" y="1025"/>
                      </a:lnTo>
                      <a:lnTo>
                        <a:pt x="360" y="1025"/>
                      </a:lnTo>
                      <a:lnTo>
                        <a:pt x="362" y="1024"/>
                      </a:lnTo>
                      <a:lnTo>
                        <a:pt x="364" y="1024"/>
                      </a:lnTo>
                      <a:lnTo>
                        <a:pt x="366" y="1024"/>
                      </a:lnTo>
                      <a:lnTo>
                        <a:pt x="369" y="1024"/>
                      </a:lnTo>
                      <a:lnTo>
                        <a:pt x="372" y="1024"/>
                      </a:lnTo>
                      <a:lnTo>
                        <a:pt x="374" y="1023"/>
                      </a:lnTo>
                      <a:lnTo>
                        <a:pt x="376" y="1023"/>
                      </a:lnTo>
                      <a:lnTo>
                        <a:pt x="379" y="1023"/>
                      </a:lnTo>
                      <a:lnTo>
                        <a:pt x="381" y="1023"/>
                      </a:lnTo>
                      <a:lnTo>
                        <a:pt x="383" y="1023"/>
                      </a:lnTo>
                      <a:lnTo>
                        <a:pt x="385" y="1023"/>
                      </a:lnTo>
                      <a:lnTo>
                        <a:pt x="387" y="1023"/>
                      </a:lnTo>
                      <a:lnTo>
                        <a:pt x="389" y="1023"/>
                      </a:lnTo>
                      <a:lnTo>
                        <a:pt x="391" y="1023"/>
                      </a:lnTo>
                      <a:lnTo>
                        <a:pt x="393" y="1023"/>
                      </a:lnTo>
                      <a:lnTo>
                        <a:pt x="395" y="1023"/>
                      </a:lnTo>
                      <a:lnTo>
                        <a:pt x="397" y="1023"/>
                      </a:lnTo>
                      <a:lnTo>
                        <a:pt x="398" y="1023"/>
                      </a:lnTo>
                      <a:lnTo>
                        <a:pt x="400" y="1023"/>
                      </a:lnTo>
                      <a:lnTo>
                        <a:pt x="403" y="1023"/>
                      </a:lnTo>
                      <a:lnTo>
                        <a:pt x="405" y="1023"/>
                      </a:lnTo>
                      <a:lnTo>
                        <a:pt x="407" y="1023"/>
                      </a:lnTo>
                      <a:lnTo>
                        <a:pt x="408" y="1023"/>
                      </a:lnTo>
                      <a:lnTo>
                        <a:pt x="409" y="1023"/>
                      </a:lnTo>
                      <a:lnTo>
                        <a:pt x="411" y="1023"/>
                      </a:lnTo>
                      <a:lnTo>
                        <a:pt x="412" y="1023"/>
                      </a:lnTo>
                      <a:lnTo>
                        <a:pt x="413" y="1023"/>
                      </a:lnTo>
                      <a:lnTo>
                        <a:pt x="414" y="1023"/>
                      </a:lnTo>
                      <a:lnTo>
                        <a:pt x="416" y="1023"/>
                      </a:lnTo>
                      <a:lnTo>
                        <a:pt x="417" y="1023"/>
                      </a:lnTo>
                      <a:lnTo>
                        <a:pt x="418" y="1023"/>
                      </a:lnTo>
                      <a:lnTo>
                        <a:pt x="419" y="1023"/>
                      </a:lnTo>
                      <a:lnTo>
                        <a:pt x="420" y="1023"/>
                      </a:lnTo>
                      <a:lnTo>
                        <a:pt x="421" y="1023"/>
                      </a:lnTo>
                      <a:lnTo>
                        <a:pt x="422" y="1022"/>
                      </a:lnTo>
                      <a:lnTo>
                        <a:pt x="423" y="1022"/>
                      </a:lnTo>
                      <a:lnTo>
                        <a:pt x="424" y="1022"/>
                      </a:lnTo>
                      <a:lnTo>
                        <a:pt x="425" y="1022"/>
                      </a:lnTo>
                      <a:lnTo>
                        <a:pt x="426" y="1022"/>
                      </a:lnTo>
                      <a:lnTo>
                        <a:pt x="427" y="1021"/>
                      </a:lnTo>
                      <a:lnTo>
                        <a:pt x="428" y="1021"/>
                      </a:lnTo>
                      <a:lnTo>
                        <a:pt x="429" y="1021"/>
                      </a:lnTo>
                      <a:lnTo>
                        <a:pt x="429" y="1021"/>
                      </a:lnTo>
                      <a:lnTo>
                        <a:pt x="430" y="1020"/>
                      </a:lnTo>
                      <a:lnTo>
                        <a:pt x="431" y="1020"/>
                      </a:lnTo>
                      <a:lnTo>
                        <a:pt x="431" y="1020"/>
                      </a:lnTo>
                      <a:lnTo>
                        <a:pt x="432" y="1020"/>
                      </a:lnTo>
                      <a:lnTo>
                        <a:pt x="432" y="1020"/>
                      </a:lnTo>
                      <a:lnTo>
                        <a:pt x="433" y="1020"/>
                      </a:lnTo>
                      <a:lnTo>
                        <a:pt x="433" y="1019"/>
                      </a:lnTo>
                      <a:lnTo>
                        <a:pt x="434" y="1019"/>
                      </a:lnTo>
                      <a:lnTo>
                        <a:pt x="434" y="1019"/>
                      </a:lnTo>
                      <a:lnTo>
                        <a:pt x="434" y="1019"/>
                      </a:lnTo>
                      <a:lnTo>
                        <a:pt x="435" y="1019"/>
                      </a:lnTo>
                      <a:lnTo>
                        <a:pt x="435" y="1018"/>
                      </a:lnTo>
                      <a:lnTo>
                        <a:pt x="435" y="1018"/>
                      </a:lnTo>
                      <a:lnTo>
                        <a:pt x="436" y="1018"/>
                      </a:lnTo>
                      <a:lnTo>
                        <a:pt x="436" y="1018"/>
                      </a:lnTo>
                      <a:lnTo>
                        <a:pt x="436" y="1017"/>
                      </a:lnTo>
                      <a:lnTo>
                        <a:pt x="437" y="1017"/>
                      </a:lnTo>
                      <a:lnTo>
                        <a:pt x="437" y="1017"/>
                      </a:lnTo>
                      <a:lnTo>
                        <a:pt x="437" y="1017"/>
                      </a:lnTo>
                      <a:lnTo>
                        <a:pt x="438" y="1016"/>
                      </a:lnTo>
                      <a:lnTo>
                        <a:pt x="438" y="1016"/>
                      </a:lnTo>
                      <a:lnTo>
                        <a:pt x="438" y="1016"/>
                      </a:lnTo>
                      <a:lnTo>
                        <a:pt x="438" y="1016"/>
                      </a:lnTo>
                      <a:lnTo>
                        <a:pt x="438" y="1016"/>
                      </a:lnTo>
                      <a:lnTo>
                        <a:pt x="438" y="1015"/>
                      </a:lnTo>
                      <a:lnTo>
                        <a:pt x="439" y="1015"/>
                      </a:lnTo>
                      <a:lnTo>
                        <a:pt x="439" y="1015"/>
                      </a:lnTo>
                      <a:lnTo>
                        <a:pt x="439" y="1015"/>
                      </a:lnTo>
                      <a:lnTo>
                        <a:pt x="439" y="1015"/>
                      </a:lnTo>
                      <a:lnTo>
                        <a:pt x="439" y="1015"/>
                      </a:lnTo>
                      <a:lnTo>
                        <a:pt x="439" y="1015"/>
                      </a:lnTo>
                      <a:lnTo>
                        <a:pt x="439" y="1015"/>
                      </a:lnTo>
                      <a:lnTo>
                        <a:pt x="439" y="1014"/>
                      </a:lnTo>
                      <a:lnTo>
                        <a:pt x="439" y="1014"/>
                      </a:lnTo>
                      <a:lnTo>
                        <a:pt x="439" y="1014"/>
                      </a:lnTo>
                      <a:lnTo>
                        <a:pt x="440" y="1014"/>
                      </a:lnTo>
                      <a:lnTo>
                        <a:pt x="440" y="1014"/>
                      </a:lnTo>
                      <a:lnTo>
                        <a:pt x="440" y="1013"/>
                      </a:lnTo>
                      <a:lnTo>
                        <a:pt x="440" y="1013"/>
                      </a:lnTo>
                      <a:lnTo>
                        <a:pt x="440" y="1013"/>
                      </a:lnTo>
                      <a:lnTo>
                        <a:pt x="440" y="1013"/>
                      </a:lnTo>
                      <a:lnTo>
                        <a:pt x="440" y="1013"/>
                      </a:lnTo>
                      <a:lnTo>
                        <a:pt x="441" y="1012"/>
                      </a:lnTo>
                      <a:lnTo>
                        <a:pt x="441" y="1012"/>
                      </a:lnTo>
                      <a:lnTo>
                        <a:pt x="441" y="1011"/>
                      </a:lnTo>
                      <a:lnTo>
                        <a:pt x="441" y="1011"/>
                      </a:lnTo>
                      <a:lnTo>
                        <a:pt x="442" y="1010"/>
                      </a:lnTo>
                      <a:lnTo>
                        <a:pt x="442" y="1010"/>
                      </a:lnTo>
                      <a:lnTo>
                        <a:pt x="442" y="1010"/>
                      </a:lnTo>
                      <a:lnTo>
                        <a:pt x="442" y="1009"/>
                      </a:lnTo>
                      <a:lnTo>
                        <a:pt x="443" y="1008"/>
                      </a:lnTo>
                      <a:lnTo>
                        <a:pt x="443" y="1007"/>
                      </a:lnTo>
                      <a:lnTo>
                        <a:pt x="443" y="1007"/>
                      </a:lnTo>
                      <a:lnTo>
                        <a:pt x="444" y="1006"/>
                      </a:lnTo>
                      <a:lnTo>
                        <a:pt x="444" y="1005"/>
                      </a:lnTo>
                      <a:lnTo>
                        <a:pt x="444" y="1004"/>
                      </a:lnTo>
                      <a:lnTo>
                        <a:pt x="445" y="1003"/>
                      </a:lnTo>
                      <a:lnTo>
                        <a:pt x="445" y="1002"/>
                      </a:lnTo>
                      <a:lnTo>
                        <a:pt x="445" y="1001"/>
                      </a:lnTo>
                      <a:lnTo>
                        <a:pt x="446" y="1000"/>
                      </a:lnTo>
                      <a:lnTo>
                        <a:pt x="446" y="999"/>
                      </a:lnTo>
                      <a:lnTo>
                        <a:pt x="447" y="998"/>
                      </a:lnTo>
                      <a:lnTo>
                        <a:pt x="447" y="997"/>
                      </a:lnTo>
                      <a:lnTo>
                        <a:pt x="447" y="996"/>
                      </a:lnTo>
                      <a:lnTo>
                        <a:pt x="447" y="995"/>
                      </a:lnTo>
                      <a:lnTo>
                        <a:pt x="448" y="993"/>
                      </a:lnTo>
                      <a:lnTo>
                        <a:pt x="448" y="992"/>
                      </a:lnTo>
                      <a:lnTo>
                        <a:pt x="449" y="991"/>
                      </a:lnTo>
                      <a:lnTo>
                        <a:pt x="449" y="989"/>
                      </a:lnTo>
                      <a:lnTo>
                        <a:pt x="449" y="988"/>
                      </a:lnTo>
                      <a:lnTo>
                        <a:pt x="449" y="987"/>
                      </a:lnTo>
                      <a:lnTo>
                        <a:pt x="450" y="985"/>
                      </a:lnTo>
                      <a:lnTo>
                        <a:pt x="450" y="984"/>
                      </a:lnTo>
                      <a:lnTo>
                        <a:pt x="450" y="982"/>
                      </a:lnTo>
                      <a:lnTo>
                        <a:pt x="451" y="981"/>
                      </a:lnTo>
                      <a:lnTo>
                        <a:pt x="451" y="980"/>
                      </a:lnTo>
                      <a:lnTo>
                        <a:pt x="451" y="979"/>
                      </a:lnTo>
                      <a:lnTo>
                        <a:pt x="452" y="977"/>
                      </a:lnTo>
                      <a:lnTo>
                        <a:pt x="452" y="975"/>
                      </a:lnTo>
                      <a:lnTo>
                        <a:pt x="452" y="973"/>
                      </a:lnTo>
                      <a:lnTo>
                        <a:pt x="453" y="971"/>
                      </a:lnTo>
                      <a:lnTo>
                        <a:pt x="453" y="969"/>
                      </a:lnTo>
                      <a:lnTo>
                        <a:pt x="454" y="967"/>
                      </a:lnTo>
                      <a:lnTo>
                        <a:pt x="454" y="966"/>
                      </a:lnTo>
                      <a:lnTo>
                        <a:pt x="454" y="964"/>
                      </a:lnTo>
                      <a:lnTo>
                        <a:pt x="454" y="962"/>
                      </a:lnTo>
                      <a:lnTo>
                        <a:pt x="455" y="960"/>
                      </a:lnTo>
                      <a:lnTo>
                        <a:pt x="455" y="958"/>
                      </a:lnTo>
                      <a:lnTo>
                        <a:pt x="455" y="956"/>
                      </a:lnTo>
                      <a:lnTo>
                        <a:pt x="456" y="954"/>
                      </a:lnTo>
                      <a:lnTo>
                        <a:pt x="456" y="952"/>
                      </a:lnTo>
                      <a:lnTo>
                        <a:pt x="456" y="951"/>
                      </a:lnTo>
                      <a:lnTo>
                        <a:pt x="457" y="949"/>
                      </a:lnTo>
                      <a:lnTo>
                        <a:pt x="457" y="947"/>
                      </a:lnTo>
                      <a:lnTo>
                        <a:pt x="457" y="945"/>
                      </a:lnTo>
                      <a:lnTo>
                        <a:pt x="457" y="944"/>
                      </a:lnTo>
                      <a:lnTo>
                        <a:pt x="457" y="942"/>
                      </a:lnTo>
                      <a:lnTo>
                        <a:pt x="458" y="940"/>
                      </a:lnTo>
                      <a:lnTo>
                        <a:pt x="458" y="938"/>
                      </a:lnTo>
                      <a:lnTo>
                        <a:pt x="458" y="936"/>
                      </a:lnTo>
                      <a:lnTo>
                        <a:pt x="458" y="934"/>
                      </a:lnTo>
                      <a:lnTo>
                        <a:pt x="458" y="932"/>
                      </a:lnTo>
                      <a:lnTo>
                        <a:pt x="459" y="931"/>
                      </a:lnTo>
                      <a:lnTo>
                        <a:pt x="459" y="929"/>
                      </a:lnTo>
                      <a:lnTo>
                        <a:pt x="459" y="927"/>
                      </a:lnTo>
                      <a:lnTo>
                        <a:pt x="459" y="925"/>
                      </a:lnTo>
                      <a:lnTo>
                        <a:pt x="459" y="924"/>
                      </a:lnTo>
                      <a:lnTo>
                        <a:pt x="459" y="922"/>
                      </a:lnTo>
                      <a:lnTo>
                        <a:pt x="460" y="920"/>
                      </a:lnTo>
                      <a:lnTo>
                        <a:pt x="460" y="918"/>
                      </a:lnTo>
                      <a:lnTo>
                        <a:pt x="460" y="915"/>
                      </a:lnTo>
                      <a:lnTo>
                        <a:pt x="460" y="913"/>
                      </a:lnTo>
                      <a:lnTo>
                        <a:pt x="460" y="911"/>
                      </a:lnTo>
                      <a:lnTo>
                        <a:pt x="461" y="907"/>
                      </a:lnTo>
                      <a:lnTo>
                        <a:pt x="461" y="904"/>
                      </a:lnTo>
                      <a:lnTo>
                        <a:pt x="461" y="901"/>
                      </a:lnTo>
                      <a:lnTo>
                        <a:pt x="461" y="898"/>
                      </a:lnTo>
                      <a:lnTo>
                        <a:pt x="461" y="895"/>
                      </a:lnTo>
                      <a:lnTo>
                        <a:pt x="462" y="891"/>
                      </a:lnTo>
                      <a:lnTo>
                        <a:pt x="462" y="888"/>
                      </a:lnTo>
                      <a:lnTo>
                        <a:pt x="462" y="884"/>
                      </a:lnTo>
                      <a:lnTo>
                        <a:pt x="462" y="880"/>
                      </a:lnTo>
                      <a:lnTo>
                        <a:pt x="462" y="876"/>
                      </a:lnTo>
                      <a:lnTo>
                        <a:pt x="463" y="872"/>
                      </a:lnTo>
                      <a:lnTo>
                        <a:pt x="463" y="868"/>
                      </a:lnTo>
                      <a:lnTo>
                        <a:pt x="463" y="864"/>
                      </a:lnTo>
                      <a:lnTo>
                        <a:pt x="463" y="859"/>
                      </a:lnTo>
                      <a:lnTo>
                        <a:pt x="464" y="855"/>
                      </a:lnTo>
                      <a:lnTo>
                        <a:pt x="464" y="850"/>
                      </a:lnTo>
                      <a:lnTo>
                        <a:pt x="464" y="845"/>
                      </a:lnTo>
                      <a:lnTo>
                        <a:pt x="464" y="840"/>
                      </a:lnTo>
                      <a:lnTo>
                        <a:pt x="464" y="835"/>
                      </a:lnTo>
                      <a:lnTo>
                        <a:pt x="464" y="830"/>
                      </a:lnTo>
                      <a:lnTo>
                        <a:pt x="465" y="825"/>
                      </a:lnTo>
                      <a:lnTo>
                        <a:pt x="465" y="819"/>
                      </a:lnTo>
                      <a:lnTo>
                        <a:pt x="465" y="814"/>
                      </a:lnTo>
                      <a:lnTo>
                        <a:pt x="465" y="808"/>
                      </a:lnTo>
                      <a:lnTo>
                        <a:pt x="466" y="802"/>
                      </a:lnTo>
                      <a:lnTo>
                        <a:pt x="466" y="796"/>
                      </a:lnTo>
                      <a:lnTo>
                        <a:pt x="466" y="790"/>
                      </a:lnTo>
                      <a:lnTo>
                        <a:pt x="466" y="783"/>
                      </a:lnTo>
                      <a:lnTo>
                        <a:pt x="467" y="777"/>
                      </a:lnTo>
                      <a:lnTo>
                        <a:pt x="467" y="770"/>
                      </a:lnTo>
                      <a:lnTo>
                        <a:pt x="467" y="764"/>
                      </a:lnTo>
                      <a:lnTo>
                        <a:pt x="467" y="757"/>
                      </a:lnTo>
                      <a:lnTo>
                        <a:pt x="467" y="750"/>
                      </a:lnTo>
                      <a:lnTo>
                        <a:pt x="468" y="743"/>
                      </a:lnTo>
                      <a:lnTo>
                        <a:pt x="468" y="736"/>
                      </a:lnTo>
                      <a:lnTo>
                        <a:pt x="468" y="728"/>
                      </a:lnTo>
                      <a:lnTo>
                        <a:pt x="468" y="721"/>
                      </a:lnTo>
                      <a:lnTo>
                        <a:pt x="468" y="713"/>
                      </a:lnTo>
                      <a:lnTo>
                        <a:pt x="469" y="705"/>
                      </a:lnTo>
                      <a:lnTo>
                        <a:pt x="469" y="698"/>
                      </a:lnTo>
                      <a:lnTo>
                        <a:pt x="469" y="690"/>
                      </a:lnTo>
                      <a:lnTo>
                        <a:pt x="469" y="682"/>
                      </a:lnTo>
                      <a:lnTo>
                        <a:pt x="469" y="673"/>
                      </a:lnTo>
                      <a:lnTo>
                        <a:pt x="470" y="663"/>
                      </a:lnTo>
                      <a:lnTo>
                        <a:pt x="470" y="654"/>
                      </a:lnTo>
                      <a:lnTo>
                        <a:pt x="470" y="644"/>
                      </a:lnTo>
                      <a:lnTo>
                        <a:pt x="470" y="634"/>
                      </a:lnTo>
                      <a:lnTo>
                        <a:pt x="471" y="623"/>
                      </a:lnTo>
                      <a:lnTo>
                        <a:pt x="471" y="613"/>
                      </a:lnTo>
                      <a:lnTo>
                        <a:pt x="471" y="601"/>
                      </a:lnTo>
                      <a:lnTo>
                        <a:pt x="472" y="589"/>
                      </a:lnTo>
                      <a:lnTo>
                        <a:pt x="472" y="575"/>
                      </a:lnTo>
                      <a:lnTo>
                        <a:pt x="472" y="561"/>
                      </a:lnTo>
                      <a:lnTo>
                        <a:pt x="473" y="545"/>
                      </a:lnTo>
                      <a:lnTo>
                        <a:pt x="473" y="527"/>
                      </a:lnTo>
                      <a:lnTo>
                        <a:pt x="474" y="507"/>
                      </a:lnTo>
                      <a:lnTo>
                        <a:pt x="474" y="480"/>
                      </a:lnTo>
                      <a:lnTo>
                        <a:pt x="475" y="451"/>
                      </a:lnTo>
                      <a:lnTo>
                        <a:pt x="475" y="426"/>
                      </a:lnTo>
                      <a:lnTo>
                        <a:pt x="476" y="405"/>
                      </a:lnTo>
                      <a:lnTo>
                        <a:pt x="476" y="388"/>
                      </a:lnTo>
                      <a:lnTo>
                        <a:pt x="477" y="372"/>
                      </a:lnTo>
                      <a:lnTo>
                        <a:pt x="477" y="358"/>
                      </a:lnTo>
                      <a:lnTo>
                        <a:pt x="477" y="344"/>
                      </a:lnTo>
                      <a:lnTo>
                        <a:pt x="477" y="331"/>
                      </a:lnTo>
                      <a:lnTo>
                        <a:pt x="478" y="319"/>
                      </a:lnTo>
                      <a:lnTo>
                        <a:pt x="478" y="307"/>
                      </a:lnTo>
                      <a:lnTo>
                        <a:pt x="478" y="295"/>
                      </a:lnTo>
                      <a:lnTo>
                        <a:pt x="479" y="285"/>
                      </a:lnTo>
                      <a:lnTo>
                        <a:pt x="479" y="275"/>
                      </a:lnTo>
                      <a:lnTo>
                        <a:pt x="479" y="265"/>
                      </a:lnTo>
                      <a:lnTo>
                        <a:pt x="479" y="255"/>
                      </a:lnTo>
                      <a:lnTo>
                        <a:pt x="480" y="245"/>
                      </a:lnTo>
                      <a:lnTo>
                        <a:pt x="480" y="235"/>
                      </a:lnTo>
                      <a:lnTo>
                        <a:pt x="480" y="227"/>
                      </a:lnTo>
                      <a:lnTo>
                        <a:pt x="480" y="219"/>
                      </a:lnTo>
                      <a:lnTo>
                        <a:pt x="481" y="211"/>
                      </a:lnTo>
                      <a:lnTo>
                        <a:pt x="481" y="203"/>
                      </a:lnTo>
                      <a:lnTo>
                        <a:pt x="481" y="196"/>
                      </a:lnTo>
                      <a:lnTo>
                        <a:pt x="481" y="188"/>
                      </a:lnTo>
                      <a:lnTo>
                        <a:pt x="481" y="183"/>
                      </a:lnTo>
                      <a:lnTo>
                        <a:pt x="481" y="180"/>
                      </a:lnTo>
                      <a:lnTo>
                        <a:pt x="482" y="177"/>
                      </a:lnTo>
                      <a:lnTo>
                        <a:pt x="482" y="175"/>
                      </a:lnTo>
                      <a:lnTo>
                        <a:pt x="482" y="172"/>
                      </a:lnTo>
                      <a:lnTo>
                        <a:pt x="482" y="169"/>
                      </a:lnTo>
                      <a:lnTo>
                        <a:pt x="482" y="167"/>
                      </a:lnTo>
                      <a:lnTo>
                        <a:pt x="482" y="165"/>
                      </a:lnTo>
                      <a:lnTo>
                        <a:pt x="482" y="162"/>
                      </a:lnTo>
                      <a:lnTo>
                        <a:pt x="482" y="159"/>
                      </a:lnTo>
                      <a:lnTo>
                        <a:pt x="482" y="157"/>
                      </a:lnTo>
                      <a:lnTo>
                        <a:pt x="482" y="154"/>
                      </a:lnTo>
                      <a:lnTo>
                        <a:pt x="482" y="151"/>
                      </a:lnTo>
                      <a:lnTo>
                        <a:pt x="482" y="148"/>
                      </a:lnTo>
                      <a:lnTo>
                        <a:pt x="482" y="146"/>
                      </a:lnTo>
                      <a:lnTo>
                        <a:pt x="483" y="143"/>
                      </a:lnTo>
                      <a:lnTo>
                        <a:pt x="483" y="139"/>
                      </a:lnTo>
                      <a:lnTo>
                        <a:pt x="483" y="132"/>
                      </a:lnTo>
                      <a:lnTo>
                        <a:pt x="483" y="126"/>
                      </a:lnTo>
                      <a:lnTo>
                        <a:pt x="483" y="120"/>
                      </a:lnTo>
                      <a:lnTo>
                        <a:pt x="484" y="115"/>
                      </a:lnTo>
                      <a:lnTo>
                        <a:pt x="484" y="110"/>
                      </a:lnTo>
                      <a:lnTo>
                        <a:pt x="484" y="105"/>
                      </a:lnTo>
                      <a:lnTo>
                        <a:pt x="484" y="101"/>
                      </a:lnTo>
                      <a:lnTo>
                        <a:pt x="484" y="96"/>
                      </a:lnTo>
                      <a:lnTo>
                        <a:pt x="484" y="92"/>
                      </a:lnTo>
                      <a:lnTo>
                        <a:pt x="484" y="88"/>
                      </a:lnTo>
                      <a:lnTo>
                        <a:pt x="485" y="84"/>
                      </a:lnTo>
                      <a:lnTo>
                        <a:pt x="485" y="79"/>
                      </a:lnTo>
                      <a:lnTo>
                        <a:pt x="485" y="76"/>
                      </a:lnTo>
                      <a:lnTo>
                        <a:pt x="485" y="72"/>
                      </a:lnTo>
                      <a:lnTo>
                        <a:pt x="485" y="68"/>
                      </a:lnTo>
                      <a:lnTo>
                        <a:pt x="486" y="64"/>
                      </a:lnTo>
                      <a:lnTo>
                        <a:pt x="486" y="61"/>
                      </a:lnTo>
                      <a:lnTo>
                        <a:pt x="486" y="57"/>
                      </a:lnTo>
                      <a:lnTo>
                        <a:pt x="486" y="54"/>
                      </a:lnTo>
                      <a:lnTo>
                        <a:pt x="486" y="51"/>
                      </a:lnTo>
                      <a:lnTo>
                        <a:pt x="487" y="48"/>
                      </a:lnTo>
                      <a:lnTo>
                        <a:pt x="487" y="45"/>
                      </a:lnTo>
                      <a:lnTo>
                        <a:pt x="487" y="42"/>
                      </a:lnTo>
                      <a:lnTo>
                        <a:pt x="487" y="39"/>
                      </a:lnTo>
                      <a:lnTo>
                        <a:pt x="487" y="36"/>
                      </a:lnTo>
                      <a:lnTo>
                        <a:pt x="487" y="34"/>
                      </a:lnTo>
                      <a:lnTo>
                        <a:pt x="487" y="31"/>
                      </a:lnTo>
                      <a:lnTo>
                        <a:pt x="488" y="29"/>
                      </a:lnTo>
                      <a:lnTo>
                        <a:pt x="488" y="26"/>
                      </a:lnTo>
                      <a:lnTo>
                        <a:pt x="488" y="24"/>
                      </a:lnTo>
                      <a:lnTo>
                        <a:pt x="488" y="22"/>
                      </a:lnTo>
                      <a:lnTo>
                        <a:pt x="488" y="20"/>
                      </a:lnTo>
                      <a:lnTo>
                        <a:pt x="489" y="18"/>
                      </a:lnTo>
                      <a:lnTo>
                        <a:pt x="489" y="16"/>
                      </a:lnTo>
                      <a:lnTo>
                        <a:pt x="489" y="14"/>
                      </a:lnTo>
                      <a:lnTo>
                        <a:pt x="489" y="13"/>
                      </a:lnTo>
                      <a:lnTo>
                        <a:pt x="489" y="11"/>
                      </a:lnTo>
                      <a:lnTo>
                        <a:pt x="489" y="10"/>
                      </a:lnTo>
                      <a:lnTo>
                        <a:pt x="489" y="9"/>
                      </a:lnTo>
                      <a:lnTo>
                        <a:pt x="490" y="7"/>
                      </a:lnTo>
                      <a:lnTo>
                        <a:pt x="490" y="6"/>
                      </a:lnTo>
                      <a:lnTo>
                        <a:pt x="490" y="5"/>
                      </a:lnTo>
                      <a:lnTo>
                        <a:pt x="490" y="4"/>
                      </a:lnTo>
                      <a:lnTo>
                        <a:pt x="490" y="4"/>
                      </a:lnTo>
                      <a:lnTo>
                        <a:pt x="490" y="3"/>
                      </a:lnTo>
                      <a:lnTo>
                        <a:pt x="491" y="2"/>
                      </a:lnTo>
                      <a:lnTo>
                        <a:pt x="491" y="2"/>
                      </a:lnTo>
                      <a:lnTo>
                        <a:pt x="491" y="1"/>
                      </a:lnTo>
                      <a:lnTo>
                        <a:pt x="491" y="1"/>
                      </a:lnTo>
                      <a:lnTo>
                        <a:pt x="491" y="1"/>
                      </a:lnTo>
                      <a:lnTo>
                        <a:pt x="492" y="0"/>
                      </a:lnTo>
                      <a:lnTo>
                        <a:pt x="492" y="0"/>
                      </a:lnTo>
                      <a:lnTo>
                        <a:pt x="492" y="1"/>
                      </a:lnTo>
                      <a:lnTo>
                        <a:pt x="492" y="1"/>
                      </a:lnTo>
                      <a:lnTo>
                        <a:pt x="492" y="1"/>
                      </a:lnTo>
                      <a:lnTo>
                        <a:pt x="493" y="2"/>
                      </a:lnTo>
                      <a:lnTo>
                        <a:pt x="493" y="2"/>
                      </a:lnTo>
                      <a:lnTo>
                        <a:pt x="493" y="3"/>
                      </a:lnTo>
                      <a:lnTo>
                        <a:pt x="493" y="4"/>
                      </a:lnTo>
                      <a:lnTo>
                        <a:pt x="494" y="5"/>
                      </a:lnTo>
                      <a:lnTo>
                        <a:pt x="494" y="6"/>
                      </a:lnTo>
                      <a:lnTo>
                        <a:pt x="494" y="8"/>
                      </a:lnTo>
                      <a:lnTo>
                        <a:pt x="494" y="9"/>
                      </a:lnTo>
                      <a:lnTo>
                        <a:pt x="494" y="11"/>
                      </a:lnTo>
                      <a:lnTo>
                        <a:pt x="494" y="12"/>
                      </a:lnTo>
                      <a:lnTo>
                        <a:pt x="495" y="14"/>
                      </a:lnTo>
                      <a:lnTo>
                        <a:pt x="495" y="16"/>
                      </a:lnTo>
                      <a:lnTo>
                        <a:pt x="495" y="18"/>
                      </a:lnTo>
                      <a:lnTo>
                        <a:pt x="495" y="20"/>
                      </a:lnTo>
                      <a:lnTo>
                        <a:pt x="496" y="22"/>
                      </a:lnTo>
                      <a:lnTo>
                        <a:pt x="496" y="25"/>
                      </a:lnTo>
                      <a:lnTo>
                        <a:pt x="496" y="27"/>
                      </a:lnTo>
                      <a:lnTo>
                        <a:pt x="496" y="30"/>
                      </a:lnTo>
                      <a:lnTo>
                        <a:pt x="497" y="33"/>
                      </a:lnTo>
                      <a:lnTo>
                        <a:pt x="497" y="36"/>
                      </a:lnTo>
                      <a:lnTo>
                        <a:pt x="497" y="39"/>
                      </a:lnTo>
                      <a:lnTo>
                        <a:pt x="497" y="43"/>
                      </a:lnTo>
                      <a:lnTo>
                        <a:pt x="497" y="47"/>
                      </a:lnTo>
                      <a:lnTo>
                        <a:pt x="498" y="51"/>
                      </a:lnTo>
                      <a:lnTo>
                        <a:pt x="498" y="55"/>
                      </a:lnTo>
                      <a:lnTo>
                        <a:pt x="498" y="59"/>
                      </a:lnTo>
                      <a:lnTo>
                        <a:pt x="499" y="63"/>
                      </a:lnTo>
                      <a:lnTo>
                        <a:pt x="499" y="68"/>
                      </a:lnTo>
                      <a:lnTo>
                        <a:pt x="499" y="73"/>
                      </a:lnTo>
                      <a:lnTo>
                        <a:pt x="499" y="78"/>
                      </a:lnTo>
                      <a:lnTo>
                        <a:pt x="500" y="84"/>
                      </a:lnTo>
                      <a:lnTo>
                        <a:pt x="500" y="89"/>
                      </a:lnTo>
                      <a:lnTo>
                        <a:pt x="500" y="95"/>
                      </a:lnTo>
                      <a:lnTo>
                        <a:pt x="501" y="101"/>
                      </a:lnTo>
                      <a:lnTo>
                        <a:pt x="501" y="108"/>
                      </a:lnTo>
                      <a:lnTo>
                        <a:pt x="501" y="115"/>
                      </a:lnTo>
                      <a:lnTo>
                        <a:pt x="502" y="122"/>
                      </a:lnTo>
                      <a:lnTo>
                        <a:pt x="502" y="129"/>
                      </a:lnTo>
                      <a:lnTo>
                        <a:pt x="502" y="137"/>
                      </a:lnTo>
                      <a:lnTo>
                        <a:pt x="503" y="146"/>
                      </a:lnTo>
                      <a:lnTo>
                        <a:pt x="503" y="155"/>
                      </a:lnTo>
                      <a:lnTo>
                        <a:pt x="504" y="165"/>
                      </a:lnTo>
                      <a:lnTo>
                        <a:pt x="504" y="175"/>
                      </a:lnTo>
                      <a:lnTo>
                        <a:pt x="505" y="187"/>
                      </a:lnTo>
                      <a:lnTo>
                        <a:pt x="505" y="199"/>
                      </a:lnTo>
                      <a:lnTo>
                        <a:pt x="506" y="212"/>
                      </a:lnTo>
                      <a:lnTo>
                        <a:pt x="506" y="227"/>
                      </a:lnTo>
                      <a:lnTo>
                        <a:pt x="507" y="244"/>
                      </a:lnTo>
                      <a:lnTo>
                        <a:pt x="508" y="266"/>
                      </a:lnTo>
                      <a:lnTo>
                        <a:pt x="509" y="293"/>
                      </a:lnTo>
                      <a:lnTo>
                        <a:pt x="510" y="318"/>
                      </a:lnTo>
                      <a:lnTo>
                        <a:pt x="511" y="337"/>
                      </a:lnTo>
                      <a:lnTo>
                        <a:pt x="512" y="354"/>
                      </a:lnTo>
                      <a:lnTo>
                        <a:pt x="512" y="369"/>
                      </a:lnTo>
                      <a:lnTo>
                        <a:pt x="513" y="384"/>
                      </a:lnTo>
                      <a:lnTo>
                        <a:pt x="514" y="398"/>
                      </a:lnTo>
                      <a:lnTo>
                        <a:pt x="514" y="410"/>
                      </a:lnTo>
                      <a:lnTo>
                        <a:pt x="515" y="423"/>
                      </a:lnTo>
                      <a:lnTo>
                        <a:pt x="515" y="434"/>
                      </a:lnTo>
                      <a:lnTo>
                        <a:pt x="516" y="446"/>
                      </a:lnTo>
                      <a:lnTo>
                        <a:pt x="516" y="457"/>
                      </a:lnTo>
                      <a:lnTo>
                        <a:pt x="517" y="468"/>
                      </a:lnTo>
                      <a:lnTo>
                        <a:pt x="517" y="478"/>
                      </a:lnTo>
                      <a:lnTo>
                        <a:pt x="518" y="489"/>
                      </a:lnTo>
                      <a:lnTo>
                        <a:pt x="518" y="499"/>
                      </a:lnTo>
                      <a:lnTo>
                        <a:pt x="519" y="508"/>
                      </a:lnTo>
                      <a:lnTo>
                        <a:pt x="519" y="517"/>
                      </a:lnTo>
                      <a:lnTo>
                        <a:pt x="520" y="526"/>
                      </a:lnTo>
                      <a:lnTo>
                        <a:pt x="520" y="535"/>
                      </a:lnTo>
                      <a:lnTo>
                        <a:pt x="521" y="544"/>
                      </a:lnTo>
                      <a:lnTo>
                        <a:pt x="521" y="553"/>
                      </a:lnTo>
                      <a:lnTo>
                        <a:pt x="522" y="561"/>
                      </a:lnTo>
                      <a:lnTo>
                        <a:pt x="522" y="570"/>
                      </a:lnTo>
                      <a:lnTo>
                        <a:pt x="523" y="578"/>
                      </a:lnTo>
                      <a:lnTo>
                        <a:pt x="523" y="585"/>
                      </a:lnTo>
                      <a:lnTo>
                        <a:pt x="524" y="592"/>
                      </a:lnTo>
                      <a:lnTo>
                        <a:pt x="524" y="600"/>
                      </a:lnTo>
                      <a:lnTo>
                        <a:pt x="524" y="607"/>
                      </a:lnTo>
                    </a:path>
                  </a:pathLst>
                </a:cu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7" name="Freeform 148"/>
                <p:cNvSpPr>
                  <a:spLocks/>
                </p:cNvSpPr>
                <p:nvPr/>
              </p:nvSpPr>
              <p:spPr bwMode="auto">
                <a:xfrm>
                  <a:off x="5862638" y="2273301"/>
                  <a:ext cx="3267075" cy="668338"/>
                </a:xfrm>
                <a:custGeom>
                  <a:avLst/>
                  <a:gdLst>
                    <a:gd name="T0" fmla="*/ 2 w 2058"/>
                    <a:gd name="T1" fmla="*/ 20 h 421"/>
                    <a:gd name="T2" fmla="*/ 2 w 2058"/>
                    <a:gd name="T3" fmla="*/ 31 h 421"/>
                    <a:gd name="T4" fmla="*/ 3 w 2058"/>
                    <a:gd name="T5" fmla="*/ 49 h 421"/>
                    <a:gd name="T6" fmla="*/ 7 w 2058"/>
                    <a:gd name="T7" fmla="*/ 98 h 421"/>
                    <a:gd name="T8" fmla="*/ 11 w 2058"/>
                    <a:gd name="T9" fmla="*/ 138 h 421"/>
                    <a:gd name="T10" fmla="*/ 15 w 2058"/>
                    <a:gd name="T11" fmla="*/ 174 h 421"/>
                    <a:gd name="T12" fmla="*/ 20 w 2058"/>
                    <a:gd name="T13" fmla="*/ 206 h 421"/>
                    <a:gd name="T14" fmla="*/ 26 w 2058"/>
                    <a:gd name="T15" fmla="*/ 234 h 421"/>
                    <a:gd name="T16" fmla="*/ 33 w 2058"/>
                    <a:gd name="T17" fmla="*/ 262 h 421"/>
                    <a:gd name="T18" fmla="*/ 43 w 2058"/>
                    <a:gd name="T19" fmla="*/ 289 h 421"/>
                    <a:gd name="T20" fmla="*/ 49 w 2058"/>
                    <a:gd name="T21" fmla="*/ 301 h 421"/>
                    <a:gd name="T22" fmla="*/ 58 w 2058"/>
                    <a:gd name="T23" fmla="*/ 317 h 421"/>
                    <a:gd name="T24" fmla="*/ 73 w 2058"/>
                    <a:gd name="T25" fmla="*/ 337 h 421"/>
                    <a:gd name="T26" fmla="*/ 89 w 2058"/>
                    <a:gd name="T27" fmla="*/ 359 h 421"/>
                    <a:gd name="T28" fmla="*/ 93 w 2058"/>
                    <a:gd name="T29" fmla="*/ 365 h 421"/>
                    <a:gd name="T30" fmla="*/ 105 w 2058"/>
                    <a:gd name="T31" fmla="*/ 382 h 421"/>
                    <a:gd name="T32" fmla="*/ 113 w 2058"/>
                    <a:gd name="T33" fmla="*/ 392 h 421"/>
                    <a:gd name="T34" fmla="*/ 122 w 2058"/>
                    <a:gd name="T35" fmla="*/ 399 h 421"/>
                    <a:gd name="T36" fmla="*/ 129 w 2058"/>
                    <a:gd name="T37" fmla="*/ 404 h 421"/>
                    <a:gd name="T38" fmla="*/ 136 w 2058"/>
                    <a:gd name="T39" fmla="*/ 407 h 421"/>
                    <a:gd name="T40" fmla="*/ 144 w 2058"/>
                    <a:gd name="T41" fmla="*/ 410 h 421"/>
                    <a:gd name="T42" fmla="*/ 156 w 2058"/>
                    <a:gd name="T43" fmla="*/ 413 h 421"/>
                    <a:gd name="T44" fmla="*/ 169 w 2058"/>
                    <a:gd name="T45" fmla="*/ 416 h 421"/>
                    <a:gd name="T46" fmla="*/ 183 w 2058"/>
                    <a:gd name="T47" fmla="*/ 417 h 421"/>
                    <a:gd name="T48" fmla="*/ 216 w 2058"/>
                    <a:gd name="T49" fmla="*/ 418 h 421"/>
                    <a:gd name="T50" fmla="*/ 239 w 2058"/>
                    <a:gd name="T51" fmla="*/ 419 h 421"/>
                    <a:gd name="T52" fmla="*/ 271 w 2058"/>
                    <a:gd name="T53" fmla="*/ 419 h 421"/>
                    <a:gd name="T54" fmla="*/ 309 w 2058"/>
                    <a:gd name="T55" fmla="*/ 420 h 421"/>
                    <a:gd name="T56" fmla="*/ 346 w 2058"/>
                    <a:gd name="T57" fmla="*/ 421 h 421"/>
                    <a:gd name="T58" fmla="*/ 378 w 2058"/>
                    <a:gd name="T59" fmla="*/ 421 h 421"/>
                    <a:gd name="T60" fmla="*/ 417 w 2058"/>
                    <a:gd name="T61" fmla="*/ 421 h 421"/>
                    <a:gd name="T62" fmla="*/ 459 w 2058"/>
                    <a:gd name="T63" fmla="*/ 421 h 421"/>
                    <a:gd name="T64" fmla="*/ 489 w 2058"/>
                    <a:gd name="T65" fmla="*/ 421 h 421"/>
                    <a:gd name="T66" fmla="*/ 529 w 2058"/>
                    <a:gd name="T67" fmla="*/ 421 h 421"/>
                    <a:gd name="T68" fmla="*/ 568 w 2058"/>
                    <a:gd name="T69" fmla="*/ 421 h 421"/>
                    <a:gd name="T70" fmla="*/ 587 w 2058"/>
                    <a:gd name="T71" fmla="*/ 420 h 421"/>
                    <a:gd name="T72" fmla="*/ 608 w 2058"/>
                    <a:gd name="T73" fmla="*/ 419 h 421"/>
                    <a:gd name="T74" fmla="*/ 624 w 2058"/>
                    <a:gd name="T75" fmla="*/ 419 h 421"/>
                    <a:gd name="T76" fmla="*/ 654 w 2058"/>
                    <a:gd name="T77" fmla="*/ 420 h 421"/>
                    <a:gd name="T78" fmla="*/ 682 w 2058"/>
                    <a:gd name="T79" fmla="*/ 420 h 421"/>
                    <a:gd name="T80" fmla="*/ 715 w 2058"/>
                    <a:gd name="T81" fmla="*/ 420 h 421"/>
                    <a:gd name="T82" fmla="*/ 758 w 2058"/>
                    <a:gd name="T83" fmla="*/ 420 h 421"/>
                    <a:gd name="T84" fmla="*/ 807 w 2058"/>
                    <a:gd name="T85" fmla="*/ 420 h 421"/>
                    <a:gd name="T86" fmla="*/ 869 w 2058"/>
                    <a:gd name="T87" fmla="*/ 420 h 421"/>
                    <a:gd name="T88" fmla="*/ 963 w 2058"/>
                    <a:gd name="T89" fmla="*/ 421 h 421"/>
                    <a:gd name="T90" fmla="*/ 1037 w 2058"/>
                    <a:gd name="T91" fmla="*/ 421 h 421"/>
                    <a:gd name="T92" fmla="*/ 1088 w 2058"/>
                    <a:gd name="T93" fmla="*/ 420 h 421"/>
                    <a:gd name="T94" fmla="*/ 1152 w 2058"/>
                    <a:gd name="T95" fmla="*/ 420 h 421"/>
                    <a:gd name="T96" fmla="*/ 1221 w 2058"/>
                    <a:gd name="T97" fmla="*/ 420 h 421"/>
                    <a:gd name="T98" fmla="*/ 1278 w 2058"/>
                    <a:gd name="T99" fmla="*/ 420 h 421"/>
                    <a:gd name="T100" fmla="*/ 1326 w 2058"/>
                    <a:gd name="T101" fmla="*/ 420 h 421"/>
                    <a:gd name="T102" fmla="*/ 1391 w 2058"/>
                    <a:gd name="T103" fmla="*/ 420 h 421"/>
                    <a:gd name="T104" fmla="*/ 1446 w 2058"/>
                    <a:gd name="T105" fmla="*/ 419 h 421"/>
                    <a:gd name="T106" fmla="*/ 1491 w 2058"/>
                    <a:gd name="T107" fmla="*/ 419 h 421"/>
                    <a:gd name="T108" fmla="*/ 1536 w 2058"/>
                    <a:gd name="T109" fmla="*/ 419 h 421"/>
                    <a:gd name="T110" fmla="*/ 1583 w 2058"/>
                    <a:gd name="T111" fmla="*/ 419 h 421"/>
                    <a:gd name="T112" fmla="*/ 1631 w 2058"/>
                    <a:gd name="T113" fmla="*/ 418 h 421"/>
                    <a:gd name="T114" fmla="*/ 1699 w 2058"/>
                    <a:gd name="T115" fmla="*/ 418 h 421"/>
                    <a:gd name="T116" fmla="*/ 1752 w 2058"/>
                    <a:gd name="T117" fmla="*/ 417 h 421"/>
                    <a:gd name="T118" fmla="*/ 1833 w 2058"/>
                    <a:gd name="T119" fmla="*/ 417 h 421"/>
                    <a:gd name="T120" fmla="*/ 1912 w 2058"/>
                    <a:gd name="T121" fmla="*/ 417 h 421"/>
                    <a:gd name="T122" fmla="*/ 1985 w 2058"/>
                    <a:gd name="T123" fmla="*/ 417 h 421"/>
                    <a:gd name="T124" fmla="*/ 2025 w 2058"/>
                    <a:gd name="T125" fmla="*/ 416 h 42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  <a:cxn ang="0">
                      <a:pos x="T116" y="T117"/>
                    </a:cxn>
                    <a:cxn ang="0">
                      <a:pos x="T118" y="T119"/>
                    </a:cxn>
                    <a:cxn ang="0">
                      <a:pos x="T120" y="T121"/>
                    </a:cxn>
                    <a:cxn ang="0">
                      <a:pos x="T122" y="T123"/>
                    </a:cxn>
                    <a:cxn ang="0">
                      <a:pos x="T124" y="T125"/>
                    </a:cxn>
                  </a:cxnLst>
                  <a:rect l="0" t="0" r="r" b="b"/>
                  <a:pathLst>
                    <a:path w="2058" h="421">
                      <a:moveTo>
                        <a:pt x="0" y="0"/>
                      </a:moveTo>
                      <a:lnTo>
                        <a:pt x="1" y="6"/>
                      </a:lnTo>
                      <a:lnTo>
                        <a:pt x="1" y="9"/>
                      </a:lnTo>
                      <a:lnTo>
                        <a:pt x="1" y="12"/>
                      </a:lnTo>
                      <a:lnTo>
                        <a:pt x="1" y="14"/>
                      </a:lnTo>
                      <a:lnTo>
                        <a:pt x="1" y="16"/>
                      </a:lnTo>
                      <a:lnTo>
                        <a:pt x="1" y="18"/>
                      </a:lnTo>
                      <a:lnTo>
                        <a:pt x="2" y="20"/>
                      </a:lnTo>
                      <a:lnTo>
                        <a:pt x="2" y="22"/>
                      </a:lnTo>
                      <a:lnTo>
                        <a:pt x="2" y="23"/>
                      </a:lnTo>
                      <a:lnTo>
                        <a:pt x="2" y="24"/>
                      </a:lnTo>
                      <a:lnTo>
                        <a:pt x="2" y="26"/>
                      </a:lnTo>
                      <a:lnTo>
                        <a:pt x="2" y="27"/>
                      </a:lnTo>
                      <a:lnTo>
                        <a:pt x="2" y="28"/>
                      </a:lnTo>
                      <a:lnTo>
                        <a:pt x="2" y="30"/>
                      </a:lnTo>
                      <a:lnTo>
                        <a:pt x="2" y="31"/>
                      </a:lnTo>
                      <a:lnTo>
                        <a:pt x="2" y="32"/>
                      </a:lnTo>
                      <a:lnTo>
                        <a:pt x="3" y="33"/>
                      </a:lnTo>
                      <a:lnTo>
                        <a:pt x="3" y="35"/>
                      </a:lnTo>
                      <a:lnTo>
                        <a:pt x="3" y="36"/>
                      </a:lnTo>
                      <a:lnTo>
                        <a:pt x="3" y="37"/>
                      </a:lnTo>
                      <a:lnTo>
                        <a:pt x="3" y="38"/>
                      </a:lnTo>
                      <a:lnTo>
                        <a:pt x="3" y="43"/>
                      </a:lnTo>
                      <a:lnTo>
                        <a:pt x="3" y="49"/>
                      </a:lnTo>
                      <a:lnTo>
                        <a:pt x="4" y="56"/>
                      </a:lnTo>
                      <a:lnTo>
                        <a:pt x="5" y="62"/>
                      </a:lnTo>
                      <a:lnTo>
                        <a:pt x="5" y="69"/>
                      </a:lnTo>
                      <a:lnTo>
                        <a:pt x="6" y="75"/>
                      </a:lnTo>
                      <a:lnTo>
                        <a:pt x="6" y="81"/>
                      </a:lnTo>
                      <a:lnTo>
                        <a:pt x="6" y="87"/>
                      </a:lnTo>
                      <a:lnTo>
                        <a:pt x="7" y="93"/>
                      </a:lnTo>
                      <a:lnTo>
                        <a:pt x="7" y="98"/>
                      </a:lnTo>
                      <a:lnTo>
                        <a:pt x="8" y="104"/>
                      </a:lnTo>
                      <a:lnTo>
                        <a:pt x="8" y="109"/>
                      </a:lnTo>
                      <a:lnTo>
                        <a:pt x="9" y="114"/>
                      </a:lnTo>
                      <a:lnTo>
                        <a:pt x="9" y="119"/>
                      </a:lnTo>
                      <a:lnTo>
                        <a:pt x="10" y="124"/>
                      </a:lnTo>
                      <a:lnTo>
                        <a:pt x="10" y="129"/>
                      </a:lnTo>
                      <a:lnTo>
                        <a:pt x="11" y="134"/>
                      </a:lnTo>
                      <a:lnTo>
                        <a:pt x="11" y="138"/>
                      </a:lnTo>
                      <a:lnTo>
                        <a:pt x="12" y="143"/>
                      </a:lnTo>
                      <a:lnTo>
                        <a:pt x="12" y="148"/>
                      </a:lnTo>
                      <a:lnTo>
                        <a:pt x="13" y="152"/>
                      </a:lnTo>
                      <a:lnTo>
                        <a:pt x="13" y="157"/>
                      </a:lnTo>
                      <a:lnTo>
                        <a:pt x="14" y="161"/>
                      </a:lnTo>
                      <a:lnTo>
                        <a:pt x="14" y="165"/>
                      </a:lnTo>
                      <a:lnTo>
                        <a:pt x="15" y="170"/>
                      </a:lnTo>
                      <a:lnTo>
                        <a:pt x="15" y="174"/>
                      </a:lnTo>
                      <a:lnTo>
                        <a:pt x="16" y="178"/>
                      </a:lnTo>
                      <a:lnTo>
                        <a:pt x="16" y="182"/>
                      </a:lnTo>
                      <a:lnTo>
                        <a:pt x="17" y="187"/>
                      </a:lnTo>
                      <a:lnTo>
                        <a:pt x="18" y="191"/>
                      </a:lnTo>
                      <a:lnTo>
                        <a:pt x="18" y="194"/>
                      </a:lnTo>
                      <a:lnTo>
                        <a:pt x="19" y="198"/>
                      </a:lnTo>
                      <a:lnTo>
                        <a:pt x="19" y="202"/>
                      </a:lnTo>
                      <a:lnTo>
                        <a:pt x="20" y="206"/>
                      </a:lnTo>
                      <a:lnTo>
                        <a:pt x="21" y="209"/>
                      </a:lnTo>
                      <a:lnTo>
                        <a:pt x="21" y="213"/>
                      </a:lnTo>
                      <a:lnTo>
                        <a:pt x="22" y="217"/>
                      </a:lnTo>
                      <a:lnTo>
                        <a:pt x="23" y="220"/>
                      </a:lnTo>
                      <a:lnTo>
                        <a:pt x="23" y="224"/>
                      </a:lnTo>
                      <a:lnTo>
                        <a:pt x="24" y="227"/>
                      </a:lnTo>
                      <a:lnTo>
                        <a:pt x="25" y="231"/>
                      </a:lnTo>
                      <a:lnTo>
                        <a:pt x="26" y="234"/>
                      </a:lnTo>
                      <a:lnTo>
                        <a:pt x="27" y="238"/>
                      </a:lnTo>
                      <a:lnTo>
                        <a:pt x="27" y="241"/>
                      </a:lnTo>
                      <a:lnTo>
                        <a:pt x="28" y="244"/>
                      </a:lnTo>
                      <a:lnTo>
                        <a:pt x="29" y="248"/>
                      </a:lnTo>
                      <a:lnTo>
                        <a:pt x="30" y="252"/>
                      </a:lnTo>
                      <a:lnTo>
                        <a:pt x="31" y="255"/>
                      </a:lnTo>
                      <a:lnTo>
                        <a:pt x="32" y="258"/>
                      </a:lnTo>
                      <a:lnTo>
                        <a:pt x="33" y="262"/>
                      </a:lnTo>
                      <a:lnTo>
                        <a:pt x="34" y="265"/>
                      </a:lnTo>
                      <a:lnTo>
                        <a:pt x="35" y="269"/>
                      </a:lnTo>
                      <a:lnTo>
                        <a:pt x="36" y="272"/>
                      </a:lnTo>
                      <a:lnTo>
                        <a:pt x="38" y="275"/>
                      </a:lnTo>
                      <a:lnTo>
                        <a:pt x="39" y="279"/>
                      </a:lnTo>
                      <a:lnTo>
                        <a:pt x="40" y="282"/>
                      </a:lnTo>
                      <a:lnTo>
                        <a:pt x="42" y="285"/>
                      </a:lnTo>
                      <a:lnTo>
                        <a:pt x="43" y="289"/>
                      </a:lnTo>
                      <a:lnTo>
                        <a:pt x="44" y="292"/>
                      </a:lnTo>
                      <a:lnTo>
                        <a:pt x="45" y="294"/>
                      </a:lnTo>
                      <a:lnTo>
                        <a:pt x="46" y="296"/>
                      </a:lnTo>
                      <a:lnTo>
                        <a:pt x="47" y="298"/>
                      </a:lnTo>
                      <a:lnTo>
                        <a:pt x="48" y="299"/>
                      </a:lnTo>
                      <a:lnTo>
                        <a:pt x="48" y="300"/>
                      </a:lnTo>
                      <a:lnTo>
                        <a:pt x="48" y="300"/>
                      </a:lnTo>
                      <a:lnTo>
                        <a:pt x="49" y="301"/>
                      </a:lnTo>
                      <a:lnTo>
                        <a:pt x="50" y="303"/>
                      </a:lnTo>
                      <a:lnTo>
                        <a:pt x="51" y="305"/>
                      </a:lnTo>
                      <a:lnTo>
                        <a:pt x="52" y="307"/>
                      </a:lnTo>
                      <a:lnTo>
                        <a:pt x="53" y="309"/>
                      </a:lnTo>
                      <a:lnTo>
                        <a:pt x="54" y="311"/>
                      </a:lnTo>
                      <a:lnTo>
                        <a:pt x="55" y="313"/>
                      </a:lnTo>
                      <a:lnTo>
                        <a:pt x="57" y="315"/>
                      </a:lnTo>
                      <a:lnTo>
                        <a:pt x="58" y="317"/>
                      </a:lnTo>
                      <a:lnTo>
                        <a:pt x="59" y="319"/>
                      </a:lnTo>
                      <a:lnTo>
                        <a:pt x="61" y="321"/>
                      </a:lnTo>
                      <a:lnTo>
                        <a:pt x="62" y="323"/>
                      </a:lnTo>
                      <a:lnTo>
                        <a:pt x="63" y="325"/>
                      </a:lnTo>
                      <a:lnTo>
                        <a:pt x="66" y="327"/>
                      </a:lnTo>
                      <a:lnTo>
                        <a:pt x="68" y="330"/>
                      </a:lnTo>
                      <a:lnTo>
                        <a:pt x="71" y="334"/>
                      </a:lnTo>
                      <a:lnTo>
                        <a:pt x="73" y="337"/>
                      </a:lnTo>
                      <a:lnTo>
                        <a:pt x="76" y="340"/>
                      </a:lnTo>
                      <a:lnTo>
                        <a:pt x="78" y="343"/>
                      </a:lnTo>
                      <a:lnTo>
                        <a:pt x="81" y="347"/>
                      </a:lnTo>
                      <a:lnTo>
                        <a:pt x="83" y="350"/>
                      </a:lnTo>
                      <a:lnTo>
                        <a:pt x="86" y="354"/>
                      </a:lnTo>
                      <a:lnTo>
                        <a:pt x="87" y="356"/>
                      </a:lnTo>
                      <a:lnTo>
                        <a:pt x="88" y="358"/>
                      </a:lnTo>
                      <a:lnTo>
                        <a:pt x="89" y="359"/>
                      </a:lnTo>
                      <a:lnTo>
                        <a:pt x="90" y="360"/>
                      </a:lnTo>
                      <a:lnTo>
                        <a:pt x="91" y="361"/>
                      </a:lnTo>
                      <a:lnTo>
                        <a:pt x="91" y="362"/>
                      </a:lnTo>
                      <a:lnTo>
                        <a:pt x="92" y="363"/>
                      </a:lnTo>
                      <a:lnTo>
                        <a:pt x="92" y="364"/>
                      </a:lnTo>
                      <a:lnTo>
                        <a:pt x="93" y="364"/>
                      </a:lnTo>
                      <a:lnTo>
                        <a:pt x="93" y="365"/>
                      </a:lnTo>
                      <a:lnTo>
                        <a:pt x="93" y="365"/>
                      </a:lnTo>
                      <a:lnTo>
                        <a:pt x="95" y="368"/>
                      </a:lnTo>
                      <a:lnTo>
                        <a:pt x="97" y="371"/>
                      </a:lnTo>
                      <a:lnTo>
                        <a:pt x="98" y="373"/>
                      </a:lnTo>
                      <a:lnTo>
                        <a:pt x="100" y="375"/>
                      </a:lnTo>
                      <a:lnTo>
                        <a:pt x="101" y="377"/>
                      </a:lnTo>
                      <a:lnTo>
                        <a:pt x="103" y="378"/>
                      </a:lnTo>
                      <a:lnTo>
                        <a:pt x="104" y="380"/>
                      </a:lnTo>
                      <a:lnTo>
                        <a:pt x="105" y="382"/>
                      </a:lnTo>
                      <a:lnTo>
                        <a:pt x="106" y="383"/>
                      </a:lnTo>
                      <a:lnTo>
                        <a:pt x="107" y="385"/>
                      </a:lnTo>
                      <a:lnTo>
                        <a:pt x="108" y="386"/>
                      </a:lnTo>
                      <a:lnTo>
                        <a:pt x="109" y="387"/>
                      </a:lnTo>
                      <a:lnTo>
                        <a:pt x="110" y="388"/>
                      </a:lnTo>
                      <a:lnTo>
                        <a:pt x="111" y="390"/>
                      </a:lnTo>
                      <a:lnTo>
                        <a:pt x="112" y="391"/>
                      </a:lnTo>
                      <a:lnTo>
                        <a:pt x="113" y="392"/>
                      </a:lnTo>
                      <a:lnTo>
                        <a:pt x="114" y="393"/>
                      </a:lnTo>
                      <a:lnTo>
                        <a:pt x="116" y="394"/>
                      </a:lnTo>
                      <a:lnTo>
                        <a:pt x="116" y="395"/>
                      </a:lnTo>
                      <a:lnTo>
                        <a:pt x="118" y="396"/>
                      </a:lnTo>
                      <a:lnTo>
                        <a:pt x="118" y="397"/>
                      </a:lnTo>
                      <a:lnTo>
                        <a:pt x="119" y="398"/>
                      </a:lnTo>
                      <a:lnTo>
                        <a:pt x="121" y="398"/>
                      </a:lnTo>
                      <a:lnTo>
                        <a:pt x="122" y="399"/>
                      </a:lnTo>
                      <a:lnTo>
                        <a:pt x="123" y="400"/>
                      </a:lnTo>
                      <a:lnTo>
                        <a:pt x="124" y="401"/>
                      </a:lnTo>
                      <a:lnTo>
                        <a:pt x="125" y="401"/>
                      </a:lnTo>
                      <a:lnTo>
                        <a:pt x="126" y="402"/>
                      </a:lnTo>
                      <a:lnTo>
                        <a:pt x="127" y="403"/>
                      </a:lnTo>
                      <a:lnTo>
                        <a:pt x="127" y="403"/>
                      </a:lnTo>
                      <a:lnTo>
                        <a:pt x="128" y="403"/>
                      </a:lnTo>
                      <a:lnTo>
                        <a:pt x="129" y="404"/>
                      </a:lnTo>
                      <a:lnTo>
                        <a:pt x="130" y="405"/>
                      </a:lnTo>
                      <a:lnTo>
                        <a:pt x="131" y="405"/>
                      </a:lnTo>
                      <a:lnTo>
                        <a:pt x="132" y="405"/>
                      </a:lnTo>
                      <a:lnTo>
                        <a:pt x="133" y="406"/>
                      </a:lnTo>
                      <a:lnTo>
                        <a:pt x="134" y="406"/>
                      </a:lnTo>
                      <a:lnTo>
                        <a:pt x="135" y="407"/>
                      </a:lnTo>
                      <a:lnTo>
                        <a:pt x="136" y="407"/>
                      </a:lnTo>
                      <a:lnTo>
                        <a:pt x="136" y="407"/>
                      </a:lnTo>
                      <a:lnTo>
                        <a:pt x="137" y="408"/>
                      </a:lnTo>
                      <a:lnTo>
                        <a:pt x="137" y="408"/>
                      </a:lnTo>
                      <a:lnTo>
                        <a:pt x="138" y="408"/>
                      </a:lnTo>
                      <a:lnTo>
                        <a:pt x="139" y="408"/>
                      </a:lnTo>
                      <a:lnTo>
                        <a:pt x="140" y="409"/>
                      </a:lnTo>
                      <a:lnTo>
                        <a:pt x="142" y="409"/>
                      </a:lnTo>
                      <a:lnTo>
                        <a:pt x="143" y="410"/>
                      </a:lnTo>
                      <a:lnTo>
                        <a:pt x="144" y="410"/>
                      </a:lnTo>
                      <a:lnTo>
                        <a:pt x="146" y="411"/>
                      </a:lnTo>
                      <a:lnTo>
                        <a:pt x="147" y="411"/>
                      </a:lnTo>
                      <a:lnTo>
                        <a:pt x="148" y="411"/>
                      </a:lnTo>
                      <a:lnTo>
                        <a:pt x="150" y="412"/>
                      </a:lnTo>
                      <a:lnTo>
                        <a:pt x="151" y="412"/>
                      </a:lnTo>
                      <a:lnTo>
                        <a:pt x="153" y="413"/>
                      </a:lnTo>
                      <a:lnTo>
                        <a:pt x="154" y="413"/>
                      </a:lnTo>
                      <a:lnTo>
                        <a:pt x="156" y="413"/>
                      </a:lnTo>
                      <a:lnTo>
                        <a:pt x="157" y="413"/>
                      </a:lnTo>
                      <a:lnTo>
                        <a:pt x="159" y="414"/>
                      </a:lnTo>
                      <a:lnTo>
                        <a:pt x="160" y="414"/>
                      </a:lnTo>
                      <a:lnTo>
                        <a:pt x="162" y="414"/>
                      </a:lnTo>
                      <a:lnTo>
                        <a:pt x="164" y="415"/>
                      </a:lnTo>
                      <a:lnTo>
                        <a:pt x="165" y="415"/>
                      </a:lnTo>
                      <a:lnTo>
                        <a:pt x="167" y="415"/>
                      </a:lnTo>
                      <a:lnTo>
                        <a:pt x="169" y="416"/>
                      </a:lnTo>
                      <a:lnTo>
                        <a:pt x="171" y="416"/>
                      </a:lnTo>
                      <a:lnTo>
                        <a:pt x="172" y="416"/>
                      </a:lnTo>
                      <a:lnTo>
                        <a:pt x="174" y="416"/>
                      </a:lnTo>
                      <a:lnTo>
                        <a:pt x="177" y="416"/>
                      </a:lnTo>
                      <a:lnTo>
                        <a:pt x="179" y="416"/>
                      </a:lnTo>
                      <a:lnTo>
                        <a:pt x="180" y="417"/>
                      </a:lnTo>
                      <a:lnTo>
                        <a:pt x="181" y="417"/>
                      </a:lnTo>
                      <a:lnTo>
                        <a:pt x="183" y="417"/>
                      </a:lnTo>
                      <a:lnTo>
                        <a:pt x="186" y="417"/>
                      </a:lnTo>
                      <a:lnTo>
                        <a:pt x="189" y="417"/>
                      </a:lnTo>
                      <a:lnTo>
                        <a:pt x="191" y="417"/>
                      </a:lnTo>
                      <a:lnTo>
                        <a:pt x="195" y="418"/>
                      </a:lnTo>
                      <a:lnTo>
                        <a:pt x="200" y="418"/>
                      </a:lnTo>
                      <a:lnTo>
                        <a:pt x="206" y="418"/>
                      </a:lnTo>
                      <a:lnTo>
                        <a:pt x="211" y="418"/>
                      </a:lnTo>
                      <a:lnTo>
                        <a:pt x="216" y="418"/>
                      </a:lnTo>
                      <a:lnTo>
                        <a:pt x="220" y="418"/>
                      </a:lnTo>
                      <a:lnTo>
                        <a:pt x="223" y="419"/>
                      </a:lnTo>
                      <a:lnTo>
                        <a:pt x="224" y="419"/>
                      </a:lnTo>
                      <a:lnTo>
                        <a:pt x="226" y="419"/>
                      </a:lnTo>
                      <a:lnTo>
                        <a:pt x="230" y="419"/>
                      </a:lnTo>
                      <a:lnTo>
                        <a:pt x="233" y="419"/>
                      </a:lnTo>
                      <a:lnTo>
                        <a:pt x="236" y="419"/>
                      </a:lnTo>
                      <a:lnTo>
                        <a:pt x="239" y="419"/>
                      </a:lnTo>
                      <a:lnTo>
                        <a:pt x="242" y="419"/>
                      </a:lnTo>
                      <a:lnTo>
                        <a:pt x="246" y="419"/>
                      </a:lnTo>
                      <a:lnTo>
                        <a:pt x="253" y="419"/>
                      </a:lnTo>
                      <a:lnTo>
                        <a:pt x="260" y="419"/>
                      </a:lnTo>
                      <a:lnTo>
                        <a:pt x="264" y="419"/>
                      </a:lnTo>
                      <a:lnTo>
                        <a:pt x="266" y="419"/>
                      </a:lnTo>
                      <a:lnTo>
                        <a:pt x="268" y="419"/>
                      </a:lnTo>
                      <a:lnTo>
                        <a:pt x="271" y="419"/>
                      </a:lnTo>
                      <a:lnTo>
                        <a:pt x="275" y="419"/>
                      </a:lnTo>
                      <a:lnTo>
                        <a:pt x="280" y="420"/>
                      </a:lnTo>
                      <a:lnTo>
                        <a:pt x="285" y="420"/>
                      </a:lnTo>
                      <a:lnTo>
                        <a:pt x="290" y="420"/>
                      </a:lnTo>
                      <a:lnTo>
                        <a:pt x="297" y="420"/>
                      </a:lnTo>
                      <a:lnTo>
                        <a:pt x="303" y="420"/>
                      </a:lnTo>
                      <a:lnTo>
                        <a:pt x="307" y="420"/>
                      </a:lnTo>
                      <a:lnTo>
                        <a:pt x="309" y="420"/>
                      </a:lnTo>
                      <a:lnTo>
                        <a:pt x="311" y="420"/>
                      </a:lnTo>
                      <a:lnTo>
                        <a:pt x="314" y="420"/>
                      </a:lnTo>
                      <a:lnTo>
                        <a:pt x="319" y="420"/>
                      </a:lnTo>
                      <a:lnTo>
                        <a:pt x="324" y="420"/>
                      </a:lnTo>
                      <a:lnTo>
                        <a:pt x="329" y="420"/>
                      </a:lnTo>
                      <a:lnTo>
                        <a:pt x="334" y="420"/>
                      </a:lnTo>
                      <a:lnTo>
                        <a:pt x="340" y="420"/>
                      </a:lnTo>
                      <a:lnTo>
                        <a:pt x="346" y="421"/>
                      </a:lnTo>
                      <a:lnTo>
                        <a:pt x="350" y="421"/>
                      </a:lnTo>
                      <a:lnTo>
                        <a:pt x="353" y="421"/>
                      </a:lnTo>
                      <a:lnTo>
                        <a:pt x="355" y="421"/>
                      </a:lnTo>
                      <a:lnTo>
                        <a:pt x="358" y="421"/>
                      </a:lnTo>
                      <a:lnTo>
                        <a:pt x="363" y="421"/>
                      </a:lnTo>
                      <a:lnTo>
                        <a:pt x="367" y="421"/>
                      </a:lnTo>
                      <a:lnTo>
                        <a:pt x="372" y="421"/>
                      </a:lnTo>
                      <a:lnTo>
                        <a:pt x="378" y="421"/>
                      </a:lnTo>
                      <a:lnTo>
                        <a:pt x="383" y="421"/>
                      </a:lnTo>
                      <a:lnTo>
                        <a:pt x="389" y="421"/>
                      </a:lnTo>
                      <a:lnTo>
                        <a:pt x="395" y="421"/>
                      </a:lnTo>
                      <a:lnTo>
                        <a:pt x="399" y="421"/>
                      </a:lnTo>
                      <a:lnTo>
                        <a:pt x="402" y="421"/>
                      </a:lnTo>
                      <a:lnTo>
                        <a:pt x="408" y="421"/>
                      </a:lnTo>
                      <a:lnTo>
                        <a:pt x="413" y="421"/>
                      </a:lnTo>
                      <a:lnTo>
                        <a:pt x="417" y="421"/>
                      </a:lnTo>
                      <a:lnTo>
                        <a:pt x="422" y="421"/>
                      </a:lnTo>
                      <a:lnTo>
                        <a:pt x="427" y="421"/>
                      </a:lnTo>
                      <a:lnTo>
                        <a:pt x="432" y="421"/>
                      </a:lnTo>
                      <a:lnTo>
                        <a:pt x="437" y="421"/>
                      </a:lnTo>
                      <a:lnTo>
                        <a:pt x="441" y="421"/>
                      </a:lnTo>
                      <a:lnTo>
                        <a:pt x="445" y="421"/>
                      </a:lnTo>
                      <a:lnTo>
                        <a:pt x="453" y="421"/>
                      </a:lnTo>
                      <a:lnTo>
                        <a:pt x="459" y="421"/>
                      </a:lnTo>
                      <a:lnTo>
                        <a:pt x="464" y="421"/>
                      </a:lnTo>
                      <a:lnTo>
                        <a:pt x="469" y="421"/>
                      </a:lnTo>
                      <a:lnTo>
                        <a:pt x="474" y="421"/>
                      </a:lnTo>
                      <a:lnTo>
                        <a:pt x="478" y="421"/>
                      </a:lnTo>
                      <a:lnTo>
                        <a:pt x="481" y="421"/>
                      </a:lnTo>
                      <a:lnTo>
                        <a:pt x="483" y="421"/>
                      </a:lnTo>
                      <a:lnTo>
                        <a:pt x="486" y="421"/>
                      </a:lnTo>
                      <a:lnTo>
                        <a:pt x="489" y="421"/>
                      </a:lnTo>
                      <a:lnTo>
                        <a:pt x="493" y="421"/>
                      </a:lnTo>
                      <a:lnTo>
                        <a:pt x="497" y="421"/>
                      </a:lnTo>
                      <a:lnTo>
                        <a:pt x="501" y="421"/>
                      </a:lnTo>
                      <a:lnTo>
                        <a:pt x="507" y="421"/>
                      </a:lnTo>
                      <a:lnTo>
                        <a:pt x="513" y="421"/>
                      </a:lnTo>
                      <a:lnTo>
                        <a:pt x="520" y="421"/>
                      </a:lnTo>
                      <a:lnTo>
                        <a:pt x="526" y="421"/>
                      </a:lnTo>
                      <a:lnTo>
                        <a:pt x="529" y="421"/>
                      </a:lnTo>
                      <a:lnTo>
                        <a:pt x="533" y="421"/>
                      </a:lnTo>
                      <a:lnTo>
                        <a:pt x="538" y="421"/>
                      </a:lnTo>
                      <a:lnTo>
                        <a:pt x="544" y="421"/>
                      </a:lnTo>
                      <a:lnTo>
                        <a:pt x="550" y="421"/>
                      </a:lnTo>
                      <a:lnTo>
                        <a:pt x="556" y="421"/>
                      </a:lnTo>
                      <a:lnTo>
                        <a:pt x="561" y="421"/>
                      </a:lnTo>
                      <a:lnTo>
                        <a:pt x="565" y="421"/>
                      </a:lnTo>
                      <a:lnTo>
                        <a:pt x="568" y="421"/>
                      </a:lnTo>
                      <a:lnTo>
                        <a:pt x="571" y="421"/>
                      </a:lnTo>
                      <a:lnTo>
                        <a:pt x="575" y="421"/>
                      </a:lnTo>
                      <a:lnTo>
                        <a:pt x="576" y="421"/>
                      </a:lnTo>
                      <a:lnTo>
                        <a:pt x="578" y="421"/>
                      </a:lnTo>
                      <a:lnTo>
                        <a:pt x="580" y="421"/>
                      </a:lnTo>
                      <a:lnTo>
                        <a:pt x="582" y="421"/>
                      </a:lnTo>
                      <a:lnTo>
                        <a:pt x="585" y="420"/>
                      </a:lnTo>
                      <a:lnTo>
                        <a:pt x="587" y="420"/>
                      </a:lnTo>
                      <a:lnTo>
                        <a:pt x="589" y="420"/>
                      </a:lnTo>
                      <a:lnTo>
                        <a:pt x="592" y="420"/>
                      </a:lnTo>
                      <a:lnTo>
                        <a:pt x="595" y="420"/>
                      </a:lnTo>
                      <a:lnTo>
                        <a:pt x="598" y="420"/>
                      </a:lnTo>
                      <a:lnTo>
                        <a:pt x="601" y="420"/>
                      </a:lnTo>
                      <a:lnTo>
                        <a:pt x="604" y="419"/>
                      </a:lnTo>
                      <a:lnTo>
                        <a:pt x="606" y="419"/>
                      </a:lnTo>
                      <a:lnTo>
                        <a:pt x="608" y="419"/>
                      </a:lnTo>
                      <a:lnTo>
                        <a:pt x="610" y="419"/>
                      </a:lnTo>
                      <a:lnTo>
                        <a:pt x="612" y="419"/>
                      </a:lnTo>
                      <a:lnTo>
                        <a:pt x="614" y="419"/>
                      </a:lnTo>
                      <a:lnTo>
                        <a:pt x="616" y="419"/>
                      </a:lnTo>
                      <a:lnTo>
                        <a:pt x="618" y="419"/>
                      </a:lnTo>
                      <a:lnTo>
                        <a:pt x="620" y="419"/>
                      </a:lnTo>
                      <a:lnTo>
                        <a:pt x="622" y="419"/>
                      </a:lnTo>
                      <a:lnTo>
                        <a:pt x="624" y="419"/>
                      </a:lnTo>
                      <a:lnTo>
                        <a:pt x="626" y="419"/>
                      </a:lnTo>
                      <a:lnTo>
                        <a:pt x="629" y="419"/>
                      </a:lnTo>
                      <a:lnTo>
                        <a:pt x="631" y="419"/>
                      </a:lnTo>
                      <a:lnTo>
                        <a:pt x="634" y="419"/>
                      </a:lnTo>
                      <a:lnTo>
                        <a:pt x="638" y="419"/>
                      </a:lnTo>
                      <a:lnTo>
                        <a:pt x="643" y="420"/>
                      </a:lnTo>
                      <a:lnTo>
                        <a:pt x="649" y="420"/>
                      </a:lnTo>
                      <a:lnTo>
                        <a:pt x="654" y="420"/>
                      </a:lnTo>
                      <a:lnTo>
                        <a:pt x="658" y="420"/>
                      </a:lnTo>
                      <a:lnTo>
                        <a:pt x="659" y="420"/>
                      </a:lnTo>
                      <a:lnTo>
                        <a:pt x="662" y="420"/>
                      </a:lnTo>
                      <a:lnTo>
                        <a:pt x="666" y="420"/>
                      </a:lnTo>
                      <a:lnTo>
                        <a:pt x="670" y="420"/>
                      </a:lnTo>
                      <a:lnTo>
                        <a:pt x="673" y="420"/>
                      </a:lnTo>
                      <a:lnTo>
                        <a:pt x="678" y="420"/>
                      </a:lnTo>
                      <a:lnTo>
                        <a:pt x="682" y="420"/>
                      </a:lnTo>
                      <a:lnTo>
                        <a:pt x="685" y="420"/>
                      </a:lnTo>
                      <a:lnTo>
                        <a:pt x="689" y="420"/>
                      </a:lnTo>
                      <a:lnTo>
                        <a:pt x="693" y="420"/>
                      </a:lnTo>
                      <a:lnTo>
                        <a:pt x="698" y="420"/>
                      </a:lnTo>
                      <a:lnTo>
                        <a:pt x="702" y="420"/>
                      </a:lnTo>
                      <a:lnTo>
                        <a:pt x="705" y="420"/>
                      </a:lnTo>
                      <a:lnTo>
                        <a:pt x="709" y="420"/>
                      </a:lnTo>
                      <a:lnTo>
                        <a:pt x="715" y="420"/>
                      </a:lnTo>
                      <a:lnTo>
                        <a:pt x="720" y="420"/>
                      </a:lnTo>
                      <a:lnTo>
                        <a:pt x="726" y="420"/>
                      </a:lnTo>
                      <a:lnTo>
                        <a:pt x="732" y="420"/>
                      </a:lnTo>
                      <a:lnTo>
                        <a:pt x="737" y="420"/>
                      </a:lnTo>
                      <a:lnTo>
                        <a:pt x="743" y="420"/>
                      </a:lnTo>
                      <a:lnTo>
                        <a:pt x="748" y="420"/>
                      </a:lnTo>
                      <a:lnTo>
                        <a:pt x="752" y="420"/>
                      </a:lnTo>
                      <a:lnTo>
                        <a:pt x="758" y="420"/>
                      </a:lnTo>
                      <a:lnTo>
                        <a:pt x="764" y="420"/>
                      </a:lnTo>
                      <a:lnTo>
                        <a:pt x="772" y="420"/>
                      </a:lnTo>
                      <a:lnTo>
                        <a:pt x="780" y="420"/>
                      </a:lnTo>
                      <a:lnTo>
                        <a:pt x="785" y="420"/>
                      </a:lnTo>
                      <a:lnTo>
                        <a:pt x="791" y="420"/>
                      </a:lnTo>
                      <a:lnTo>
                        <a:pt x="795" y="420"/>
                      </a:lnTo>
                      <a:lnTo>
                        <a:pt x="800" y="420"/>
                      </a:lnTo>
                      <a:lnTo>
                        <a:pt x="807" y="420"/>
                      </a:lnTo>
                      <a:lnTo>
                        <a:pt x="815" y="420"/>
                      </a:lnTo>
                      <a:lnTo>
                        <a:pt x="823" y="420"/>
                      </a:lnTo>
                      <a:lnTo>
                        <a:pt x="831" y="420"/>
                      </a:lnTo>
                      <a:lnTo>
                        <a:pt x="837" y="420"/>
                      </a:lnTo>
                      <a:lnTo>
                        <a:pt x="843" y="420"/>
                      </a:lnTo>
                      <a:lnTo>
                        <a:pt x="849" y="420"/>
                      </a:lnTo>
                      <a:lnTo>
                        <a:pt x="858" y="420"/>
                      </a:lnTo>
                      <a:lnTo>
                        <a:pt x="869" y="420"/>
                      </a:lnTo>
                      <a:lnTo>
                        <a:pt x="883" y="420"/>
                      </a:lnTo>
                      <a:lnTo>
                        <a:pt x="897" y="421"/>
                      </a:lnTo>
                      <a:lnTo>
                        <a:pt x="909" y="421"/>
                      </a:lnTo>
                      <a:lnTo>
                        <a:pt x="921" y="421"/>
                      </a:lnTo>
                      <a:lnTo>
                        <a:pt x="933" y="421"/>
                      </a:lnTo>
                      <a:lnTo>
                        <a:pt x="942" y="421"/>
                      </a:lnTo>
                      <a:lnTo>
                        <a:pt x="953" y="421"/>
                      </a:lnTo>
                      <a:lnTo>
                        <a:pt x="963" y="421"/>
                      </a:lnTo>
                      <a:lnTo>
                        <a:pt x="969" y="421"/>
                      </a:lnTo>
                      <a:lnTo>
                        <a:pt x="978" y="421"/>
                      </a:lnTo>
                      <a:lnTo>
                        <a:pt x="989" y="421"/>
                      </a:lnTo>
                      <a:lnTo>
                        <a:pt x="998" y="421"/>
                      </a:lnTo>
                      <a:lnTo>
                        <a:pt x="1005" y="421"/>
                      </a:lnTo>
                      <a:lnTo>
                        <a:pt x="1013" y="421"/>
                      </a:lnTo>
                      <a:lnTo>
                        <a:pt x="1024" y="421"/>
                      </a:lnTo>
                      <a:lnTo>
                        <a:pt x="1037" y="421"/>
                      </a:lnTo>
                      <a:lnTo>
                        <a:pt x="1045" y="421"/>
                      </a:lnTo>
                      <a:lnTo>
                        <a:pt x="1050" y="421"/>
                      </a:lnTo>
                      <a:lnTo>
                        <a:pt x="1055" y="421"/>
                      </a:lnTo>
                      <a:lnTo>
                        <a:pt x="1060" y="420"/>
                      </a:lnTo>
                      <a:lnTo>
                        <a:pt x="1067" y="420"/>
                      </a:lnTo>
                      <a:lnTo>
                        <a:pt x="1074" y="420"/>
                      </a:lnTo>
                      <a:lnTo>
                        <a:pt x="1082" y="420"/>
                      </a:lnTo>
                      <a:lnTo>
                        <a:pt x="1088" y="420"/>
                      </a:lnTo>
                      <a:lnTo>
                        <a:pt x="1096" y="420"/>
                      </a:lnTo>
                      <a:lnTo>
                        <a:pt x="1107" y="420"/>
                      </a:lnTo>
                      <a:lnTo>
                        <a:pt x="1119" y="420"/>
                      </a:lnTo>
                      <a:lnTo>
                        <a:pt x="1130" y="420"/>
                      </a:lnTo>
                      <a:lnTo>
                        <a:pt x="1138" y="420"/>
                      </a:lnTo>
                      <a:lnTo>
                        <a:pt x="1141" y="420"/>
                      </a:lnTo>
                      <a:lnTo>
                        <a:pt x="1146" y="420"/>
                      </a:lnTo>
                      <a:lnTo>
                        <a:pt x="1152" y="420"/>
                      </a:lnTo>
                      <a:lnTo>
                        <a:pt x="1158" y="420"/>
                      </a:lnTo>
                      <a:lnTo>
                        <a:pt x="1166" y="420"/>
                      </a:lnTo>
                      <a:lnTo>
                        <a:pt x="1175" y="420"/>
                      </a:lnTo>
                      <a:lnTo>
                        <a:pt x="1186" y="420"/>
                      </a:lnTo>
                      <a:lnTo>
                        <a:pt x="1196" y="420"/>
                      </a:lnTo>
                      <a:lnTo>
                        <a:pt x="1204" y="420"/>
                      </a:lnTo>
                      <a:lnTo>
                        <a:pt x="1213" y="420"/>
                      </a:lnTo>
                      <a:lnTo>
                        <a:pt x="1221" y="420"/>
                      </a:lnTo>
                      <a:lnTo>
                        <a:pt x="1228" y="420"/>
                      </a:lnTo>
                      <a:lnTo>
                        <a:pt x="1234" y="420"/>
                      </a:lnTo>
                      <a:lnTo>
                        <a:pt x="1242" y="420"/>
                      </a:lnTo>
                      <a:lnTo>
                        <a:pt x="1251" y="420"/>
                      </a:lnTo>
                      <a:lnTo>
                        <a:pt x="1259" y="420"/>
                      </a:lnTo>
                      <a:lnTo>
                        <a:pt x="1267" y="420"/>
                      </a:lnTo>
                      <a:lnTo>
                        <a:pt x="1273" y="420"/>
                      </a:lnTo>
                      <a:lnTo>
                        <a:pt x="1278" y="420"/>
                      </a:lnTo>
                      <a:lnTo>
                        <a:pt x="1284" y="420"/>
                      </a:lnTo>
                      <a:lnTo>
                        <a:pt x="1292" y="420"/>
                      </a:lnTo>
                      <a:lnTo>
                        <a:pt x="1302" y="420"/>
                      </a:lnTo>
                      <a:lnTo>
                        <a:pt x="1309" y="420"/>
                      </a:lnTo>
                      <a:lnTo>
                        <a:pt x="1314" y="420"/>
                      </a:lnTo>
                      <a:lnTo>
                        <a:pt x="1318" y="420"/>
                      </a:lnTo>
                      <a:lnTo>
                        <a:pt x="1321" y="420"/>
                      </a:lnTo>
                      <a:lnTo>
                        <a:pt x="1326" y="420"/>
                      </a:lnTo>
                      <a:lnTo>
                        <a:pt x="1332" y="420"/>
                      </a:lnTo>
                      <a:lnTo>
                        <a:pt x="1339" y="420"/>
                      </a:lnTo>
                      <a:lnTo>
                        <a:pt x="1347" y="420"/>
                      </a:lnTo>
                      <a:lnTo>
                        <a:pt x="1356" y="420"/>
                      </a:lnTo>
                      <a:lnTo>
                        <a:pt x="1362" y="420"/>
                      </a:lnTo>
                      <a:lnTo>
                        <a:pt x="1370" y="420"/>
                      </a:lnTo>
                      <a:lnTo>
                        <a:pt x="1382" y="420"/>
                      </a:lnTo>
                      <a:lnTo>
                        <a:pt x="1391" y="420"/>
                      </a:lnTo>
                      <a:lnTo>
                        <a:pt x="1396" y="419"/>
                      </a:lnTo>
                      <a:lnTo>
                        <a:pt x="1400" y="419"/>
                      </a:lnTo>
                      <a:lnTo>
                        <a:pt x="1404" y="419"/>
                      </a:lnTo>
                      <a:lnTo>
                        <a:pt x="1409" y="419"/>
                      </a:lnTo>
                      <a:lnTo>
                        <a:pt x="1416" y="419"/>
                      </a:lnTo>
                      <a:lnTo>
                        <a:pt x="1428" y="419"/>
                      </a:lnTo>
                      <a:lnTo>
                        <a:pt x="1440" y="419"/>
                      </a:lnTo>
                      <a:lnTo>
                        <a:pt x="1446" y="419"/>
                      </a:lnTo>
                      <a:lnTo>
                        <a:pt x="1453" y="419"/>
                      </a:lnTo>
                      <a:lnTo>
                        <a:pt x="1460" y="419"/>
                      </a:lnTo>
                      <a:lnTo>
                        <a:pt x="1466" y="419"/>
                      </a:lnTo>
                      <a:lnTo>
                        <a:pt x="1473" y="419"/>
                      </a:lnTo>
                      <a:lnTo>
                        <a:pt x="1479" y="419"/>
                      </a:lnTo>
                      <a:lnTo>
                        <a:pt x="1485" y="419"/>
                      </a:lnTo>
                      <a:lnTo>
                        <a:pt x="1488" y="419"/>
                      </a:lnTo>
                      <a:lnTo>
                        <a:pt x="1491" y="419"/>
                      </a:lnTo>
                      <a:lnTo>
                        <a:pt x="1496" y="419"/>
                      </a:lnTo>
                      <a:lnTo>
                        <a:pt x="1504" y="419"/>
                      </a:lnTo>
                      <a:lnTo>
                        <a:pt x="1510" y="419"/>
                      </a:lnTo>
                      <a:lnTo>
                        <a:pt x="1519" y="419"/>
                      </a:lnTo>
                      <a:lnTo>
                        <a:pt x="1526" y="419"/>
                      </a:lnTo>
                      <a:lnTo>
                        <a:pt x="1529" y="419"/>
                      </a:lnTo>
                      <a:lnTo>
                        <a:pt x="1533" y="419"/>
                      </a:lnTo>
                      <a:lnTo>
                        <a:pt x="1536" y="419"/>
                      </a:lnTo>
                      <a:lnTo>
                        <a:pt x="1540" y="419"/>
                      </a:lnTo>
                      <a:lnTo>
                        <a:pt x="1545" y="419"/>
                      </a:lnTo>
                      <a:lnTo>
                        <a:pt x="1550" y="419"/>
                      </a:lnTo>
                      <a:lnTo>
                        <a:pt x="1556" y="419"/>
                      </a:lnTo>
                      <a:lnTo>
                        <a:pt x="1563" y="419"/>
                      </a:lnTo>
                      <a:lnTo>
                        <a:pt x="1571" y="419"/>
                      </a:lnTo>
                      <a:lnTo>
                        <a:pt x="1577" y="419"/>
                      </a:lnTo>
                      <a:lnTo>
                        <a:pt x="1583" y="419"/>
                      </a:lnTo>
                      <a:lnTo>
                        <a:pt x="1589" y="419"/>
                      </a:lnTo>
                      <a:lnTo>
                        <a:pt x="1594" y="419"/>
                      </a:lnTo>
                      <a:lnTo>
                        <a:pt x="1601" y="418"/>
                      </a:lnTo>
                      <a:lnTo>
                        <a:pt x="1609" y="418"/>
                      </a:lnTo>
                      <a:lnTo>
                        <a:pt x="1614" y="418"/>
                      </a:lnTo>
                      <a:lnTo>
                        <a:pt x="1618" y="418"/>
                      </a:lnTo>
                      <a:lnTo>
                        <a:pt x="1623" y="418"/>
                      </a:lnTo>
                      <a:lnTo>
                        <a:pt x="1631" y="418"/>
                      </a:lnTo>
                      <a:lnTo>
                        <a:pt x="1639" y="418"/>
                      </a:lnTo>
                      <a:lnTo>
                        <a:pt x="1647" y="418"/>
                      </a:lnTo>
                      <a:lnTo>
                        <a:pt x="1654" y="418"/>
                      </a:lnTo>
                      <a:lnTo>
                        <a:pt x="1659" y="418"/>
                      </a:lnTo>
                      <a:lnTo>
                        <a:pt x="1667" y="418"/>
                      </a:lnTo>
                      <a:lnTo>
                        <a:pt x="1679" y="418"/>
                      </a:lnTo>
                      <a:lnTo>
                        <a:pt x="1690" y="418"/>
                      </a:lnTo>
                      <a:lnTo>
                        <a:pt x="1699" y="418"/>
                      </a:lnTo>
                      <a:lnTo>
                        <a:pt x="1703" y="418"/>
                      </a:lnTo>
                      <a:lnTo>
                        <a:pt x="1707" y="418"/>
                      </a:lnTo>
                      <a:lnTo>
                        <a:pt x="1714" y="418"/>
                      </a:lnTo>
                      <a:lnTo>
                        <a:pt x="1722" y="418"/>
                      </a:lnTo>
                      <a:lnTo>
                        <a:pt x="1731" y="418"/>
                      </a:lnTo>
                      <a:lnTo>
                        <a:pt x="1739" y="417"/>
                      </a:lnTo>
                      <a:lnTo>
                        <a:pt x="1746" y="417"/>
                      </a:lnTo>
                      <a:lnTo>
                        <a:pt x="1752" y="417"/>
                      </a:lnTo>
                      <a:lnTo>
                        <a:pt x="1760" y="417"/>
                      </a:lnTo>
                      <a:lnTo>
                        <a:pt x="1770" y="417"/>
                      </a:lnTo>
                      <a:lnTo>
                        <a:pt x="1780" y="417"/>
                      </a:lnTo>
                      <a:lnTo>
                        <a:pt x="1790" y="417"/>
                      </a:lnTo>
                      <a:lnTo>
                        <a:pt x="1799" y="417"/>
                      </a:lnTo>
                      <a:lnTo>
                        <a:pt x="1807" y="417"/>
                      </a:lnTo>
                      <a:lnTo>
                        <a:pt x="1818" y="417"/>
                      </a:lnTo>
                      <a:lnTo>
                        <a:pt x="1833" y="417"/>
                      </a:lnTo>
                      <a:lnTo>
                        <a:pt x="1844" y="417"/>
                      </a:lnTo>
                      <a:lnTo>
                        <a:pt x="1853" y="417"/>
                      </a:lnTo>
                      <a:lnTo>
                        <a:pt x="1864" y="417"/>
                      </a:lnTo>
                      <a:lnTo>
                        <a:pt x="1873" y="417"/>
                      </a:lnTo>
                      <a:lnTo>
                        <a:pt x="1879" y="417"/>
                      </a:lnTo>
                      <a:lnTo>
                        <a:pt x="1888" y="417"/>
                      </a:lnTo>
                      <a:lnTo>
                        <a:pt x="1900" y="417"/>
                      </a:lnTo>
                      <a:lnTo>
                        <a:pt x="1912" y="417"/>
                      </a:lnTo>
                      <a:lnTo>
                        <a:pt x="1923" y="417"/>
                      </a:lnTo>
                      <a:lnTo>
                        <a:pt x="1933" y="417"/>
                      </a:lnTo>
                      <a:lnTo>
                        <a:pt x="1945" y="417"/>
                      </a:lnTo>
                      <a:lnTo>
                        <a:pt x="1956" y="417"/>
                      </a:lnTo>
                      <a:lnTo>
                        <a:pt x="1963" y="417"/>
                      </a:lnTo>
                      <a:lnTo>
                        <a:pt x="1967" y="417"/>
                      </a:lnTo>
                      <a:lnTo>
                        <a:pt x="1974" y="417"/>
                      </a:lnTo>
                      <a:lnTo>
                        <a:pt x="1985" y="417"/>
                      </a:lnTo>
                      <a:lnTo>
                        <a:pt x="1996" y="417"/>
                      </a:lnTo>
                      <a:lnTo>
                        <a:pt x="2004" y="417"/>
                      </a:lnTo>
                      <a:lnTo>
                        <a:pt x="2008" y="417"/>
                      </a:lnTo>
                      <a:lnTo>
                        <a:pt x="2013" y="417"/>
                      </a:lnTo>
                      <a:lnTo>
                        <a:pt x="2016" y="417"/>
                      </a:lnTo>
                      <a:lnTo>
                        <a:pt x="2020" y="416"/>
                      </a:lnTo>
                      <a:lnTo>
                        <a:pt x="2023" y="416"/>
                      </a:lnTo>
                      <a:lnTo>
                        <a:pt x="2025" y="416"/>
                      </a:lnTo>
                      <a:lnTo>
                        <a:pt x="2027" y="416"/>
                      </a:lnTo>
                      <a:lnTo>
                        <a:pt x="2031" y="416"/>
                      </a:lnTo>
                      <a:lnTo>
                        <a:pt x="2036" y="416"/>
                      </a:lnTo>
                      <a:lnTo>
                        <a:pt x="2041" y="416"/>
                      </a:lnTo>
                      <a:lnTo>
                        <a:pt x="2047" y="416"/>
                      </a:lnTo>
                      <a:lnTo>
                        <a:pt x="2052" y="416"/>
                      </a:lnTo>
                      <a:lnTo>
                        <a:pt x="2058" y="416"/>
                      </a:lnTo>
                    </a:path>
                  </a:pathLst>
                </a:cu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9" name="Freeform 150"/>
                <p:cNvSpPr>
                  <a:spLocks/>
                </p:cNvSpPr>
                <p:nvPr/>
              </p:nvSpPr>
              <p:spPr bwMode="auto">
                <a:xfrm>
                  <a:off x="9129713" y="2897188"/>
                  <a:ext cx="1939925" cy="65088"/>
                </a:xfrm>
                <a:custGeom>
                  <a:avLst/>
                  <a:gdLst>
                    <a:gd name="T0" fmla="*/ 75 w 1222"/>
                    <a:gd name="T1" fmla="*/ 23 h 41"/>
                    <a:gd name="T2" fmla="*/ 163 w 1222"/>
                    <a:gd name="T3" fmla="*/ 23 h 41"/>
                    <a:gd name="T4" fmla="*/ 232 w 1222"/>
                    <a:gd name="T5" fmla="*/ 23 h 41"/>
                    <a:gd name="T6" fmla="*/ 293 w 1222"/>
                    <a:gd name="T7" fmla="*/ 23 h 41"/>
                    <a:gd name="T8" fmla="*/ 342 w 1222"/>
                    <a:gd name="T9" fmla="*/ 23 h 41"/>
                    <a:gd name="T10" fmla="*/ 387 w 1222"/>
                    <a:gd name="T11" fmla="*/ 22 h 41"/>
                    <a:gd name="T12" fmla="*/ 430 w 1222"/>
                    <a:gd name="T13" fmla="*/ 22 h 41"/>
                    <a:gd name="T14" fmla="*/ 485 w 1222"/>
                    <a:gd name="T15" fmla="*/ 21 h 41"/>
                    <a:gd name="T16" fmla="*/ 529 w 1222"/>
                    <a:gd name="T17" fmla="*/ 21 h 41"/>
                    <a:gd name="T18" fmla="*/ 575 w 1222"/>
                    <a:gd name="T19" fmla="*/ 21 h 41"/>
                    <a:gd name="T20" fmla="*/ 615 w 1222"/>
                    <a:gd name="T21" fmla="*/ 20 h 41"/>
                    <a:gd name="T22" fmla="*/ 660 w 1222"/>
                    <a:gd name="T23" fmla="*/ 20 h 41"/>
                    <a:gd name="T24" fmla="*/ 701 w 1222"/>
                    <a:gd name="T25" fmla="*/ 20 h 41"/>
                    <a:gd name="T26" fmla="*/ 745 w 1222"/>
                    <a:gd name="T27" fmla="*/ 20 h 41"/>
                    <a:gd name="T28" fmla="*/ 794 w 1222"/>
                    <a:gd name="T29" fmla="*/ 20 h 41"/>
                    <a:gd name="T30" fmla="*/ 821 w 1222"/>
                    <a:gd name="T31" fmla="*/ 19 h 41"/>
                    <a:gd name="T32" fmla="*/ 860 w 1222"/>
                    <a:gd name="T33" fmla="*/ 18 h 41"/>
                    <a:gd name="T34" fmla="*/ 881 w 1222"/>
                    <a:gd name="T35" fmla="*/ 17 h 41"/>
                    <a:gd name="T36" fmla="*/ 897 w 1222"/>
                    <a:gd name="T37" fmla="*/ 17 h 41"/>
                    <a:gd name="T38" fmla="*/ 905 w 1222"/>
                    <a:gd name="T39" fmla="*/ 16 h 41"/>
                    <a:gd name="T40" fmla="*/ 912 w 1222"/>
                    <a:gd name="T41" fmla="*/ 15 h 41"/>
                    <a:gd name="T42" fmla="*/ 922 w 1222"/>
                    <a:gd name="T43" fmla="*/ 14 h 41"/>
                    <a:gd name="T44" fmla="*/ 932 w 1222"/>
                    <a:gd name="T45" fmla="*/ 11 h 41"/>
                    <a:gd name="T46" fmla="*/ 945 w 1222"/>
                    <a:gd name="T47" fmla="*/ 8 h 41"/>
                    <a:gd name="T48" fmla="*/ 947 w 1222"/>
                    <a:gd name="T49" fmla="*/ 7 h 41"/>
                    <a:gd name="T50" fmla="*/ 960 w 1222"/>
                    <a:gd name="T51" fmla="*/ 4 h 41"/>
                    <a:gd name="T52" fmla="*/ 972 w 1222"/>
                    <a:gd name="T53" fmla="*/ 1 h 41"/>
                    <a:gd name="T54" fmla="*/ 982 w 1222"/>
                    <a:gd name="T55" fmla="*/ 0 h 41"/>
                    <a:gd name="T56" fmla="*/ 989 w 1222"/>
                    <a:gd name="T57" fmla="*/ 1 h 41"/>
                    <a:gd name="T58" fmla="*/ 994 w 1222"/>
                    <a:gd name="T59" fmla="*/ 1 h 41"/>
                    <a:gd name="T60" fmla="*/ 1005 w 1222"/>
                    <a:gd name="T61" fmla="*/ 4 h 41"/>
                    <a:gd name="T62" fmla="*/ 1020 w 1222"/>
                    <a:gd name="T63" fmla="*/ 8 h 41"/>
                    <a:gd name="T64" fmla="*/ 1034 w 1222"/>
                    <a:gd name="T65" fmla="*/ 13 h 41"/>
                    <a:gd name="T66" fmla="*/ 1036 w 1222"/>
                    <a:gd name="T67" fmla="*/ 14 h 41"/>
                    <a:gd name="T68" fmla="*/ 1049 w 1222"/>
                    <a:gd name="T69" fmla="*/ 19 h 41"/>
                    <a:gd name="T70" fmla="*/ 1063 w 1222"/>
                    <a:gd name="T71" fmla="*/ 23 h 41"/>
                    <a:gd name="T72" fmla="*/ 1075 w 1222"/>
                    <a:gd name="T73" fmla="*/ 27 h 41"/>
                    <a:gd name="T74" fmla="*/ 1079 w 1222"/>
                    <a:gd name="T75" fmla="*/ 28 h 41"/>
                    <a:gd name="T76" fmla="*/ 1082 w 1222"/>
                    <a:gd name="T77" fmla="*/ 28 h 41"/>
                    <a:gd name="T78" fmla="*/ 1092 w 1222"/>
                    <a:gd name="T79" fmla="*/ 30 h 41"/>
                    <a:gd name="T80" fmla="*/ 1103 w 1222"/>
                    <a:gd name="T81" fmla="*/ 33 h 41"/>
                    <a:gd name="T82" fmla="*/ 1113 w 1222"/>
                    <a:gd name="T83" fmla="*/ 34 h 41"/>
                    <a:gd name="T84" fmla="*/ 1120 w 1222"/>
                    <a:gd name="T85" fmla="*/ 35 h 41"/>
                    <a:gd name="T86" fmla="*/ 1124 w 1222"/>
                    <a:gd name="T87" fmla="*/ 35 h 41"/>
                    <a:gd name="T88" fmla="*/ 1129 w 1222"/>
                    <a:gd name="T89" fmla="*/ 36 h 41"/>
                    <a:gd name="T90" fmla="*/ 1140 w 1222"/>
                    <a:gd name="T91" fmla="*/ 37 h 41"/>
                    <a:gd name="T92" fmla="*/ 1150 w 1222"/>
                    <a:gd name="T93" fmla="*/ 38 h 41"/>
                    <a:gd name="T94" fmla="*/ 1159 w 1222"/>
                    <a:gd name="T95" fmla="*/ 39 h 41"/>
                    <a:gd name="T96" fmla="*/ 1166 w 1222"/>
                    <a:gd name="T97" fmla="*/ 39 h 41"/>
                    <a:gd name="T98" fmla="*/ 1172 w 1222"/>
                    <a:gd name="T99" fmla="*/ 39 h 41"/>
                    <a:gd name="T100" fmla="*/ 1185 w 1222"/>
                    <a:gd name="T101" fmla="*/ 40 h 41"/>
                    <a:gd name="T102" fmla="*/ 1198 w 1222"/>
                    <a:gd name="T103" fmla="*/ 40 h 41"/>
                    <a:gd name="T104" fmla="*/ 1212 w 1222"/>
                    <a:gd name="T105" fmla="*/ 41 h 4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</a:cxnLst>
                  <a:rect l="0" t="0" r="r" b="b"/>
                  <a:pathLst>
                    <a:path w="1222" h="41">
                      <a:moveTo>
                        <a:pt x="0" y="23"/>
                      </a:moveTo>
                      <a:lnTo>
                        <a:pt x="11" y="23"/>
                      </a:lnTo>
                      <a:lnTo>
                        <a:pt x="27" y="23"/>
                      </a:lnTo>
                      <a:lnTo>
                        <a:pt x="43" y="23"/>
                      </a:lnTo>
                      <a:lnTo>
                        <a:pt x="59" y="23"/>
                      </a:lnTo>
                      <a:lnTo>
                        <a:pt x="75" y="23"/>
                      </a:lnTo>
                      <a:lnTo>
                        <a:pt x="92" y="23"/>
                      </a:lnTo>
                      <a:lnTo>
                        <a:pt x="109" y="23"/>
                      </a:lnTo>
                      <a:lnTo>
                        <a:pt x="125" y="23"/>
                      </a:lnTo>
                      <a:lnTo>
                        <a:pt x="138" y="23"/>
                      </a:lnTo>
                      <a:lnTo>
                        <a:pt x="150" y="23"/>
                      </a:lnTo>
                      <a:lnTo>
                        <a:pt x="163" y="23"/>
                      </a:lnTo>
                      <a:lnTo>
                        <a:pt x="174" y="23"/>
                      </a:lnTo>
                      <a:lnTo>
                        <a:pt x="183" y="23"/>
                      </a:lnTo>
                      <a:lnTo>
                        <a:pt x="191" y="23"/>
                      </a:lnTo>
                      <a:lnTo>
                        <a:pt x="200" y="23"/>
                      </a:lnTo>
                      <a:lnTo>
                        <a:pt x="216" y="23"/>
                      </a:lnTo>
                      <a:lnTo>
                        <a:pt x="232" y="23"/>
                      </a:lnTo>
                      <a:lnTo>
                        <a:pt x="244" y="23"/>
                      </a:lnTo>
                      <a:lnTo>
                        <a:pt x="254" y="23"/>
                      </a:lnTo>
                      <a:lnTo>
                        <a:pt x="264" y="23"/>
                      </a:lnTo>
                      <a:lnTo>
                        <a:pt x="274" y="23"/>
                      </a:lnTo>
                      <a:lnTo>
                        <a:pt x="285" y="23"/>
                      </a:lnTo>
                      <a:lnTo>
                        <a:pt x="293" y="23"/>
                      </a:lnTo>
                      <a:lnTo>
                        <a:pt x="298" y="23"/>
                      </a:lnTo>
                      <a:lnTo>
                        <a:pt x="305" y="23"/>
                      </a:lnTo>
                      <a:lnTo>
                        <a:pt x="317" y="23"/>
                      </a:lnTo>
                      <a:lnTo>
                        <a:pt x="330" y="23"/>
                      </a:lnTo>
                      <a:lnTo>
                        <a:pt x="338" y="23"/>
                      </a:lnTo>
                      <a:lnTo>
                        <a:pt x="342" y="23"/>
                      </a:lnTo>
                      <a:lnTo>
                        <a:pt x="347" y="22"/>
                      </a:lnTo>
                      <a:lnTo>
                        <a:pt x="356" y="22"/>
                      </a:lnTo>
                      <a:lnTo>
                        <a:pt x="366" y="22"/>
                      </a:lnTo>
                      <a:lnTo>
                        <a:pt x="376" y="22"/>
                      </a:lnTo>
                      <a:lnTo>
                        <a:pt x="383" y="22"/>
                      </a:lnTo>
                      <a:lnTo>
                        <a:pt x="387" y="22"/>
                      </a:lnTo>
                      <a:lnTo>
                        <a:pt x="392" y="22"/>
                      </a:lnTo>
                      <a:lnTo>
                        <a:pt x="399" y="22"/>
                      </a:lnTo>
                      <a:lnTo>
                        <a:pt x="411" y="22"/>
                      </a:lnTo>
                      <a:lnTo>
                        <a:pt x="421" y="22"/>
                      </a:lnTo>
                      <a:lnTo>
                        <a:pt x="427" y="22"/>
                      </a:lnTo>
                      <a:lnTo>
                        <a:pt x="430" y="22"/>
                      </a:lnTo>
                      <a:lnTo>
                        <a:pt x="436" y="22"/>
                      </a:lnTo>
                      <a:lnTo>
                        <a:pt x="447" y="22"/>
                      </a:lnTo>
                      <a:lnTo>
                        <a:pt x="459" y="22"/>
                      </a:lnTo>
                      <a:lnTo>
                        <a:pt x="470" y="21"/>
                      </a:lnTo>
                      <a:lnTo>
                        <a:pt x="477" y="21"/>
                      </a:lnTo>
                      <a:lnTo>
                        <a:pt x="485" y="21"/>
                      </a:lnTo>
                      <a:lnTo>
                        <a:pt x="494" y="21"/>
                      </a:lnTo>
                      <a:lnTo>
                        <a:pt x="503" y="21"/>
                      </a:lnTo>
                      <a:lnTo>
                        <a:pt x="510" y="21"/>
                      </a:lnTo>
                      <a:lnTo>
                        <a:pt x="516" y="21"/>
                      </a:lnTo>
                      <a:lnTo>
                        <a:pt x="521" y="21"/>
                      </a:lnTo>
                      <a:lnTo>
                        <a:pt x="529" y="21"/>
                      </a:lnTo>
                      <a:lnTo>
                        <a:pt x="539" y="21"/>
                      </a:lnTo>
                      <a:lnTo>
                        <a:pt x="549" y="21"/>
                      </a:lnTo>
                      <a:lnTo>
                        <a:pt x="556" y="21"/>
                      </a:lnTo>
                      <a:lnTo>
                        <a:pt x="561" y="21"/>
                      </a:lnTo>
                      <a:lnTo>
                        <a:pt x="567" y="21"/>
                      </a:lnTo>
                      <a:lnTo>
                        <a:pt x="575" y="21"/>
                      </a:lnTo>
                      <a:lnTo>
                        <a:pt x="584" y="21"/>
                      </a:lnTo>
                      <a:lnTo>
                        <a:pt x="593" y="21"/>
                      </a:lnTo>
                      <a:lnTo>
                        <a:pt x="599" y="20"/>
                      </a:lnTo>
                      <a:lnTo>
                        <a:pt x="602" y="20"/>
                      </a:lnTo>
                      <a:lnTo>
                        <a:pt x="608" y="20"/>
                      </a:lnTo>
                      <a:lnTo>
                        <a:pt x="615" y="20"/>
                      </a:lnTo>
                      <a:lnTo>
                        <a:pt x="624" y="20"/>
                      </a:lnTo>
                      <a:lnTo>
                        <a:pt x="634" y="20"/>
                      </a:lnTo>
                      <a:lnTo>
                        <a:pt x="641" y="20"/>
                      </a:lnTo>
                      <a:lnTo>
                        <a:pt x="645" y="20"/>
                      </a:lnTo>
                      <a:lnTo>
                        <a:pt x="651" y="20"/>
                      </a:lnTo>
                      <a:lnTo>
                        <a:pt x="660" y="20"/>
                      </a:lnTo>
                      <a:lnTo>
                        <a:pt x="670" y="20"/>
                      </a:lnTo>
                      <a:lnTo>
                        <a:pt x="680" y="20"/>
                      </a:lnTo>
                      <a:lnTo>
                        <a:pt x="686" y="20"/>
                      </a:lnTo>
                      <a:lnTo>
                        <a:pt x="689" y="20"/>
                      </a:lnTo>
                      <a:lnTo>
                        <a:pt x="693" y="20"/>
                      </a:lnTo>
                      <a:lnTo>
                        <a:pt x="701" y="20"/>
                      </a:lnTo>
                      <a:lnTo>
                        <a:pt x="711" y="20"/>
                      </a:lnTo>
                      <a:lnTo>
                        <a:pt x="720" y="20"/>
                      </a:lnTo>
                      <a:lnTo>
                        <a:pt x="728" y="20"/>
                      </a:lnTo>
                      <a:lnTo>
                        <a:pt x="733" y="20"/>
                      </a:lnTo>
                      <a:lnTo>
                        <a:pt x="738" y="20"/>
                      </a:lnTo>
                      <a:lnTo>
                        <a:pt x="745" y="20"/>
                      </a:lnTo>
                      <a:lnTo>
                        <a:pt x="753" y="20"/>
                      </a:lnTo>
                      <a:lnTo>
                        <a:pt x="762" y="20"/>
                      </a:lnTo>
                      <a:lnTo>
                        <a:pt x="771" y="20"/>
                      </a:lnTo>
                      <a:lnTo>
                        <a:pt x="780" y="20"/>
                      </a:lnTo>
                      <a:lnTo>
                        <a:pt x="788" y="20"/>
                      </a:lnTo>
                      <a:lnTo>
                        <a:pt x="794" y="20"/>
                      </a:lnTo>
                      <a:lnTo>
                        <a:pt x="799" y="20"/>
                      </a:lnTo>
                      <a:lnTo>
                        <a:pt x="804" y="19"/>
                      </a:lnTo>
                      <a:lnTo>
                        <a:pt x="810" y="19"/>
                      </a:lnTo>
                      <a:lnTo>
                        <a:pt x="815" y="19"/>
                      </a:lnTo>
                      <a:lnTo>
                        <a:pt x="818" y="19"/>
                      </a:lnTo>
                      <a:lnTo>
                        <a:pt x="821" y="19"/>
                      </a:lnTo>
                      <a:lnTo>
                        <a:pt x="825" y="19"/>
                      </a:lnTo>
                      <a:lnTo>
                        <a:pt x="831" y="19"/>
                      </a:lnTo>
                      <a:lnTo>
                        <a:pt x="837" y="19"/>
                      </a:lnTo>
                      <a:lnTo>
                        <a:pt x="845" y="19"/>
                      </a:lnTo>
                      <a:lnTo>
                        <a:pt x="854" y="18"/>
                      </a:lnTo>
                      <a:lnTo>
                        <a:pt x="860" y="18"/>
                      </a:lnTo>
                      <a:lnTo>
                        <a:pt x="862" y="18"/>
                      </a:lnTo>
                      <a:lnTo>
                        <a:pt x="864" y="18"/>
                      </a:lnTo>
                      <a:lnTo>
                        <a:pt x="867" y="18"/>
                      </a:lnTo>
                      <a:lnTo>
                        <a:pt x="872" y="18"/>
                      </a:lnTo>
                      <a:lnTo>
                        <a:pt x="877" y="18"/>
                      </a:lnTo>
                      <a:lnTo>
                        <a:pt x="881" y="17"/>
                      </a:lnTo>
                      <a:lnTo>
                        <a:pt x="884" y="17"/>
                      </a:lnTo>
                      <a:lnTo>
                        <a:pt x="887" y="17"/>
                      </a:lnTo>
                      <a:lnTo>
                        <a:pt x="890" y="17"/>
                      </a:lnTo>
                      <a:lnTo>
                        <a:pt x="893" y="17"/>
                      </a:lnTo>
                      <a:lnTo>
                        <a:pt x="895" y="17"/>
                      </a:lnTo>
                      <a:lnTo>
                        <a:pt x="897" y="17"/>
                      </a:lnTo>
                      <a:lnTo>
                        <a:pt x="900" y="17"/>
                      </a:lnTo>
                      <a:lnTo>
                        <a:pt x="901" y="17"/>
                      </a:lnTo>
                      <a:lnTo>
                        <a:pt x="903" y="16"/>
                      </a:lnTo>
                      <a:lnTo>
                        <a:pt x="904" y="16"/>
                      </a:lnTo>
                      <a:lnTo>
                        <a:pt x="904" y="16"/>
                      </a:lnTo>
                      <a:lnTo>
                        <a:pt x="905" y="16"/>
                      </a:lnTo>
                      <a:lnTo>
                        <a:pt x="906" y="16"/>
                      </a:lnTo>
                      <a:lnTo>
                        <a:pt x="906" y="16"/>
                      </a:lnTo>
                      <a:lnTo>
                        <a:pt x="907" y="16"/>
                      </a:lnTo>
                      <a:lnTo>
                        <a:pt x="908" y="16"/>
                      </a:lnTo>
                      <a:lnTo>
                        <a:pt x="910" y="16"/>
                      </a:lnTo>
                      <a:lnTo>
                        <a:pt x="912" y="15"/>
                      </a:lnTo>
                      <a:lnTo>
                        <a:pt x="914" y="15"/>
                      </a:lnTo>
                      <a:lnTo>
                        <a:pt x="916" y="15"/>
                      </a:lnTo>
                      <a:lnTo>
                        <a:pt x="917" y="15"/>
                      </a:lnTo>
                      <a:lnTo>
                        <a:pt x="919" y="14"/>
                      </a:lnTo>
                      <a:lnTo>
                        <a:pt x="921" y="14"/>
                      </a:lnTo>
                      <a:lnTo>
                        <a:pt x="922" y="14"/>
                      </a:lnTo>
                      <a:lnTo>
                        <a:pt x="924" y="13"/>
                      </a:lnTo>
                      <a:lnTo>
                        <a:pt x="925" y="13"/>
                      </a:lnTo>
                      <a:lnTo>
                        <a:pt x="927" y="13"/>
                      </a:lnTo>
                      <a:lnTo>
                        <a:pt x="929" y="12"/>
                      </a:lnTo>
                      <a:lnTo>
                        <a:pt x="930" y="12"/>
                      </a:lnTo>
                      <a:lnTo>
                        <a:pt x="932" y="11"/>
                      </a:lnTo>
                      <a:lnTo>
                        <a:pt x="934" y="11"/>
                      </a:lnTo>
                      <a:lnTo>
                        <a:pt x="936" y="10"/>
                      </a:lnTo>
                      <a:lnTo>
                        <a:pt x="939" y="10"/>
                      </a:lnTo>
                      <a:lnTo>
                        <a:pt x="941" y="9"/>
                      </a:lnTo>
                      <a:lnTo>
                        <a:pt x="944" y="8"/>
                      </a:lnTo>
                      <a:lnTo>
                        <a:pt x="945" y="8"/>
                      </a:lnTo>
                      <a:lnTo>
                        <a:pt x="946" y="7"/>
                      </a:lnTo>
                      <a:lnTo>
                        <a:pt x="946" y="7"/>
                      </a:lnTo>
                      <a:lnTo>
                        <a:pt x="947" y="7"/>
                      </a:lnTo>
                      <a:lnTo>
                        <a:pt x="947" y="7"/>
                      </a:lnTo>
                      <a:lnTo>
                        <a:pt x="947" y="7"/>
                      </a:lnTo>
                      <a:lnTo>
                        <a:pt x="947" y="7"/>
                      </a:lnTo>
                      <a:lnTo>
                        <a:pt x="949" y="7"/>
                      </a:lnTo>
                      <a:lnTo>
                        <a:pt x="951" y="6"/>
                      </a:lnTo>
                      <a:lnTo>
                        <a:pt x="953" y="5"/>
                      </a:lnTo>
                      <a:lnTo>
                        <a:pt x="955" y="5"/>
                      </a:lnTo>
                      <a:lnTo>
                        <a:pt x="957" y="4"/>
                      </a:lnTo>
                      <a:lnTo>
                        <a:pt x="960" y="4"/>
                      </a:lnTo>
                      <a:lnTo>
                        <a:pt x="962" y="3"/>
                      </a:lnTo>
                      <a:lnTo>
                        <a:pt x="964" y="2"/>
                      </a:lnTo>
                      <a:lnTo>
                        <a:pt x="966" y="2"/>
                      </a:lnTo>
                      <a:lnTo>
                        <a:pt x="968" y="2"/>
                      </a:lnTo>
                      <a:lnTo>
                        <a:pt x="970" y="1"/>
                      </a:lnTo>
                      <a:lnTo>
                        <a:pt x="972" y="1"/>
                      </a:lnTo>
                      <a:lnTo>
                        <a:pt x="973" y="1"/>
                      </a:lnTo>
                      <a:lnTo>
                        <a:pt x="975" y="1"/>
                      </a:lnTo>
                      <a:lnTo>
                        <a:pt x="977" y="1"/>
                      </a:lnTo>
                      <a:lnTo>
                        <a:pt x="979" y="0"/>
                      </a:lnTo>
                      <a:lnTo>
                        <a:pt x="980" y="0"/>
                      </a:lnTo>
                      <a:lnTo>
                        <a:pt x="982" y="0"/>
                      </a:lnTo>
                      <a:lnTo>
                        <a:pt x="983" y="0"/>
                      </a:lnTo>
                      <a:lnTo>
                        <a:pt x="985" y="0"/>
                      </a:lnTo>
                      <a:lnTo>
                        <a:pt x="987" y="0"/>
                      </a:lnTo>
                      <a:lnTo>
                        <a:pt x="988" y="0"/>
                      </a:lnTo>
                      <a:lnTo>
                        <a:pt x="989" y="1"/>
                      </a:lnTo>
                      <a:lnTo>
                        <a:pt x="989" y="1"/>
                      </a:lnTo>
                      <a:lnTo>
                        <a:pt x="990" y="1"/>
                      </a:lnTo>
                      <a:lnTo>
                        <a:pt x="991" y="1"/>
                      </a:lnTo>
                      <a:lnTo>
                        <a:pt x="991" y="1"/>
                      </a:lnTo>
                      <a:lnTo>
                        <a:pt x="992" y="1"/>
                      </a:lnTo>
                      <a:lnTo>
                        <a:pt x="993" y="1"/>
                      </a:lnTo>
                      <a:lnTo>
                        <a:pt x="994" y="1"/>
                      </a:lnTo>
                      <a:lnTo>
                        <a:pt x="996" y="2"/>
                      </a:lnTo>
                      <a:lnTo>
                        <a:pt x="998" y="2"/>
                      </a:lnTo>
                      <a:lnTo>
                        <a:pt x="1000" y="2"/>
                      </a:lnTo>
                      <a:lnTo>
                        <a:pt x="1002" y="3"/>
                      </a:lnTo>
                      <a:lnTo>
                        <a:pt x="1003" y="3"/>
                      </a:lnTo>
                      <a:lnTo>
                        <a:pt x="1005" y="4"/>
                      </a:lnTo>
                      <a:lnTo>
                        <a:pt x="1008" y="4"/>
                      </a:lnTo>
                      <a:lnTo>
                        <a:pt x="1010" y="5"/>
                      </a:lnTo>
                      <a:lnTo>
                        <a:pt x="1012" y="6"/>
                      </a:lnTo>
                      <a:lnTo>
                        <a:pt x="1015" y="6"/>
                      </a:lnTo>
                      <a:lnTo>
                        <a:pt x="1017" y="7"/>
                      </a:lnTo>
                      <a:lnTo>
                        <a:pt x="1020" y="8"/>
                      </a:lnTo>
                      <a:lnTo>
                        <a:pt x="1024" y="10"/>
                      </a:lnTo>
                      <a:lnTo>
                        <a:pt x="1027" y="11"/>
                      </a:lnTo>
                      <a:lnTo>
                        <a:pt x="1030" y="12"/>
                      </a:lnTo>
                      <a:lnTo>
                        <a:pt x="1033" y="13"/>
                      </a:lnTo>
                      <a:lnTo>
                        <a:pt x="1033" y="13"/>
                      </a:lnTo>
                      <a:lnTo>
                        <a:pt x="1034" y="13"/>
                      </a:lnTo>
                      <a:lnTo>
                        <a:pt x="1034" y="14"/>
                      </a:lnTo>
                      <a:lnTo>
                        <a:pt x="1035" y="14"/>
                      </a:lnTo>
                      <a:lnTo>
                        <a:pt x="1035" y="14"/>
                      </a:lnTo>
                      <a:lnTo>
                        <a:pt x="1036" y="14"/>
                      </a:lnTo>
                      <a:lnTo>
                        <a:pt x="1036" y="14"/>
                      </a:lnTo>
                      <a:lnTo>
                        <a:pt x="1036" y="14"/>
                      </a:lnTo>
                      <a:lnTo>
                        <a:pt x="1037" y="14"/>
                      </a:lnTo>
                      <a:lnTo>
                        <a:pt x="1038" y="15"/>
                      </a:lnTo>
                      <a:lnTo>
                        <a:pt x="1042" y="16"/>
                      </a:lnTo>
                      <a:lnTo>
                        <a:pt x="1044" y="17"/>
                      </a:lnTo>
                      <a:lnTo>
                        <a:pt x="1047" y="18"/>
                      </a:lnTo>
                      <a:lnTo>
                        <a:pt x="1049" y="19"/>
                      </a:lnTo>
                      <a:lnTo>
                        <a:pt x="1052" y="20"/>
                      </a:lnTo>
                      <a:lnTo>
                        <a:pt x="1054" y="20"/>
                      </a:lnTo>
                      <a:lnTo>
                        <a:pt x="1056" y="21"/>
                      </a:lnTo>
                      <a:lnTo>
                        <a:pt x="1059" y="22"/>
                      </a:lnTo>
                      <a:lnTo>
                        <a:pt x="1061" y="23"/>
                      </a:lnTo>
                      <a:lnTo>
                        <a:pt x="1063" y="23"/>
                      </a:lnTo>
                      <a:lnTo>
                        <a:pt x="1066" y="24"/>
                      </a:lnTo>
                      <a:lnTo>
                        <a:pt x="1068" y="25"/>
                      </a:lnTo>
                      <a:lnTo>
                        <a:pt x="1070" y="25"/>
                      </a:lnTo>
                      <a:lnTo>
                        <a:pt x="1072" y="26"/>
                      </a:lnTo>
                      <a:lnTo>
                        <a:pt x="1074" y="26"/>
                      </a:lnTo>
                      <a:lnTo>
                        <a:pt x="1075" y="27"/>
                      </a:lnTo>
                      <a:lnTo>
                        <a:pt x="1076" y="27"/>
                      </a:lnTo>
                      <a:lnTo>
                        <a:pt x="1077" y="27"/>
                      </a:lnTo>
                      <a:lnTo>
                        <a:pt x="1078" y="27"/>
                      </a:lnTo>
                      <a:lnTo>
                        <a:pt x="1078" y="28"/>
                      </a:lnTo>
                      <a:lnTo>
                        <a:pt x="1079" y="28"/>
                      </a:lnTo>
                      <a:lnTo>
                        <a:pt x="1079" y="28"/>
                      </a:lnTo>
                      <a:lnTo>
                        <a:pt x="1080" y="28"/>
                      </a:lnTo>
                      <a:lnTo>
                        <a:pt x="1080" y="28"/>
                      </a:lnTo>
                      <a:lnTo>
                        <a:pt x="1081" y="28"/>
                      </a:lnTo>
                      <a:lnTo>
                        <a:pt x="1081" y="28"/>
                      </a:lnTo>
                      <a:lnTo>
                        <a:pt x="1081" y="28"/>
                      </a:lnTo>
                      <a:lnTo>
                        <a:pt x="1082" y="28"/>
                      </a:lnTo>
                      <a:lnTo>
                        <a:pt x="1084" y="29"/>
                      </a:lnTo>
                      <a:lnTo>
                        <a:pt x="1085" y="29"/>
                      </a:lnTo>
                      <a:lnTo>
                        <a:pt x="1087" y="30"/>
                      </a:lnTo>
                      <a:lnTo>
                        <a:pt x="1089" y="30"/>
                      </a:lnTo>
                      <a:lnTo>
                        <a:pt x="1090" y="30"/>
                      </a:lnTo>
                      <a:lnTo>
                        <a:pt x="1092" y="30"/>
                      </a:lnTo>
                      <a:lnTo>
                        <a:pt x="1094" y="31"/>
                      </a:lnTo>
                      <a:lnTo>
                        <a:pt x="1095" y="31"/>
                      </a:lnTo>
                      <a:lnTo>
                        <a:pt x="1097" y="32"/>
                      </a:lnTo>
                      <a:lnTo>
                        <a:pt x="1099" y="32"/>
                      </a:lnTo>
                      <a:lnTo>
                        <a:pt x="1101" y="32"/>
                      </a:lnTo>
                      <a:lnTo>
                        <a:pt x="1103" y="33"/>
                      </a:lnTo>
                      <a:lnTo>
                        <a:pt x="1104" y="33"/>
                      </a:lnTo>
                      <a:lnTo>
                        <a:pt x="1106" y="33"/>
                      </a:lnTo>
                      <a:lnTo>
                        <a:pt x="1108" y="33"/>
                      </a:lnTo>
                      <a:lnTo>
                        <a:pt x="1110" y="34"/>
                      </a:lnTo>
                      <a:lnTo>
                        <a:pt x="1112" y="34"/>
                      </a:lnTo>
                      <a:lnTo>
                        <a:pt x="1113" y="34"/>
                      </a:lnTo>
                      <a:lnTo>
                        <a:pt x="1114" y="34"/>
                      </a:lnTo>
                      <a:lnTo>
                        <a:pt x="1115" y="34"/>
                      </a:lnTo>
                      <a:lnTo>
                        <a:pt x="1117" y="35"/>
                      </a:lnTo>
                      <a:lnTo>
                        <a:pt x="1118" y="35"/>
                      </a:lnTo>
                      <a:lnTo>
                        <a:pt x="1120" y="35"/>
                      </a:lnTo>
                      <a:lnTo>
                        <a:pt x="1120" y="35"/>
                      </a:lnTo>
                      <a:lnTo>
                        <a:pt x="1121" y="35"/>
                      </a:lnTo>
                      <a:lnTo>
                        <a:pt x="1122" y="35"/>
                      </a:lnTo>
                      <a:lnTo>
                        <a:pt x="1122" y="35"/>
                      </a:lnTo>
                      <a:lnTo>
                        <a:pt x="1123" y="35"/>
                      </a:lnTo>
                      <a:lnTo>
                        <a:pt x="1124" y="35"/>
                      </a:lnTo>
                      <a:lnTo>
                        <a:pt x="1124" y="35"/>
                      </a:lnTo>
                      <a:lnTo>
                        <a:pt x="1125" y="35"/>
                      </a:lnTo>
                      <a:lnTo>
                        <a:pt x="1125" y="36"/>
                      </a:lnTo>
                      <a:lnTo>
                        <a:pt x="1125" y="36"/>
                      </a:lnTo>
                      <a:lnTo>
                        <a:pt x="1126" y="36"/>
                      </a:lnTo>
                      <a:lnTo>
                        <a:pt x="1128" y="36"/>
                      </a:lnTo>
                      <a:lnTo>
                        <a:pt x="1129" y="36"/>
                      </a:lnTo>
                      <a:lnTo>
                        <a:pt x="1131" y="36"/>
                      </a:lnTo>
                      <a:lnTo>
                        <a:pt x="1133" y="36"/>
                      </a:lnTo>
                      <a:lnTo>
                        <a:pt x="1135" y="37"/>
                      </a:lnTo>
                      <a:lnTo>
                        <a:pt x="1136" y="37"/>
                      </a:lnTo>
                      <a:lnTo>
                        <a:pt x="1138" y="37"/>
                      </a:lnTo>
                      <a:lnTo>
                        <a:pt x="1140" y="37"/>
                      </a:lnTo>
                      <a:lnTo>
                        <a:pt x="1142" y="37"/>
                      </a:lnTo>
                      <a:lnTo>
                        <a:pt x="1143" y="38"/>
                      </a:lnTo>
                      <a:lnTo>
                        <a:pt x="1145" y="38"/>
                      </a:lnTo>
                      <a:lnTo>
                        <a:pt x="1147" y="38"/>
                      </a:lnTo>
                      <a:lnTo>
                        <a:pt x="1148" y="38"/>
                      </a:lnTo>
                      <a:lnTo>
                        <a:pt x="1150" y="38"/>
                      </a:lnTo>
                      <a:lnTo>
                        <a:pt x="1151" y="38"/>
                      </a:lnTo>
                      <a:lnTo>
                        <a:pt x="1153" y="38"/>
                      </a:lnTo>
                      <a:lnTo>
                        <a:pt x="1155" y="38"/>
                      </a:lnTo>
                      <a:lnTo>
                        <a:pt x="1156" y="38"/>
                      </a:lnTo>
                      <a:lnTo>
                        <a:pt x="1157" y="38"/>
                      </a:lnTo>
                      <a:lnTo>
                        <a:pt x="1159" y="39"/>
                      </a:lnTo>
                      <a:lnTo>
                        <a:pt x="1161" y="39"/>
                      </a:lnTo>
                      <a:lnTo>
                        <a:pt x="1162" y="39"/>
                      </a:lnTo>
                      <a:lnTo>
                        <a:pt x="1164" y="39"/>
                      </a:lnTo>
                      <a:lnTo>
                        <a:pt x="1165" y="39"/>
                      </a:lnTo>
                      <a:lnTo>
                        <a:pt x="1166" y="39"/>
                      </a:lnTo>
                      <a:lnTo>
                        <a:pt x="1166" y="39"/>
                      </a:lnTo>
                      <a:lnTo>
                        <a:pt x="1167" y="39"/>
                      </a:lnTo>
                      <a:lnTo>
                        <a:pt x="1168" y="39"/>
                      </a:lnTo>
                      <a:lnTo>
                        <a:pt x="1168" y="39"/>
                      </a:lnTo>
                      <a:lnTo>
                        <a:pt x="1169" y="39"/>
                      </a:lnTo>
                      <a:lnTo>
                        <a:pt x="1170" y="39"/>
                      </a:lnTo>
                      <a:lnTo>
                        <a:pt x="1172" y="39"/>
                      </a:lnTo>
                      <a:lnTo>
                        <a:pt x="1174" y="39"/>
                      </a:lnTo>
                      <a:lnTo>
                        <a:pt x="1177" y="40"/>
                      </a:lnTo>
                      <a:lnTo>
                        <a:pt x="1179" y="40"/>
                      </a:lnTo>
                      <a:lnTo>
                        <a:pt x="1181" y="40"/>
                      </a:lnTo>
                      <a:lnTo>
                        <a:pt x="1184" y="40"/>
                      </a:lnTo>
                      <a:lnTo>
                        <a:pt x="1185" y="40"/>
                      </a:lnTo>
                      <a:lnTo>
                        <a:pt x="1187" y="40"/>
                      </a:lnTo>
                      <a:lnTo>
                        <a:pt x="1190" y="40"/>
                      </a:lnTo>
                      <a:lnTo>
                        <a:pt x="1192" y="40"/>
                      </a:lnTo>
                      <a:lnTo>
                        <a:pt x="1194" y="40"/>
                      </a:lnTo>
                      <a:lnTo>
                        <a:pt x="1196" y="40"/>
                      </a:lnTo>
                      <a:lnTo>
                        <a:pt x="1198" y="40"/>
                      </a:lnTo>
                      <a:lnTo>
                        <a:pt x="1201" y="40"/>
                      </a:lnTo>
                      <a:lnTo>
                        <a:pt x="1203" y="40"/>
                      </a:lnTo>
                      <a:lnTo>
                        <a:pt x="1205" y="40"/>
                      </a:lnTo>
                      <a:lnTo>
                        <a:pt x="1207" y="40"/>
                      </a:lnTo>
                      <a:lnTo>
                        <a:pt x="1210" y="41"/>
                      </a:lnTo>
                      <a:lnTo>
                        <a:pt x="1212" y="41"/>
                      </a:lnTo>
                      <a:lnTo>
                        <a:pt x="1214" y="41"/>
                      </a:lnTo>
                      <a:lnTo>
                        <a:pt x="1216" y="41"/>
                      </a:lnTo>
                      <a:lnTo>
                        <a:pt x="1218" y="41"/>
                      </a:lnTo>
                      <a:lnTo>
                        <a:pt x="1220" y="41"/>
                      </a:lnTo>
                      <a:lnTo>
                        <a:pt x="1222" y="41"/>
                      </a:lnTo>
                    </a:path>
                  </a:pathLst>
                </a:cu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68" name="TextBox 67"/>
              <p:cNvSpPr txBox="1"/>
              <p:nvPr/>
            </p:nvSpPr>
            <p:spPr>
              <a:xfrm rot="16200000">
                <a:off x="539568" y="5841239"/>
                <a:ext cx="1168630" cy="2655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Intensity (</a:t>
                </a:r>
                <a:r>
                  <a:rPr lang="en-US" sz="1100" dirty="0" err="1">
                    <a:latin typeface="Arial" pitchFamily="34" charset="0"/>
                    <a:cs typeface="Arial" pitchFamily="34" charset="0"/>
                  </a:rPr>
                  <a:t>mAU</a:t>
                </a:r>
                <a:r>
                  <a:rPr lang="en-US" sz="1100" dirty="0">
                    <a:latin typeface="Arial" pitchFamily="34" charset="0"/>
                    <a:cs typeface="Arial" pitchFamily="34" charset="0"/>
                  </a:rPr>
                  <a:t>)</a:t>
                </a:r>
              </a:p>
            </p:txBody>
          </p:sp>
        </p:grpSp>
        <p:sp>
          <p:nvSpPr>
            <p:cNvPr id="238" name="TextBox 237"/>
            <p:cNvSpPr txBox="1"/>
            <p:nvPr/>
          </p:nvSpPr>
          <p:spPr>
            <a:xfrm>
              <a:off x="1575441" y="2731786"/>
              <a:ext cx="17557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521 </a:t>
              </a:r>
              <a:r>
                <a:rPr lang="en-US" sz="1000" dirty="0" err="1">
                  <a:latin typeface="Arial" pitchFamily="34" charset="0"/>
                  <a:cs typeface="Arial" pitchFamily="34" charset="0"/>
                </a:rPr>
                <a:t>nt</a:t>
              </a:r>
              <a:r>
                <a:rPr lang="en-US" sz="1000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000" dirty="0" err="1">
                  <a:latin typeface="Arial" pitchFamily="34" charset="0"/>
                  <a:cs typeface="Arial" pitchFamily="34" charset="0"/>
                </a:rPr>
                <a:t>ssRNA</a:t>
              </a:r>
              <a:r>
                <a:rPr lang="en-US" sz="1000" dirty="0">
                  <a:latin typeface="Arial" pitchFamily="34" charset="0"/>
                  <a:cs typeface="Arial" pitchFamily="34" charset="0"/>
                </a:rPr>
                <a:t> (2)</a:t>
              </a:r>
            </a:p>
          </p:txBody>
        </p:sp>
        <p:sp>
          <p:nvSpPr>
            <p:cNvPr id="240" name="TextBox 239"/>
            <p:cNvSpPr txBox="1"/>
            <p:nvPr/>
          </p:nvSpPr>
          <p:spPr>
            <a:xfrm>
              <a:off x="2547060" y="4748010"/>
              <a:ext cx="171999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itchFamily="34" charset="0"/>
                  <a:cs typeface="Arial" pitchFamily="34" charset="0"/>
                </a:rPr>
                <a:t>Retention time (min)</a:t>
              </a:r>
            </a:p>
          </p:txBody>
        </p:sp>
      </p:grpSp>
      <p:sp>
        <p:nvSpPr>
          <p:cNvPr id="136" name="TextBox 135">
            <a:extLst>
              <a:ext uri="{FF2B5EF4-FFF2-40B4-BE49-F238E27FC236}">
                <a16:creationId xmlns:a16="http://schemas.microsoft.com/office/drawing/2014/main" id="{BC1FE502-A954-4218-9341-277408CCE131}"/>
              </a:ext>
            </a:extLst>
          </p:cNvPr>
          <p:cNvSpPr txBox="1"/>
          <p:nvPr/>
        </p:nvSpPr>
        <p:spPr>
          <a:xfrm>
            <a:off x="109295" y="4833263"/>
            <a:ext cx="282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C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DB56567B-B22A-46CF-A101-8EC468801545}"/>
              </a:ext>
            </a:extLst>
          </p:cNvPr>
          <p:cNvSpPr txBox="1"/>
          <p:nvPr/>
        </p:nvSpPr>
        <p:spPr>
          <a:xfrm>
            <a:off x="77789" y="55423"/>
            <a:ext cx="3072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A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52225C56-4E93-4ABC-86E2-5CD87AFABBFF}"/>
              </a:ext>
            </a:extLst>
          </p:cNvPr>
          <p:cNvSpPr txBox="1"/>
          <p:nvPr/>
        </p:nvSpPr>
        <p:spPr>
          <a:xfrm>
            <a:off x="77789" y="2435912"/>
            <a:ext cx="3072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B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29A2650-A234-4E0C-8B48-EB01EDB1AEE9}"/>
              </a:ext>
            </a:extLst>
          </p:cNvPr>
          <p:cNvSpPr txBox="1"/>
          <p:nvPr/>
        </p:nvSpPr>
        <p:spPr>
          <a:xfrm>
            <a:off x="-27384" y="9480212"/>
            <a:ext cx="53525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itchFamily="34" charset="0"/>
                <a:cs typeface="Arial" pitchFamily="34" charset="0"/>
              </a:rPr>
              <a:t>Supplementary Figure 1</a:t>
            </a:r>
          </a:p>
        </p:txBody>
      </p:sp>
      <p:grpSp>
        <p:nvGrpSpPr>
          <p:cNvPr id="139" name="Group 138">
            <a:extLst>
              <a:ext uri="{FF2B5EF4-FFF2-40B4-BE49-F238E27FC236}">
                <a16:creationId xmlns:a16="http://schemas.microsoft.com/office/drawing/2014/main" id="{B9C0CB67-60AB-4C36-A584-A66696618666}"/>
              </a:ext>
            </a:extLst>
          </p:cNvPr>
          <p:cNvGrpSpPr/>
          <p:nvPr/>
        </p:nvGrpSpPr>
        <p:grpSpPr>
          <a:xfrm>
            <a:off x="1052737" y="4808984"/>
            <a:ext cx="4608511" cy="2349842"/>
            <a:chOff x="555547" y="1352550"/>
            <a:chExt cx="5653166" cy="2786037"/>
          </a:xfrm>
        </p:grpSpPr>
        <p:sp>
          <p:nvSpPr>
            <p:cNvPr id="140" name="AutoShape 3">
              <a:extLst>
                <a:ext uri="{FF2B5EF4-FFF2-40B4-BE49-F238E27FC236}">
                  <a16:creationId xmlns:a16="http://schemas.microsoft.com/office/drawing/2014/main" id="{E1CF1E09-7506-4BA8-A693-61960FF26C6F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981075" y="1352550"/>
              <a:ext cx="5227638" cy="2590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1" name="Rectangle 140">
              <a:extLst>
                <a:ext uri="{FF2B5EF4-FFF2-40B4-BE49-F238E27FC236}">
                  <a16:creationId xmlns:a16="http://schemas.microsoft.com/office/drawing/2014/main" id="{DAE8A0B6-F0D6-4562-9D57-7B9585E848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3150" y="3787775"/>
              <a:ext cx="984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" name="Line 7">
              <a:extLst>
                <a:ext uri="{FF2B5EF4-FFF2-40B4-BE49-F238E27FC236}">
                  <a16:creationId xmlns:a16="http://schemas.microsoft.com/office/drawing/2014/main" id="{88F8D1FE-11C7-4025-B377-E42C66E562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2363" y="3725863"/>
              <a:ext cx="0" cy="619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3" name="Rectangle 142">
              <a:extLst>
                <a:ext uri="{FF2B5EF4-FFF2-40B4-BE49-F238E27FC236}">
                  <a16:creationId xmlns:a16="http://schemas.microsoft.com/office/drawing/2014/main" id="{23CC647B-91AA-4CD6-8AB0-5ABAE88E7E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5938" y="3787775"/>
              <a:ext cx="984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" name="Line 21">
              <a:extLst>
                <a:ext uri="{FF2B5EF4-FFF2-40B4-BE49-F238E27FC236}">
                  <a16:creationId xmlns:a16="http://schemas.microsoft.com/office/drawing/2014/main" id="{D6D7E824-0BF6-4D7D-ACE3-F5DA983E1A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35150" y="3725863"/>
              <a:ext cx="0" cy="619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5" name="Rectangle 144">
              <a:extLst>
                <a:ext uri="{FF2B5EF4-FFF2-40B4-BE49-F238E27FC236}">
                  <a16:creationId xmlns:a16="http://schemas.microsoft.com/office/drawing/2014/main" id="{2E764DFB-0A42-4E5C-A91F-736D09B014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0688" y="3787775"/>
              <a:ext cx="13017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.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" name="Line 45">
              <a:extLst>
                <a:ext uri="{FF2B5EF4-FFF2-40B4-BE49-F238E27FC236}">
                  <a16:creationId xmlns:a16="http://schemas.microsoft.com/office/drawing/2014/main" id="{1845A084-3576-437A-A248-FEC35507B1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25775" y="3725863"/>
              <a:ext cx="0" cy="619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7" name="Rectangle 146">
              <a:extLst>
                <a:ext uri="{FF2B5EF4-FFF2-40B4-BE49-F238E27FC236}">
                  <a16:creationId xmlns:a16="http://schemas.microsoft.com/office/drawing/2014/main" id="{FFB09B2D-6246-47A7-A00E-7697B071F9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49725" y="3787775"/>
              <a:ext cx="13017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.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" name="Line 69">
              <a:extLst>
                <a:ext uri="{FF2B5EF4-FFF2-40B4-BE49-F238E27FC236}">
                  <a16:creationId xmlns:a16="http://schemas.microsoft.com/office/drawing/2014/main" id="{4D740FA0-4CA8-4D99-9DD2-0199313691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14813" y="3725863"/>
              <a:ext cx="0" cy="619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9" name="Rectangle 148">
              <a:extLst>
                <a:ext uri="{FF2B5EF4-FFF2-40B4-BE49-F238E27FC236}">
                  <a16:creationId xmlns:a16="http://schemas.microsoft.com/office/drawing/2014/main" id="{CFF4FCE2-AA7B-45A0-B7EE-0297778575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40350" y="3787775"/>
              <a:ext cx="13017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.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" name="Line 93">
              <a:extLst>
                <a:ext uri="{FF2B5EF4-FFF2-40B4-BE49-F238E27FC236}">
                  <a16:creationId xmlns:a16="http://schemas.microsoft.com/office/drawing/2014/main" id="{9AF85510-0A5B-463F-A830-1D2FC89A06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05438" y="3725863"/>
              <a:ext cx="0" cy="619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1" name="Rectangle 150">
              <a:extLst>
                <a:ext uri="{FF2B5EF4-FFF2-40B4-BE49-F238E27FC236}">
                  <a16:creationId xmlns:a16="http://schemas.microsoft.com/office/drawing/2014/main" id="{7F006E37-B04F-40C4-81CE-D9725AE67C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76950" y="3787775"/>
              <a:ext cx="13017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3.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" name="Line 108">
              <a:extLst>
                <a:ext uri="{FF2B5EF4-FFF2-40B4-BE49-F238E27FC236}">
                  <a16:creationId xmlns:a16="http://schemas.microsoft.com/office/drawing/2014/main" id="{7FB62945-3E82-49C4-8983-EC017B916E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42038" y="3725863"/>
              <a:ext cx="0" cy="619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3" name="Rectangle 152">
              <a:extLst>
                <a:ext uri="{FF2B5EF4-FFF2-40B4-BE49-F238E27FC236}">
                  <a16:creationId xmlns:a16="http://schemas.microsoft.com/office/drawing/2014/main" id="{DCF2EDD8-0E67-47C2-B12E-B439C7574A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22363" y="1506538"/>
              <a:ext cx="5019675" cy="2219326"/>
            </a:xfrm>
            <a:prstGeom prst="rect">
              <a:avLst/>
            </a:prstGeom>
            <a:noFill/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4" name="Rectangle 153">
              <a:extLst>
                <a:ext uri="{FF2B5EF4-FFF2-40B4-BE49-F238E27FC236}">
                  <a16:creationId xmlns:a16="http://schemas.microsoft.com/office/drawing/2014/main" id="{FD441692-325D-41C6-A7C2-B83479C26E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3717" y="3663950"/>
              <a:ext cx="10160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" name="Line 111">
              <a:extLst>
                <a:ext uri="{FF2B5EF4-FFF2-40B4-BE49-F238E27FC236}">
                  <a16:creationId xmlns:a16="http://schemas.microsoft.com/office/drawing/2014/main" id="{06030642-177D-4E24-A191-11BF0FA67E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89025" y="3725863"/>
              <a:ext cx="3333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6" name="Line 113">
              <a:extLst>
                <a:ext uri="{FF2B5EF4-FFF2-40B4-BE49-F238E27FC236}">
                  <a16:creationId xmlns:a16="http://schemas.microsoft.com/office/drawing/2014/main" id="{14002338-8ACA-470E-B7A1-46F95B7B60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89025" y="3448050"/>
              <a:ext cx="3333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7" name="Rectangle 156">
              <a:extLst>
                <a:ext uri="{FF2B5EF4-FFF2-40B4-BE49-F238E27FC236}">
                  <a16:creationId xmlns:a16="http://schemas.microsoft.com/office/drawing/2014/main" id="{F97E6691-37FA-4F38-BEE1-7DC95D61B7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1180" y="2692400"/>
              <a:ext cx="84138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" name="Line 119">
              <a:extLst>
                <a:ext uri="{FF2B5EF4-FFF2-40B4-BE49-F238E27FC236}">
                  <a16:creationId xmlns:a16="http://schemas.microsoft.com/office/drawing/2014/main" id="{978FC0B6-D0DF-4576-9836-0853FC1643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89025" y="2754313"/>
              <a:ext cx="3333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" name="Rectangle 158">
              <a:extLst>
                <a:ext uri="{FF2B5EF4-FFF2-40B4-BE49-F238E27FC236}">
                  <a16:creationId xmlns:a16="http://schemas.microsoft.com/office/drawing/2014/main" id="{C8080952-FB92-4C7C-8995-68BE157492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1017" y="1998663"/>
              <a:ext cx="11430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0" name="Line 125">
              <a:extLst>
                <a:ext uri="{FF2B5EF4-FFF2-40B4-BE49-F238E27FC236}">
                  <a16:creationId xmlns:a16="http://schemas.microsoft.com/office/drawing/2014/main" id="{17BF45AF-DD73-4AE7-9C14-80F2007125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89025" y="2060575"/>
              <a:ext cx="3333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1" name="Rectangle 160">
              <a:extLst>
                <a:ext uri="{FF2B5EF4-FFF2-40B4-BE49-F238E27FC236}">
                  <a16:creationId xmlns:a16="http://schemas.microsoft.com/office/drawing/2014/main" id="{369B3ACA-1B98-49C1-B13B-67A7F1DA66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1017" y="1444625"/>
              <a:ext cx="11430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2" name="Freeform 138">
              <a:extLst>
                <a:ext uri="{FF2B5EF4-FFF2-40B4-BE49-F238E27FC236}">
                  <a16:creationId xmlns:a16="http://schemas.microsoft.com/office/drawing/2014/main" id="{47885609-3A65-4E12-99DE-E548063DE17C}"/>
                </a:ext>
              </a:extLst>
            </p:cNvPr>
            <p:cNvSpPr>
              <a:spLocks/>
            </p:cNvSpPr>
            <p:nvPr/>
          </p:nvSpPr>
          <p:spPr bwMode="auto">
            <a:xfrm>
              <a:off x="1122363" y="3432175"/>
              <a:ext cx="1589088" cy="9525"/>
            </a:xfrm>
            <a:custGeom>
              <a:avLst/>
              <a:gdLst>
                <a:gd name="T0" fmla="*/ 12 w 1001"/>
                <a:gd name="T1" fmla="*/ 5 h 6"/>
                <a:gd name="T2" fmla="*/ 27 w 1001"/>
                <a:gd name="T3" fmla="*/ 5 h 6"/>
                <a:gd name="T4" fmla="*/ 38 w 1001"/>
                <a:gd name="T5" fmla="*/ 6 h 6"/>
                <a:gd name="T6" fmla="*/ 49 w 1001"/>
                <a:gd name="T7" fmla="*/ 5 h 6"/>
                <a:gd name="T8" fmla="*/ 63 w 1001"/>
                <a:gd name="T9" fmla="*/ 5 h 6"/>
                <a:gd name="T10" fmla="*/ 77 w 1001"/>
                <a:gd name="T11" fmla="*/ 5 h 6"/>
                <a:gd name="T12" fmla="*/ 87 w 1001"/>
                <a:gd name="T13" fmla="*/ 5 h 6"/>
                <a:gd name="T14" fmla="*/ 97 w 1001"/>
                <a:gd name="T15" fmla="*/ 4 h 6"/>
                <a:gd name="T16" fmla="*/ 106 w 1001"/>
                <a:gd name="T17" fmla="*/ 4 h 6"/>
                <a:gd name="T18" fmla="*/ 114 w 1001"/>
                <a:gd name="T19" fmla="*/ 4 h 6"/>
                <a:gd name="T20" fmla="*/ 130 w 1001"/>
                <a:gd name="T21" fmla="*/ 5 h 6"/>
                <a:gd name="T22" fmla="*/ 141 w 1001"/>
                <a:gd name="T23" fmla="*/ 5 h 6"/>
                <a:gd name="T24" fmla="*/ 155 w 1001"/>
                <a:gd name="T25" fmla="*/ 5 h 6"/>
                <a:gd name="T26" fmla="*/ 167 w 1001"/>
                <a:gd name="T27" fmla="*/ 4 h 6"/>
                <a:gd name="T28" fmla="*/ 184 w 1001"/>
                <a:gd name="T29" fmla="*/ 4 h 6"/>
                <a:gd name="T30" fmla="*/ 192 w 1001"/>
                <a:gd name="T31" fmla="*/ 3 h 6"/>
                <a:gd name="T32" fmla="*/ 200 w 1001"/>
                <a:gd name="T33" fmla="*/ 3 h 6"/>
                <a:gd name="T34" fmla="*/ 212 w 1001"/>
                <a:gd name="T35" fmla="*/ 3 h 6"/>
                <a:gd name="T36" fmla="*/ 221 w 1001"/>
                <a:gd name="T37" fmla="*/ 3 h 6"/>
                <a:gd name="T38" fmla="*/ 238 w 1001"/>
                <a:gd name="T39" fmla="*/ 2 h 6"/>
                <a:gd name="T40" fmla="*/ 253 w 1001"/>
                <a:gd name="T41" fmla="*/ 2 h 6"/>
                <a:gd name="T42" fmla="*/ 267 w 1001"/>
                <a:gd name="T43" fmla="*/ 2 h 6"/>
                <a:gd name="T44" fmla="*/ 277 w 1001"/>
                <a:gd name="T45" fmla="*/ 2 h 6"/>
                <a:gd name="T46" fmla="*/ 286 w 1001"/>
                <a:gd name="T47" fmla="*/ 2 h 6"/>
                <a:gd name="T48" fmla="*/ 291 w 1001"/>
                <a:gd name="T49" fmla="*/ 1 h 6"/>
                <a:gd name="T50" fmla="*/ 298 w 1001"/>
                <a:gd name="T51" fmla="*/ 1 h 6"/>
                <a:gd name="T52" fmla="*/ 303 w 1001"/>
                <a:gd name="T53" fmla="*/ 0 h 6"/>
                <a:gd name="T54" fmla="*/ 315 w 1001"/>
                <a:gd name="T55" fmla="*/ 1 h 6"/>
                <a:gd name="T56" fmla="*/ 325 w 1001"/>
                <a:gd name="T57" fmla="*/ 2 h 6"/>
                <a:gd name="T58" fmla="*/ 334 w 1001"/>
                <a:gd name="T59" fmla="*/ 1 h 6"/>
                <a:gd name="T60" fmla="*/ 343 w 1001"/>
                <a:gd name="T61" fmla="*/ 0 h 6"/>
                <a:gd name="T62" fmla="*/ 349 w 1001"/>
                <a:gd name="T63" fmla="*/ 0 h 6"/>
                <a:gd name="T64" fmla="*/ 360 w 1001"/>
                <a:gd name="T65" fmla="*/ 1 h 6"/>
                <a:gd name="T66" fmla="*/ 372 w 1001"/>
                <a:gd name="T67" fmla="*/ 1 h 6"/>
                <a:gd name="T68" fmla="*/ 384 w 1001"/>
                <a:gd name="T69" fmla="*/ 2 h 6"/>
                <a:gd name="T70" fmla="*/ 396 w 1001"/>
                <a:gd name="T71" fmla="*/ 2 h 6"/>
                <a:gd name="T72" fmla="*/ 417 w 1001"/>
                <a:gd name="T73" fmla="*/ 3 h 6"/>
                <a:gd name="T74" fmla="*/ 428 w 1001"/>
                <a:gd name="T75" fmla="*/ 3 h 6"/>
                <a:gd name="T76" fmla="*/ 451 w 1001"/>
                <a:gd name="T77" fmla="*/ 3 h 6"/>
                <a:gd name="T78" fmla="*/ 471 w 1001"/>
                <a:gd name="T79" fmla="*/ 3 h 6"/>
                <a:gd name="T80" fmla="*/ 486 w 1001"/>
                <a:gd name="T81" fmla="*/ 3 h 6"/>
                <a:gd name="T82" fmla="*/ 502 w 1001"/>
                <a:gd name="T83" fmla="*/ 3 h 6"/>
                <a:gd name="T84" fmla="*/ 522 w 1001"/>
                <a:gd name="T85" fmla="*/ 3 h 6"/>
                <a:gd name="T86" fmla="*/ 544 w 1001"/>
                <a:gd name="T87" fmla="*/ 3 h 6"/>
                <a:gd name="T88" fmla="*/ 568 w 1001"/>
                <a:gd name="T89" fmla="*/ 3 h 6"/>
                <a:gd name="T90" fmla="*/ 589 w 1001"/>
                <a:gd name="T91" fmla="*/ 3 h 6"/>
                <a:gd name="T92" fmla="*/ 606 w 1001"/>
                <a:gd name="T93" fmla="*/ 3 h 6"/>
                <a:gd name="T94" fmla="*/ 627 w 1001"/>
                <a:gd name="T95" fmla="*/ 3 h 6"/>
                <a:gd name="T96" fmla="*/ 652 w 1001"/>
                <a:gd name="T97" fmla="*/ 3 h 6"/>
                <a:gd name="T98" fmla="*/ 684 w 1001"/>
                <a:gd name="T99" fmla="*/ 3 h 6"/>
                <a:gd name="T100" fmla="*/ 707 w 1001"/>
                <a:gd name="T101" fmla="*/ 3 h 6"/>
                <a:gd name="T102" fmla="*/ 729 w 1001"/>
                <a:gd name="T103" fmla="*/ 3 h 6"/>
                <a:gd name="T104" fmla="*/ 759 w 1001"/>
                <a:gd name="T105" fmla="*/ 3 h 6"/>
                <a:gd name="T106" fmla="*/ 791 w 1001"/>
                <a:gd name="T107" fmla="*/ 3 h 6"/>
                <a:gd name="T108" fmla="*/ 822 w 1001"/>
                <a:gd name="T109" fmla="*/ 3 h 6"/>
                <a:gd name="T110" fmla="*/ 845 w 1001"/>
                <a:gd name="T111" fmla="*/ 3 h 6"/>
                <a:gd name="T112" fmla="*/ 858 w 1001"/>
                <a:gd name="T113" fmla="*/ 3 h 6"/>
                <a:gd name="T114" fmla="*/ 874 w 1001"/>
                <a:gd name="T115" fmla="*/ 3 h 6"/>
                <a:gd name="T116" fmla="*/ 891 w 1001"/>
                <a:gd name="T117" fmla="*/ 2 h 6"/>
                <a:gd name="T118" fmla="*/ 909 w 1001"/>
                <a:gd name="T119" fmla="*/ 2 h 6"/>
                <a:gd name="T120" fmla="*/ 938 w 1001"/>
                <a:gd name="T121" fmla="*/ 2 h 6"/>
                <a:gd name="T122" fmla="*/ 959 w 1001"/>
                <a:gd name="T123" fmla="*/ 1 h 6"/>
                <a:gd name="T124" fmla="*/ 983 w 1001"/>
                <a:gd name="T125" fmla="*/ 1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001" h="6">
                  <a:moveTo>
                    <a:pt x="0" y="4"/>
                  </a:moveTo>
                  <a:lnTo>
                    <a:pt x="0" y="4"/>
                  </a:lnTo>
                  <a:lnTo>
                    <a:pt x="1" y="4"/>
                  </a:lnTo>
                  <a:lnTo>
                    <a:pt x="3" y="4"/>
                  </a:lnTo>
                  <a:lnTo>
                    <a:pt x="5" y="4"/>
                  </a:lnTo>
                  <a:lnTo>
                    <a:pt x="6" y="4"/>
                  </a:lnTo>
                  <a:lnTo>
                    <a:pt x="9" y="5"/>
                  </a:lnTo>
                  <a:lnTo>
                    <a:pt x="12" y="5"/>
                  </a:lnTo>
                  <a:lnTo>
                    <a:pt x="15" y="5"/>
                  </a:lnTo>
                  <a:lnTo>
                    <a:pt x="16" y="5"/>
                  </a:lnTo>
                  <a:lnTo>
                    <a:pt x="18" y="5"/>
                  </a:lnTo>
                  <a:lnTo>
                    <a:pt x="19" y="5"/>
                  </a:lnTo>
                  <a:lnTo>
                    <a:pt x="22" y="5"/>
                  </a:lnTo>
                  <a:lnTo>
                    <a:pt x="24" y="5"/>
                  </a:lnTo>
                  <a:lnTo>
                    <a:pt x="25" y="5"/>
                  </a:lnTo>
                  <a:lnTo>
                    <a:pt x="27" y="5"/>
                  </a:lnTo>
                  <a:lnTo>
                    <a:pt x="29" y="5"/>
                  </a:lnTo>
                  <a:lnTo>
                    <a:pt x="30" y="5"/>
                  </a:lnTo>
                  <a:lnTo>
                    <a:pt x="31" y="5"/>
                  </a:lnTo>
                  <a:lnTo>
                    <a:pt x="33" y="5"/>
                  </a:lnTo>
                  <a:lnTo>
                    <a:pt x="34" y="5"/>
                  </a:lnTo>
                  <a:lnTo>
                    <a:pt x="36" y="6"/>
                  </a:lnTo>
                  <a:lnTo>
                    <a:pt x="37" y="6"/>
                  </a:lnTo>
                  <a:lnTo>
                    <a:pt x="38" y="6"/>
                  </a:lnTo>
                  <a:lnTo>
                    <a:pt x="39" y="6"/>
                  </a:lnTo>
                  <a:lnTo>
                    <a:pt x="40" y="6"/>
                  </a:lnTo>
                  <a:lnTo>
                    <a:pt x="42" y="6"/>
                  </a:lnTo>
                  <a:lnTo>
                    <a:pt x="43" y="6"/>
                  </a:lnTo>
                  <a:lnTo>
                    <a:pt x="45" y="6"/>
                  </a:lnTo>
                  <a:lnTo>
                    <a:pt x="46" y="6"/>
                  </a:lnTo>
                  <a:lnTo>
                    <a:pt x="48" y="5"/>
                  </a:lnTo>
                  <a:lnTo>
                    <a:pt x="49" y="5"/>
                  </a:lnTo>
                  <a:lnTo>
                    <a:pt x="51" y="5"/>
                  </a:lnTo>
                  <a:lnTo>
                    <a:pt x="53" y="5"/>
                  </a:lnTo>
                  <a:lnTo>
                    <a:pt x="55" y="5"/>
                  </a:lnTo>
                  <a:lnTo>
                    <a:pt x="57" y="5"/>
                  </a:lnTo>
                  <a:lnTo>
                    <a:pt x="59" y="5"/>
                  </a:lnTo>
                  <a:lnTo>
                    <a:pt x="61" y="5"/>
                  </a:lnTo>
                  <a:lnTo>
                    <a:pt x="62" y="5"/>
                  </a:lnTo>
                  <a:lnTo>
                    <a:pt x="63" y="5"/>
                  </a:lnTo>
                  <a:lnTo>
                    <a:pt x="64" y="5"/>
                  </a:lnTo>
                  <a:lnTo>
                    <a:pt x="65" y="5"/>
                  </a:lnTo>
                  <a:lnTo>
                    <a:pt x="67" y="5"/>
                  </a:lnTo>
                  <a:lnTo>
                    <a:pt x="68" y="5"/>
                  </a:lnTo>
                  <a:lnTo>
                    <a:pt x="70" y="5"/>
                  </a:lnTo>
                  <a:lnTo>
                    <a:pt x="72" y="5"/>
                  </a:lnTo>
                  <a:lnTo>
                    <a:pt x="74" y="5"/>
                  </a:lnTo>
                  <a:lnTo>
                    <a:pt x="77" y="5"/>
                  </a:lnTo>
                  <a:lnTo>
                    <a:pt x="80" y="5"/>
                  </a:lnTo>
                  <a:lnTo>
                    <a:pt x="82" y="5"/>
                  </a:lnTo>
                  <a:lnTo>
                    <a:pt x="83" y="5"/>
                  </a:lnTo>
                  <a:lnTo>
                    <a:pt x="84" y="5"/>
                  </a:lnTo>
                  <a:lnTo>
                    <a:pt x="85" y="5"/>
                  </a:lnTo>
                  <a:lnTo>
                    <a:pt x="86" y="5"/>
                  </a:lnTo>
                  <a:lnTo>
                    <a:pt x="87" y="5"/>
                  </a:lnTo>
                  <a:lnTo>
                    <a:pt x="87" y="5"/>
                  </a:lnTo>
                  <a:lnTo>
                    <a:pt x="88" y="5"/>
                  </a:lnTo>
                  <a:lnTo>
                    <a:pt x="89" y="5"/>
                  </a:lnTo>
                  <a:lnTo>
                    <a:pt x="90" y="5"/>
                  </a:lnTo>
                  <a:lnTo>
                    <a:pt x="91" y="5"/>
                  </a:lnTo>
                  <a:lnTo>
                    <a:pt x="93" y="4"/>
                  </a:lnTo>
                  <a:lnTo>
                    <a:pt x="94" y="4"/>
                  </a:lnTo>
                  <a:lnTo>
                    <a:pt x="96" y="4"/>
                  </a:lnTo>
                  <a:lnTo>
                    <a:pt x="97" y="4"/>
                  </a:lnTo>
                  <a:lnTo>
                    <a:pt x="98" y="4"/>
                  </a:lnTo>
                  <a:lnTo>
                    <a:pt x="99" y="4"/>
                  </a:lnTo>
                  <a:lnTo>
                    <a:pt x="100" y="4"/>
                  </a:lnTo>
                  <a:lnTo>
                    <a:pt x="101" y="4"/>
                  </a:lnTo>
                  <a:lnTo>
                    <a:pt x="102" y="4"/>
                  </a:lnTo>
                  <a:lnTo>
                    <a:pt x="103" y="4"/>
                  </a:lnTo>
                  <a:lnTo>
                    <a:pt x="105" y="4"/>
                  </a:lnTo>
                  <a:lnTo>
                    <a:pt x="106" y="4"/>
                  </a:lnTo>
                  <a:lnTo>
                    <a:pt x="107" y="4"/>
                  </a:lnTo>
                  <a:lnTo>
                    <a:pt x="109" y="4"/>
                  </a:lnTo>
                  <a:lnTo>
                    <a:pt x="110" y="4"/>
                  </a:lnTo>
                  <a:lnTo>
                    <a:pt x="111" y="4"/>
                  </a:lnTo>
                  <a:lnTo>
                    <a:pt x="112" y="4"/>
                  </a:lnTo>
                  <a:lnTo>
                    <a:pt x="112" y="4"/>
                  </a:lnTo>
                  <a:lnTo>
                    <a:pt x="113" y="4"/>
                  </a:lnTo>
                  <a:lnTo>
                    <a:pt x="114" y="4"/>
                  </a:lnTo>
                  <a:lnTo>
                    <a:pt x="115" y="4"/>
                  </a:lnTo>
                  <a:lnTo>
                    <a:pt x="117" y="4"/>
                  </a:lnTo>
                  <a:lnTo>
                    <a:pt x="119" y="5"/>
                  </a:lnTo>
                  <a:lnTo>
                    <a:pt x="122" y="5"/>
                  </a:lnTo>
                  <a:lnTo>
                    <a:pt x="124" y="5"/>
                  </a:lnTo>
                  <a:lnTo>
                    <a:pt x="126" y="5"/>
                  </a:lnTo>
                  <a:lnTo>
                    <a:pt x="128" y="5"/>
                  </a:lnTo>
                  <a:lnTo>
                    <a:pt x="130" y="5"/>
                  </a:lnTo>
                  <a:lnTo>
                    <a:pt x="131" y="5"/>
                  </a:lnTo>
                  <a:lnTo>
                    <a:pt x="133" y="5"/>
                  </a:lnTo>
                  <a:lnTo>
                    <a:pt x="135" y="5"/>
                  </a:lnTo>
                  <a:lnTo>
                    <a:pt x="136" y="5"/>
                  </a:lnTo>
                  <a:lnTo>
                    <a:pt x="138" y="5"/>
                  </a:lnTo>
                  <a:lnTo>
                    <a:pt x="139" y="5"/>
                  </a:lnTo>
                  <a:lnTo>
                    <a:pt x="140" y="5"/>
                  </a:lnTo>
                  <a:lnTo>
                    <a:pt x="141" y="5"/>
                  </a:lnTo>
                  <a:lnTo>
                    <a:pt x="143" y="5"/>
                  </a:lnTo>
                  <a:lnTo>
                    <a:pt x="145" y="5"/>
                  </a:lnTo>
                  <a:lnTo>
                    <a:pt x="147" y="5"/>
                  </a:lnTo>
                  <a:lnTo>
                    <a:pt x="148" y="5"/>
                  </a:lnTo>
                  <a:lnTo>
                    <a:pt x="150" y="5"/>
                  </a:lnTo>
                  <a:lnTo>
                    <a:pt x="152" y="5"/>
                  </a:lnTo>
                  <a:lnTo>
                    <a:pt x="153" y="5"/>
                  </a:lnTo>
                  <a:lnTo>
                    <a:pt x="155" y="5"/>
                  </a:lnTo>
                  <a:lnTo>
                    <a:pt x="157" y="5"/>
                  </a:lnTo>
                  <a:lnTo>
                    <a:pt x="159" y="5"/>
                  </a:lnTo>
                  <a:lnTo>
                    <a:pt x="161" y="5"/>
                  </a:lnTo>
                  <a:lnTo>
                    <a:pt x="163" y="5"/>
                  </a:lnTo>
                  <a:lnTo>
                    <a:pt x="163" y="5"/>
                  </a:lnTo>
                  <a:lnTo>
                    <a:pt x="164" y="5"/>
                  </a:lnTo>
                  <a:lnTo>
                    <a:pt x="165" y="5"/>
                  </a:lnTo>
                  <a:lnTo>
                    <a:pt x="167" y="4"/>
                  </a:lnTo>
                  <a:lnTo>
                    <a:pt x="169" y="4"/>
                  </a:lnTo>
                  <a:lnTo>
                    <a:pt x="172" y="4"/>
                  </a:lnTo>
                  <a:lnTo>
                    <a:pt x="175" y="4"/>
                  </a:lnTo>
                  <a:lnTo>
                    <a:pt x="178" y="4"/>
                  </a:lnTo>
                  <a:lnTo>
                    <a:pt x="179" y="4"/>
                  </a:lnTo>
                  <a:lnTo>
                    <a:pt x="181" y="4"/>
                  </a:lnTo>
                  <a:lnTo>
                    <a:pt x="182" y="4"/>
                  </a:lnTo>
                  <a:lnTo>
                    <a:pt x="184" y="4"/>
                  </a:lnTo>
                  <a:lnTo>
                    <a:pt x="185" y="4"/>
                  </a:lnTo>
                  <a:lnTo>
                    <a:pt x="186" y="4"/>
                  </a:lnTo>
                  <a:lnTo>
                    <a:pt x="187" y="4"/>
                  </a:lnTo>
                  <a:lnTo>
                    <a:pt x="188" y="4"/>
                  </a:lnTo>
                  <a:lnTo>
                    <a:pt x="189" y="4"/>
                  </a:lnTo>
                  <a:lnTo>
                    <a:pt x="190" y="4"/>
                  </a:lnTo>
                  <a:lnTo>
                    <a:pt x="191" y="3"/>
                  </a:lnTo>
                  <a:lnTo>
                    <a:pt x="192" y="3"/>
                  </a:lnTo>
                  <a:lnTo>
                    <a:pt x="193" y="3"/>
                  </a:lnTo>
                  <a:lnTo>
                    <a:pt x="194" y="3"/>
                  </a:lnTo>
                  <a:lnTo>
                    <a:pt x="195" y="3"/>
                  </a:lnTo>
                  <a:lnTo>
                    <a:pt x="196" y="3"/>
                  </a:lnTo>
                  <a:lnTo>
                    <a:pt x="197" y="3"/>
                  </a:lnTo>
                  <a:lnTo>
                    <a:pt x="198" y="3"/>
                  </a:lnTo>
                  <a:lnTo>
                    <a:pt x="199" y="3"/>
                  </a:lnTo>
                  <a:lnTo>
                    <a:pt x="200" y="3"/>
                  </a:lnTo>
                  <a:lnTo>
                    <a:pt x="202" y="3"/>
                  </a:lnTo>
                  <a:lnTo>
                    <a:pt x="203" y="3"/>
                  </a:lnTo>
                  <a:lnTo>
                    <a:pt x="204" y="3"/>
                  </a:lnTo>
                  <a:lnTo>
                    <a:pt x="206" y="3"/>
                  </a:lnTo>
                  <a:lnTo>
                    <a:pt x="208" y="3"/>
                  </a:lnTo>
                  <a:lnTo>
                    <a:pt x="210" y="3"/>
                  </a:lnTo>
                  <a:lnTo>
                    <a:pt x="211" y="3"/>
                  </a:lnTo>
                  <a:lnTo>
                    <a:pt x="212" y="3"/>
                  </a:lnTo>
                  <a:lnTo>
                    <a:pt x="213" y="3"/>
                  </a:lnTo>
                  <a:lnTo>
                    <a:pt x="214" y="3"/>
                  </a:lnTo>
                  <a:lnTo>
                    <a:pt x="215" y="3"/>
                  </a:lnTo>
                  <a:lnTo>
                    <a:pt x="216" y="3"/>
                  </a:lnTo>
                  <a:lnTo>
                    <a:pt x="217" y="3"/>
                  </a:lnTo>
                  <a:lnTo>
                    <a:pt x="219" y="3"/>
                  </a:lnTo>
                  <a:lnTo>
                    <a:pt x="220" y="3"/>
                  </a:lnTo>
                  <a:lnTo>
                    <a:pt x="221" y="3"/>
                  </a:lnTo>
                  <a:lnTo>
                    <a:pt x="223" y="3"/>
                  </a:lnTo>
                  <a:lnTo>
                    <a:pt x="225" y="3"/>
                  </a:lnTo>
                  <a:lnTo>
                    <a:pt x="227" y="3"/>
                  </a:lnTo>
                  <a:lnTo>
                    <a:pt x="229" y="3"/>
                  </a:lnTo>
                  <a:lnTo>
                    <a:pt x="231" y="3"/>
                  </a:lnTo>
                  <a:lnTo>
                    <a:pt x="233" y="3"/>
                  </a:lnTo>
                  <a:lnTo>
                    <a:pt x="235" y="3"/>
                  </a:lnTo>
                  <a:lnTo>
                    <a:pt x="238" y="2"/>
                  </a:lnTo>
                  <a:lnTo>
                    <a:pt x="240" y="2"/>
                  </a:lnTo>
                  <a:lnTo>
                    <a:pt x="242" y="2"/>
                  </a:lnTo>
                  <a:lnTo>
                    <a:pt x="244" y="2"/>
                  </a:lnTo>
                  <a:lnTo>
                    <a:pt x="246" y="2"/>
                  </a:lnTo>
                  <a:lnTo>
                    <a:pt x="248" y="2"/>
                  </a:lnTo>
                  <a:lnTo>
                    <a:pt x="249" y="2"/>
                  </a:lnTo>
                  <a:lnTo>
                    <a:pt x="251" y="2"/>
                  </a:lnTo>
                  <a:lnTo>
                    <a:pt x="253" y="2"/>
                  </a:lnTo>
                  <a:lnTo>
                    <a:pt x="255" y="2"/>
                  </a:lnTo>
                  <a:lnTo>
                    <a:pt x="257" y="2"/>
                  </a:lnTo>
                  <a:lnTo>
                    <a:pt x="258" y="2"/>
                  </a:lnTo>
                  <a:lnTo>
                    <a:pt x="260" y="2"/>
                  </a:lnTo>
                  <a:lnTo>
                    <a:pt x="262" y="2"/>
                  </a:lnTo>
                  <a:lnTo>
                    <a:pt x="264" y="2"/>
                  </a:lnTo>
                  <a:lnTo>
                    <a:pt x="265" y="2"/>
                  </a:lnTo>
                  <a:lnTo>
                    <a:pt x="267" y="2"/>
                  </a:lnTo>
                  <a:lnTo>
                    <a:pt x="268" y="2"/>
                  </a:lnTo>
                  <a:lnTo>
                    <a:pt x="270" y="2"/>
                  </a:lnTo>
                  <a:lnTo>
                    <a:pt x="271" y="2"/>
                  </a:lnTo>
                  <a:lnTo>
                    <a:pt x="272" y="2"/>
                  </a:lnTo>
                  <a:lnTo>
                    <a:pt x="273" y="2"/>
                  </a:lnTo>
                  <a:lnTo>
                    <a:pt x="274" y="2"/>
                  </a:lnTo>
                  <a:lnTo>
                    <a:pt x="276" y="2"/>
                  </a:lnTo>
                  <a:lnTo>
                    <a:pt x="277" y="2"/>
                  </a:lnTo>
                  <a:lnTo>
                    <a:pt x="279" y="2"/>
                  </a:lnTo>
                  <a:lnTo>
                    <a:pt x="280" y="2"/>
                  </a:lnTo>
                  <a:lnTo>
                    <a:pt x="282" y="2"/>
                  </a:lnTo>
                  <a:lnTo>
                    <a:pt x="283" y="2"/>
                  </a:lnTo>
                  <a:lnTo>
                    <a:pt x="284" y="2"/>
                  </a:lnTo>
                  <a:lnTo>
                    <a:pt x="285" y="2"/>
                  </a:lnTo>
                  <a:lnTo>
                    <a:pt x="285" y="2"/>
                  </a:lnTo>
                  <a:lnTo>
                    <a:pt x="286" y="2"/>
                  </a:lnTo>
                  <a:lnTo>
                    <a:pt x="287" y="2"/>
                  </a:lnTo>
                  <a:lnTo>
                    <a:pt x="288" y="2"/>
                  </a:lnTo>
                  <a:lnTo>
                    <a:pt x="289" y="2"/>
                  </a:lnTo>
                  <a:lnTo>
                    <a:pt x="289" y="2"/>
                  </a:lnTo>
                  <a:lnTo>
                    <a:pt x="290" y="2"/>
                  </a:lnTo>
                  <a:lnTo>
                    <a:pt x="290" y="2"/>
                  </a:lnTo>
                  <a:lnTo>
                    <a:pt x="290" y="2"/>
                  </a:lnTo>
                  <a:lnTo>
                    <a:pt x="291" y="1"/>
                  </a:lnTo>
                  <a:lnTo>
                    <a:pt x="292" y="1"/>
                  </a:lnTo>
                  <a:lnTo>
                    <a:pt x="293" y="1"/>
                  </a:lnTo>
                  <a:lnTo>
                    <a:pt x="295" y="1"/>
                  </a:lnTo>
                  <a:lnTo>
                    <a:pt x="296" y="1"/>
                  </a:lnTo>
                  <a:lnTo>
                    <a:pt x="296" y="1"/>
                  </a:lnTo>
                  <a:lnTo>
                    <a:pt x="297" y="1"/>
                  </a:lnTo>
                  <a:lnTo>
                    <a:pt x="298" y="1"/>
                  </a:lnTo>
                  <a:lnTo>
                    <a:pt x="298" y="1"/>
                  </a:lnTo>
                  <a:lnTo>
                    <a:pt x="299" y="0"/>
                  </a:lnTo>
                  <a:lnTo>
                    <a:pt x="300" y="0"/>
                  </a:lnTo>
                  <a:lnTo>
                    <a:pt x="300" y="0"/>
                  </a:lnTo>
                  <a:lnTo>
                    <a:pt x="301" y="0"/>
                  </a:lnTo>
                  <a:lnTo>
                    <a:pt x="301" y="0"/>
                  </a:lnTo>
                  <a:lnTo>
                    <a:pt x="302" y="0"/>
                  </a:lnTo>
                  <a:lnTo>
                    <a:pt x="303" y="0"/>
                  </a:lnTo>
                  <a:lnTo>
                    <a:pt x="303" y="0"/>
                  </a:lnTo>
                  <a:lnTo>
                    <a:pt x="304" y="1"/>
                  </a:lnTo>
                  <a:lnTo>
                    <a:pt x="305" y="1"/>
                  </a:lnTo>
                  <a:lnTo>
                    <a:pt x="306" y="1"/>
                  </a:lnTo>
                  <a:lnTo>
                    <a:pt x="307" y="1"/>
                  </a:lnTo>
                  <a:lnTo>
                    <a:pt x="309" y="1"/>
                  </a:lnTo>
                  <a:lnTo>
                    <a:pt x="311" y="1"/>
                  </a:lnTo>
                  <a:lnTo>
                    <a:pt x="313" y="1"/>
                  </a:lnTo>
                  <a:lnTo>
                    <a:pt x="315" y="1"/>
                  </a:lnTo>
                  <a:lnTo>
                    <a:pt x="316" y="1"/>
                  </a:lnTo>
                  <a:lnTo>
                    <a:pt x="318" y="1"/>
                  </a:lnTo>
                  <a:lnTo>
                    <a:pt x="319" y="1"/>
                  </a:lnTo>
                  <a:lnTo>
                    <a:pt x="320" y="1"/>
                  </a:lnTo>
                  <a:lnTo>
                    <a:pt x="322" y="2"/>
                  </a:lnTo>
                  <a:lnTo>
                    <a:pt x="323" y="2"/>
                  </a:lnTo>
                  <a:lnTo>
                    <a:pt x="324" y="2"/>
                  </a:lnTo>
                  <a:lnTo>
                    <a:pt x="325" y="2"/>
                  </a:lnTo>
                  <a:lnTo>
                    <a:pt x="326" y="2"/>
                  </a:lnTo>
                  <a:lnTo>
                    <a:pt x="327" y="2"/>
                  </a:lnTo>
                  <a:lnTo>
                    <a:pt x="328" y="1"/>
                  </a:lnTo>
                  <a:lnTo>
                    <a:pt x="329" y="1"/>
                  </a:lnTo>
                  <a:lnTo>
                    <a:pt x="330" y="1"/>
                  </a:lnTo>
                  <a:lnTo>
                    <a:pt x="331" y="1"/>
                  </a:lnTo>
                  <a:lnTo>
                    <a:pt x="332" y="1"/>
                  </a:lnTo>
                  <a:lnTo>
                    <a:pt x="334" y="1"/>
                  </a:lnTo>
                  <a:lnTo>
                    <a:pt x="335" y="1"/>
                  </a:lnTo>
                  <a:lnTo>
                    <a:pt x="336" y="1"/>
                  </a:lnTo>
                  <a:lnTo>
                    <a:pt x="338" y="1"/>
                  </a:lnTo>
                  <a:lnTo>
                    <a:pt x="339" y="1"/>
                  </a:lnTo>
                  <a:lnTo>
                    <a:pt x="340" y="0"/>
                  </a:lnTo>
                  <a:lnTo>
                    <a:pt x="341" y="0"/>
                  </a:lnTo>
                  <a:lnTo>
                    <a:pt x="342" y="0"/>
                  </a:lnTo>
                  <a:lnTo>
                    <a:pt x="343" y="0"/>
                  </a:lnTo>
                  <a:lnTo>
                    <a:pt x="344" y="0"/>
                  </a:lnTo>
                  <a:lnTo>
                    <a:pt x="345" y="0"/>
                  </a:lnTo>
                  <a:lnTo>
                    <a:pt x="345" y="0"/>
                  </a:lnTo>
                  <a:lnTo>
                    <a:pt x="346" y="0"/>
                  </a:lnTo>
                  <a:lnTo>
                    <a:pt x="347" y="0"/>
                  </a:lnTo>
                  <a:lnTo>
                    <a:pt x="347" y="0"/>
                  </a:lnTo>
                  <a:lnTo>
                    <a:pt x="348" y="0"/>
                  </a:lnTo>
                  <a:lnTo>
                    <a:pt x="349" y="0"/>
                  </a:lnTo>
                  <a:lnTo>
                    <a:pt x="350" y="0"/>
                  </a:lnTo>
                  <a:lnTo>
                    <a:pt x="351" y="1"/>
                  </a:lnTo>
                  <a:lnTo>
                    <a:pt x="353" y="1"/>
                  </a:lnTo>
                  <a:lnTo>
                    <a:pt x="354" y="1"/>
                  </a:lnTo>
                  <a:lnTo>
                    <a:pt x="356" y="1"/>
                  </a:lnTo>
                  <a:lnTo>
                    <a:pt x="357" y="1"/>
                  </a:lnTo>
                  <a:lnTo>
                    <a:pt x="359" y="1"/>
                  </a:lnTo>
                  <a:lnTo>
                    <a:pt x="360" y="1"/>
                  </a:lnTo>
                  <a:lnTo>
                    <a:pt x="362" y="1"/>
                  </a:lnTo>
                  <a:lnTo>
                    <a:pt x="363" y="1"/>
                  </a:lnTo>
                  <a:lnTo>
                    <a:pt x="365" y="1"/>
                  </a:lnTo>
                  <a:lnTo>
                    <a:pt x="367" y="1"/>
                  </a:lnTo>
                  <a:lnTo>
                    <a:pt x="368" y="1"/>
                  </a:lnTo>
                  <a:lnTo>
                    <a:pt x="369" y="1"/>
                  </a:lnTo>
                  <a:lnTo>
                    <a:pt x="370" y="1"/>
                  </a:lnTo>
                  <a:lnTo>
                    <a:pt x="372" y="1"/>
                  </a:lnTo>
                  <a:lnTo>
                    <a:pt x="374" y="1"/>
                  </a:lnTo>
                  <a:lnTo>
                    <a:pt x="375" y="1"/>
                  </a:lnTo>
                  <a:lnTo>
                    <a:pt x="377" y="1"/>
                  </a:lnTo>
                  <a:lnTo>
                    <a:pt x="378" y="1"/>
                  </a:lnTo>
                  <a:lnTo>
                    <a:pt x="379" y="1"/>
                  </a:lnTo>
                  <a:lnTo>
                    <a:pt x="381" y="1"/>
                  </a:lnTo>
                  <a:lnTo>
                    <a:pt x="382" y="2"/>
                  </a:lnTo>
                  <a:lnTo>
                    <a:pt x="384" y="2"/>
                  </a:lnTo>
                  <a:lnTo>
                    <a:pt x="386" y="2"/>
                  </a:lnTo>
                  <a:lnTo>
                    <a:pt x="388" y="2"/>
                  </a:lnTo>
                  <a:lnTo>
                    <a:pt x="389" y="2"/>
                  </a:lnTo>
                  <a:lnTo>
                    <a:pt x="391" y="2"/>
                  </a:lnTo>
                  <a:lnTo>
                    <a:pt x="393" y="2"/>
                  </a:lnTo>
                  <a:lnTo>
                    <a:pt x="393" y="2"/>
                  </a:lnTo>
                  <a:lnTo>
                    <a:pt x="394" y="2"/>
                  </a:lnTo>
                  <a:lnTo>
                    <a:pt x="396" y="2"/>
                  </a:lnTo>
                  <a:lnTo>
                    <a:pt x="397" y="2"/>
                  </a:lnTo>
                  <a:lnTo>
                    <a:pt x="399" y="2"/>
                  </a:lnTo>
                  <a:lnTo>
                    <a:pt x="401" y="2"/>
                  </a:lnTo>
                  <a:lnTo>
                    <a:pt x="404" y="2"/>
                  </a:lnTo>
                  <a:lnTo>
                    <a:pt x="408" y="3"/>
                  </a:lnTo>
                  <a:lnTo>
                    <a:pt x="413" y="3"/>
                  </a:lnTo>
                  <a:lnTo>
                    <a:pt x="416" y="3"/>
                  </a:lnTo>
                  <a:lnTo>
                    <a:pt x="417" y="3"/>
                  </a:lnTo>
                  <a:lnTo>
                    <a:pt x="419" y="3"/>
                  </a:lnTo>
                  <a:lnTo>
                    <a:pt x="419" y="3"/>
                  </a:lnTo>
                  <a:lnTo>
                    <a:pt x="420" y="3"/>
                  </a:lnTo>
                  <a:lnTo>
                    <a:pt x="421" y="3"/>
                  </a:lnTo>
                  <a:lnTo>
                    <a:pt x="423" y="3"/>
                  </a:lnTo>
                  <a:lnTo>
                    <a:pt x="424" y="3"/>
                  </a:lnTo>
                  <a:lnTo>
                    <a:pt x="426" y="3"/>
                  </a:lnTo>
                  <a:lnTo>
                    <a:pt x="428" y="3"/>
                  </a:lnTo>
                  <a:lnTo>
                    <a:pt x="430" y="3"/>
                  </a:lnTo>
                  <a:lnTo>
                    <a:pt x="432" y="3"/>
                  </a:lnTo>
                  <a:lnTo>
                    <a:pt x="436" y="3"/>
                  </a:lnTo>
                  <a:lnTo>
                    <a:pt x="438" y="3"/>
                  </a:lnTo>
                  <a:lnTo>
                    <a:pt x="441" y="3"/>
                  </a:lnTo>
                  <a:lnTo>
                    <a:pt x="444" y="3"/>
                  </a:lnTo>
                  <a:lnTo>
                    <a:pt x="448" y="3"/>
                  </a:lnTo>
                  <a:lnTo>
                    <a:pt x="451" y="3"/>
                  </a:lnTo>
                  <a:lnTo>
                    <a:pt x="453" y="3"/>
                  </a:lnTo>
                  <a:lnTo>
                    <a:pt x="455" y="3"/>
                  </a:lnTo>
                  <a:lnTo>
                    <a:pt x="457" y="3"/>
                  </a:lnTo>
                  <a:lnTo>
                    <a:pt x="459" y="3"/>
                  </a:lnTo>
                  <a:lnTo>
                    <a:pt x="462" y="3"/>
                  </a:lnTo>
                  <a:lnTo>
                    <a:pt x="466" y="3"/>
                  </a:lnTo>
                  <a:lnTo>
                    <a:pt x="469" y="3"/>
                  </a:lnTo>
                  <a:lnTo>
                    <a:pt x="471" y="3"/>
                  </a:lnTo>
                  <a:lnTo>
                    <a:pt x="473" y="3"/>
                  </a:lnTo>
                  <a:lnTo>
                    <a:pt x="475" y="3"/>
                  </a:lnTo>
                  <a:lnTo>
                    <a:pt x="477" y="3"/>
                  </a:lnTo>
                  <a:lnTo>
                    <a:pt x="479" y="3"/>
                  </a:lnTo>
                  <a:lnTo>
                    <a:pt x="480" y="3"/>
                  </a:lnTo>
                  <a:lnTo>
                    <a:pt x="482" y="3"/>
                  </a:lnTo>
                  <a:lnTo>
                    <a:pt x="484" y="3"/>
                  </a:lnTo>
                  <a:lnTo>
                    <a:pt x="486" y="3"/>
                  </a:lnTo>
                  <a:lnTo>
                    <a:pt x="488" y="3"/>
                  </a:lnTo>
                  <a:lnTo>
                    <a:pt x="490" y="3"/>
                  </a:lnTo>
                  <a:lnTo>
                    <a:pt x="493" y="3"/>
                  </a:lnTo>
                  <a:lnTo>
                    <a:pt x="495" y="3"/>
                  </a:lnTo>
                  <a:lnTo>
                    <a:pt x="496" y="3"/>
                  </a:lnTo>
                  <a:lnTo>
                    <a:pt x="498" y="3"/>
                  </a:lnTo>
                  <a:lnTo>
                    <a:pt x="499" y="3"/>
                  </a:lnTo>
                  <a:lnTo>
                    <a:pt x="502" y="3"/>
                  </a:lnTo>
                  <a:lnTo>
                    <a:pt x="504" y="3"/>
                  </a:lnTo>
                  <a:lnTo>
                    <a:pt x="507" y="3"/>
                  </a:lnTo>
                  <a:lnTo>
                    <a:pt x="509" y="3"/>
                  </a:lnTo>
                  <a:lnTo>
                    <a:pt x="511" y="3"/>
                  </a:lnTo>
                  <a:lnTo>
                    <a:pt x="514" y="3"/>
                  </a:lnTo>
                  <a:lnTo>
                    <a:pt x="517" y="3"/>
                  </a:lnTo>
                  <a:lnTo>
                    <a:pt x="520" y="3"/>
                  </a:lnTo>
                  <a:lnTo>
                    <a:pt x="522" y="3"/>
                  </a:lnTo>
                  <a:lnTo>
                    <a:pt x="524" y="3"/>
                  </a:lnTo>
                  <a:lnTo>
                    <a:pt x="526" y="3"/>
                  </a:lnTo>
                  <a:lnTo>
                    <a:pt x="528" y="3"/>
                  </a:lnTo>
                  <a:lnTo>
                    <a:pt x="530" y="3"/>
                  </a:lnTo>
                  <a:lnTo>
                    <a:pt x="531" y="3"/>
                  </a:lnTo>
                  <a:lnTo>
                    <a:pt x="534" y="3"/>
                  </a:lnTo>
                  <a:lnTo>
                    <a:pt x="538" y="3"/>
                  </a:lnTo>
                  <a:lnTo>
                    <a:pt x="544" y="3"/>
                  </a:lnTo>
                  <a:lnTo>
                    <a:pt x="547" y="3"/>
                  </a:lnTo>
                  <a:lnTo>
                    <a:pt x="550" y="3"/>
                  </a:lnTo>
                  <a:lnTo>
                    <a:pt x="553" y="3"/>
                  </a:lnTo>
                  <a:lnTo>
                    <a:pt x="556" y="3"/>
                  </a:lnTo>
                  <a:lnTo>
                    <a:pt x="559" y="3"/>
                  </a:lnTo>
                  <a:lnTo>
                    <a:pt x="562" y="3"/>
                  </a:lnTo>
                  <a:lnTo>
                    <a:pt x="565" y="3"/>
                  </a:lnTo>
                  <a:lnTo>
                    <a:pt x="568" y="3"/>
                  </a:lnTo>
                  <a:lnTo>
                    <a:pt x="571" y="3"/>
                  </a:lnTo>
                  <a:lnTo>
                    <a:pt x="575" y="3"/>
                  </a:lnTo>
                  <a:lnTo>
                    <a:pt x="578" y="3"/>
                  </a:lnTo>
                  <a:lnTo>
                    <a:pt x="580" y="3"/>
                  </a:lnTo>
                  <a:lnTo>
                    <a:pt x="582" y="3"/>
                  </a:lnTo>
                  <a:lnTo>
                    <a:pt x="584" y="3"/>
                  </a:lnTo>
                  <a:lnTo>
                    <a:pt x="586" y="3"/>
                  </a:lnTo>
                  <a:lnTo>
                    <a:pt x="589" y="3"/>
                  </a:lnTo>
                  <a:lnTo>
                    <a:pt x="592" y="3"/>
                  </a:lnTo>
                  <a:lnTo>
                    <a:pt x="595" y="3"/>
                  </a:lnTo>
                  <a:lnTo>
                    <a:pt x="598" y="3"/>
                  </a:lnTo>
                  <a:lnTo>
                    <a:pt x="599" y="3"/>
                  </a:lnTo>
                  <a:lnTo>
                    <a:pt x="601" y="3"/>
                  </a:lnTo>
                  <a:lnTo>
                    <a:pt x="603" y="3"/>
                  </a:lnTo>
                  <a:lnTo>
                    <a:pt x="604" y="3"/>
                  </a:lnTo>
                  <a:lnTo>
                    <a:pt x="606" y="3"/>
                  </a:lnTo>
                  <a:lnTo>
                    <a:pt x="609" y="3"/>
                  </a:lnTo>
                  <a:lnTo>
                    <a:pt x="612" y="3"/>
                  </a:lnTo>
                  <a:lnTo>
                    <a:pt x="615" y="3"/>
                  </a:lnTo>
                  <a:lnTo>
                    <a:pt x="618" y="3"/>
                  </a:lnTo>
                  <a:lnTo>
                    <a:pt x="621" y="3"/>
                  </a:lnTo>
                  <a:lnTo>
                    <a:pt x="624" y="3"/>
                  </a:lnTo>
                  <a:lnTo>
                    <a:pt x="626" y="3"/>
                  </a:lnTo>
                  <a:lnTo>
                    <a:pt x="627" y="3"/>
                  </a:lnTo>
                  <a:lnTo>
                    <a:pt x="628" y="3"/>
                  </a:lnTo>
                  <a:lnTo>
                    <a:pt x="630" y="3"/>
                  </a:lnTo>
                  <a:lnTo>
                    <a:pt x="634" y="3"/>
                  </a:lnTo>
                  <a:lnTo>
                    <a:pt x="637" y="3"/>
                  </a:lnTo>
                  <a:lnTo>
                    <a:pt x="640" y="3"/>
                  </a:lnTo>
                  <a:lnTo>
                    <a:pt x="644" y="3"/>
                  </a:lnTo>
                  <a:lnTo>
                    <a:pt x="648" y="3"/>
                  </a:lnTo>
                  <a:lnTo>
                    <a:pt x="652" y="3"/>
                  </a:lnTo>
                  <a:lnTo>
                    <a:pt x="657" y="3"/>
                  </a:lnTo>
                  <a:lnTo>
                    <a:pt x="662" y="3"/>
                  </a:lnTo>
                  <a:lnTo>
                    <a:pt x="668" y="3"/>
                  </a:lnTo>
                  <a:lnTo>
                    <a:pt x="673" y="3"/>
                  </a:lnTo>
                  <a:lnTo>
                    <a:pt x="676" y="3"/>
                  </a:lnTo>
                  <a:lnTo>
                    <a:pt x="678" y="3"/>
                  </a:lnTo>
                  <a:lnTo>
                    <a:pt x="681" y="3"/>
                  </a:lnTo>
                  <a:lnTo>
                    <a:pt x="684" y="3"/>
                  </a:lnTo>
                  <a:lnTo>
                    <a:pt x="688" y="3"/>
                  </a:lnTo>
                  <a:lnTo>
                    <a:pt x="691" y="3"/>
                  </a:lnTo>
                  <a:lnTo>
                    <a:pt x="695" y="3"/>
                  </a:lnTo>
                  <a:lnTo>
                    <a:pt x="699" y="3"/>
                  </a:lnTo>
                  <a:lnTo>
                    <a:pt x="701" y="3"/>
                  </a:lnTo>
                  <a:lnTo>
                    <a:pt x="703" y="3"/>
                  </a:lnTo>
                  <a:lnTo>
                    <a:pt x="705" y="3"/>
                  </a:lnTo>
                  <a:lnTo>
                    <a:pt x="707" y="3"/>
                  </a:lnTo>
                  <a:lnTo>
                    <a:pt x="710" y="3"/>
                  </a:lnTo>
                  <a:lnTo>
                    <a:pt x="712" y="3"/>
                  </a:lnTo>
                  <a:lnTo>
                    <a:pt x="716" y="3"/>
                  </a:lnTo>
                  <a:lnTo>
                    <a:pt x="719" y="3"/>
                  </a:lnTo>
                  <a:lnTo>
                    <a:pt x="722" y="3"/>
                  </a:lnTo>
                  <a:lnTo>
                    <a:pt x="724" y="3"/>
                  </a:lnTo>
                  <a:lnTo>
                    <a:pt x="727" y="3"/>
                  </a:lnTo>
                  <a:lnTo>
                    <a:pt x="729" y="3"/>
                  </a:lnTo>
                  <a:lnTo>
                    <a:pt x="732" y="3"/>
                  </a:lnTo>
                  <a:lnTo>
                    <a:pt x="736" y="3"/>
                  </a:lnTo>
                  <a:lnTo>
                    <a:pt x="740" y="3"/>
                  </a:lnTo>
                  <a:lnTo>
                    <a:pt x="744" y="3"/>
                  </a:lnTo>
                  <a:lnTo>
                    <a:pt x="748" y="3"/>
                  </a:lnTo>
                  <a:lnTo>
                    <a:pt x="752" y="3"/>
                  </a:lnTo>
                  <a:lnTo>
                    <a:pt x="756" y="3"/>
                  </a:lnTo>
                  <a:lnTo>
                    <a:pt x="759" y="3"/>
                  </a:lnTo>
                  <a:lnTo>
                    <a:pt x="763" y="3"/>
                  </a:lnTo>
                  <a:lnTo>
                    <a:pt x="766" y="3"/>
                  </a:lnTo>
                  <a:lnTo>
                    <a:pt x="770" y="3"/>
                  </a:lnTo>
                  <a:lnTo>
                    <a:pt x="774" y="3"/>
                  </a:lnTo>
                  <a:lnTo>
                    <a:pt x="778" y="3"/>
                  </a:lnTo>
                  <a:lnTo>
                    <a:pt x="782" y="3"/>
                  </a:lnTo>
                  <a:lnTo>
                    <a:pt x="786" y="3"/>
                  </a:lnTo>
                  <a:lnTo>
                    <a:pt x="791" y="3"/>
                  </a:lnTo>
                  <a:lnTo>
                    <a:pt x="796" y="3"/>
                  </a:lnTo>
                  <a:lnTo>
                    <a:pt x="801" y="3"/>
                  </a:lnTo>
                  <a:lnTo>
                    <a:pt x="805" y="3"/>
                  </a:lnTo>
                  <a:lnTo>
                    <a:pt x="809" y="3"/>
                  </a:lnTo>
                  <a:lnTo>
                    <a:pt x="813" y="3"/>
                  </a:lnTo>
                  <a:lnTo>
                    <a:pt x="816" y="3"/>
                  </a:lnTo>
                  <a:lnTo>
                    <a:pt x="819" y="3"/>
                  </a:lnTo>
                  <a:lnTo>
                    <a:pt x="822" y="3"/>
                  </a:lnTo>
                  <a:lnTo>
                    <a:pt x="825" y="3"/>
                  </a:lnTo>
                  <a:lnTo>
                    <a:pt x="828" y="3"/>
                  </a:lnTo>
                  <a:lnTo>
                    <a:pt x="830" y="3"/>
                  </a:lnTo>
                  <a:lnTo>
                    <a:pt x="832" y="3"/>
                  </a:lnTo>
                  <a:lnTo>
                    <a:pt x="835" y="3"/>
                  </a:lnTo>
                  <a:lnTo>
                    <a:pt x="839" y="3"/>
                  </a:lnTo>
                  <a:lnTo>
                    <a:pt x="842" y="3"/>
                  </a:lnTo>
                  <a:lnTo>
                    <a:pt x="845" y="3"/>
                  </a:lnTo>
                  <a:lnTo>
                    <a:pt x="848" y="3"/>
                  </a:lnTo>
                  <a:lnTo>
                    <a:pt x="850" y="3"/>
                  </a:lnTo>
                  <a:lnTo>
                    <a:pt x="852" y="3"/>
                  </a:lnTo>
                  <a:lnTo>
                    <a:pt x="853" y="3"/>
                  </a:lnTo>
                  <a:lnTo>
                    <a:pt x="855" y="3"/>
                  </a:lnTo>
                  <a:lnTo>
                    <a:pt x="855" y="3"/>
                  </a:lnTo>
                  <a:lnTo>
                    <a:pt x="857" y="3"/>
                  </a:lnTo>
                  <a:lnTo>
                    <a:pt x="858" y="3"/>
                  </a:lnTo>
                  <a:lnTo>
                    <a:pt x="859" y="3"/>
                  </a:lnTo>
                  <a:lnTo>
                    <a:pt x="861" y="3"/>
                  </a:lnTo>
                  <a:lnTo>
                    <a:pt x="862" y="3"/>
                  </a:lnTo>
                  <a:lnTo>
                    <a:pt x="864" y="3"/>
                  </a:lnTo>
                  <a:lnTo>
                    <a:pt x="866" y="3"/>
                  </a:lnTo>
                  <a:lnTo>
                    <a:pt x="868" y="3"/>
                  </a:lnTo>
                  <a:lnTo>
                    <a:pt x="870" y="3"/>
                  </a:lnTo>
                  <a:lnTo>
                    <a:pt x="874" y="3"/>
                  </a:lnTo>
                  <a:lnTo>
                    <a:pt x="878" y="3"/>
                  </a:lnTo>
                  <a:lnTo>
                    <a:pt x="879" y="2"/>
                  </a:lnTo>
                  <a:lnTo>
                    <a:pt x="880" y="2"/>
                  </a:lnTo>
                  <a:lnTo>
                    <a:pt x="882" y="2"/>
                  </a:lnTo>
                  <a:lnTo>
                    <a:pt x="884" y="2"/>
                  </a:lnTo>
                  <a:lnTo>
                    <a:pt x="886" y="2"/>
                  </a:lnTo>
                  <a:lnTo>
                    <a:pt x="889" y="2"/>
                  </a:lnTo>
                  <a:lnTo>
                    <a:pt x="891" y="2"/>
                  </a:lnTo>
                  <a:lnTo>
                    <a:pt x="893" y="2"/>
                  </a:lnTo>
                  <a:lnTo>
                    <a:pt x="896" y="2"/>
                  </a:lnTo>
                  <a:lnTo>
                    <a:pt x="899" y="2"/>
                  </a:lnTo>
                  <a:lnTo>
                    <a:pt x="902" y="2"/>
                  </a:lnTo>
                  <a:lnTo>
                    <a:pt x="904" y="2"/>
                  </a:lnTo>
                  <a:lnTo>
                    <a:pt x="906" y="2"/>
                  </a:lnTo>
                  <a:lnTo>
                    <a:pt x="907" y="2"/>
                  </a:lnTo>
                  <a:lnTo>
                    <a:pt x="909" y="2"/>
                  </a:lnTo>
                  <a:lnTo>
                    <a:pt x="911" y="2"/>
                  </a:lnTo>
                  <a:lnTo>
                    <a:pt x="913" y="2"/>
                  </a:lnTo>
                  <a:lnTo>
                    <a:pt x="916" y="2"/>
                  </a:lnTo>
                  <a:lnTo>
                    <a:pt x="920" y="2"/>
                  </a:lnTo>
                  <a:lnTo>
                    <a:pt x="925" y="2"/>
                  </a:lnTo>
                  <a:lnTo>
                    <a:pt x="930" y="2"/>
                  </a:lnTo>
                  <a:lnTo>
                    <a:pt x="934" y="2"/>
                  </a:lnTo>
                  <a:lnTo>
                    <a:pt x="938" y="2"/>
                  </a:lnTo>
                  <a:lnTo>
                    <a:pt x="941" y="2"/>
                  </a:lnTo>
                  <a:lnTo>
                    <a:pt x="944" y="2"/>
                  </a:lnTo>
                  <a:lnTo>
                    <a:pt x="947" y="2"/>
                  </a:lnTo>
                  <a:lnTo>
                    <a:pt x="950" y="2"/>
                  </a:lnTo>
                  <a:lnTo>
                    <a:pt x="953" y="2"/>
                  </a:lnTo>
                  <a:lnTo>
                    <a:pt x="956" y="2"/>
                  </a:lnTo>
                  <a:lnTo>
                    <a:pt x="957" y="2"/>
                  </a:lnTo>
                  <a:lnTo>
                    <a:pt x="959" y="1"/>
                  </a:lnTo>
                  <a:lnTo>
                    <a:pt x="962" y="1"/>
                  </a:lnTo>
                  <a:lnTo>
                    <a:pt x="964" y="1"/>
                  </a:lnTo>
                  <a:lnTo>
                    <a:pt x="967" y="1"/>
                  </a:lnTo>
                  <a:lnTo>
                    <a:pt x="970" y="1"/>
                  </a:lnTo>
                  <a:lnTo>
                    <a:pt x="974" y="1"/>
                  </a:lnTo>
                  <a:lnTo>
                    <a:pt x="977" y="1"/>
                  </a:lnTo>
                  <a:lnTo>
                    <a:pt x="981" y="1"/>
                  </a:lnTo>
                  <a:lnTo>
                    <a:pt x="983" y="1"/>
                  </a:lnTo>
                  <a:lnTo>
                    <a:pt x="984" y="1"/>
                  </a:lnTo>
                  <a:lnTo>
                    <a:pt x="986" y="1"/>
                  </a:lnTo>
                  <a:lnTo>
                    <a:pt x="988" y="1"/>
                  </a:lnTo>
                  <a:lnTo>
                    <a:pt x="989" y="1"/>
                  </a:lnTo>
                  <a:lnTo>
                    <a:pt x="992" y="1"/>
                  </a:lnTo>
                  <a:lnTo>
                    <a:pt x="996" y="1"/>
                  </a:lnTo>
                  <a:lnTo>
                    <a:pt x="1001" y="1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3" name="Freeform 139">
              <a:extLst>
                <a:ext uri="{FF2B5EF4-FFF2-40B4-BE49-F238E27FC236}">
                  <a16:creationId xmlns:a16="http://schemas.microsoft.com/office/drawing/2014/main" id="{0A802CB5-85BB-43C3-8387-7C937FCB52AD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1450" y="1624013"/>
              <a:ext cx="858838" cy="1809750"/>
            </a:xfrm>
            <a:custGeom>
              <a:avLst/>
              <a:gdLst>
                <a:gd name="T0" fmla="*/ 20 w 541"/>
                <a:gd name="T1" fmla="*/ 1140 h 1140"/>
                <a:gd name="T2" fmla="*/ 50 w 541"/>
                <a:gd name="T3" fmla="*/ 1140 h 1140"/>
                <a:gd name="T4" fmla="*/ 67 w 541"/>
                <a:gd name="T5" fmla="*/ 1140 h 1140"/>
                <a:gd name="T6" fmla="*/ 95 w 541"/>
                <a:gd name="T7" fmla="*/ 1139 h 1140"/>
                <a:gd name="T8" fmla="*/ 113 w 541"/>
                <a:gd name="T9" fmla="*/ 1139 h 1140"/>
                <a:gd name="T10" fmla="*/ 135 w 541"/>
                <a:gd name="T11" fmla="*/ 1139 h 1140"/>
                <a:gd name="T12" fmla="*/ 154 w 541"/>
                <a:gd name="T13" fmla="*/ 1138 h 1140"/>
                <a:gd name="T14" fmla="*/ 167 w 541"/>
                <a:gd name="T15" fmla="*/ 1138 h 1140"/>
                <a:gd name="T16" fmla="*/ 182 w 541"/>
                <a:gd name="T17" fmla="*/ 1138 h 1140"/>
                <a:gd name="T18" fmla="*/ 193 w 541"/>
                <a:gd name="T19" fmla="*/ 1137 h 1140"/>
                <a:gd name="T20" fmla="*/ 208 w 541"/>
                <a:gd name="T21" fmla="*/ 1136 h 1140"/>
                <a:gd name="T22" fmla="*/ 215 w 541"/>
                <a:gd name="T23" fmla="*/ 1136 h 1140"/>
                <a:gd name="T24" fmla="*/ 232 w 541"/>
                <a:gd name="T25" fmla="*/ 1134 h 1140"/>
                <a:gd name="T26" fmla="*/ 246 w 541"/>
                <a:gd name="T27" fmla="*/ 1133 h 1140"/>
                <a:gd name="T28" fmla="*/ 265 w 541"/>
                <a:gd name="T29" fmla="*/ 1132 h 1140"/>
                <a:gd name="T30" fmla="*/ 286 w 541"/>
                <a:gd name="T31" fmla="*/ 1130 h 1140"/>
                <a:gd name="T32" fmla="*/ 300 w 541"/>
                <a:gd name="T33" fmla="*/ 1128 h 1140"/>
                <a:gd name="T34" fmla="*/ 313 w 541"/>
                <a:gd name="T35" fmla="*/ 1127 h 1140"/>
                <a:gd name="T36" fmla="*/ 322 w 541"/>
                <a:gd name="T37" fmla="*/ 1125 h 1140"/>
                <a:gd name="T38" fmla="*/ 336 w 541"/>
                <a:gd name="T39" fmla="*/ 1122 h 1140"/>
                <a:gd name="T40" fmla="*/ 340 w 541"/>
                <a:gd name="T41" fmla="*/ 1121 h 1140"/>
                <a:gd name="T42" fmla="*/ 349 w 541"/>
                <a:gd name="T43" fmla="*/ 1118 h 1140"/>
                <a:gd name="T44" fmla="*/ 361 w 541"/>
                <a:gd name="T45" fmla="*/ 1112 h 1140"/>
                <a:gd name="T46" fmla="*/ 365 w 541"/>
                <a:gd name="T47" fmla="*/ 1109 h 1140"/>
                <a:gd name="T48" fmla="*/ 373 w 541"/>
                <a:gd name="T49" fmla="*/ 1103 h 1140"/>
                <a:gd name="T50" fmla="*/ 381 w 541"/>
                <a:gd name="T51" fmla="*/ 1096 h 1140"/>
                <a:gd name="T52" fmla="*/ 387 w 541"/>
                <a:gd name="T53" fmla="*/ 1088 h 1140"/>
                <a:gd name="T54" fmla="*/ 390 w 541"/>
                <a:gd name="T55" fmla="*/ 1083 h 1140"/>
                <a:gd name="T56" fmla="*/ 399 w 541"/>
                <a:gd name="T57" fmla="*/ 1068 h 1140"/>
                <a:gd name="T58" fmla="*/ 408 w 541"/>
                <a:gd name="T59" fmla="*/ 1049 h 1140"/>
                <a:gd name="T60" fmla="*/ 414 w 541"/>
                <a:gd name="T61" fmla="*/ 1034 h 1140"/>
                <a:gd name="T62" fmla="*/ 415 w 541"/>
                <a:gd name="T63" fmla="*/ 1029 h 1140"/>
                <a:gd name="T64" fmla="*/ 434 w 541"/>
                <a:gd name="T65" fmla="*/ 972 h 1140"/>
                <a:gd name="T66" fmla="*/ 441 w 541"/>
                <a:gd name="T67" fmla="*/ 952 h 1140"/>
                <a:gd name="T68" fmla="*/ 454 w 541"/>
                <a:gd name="T69" fmla="*/ 912 h 1140"/>
                <a:gd name="T70" fmla="*/ 465 w 541"/>
                <a:gd name="T71" fmla="*/ 871 h 1140"/>
                <a:gd name="T72" fmla="*/ 468 w 541"/>
                <a:gd name="T73" fmla="*/ 857 h 1140"/>
                <a:gd name="T74" fmla="*/ 478 w 541"/>
                <a:gd name="T75" fmla="*/ 804 h 1140"/>
                <a:gd name="T76" fmla="*/ 484 w 541"/>
                <a:gd name="T77" fmla="*/ 760 h 1140"/>
                <a:gd name="T78" fmla="*/ 488 w 541"/>
                <a:gd name="T79" fmla="*/ 707 h 1140"/>
                <a:gd name="T80" fmla="*/ 491 w 541"/>
                <a:gd name="T81" fmla="*/ 675 h 1140"/>
                <a:gd name="T82" fmla="*/ 492 w 541"/>
                <a:gd name="T83" fmla="*/ 660 h 1140"/>
                <a:gd name="T84" fmla="*/ 498 w 541"/>
                <a:gd name="T85" fmla="*/ 560 h 1140"/>
                <a:gd name="T86" fmla="*/ 502 w 541"/>
                <a:gd name="T87" fmla="*/ 492 h 1140"/>
                <a:gd name="T88" fmla="*/ 506 w 541"/>
                <a:gd name="T89" fmla="*/ 452 h 1140"/>
                <a:gd name="T90" fmla="*/ 512 w 541"/>
                <a:gd name="T91" fmla="*/ 413 h 1140"/>
                <a:gd name="T92" fmla="*/ 515 w 541"/>
                <a:gd name="T93" fmla="*/ 385 h 1140"/>
                <a:gd name="T94" fmla="*/ 516 w 541"/>
                <a:gd name="T95" fmla="*/ 369 h 1140"/>
                <a:gd name="T96" fmla="*/ 516 w 541"/>
                <a:gd name="T97" fmla="*/ 360 h 1140"/>
                <a:gd name="T98" fmla="*/ 518 w 541"/>
                <a:gd name="T99" fmla="*/ 328 h 1140"/>
                <a:gd name="T100" fmla="*/ 520 w 541"/>
                <a:gd name="T101" fmla="*/ 269 h 1140"/>
                <a:gd name="T102" fmla="*/ 524 w 541"/>
                <a:gd name="T103" fmla="*/ 152 h 1140"/>
                <a:gd name="T104" fmla="*/ 526 w 541"/>
                <a:gd name="T105" fmla="*/ 70 h 1140"/>
                <a:gd name="T106" fmla="*/ 528 w 541"/>
                <a:gd name="T107" fmla="*/ 27 h 1140"/>
                <a:gd name="T108" fmla="*/ 530 w 541"/>
                <a:gd name="T109" fmla="*/ 5 h 1140"/>
                <a:gd name="T110" fmla="*/ 531 w 541"/>
                <a:gd name="T111" fmla="*/ 0 h 1140"/>
                <a:gd name="T112" fmla="*/ 532 w 541"/>
                <a:gd name="T113" fmla="*/ 10 h 1140"/>
                <a:gd name="T114" fmla="*/ 534 w 541"/>
                <a:gd name="T115" fmla="*/ 32 h 1140"/>
                <a:gd name="T116" fmla="*/ 535 w 541"/>
                <a:gd name="T117" fmla="*/ 69 h 1140"/>
                <a:gd name="T118" fmla="*/ 536 w 541"/>
                <a:gd name="T119" fmla="*/ 123 h 1140"/>
                <a:gd name="T120" fmla="*/ 537 w 541"/>
                <a:gd name="T121" fmla="*/ 195 h 1140"/>
                <a:gd name="T122" fmla="*/ 539 w 541"/>
                <a:gd name="T123" fmla="*/ 316 h 1140"/>
                <a:gd name="T124" fmla="*/ 541 w 541"/>
                <a:gd name="T125" fmla="*/ 448 h 1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541" h="1140">
                  <a:moveTo>
                    <a:pt x="0" y="1140"/>
                  </a:moveTo>
                  <a:lnTo>
                    <a:pt x="3" y="1140"/>
                  </a:lnTo>
                  <a:lnTo>
                    <a:pt x="6" y="1140"/>
                  </a:lnTo>
                  <a:lnTo>
                    <a:pt x="8" y="1140"/>
                  </a:lnTo>
                  <a:lnTo>
                    <a:pt x="10" y="1140"/>
                  </a:lnTo>
                  <a:lnTo>
                    <a:pt x="13" y="1140"/>
                  </a:lnTo>
                  <a:lnTo>
                    <a:pt x="17" y="1140"/>
                  </a:lnTo>
                  <a:lnTo>
                    <a:pt x="20" y="1140"/>
                  </a:lnTo>
                  <a:lnTo>
                    <a:pt x="24" y="1140"/>
                  </a:lnTo>
                  <a:lnTo>
                    <a:pt x="28" y="1140"/>
                  </a:lnTo>
                  <a:lnTo>
                    <a:pt x="32" y="1140"/>
                  </a:lnTo>
                  <a:lnTo>
                    <a:pt x="35" y="1140"/>
                  </a:lnTo>
                  <a:lnTo>
                    <a:pt x="38" y="1140"/>
                  </a:lnTo>
                  <a:lnTo>
                    <a:pt x="41" y="1140"/>
                  </a:lnTo>
                  <a:lnTo>
                    <a:pt x="45" y="1140"/>
                  </a:lnTo>
                  <a:lnTo>
                    <a:pt x="50" y="1140"/>
                  </a:lnTo>
                  <a:lnTo>
                    <a:pt x="54" y="1140"/>
                  </a:lnTo>
                  <a:lnTo>
                    <a:pt x="56" y="1140"/>
                  </a:lnTo>
                  <a:lnTo>
                    <a:pt x="58" y="1140"/>
                  </a:lnTo>
                  <a:lnTo>
                    <a:pt x="59" y="1140"/>
                  </a:lnTo>
                  <a:lnTo>
                    <a:pt x="61" y="1140"/>
                  </a:lnTo>
                  <a:lnTo>
                    <a:pt x="63" y="1140"/>
                  </a:lnTo>
                  <a:lnTo>
                    <a:pt x="65" y="1140"/>
                  </a:lnTo>
                  <a:lnTo>
                    <a:pt x="67" y="1140"/>
                  </a:lnTo>
                  <a:lnTo>
                    <a:pt x="69" y="1140"/>
                  </a:lnTo>
                  <a:lnTo>
                    <a:pt x="72" y="1140"/>
                  </a:lnTo>
                  <a:lnTo>
                    <a:pt x="74" y="1140"/>
                  </a:lnTo>
                  <a:lnTo>
                    <a:pt x="77" y="1140"/>
                  </a:lnTo>
                  <a:lnTo>
                    <a:pt x="81" y="1140"/>
                  </a:lnTo>
                  <a:lnTo>
                    <a:pt x="87" y="1140"/>
                  </a:lnTo>
                  <a:lnTo>
                    <a:pt x="92" y="1139"/>
                  </a:lnTo>
                  <a:lnTo>
                    <a:pt x="95" y="1139"/>
                  </a:lnTo>
                  <a:lnTo>
                    <a:pt x="98" y="1139"/>
                  </a:lnTo>
                  <a:lnTo>
                    <a:pt x="101" y="1139"/>
                  </a:lnTo>
                  <a:lnTo>
                    <a:pt x="104" y="1139"/>
                  </a:lnTo>
                  <a:lnTo>
                    <a:pt x="107" y="1139"/>
                  </a:lnTo>
                  <a:lnTo>
                    <a:pt x="108" y="1139"/>
                  </a:lnTo>
                  <a:lnTo>
                    <a:pt x="109" y="1139"/>
                  </a:lnTo>
                  <a:lnTo>
                    <a:pt x="111" y="1139"/>
                  </a:lnTo>
                  <a:lnTo>
                    <a:pt x="113" y="1139"/>
                  </a:lnTo>
                  <a:lnTo>
                    <a:pt x="117" y="1139"/>
                  </a:lnTo>
                  <a:lnTo>
                    <a:pt x="121" y="1139"/>
                  </a:lnTo>
                  <a:lnTo>
                    <a:pt x="124" y="1139"/>
                  </a:lnTo>
                  <a:lnTo>
                    <a:pt x="127" y="1139"/>
                  </a:lnTo>
                  <a:lnTo>
                    <a:pt x="130" y="1139"/>
                  </a:lnTo>
                  <a:lnTo>
                    <a:pt x="132" y="1139"/>
                  </a:lnTo>
                  <a:lnTo>
                    <a:pt x="134" y="1139"/>
                  </a:lnTo>
                  <a:lnTo>
                    <a:pt x="135" y="1139"/>
                  </a:lnTo>
                  <a:lnTo>
                    <a:pt x="135" y="1139"/>
                  </a:lnTo>
                  <a:lnTo>
                    <a:pt x="137" y="1139"/>
                  </a:lnTo>
                  <a:lnTo>
                    <a:pt x="139" y="1139"/>
                  </a:lnTo>
                  <a:lnTo>
                    <a:pt x="142" y="1139"/>
                  </a:lnTo>
                  <a:lnTo>
                    <a:pt x="145" y="1139"/>
                  </a:lnTo>
                  <a:lnTo>
                    <a:pt x="148" y="1139"/>
                  </a:lnTo>
                  <a:lnTo>
                    <a:pt x="150" y="1138"/>
                  </a:lnTo>
                  <a:lnTo>
                    <a:pt x="154" y="1138"/>
                  </a:lnTo>
                  <a:lnTo>
                    <a:pt x="156" y="1138"/>
                  </a:lnTo>
                  <a:lnTo>
                    <a:pt x="159" y="1138"/>
                  </a:lnTo>
                  <a:lnTo>
                    <a:pt x="160" y="1138"/>
                  </a:lnTo>
                  <a:lnTo>
                    <a:pt x="161" y="1138"/>
                  </a:lnTo>
                  <a:lnTo>
                    <a:pt x="162" y="1138"/>
                  </a:lnTo>
                  <a:lnTo>
                    <a:pt x="164" y="1138"/>
                  </a:lnTo>
                  <a:lnTo>
                    <a:pt x="165" y="1138"/>
                  </a:lnTo>
                  <a:lnTo>
                    <a:pt x="167" y="1138"/>
                  </a:lnTo>
                  <a:lnTo>
                    <a:pt x="169" y="1138"/>
                  </a:lnTo>
                  <a:lnTo>
                    <a:pt x="170" y="1138"/>
                  </a:lnTo>
                  <a:lnTo>
                    <a:pt x="172" y="1138"/>
                  </a:lnTo>
                  <a:lnTo>
                    <a:pt x="174" y="1138"/>
                  </a:lnTo>
                  <a:lnTo>
                    <a:pt x="175" y="1138"/>
                  </a:lnTo>
                  <a:lnTo>
                    <a:pt x="177" y="1138"/>
                  </a:lnTo>
                  <a:lnTo>
                    <a:pt x="180" y="1138"/>
                  </a:lnTo>
                  <a:lnTo>
                    <a:pt x="182" y="1138"/>
                  </a:lnTo>
                  <a:lnTo>
                    <a:pt x="183" y="1138"/>
                  </a:lnTo>
                  <a:lnTo>
                    <a:pt x="184" y="1138"/>
                  </a:lnTo>
                  <a:lnTo>
                    <a:pt x="185" y="1138"/>
                  </a:lnTo>
                  <a:lnTo>
                    <a:pt x="186" y="1138"/>
                  </a:lnTo>
                  <a:lnTo>
                    <a:pt x="187" y="1138"/>
                  </a:lnTo>
                  <a:lnTo>
                    <a:pt x="189" y="1137"/>
                  </a:lnTo>
                  <a:lnTo>
                    <a:pt x="190" y="1137"/>
                  </a:lnTo>
                  <a:lnTo>
                    <a:pt x="193" y="1137"/>
                  </a:lnTo>
                  <a:lnTo>
                    <a:pt x="196" y="1137"/>
                  </a:lnTo>
                  <a:lnTo>
                    <a:pt x="198" y="1137"/>
                  </a:lnTo>
                  <a:lnTo>
                    <a:pt x="200" y="1137"/>
                  </a:lnTo>
                  <a:lnTo>
                    <a:pt x="201" y="1137"/>
                  </a:lnTo>
                  <a:lnTo>
                    <a:pt x="203" y="1137"/>
                  </a:lnTo>
                  <a:lnTo>
                    <a:pt x="204" y="1137"/>
                  </a:lnTo>
                  <a:lnTo>
                    <a:pt x="206" y="1137"/>
                  </a:lnTo>
                  <a:lnTo>
                    <a:pt x="208" y="1136"/>
                  </a:lnTo>
                  <a:lnTo>
                    <a:pt x="209" y="1136"/>
                  </a:lnTo>
                  <a:lnTo>
                    <a:pt x="210" y="1136"/>
                  </a:lnTo>
                  <a:lnTo>
                    <a:pt x="211" y="1136"/>
                  </a:lnTo>
                  <a:lnTo>
                    <a:pt x="211" y="1136"/>
                  </a:lnTo>
                  <a:lnTo>
                    <a:pt x="211" y="1136"/>
                  </a:lnTo>
                  <a:lnTo>
                    <a:pt x="212" y="1136"/>
                  </a:lnTo>
                  <a:lnTo>
                    <a:pt x="213" y="1136"/>
                  </a:lnTo>
                  <a:lnTo>
                    <a:pt x="215" y="1136"/>
                  </a:lnTo>
                  <a:lnTo>
                    <a:pt x="216" y="1136"/>
                  </a:lnTo>
                  <a:lnTo>
                    <a:pt x="218" y="1135"/>
                  </a:lnTo>
                  <a:lnTo>
                    <a:pt x="219" y="1135"/>
                  </a:lnTo>
                  <a:lnTo>
                    <a:pt x="221" y="1135"/>
                  </a:lnTo>
                  <a:lnTo>
                    <a:pt x="224" y="1135"/>
                  </a:lnTo>
                  <a:lnTo>
                    <a:pt x="226" y="1135"/>
                  </a:lnTo>
                  <a:lnTo>
                    <a:pt x="229" y="1134"/>
                  </a:lnTo>
                  <a:lnTo>
                    <a:pt x="232" y="1134"/>
                  </a:lnTo>
                  <a:lnTo>
                    <a:pt x="233" y="1134"/>
                  </a:lnTo>
                  <a:lnTo>
                    <a:pt x="235" y="1134"/>
                  </a:lnTo>
                  <a:lnTo>
                    <a:pt x="236" y="1134"/>
                  </a:lnTo>
                  <a:lnTo>
                    <a:pt x="237" y="1134"/>
                  </a:lnTo>
                  <a:lnTo>
                    <a:pt x="237" y="1134"/>
                  </a:lnTo>
                  <a:lnTo>
                    <a:pt x="239" y="1134"/>
                  </a:lnTo>
                  <a:lnTo>
                    <a:pt x="242" y="1133"/>
                  </a:lnTo>
                  <a:lnTo>
                    <a:pt x="246" y="1133"/>
                  </a:lnTo>
                  <a:lnTo>
                    <a:pt x="250" y="1133"/>
                  </a:lnTo>
                  <a:lnTo>
                    <a:pt x="253" y="1133"/>
                  </a:lnTo>
                  <a:lnTo>
                    <a:pt x="256" y="1132"/>
                  </a:lnTo>
                  <a:lnTo>
                    <a:pt x="259" y="1132"/>
                  </a:lnTo>
                  <a:lnTo>
                    <a:pt x="261" y="1132"/>
                  </a:lnTo>
                  <a:lnTo>
                    <a:pt x="262" y="1132"/>
                  </a:lnTo>
                  <a:lnTo>
                    <a:pt x="263" y="1132"/>
                  </a:lnTo>
                  <a:lnTo>
                    <a:pt x="265" y="1132"/>
                  </a:lnTo>
                  <a:lnTo>
                    <a:pt x="269" y="1131"/>
                  </a:lnTo>
                  <a:lnTo>
                    <a:pt x="273" y="1131"/>
                  </a:lnTo>
                  <a:lnTo>
                    <a:pt x="277" y="1131"/>
                  </a:lnTo>
                  <a:lnTo>
                    <a:pt x="280" y="1130"/>
                  </a:lnTo>
                  <a:lnTo>
                    <a:pt x="282" y="1130"/>
                  </a:lnTo>
                  <a:lnTo>
                    <a:pt x="284" y="1130"/>
                  </a:lnTo>
                  <a:lnTo>
                    <a:pt x="285" y="1130"/>
                  </a:lnTo>
                  <a:lnTo>
                    <a:pt x="286" y="1130"/>
                  </a:lnTo>
                  <a:lnTo>
                    <a:pt x="287" y="1130"/>
                  </a:lnTo>
                  <a:lnTo>
                    <a:pt x="288" y="1130"/>
                  </a:lnTo>
                  <a:lnTo>
                    <a:pt x="288" y="1129"/>
                  </a:lnTo>
                  <a:lnTo>
                    <a:pt x="290" y="1129"/>
                  </a:lnTo>
                  <a:lnTo>
                    <a:pt x="292" y="1129"/>
                  </a:lnTo>
                  <a:lnTo>
                    <a:pt x="295" y="1129"/>
                  </a:lnTo>
                  <a:lnTo>
                    <a:pt x="297" y="1129"/>
                  </a:lnTo>
                  <a:lnTo>
                    <a:pt x="300" y="1128"/>
                  </a:lnTo>
                  <a:lnTo>
                    <a:pt x="303" y="1128"/>
                  </a:lnTo>
                  <a:lnTo>
                    <a:pt x="305" y="1128"/>
                  </a:lnTo>
                  <a:lnTo>
                    <a:pt x="308" y="1127"/>
                  </a:lnTo>
                  <a:lnTo>
                    <a:pt x="310" y="1127"/>
                  </a:lnTo>
                  <a:lnTo>
                    <a:pt x="311" y="1127"/>
                  </a:lnTo>
                  <a:lnTo>
                    <a:pt x="312" y="1127"/>
                  </a:lnTo>
                  <a:lnTo>
                    <a:pt x="312" y="1127"/>
                  </a:lnTo>
                  <a:lnTo>
                    <a:pt x="313" y="1127"/>
                  </a:lnTo>
                  <a:lnTo>
                    <a:pt x="314" y="1127"/>
                  </a:lnTo>
                  <a:lnTo>
                    <a:pt x="314" y="1127"/>
                  </a:lnTo>
                  <a:lnTo>
                    <a:pt x="315" y="1127"/>
                  </a:lnTo>
                  <a:lnTo>
                    <a:pt x="316" y="1126"/>
                  </a:lnTo>
                  <a:lnTo>
                    <a:pt x="318" y="1126"/>
                  </a:lnTo>
                  <a:lnTo>
                    <a:pt x="319" y="1126"/>
                  </a:lnTo>
                  <a:lnTo>
                    <a:pt x="320" y="1126"/>
                  </a:lnTo>
                  <a:lnTo>
                    <a:pt x="322" y="1125"/>
                  </a:lnTo>
                  <a:lnTo>
                    <a:pt x="323" y="1125"/>
                  </a:lnTo>
                  <a:lnTo>
                    <a:pt x="325" y="1125"/>
                  </a:lnTo>
                  <a:lnTo>
                    <a:pt x="327" y="1124"/>
                  </a:lnTo>
                  <a:lnTo>
                    <a:pt x="328" y="1124"/>
                  </a:lnTo>
                  <a:lnTo>
                    <a:pt x="330" y="1123"/>
                  </a:lnTo>
                  <a:lnTo>
                    <a:pt x="333" y="1123"/>
                  </a:lnTo>
                  <a:lnTo>
                    <a:pt x="335" y="1122"/>
                  </a:lnTo>
                  <a:lnTo>
                    <a:pt x="336" y="1122"/>
                  </a:lnTo>
                  <a:lnTo>
                    <a:pt x="337" y="1122"/>
                  </a:lnTo>
                  <a:lnTo>
                    <a:pt x="337" y="1122"/>
                  </a:lnTo>
                  <a:lnTo>
                    <a:pt x="338" y="1122"/>
                  </a:lnTo>
                  <a:lnTo>
                    <a:pt x="338" y="1121"/>
                  </a:lnTo>
                  <a:lnTo>
                    <a:pt x="339" y="1121"/>
                  </a:lnTo>
                  <a:lnTo>
                    <a:pt x="339" y="1121"/>
                  </a:lnTo>
                  <a:lnTo>
                    <a:pt x="339" y="1121"/>
                  </a:lnTo>
                  <a:lnTo>
                    <a:pt x="340" y="1121"/>
                  </a:lnTo>
                  <a:lnTo>
                    <a:pt x="340" y="1121"/>
                  </a:lnTo>
                  <a:lnTo>
                    <a:pt x="342" y="1120"/>
                  </a:lnTo>
                  <a:lnTo>
                    <a:pt x="343" y="1120"/>
                  </a:lnTo>
                  <a:lnTo>
                    <a:pt x="344" y="1120"/>
                  </a:lnTo>
                  <a:lnTo>
                    <a:pt x="345" y="1119"/>
                  </a:lnTo>
                  <a:lnTo>
                    <a:pt x="346" y="1119"/>
                  </a:lnTo>
                  <a:lnTo>
                    <a:pt x="348" y="1118"/>
                  </a:lnTo>
                  <a:lnTo>
                    <a:pt x="349" y="1118"/>
                  </a:lnTo>
                  <a:lnTo>
                    <a:pt x="351" y="1117"/>
                  </a:lnTo>
                  <a:lnTo>
                    <a:pt x="352" y="1117"/>
                  </a:lnTo>
                  <a:lnTo>
                    <a:pt x="353" y="1116"/>
                  </a:lnTo>
                  <a:lnTo>
                    <a:pt x="355" y="1115"/>
                  </a:lnTo>
                  <a:lnTo>
                    <a:pt x="356" y="1114"/>
                  </a:lnTo>
                  <a:lnTo>
                    <a:pt x="358" y="1114"/>
                  </a:lnTo>
                  <a:lnTo>
                    <a:pt x="359" y="1113"/>
                  </a:lnTo>
                  <a:lnTo>
                    <a:pt x="361" y="1112"/>
                  </a:lnTo>
                  <a:lnTo>
                    <a:pt x="362" y="1112"/>
                  </a:lnTo>
                  <a:lnTo>
                    <a:pt x="362" y="1111"/>
                  </a:lnTo>
                  <a:lnTo>
                    <a:pt x="363" y="1111"/>
                  </a:lnTo>
                  <a:lnTo>
                    <a:pt x="363" y="1110"/>
                  </a:lnTo>
                  <a:lnTo>
                    <a:pt x="364" y="1110"/>
                  </a:lnTo>
                  <a:lnTo>
                    <a:pt x="364" y="1110"/>
                  </a:lnTo>
                  <a:lnTo>
                    <a:pt x="365" y="1110"/>
                  </a:lnTo>
                  <a:lnTo>
                    <a:pt x="365" y="1109"/>
                  </a:lnTo>
                  <a:lnTo>
                    <a:pt x="365" y="1109"/>
                  </a:lnTo>
                  <a:lnTo>
                    <a:pt x="366" y="1109"/>
                  </a:lnTo>
                  <a:lnTo>
                    <a:pt x="367" y="1108"/>
                  </a:lnTo>
                  <a:lnTo>
                    <a:pt x="369" y="1107"/>
                  </a:lnTo>
                  <a:lnTo>
                    <a:pt x="370" y="1106"/>
                  </a:lnTo>
                  <a:lnTo>
                    <a:pt x="371" y="1105"/>
                  </a:lnTo>
                  <a:lnTo>
                    <a:pt x="372" y="1104"/>
                  </a:lnTo>
                  <a:lnTo>
                    <a:pt x="373" y="1103"/>
                  </a:lnTo>
                  <a:lnTo>
                    <a:pt x="374" y="1102"/>
                  </a:lnTo>
                  <a:lnTo>
                    <a:pt x="375" y="1102"/>
                  </a:lnTo>
                  <a:lnTo>
                    <a:pt x="376" y="1101"/>
                  </a:lnTo>
                  <a:lnTo>
                    <a:pt x="377" y="1100"/>
                  </a:lnTo>
                  <a:lnTo>
                    <a:pt x="378" y="1099"/>
                  </a:lnTo>
                  <a:lnTo>
                    <a:pt x="379" y="1098"/>
                  </a:lnTo>
                  <a:lnTo>
                    <a:pt x="380" y="1097"/>
                  </a:lnTo>
                  <a:lnTo>
                    <a:pt x="381" y="1096"/>
                  </a:lnTo>
                  <a:lnTo>
                    <a:pt x="381" y="1095"/>
                  </a:lnTo>
                  <a:lnTo>
                    <a:pt x="382" y="1094"/>
                  </a:lnTo>
                  <a:lnTo>
                    <a:pt x="383" y="1093"/>
                  </a:lnTo>
                  <a:lnTo>
                    <a:pt x="384" y="1092"/>
                  </a:lnTo>
                  <a:lnTo>
                    <a:pt x="385" y="1091"/>
                  </a:lnTo>
                  <a:lnTo>
                    <a:pt x="386" y="1090"/>
                  </a:lnTo>
                  <a:lnTo>
                    <a:pt x="387" y="1089"/>
                  </a:lnTo>
                  <a:lnTo>
                    <a:pt x="387" y="1088"/>
                  </a:lnTo>
                  <a:lnTo>
                    <a:pt x="388" y="1087"/>
                  </a:lnTo>
                  <a:lnTo>
                    <a:pt x="388" y="1086"/>
                  </a:lnTo>
                  <a:lnTo>
                    <a:pt x="389" y="1086"/>
                  </a:lnTo>
                  <a:lnTo>
                    <a:pt x="389" y="1085"/>
                  </a:lnTo>
                  <a:lnTo>
                    <a:pt x="389" y="1085"/>
                  </a:lnTo>
                  <a:lnTo>
                    <a:pt x="390" y="1084"/>
                  </a:lnTo>
                  <a:lnTo>
                    <a:pt x="390" y="1084"/>
                  </a:lnTo>
                  <a:lnTo>
                    <a:pt x="390" y="1083"/>
                  </a:lnTo>
                  <a:lnTo>
                    <a:pt x="390" y="1083"/>
                  </a:lnTo>
                  <a:lnTo>
                    <a:pt x="391" y="1082"/>
                  </a:lnTo>
                  <a:lnTo>
                    <a:pt x="392" y="1080"/>
                  </a:lnTo>
                  <a:lnTo>
                    <a:pt x="393" y="1078"/>
                  </a:lnTo>
                  <a:lnTo>
                    <a:pt x="395" y="1076"/>
                  </a:lnTo>
                  <a:lnTo>
                    <a:pt x="396" y="1073"/>
                  </a:lnTo>
                  <a:lnTo>
                    <a:pt x="397" y="1071"/>
                  </a:lnTo>
                  <a:lnTo>
                    <a:pt x="399" y="1068"/>
                  </a:lnTo>
                  <a:lnTo>
                    <a:pt x="400" y="1066"/>
                  </a:lnTo>
                  <a:lnTo>
                    <a:pt x="401" y="1063"/>
                  </a:lnTo>
                  <a:lnTo>
                    <a:pt x="402" y="1061"/>
                  </a:lnTo>
                  <a:lnTo>
                    <a:pt x="404" y="1058"/>
                  </a:lnTo>
                  <a:lnTo>
                    <a:pt x="405" y="1056"/>
                  </a:lnTo>
                  <a:lnTo>
                    <a:pt x="406" y="1054"/>
                  </a:lnTo>
                  <a:lnTo>
                    <a:pt x="407" y="1051"/>
                  </a:lnTo>
                  <a:lnTo>
                    <a:pt x="408" y="1049"/>
                  </a:lnTo>
                  <a:lnTo>
                    <a:pt x="409" y="1047"/>
                  </a:lnTo>
                  <a:lnTo>
                    <a:pt x="410" y="1044"/>
                  </a:lnTo>
                  <a:lnTo>
                    <a:pt x="411" y="1042"/>
                  </a:lnTo>
                  <a:lnTo>
                    <a:pt x="412" y="1039"/>
                  </a:lnTo>
                  <a:lnTo>
                    <a:pt x="412" y="1037"/>
                  </a:lnTo>
                  <a:lnTo>
                    <a:pt x="413" y="1035"/>
                  </a:lnTo>
                  <a:lnTo>
                    <a:pt x="413" y="1034"/>
                  </a:lnTo>
                  <a:lnTo>
                    <a:pt x="414" y="1034"/>
                  </a:lnTo>
                  <a:lnTo>
                    <a:pt x="414" y="1033"/>
                  </a:lnTo>
                  <a:lnTo>
                    <a:pt x="414" y="1032"/>
                  </a:lnTo>
                  <a:lnTo>
                    <a:pt x="414" y="1032"/>
                  </a:lnTo>
                  <a:lnTo>
                    <a:pt x="414" y="1031"/>
                  </a:lnTo>
                  <a:lnTo>
                    <a:pt x="415" y="1031"/>
                  </a:lnTo>
                  <a:lnTo>
                    <a:pt x="415" y="1030"/>
                  </a:lnTo>
                  <a:lnTo>
                    <a:pt x="415" y="1030"/>
                  </a:lnTo>
                  <a:lnTo>
                    <a:pt x="415" y="1029"/>
                  </a:lnTo>
                  <a:lnTo>
                    <a:pt x="415" y="1029"/>
                  </a:lnTo>
                  <a:lnTo>
                    <a:pt x="416" y="1027"/>
                  </a:lnTo>
                  <a:lnTo>
                    <a:pt x="418" y="1020"/>
                  </a:lnTo>
                  <a:lnTo>
                    <a:pt x="421" y="1011"/>
                  </a:lnTo>
                  <a:lnTo>
                    <a:pt x="424" y="1002"/>
                  </a:lnTo>
                  <a:lnTo>
                    <a:pt x="427" y="992"/>
                  </a:lnTo>
                  <a:lnTo>
                    <a:pt x="431" y="982"/>
                  </a:lnTo>
                  <a:lnTo>
                    <a:pt x="434" y="972"/>
                  </a:lnTo>
                  <a:lnTo>
                    <a:pt x="437" y="963"/>
                  </a:lnTo>
                  <a:lnTo>
                    <a:pt x="439" y="958"/>
                  </a:lnTo>
                  <a:lnTo>
                    <a:pt x="439" y="957"/>
                  </a:lnTo>
                  <a:lnTo>
                    <a:pt x="440" y="956"/>
                  </a:lnTo>
                  <a:lnTo>
                    <a:pt x="440" y="954"/>
                  </a:lnTo>
                  <a:lnTo>
                    <a:pt x="440" y="954"/>
                  </a:lnTo>
                  <a:lnTo>
                    <a:pt x="440" y="953"/>
                  </a:lnTo>
                  <a:lnTo>
                    <a:pt x="441" y="952"/>
                  </a:lnTo>
                  <a:lnTo>
                    <a:pt x="441" y="952"/>
                  </a:lnTo>
                  <a:lnTo>
                    <a:pt x="442" y="948"/>
                  </a:lnTo>
                  <a:lnTo>
                    <a:pt x="444" y="941"/>
                  </a:lnTo>
                  <a:lnTo>
                    <a:pt x="446" y="934"/>
                  </a:lnTo>
                  <a:lnTo>
                    <a:pt x="449" y="927"/>
                  </a:lnTo>
                  <a:lnTo>
                    <a:pt x="451" y="921"/>
                  </a:lnTo>
                  <a:lnTo>
                    <a:pt x="452" y="916"/>
                  </a:lnTo>
                  <a:lnTo>
                    <a:pt x="454" y="912"/>
                  </a:lnTo>
                  <a:lnTo>
                    <a:pt x="455" y="908"/>
                  </a:lnTo>
                  <a:lnTo>
                    <a:pt x="456" y="903"/>
                  </a:lnTo>
                  <a:lnTo>
                    <a:pt x="458" y="897"/>
                  </a:lnTo>
                  <a:lnTo>
                    <a:pt x="460" y="890"/>
                  </a:lnTo>
                  <a:lnTo>
                    <a:pt x="462" y="883"/>
                  </a:lnTo>
                  <a:lnTo>
                    <a:pt x="463" y="877"/>
                  </a:lnTo>
                  <a:lnTo>
                    <a:pt x="464" y="873"/>
                  </a:lnTo>
                  <a:lnTo>
                    <a:pt x="465" y="871"/>
                  </a:lnTo>
                  <a:lnTo>
                    <a:pt x="465" y="870"/>
                  </a:lnTo>
                  <a:lnTo>
                    <a:pt x="465" y="869"/>
                  </a:lnTo>
                  <a:lnTo>
                    <a:pt x="466" y="868"/>
                  </a:lnTo>
                  <a:lnTo>
                    <a:pt x="466" y="867"/>
                  </a:lnTo>
                  <a:lnTo>
                    <a:pt x="466" y="866"/>
                  </a:lnTo>
                  <a:lnTo>
                    <a:pt x="466" y="865"/>
                  </a:lnTo>
                  <a:lnTo>
                    <a:pt x="467" y="862"/>
                  </a:lnTo>
                  <a:lnTo>
                    <a:pt x="468" y="857"/>
                  </a:lnTo>
                  <a:lnTo>
                    <a:pt x="469" y="851"/>
                  </a:lnTo>
                  <a:lnTo>
                    <a:pt x="470" y="845"/>
                  </a:lnTo>
                  <a:lnTo>
                    <a:pt x="472" y="839"/>
                  </a:lnTo>
                  <a:lnTo>
                    <a:pt x="473" y="832"/>
                  </a:lnTo>
                  <a:lnTo>
                    <a:pt x="474" y="825"/>
                  </a:lnTo>
                  <a:lnTo>
                    <a:pt x="475" y="818"/>
                  </a:lnTo>
                  <a:lnTo>
                    <a:pt x="476" y="811"/>
                  </a:lnTo>
                  <a:lnTo>
                    <a:pt x="478" y="804"/>
                  </a:lnTo>
                  <a:lnTo>
                    <a:pt x="479" y="798"/>
                  </a:lnTo>
                  <a:lnTo>
                    <a:pt x="479" y="792"/>
                  </a:lnTo>
                  <a:lnTo>
                    <a:pt x="480" y="787"/>
                  </a:lnTo>
                  <a:lnTo>
                    <a:pt x="481" y="782"/>
                  </a:lnTo>
                  <a:lnTo>
                    <a:pt x="482" y="776"/>
                  </a:lnTo>
                  <a:lnTo>
                    <a:pt x="482" y="771"/>
                  </a:lnTo>
                  <a:lnTo>
                    <a:pt x="483" y="765"/>
                  </a:lnTo>
                  <a:lnTo>
                    <a:pt x="484" y="760"/>
                  </a:lnTo>
                  <a:lnTo>
                    <a:pt x="484" y="754"/>
                  </a:lnTo>
                  <a:lnTo>
                    <a:pt x="485" y="748"/>
                  </a:lnTo>
                  <a:lnTo>
                    <a:pt x="485" y="742"/>
                  </a:lnTo>
                  <a:lnTo>
                    <a:pt x="486" y="735"/>
                  </a:lnTo>
                  <a:lnTo>
                    <a:pt x="487" y="729"/>
                  </a:lnTo>
                  <a:lnTo>
                    <a:pt x="487" y="722"/>
                  </a:lnTo>
                  <a:lnTo>
                    <a:pt x="488" y="715"/>
                  </a:lnTo>
                  <a:lnTo>
                    <a:pt x="488" y="707"/>
                  </a:lnTo>
                  <a:lnTo>
                    <a:pt x="489" y="699"/>
                  </a:lnTo>
                  <a:lnTo>
                    <a:pt x="489" y="693"/>
                  </a:lnTo>
                  <a:lnTo>
                    <a:pt x="490" y="689"/>
                  </a:lnTo>
                  <a:lnTo>
                    <a:pt x="490" y="686"/>
                  </a:lnTo>
                  <a:lnTo>
                    <a:pt x="490" y="683"/>
                  </a:lnTo>
                  <a:lnTo>
                    <a:pt x="490" y="680"/>
                  </a:lnTo>
                  <a:lnTo>
                    <a:pt x="490" y="677"/>
                  </a:lnTo>
                  <a:lnTo>
                    <a:pt x="491" y="675"/>
                  </a:lnTo>
                  <a:lnTo>
                    <a:pt x="491" y="672"/>
                  </a:lnTo>
                  <a:lnTo>
                    <a:pt x="491" y="670"/>
                  </a:lnTo>
                  <a:lnTo>
                    <a:pt x="491" y="668"/>
                  </a:lnTo>
                  <a:lnTo>
                    <a:pt x="491" y="666"/>
                  </a:lnTo>
                  <a:lnTo>
                    <a:pt x="491" y="665"/>
                  </a:lnTo>
                  <a:lnTo>
                    <a:pt x="491" y="663"/>
                  </a:lnTo>
                  <a:lnTo>
                    <a:pt x="492" y="662"/>
                  </a:lnTo>
                  <a:lnTo>
                    <a:pt x="492" y="660"/>
                  </a:lnTo>
                  <a:lnTo>
                    <a:pt x="492" y="655"/>
                  </a:lnTo>
                  <a:lnTo>
                    <a:pt x="493" y="644"/>
                  </a:lnTo>
                  <a:lnTo>
                    <a:pt x="493" y="634"/>
                  </a:lnTo>
                  <a:lnTo>
                    <a:pt x="494" y="622"/>
                  </a:lnTo>
                  <a:lnTo>
                    <a:pt x="495" y="609"/>
                  </a:lnTo>
                  <a:lnTo>
                    <a:pt x="496" y="594"/>
                  </a:lnTo>
                  <a:lnTo>
                    <a:pt x="497" y="576"/>
                  </a:lnTo>
                  <a:lnTo>
                    <a:pt x="498" y="560"/>
                  </a:lnTo>
                  <a:lnTo>
                    <a:pt x="498" y="548"/>
                  </a:lnTo>
                  <a:lnTo>
                    <a:pt x="499" y="538"/>
                  </a:lnTo>
                  <a:lnTo>
                    <a:pt x="500" y="529"/>
                  </a:lnTo>
                  <a:lnTo>
                    <a:pt x="500" y="520"/>
                  </a:lnTo>
                  <a:lnTo>
                    <a:pt x="501" y="513"/>
                  </a:lnTo>
                  <a:lnTo>
                    <a:pt x="501" y="506"/>
                  </a:lnTo>
                  <a:lnTo>
                    <a:pt x="502" y="499"/>
                  </a:lnTo>
                  <a:lnTo>
                    <a:pt x="502" y="492"/>
                  </a:lnTo>
                  <a:lnTo>
                    <a:pt x="503" y="486"/>
                  </a:lnTo>
                  <a:lnTo>
                    <a:pt x="503" y="480"/>
                  </a:lnTo>
                  <a:lnTo>
                    <a:pt x="504" y="475"/>
                  </a:lnTo>
                  <a:lnTo>
                    <a:pt x="504" y="470"/>
                  </a:lnTo>
                  <a:lnTo>
                    <a:pt x="505" y="465"/>
                  </a:lnTo>
                  <a:lnTo>
                    <a:pt x="505" y="461"/>
                  </a:lnTo>
                  <a:lnTo>
                    <a:pt x="505" y="456"/>
                  </a:lnTo>
                  <a:lnTo>
                    <a:pt x="506" y="452"/>
                  </a:lnTo>
                  <a:lnTo>
                    <a:pt x="506" y="447"/>
                  </a:lnTo>
                  <a:lnTo>
                    <a:pt x="507" y="443"/>
                  </a:lnTo>
                  <a:lnTo>
                    <a:pt x="508" y="438"/>
                  </a:lnTo>
                  <a:lnTo>
                    <a:pt x="508" y="433"/>
                  </a:lnTo>
                  <a:lnTo>
                    <a:pt x="509" y="428"/>
                  </a:lnTo>
                  <a:lnTo>
                    <a:pt x="510" y="422"/>
                  </a:lnTo>
                  <a:lnTo>
                    <a:pt x="511" y="417"/>
                  </a:lnTo>
                  <a:lnTo>
                    <a:pt x="512" y="413"/>
                  </a:lnTo>
                  <a:lnTo>
                    <a:pt x="512" y="409"/>
                  </a:lnTo>
                  <a:lnTo>
                    <a:pt x="513" y="406"/>
                  </a:lnTo>
                  <a:lnTo>
                    <a:pt x="513" y="403"/>
                  </a:lnTo>
                  <a:lnTo>
                    <a:pt x="513" y="399"/>
                  </a:lnTo>
                  <a:lnTo>
                    <a:pt x="514" y="396"/>
                  </a:lnTo>
                  <a:lnTo>
                    <a:pt x="514" y="392"/>
                  </a:lnTo>
                  <a:lnTo>
                    <a:pt x="514" y="389"/>
                  </a:lnTo>
                  <a:lnTo>
                    <a:pt x="515" y="385"/>
                  </a:lnTo>
                  <a:lnTo>
                    <a:pt x="515" y="381"/>
                  </a:lnTo>
                  <a:lnTo>
                    <a:pt x="515" y="378"/>
                  </a:lnTo>
                  <a:lnTo>
                    <a:pt x="515" y="377"/>
                  </a:lnTo>
                  <a:lnTo>
                    <a:pt x="516" y="375"/>
                  </a:lnTo>
                  <a:lnTo>
                    <a:pt x="516" y="373"/>
                  </a:lnTo>
                  <a:lnTo>
                    <a:pt x="516" y="372"/>
                  </a:lnTo>
                  <a:lnTo>
                    <a:pt x="516" y="371"/>
                  </a:lnTo>
                  <a:lnTo>
                    <a:pt x="516" y="369"/>
                  </a:lnTo>
                  <a:lnTo>
                    <a:pt x="516" y="368"/>
                  </a:lnTo>
                  <a:lnTo>
                    <a:pt x="516" y="367"/>
                  </a:lnTo>
                  <a:lnTo>
                    <a:pt x="516" y="365"/>
                  </a:lnTo>
                  <a:lnTo>
                    <a:pt x="516" y="364"/>
                  </a:lnTo>
                  <a:lnTo>
                    <a:pt x="516" y="363"/>
                  </a:lnTo>
                  <a:lnTo>
                    <a:pt x="516" y="362"/>
                  </a:lnTo>
                  <a:lnTo>
                    <a:pt x="516" y="361"/>
                  </a:lnTo>
                  <a:lnTo>
                    <a:pt x="516" y="360"/>
                  </a:lnTo>
                  <a:lnTo>
                    <a:pt x="516" y="360"/>
                  </a:lnTo>
                  <a:lnTo>
                    <a:pt x="516" y="359"/>
                  </a:lnTo>
                  <a:lnTo>
                    <a:pt x="517" y="356"/>
                  </a:lnTo>
                  <a:lnTo>
                    <a:pt x="517" y="351"/>
                  </a:lnTo>
                  <a:lnTo>
                    <a:pt x="517" y="345"/>
                  </a:lnTo>
                  <a:lnTo>
                    <a:pt x="517" y="340"/>
                  </a:lnTo>
                  <a:lnTo>
                    <a:pt x="518" y="334"/>
                  </a:lnTo>
                  <a:lnTo>
                    <a:pt x="518" y="328"/>
                  </a:lnTo>
                  <a:lnTo>
                    <a:pt x="518" y="322"/>
                  </a:lnTo>
                  <a:lnTo>
                    <a:pt x="519" y="315"/>
                  </a:lnTo>
                  <a:lnTo>
                    <a:pt x="519" y="309"/>
                  </a:lnTo>
                  <a:lnTo>
                    <a:pt x="519" y="302"/>
                  </a:lnTo>
                  <a:lnTo>
                    <a:pt x="519" y="294"/>
                  </a:lnTo>
                  <a:lnTo>
                    <a:pt x="520" y="286"/>
                  </a:lnTo>
                  <a:lnTo>
                    <a:pt x="520" y="278"/>
                  </a:lnTo>
                  <a:lnTo>
                    <a:pt x="520" y="269"/>
                  </a:lnTo>
                  <a:lnTo>
                    <a:pt x="521" y="259"/>
                  </a:lnTo>
                  <a:lnTo>
                    <a:pt x="521" y="249"/>
                  </a:lnTo>
                  <a:lnTo>
                    <a:pt x="521" y="238"/>
                  </a:lnTo>
                  <a:lnTo>
                    <a:pt x="522" y="226"/>
                  </a:lnTo>
                  <a:lnTo>
                    <a:pt x="522" y="212"/>
                  </a:lnTo>
                  <a:lnTo>
                    <a:pt x="523" y="193"/>
                  </a:lnTo>
                  <a:lnTo>
                    <a:pt x="523" y="171"/>
                  </a:lnTo>
                  <a:lnTo>
                    <a:pt x="524" y="152"/>
                  </a:lnTo>
                  <a:lnTo>
                    <a:pt x="524" y="137"/>
                  </a:lnTo>
                  <a:lnTo>
                    <a:pt x="525" y="125"/>
                  </a:lnTo>
                  <a:lnTo>
                    <a:pt x="525" y="113"/>
                  </a:lnTo>
                  <a:lnTo>
                    <a:pt x="525" y="103"/>
                  </a:lnTo>
                  <a:lnTo>
                    <a:pt x="526" y="94"/>
                  </a:lnTo>
                  <a:lnTo>
                    <a:pt x="526" y="85"/>
                  </a:lnTo>
                  <a:lnTo>
                    <a:pt x="526" y="77"/>
                  </a:lnTo>
                  <a:lnTo>
                    <a:pt x="526" y="70"/>
                  </a:lnTo>
                  <a:lnTo>
                    <a:pt x="527" y="63"/>
                  </a:lnTo>
                  <a:lnTo>
                    <a:pt x="527" y="57"/>
                  </a:lnTo>
                  <a:lnTo>
                    <a:pt x="527" y="51"/>
                  </a:lnTo>
                  <a:lnTo>
                    <a:pt x="527" y="45"/>
                  </a:lnTo>
                  <a:lnTo>
                    <a:pt x="528" y="40"/>
                  </a:lnTo>
                  <a:lnTo>
                    <a:pt x="528" y="35"/>
                  </a:lnTo>
                  <a:lnTo>
                    <a:pt x="528" y="31"/>
                  </a:lnTo>
                  <a:lnTo>
                    <a:pt x="528" y="27"/>
                  </a:lnTo>
                  <a:lnTo>
                    <a:pt x="529" y="23"/>
                  </a:lnTo>
                  <a:lnTo>
                    <a:pt x="529" y="20"/>
                  </a:lnTo>
                  <a:lnTo>
                    <a:pt x="529" y="17"/>
                  </a:lnTo>
                  <a:lnTo>
                    <a:pt x="529" y="14"/>
                  </a:lnTo>
                  <a:lnTo>
                    <a:pt x="529" y="11"/>
                  </a:lnTo>
                  <a:lnTo>
                    <a:pt x="529" y="9"/>
                  </a:lnTo>
                  <a:lnTo>
                    <a:pt x="530" y="7"/>
                  </a:lnTo>
                  <a:lnTo>
                    <a:pt x="530" y="5"/>
                  </a:lnTo>
                  <a:lnTo>
                    <a:pt x="530" y="4"/>
                  </a:lnTo>
                  <a:lnTo>
                    <a:pt x="530" y="3"/>
                  </a:lnTo>
                  <a:lnTo>
                    <a:pt x="530" y="2"/>
                  </a:lnTo>
                  <a:lnTo>
                    <a:pt x="531" y="1"/>
                  </a:lnTo>
                  <a:lnTo>
                    <a:pt x="531" y="1"/>
                  </a:lnTo>
                  <a:lnTo>
                    <a:pt x="531" y="0"/>
                  </a:lnTo>
                  <a:lnTo>
                    <a:pt x="531" y="0"/>
                  </a:lnTo>
                  <a:lnTo>
                    <a:pt x="531" y="0"/>
                  </a:lnTo>
                  <a:lnTo>
                    <a:pt x="531" y="1"/>
                  </a:lnTo>
                  <a:lnTo>
                    <a:pt x="532" y="2"/>
                  </a:lnTo>
                  <a:lnTo>
                    <a:pt x="532" y="3"/>
                  </a:lnTo>
                  <a:lnTo>
                    <a:pt x="532" y="4"/>
                  </a:lnTo>
                  <a:lnTo>
                    <a:pt x="532" y="5"/>
                  </a:lnTo>
                  <a:lnTo>
                    <a:pt x="532" y="6"/>
                  </a:lnTo>
                  <a:lnTo>
                    <a:pt x="532" y="8"/>
                  </a:lnTo>
                  <a:lnTo>
                    <a:pt x="532" y="10"/>
                  </a:lnTo>
                  <a:lnTo>
                    <a:pt x="533" y="12"/>
                  </a:lnTo>
                  <a:lnTo>
                    <a:pt x="533" y="14"/>
                  </a:lnTo>
                  <a:lnTo>
                    <a:pt x="533" y="16"/>
                  </a:lnTo>
                  <a:lnTo>
                    <a:pt x="533" y="19"/>
                  </a:lnTo>
                  <a:lnTo>
                    <a:pt x="533" y="22"/>
                  </a:lnTo>
                  <a:lnTo>
                    <a:pt x="533" y="25"/>
                  </a:lnTo>
                  <a:lnTo>
                    <a:pt x="534" y="28"/>
                  </a:lnTo>
                  <a:lnTo>
                    <a:pt x="534" y="32"/>
                  </a:lnTo>
                  <a:lnTo>
                    <a:pt x="534" y="35"/>
                  </a:lnTo>
                  <a:lnTo>
                    <a:pt x="534" y="40"/>
                  </a:lnTo>
                  <a:lnTo>
                    <a:pt x="534" y="44"/>
                  </a:lnTo>
                  <a:lnTo>
                    <a:pt x="534" y="48"/>
                  </a:lnTo>
                  <a:lnTo>
                    <a:pt x="534" y="53"/>
                  </a:lnTo>
                  <a:lnTo>
                    <a:pt x="535" y="58"/>
                  </a:lnTo>
                  <a:lnTo>
                    <a:pt x="535" y="63"/>
                  </a:lnTo>
                  <a:lnTo>
                    <a:pt x="535" y="69"/>
                  </a:lnTo>
                  <a:lnTo>
                    <a:pt x="535" y="75"/>
                  </a:lnTo>
                  <a:lnTo>
                    <a:pt x="535" y="81"/>
                  </a:lnTo>
                  <a:lnTo>
                    <a:pt x="535" y="87"/>
                  </a:lnTo>
                  <a:lnTo>
                    <a:pt x="536" y="94"/>
                  </a:lnTo>
                  <a:lnTo>
                    <a:pt x="536" y="101"/>
                  </a:lnTo>
                  <a:lnTo>
                    <a:pt x="536" y="108"/>
                  </a:lnTo>
                  <a:lnTo>
                    <a:pt x="536" y="115"/>
                  </a:lnTo>
                  <a:lnTo>
                    <a:pt x="536" y="123"/>
                  </a:lnTo>
                  <a:lnTo>
                    <a:pt x="536" y="131"/>
                  </a:lnTo>
                  <a:lnTo>
                    <a:pt x="536" y="138"/>
                  </a:lnTo>
                  <a:lnTo>
                    <a:pt x="537" y="147"/>
                  </a:lnTo>
                  <a:lnTo>
                    <a:pt x="537" y="155"/>
                  </a:lnTo>
                  <a:lnTo>
                    <a:pt x="537" y="164"/>
                  </a:lnTo>
                  <a:lnTo>
                    <a:pt x="537" y="174"/>
                  </a:lnTo>
                  <a:lnTo>
                    <a:pt x="537" y="184"/>
                  </a:lnTo>
                  <a:lnTo>
                    <a:pt x="537" y="195"/>
                  </a:lnTo>
                  <a:lnTo>
                    <a:pt x="537" y="207"/>
                  </a:lnTo>
                  <a:lnTo>
                    <a:pt x="538" y="219"/>
                  </a:lnTo>
                  <a:lnTo>
                    <a:pt x="538" y="232"/>
                  </a:lnTo>
                  <a:lnTo>
                    <a:pt x="538" y="246"/>
                  </a:lnTo>
                  <a:lnTo>
                    <a:pt x="538" y="260"/>
                  </a:lnTo>
                  <a:lnTo>
                    <a:pt x="539" y="277"/>
                  </a:lnTo>
                  <a:lnTo>
                    <a:pt x="539" y="296"/>
                  </a:lnTo>
                  <a:lnTo>
                    <a:pt x="539" y="316"/>
                  </a:lnTo>
                  <a:lnTo>
                    <a:pt x="539" y="341"/>
                  </a:lnTo>
                  <a:lnTo>
                    <a:pt x="540" y="374"/>
                  </a:lnTo>
                  <a:lnTo>
                    <a:pt x="540" y="408"/>
                  </a:lnTo>
                  <a:lnTo>
                    <a:pt x="541" y="428"/>
                  </a:lnTo>
                  <a:lnTo>
                    <a:pt x="541" y="437"/>
                  </a:lnTo>
                  <a:lnTo>
                    <a:pt x="541" y="441"/>
                  </a:lnTo>
                  <a:lnTo>
                    <a:pt x="541" y="445"/>
                  </a:lnTo>
                  <a:lnTo>
                    <a:pt x="541" y="448"/>
                  </a:lnTo>
                  <a:lnTo>
                    <a:pt x="541" y="452"/>
                  </a:lnTo>
                  <a:lnTo>
                    <a:pt x="541" y="455"/>
                  </a:lnTo>
                  <a:lnTo>
                    <a:pt x="541" y="459"/>
                  </a:lnTo>
                  <a:lnTo>
                    <a:pt x="541" y="463"/>
                  </a:lnTo>
                  <a:lnTo>
                    <a:pt x="541" y="466"/>
                  </a:lnTo>
                  <a:lnTo>
                    <a:pt x="541" y="470"/>
                  </a:lnTo>
                  <a:lnTo>
                    <a:pt x="541" y="473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4" name="Freeform 140">
              <a:extLst>
                <a:ext uri="{FF2B5EF4-FFF2-40B4-BE49-F238E27FC236}">
                  <a16:creationId xmlns:a16="http://schemas.microsoft.com/office/drawing/2014/main" id="{D91C6027-ABB7-4949-90D5-E6800361368E}"/>
                </a:ext>
              </a:extLst>
            </p:cNvPr>
            <p:cNvSpPr>
              <a:spLocks/>
            </p:cNvSpPr>
            <p:nvPr/>
          </p:nvSpPr>
          <p:spPr bwMode="auto">
            <a:xfrm>
              <a:off x="3570288" y="2374900"/>
              <a:ext cx="1266825" cy="1054100"/>
            </a:xfrm>
            <a:custGeom>
              <a:avLst/>
              <a:gdLst>
                <a:gd name="T0" fmla="*/ 1 w 798"/>
                <a:gd name="T1" fmla="*/ 23 h 664"/>
                <a:gd name="T2" fmla="*/ 2 w 798"/>
                <a:gd name="T3" fmla="*/ 115 h 664"/>
                <a:gd name="T4" fmla="*/ 3 w 798"/>
                <a:gd name="T5" fmla="*/ 195 h 664"/>
                <a:gd name="T6" fmla="*/ 5 w 798"/>
                <a:gd name="T7" fmla="*/ 258 h 664"/>
                <a:gd name="T8" fmla="*/ 6 w 798"/>
                <a:gd name="T9" fmla="*/ 312 h 664"/>
                <a:gd name="T10" fmla="*/ 8 w 798"/>
                <a:gd name="T11" fmla="*/ 356 h 664"/>
                <a:gd name="T12" fmla="*/ 10 w 798"/>
                <a:gd name="T13" fmla="*/ 389 h 664"/>
                <a:gd name="T14" fmla="*/ 13 w 798"/>
                <a:gd name="T15" fmla="*/ 415 h 664"/>
                <a:gd name="T16" fmla="*/ 17 w 798"/>
                <a:gd name="T17" fmla="*/ 444 h 664"/>
                <a:gd name="T18" fmla="*/ 21 w 798"/>
                <a:gd name="T19" fmla="*/ 470 h 664"/>
                <a:gd name="T20" fmla="*/ 25 w 798"/>
                <a:gd name="T21" fmla="*/ 518 h 664"/>
                <a:gd name="T22" fmla="*/ 27 w 798"/>
                <a:gd name="T23" fmla="*/ 537 h 664"/>
                <a:gd name="T24" fmla="*/ 28 w 798"/>
                <a:gd name="T25" fmla="*/ 551 h 664"/>
                <a:gd name="T26" fmla="*/ 31 w 798"/>
                <a:gd name="T27" fmla="*/ 577 h 664"/>
                <a:gd name="T28" fmla="*/ 33 w 798"/>
                <a:gd name="T29" fmla="*/ 597 h 664"/>
                <a:gd name="T30" fmla="*/ 36 w 798"/>
                <a:gd name="T31" fmla="*/ 615 h 664"/>
                <a:gd name="T32" fmla="*/ 38 w 798"/>
                <a:gd name="T33" fmla="*/ 625 h 664"/>
                <a:gd name="T34" fmla="*/ 40 w 798"/>
                <a:gd name="T35" fmla="*/ 633 h 664"/>
                <a:gd name="T36" fmla="*/ 42 w 798"/>
                <a:gd name="T37" fmla="*/ 640 h 664"/>
                <a:gd name="T38" fmla="*/ 44 w 798"/>
                <a:gd name="T39" fmla="*/ 646 h 664"/>
                <a:gd name="T40" fmla="*/ 46 w 798"/>
                <a:gd name="T41" fmla="*/ 649 h 664"/>
                <a:gd name="T42" fmla="*/ 48 w 798"/>
                <a:gd name="T43" fmla="*/ 651 h 664"/>
                <a:gd name="T44" fmla="*/ 51 w 798"/>
                <a:gd name="T45" fmla="*/ 654 h 664"/>
                <a:gd name="T46" fmla="*/ 54 w 798"/>
                <a:gd name="T47" fmla="*/ 656 h 664"/>
                <a:gd name="T48" fmla="*/ 60 w 798"/>
                <a:gd name="T49" fmla="*/ 658 h 664"/>
                <a:gd name="T50" fmla="*/ 68 w 798"/>
                <a:gd name="T51" fmla="*/ 659 h 664"/>
                <a:gd name="T52" fmla="*/ 80 w 798"/>
                <a:gd name="T53" fmla="*/ 661 h 664"/>
                <a:gd name="T54" fmla="*/ 101 w 798"/>
                <a:gd name="T55" fmla="*/ 662 h 664"/>
                <a:gd name="T56" fmla="*/ 115 w 798"/>
                <a:gd name="T57" fmla="*/ 662 h 664"/>
                <a:gd name="T58" fmla="*/ 134 w 798"/>
                <a:gd name="T59" fmla="*/ 663 h 664"/>
                <a:gd name="T60" fmla="*/ 156 w 798"/>
                <a:gd name="T61" fmla="*/ 663 h 664"/>
                <a:gd name="T62" fmla="*/ 176 w 798"/>
                <a:gd name="T63" fmla="*/ 663 h 664"/>
                <a:gd name="T64" fmla="*/ 187 w 798"/>
                <a:gd name="T65" fmla="*/ 663 h 664"/>
                <a:gd name="T66" fmla="*/ 207 w 798"/>
                <a:gd name="T67" fmla="*/ 664 h 664"/>
                <a:gd name="T68" fmla="*/ 225 w 798"/>
                <a:gd name="T69" fmla="*/ 664 h 664"/>
                <a:gd name="T70" fmla="*/ 239 w 798"/>
                <a:gd name="T71" fmla="*/ 664 h 664"/>
                <a:gd name="T72" fmla="*/ 264 w 798"/>
                <a:gd name="T73" fmla="*/ 664 h 664"/>
                <a:gd name="T74" fmla="*/ 282 w 798"/>
                <a:gd name="T75" fmla="*/ 664 h 664"/>
                <a:gd name="T76" fmla="*/ 304 w 798"/>
                <a:gd name="T77" fmla="*/ 664 h 664"/>
                <a:gd name="T78" fmla="*/ 324 w 798"/>
                <a:gd name="T79" fmla="*/ 664 h 664"/>
                <a:gd name="T80" fmla="*/ 339 w 798"/>
                <a:gd name="T81" fmla="*/ 664 h 664"/>
                <a:gd name="T82" fmla="*/ 359 w 798"/>
                <a:gd name="T83" fmla="*/ 663 h 664"/>
                <a:gd name="T84" fmla="*/ 373 w 798"/>
                <a:gd name="T85" fmla="*/ 663 h 664"/>
                <a:gd name="T86" fmla="*/ 387 w 798"/>
                <a:gd name="T87" fmla="*/ 663 h 664"/>
                <a:gd name="T88" fmla="*/ 407 w 798"/>
                <a:gd name="T89" fmla="*/ 664 h 664"/>
                <a:gd name="T90" fmla="*/ 425 w 798"/>
                <a:gd name="T91" fmla="*/ 664 h 664"/>
                <a:gd name="T92" fmla="*/ 444 w 798"/>
                <a:gd name="T93" fmla="*/ 663 h 664"/>
                <a:gd name="T94" fmla="*/ 470 w 798"/>
                <a:gd name="T95" fmla="*/ 663 h 664"/>
                <a:gd name="T96" fmla="*/ 491 w 798"/>
                <a:gd name="T97" fmla="*/ 663 h 664"/>
                <a:gd name="T98" fmla="*/ 518 w 798"/>
                <a:gd name="T99" fmla="*/ 663 h 664"/>
                <a:gd name="T100" fmla="*/ 543 w 798"/>
                <a:gd name="T101" fmla="*/ 663 h 664"/>
                <a:gd name="T102" fmla="*/ 563 w 798"/>
                <a:gd name="T103" fmla="*/ 663 h 664"/>
                <a:gd name="T104" fmla="*/ 575 w 798"/>
                <a:gd name="T105" fmla="*/ 663 h 664"/>
                <a:gd name="T106" fmla="*/ 591 w 798"/>
                <a:gd name="T107" fmla="*/ 662 h 664"/>
                <a:gd name="T108" fmla="*/ 611 w 798"/>
                <a:gd name="T109" fmla="*/ 661 h 664"/>
                <a:gd name="T110" fmla="*/ 635 w 798"/>
                <a:gd name="T111" fmla="*/ 661 h 664"/>
                <a:gd name="T112" fmla="*/ 651 w 798"/>
                <a:gd name="T113" fmla="*/ 661 h 664"/>
                <a:gd name="T114" fmla="*/ 671 w 798"/>
                <a:gd name="T115" fmla="*/ 661 h 664"/>
                <a:gd name="T116" fmla="*/ 690 w 798"/>
                <a:gd name="T117" fmla="*/ 661 h 664"/>
                <a:gd name="T118" fmla="*/ 716 w 798"/>
                <a:gd name="T119" fmla="*/ 661 h 664"/>
                <a:gd name="T120" fmla="*/ 734 w 798"/>
                <a:gd name="T121" fmla="*/ 662 h 664"/>
                <a:gd name="T122" fmla="*/ 749 w 798"/>
                <a:gd name="T123" fmla="*/ 662 h 664"/>
                <a:gd name="T124" fmla="*/ 768 w 798"/>
                <a:gd name="T125" fmla="*/ 662 h 6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798" h="664">
                  <a:moveTo>
                    <a:pt x="0" y="0"/>
                  </a:moveTo>
                  <a:lnTo>
                    <a:pt x="0" y="2"/>
                  </a:lnTo>
                  <a:lnTo>
                    <a:pt x="0" y="5"/>
                  </a:lnTo>
                  <a:lnTo>
                    <a:pt x="0" y="9"/>
                  </a:lnTo>
                  <a:lnTo>
                    <a:pt x="1" y="12"/>
                  </a:lnTo>
                  <a:lnTo>
                    <a:pt x="1" y="16"/>
                  </a:lnTo>
                  <a:lnTo>
                    <a:pt x="1" y="19"/>
                  </a:lnTo>
                  <a:lnTo>
                    <a:pt x="1" y="23"/>
                  </a:lnTo>
                  <a:lnTo>
                    <a:pt x="1" y="26"/>
                  </a:lnTo>
                  <a:lnTo>
                    <a:pt x="1" y="35"/>
                  </a:lnTo>
                  <a:lnTo>
                    <a:pt x="1" y="50"/>
                  </a:lnTo>
                  <a:lnTo>
                    <a:pt x="1" y="64"/>
                  </a:lnTo>
                  <a:lnTo>
                    <a:pt x="1" y="77"/>
                  </a:lnTo>
                  <a:lnTo>
                    <a:pt x="2" y="90"/>
                  </a:lnTo>
                  <a:lnTo>
                    <a:pt x="2" y="103"/>
                  </a:lnTo>
                  <a:lnTo>
                    <a:pt x="2" y="115"/>
                  </a:lnTo>
                  <a:lnTo>
                    <a:pt x="2" y="127"/>
                  </a:lnTo>
                  <a:lnTo>
                    <a:pt x="2" y="138"/>
                  </a:lnTo>
                  <a:lnTo>
                    <a:pt x="3" y="148"/>
                  </a:lnTo>
                  <a:lnTo>
                    <a:pt x="3" y="158"/>
                  </a:lnTo>
                  <a:lnTo>
                    <a:pt x="3" y="167"/>
                  </a:lnTo>
                  <a:lnTo>
                    <a:pt x="3" y="177"/>
                  </a:lnTo>
                  <a:lnTo>
                    <a:pt x="3" y="186"/>
                  </a:lnTo>
                  <a:lnTo>
                    <a:pt x="3" y="195"/>
                  </a:lnTo>
                  <a:lnTo>
                    <a:pt x="4" y="204"/>
                  </a:lnTo>
                  <a:lnTo>
                    <a:pt x="4" y="212"/>
                  </a:lnTo>
                  <a:lnTo>
                    <a:pt x="4" y="220"/>
                  </a:lnTo>
                  <a:lnTo>
                    <a:pt x="4" y="229"/>
                  </a:lnTo>
                  <a:lnTo>
                    <a:pt x="4" y="236"/>
                  </a:lnTo>
                  <a:lnTo>
                    <a:pt x="5" y="244"/>
                  </a:lnTo>
                  <a:lnTo>
                    <a:pt x="5" y="251"/>
                  </a:lnTo>
                  <a:lnTo>
                    <a:pt x="5" y="258"/>
                  </a:lnTo>
                  <a:lnTo>
                    <a:pt x="5" y="265"/>
                  </a:lnTo>
                  <a:lnTo>
                    <a:pt x="5" y="272"/>
                  </a:lnTo>
                  <a:lnTo>
                    <a:pt x="5" y="279"/>
                  </a:lnTo>
                  <a:lnTo>
                    <a:pt x="6" y="286"/>
                  </a:lnTo>
                  <a:lnTo>
                    <a:pt x="6" y="293"/>
                  </a:lnTo>
                  <a:lnTo>
                    <a:pt x="6" y="300"/>
                  </a:lnTo>
                  <a:lnTo>
                    <a:pt x="6" y="306"/>
                  </a:lnTo>
                  <a:lnTo>
                    <a:pt x="6" y="312"/>
                  </a:lnTo>
                  <a:lnTo>
                    <a:pt x="7" y="318"/>
                  </a:lnTo>
                  <a:lnTo>
                    <a:pt x="7" y="324"/>
                  </a:lnTo>
                  <a:lnTo>
                    <a:pt x="7" y="329"/>
                  </a:lnTo>
                  <a:lnTo>
                    <a:pt x="7" y="335"/>
                  </a:lnTo>
                  <a:lnTo>
                    <a:pt x="7" y="340"/>
                  </a:lnTo>
                  <a:lnTo>
                    <a:pt x="8" y="346"/>
                  </a:lnTo>
                  <a:lnTo>
                    <a:pt x="8" y="351"/>
                  </a:lnTo>
                  <a:lnTo>
                    <a:pt x="8" y="356"/>
                  </a:lnTo>
                  <a:lnTo>
                    <a:pt x="8" y="360"/>
                  </a:lnTo>
                  <a:lnTo>
                    <a:pt x="9" y="365"/>
                  </a:lnTo>
                  <a:lnTo>
                    <a:pt x="9" y="369"/>
                  </a:lnTo>
                  <a:lnTo>
                    <a:pt x="9" y="373"/>
                  </a:lnTo>
                  <a:lnTo>
                    <a:pt x="9" y="378"/>
                  </a:lnTo>
                  <a:lnTo>
                    <a:pt x="10" y="382"/>
                  </a:lnTo>
                  <a:lnTo>
                    <a:pt x="10" y="385"/>
                  </a:lnTo>
                  <a:lnTo>
                    <a:pt x="10" y="389"/>
                  </a:lnTo>
                  <a:lnTo>
                    <a:pt x="10" y="393"/>
                  </a:lnTo>
                  <a:lnTo>
                    <a:pt x="11" y="396"/>
                  </a:lnTo>
                  <a:lnTo>
                    <a:pt x="11" y="400"/>
                  </a:lnTo>
                  <a:lnTo>
                    <a:pt x="11" y="403"/>
                  </a:lnTo>
                  <a:lnTo>
                    <a:pt x="12" y="406"/>
                  </a:lnTo>
                  <a:lnTo>
                    <a:pt x="12" y="409"/>
                  </a:lnTo>
                  <a:lnTo>
                    <a:pt x="12" y="412"/>
                  </a:lnTo>
                  <a:lnTo>
                    <a:pt x="13" y="415"/>
                  </a:lnTo>
                  <a:lnTo>
                    <a:pt x="13" y="418"/>
                  </a:lnTo>
                  <a:lnTo>
                    <a:pt x="14" y="420"/>
                  </a:lnTo>
                  <a:lnTo>
                    <a:pt x="14" y="424"/>
                  </a:lnTo>
                  <a:lnTo>
                    <a:pt x="15" y="427"/>
                  </a:lnTo>
                  <a:lnTo>
                    <a:pt x="16" y="432"/>
                  </a:lnTo>
                  <a:lnTo>
                    <a:pt x="16" y="437"/>
                  </a:lnTo>
                  <a:lnTo>
                    <a:pt x="17" y="440"/>
                  </a:lnTo>
                  <a:lnTo>
                    <a:pt x="17" y="444"/>
                  </a:lnTo>
                  <a:lnTo>
                    <a:pt x="18" y="447"/>
                  </a:lnTo>
                  <a:lnTo>
                    <a:pt x="18" y="450"/>
                  </a:lnTo>
                  <a:lnTo>
                    <a:pt x="19" y="453"/>
                  </a:lnTo>
                  <a:lnTo>
                    <a:pt x="19" y="456"/>
                  </a:lnTo>
                  <a:lnTo>
                    <a:pt x="20" y="459"/>
                  </a:lnTo>
                  <a:lnTo>
                    <a:pt x="20" y="463"/>
                  </a:lnTo>
                  <a:lnTo>
                    <a:pt x="20" y="466"/>
                  </a:lnTo>
                  <a:lnTo>
                    <a:pt x="21" y="470"/>
                  </a:lnTo>
                  <a:lnTo>
                    <a:pt x="21" y="474"/>
                  </a:lnTo>
                  <a:lnTo>
                    <a:pt x="22" y="478"/>
                  </a:lnTo>
                  <a:lnTo>
                    <a:pt x="22" y="483"/>
                  </a:lnTo>
                  <a:lnTo>
                    <a:pt x="22" y="488"/>
                  </a:lnTo>
                  <a:lnTo>
                    <a:pt x="23" y="494"/>
                  </a:lnTo>
                  <a:lnTo>
                    <a:pt x="24" y="500"/>
                  </a:lnTo>
                  <a:lnTo>
                    <a:pt x="24" y="509"/>
                  </a:lnTo>
                  <a:lnTo>
                    <a:pt x="25" y="518"/>
                  </a:lnTo>
                  <a:lnTo>
                    <a:pt x="25" y="523"/>
                  </a:lnTo>
                  <a:lnTo>
                    <a:pt x="26" y="525"/>
                  </a:lnTo>
                  <a:lnTo>
                    <a:pt x="26" y="528"/>
                  </a:lnTo>
                  <a:lnTo>
                    <a:pt x="26" y="530"/>
                  </a:lnTo>
                  <a:lnTo>
                    <a:pt x="26" y="532"/>
                  </a:lnTo>
                  <a:lnTo>
                    <a:pt x="26" y="534"/>
                  </a:lnTo>
                  <a:lnTo>
                    <a:pt x="27" y="536"/>
                  </a:lnTo>
                  <a:lnTo>
                    <a:pt x="27" y="537"/>
                  </a:lnTo>
                  <a:lnTo>
                    <a:pt x="27" y="538"/>
                  </a:lnTo>
                  <a:lnTo>
                    <a:pt x="27" y="540"/>
                  </a:lnTo>
                  <a:lnTo>
                    <a:pt x="27" y="541"/>
                  </a:lnTo>
                  <a:lnTo>
                    <a:pt x="27" y="542"/>
                  </a:lnTo>
                  <a:lnTo>
                    <a:pt x="27" y="543"/>
                  </a:lnTo>
                  <a:lnTo>
                    <a:pt x="27" y="543"/>
                  </a:lnTo>
                  <a:lnTo>
                    <a:pt x="27" y="546"/>
                  </a:lnTo>
                  <a:lnTo>
                    <a:pt x="28" y="551"/>
                  </a:lnTo>
                  <a:lnTo>
                    <a:pt x="28" y="555"/>
                  </a:lnTo>
                  <a:lnTo>
                    <a:pt x="29" y="558"/>
                  </a:lnTo>
                  <a:lnTo>
                    <a:pt x="29" y="562"/>
                  </a:lnTo>
                  <a:lnTo>
                    <a:pt x="29" y="565"/>
                  </a:lnTo>
                  <a:lnTo>
                    <a:pt x="30" y="568"/>
                  </a:lnTo>
                  <a:lnTo>
                    <a:pt x="30" y="571"/>
                  </a:lnTo>
                  <a:lnTo>
                    <a:pt x="30" y="574"/>
                  </a:lnTo>
                  <a:lnTo>
                    <a:pt x="31" y="577"/>
                  </a:lnTo>
                  <a:lnTo>
                    <a:pt x="31" y="579"/>
                  </a:lnTo>
                  <a:lnTo>
                    <a:pt x="31" y="582"/>
                  </a:lnTo>
                  <a:lnTo>
                    <a:pt x="32" y="585"/>
                  </a:lnTo>
                  <a:lnTo>
                    <a:pt x="32" y="588"/>
                  </a:lnTo>
                  <a:lnTo>
                    <a:pt x="32" y="590"/>
                  </a:lnTo>
                  <a:lnTo>
                    <a:pt x="33" y="593"/>
                  </a:lnTo>
                  <a:lnTo>
                    <a:pt x="33" y="595"/>
                  </a:lnTo>
                  <a:lnTo>
                    <a:pt x="33" y="597"/>
                  </a:lnTo>
                  <a:lnTo>
                    <a:pt x="34" y="600"/>
                  </a:lnTo>
                  <a:lnTo>
                    <a:pt x="34" y="602"/>
                  </a:lnTo>
                  <a:lnTo>
                    <a:pt x="34" y="604"/>
                  </a:lnTo>
                  <a:lnTo>
                    <a:pt x="35" y="606"/>
                  </a:lnTo>
                  <a:lnTo>
                    <a:pt x="35" y="609"/>
                  </a:lnTo>
                  <a:lnTo>
                    <a:pt x="35" y="611"/>
                  </a:lnTo>
                  <a:lnTo>
                    <a:pt x="36" y="613"/>
                  </a:lnTo>
                  <a:lnTo>
                    <a:pt x="36" y="615"/>
                  </a:lnTo>
                  <a:lnTo>
                    <a:pt x="36" y="616"/>
                  </a:lnTo>
                  <a:lnTo>
                    <a:pt x="36" y="617"/>
                  </a:lnTo>
                  <a:lnTo>
                    <a:pt x="37" y="619"/>
                  </a:lnTo>
                  <a:lnTo>
                    <a:pt x="37" y="620"/>
                  </a:lnTo>
                  <a:lnTo>
                    <a:pt x="37" y="621"/>
                  </a:lnTo>
                  <a:lnTo>
                    <a:pt x="37" y="622"/>
                  </a:lnTo>
                  <a:lnTo>
                    <a:pt x="38" y="624"/>
                  </a:lnTo>
                  <a:lnTo>
                    <a:pt x="38" y="625"/>
                  </a:lnTo>
                  <a:lnTo>
                    <a:pt x="38" y="626"/>
                  </a:lnTo>
                  <a:lnTo>
                    <a:pt x="38" y="627"/>
                  </a:lnTo>
                  <a:lnTo>
                    <a:pt x="38" y="628"/>
                  </a:lnTo>
                  <a:lnTo>
                    <a:pt x="39" y="629"/>
                  </a:lnTo>
                  <a:lnTo>
                    <a:pt x="39" y="630"/>
                  </a:lnTo>
                  <a:lnTo>
                    <a:pt x="39" y="631"/>
                  </a:lnTo>
                  <a:lnTo>
                    <a:pt x="39" y="632"/>
                  </a:lnTo>
                  <a:lnTo>
                    <a:pt x="40" y="633"/>
                  </a:lnTo>
                  <a:lnTo>
                    <a:pt x="40" y="634"/>
                  </a:lnTo>
                  <a:lnTo>
                    <a:pt x="40" y="635"/>
                  </a:lnTo>
                  <a:lnTo>
                    <a:pt x="40" y="636"/>
                  </a:lnTo>
                  <a:lnTo>
                    <a:pt x="41" y="637"/>
                  </a:lnTo>
                  <a:lnTo>
                    <a:pt x="41" y="638"/>
                  </a:lnTo>
                  <a:lnTo>
                    <a:pt x="41" y="639"/>
                  </a:lnTo>
                  <a:lnTo>
                    <a:pt x="42" y="639"/>
                  </a:lnTo>
                  <a:lnTo>
                    <a:pt x="42" y="640"/>
                  </a:lnTo>
                  <a:lnTo>
                    <a:pt x="42" y="641"/>
                  </a:lnTo>
                  <a:lnTo>
                    <a:pt x="42" y="641"/>
                  </a:lnTo>
                  <a:lnTo>
                    <a:pt x="43" y="642"/>
                  </a:lnTo>
                  <a:lnTo>
                    <a:pt x="43" y="643"/>
                  </a:lnTo>
                  <a:lnTo>
                    <a:pt x="43" y="644"/>
                  </a:lnTo>
                  <a:lnTo>
                    <a:pt x="44" y="644"/>
                  </a:lnTo>
                  <a:lnTo>
                    <a:pt x="44" y="645"/>
                  </a:lnTo>
                  <a:lnTo>
                    <a:pt x="44" y="646"/>
                  </a:lnTo>
                  <a:lnTo>
                    <a:pt x="44" y="646"/>
                  </a:lnTo>
                  <a:lnTo>
                    <a:pt x="45" y="646"/>
                  </a:lnTo>
                  <a:lnTo>
                    <a:pt x="45" y="647"/>
                  </a:lnTo>
                  <a:lnTo>
                    <a:pt x="45" y="647"/>
                  </a:lnTo>
                  <a:lnTo>
                    <a:pt x="45" y="648"/>
                  </a:lnTo>
                  <a:lnTo>
                    <a:pt x="45" y="648"/>
                  </a:lnTo>
                  <a:lnTo>
                    <a:pt x="46" y="648"/>
                  </a:lnTo>
                  <a:lnTo>
                    <a:pt x="46" y="649"/>
                  </a:lnTo>
                  <a:lnTo>
                    <a:pt x="46" y="649"/>
                  </a:lnTo>
                  <a:lnTo>
                    <a:pt x="47" y="649"/>
                  </a:lnTo>
                  <a:lnTo>
                    <a:pt x="47" y="650"/>
                  </a:lnTo>
                  <a:lnTo>
                    <a:pt x="47" y="650"/>
                  </a:lnTo>
                  <a:lnTo>
                    <a:pt x="47" y="651"/>
                  </a:lnTo>
                  <a:lnTo>
                    <a:pt x="48" y="651"/>
                  </a:lnTo>
                  <a:lnTo>
                    <a:pt x="48" y="651"/>
                  </a:lnTo>
                  <a:lnTo>
                    <a:pt x="48" y="651"/>
                  </a:lnTo>
                  <a:lnTo>
                    <a:pt x="48" y="652"/>
                  </a:lnTo>
                  <a:lnTo>
                    <a:pt x="49" y="652"/>
                  </a:lnTo>
                  <a:lnTo>
                    <a:pt x="49" y="652"/>
                  </a:lnTo>
                  <a:lnTo>
                    <a:pt x="49" y="653"/>
                  </a:lnTo>
                  <a:lnTo>
                    <a:pt x="50" y="653"/>
                  </a:lnTo>
                  <a:lnTo>
                    <a:pt x="50" y="653"/>
                  </a:lnTo>
                  <a:lnTo>
                    <a:pt x="50" y="654"/>
                  </a:lnTo>
                  <a:lnTo>
                    <a:pt x="51" y="654"/>
                  </a:lnTo>
                  <a:lnTo>
                    <a:pt x="51" y="654"/>
                  </a:lnTo>
                  <a:lnTo>
                    <a:pt x="51" y="654"/>
                  </a:lnTo>
                  <a:lnTo>
                    <a:pt x="52" y="655"/>
                  </a:lnTo>
                  <a:lnTo>
                    <a:pt x="52" y="655"/>
                  </a:lnTo>
                  <a:lnTo>
                    <a:pt x="53" y="655"/>
                  </a:lnTo>
                  <a:lnTo>
                    <a:pt x="53" y="656"/>
                  </a:lnTo>
                  <a:lnTo>
                    <a:pt x="54" y="656"/>
                  </a:lnTo>
                  <a:lnTo>
                    <a:pt x="54" y="656"/>
                  </a:lnTo>
                  <a:lnTo>
                    <a:pt x="55" y="656"/>
                  </a:lnTo>
                  <a:lnTo>
                    <a:pt x="55" y="656"/>
                  </a:lnTo>
                  <a:lnTo>
                    <a:pt x="56" y="657"/>
                  </a:lnTo>
                  <a:lnTo>
                    <a:pt x="57" y="657"/>
                  </a:lnTo>
                  <a:lnTo>
                    <a:pt x="57" y="657"/>
                  </a:lnTo>
                  <a:lnTo>
                    <a:pt x="58" y="657"/>
                  </a:lnTo>
                  <a:lnTo>
                    <a:pt x="59" y="658"/>
                  </a:lnTo>
                  <a:lnTo>
                    <a:pt x="60" y="658"/>
                  </a:lnTo>
                  <a:lnTo>
                    <a:pt x="61" y="658"/>
                  </a:lnTo>
                  <a:lnTo>
                    <a:pt x="61" y="658"/>
                  </a:lnTo>
                  <a:lnTo>
                    <a:pt x="62" y="659"/>
                  </a:lnTo>
                  <a:lnTo>
                    <a:pt x="63" y="659"/>
                  </a:lnTo>
                  <a:lnTo>
                    <a:pt x="64" y="659"/>
                  </a:lnTo>
                  <a:lnTo>
                    <a:pt x="65" y="659"/>
                  </a:lnTo>
                  <a:lnTo>
                    <a:pt x="67" y="659"/>
                  </a:lnTo>
                  <a:lnTo>
                    <a:pt x="68" y="659"/>
                  </a:lnTo>
                  <a:lnTo>
                    <a:pt x="69" y="659"/>
                  </a:lnTo>
                  <a:lnTo>
                    <a:pt x="70" y="660"/>
                  </a:lnTo>
                  <a:lnTo>
                    <a:pt x="72" y="660"/>
                  </a:lnTo>
                  <a:lnTo>
                    <a:pt x="73" y="660"/>
                  </a:lnTo>
                  <a:lnTo>
                    <a:pt x="75" y="660"/>
                  </a:lnTo>
                  <a:lnTo>
                    <a:pt x="77" y="660"/>
                  </a:lnTo>
                  <a:lnTo>
                    <a:pt x="79" y="660"/>
                  </a:lnTo>
                  <a:lnTo>
                    <a:pt x="80" y="661"/>
                  </a:lnTo>
                  <a:lnTo>
                    <a:pt x="80" y="661"/>
                  </a:lnTo>
                  <a:lnTo>
                    <a:pt x="82" y="661"/>
                  </a:lnTo>
                  <a:lnTo>
                    <a:pt x="84" y="661"/>
                  </a:lnTo>
                  <a:lnTo>
                    <a:pt x="86" y="661"/>
                  </a:lnTo>
                  <a:lnTo>
                    <a:pt x="88" y="661"/>
                  </a:lnTo>
                  <a:lnTo>
                    <a:pt x="93" y="661"/>
                  </a:lnTo>
                  <a:lnTo>
                    <a:pt x="98" y="661"/>
                  </a:lnTo>
                  <a:lnTo>
                    <a:pt x="101" y="662"/>
                  </a:lnTo>
                  <a:lnTo>
                    <a:pt x="103" y="662"/>
                  </a:lnTo>
                  <a:lnTo>
                    <a:pt x="104" y="662"/>
                  </a:lnTo>
                  <a:lnTo>
                    <a:pt x="105" y="662"/>
                  </a:lnTo>
                  <a:lnTo>
                    <a:pt x="106" y="662"/>
                  </a:lnTo>
                  <a:lnTo>
                    <a:pt x="107" y="662"/>
                  </a:lnTo>
                  <a:lnTo>
                    <a:pt x="110" y="662"/>
                  </a:lnTo>
                  <a:lnTo>
                    <a:pt x="112" y="662"/>
                  </a:lnTo>
                  <a:lnTo>
                    <a:pt x="115" y="662"/>
                  </a:lnTo>
                  <a:lnTo>
                    <a:pt x="118" y="662"/>
                  </a:lnTo>
                  <a:lnTo>
                    <a:pt x="121" y="662"/>
                  </a:lnTo>
                  <a:lnTo>
                    <a:pt x="124" y="662"/>
                  </a:lnTo>
                  <a:lnTo>
                    <a:pt x="127" y="663"/>
                  </a:lnTo>
                  <a:lnTo>
                    <a:pt x="129" y="663"/>
                  </a:lnTo>
                  <a:lnTo>
                    <a:pt x="131" y="663"/>
                  </a:lnTo>
                  <a:lnTo>
                    <a:pt x="132" y="663"/>
                  </a:lnTo>
                  <a:lnTo>
                    <a:pt x="134" y="663"/>
                  </a:lnTo>
                  <a:lnTo>
                    <a:pt x="136" y="663"/>
                  </a:lnTo>
                  <a:lnTo>
                    <a:pt x="137" y="663"/>
                  </a:lnTo>
                  <a:lnTo>
                    <a:pt x="140" y="663"/>
                  </a:lnTo>
                  <a:lnTo>
                    <a:pt x="143" y="663"/>
                  </a:lnTo>
                  <a:lnTo>
                    <a:pt x="146" y="663"/>
                  </a:lnTo>
                  <a:lnTo>
                    <a:pt x="149" y="663"/>
                  </a:lnTo>
                  <a:lnTo>
                    <a:pt x="153" y="663"/>
                  </a:lnTo>
                  <a:lnTo>
                    <a:pt x="156" y="663"/>
                  </a:lnTo>
                  <a:lnTo>
                    <a:pt x="158" y="663"/>
                  </a:lnTo>
                  <a:lnTo>
                    <a:pt x="160" y="663"/>
                  </a:lnTo>
                  <a:lnTo>
                    <a:pt x="162" y="663"/>
                  </a:lnTo>
                  <a:lnTo>
                    <a:pt x="164" y="663"/>
                  </a:lnTo>
                  <a:lnTo>
                    <a:pt x="168" y="663"/>
                  </a:lnTo>
                  <a:lnTo>
                    <a:pt x="171" y="663"/>
                  </a:lnTo>
                  <a:lnTo>
                    <a:pt x="173" y="663"/>
                  </a:lnTo>
                  <a:lnTo>
                    <a:pt x="176" y="663"/>
                  </a:lnTo>
                  <a:lnTo>
                    <a:pt x="178" y="663"/>
                  </a:lnTo>
                  <a:lnTo>
                    <a:pt x="180" y="663"/>
                  </a:lnTo>
                  <a:lnTo>
                    <a:pt x="181" y="663"/>
                  </a:lnTo>
                  <a:lnTo>
                    <a:pt x="182" y="663"/>
                  </a:lnTo>
                  <a:lnTo>
                    <a:pt x="183" y="663"/>
                  </a:lnTo>
                  <a:lnTo>
                    <a:pt x="184" y="663"/>
                  </a:lnTo>
                  <a:lnTo>
                    <a:pt x="186" y="663"/>
                  </a:lnTo>
                  <a:lnTo>
                    <a:pt x="187" y="663"/>
                  </a:lnTo>
                  <a:lnTo>
                    <a:pt x="188" y="663"/>
                  </a:lnTo>
                  <a:lnTo>
                    <a:pt x="190" y="663"/>
                  </a:lnTo>
                  <a:lnTo>
                    <a:pt x="192" y="663"/>
                  </a:lnTo>
                  <a:lnTo>
                    <a:pt x="194" y="663"/>
                  </a:lnTo>
                  <a:lnTo>
                    <a:pt x="199" y="663"/>
                  </a:lnTo>
                  <a:lnTo>
                    <a:pt x="203" y="664"/>
                  </a:lnTo>
                  <a:lnTo>
                    <a:pt x="206" y="664"/>
                  </a:lnTo>
                  <a:lnTo>
                    <a:pt x="207" y="664"/>
                  </a:lnTo>
                  <a:lnTo>
                    <a:pt x="208" y="664"/>
                  </a:lnTo>
                  <a:lnTo>
                    <a:pt x="210" y="664"/>
                  </a:lnTo>
                  <a:lnTo>
                    <a:pt x="212" y="664"/>
                  </a:lnTo>
                  <a:lnTo>
                    <a:pt x="216" y="664"/>
                  </a:lnTo>
                  <a:lnTo>
                    <a:pt x="219" y="664"/>
                  </a:lnTo>
                  <a:lnTo>
                    <a:pt x="221" y="664"/>
                  </a:lnTo>
                  <a:lnTo>
                    <a:pt x="223" y="664"/>
                  </a:lnTo>
                  <a:lnTo>
                    <a:pt x="225" y="664"/>
                  </a:lnTo>
                  <a:lnTo>
                    <a:pt x="227" y="664"/>
                  </a:lnTo>
                  <a:lnTo>
                    <a:pt x="229" y="664"/>
                  </a:lnTo>
                  <a:lnTo>
                    <a:pt x="231" y="664"/>
                  </a:lnTo>
                  <a:lnTo>
                    <a:pt x="233" y="664"/>
                  </a:lnTo>
                  <a:lnTo>
                    <a:pt x="234" y="664"/>
                  </a:lnTo>
                  <a:lnTo>
                    <a:pt x="235" y="664"/>
                  </a:lnTo>
                  <a:lnTo>
                    <a:pt x="237" y="664"/>
                  </a:lnTo>
                  <a:lnTo>
                    <a:pt x="239" y="664"/>
                  </a:lnTo>
                  <a:lnTo>
                    <a:pt x="243" y="664"/>
                  </a:lnTo>
                  <a:lnTo>
                    <a:pt x="248" y="664"/>
                  </a:lnTo>
                  <a:lnTo>
                    <a:pt x="252" y="664"/>
                  </a:lnTo>
                  <a:lnTo>
                    <a:pt x="256" y="664"/>
                  </a:lnTo>
                  <a:lnTo>
                    <a:pt x="258" y="664"/>
                  </a:lnTo>
                  <a:lnTo>
                    <a:pt x="259" y="664"/>
                  </a:lnTo>
                  <a:lnTo>
                    <a:pt x="261" y="664"/>
                  </a:lnTo>
                  <a:lnTo>
                    <a:pt x="264" y="664"/>
                  </a:lnTo>
                  <a:lnTo>
                    <a:pt x="266" y="664"/>
                  </a:lnTo>
                  <a:lnTo>
                    <a:pt x="269" y="664"/>
                  </a:lnTo>
                  <a:lnTo>
                    <a:pt x="272" y="664"/>
                  </a:lnTo>
                  <a:lnTo>
                    <a:pt x="274" y="664"/>
                  </a:lnTo>
                  <a:lnTo>
                    <a:pt x="276" y="664"/>
                  </a:lnTo>
                  <a:lnTo>
                    <a:pt x="278" y="664"/>
                  </a:lnTo>
                  <a:lnTo>
                    <a:pt x="280" y="664"/>
                  </a:lnTo>
                  <a:lnTo>
                    <a:pt x="282" y="664"/>
                  </a:lnTo>
                  <a:lnTo>
                    <a:pt x="284" y="664"/>
                  </a:lnTo>
                  <a:lnTo>
                    <a:pt x="286" y="664"/>
                  </a:lnTo>
                  <a:lnTo>
                    <a:pt x="289" y="664"/>
                  </a:lnTo>
                  <a:lnTo>
                    <a:pt x="292" y="664"/>
                  </a:lnTo>
                  <a:lnTo>
                    <a:pt x="294" y="664"/>
                  </a:lnTo>
                  <a:lnTo>
                    <a:pt x="296" y="664"/>
                  </a:lnTo>
                  <a:lnTo>
                    <a:pt x="300" y="664"/>
                  </a:lnTo>
                  <a:lnTo>
                    <a:pt x="304" y="664"/>
                  </a:lnTo>
                  <a:lnTo>
                    <a:pt x="307" y="664"/>
                  </a:lnTo>
                  <a:lnTo>
                    <a:pt x="310" y="664"/>
                  </a:lnTo>
                  <a:lnTo>
                    <a:pt x="312" y="664"/>
                  </a:lnTo>
                  <a:lnTo>
                    <a:pt x="314" y="664"/>
                  </a:lnTo>
                  <a:lnTo>
                    <a:pt x="316" y="664"/>
                  </a:lnTo>
                  <a:lnTo>
                    <a:pt x="318" y="664"/>
                  </a:lnTo>
                  <a:lnTo>
                    <a:pt x="321" y="664"/>
                  </a:lnTo>
                  <a:lnTo>
                    <a:pt x="324" y="664"/>
                  </a:lnTo>
                  <a:lnTo>
                    <a:pt x="326" y="664"/>
                  </a:lnTo>
                  <a:lnTo>
                    <a:pt x="329" y="664"/>
                  </a:lnTo>
                  <a:lnTo>
                    <a:pt x="331" y="664"/>
                  </a:lnTo>
                  <a:lnTo>
                    <a:pt x="333" y="664"/>
                  </a:lnTo>
                  <a:lnTo>
                    <a:pt x="335" y="664"/>
                  </a:lnTo>
                  <a:lnTo>
                    <a:pt x="336" y="664"/>
                  </a:lnTo>
                  <a:lnTo>
                    <a:pt x="337" y="664"/>
                  </a:lnTo>
                  <a:lnTo>
                    <a:pt x="339" y="664"/>
                  </a:lnTo>
                  <a:lnTo>
                    <a:pt x="341" y="664"/>
                  </a:lnTo>
                  <a:lnTo>
                    <a:pt x="342" y="664"/>
                  </a:lnTo>
                  <a:lnTo>
                    <a:pt x="344" y="664"/>
                  </a:lnTo>
                  <a:lnTo>
                    <a:pt x="347" y="664"/>
                  </a:lnTo>
                  <a:lnTo>
                    <a:pt x="350" y="664"/>
                  </a:lnTo>
                  <a:lnTo>
                    <a:pt x="354" y="664"/>
                  </a:lnTo>
                  <a:lnTo>
                    <a:pt x="357" y="663"/>
                  </a:lnTo>
                  <a:lnTo>
                    <a:pt x="359" y="663"/>
                  </a:lnTo>
                  <a:lnTo>
                    <a:pt x="361" y="663"/>
                  </a:lnTo>
                  <a:lnTo>
                    <a:pt x="363" y="663"/>
                  </a:lnTo>
                  <a:lnTo>
                    <a:pt x="364" y="663"/>
                  </a:lnTo>
                  <a:lnTo>
                    <a:pt x="366" y="663"/>
                  </a:lnTo>
                  <a:lnTo>
                    <a:pt x="368" y="663"/>
                  </a:lnTo>
                  <a:lnTo>
                    <a:pt x="369" y="663"/>
                  </a:lnTo>
                  <a:lnTo>
                    <a:pt x="371" y="663"/>
                  </a:lnTo>
                  <a:lnTo>
                    <a:pt x="373" y="663"/>
                  </a:lnTo>
                  <a:lnTo>
                    <a:pt x="375" y="663"/>
                  </a:lnTo>
                  <a:lnTo>
                    <a:pt x="377" y="663"/>
                  </a:lnTo>
                  <a:lnTo>
                    <a:pt x="379" y="663"/>
                  </a:lnTo>
                  <a:lnTo>
                    <a:pt x="381" y="663"/>
                  </a:lnTo>
                  <a:lnTo>
                    <a:pt x="383" y="663"/>
                  </a:lnTo>
                  <a:lnTo>
                    <a:pt x="384" y="663"/>
                  </a:lnTo>
                  <a:lnTo>
                    <a:pt x="386" y="663"/>
                  </a:lnTo>
                  <a:lnTo>
                    <a:pt x="387" y="663"/>
                  </a:lnTo>
                  <a:lnTo>
                    <a:pt x="389" y="663"/>
                  </a:lnTo>
                  <a:lnTo>
                    <a:pt x="391" y="663"/>
                  </a:lnTo>
                  <a:lnTo>
                    <a:pt x="393" y="664"/>
                  </a:lnTo>
                  <a:lnTo>
                    <a:pt x="395" y="664"/>
                  </a:lnTo>
                  <a:lnTo>
                    <a:pt x="397" y="664"/>
                  </a:lnTo>
                  <a:lnTo>
                    <a:pt x="401" y="664"/>
                  </a:lnTo>
                  <a:lnTo>
                    <a:pt x="405" y="664"/>
                  </a:lnTo>
                  <a:lnTo>
                    <a:pt x="407" y="664"/>
                  </a:lnTo>
                  <a:lnTo>
                    <a:pt x="409" y="664"/>
                  </a:lnTo>
                  <a:lnTo>
                    <a:pt x="411" y="664"/>
                  </a:lnTo>
                  <a:lnTo>
                    <a:pt x="413" y="664"/>
                  </a:lnTo>
                  <a:lnTo>
                    <a:pt x="414" y="664"/>
                  </a:lnTo>
                  <a:lnTo>
                    <a:pt x="416" y="664"/>
                  </a:lnTo>
                  <a:lnTo>
                    <a:pt x="419" y="664"/>
                  </a:lnTo>
                  <a:lnTo>
                    <a:pt x="422" y="664"/>
                  </a:lnTo>
                  <a:lnTo>
                    <a:pt x="425" y="664"/>
                  </a:lnTo>
                  <a:lnTo>
                    <a:pt x="428" y="664"/>
                  </a:lnTo>
                  <a:lnTo>
                    <a:pt x="432" y="664"/>
                  </a:lnTo>
                  <a:lnTo>
                    <a:pt x="435" y="663"/>
                  </a:lnTo>
                  <a:lnTo>
                    <a:pt x="438" y="663"/>
                  </a:lnTo>
                  <a:lnTo>
                    <a:pt x="439" y="663"/>
                  </a:lnTo>
                  <a:lnTo>
                    <a:pt x="440" y="663"/>
                  </a:lnTo>
                  <a:lnTo>
                    <a:pt x="442" y="663"/>
                  </a:lnTo>
                  <a:lnTo>
                    <a:pt x="444" y="663"/>
                  </a:lnTo>
                  <a:lnTo>
                    <a:pt x="448" y="663"/>
                  </a:lnTo>
                  <a:lnTo>
                    <a:pt x="453" y="663"/>
                  </a:lnTo>
                  <a:lnTo>
                    <a:pt x="459" y="663"/>
                  </a:lnTo>
                  <a:lnTo>
                    <a:pt x="462" y="663"/>
                  </a:lnTo>
                  <a:lnTo>
                    <a:pt x="464" y="663"/>
                  </a:lnTo>
                  <a:lnTo>
                    <a:pt x="465" y="663"/>
                  </a:lnTo>
                  <a:lnTo>
                    <a:pt x="468" y="663"/>
                  </a:lnTo>
                  <a:lnTo>
                    <a:pt x="470" y="663"/>
                  </a:lnTo>
                  <a:lnTo>
                    <a:pt x="473" y="663"/>
                  </a:lnTo>
                  <a:lnTo>
                    <a:pt x="475" y="663"/>
                  </a:lnTo>
                  <a:lnTo>
                    <a:pt x="478" y="663"/>
                  </a:lnTo>
                  <a:lnTo>
                    <a:pt x="481" y="663"/>
                  </a:lnTo>
                  <a:lnTo>
                    <a:pt x="484" y="663"/>
                  </a:lnTo>
                  <a:lnTo>
                    <a:pt x="488" y="663"/>
                  </a:lnTo>
                  <a:lnTo>
                    <a:pt x="490" y="663"/>
                  </a:lnTo>
                  <a:lnTo>
                    <a:pt x="491" y="663"/>
                  </a:lnTo>
                  <a:lnTo>
                    <a:pt x="493" y="663"/>
                  </a:lnTo>
                  <a:lnTo>
                    <a:pt x="495" y="663"/>
                  </a:lnTo>
                  <a:lnTo>
                    <a:pt x="499" y="663"/>
                  </a:lnTo>
                  <a:lnTo>
                    <a:pt x="504" y="663"/>
                  </a:lnTo>
                  <a:lnTo>
                    <a:pt x="509" y="663"/>
                  </a:lnTo>
                  <a:lnTo>
                    <a:pt x="513" y="663"/>
                  </a:lnTo>
                  <a:lnTo>
                    <a:pt x="516" y="663"/>
                  </a:lnTo>
                  <a:lnTo>
                    <a:pt x="518" y="663"/>
                  </a:lnTo>
                  <a:lnTo>
                    <a:pt x="522" y="663"/>
                  </a:lnTo>
                  <a:lnTo>
                    <a:pt x="526" y="663"/>
                  </a:lnTo>
                  <a:lnTo>
                    <a:pt x="528" y="663"/>
                  </a:lnTo>
                  <a:lnTo>
                    <a:pt x="530" y="663"/>
                  </a:lnTo>
                  <a:lnTo>
                    <a:pt x="533" y="663"/>
                  </a:lnTo>
                  <a:lnTo>
                    <a:pt x="537" y="663"/>
                  </a:lnTo>
                  <a:lnTo>
                    <a:pt x="540" y="663"/>
                  </a:lnTo>
                  <a:lnTo>
                    <a:pt x="543" y="663"/>
                  </a:lnTo>
                  <a:lnTo>
                    <a:pt x="545" y="663"/>
                  </a:lnTo>
                  <a:lnTo>
                    <a:pt x="547" y="663"/>
                  </a:lnTo>
                  <a:lnTo>
                    <a:pt x="550" y="663"/>
                  </a:lnTo>
                  <a:lnTo>
                    <a:pt x="552" y="663"/>
                  </a:lnTo>
                  <a:lnTo>
                    <a:pt x="555" y="663"/>
                  </a:lnTo>
                  <a:lnTo>
                    <a:pt x="558" y="663"/>
                  </a:lnTo>
                  <a:lnTo>
                    <a:pt x="560" y="663"/>
                  </a:lnTo>
                  <a:lnTo>
                    <a:pt x="563" y="663"/>
                  </a:lnTo>
                  <a:lnTo>
                    <a:pt x="565" y="663"/>
                  </a:lnTo>
                  <a:lnTo>
                    <a:pt x="566" y="663"/>
                  </a:lnTo>
                  <a:lnTo>
                    <a:pt x="567" y="663"/>
                  </a:lnTo>
                  <a:lnTo>
                    <a:pt x="568" y="663"/>
                  </a:lnTo>
                  <a:lnTo>
                    <a:pt x="571" y="663"/>
                  </a:lnTo>
                  <a:lnTo>
                    <a:pt x="572" y="663"/>
                  </a:lnTo>
                  <a:lnTo>
                    <a:pt x="574" y="663"/>
                  </a:lnTo>
                  <a:lnTo>
                    <a:pt x="575" y="663"/>
                  </a:lnTo>
                  <a:lnTo>
                    <a:pt x="577" y="663"/>
                  </a:lnTo>
                  <a:lnTo>
                    <a:pt x="579" y="663"/>
                  </a:lnTo>
                  <a:lnTo>
                    <a:pt x="581" y="663"/>
                  </a:lnTo>
                  <a:lnTo>
                    <a:pt x="583" y="662"/>
                  </a:lnTo>
                  <a:lnTo>
                    <a:pt x="587" y="662"/>
                  </a:lnTo>
                  <a:lnTo>
                    <a:pt x="589" y="662"/>
                  </a:lnTo>
                  <a:lnTo>
                    <a:pt x="590" y="662"/>
                  </a:lnTo>
                  <a:lnTo>
                    <a:pt x="591" y="662"/>
                  </a:lnTo>
                  <a:lnTo>
                    <a:pt x="592" y="662"/>
                  </a:lnTo>
                  <a:lnTo>
                    <a:pt x="594" y="662"/>
                  </a:lnTo>
                  <a:lnTo>
                    <a:pt x="597" y="662"/>
                  </a:lnTo>
                  <a:lnTo>
                    <a:pt x="601" y="662"/>
                  </a:lnTo>
                  <a:lnTo>
                    <a:pt x="604" y="662"/>
                  </a:lnTo>
                  <a:lnTo>
                    <a:pt x="606" y="661"/>
                  </a:lnTo>
                  <a:lnTo>
                    <a:pt x="609" y="661"/>
                  </a:lnTo>
                  <a:lnTo>
                    <a:pt x="611" y="661"/>
                  </a:lnTo>
                  <a:lnTo>
                    <a:pt x="613" y="661"/>
                  </a:lnTo>
                  <a:lnTo>
                    <a:pt x="615" y="661"/>
                  </a:lnTo>
                  <a:lnTo>
                    <a:pt x="617" y="661"/>
                  </a:lnTo>
                  <a:lnTo>
                    <a:pt x="620" y="661"/>
                  </a:lnTo>
                  <a:lnTo>
                    <a:pt x="623" y="661"/>
                  </a:lnTo>
                  <a:lnTo>
                    <a:pt x="626" y="661"/>
                  </a:lnTo>
                  <a:lnTo>
                    <a:pt x="631" y="661"/>
                  </a:lnTo>
                  <a:lnTo>
                    <a:pt x="635" y="661"/>
                  </a:lnTo>
                  <a:lnTo>
                    <a:pt x="638" y="661"/>
                  </a:lnTo>
                  <a:lnTo>
                    <a:pt x="641" y="661"/>
                  </a:lnTo>
                  <a:lnTo>
                    <a:pt x="643" y="661"/>
                  </a:lnTo>
                  <a:lnTo>
                    <a:pt x="644" y="661"/>
                  </a:lnTo>
                  <a:lnTo>
                    <a:pt x="646" y="661"/>
                  </a:lnTo>
                  <a:lnTo>
                    <a:pt x="647" y="661"/>
                  </a:lnTo>
                  <a:lnTo>
                    <a:pt x="649" y="661"/>
                  </a:lnTo>
                  <a:lnTo>
                    <a:pt x="651" y="661"/>
                  </a:lnTo>
                  <a:lnTo>
                    <a:pt x="654" y="661"/>
                  </a:lnTo>
                  <a:lnTo>
                    <a:pt x="657" y="661"/>
                  </a:lnTo>
                  <a:lnTo>
                    <a:pt x="660" y="661"/>
                  </a:lnTo>
                  <a:lnTo>
                    <a:pt x="663" y="661"/>
                  </a:lnTo>
                  <a:lnTo>
                    <a:pt x="667" y="661"/>
                  </a:lnTo>
                  <a:lnTo>
                    <a:pt x="668" y="661"/>
                  </a:lnTo>
                  <a:lnTo>
                    <a:pt x="670" y="661"/>
                  </a:lnTo>
                  <a:lnTo>
                    <a:pt x="671" y="661"/>
                  </a:lnTo>
                  <a:lnTo>
                    <a:pt x="673" y="661"/>
                  </a:lnTo>
                  <a:lnTo>
                    <a:pt x="675" y="661"/>
                  </a:lnTo>
                  <a:lnTo>
                    <a:pt x="676" y="661"/>
                  </a:lnTo>
                  <a:lnTo>
                    <a:pt x="678" y="661"/>
                  </a:lnTo>
                  <a:lnTo>
                    <a:pt x="680" y="661"/>
                  </a:lnTo>
                  <a:lnTo>
                    <a:pt x="683" y="661"/>
                  </a:lnTo>
                  <a:lnTo>
                    <a:pt x="687" y="661"/>
                  </a:lnTo>
                  <a:lnTo>
                    <a:pt x="690" y="661"/>
                  </a:lnTo>
                  <a:lnTo>
                    <a:pt x="692" y="661"/>
                  </a:lnTo>
                  <a:lnTo>
                    <a:pt x="695" y="661"/>
                  </a:lnTo>
                  <a:lnTo>
                    <a:pt x="697" y="661"/>
                  </a:lnTo>
                  <a:lnTo>
                    <a:pt x="699" y="661"/>
                  </a:lnTo>
                  <a:lnTo>
                    <a:pt x="702" y="661"/>
                  </a:lnTo>
                  <a:lnTo>
                    <a:pt x="705" y="661"/>
                  </a:lnTo>
                  <a:lnTo>
                    <a:pt x="710" y="661"/>
                  </a:lnTo>
                  <a:lnTo>
                    <a:pt x="716" y="661"/>
                  </a:lnTo>
                  <a:lnTo>
                    <a:pt x="719" y="661"/>
                  </a:lnTo>
                  <a:lnTo>
                    <a:pt x="720" y="661"/>
                  </a:lnTo>
                  <a:lnTo>
                    <a:pt x="722" y="661"/>
                  </a:lnTo>
                  <a:lnTo>
                    <a:pt x="724" y="661"/>
                  </a:lnTo>
                  <a:lnTo>
                    <a:pt x="727" y="662"/>
                  </a:lnTo>
                  <a:lnTo>
                    <a:pt x="729" y="662"/>
                  </a:lnTo>
                  <a:lnTo>
                    <a:pt x="731" y="662"/>
                  </a:lnTo>
                  <a:lnTo>
                    <a:pt x="734" y="662"/>
                  </a:lnTo>
                  <a:lnTo>
                    <a:pt x="736" y="662"/>
                  </a:lnTo>
                  <a:lnTo>
                    <a:pt x="738" y="662"/>
                  </a:lnTo>
                  <a:lnTo>
                    <a:pt x="740" y="662"/>
                  </a:lnTo>
                  <a:lnTo>
                    <a:pt x="743" y="662"/>
                  </a:lnTo>
                  <a:lnTo>
                    <a:pt x="745" y="662"/>
                  </a:lnTo>
                  <a:lnTo>
                    <a:pt x="746" y="662"/>
                  </a:lnTo>
                  <a:lnTo>
                    <a:pt x="748" y="662"/>
                  </a:lnTo>
                  <a:lnTo>
                    <a:pt x="749" y="662"/>
                  </a:lnTo>
                  <a:lnTo>
                    <a:pt x="751" y="662"/>
                  </a:lnTo>
                  <a:lnTo>
                    <a:pt x="753" y="662"/>
                  </a:lnTo>
                  <a:lnTo>
                    <a:pt x="755" y="662"/>
                  </a:lnTo>
                  <a:lnTo>
                    <a:pt x="757" y="662"/>
                  </a:lnTo>
                  <a:lnTo>
                    <a:pt x="760" y="662"/>
                  </a:lnTo>
                  <a:lnTo>
                    <a:pt x="762" y="662"/>
                  </a:lnTo>
                  <a:lnTo>
                    <a:pt x="765" y="662"/>
                  </a:lnTo>
                  <a:lnTo>
                    <a:pt x="768" y="662"/>
                  </a:lnTo>
                  <a:lnTo>
                    <a:pt x="771" y="662"/>
                  </a:lnTo>
                  <a:lnTo>
                    <a:pt x="776" y="662"/>
                  </a:lnTo>
                  <a:lnTo>
                    <a:pt x="781" y="662"/>
                  </a:lnTo>
                  <a:lnTo>
                    <a:pt x="786" y="662"/>
                  </a:lnTo>
                  <a:lnTo>
                    <a:pt x="790" y="662"/>
                  </a:lnTo>
                  <a:lnTo>
                    <a:pt x="795" y="662"/>
                  </a:lnTo>
                  <a:lnTo>
                    <a:pt x="798" y="662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5" name="Freeform 142">
              <a:extLst>
                <a:ext uri="{FF2B5EF4-FFF2-40B4-BE49-F238E27FC236}">
                  <a16:creationId xmlns:a16="http://schemas.microsoft.com/office/drawing/2014/main" id="{6047AE31-E276-40C7-8E57-64C31482FAFB}"/>
                </a:ext>
              </a:extLst>
            </p:cNvPr>
            <p:cNvSpPr>
              <a:spLocks/>
            </p:cNvSpPr>
            <p:nvPr/>
          </p:nvSpPr>
          <p:spPr bwMode="auto">
            <a:xfrm>
              <a:off x="4837113" y="3321050"/>
              <a:ext cx="1304925" cy="127000"/>
            </a:xfrm>
            <a:custGeom>
              <a:avLst/>
              <a:gdLst>
                <a:gd name="T0" fmla="*/ 30 w 822"/>
                <a:gd name="T1" fmla="*/ 66 h 80"/>
                <a:gd name="T2" fmla="*/ 68 w 822"/>
                <a:gd name="T3" fmla="*/ 66 h 80"/>
                <a:gd name="T4" fmla="*/ 106 w 822"/>
                <a:gd name="T5" fmla="*/ 66 h 80"/>
                <a:gd name="T6" fmla="*/ 147 w 822"/>
                <a:gd name="T7" fmla="*/ 66 h 80"/>
                <a:gd name="T8" fmla="*/ 180 w 822"/>
                <a:gd name="T9" fmla="*/ 66 h 80"/>
                <a:gd name="T10" fmla="*/ 214 w 822"/>
                <a:gd name="T11" fmla="*/ 67 h 80"/>
                <a:gd name="T12" fmla="*/ 243 w 822"/>
                <a:gd name="T13" fmla="*/ 66 h 80"/>
                <a:gd name="T14" fmla="*/ 274 w 822"/>
                <a:gd name="T15" fmla="*/ 66 h 80"/>
                <a:gd name="T16" fmla="*/ 302 w 822"/>
                <a:gd name="T17" fmla="*/ 66 h 80"/>
                <a:gd name="T18" fmla="*/ 336 w 822"/>
                <a:gd name="T19" fmla="*/ 66 h 80"/>
                <a:gd name="T20" fmla="*/ 374 w 822"/>
                <a:gd name="T21" fmla="*/ 66 h 80"/>
                <a:gd name="T22" fmla="*/ 400 w 822"/>
                <a:gd name="T23" fmla="*/ 65 h 80"/>
                <a:gd name="T24" fmla="*/ 435 w 822"/>
                <a:gd name="T25" fmla="*/ 65 h 80"/>
                <a:gd name="T26" fmla="*/ 470 w 822"/>
                <a:gd name="T27" fmla="*/ 65 h 80"/>
                <a:gd name="T28" fmla="*/ 510 w 822"/>
                <a:gd name="T29" fmla="*/ 64 h 80"/>
                <a:gd name="T30" fmla="*/ 537 w 822"/>
                <a:gd name="T31" fmla="*/ 64 h 80"/>
                <a:gd name="T32" fmla="*/ 553 w 822"/>
                <a:gd name="T33" fmla="*/ 65 h 80"/>
                <a:gd name="T34" fmla="*/ 565 w 822"/>
                <a:gd name="T35" fmla="*/ 66 h 80"/>
                <a:gd name="T36" fmla="*/ 574 w 822"/>
                <a:gd name="T37" fmla="*/ 66 h 80"/>
                <a:gd name="T38" fmla="*/ 583 w 822"/>
                <a:gd name="T39" fmla="*/ 66 h 80"/>
                <a:gd name="T40" fmla="*/ 587 w 822"/>
                <a:gd name="T41" fmla="*/ 65 h 80"/>
                <a:gd name="T42" fmla="*/ 608 w 822"/>
                <a:gd name="T43" fmla="*/ 63 h 80"/>
                <a:gd name="T44" fmla="*/ 616 w 822"/>
                <a:gd name="T45" fmla="*/ 62 h 80"/>
                <a:gd name="T46" fmla="*/ 624 w 822"/>
                <a:gd name="T47" fmla="*/ 60 h 80"/>
                <a:gd name="T48" fmla="*/ 630 w 822"/>
                <a:gd name="T49" fmla="*/ 58 h 80"/>
                <a:gd name="T50" fmla="*/ 634 w 822"/>
                <a:gd name="T51" fmla="*/ 56 h 80"/>
                <a:gd name="T52" fmla="*/ 636 w 822"/>
                <a:gd name="T53" fmla="*/ 54 h 80"/>
                <a:gd name="T54" fmla="*/ 637 w 822"/>
                <a:gd name="T55" fmla="*/ 53 h 80"/>
                <a:gd name="T56" fmla="*/ 641 w 822"/>
                <a:gd name="T57" fmla="*/ 50 h 80"/>
                <a:gd name="T58" fmla="*/ 646 w 822"/>
                <a:gd name="T59" fmla="*/ 43 h 80"/>
                <a:gd name="T60" fmla="*/ 654 w 822"/>
                <a:gd name="T61" fmla="*/ 30 h 80"/>
                <a:gd name="T62" fmla="*/ 661 w 822"/>
                <a:gd name="T63" fmla="*/ 19 h 80"/>
                <a:gd name="T64" fmla="*/ 664 w 822"/>
                <a:gd name="T65" fmla="*/ 13 h 80"/>
                <a:gd name="T66" fmla="*/ 671 w 822"/>
                <a:gd name="T67" fmla="*/ 4 h 80"/>
                <a:gd name="T68" fmla="*/ 677 w 822"/>
                <a:gd name="T69" fmla="*/ 0 h 80"/>
                <a:gd name="T70" fmla="*/ 683 w 822"/>
                <a:gd name="T71" fmla="*/ 1 h 80"/>
                <a:gd name="T72" fmla="*/ 687 w 822"/>
                <a:gd name="T73" fmla="*/ 4 h 80"/>
                <a:gd name="T74" fmla="*/ 693 w 822"/>
                <a:gd name="T75" fmla="*/ 10 h 80"/>
                <a:gd name="T76" fmla="*/ 707 w 822"/>
                <a:gd name="T77" fmla="*/ 29 h 80"/>
                <a:gd name="T78" fmla="*/ 713 w 822"/>
                <a:gd name="T79" fmla="*/ 37 h 80"/>
                <a:gd name="T80" fmla="*/ 718 w 822"/>
                <a:gd name="T81" fmla="*/ 43 h 80"/>
                <a:gd name="T82" fmla="*/ 726 w 822"/>
                <a:gd name="T83" fmla="*/ 52 h 80"/>
                <a:gd name="T84" fmla="*/ 733 w 822"/>
                <a:gd name="T85" fmla="*/ 58 h 80"/>
                <a:gd name="T86" fmla="*/ 739 w 822"/>
                <a:gd name="T87" fmla="*/ 61 h 80"/>
                <a:gd name="T88" fmla="*/ 742 w 822"/>
                <a:gd name="T89" fmla="*/ 64 h 80"/>
                <a:gd name="T90" fmla="*/ 748 w 822"/>
                <a:gd name="T91" fmla="*/ 67 h 80"/>
                <a:gd name="T92" fmla="*/ 754 w 822"/>
                <a:gd name="T93" fmla="*/ 70 h 80"/>
                <a:gd name="T94" fmla="*/ 761 w 822"/>
                <a:gd name="T95" fmla="*/ 72 h 80"/>
                <a:gd name="T96" fmla="*/ 765 w 822"/>
                <a:gd name="T97" fmla="*/ 73 h 80"/>
                <a:gd name="T98" fmla="*/ 770 w 822"/>
                <a:gd name="T99" fmla="*/ 74 h 80"/>
                <a:gd name="T100" fmla="*/ 777 w 822"/>
                <a:gd name="T101" fmla="*/ 76 h 80"/>
                <a:gd name="T102" fmla="*/ 785 w 822"/>
                <a:gd name="T103" fmla="*/ 77 h 80"/>
                <a:gd name="T104" fmla="*/ 791 w 822"/>
                <a:gd name="T105" fmla="*/ 78 h 80"/>
                <a:gd name="T106" fmla="*/ 800 w 822"/>
                <a:gd name="T107" fmla="*/ 79 h 80"/>
                <a:gd name="T108" fmla="*/ 810 w 822"/>
                <a:gd name="T109" fmla="*/ 79 h 80"/>
                <a:gd name="T110" fmla="*/ 820 w 822"/>
                <a:gd name="T111" fmla="*/ 8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822" h="80">
                  <a:moveTo>
                    <a:pt x="0" y="66"/>
                  </a:moveTo>
                  <a:lnTo>
                    <a:pt x="3" y="66"/>
                  </a:lnTo>
                  <a:lnTo>
                    <a:pt x="6" y="66"/>
                  </a:lnTo>
                  <a:lnTo>
                    <a:pt x="11" y="66"/>
                  </a:lnTo>
                  <a:lnTo>
                    <a:pt x="17" y="66"/>
                  </a:lnTo>
                  <a:lnTo>
                    <a:pt x="21" y="66"/>
                  </a:lnTo>
                  <a:lnTo>
                    <a:pt x="26" y="66"/>
                  </a:lnTo>
                  <a:lnTo>
                    <a:pt x="30" y="66"/>
                  </a:lnTo>
                  <a:lnTo>
                    <a:pt x="34" y="66"/>
                  </a:lnTo>
                  <a:lnTo>
                    <a:pt x="37" y="66"/>
                  </a:lnTo>
                  <a:lnTo>
                    <a:pt x="43" y="66"/>
                  </a:lnTo>
                  <a:lnTo>
                    <a:pt x="48" y="66"/>
                  </a:lnTo>
                  <a:lnTo>
                    <a:pt x="53" y="66"/>
                  </a:lnTo>
                  <a:lnTo>
                    <a:pt x="58" y="66"/>
                  </a:lnTo>
                  <a:lnTo>
                    <a:pt x="64" y="66"/>
                  </a:lnTo>
                  <a:lnTo>
                    <a:pt x="68" y="66"/>
                  </a:lnTo>
                  <a:lnTo>
                    <a:pt x="72" y="66"/>
                  </a:lnTo>
                  <a:lnTo>
                    <a:pt x="76" y="66"/>
                  </a:lnTo>
                  <a:lnTo>
                    <a:pt x="81" y="66"/>
                  </a:lnTo>
                  <a:lnTo>
                    <a:pt x="85" y="66"/>
                  </a:lnTo>
                  <a:lnTo>
                    <a:pt x="89" y="66"/>
                  </a:lnTo>
                  <a:lnTo>
                    <a:pt x="94" y="66"/>
                  </a:lnTo>
                  <a:lnTo>
                    <a:pt x="99" y="66"/>
                  </a:lnTo>
                  <a:lnTo>
                    <a:pt x="106" y="66"/>
                  </a:lnTo>
                  <a:lnTo>
                    <a:pt x="112" y="66"/>
                  </a:lnTo>
                  <a:lnTo>
                    <a:pt x="117" y="66"/>
                  </a:lnTo>
                  <a:lnTo>
                    <a:pt x="123" y="66"/>
                  </a:lnTo>
                  <a:lnTo>
                    <a:pt x="128" y="66"/>
                  </a:lnTo>
                  <a:lnTo>
                    <a:pt x="133" y="66"/>
                  </a:lnTo>
                  <a:lnTo>
                    <a:pt x="138" y="66"/>
                  </a:lnTo>
                  <a:lnTo>
                    <a:pt x="143" y="66"/>
                  </a:lnTo>
                  <a:lnTo>
                    <a:pt x="147" y="66"/>
                  </a:lnTo>
                  <a:lnTo>
                    <a:pt x="151" y="66"/>
                  </a:lnTo>
                  <a:lnTo>
                    <a:pt x="154" y="66"/>
                  </a:lnTo>
                  <a:lnTo>
                    <a:pt x="157" y="66"/>
                  </a:lnTo>
                  <a:lnTo>
                    <a:pt x="159" y="66"/>
                  </a:lnTo>
                  <a:lnTo>
                    <a:pt x="163" y="66"/>
                  </a:lnTo>
                  <a:lnTo>
                    <a:pt x="168" y="66"/>
                  </a:lnTo>
                  <a:lnTo>
                    <a:pt x="173" y="66"/>
                  </a:lnTo>
                  <a:lnTo>
                    <a:pt x="180" y="66"/>
                  </a:lnTo>
                  <a:lnTo>
                    <a:pt x="185" y="66"/>
                  </a:lnTo>
                  <a:lnTo>
                    <a:pt x="188" y="66"/>
                  </a:lnTo>
                  <a:lnTo>
                    <a:pt x="191" y="66"/>
                  </a:lnTo>
                  <a:lnTo>
                    <a:pt x="196" y="66"/>
                  </a:lnTo>
                  <a:lnTo>
                    <a:pt x="202" y="66"/>
                  </a:lnTo>
                  <a:lnTo>
                    <a:pt x="206" y="66"/>
                  </a:lnTo>
                  <a:lnTo>
                    <a:pt x="210" y="66"/>
                  </a:lnTo>
                  <a:lnTo>
                    <a:pt x="214" y="67"/>
                  </a:lnTo>
                  <a:lnTo>
                    <a:pt x="217" y="67"/>
                  </a:lnTo>
                  <a:lnTo>
                    <a:pt x="220" y="67"/>
                  </a:lnTo>
                  <a:lnTo>
                    <a:pt x="223" y="67"/>
                  </a:lnTo>
                  <a:lnTo>
                    <a:pt x="226" y="66"/>
                  </a:lnTo>
                  <a:lnTo>
                    <a:pt x="230" y="66"/>
                  </a:lnTo>
                  <a:lnTo>
                    <a:pt x="232" y="66"/>
                  </a:lnTo>
                  <a:lnTo>
                    <a:pt x="237" y="66"/>
                  </a:lnTo>
                  <a:lnTo>
                    <a:pt x="243" y="66"/>
                  </a:lnTo>
                  <a:lnTo>
                    <a:pt x="247" y="66"/>
                  </a:lnTo>
                  <a:lnTo>
                    <a:pt x="251" y="66"/>
                  </a:lnTo>
                  <a:lnTo>
                    <a:pt x="254" y="66"/>
                  </a:lnTo>
                  <a:lnTo>
                    <a:pt x="258" y="66"/>
                  </a:lnTo>
                  <a:lnTo>
                    <a:pt x="263" y="66"/>
                  </a:lnTo>
                  <a:lnTo>
                    <a:pt x="267" y="66"/>
                  </a:lnTo>
                  <a:lnTo>
                    <a:pt x="271" y="66"/>
                  </a:lnTo>
                  <a:lnTo>
                    <a:pt x="274" y="66"/>
                  </a:lnTo>
                  <a:lnTo>
                    <a:pt x="278" y="66"/>
                  </a:lnTo>
                  <a:lnTo>
                    <a:pt x="281" y="66"/>
                  </a:lnTo>
                  <a:lnTo>
                    <a:pt x="283" y="66"/>
                  </a:lnTo>
                  <a:lnTo>
                    <a:pt x="286" y="66"/>
                  </a:lnTo>
                  <a:lnTo>
                    <a:pt x="290" y="66"/>
                  </a:lnTo>
                  <a:lnTo>
                    <a:pt x="294" y="66"/>
                  </a:lnTo>
                  <a:lnTo>
                    <a:pt x="298" y="66"/>
                  </a:lnTo>
                  <a:lnTo>
                    <a:pt x="302" y="66"/>
                  </a:lnTo>
                  <a:lnTo>
                    <a:pt x="305" y="66"/>
                  </a:lnTo>
                  <a:lnTo>
                    <a:pt x="309" y="66"/>
                  </a:lnTo>
                  <a:lnTo>
                    <a:pt x="314" y="66"/>
                  </a:lnTo>
                  <a:lnTo>
                    <a:pt x="318" y="66"/>
                  </a:lnTo>
                  <a:lnTo>
                    <a:pt x="321" y="66"/>
                  </a:lnTo>
                  <a:lnTo>
                    <a:pt x="326" y="66"/>
                  </a:lnTo>
                  <a:lnTo>
                    <a:pt x="331" y="66"/>
                  </a:lnTo>
                  <a:lnTo>
                    <a:pt x="336" y="66"/>
                  </a:lnTo>
                  <a:lnTo>
                    <a:pt x="341" y="66"/>
                  </a:lnTo>
                  <a:lnTo>
                    <a:pt x="347" y="66"/>
                  </a:lnTo>
                  <a:lnTo>
                    <a:pt x="352" y="66"/>
                  </a:lnTo>
                  <a:lnTo>
                    <a:pt x="357" y="66"/>
                  </a:lnTo>
                  <a:lnTo>
                    <a:pt x="362" y="66"/>
                  </a:lnTo>
                  <a:lnTo>
                    <a:pt x="367" y="66"/>
                  </a:lnTo>
                  <a:lnTo>
                    <a:pt x="371" y="66"/>
                  </a:lnTo>
                  <a:lnTo>
                    <a:pt x="374" y="66"/>
                  </a:lnTo>
                  <a:lnTo>
                    <a:pt x="378" y="66"/>
                  </a:lnTo>
                  <a:lnTo>
                    <a:pt x="382" y="66"/>
                  </a:lnTo>
                  <a:lnTo>
                    <a:pt x="384" y="66"/>
                  </a:lnTo>
                  <a:lnTo>
                    <a:pt x="386" y="65"/>
                  </a:lnTo>
                  <a:lnTo>
                    <a:pt x="388" y="65"/>
                  </a:lnTo>
                  <a:lnTo>
                    <a:pt x="392" y="65"/>
                  </a:lnTo>
                  <a:lnTo>
                    <a:pt x="395" y="65"/>
                  </a:lnTo>
                  <a:lnTo>
                    <a:pt x="400" y="65"/>
                  </a:lnTo>
                  <a:lnTo>
                    <a:pt x="404" y="65"/>
                  </a:lnTo>
                  <a:lnTo>
                    <a:pt x="408" y="65"/>
                  </a:lnTo>
                  <a:lnTo>
                    <a:pt x="412" y="65"/>
                  </a:lnTo>
                  <a:lnTo>
                    <a:pt x="416" y="65"/>
                  </a:lnTo>
                  <a:lnTo>
                    <a:pt x="421" y="65"/>
                  </a:lnTo>
                  <a:lnTo>
                    <a:pt x="427" y="65"/>
                  </a:lnTo>
                  <a:lnTo>
                    <a:pt x="431" y="65"/>
                  </a:lnTo>
                  <a:lnTo>
                    <a:pt x="435" y="65"/>
                  </a:lnTo>
                  <a:lnTo>
                    <a:pt x="439" y="65"/>
                  </a:lnTo>
                  <a:lnTo>
                    <a:pt x="442" y="65"/>
                  </a:lnTo>
                  <a:lnTo>
                    <a:pt x="447" y="65"/>
                  </a:lnTo>
                  <a:lnTo>
                    <a:pt x="452" y="65"/>
                  </a:lnTo>
                  <a:lnTo>
                    <a:pt x="457" y="65"/>
                  </a:lnTo>
                  <a:lnTo>
                    <a:pt x="462" y="65"/>
                  </a:lnTo>
                  <a:lnTo>
                    <a:pt x="466" y="65"/>
                  </a:lnTo>
                  <a:lnTo>
                    <a:pt x="470" y="65"/>
                  </a:lnTo>
                  <a:lnTo>
                    <a:pt x="475" y="65"/>
                  </a:lnTo>
                  <a:lnTo>
                    <a:pt x="482" y="65"/>
                  </a:lnTo>
                  <a:lnTo>
                    <a:pt x="487" y="65"/>
                  </a:lnTo>
                  <a:lnTo>
                    <a:pt x="492" y="65"/>
                  </a:lnTo>
                  <a:lnTo>
                    <a:pt x="497" y="65"/>
                  </a:lnTo>
                  <a:lnTo>
                    <a:pt x="501" y="65"/>
                  </a:lnTo>
                  <a:lnTo>
                    <a:pt x="506" y="64"/>
                  </a:lnTo>
                  <a:lnTo>
                    <a:pt x="510" y="64"/>
                  </a:lnTo>
                  <a:lnTo>
                    <a:pt x="514" y="64"/>
                  </a:lnTo>
                  <a:lnTo>
                    <a:pt x="518" y="64"/>
                  </a:lnTo>
                  <a:lnTo>
                    <a:pt x="522" y="64"/>
                  </a:lnTo>
                  <a:lnTo>
                    <a:pt x="527" y="64"/>
                  </a:lnTo>
                  <a:lnTo>
                    <a:pt x="530" y="64"/>
                  </a:lnTo>
                  <a:lnTo>
                    <a:pt x="533" y="64"/>
                  </a:lnTo>
                  <a:lnTo>
                    <a:pt x="535" y="64"/>
                  </a:lnTo>
                  <a:lnTo>
                    <a:pt x="537" y="64"/>
                  </a:lnTo>
                  <a:lnTo>
                    <a:pt x="538" y="64"/>
                  </a:lnTo>
                  <a:lnTo>
                    <a:pt x="540" y="64"/>
                  </a:lnTo>
                  <a:lnTo>
                    <a:pt x="542" y="64"/>
                  </a:lnTo>
                  <a:lnTo>
                    <a:pt x="545" y="64"/>
                  </a:lnTo>
                  <a:lnTo>
                    <a:pt x="547" y="64"/>
                  </a:lnTo>
                  <a:lnTo>
                    <a:pt x="549" y="64"/>
                  </a:lnTo>
                  <a:lnTo>
                    <a:pt x="551" y="65"/>
                  </a:lnTo>
                  <a:lnTo>
                    <a:pt x="553" y="65"/>
                  </a:lnTo>
                  <a:lnTo>
                    <a:pt x="556" y="65"/>
                  </a:lnTo>
                  <a:lnTo>
                    <a:pt x="558" y="65"/>
                  </a:lnTo>
                  <a:lnTo>
                    <a:pt x="559" y="65"/>
                  </a:lnTo>
                  <a:lnTo>
                    <a:pt x="560" y="65"/>
                  </a:lnTo>
                  <a:lnTo>
                    <a:pt x="561" y="65"/>
                  </a:lnTo>
                  <a:lnTo>
                    <a:pt x="562" y="65"/>
                  </a:lnTo>
                  <a:lnTo>
                    <a:pt x="564" y="65"/>
                  </a:lnTo>
                  <a:lnTo>
                    <a:pt x="565" y="66"/>
                  </a:lnTo>
                  <a:lnTo>
                    <a:pt x="566" y="66"/>
                  </a:lnTo>
                  <a:lnTo>
                    <a:pt x="567" y="66"/>
                  </a:lnTo>
                  <a:lnTo>
                    <a:pt x="568" y="66"/>
                  </a:lnTo>
                  <a:lnTo>
                    <a:pt x="569" y="66"/>
                  </a:lnTo>
                  <a:lnTo>
                    <a:pt x="571" y="66"/>
                  </a:lnTo>
                  <a:lnTo>
                    <a:pt x="572" y="66"/>
                  </a:lnTo>
                  <a:lnTo>
                    <a:pt x="573" y="66"/>
                  </a:lnTo>
                  <a:lnTo>
                    <a:pt x="574" y="66"/>
                  </a:lnTo>
                  <a:lnTo>
                    <a:pt x="575" y="66"/>
                  </a:lnTo>
                  <a:lnTo>
                    <a:pt x="576" y="66"/>
                  </a:lnTo>
                  <a:lnTo>
                    <a:pt x="577" y="66"/>
                  </a:lnTo>
                  <a:lnTo>
                    <a:pt x="578" y="66"/>
                  </a:lnTo>
                  <a:lnTo>
                    <a:pt x="579" y="66"/>
                  </a:lnTo>
                  <a:lnTo>
                    <a:pt x="580" y="66"/>
                  </a:lnTo>
                  <a:lnTo>
                    <a:pt x="582" y="66"/>
                  </a:lnTo>
                  <a:lnTo>
                    <a:pt x="583" y="66"/>
                  </a:lnTo>
                  <a:lnTo>
                    <a:pt x="583" y="65"/>
                  </a:lnTo>
                  <a:lnTo>
                    <a:pt x="584" y="65"/>
                  </a:lnTo>
                  <a:lnTo>
                    <a:pt x="585" y="65"/>
                  </a:lnTo>
                  <a:lnTo>
                    <a:pt x="585" y="65"/>
                  </a:lnTo>
                  <a:lnTo>
                    <a:pt x="586" y="65"/>
                  </a:lnTo>
                  <a:lnTo>
                    <a:pt x="586" y="65"/>
                  </a:lnTo>
                  <a:lnTo>
                    <a:pt x="587" y="65"/>
                  </a:lnTo>
                  <a:lnTo>
                    <a:pt x="587" y="65"/>
                  </a:lnTo>
                  <a:lnTo>
                    <a:pt x="588" y="65"/>
                  </a:lnTo>
                  <a:lnTo>
                    <a:pt x="590" y="65"/>
                  </a:lnTo>
                  <a:lnTo>
                    <a:pt x="591" y="65"/>
                  </a:lnTo>
                  <a:lnTo>
                    <a:pt x="593" y="65"/>
                  </a:lnTo>
                  <a:lnTo>
                    <a:pt x="595" y="64"/>
                  </a:lnTo>
                  <a:lnTo>
                    <a:pt x="600" y="64"/>
                  </a:lnTo>
                  <a:lnTo>
                    <a:pt x="605" y="63"/>
                  </a:lnTo>
                  <a:lnTo>
                    <a:pt x="608" y="63"/>
                  </a:lnTo>
                  <a:lnTo>
                    <a:pt x="609" y="63"/>
                  </a:lnTo>
                  <a:lnTo>
                    <a:pt x="610" y="62"/>
                  </a:lnTo>
                  <a:lnTo>
                    <a:pt x="611" y="62"/>
                  </a:lnTo>
                  <a:lnTo>
                    <a:pt x="611" y="62"/>
                  </a:lnTo>
                  <a:lnTo>
                    <a:pt x="612" y="62"/>
                  </a:lnTo>
                  <a:lnTo>
                    <a:pt x="612" y="62"/>
                  </a:lnTo>
                  <a:lnTo>
                    <a:pt x="614" y="62"/>
                  </a:lnTo>
                  <a:lnTo>
                    <a:pt x="616" y="62"/>
                  </a:lnTo>
                  <a:lnTo>
                    <a:pt x="617" y="61"/>
                  </a:lnTo>
                  <a:lnTo>
                    <a:pt x="619" y="61"/>
                  </a:lnTo>
                  <a:lnTo>
                    <a:pt x="620" y="61"/>
                  </a:lnTo>
                  <a:lnTo>
                    <a:pt x="621" y="61"/>
                  </a:lnTo>
                  <a:lnTo>
                    <a:pt x="621" y="61"/>
                  </a:lnTo>
                  <a:lnTo>
                    <a:pt x="622" y="60"/>
                  </a:lnTo>
                  <a:lnTo>
                    <a:pt x="623" y="60"/>
                  </a:lnTo>
                  <a:lnTo>
                    <a:pt x="624" y="60"/>
                  </a:lnTo>
                  <a:lnTo>
                    <a:pt x="625" y="60"/>
                  </a:lnTo>
                  <a:lnTo>
                    <a:pt x="626" y="60"/>
                  </a:lnTo>
                  <a:lnTo>
                    <a:pt x="626" y="59"/>
                  </a:lnTo>
                  <a:lnTo>
                    <a:pt x="627" y="59"/>
                  </a:lnTo>
                  <a:lnTo>
                    <a:pt x="628" y="59"/>
                  </a:lnTo>
                  <a:lnTo>
                    <a:pt x="628" y="59"/>
                  </a:lnTo>
                  <a:lnTo>
                    <a:pt x="629" y="58"/>
                  </a:lnTo>
                  <a:lnTo>
                    <a:pt x="630" y="58"/>
                  </a:lnTo>
                  <a:lnTo>
                    <a:pt x="630" y="58"/>
                  </a:lnTo>
                  <a:lnTo>
                    <a:pt x="631" y="58"/>
                  </a:lnTo>
                  <a:lnTo>
                    <a:pt x="631" y="57"/>
                  </a:lnTo>
                  <a:lnTo>
                    <a:pt x="632" y="57"/>
                  </a:lnTo>
                  <a:lnTo>
                    <a:pt x="633" y="57"/>
                  </a:lnTo>
                  <a:lnTo>
                    <a:pt x="633" y="56"/>
                  </a:lnTo>
                  <a:lnTo>
                    <a:pt x="634" y="56"/>
                  </a:lnTo>
                  <a:lnTo>
                    <a:pt x="634" y="56"/>
                  </a:lnTo>
                  <a:lnTo>
                    <a:pt x="635" y="55"/>
                  </a:lnTo>
                  <a:lnTo>
                    <a:pt x="635" y="55"/>
                  </a:lnTo>
                  <a:lnTo>
                    <a:pt x="635" y="55"/>
                  </a:lnTo>
                  <a:lnTo>
                    <a:pt x="635" y="55"/>
                  </a:lnTo>
                  <a:lnTo>
                    <a:pt x="636" y="55"/>
                  </a:lnTo>
                  <a:lnTo>
                    <a:pt x="636" y="55"/>
                  </a:lnTo>
                  <a:lnTo>
                    <a:pt x="636" y="54"/>
                  </a:lnTo>
                  <a:lnTo>
                    <a:pt x="636" y="54"/>
                  </a:lnTo>
                  <a:lnTo>
                    <a:pt x="636" y="54"/>
                  </a:lnTo>
                  <a:lnTo>
                    <a:pt x="637" y="54"/>
                  </a:lnTo>
                  <a:lnTo>
                    <a:pt x="637" y="54"/>
                  </a:lnTo>
                  <a:lnTo>
                    <a:pt x="637" y="54"/>
                  </a:lnTo>
                  <a:lnTo>
                    <a:pt x="637" y="53"/>
                  </a:lnTo>
                  <a:lnTo>
                    <a:pt x="637" y="53"/>
                  </a:lnTo>
                  <a:lnTo>
                    <a:pt x="637" y="53"/>
                  </a:lnTo>
                  <a:lnTo>
                    <a:pt x="637" y="53"/>
                  </a:lnTo>
                  <a:lnTo>
                    <a:pt x="638" y="53"/>
                  </a:lnTo>
                  <a:lnTo>
                    <a:pt x="638" y="53"/>
                  </a:lnTo>
                  <a:lnTo>
                    <a:pt x="639" y="52"/>
                  </a:lnTo>
                  <a:lnTo>
                    <a:pt x="639" y="52"/>
                  </a:lnTo>
                  <a:lnTo>
                    <a:pt x="640" y="51"/>
                  </a:lnTo>
                  <a:lnTo>
                    <a:pt x="640" y="51"/>
                  </a:lnTo>
                  <a:lnTo>
                    <a:pt x="641" y="50"/>
                  </a:lnTo>
                  <a:lnTo>
                    <a:pt x="641" y="50"/>
                  </a:lnTo>
                  <a:lnTo>
                    <a:pt x="642" y="49"/>
                  </a:lnTo>
                  <a:lnTo>
                    <a:pt x="642" y="48"/>
                  </a:lnTo>
                  <a:lnTo>
                    <a:pt x="643" y="48"/>
                  </a:lnTo>
                  <a:lnTo>
                    <a:pt x="644" y="47"/>
                  </a:lnTo>
                  <a:lnTo>
                    <a:pt x="644" y="46"/>
                  </a:lnTo>
                  <a:lnTo>
                    <a:pt x="645" y="45"/>
                  </a:lnTo>
                  <a:lnTo>
                    <a:pt x="646" y="44"/>
                  </a:lnTo>
                  <a:lnTo>
                    <a:pt x="646" y="43"/>
                  </a:lnTo>
                  <a:lnTo>
                    <a:pt x="647" y="42"/>
                  </a:lnTo>
                  <a:lnTo>
                    <a:pt x="648" y="40"/>
                  </a:lnTo>
                  <a:lnTo>
                    <a:pt x="649" y="39"/>
                  </a:lnTo>
                  <a:lnTo>
                    <a:pt x="650" y="38"/>
                  </a:lnTo>
                  <a:lnTo>
                    <a:pt x="651" y="36"/>
                  </a:lnTo>
                  <a:lnTo>
                    <a:pt x="652" y="34"/>
                  </a:lnTo>
                  <a:lnTo>
                    <a:pt x="653" y="32"/>
                  </a:lnTo>
                  <a:lnTo>
                    <a:pt x="654" y="30"/>
                  </a:lnTo>
                  <a:lnTo>
                    <a:pt x="655" y="28"/>
                  </a:lnTo>
                  <a:lnTo>
                    <a:pt x="657" y="25"/>
                  </a:lnTo>
                  <a:lnTo>
                    <a:pt x="659" y="22"/>
                  </a:lnTo>
                  <a:lnTo>
                    <a:pt x="660" y="20"/>
                  </a:lnTo>
                  <a:lnTo>
                    <a:pt x="660" y="20"/>
                  </a:lnTo>
                  <a:lnTo>
                    <a:pt x="660" y="19"/>
                  </a:lnTo>
                  <a:lnTo>
                    <a:pt x="660" y="19"/>
                  </a:lnTo>
                  <a:lnTo>
                    <a:pt x="661" y="19"/>
                  </a:lnTo>
                  <a:lnTo>
                    <a:pt x="661" y="18"/>
                  </a:lnTo>
                  <a:lnTo>
                    <a:pt x="661" y="18"/>
                  </a:lnTo>
                  <a:lnTo>
                    <a:pt x="661" y="18"/>
                  </a:lnTo>
                  <a:lnTo>
                    <a:pt x="661" y="18"/>
                  </a:lnTo>
                  <a:lnTo>
                    <a:pt x="661" y="17"/>
                  </a:lnTo>
                  <a:lnTo>
                    <a:pt x="662" y="17"/>
                  </a:lnTo>
                  <a:lnTo>
                    <a:pt x="663" y="15"/>
                  </a:lnTo>
                  <a:lnTo>
                    <a:pt x="664" y="13"/>
                  </a:lnTo>
                  <a:lnTo>
                    <a:pt x="665" y="11"/>
                  </a:lnTo>
                  <a:lnTo>
                    <a:pt x="666" y="10"/>
                  </a:lnTo>
                  <a:lnTo>
                    <a:pt x="667" y="9"/>
                  </a:lnTo>
                  <a:lnTo>
                    <a:pt x="668" y="8"/>
                  </a:lnTo>
                  <a:lnTo>
                    <a:pt x="668" y="7"/>
                  </a:lnTo>
                  <a:lnTo>
                    <a:pt x="669" y="6"/>
                  </a:lnTo>
                  <a:lnTo>
                    <a:pt x="670" y="5"/>
                  </a:lnTo>
                  <a:lnTo>
                    <a:pt x="671" y="4"/>
                  </a:lnTo>
                  <a:lnTo>
                    <a:pt x="672" y="3"/>
                  </a:lnTo>
                  <a:lnTo>
                    <a:pt x="672" y="3"/>
                  </a:lnTo>
                  <a:lnTo>
                    <a:pt x="673" y="2"/>
                  </a:lnTo>
                  <a:lnTo>
                    <a:pt x="674" y="2"/>
                  </a:lnTo>
                  <a:lnTo>
                    <a:pt x="675" y="1"/>
                  </a:lnTo>
                  <a:lnTo>
                    <a:pt x="675" y="1"/>
                  </a:lnTo>
                  <a:lnTo>
                    <a:pt x="676" y="0"/>
                  </a:lnTo>
                  <a:lnTo>
                    <a:pt x="677" y="0"/>
                  </a:lnTo>
                  <a:lnTo>
                    <a:pt x="678" y="0"/>
                  </a:lnTo>
                  <a:lnTo>
                    <a:pt x="678" y="0"/>
                  </a:lnTo>
                  <a:lnTo>
                    <a:pt x="679" y="0"/>
                  </a:lnTo>
                  <a:lnTo>
                    <a:pt x="680" y="0"/>
                  </a:lnTo>
                  <a:lnTo>
                    <a:pt x="681" y="0"/>
                  </a:lnTo>
                  <a:lnTo>
                    <a:pt x="681" y="0"/>
                  </a:lnTo>
                  <a:lnTo>
                    <a:pt x="682" y="1"/>
                  </a:lnTo>
                  <a:lnTo>
                    <a:pt x="683" y="1"/>
                  </a:lnTo>
                  <a:lnTo>
                    <a:pt x="684" y="1"/>
                  </a:lnTo>
                  <a:lnTo>
                    <a:pt x="685" y="2"/>
                  </a:lnTo>
                  <a:lnTo>
                    <a:pt x="685" y="2"/>
                  </a:lnTo>
                  <a:lnTo>
                    <a:pt x="686" y="3"/>
                  </a:lnTo>
                  <a:lnTo>
                    <a:pt x="686" y="3"/>
                  </a:lnTo>
                  <a:lnTo>
                    <a:pt x="686" y="3"/>
                  </a:lnTo>
                  <a:lnTo>
                    <a:pt x="687" y="3"/>
                  </a:lnTo>
                  <a:lnTo>
                    <a:pt x="687" y="4"/>
                  </a:lnTo>
                  <a:lnTo>
                    <a:pt x="687" y="4"/>
                  </a:lnTo>
                  <a:lnTo>
                    <a:pt x="688" y="4"/>
                  </a:lnTo>
                  <a:lnTo>
                    <a:pt x="688" y="4"/>
                  </a:lnTo>
                  <a:lnTo>
                    <a:pt x="689" y="5"/>
                  </a:lnTo>
                  <a:lnTo>
                    <a:pt x="690" y="6"/>
                  </a:lnTo>
                  <a:lnTo>
                    <a:pt x="691" y="7"/>
                  </a:lnTo>
                  <a:lnTo>
                    <a:pt x="692" y="8"/>
                  </a:lnTo>
                  <a:lnTo>
                    <a:pt x="693" y="10"/>
                  </a:lnTo>
                  <a:lnTo>
                    <a:pt x="694" y="11"/>
                  </a:lnTo>
                  <a:lnTo>
                    <a:pt x="696" y="13"/>
                  </a:lnTo>
                  <a:lnTo>
                    <a:pt x="697" y="15"/>
                  </a:lnTo>
                  <a:lnTo>
                    <a:pt x="699" y="18"/>
                  </a:lnTo>
                  <a:lnTo>
                    <a:pt x="701" y="20"/>
                  </a:lnTo>
                  <a:lnTo>
                    <a:pt x="703" y="23"/>
                  </a:lnTo>
                  <a:lnTo>
                    <a:pt x="705" y="26"/>
                  </a:lnTo>
                  <a:lnTo>
                    <a:pt x="707" y="29"/>
                  </a:lnTo>
                  <a:lnTo>
                    <a:pt x="709" y="31"/>
                  </a:lnTo>
                  <a:lnTo>
                    <a:pt x="710" y="33"/>
                  </a:lnTo>
                  <a:lnTo>
                    <a:pt x="711" y="35"/>
                  </a:lnTo>
                  <a:lnTo>
                    <a:pt x="712" y="35"/>
                  </a:lnTo>
                  <a:lnTo>
                    <a:pt x="712" y="36"/>
                  </a:lnTo>
                  <a:lnTo>
                    <a:pt x="713" y="36"/>
                  </a:lnTo>
                  <a:lnTo>
                    <a:pt x="713" y="37"/>
                  </a:lnTo>
                  <a:lnTo>
                    <a:pt x="713" y="37"/>
                  </a:lnTo>
                  <a:lnTo>
                    <a:pt x="714" y="38"/>
                  </a:lnTo>
                  <a:lnTo>
                    <a:pt x="714" y="38"/>
                  </a:lnTo>
                  <a:lnTo>
                    <a:pt x="714" y="38"/>
                  </a:lnTo>
                  <a:lnTo>
                    <a:pt x="714" y="38"/>
                  </a:lnTo>
                  <a:lnTo>
                    <a:pt x="715" y="39"/>
                  </a:lnTo>
                  <a:lnTo>
                    <a:pt x="716" y="40"/>
                  </a:lnTo>
                  <a:lnTo>
                    <a:pt x="717" y="42"/>
                  </a:lnTo>
                  <a:lnTo>
                    <a:pt x="718" y="43"/>
                  </a:lnTo>
                  <a:lnTo>
                    <a:pt x="720" y="45"/>
                  </a:lnTo>
                  <a:lnTo>
                    <a:pt x="721" y="46"/>
                  </a:lnTo>
                  <a:lnTo>
                    <a:pt x="722" y="47"/>
                  </a:lnTo>
                  <a:lnTo>
                    <a:pt x="723" y="48"/>
                  </a:lnTo>
                  <a:lnTo>
                    <a:pt x="724" y="49"/>
                  </a:lnTo>
                  <a:lnTo>
                    <a:pt x="725" y="50"/>
                  </a:lnTo>
                  <a:lnTo>
                    <a:pt x="726" y="51"/>
                  </a:lnTo>
                  <a:lnTo>
                    <a:pt x="726" y="52"/>
                  </a:lnTo>
                  <a:lnTo>
                    <a:pt x="727" y="53"/>
                  </a:lnTo>
                  <a:lnTo>
                    <a:pt x="728" y="53"/>
                  </a:lnTo>
                  <a:lnTo>
                    <a:pt x="729" y="54"/>
                  </a:lnTo>
                  <a:lnTo>
                    <a:pt x="730" y="55"/>
                  </a:lnTo>
                  <a:lnTo>
                    <a:pt x="731" y="55"/>
                  </a:lnTo>
                  <a:lnTo>
                    <a:pt x="732" y="56"/>
                  </a:lnTo>
                  <a:lnTo>
                    <a:pt x="732" y="57"/>
                  </a:lnTo>
                  <a:lnTo>
                    <a:pt x="733" y="58"/>
                  </a:lnTo>
                  <a:lnTo>
                    <a:pt x="734" y="58"/>
                  </a:lnTo>
                  <a:lnTo>
                    <a:pt x="735" y="59"/>
                  </a:lnTo>
                  <a:lnTo>
                    <a:pt x="736" y="59"/>
                  </a:lnTo>
                  <a:lnTo>
                    <a:pt x="737" y="60"/>
                  </a:lnTo>
                  <a:lnTo>
                    <a:pt x="737" y="60"/>
                  </a:lnTo>
                  <a:lnTo>
                    <a:pt x="738" y="61"/>
                  </a:lnTo>
                  <a:lnTo>
                    <a:pt x="738" y="61"/>
                  </a:lnTo>
                  <a:lnTo>
                    <a:pt x="739" y="61"/>
                  </a:lnTo>
                  <a:lnTo>
                    <a:pt x="739" y="62"/>
                  </a:lnTo>
                  <a:lnTo>
                    <a:pt x="739" y="62"/>
                  </a:lnTo>
                  <a:lnTo>
                    <a:pt x="740" y="62"/>
                  </a:lnTo>
                  <a:lnTo>
                    <a:pt x="740" y="62"/>
                  </a:lnTo>
                  <a:lnTo>
                    <a:pt x="740" y="62"/>
                  </a:lnTo>
                  <a:lnTo>
                    <a:pt x="741" y="63"/>
                  </a:lnTo>
                  <a:lnTo>
                    <a:pt x="741" y="63"/>
                  </a:lnTo>
                  <a:lnTo>
                    <a:pt x="742" y="64"/>
                  </a:lnTo>
                  <a:lnTo>
                    <a:pt x="743" y="64"/>
                  </a:lnTo>
                  <a:lnTo>
                    <a:pt x="744" y="65"/>
                  </a:lnTo>
                  <a:lnTo>
                    <a:pt x="745" y="65"/>
                  </a:lnTo>
                  <a:lnTo>
                    <a:pt x="745" y="65"/>
                  </a:lnTo>
                  <a:lnTo>
                    <a:pt x="746" y="66"/>
                  </a:lnTo>
                  <a:lnTo>
                    <a:pt x="747" y="66"/>
                  </a:lnTo>
                  <a:lnTo>
                    <a:pt x="747" y="66"/>
                  </a:lnTo>
                  <a:lnTo>
                    <a:pt x="748" y="67"/>
                  </a:lnTo>
                  <a:lnTo>
                    <a:pt x="749" y="67"/>
                  </a:lnTo>
                  <a:lnTo>
                    <a:pt x="750" y="68"/>
                  </a:lnTo>
                  <a:lnTo>
                    <a:pt x="751" y="68"/>
                  </a:lnTo>
                  <a:lnTo>
                    <a:pt x="751" y="68"/>
                  </a:lnTo>
                  <a:lnTo>
                    <a:pt x="752" y="69"/>
                  </a:lnTo>
                  <a:lnTo>
                    <a:pt x="753" y="69"/>
                  </a:lnTo>
                  <a:lnTo>
                    <a:pt x="754" y="69"/>
                  </a:lnTo>
                  <a:lnTo>
                    <a:pt x="754" y="70"/>
                  </a:lnTo>
                  <a:lnTo>
                    <a:pt x="755" y="70"/>
                  </a:lnTo>
                  <a:lnTo>
                    <a:pt x="756" y="70"/>
                  </a:lnTo>
                  <a:lnTo>
                    <a:pt x="757" y="70"/>
                  </a:lnTo>
                  <a:lnTo>
                    <a:pt x="758" y="71"/>
                  </a:lnTo>
                  <a:lnTo>
                    <a:pt x="759" y="71"/>
                  </a:lnTo>
                  <a:lnTo>
                    <a:pt x="759" y="71"/>
                  </a:lnTo>
                  <a:lnTo>
                    <a:pt x="760" y="72"/>
                  </a:lnTo>
                  <a:lnTo>
                    <a:pt x="761" y="72"/>
                  </a:lnTo>
                  <a:lnTo>
                    <a:pt x="762" y="72"/>
                  </a:lnTo>
                  <a:lnTo>
                    <a:pt x="763" y="73"/>
                  </a:lnTo>
                  <a:lnTo>
                    <a:pt x="763" y="73"/>
                  </a:lnTo>
                  <a:lnTo>
                    <a:pt x="764" y="73"/>
                  </a:lnTo>
                  <a:lnTo>
                    <a:pt x="764" y="73"/>
                  </a:lnTo>
                  <a:lnTo>
                    <a:pt x="765" y="73"/>
                  </a:lnTo>
                  <a:lnTo>
                    <a:pt x="765" y="73"/>
                  </a:lnTo>
                  <a:lnTo>
                    <a:pt x="765" y="73"/>
                  </a:lnTo>
                  <a:lnTo>
                    <a:pt x="765" y="73"/>
                  </a:lnTo>
                  <a:lnTo>
                    <a:pt x="766" y="73"/>
                  </a:lnTo>
                  <a:lnTo>
                    <a:pt x="766" y="73"/>
                  </a:lnTo>
                  <a:lnTo>
                    <a:pt x="767" y="74"/>
                  </a:lnTo>
                  <a:lnTo>
                    <a:pt x="768" y="74"/>
                  </a:lnTo>
                  <a:lnTo>
                    <a:pt x="769" y="74"/>
                  </a:lnTo>
                  <a:lnTo>
                    <a:pt x="769" y="74"/>
                  </a:lnTo>
                  <a:lnTo>
                    <a:pt x="770" y="74"/>
                  </a:lnTo>
                  <a:lnTo>
                    <a:pt x="771" y="75"/>
                  </a:lnTo>
                  <a:lnTo>
                    <a:pt x="772" y="75"/>
                  </a:lnTo>
                  <a:lnTo>
                    <a:pt x="773" y="75"/>
                  </a:lnTo>
                  <a:lnTo>
                    <a:pt x="773" y="75"/>
                  </a:lnTo>
                  <a:lnTo>
                    <a:pt x="774" y="75"/>
                  </a:lnTo>
                  <a:lnTo>
                    <a:pt x="775" y="75"/>
                  </a:lnTo>
                  <a:lnTo>
                    <a:pt x="776" y="76"/>
                  </a:lnTo>
                  <a:lnTo>
                    <a:pt x="777" y="76"/>
                  </a:lnTo>
                  <a:lnTo>
                    <a:pt x="778" y="76"/>
                  </a:lnTo>
                  <a:lnTo>
                    <a:pt x="779" y="76"/>
                  </a:lnTo>
                  <a:lnTo>
                    <a:pt x="780" y="76"/>
                  </a:lnTo>
                  <a:lnTo>
                    <a:pt x="781" y="77"/>
                  </a:lnTo>
                  <a:lnTo>
                    <a:pt x="782" y="77"/>
                  </a:lnTo>
                  <a:lnTo>
                    <a:pt x="783" y="77"/>
                  </a:lnTo>
                  <a:lnTo>
                    <a:pt x="784" y="77"/>
                  </a:lnTo>
                  <a:lnTo>
                    <a:pt x="785" y="77"/>
                  </a:lnTo>
                  <a:lnTo>
                    <a:pt x="786" y="77"/>
                  </a:lnTo>
                  <a:lnTo>
                    <a:pt x="787" y="77"/>
                  </a:lnTo>
                  <a:lnTo>
                    <a:pt x="788" y="78"/>
                  </a:lnTo>
                  <a:lnTo>
                    <a:pt x="789" y="78"/>
                  </a:lnTo>
                  <a:lnTo>
                    <a:pt x="790" y="78"/>
                  </a:lnTo>
                  <a:lnTo>
                    <a:pt x="790" y="78"/>
                  </a:lnTo>
                  <a:lnTo>
                    <a:pt x="791" y="78"/>
                  </a:lnTo>
                  <a:lnTo>
                    <a:pt x="791" y="78"/>
                  </a:lnTo>
                  <a:lnTo>
                    <a:pt x="791" y="78"/>
                  </a:lnTo>
                  <a:lnTo>
                    <a:pt x="792" y="78"/>
                  </a:lnTo>
                  <a:lnTo>
                    <a:pt x="793" y="78"/>
                  </a:lnTo>
                  <a:lnTo>
                    <a:pt x="795" y="78"/>
                  </a:lnTo>
                  <a:lnTo>
                    <a:pt x="796" y="78"/>
                  </a:lnTo>
                  <a:lnTo>
                    <a:pt x="797" y="78"/>
                  </a:lnTo>
                  <a:lnTo>
                    <a:pt x="799" y="79"/>
                  </a:lnTo>
                  <a:lnTo>
                    <a:pt x="800" y="79"/>
                  </a:lnTo>
                  <a:lnTo>
                    <a:pt x="801" y="79"/>
                  </a:lnTo>
                  <a:lnTo>
                    <a:pt x="802" y="79"/>
                  </a:lnTo>
                  <a:lnTo>
                    <a:pt x="804" y="79"/>
                  </a:lnTo>
                  <a:lnTo>
                    <a:pt x="805" y="79"/>
                  </a:lnTo>
                  <a:lnTo>
                    <a:pt x="806" y="79"/>
                  </a:lnTo>
                  <a:lnTo>
                    <a:pt x="807" y="79"/>
                  </a:lnTo>
                  <a:lnTo>
                    <a:pt x="809" y="79"/>
                  </a:lnTo>
                  <a:lnTo>
                    <a:pt x="810" y="79"/>
                  </a:lnTo>
                  <a:lnTo>
                    <a:pt x="811" y="79"/>
                  </a:lnTo>
                  <a:lnTo>
                    <a:pt x="812" y="80"/>
                  </a:lnTo>
                  <a:lnTo>
                    <a:pt x="813" y="80"/>
                  </a:lnTo>
                  <a:lnTo>
                    <a:pt x="815" y="80"/>
                  </a:lnTo>
                  <a:lnTo>
                    <a:pt x="816" y="80"/>
                  </a:lnTo>
                  <a:lnTo>
                    <a:pt x="817" y="80"/>
                  </a:lnTo>
                  <a:lnTo>
                    <a:pt x="818" y="80"/>
                  </a:lnTo>
                  <a:lnTo>
                    <a:pt x="820" y="80"/>
                  </a:lnTo>
                  <a:lnTo>
                    <a:pt x="821" y="80"/>
                  </a:lnTo>
                  <a:lnTo>
                    <a:pt x="822" y="80"/>
                  </a:lnTo>
                  <a:lnTo>
                    <a:pt x="822" y="8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A4725453-AED6-4E78-8AC9-13C6C98CFDE4}"/>
                </a:ext>
              </a:extLst>
            </p:cNvPr>
            <p:cNvSpPr txBox="1"/>
            <p:nvPr/>
          </p:nvSpPr>
          <p:spPr>
            <a:xfrm rot="16200000">
              <a:off x="-98610" y="2370092"/>
              <a:ext cx="1629226" cy="3209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itchFamily="34" charset="0"/>
                  <a:cs typeface="Arial" pitchFamily="34" charset="0"/>
                </a:rPr>
                <a:t>Intensity (</a:t>
              </a:r>
              <a:r>
                <a:rPr lang="en-US" sz="1100" dirty="0" err="1">
                  <a:latin typeface="Arial" pitchFamily="34" charset="0"/>
                  <a:cs typeface="Arial" pitchFamily="34" charset="0"/>
                </a:rPr>
                <a:t>mAU</a:t>
              </a:r>
              <a:r>
                <a:rPr lang="en-US" sz="1100" dirty="0">
                  <a:latin typeface="Arial" pitchFamily="34" charset="0"/>
                  <a:cs typeface="Arial" pitchFamily="34" charset="0"/>
                </a:rPr>
                <a:t>)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BB0CEE8F-D09A-48EC-A61A-F76890C5ACD8}"/>
                </a:ext>
              </a:extLst>
            </p:cNvPr>
            <p:cNvSpPr txBox="1"/>
            <p:nvPr/>
          </p:nvSpPr>
          <p:spPr>
            <a:xfrm>
              <a:off x="2422027" y="3828415"/>
              <a:ext cx="2325444" cy="3101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itchFamily="34" charset="0"/>
                  <a:cs typeface="Arial" pitchFamily="34" charset="0"/>
                </a:rPr>
                <a:t>Retention time (min)</a:t>
              </a:r>
            </a:p>
          </p:txBody>
        </p:sp>
      </p:grpSp>
      <p:sp>
        <p:nvSpPr>
          <p:cNvPr id="168" name="TextBox 167">
            <a:extLst>
              <a:ext uri="{FF2B5EF4-FFF2-40B4-BE49-F238E27FC236}">
                <a16:creationId xmlns:a16="http://schemas.microsoft.com/office/drawing/2014/main" id="{A2A04343-EBCD-4357-93EE-618FC3A91B2A}"/>
              </a:ext>
            </a:extLst>
          </p:cNvPr>
          <p:cNvSpPr txBox="1"/>
          <p:nvPr/>
        </p:nvSpPr>
        <p:spPr>
          <a:xfrm>
            <a:off x="1589578" y="4992192"/>
            <a:ext cx="1080154" cy="2488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686 </a:t>
            </a:r>
            <a:r>
              <a:rPr lang="en-US" sz="1000" dirty="0" err="1">
                <a:latin typeface="Arial" pitchFamily="34" charset="0"/>
                <a:cs typeface="Arial" pitchFamily="34" charset="0"/>
              </a:rPr>
              <a:t>bp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 dsRNA 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9457CE5F-C843-45A4-883A-DB96AC1E9AE7}"/>
              </a:ext>
            </a:extLst>
          </p:cNvPr>
          <p:cNvSpPr txBox="1"/>
          <p:nvPr/>
        </p:nvSpPr>
        <p:spPr>
          <a:xfrm>
            <a:off x="109295" y="7130848"/>
            <a:ext cx="3072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D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70" name="Group 169">
            <a:extLst>
              <a:ext uri="{FF2B5EF4-FFF2-40B4-BE49-F238E27FC236}">
                <a16:creationId xmlns:a16="http://schemas.microsoft.com/office/drawing/2014/main" id="{01EE6BC2-926A-4A74-8F81-9F09FA6BA98F}"/>
              </a:ext>
            </a:extLst>
          </p:cNvPr>
          <p:cNvGrpSpPr/>
          <p:nvPr/>
        </p:nvGrpSpPr>
        <p:grpSpPr>
          <a:xfrm>
            <a:off x="1052736" y="7185248"/>
            <a:ext cx="4659609" cy="2504891"/>
            <a:chOff x="-180518" y="1497013"/>
            <a:chExt cx="6440031" cy="2873268"/>
          </a:xfrm>
        </p:grpSpPr>
        <p:sp>
          <p:nvSpPr>
            <p:cNvPr id="171" name="AutoShape 144">
              <a:extLst>
                <a:ext uri="{FF2B5EF4-FFF2-40B4-BE49-F238E27FC236}">
                  <a16:creationId xmlns:a16="http://schemas.microsoft.com/office/drawing/2014/main" id="{BEE1334D-0368-4A1D-83D0-28532B6DF376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260350" y="1497013"/>
              <a:ext cx="5999163" cy="2590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2" name="Rectangle 171">
              <a:extLst>
                <a:ext uri="{FF2B5EF4-FFF2-40B4-BE49-F238E27FC236}">
                  <a16:creationId xmlns:a16="http://schemas.microsoft.com/office/drawing/2014/main" id="{9208D3C6-AB1C-4C4E-B47B-5E50F14BC0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125" y="3932238"/>
              <a:ext cx="11430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" name="Line 148">
              <a:extLst>
                <a:ext uri="{FF2B5EF4-FFF2-40B4-BE49-F238E27FC236}">
                  <a16:creationId xmlns:a16="http://schemas.microsoft.com/office/drawing/2014/main" id="{5B2009D0-F71A-4277-91E9-ECD2CB47E8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2275" y="3870326"/>
              <a:ext cx="0" cy="619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4" name="Rectangle 161">
              <a:extLst>
                <a:ext uri="{FF2B5EF4-FFF2-40B4-BE49-F238E27FC236}">
                  <a16:creationId xmlns:a16="http://schemas.microsoft.com/office/drawing/2014/main" id="{619764E4-0DCF-463D-BAD2-F810D4BD44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4275" y="3932238"/>
              <a:ext cx="114300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" name="Line 162">
              <a:extLst>
                <a:ext uri="{FF2B5EF4-FFF2-40B4-BE49-F238E27FC236}">
                  <a16:creationId xmlns:a16="http://schemas.microsoft.com/office/drawing/2014/main" id="{A24DF38F-1300-4CD7-A824-84C36EFEEE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41425" y="3870326"/>
              <a:ext cx="0" cy="619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6" name="Rectangle 185">
              <a:extLst>
                <a:ext uri="{FF2B5EF4-FFF2-40B4-BE49-F238E27FC236}">
                  <a16:creationId xmlns:a16="http://schemas.microsoft.com/office/drawing/2014/main" id="{270637B9-0963-4C84-BC52-BCB964562F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2063" y="3932238"/>
              <a:ext cx="1492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.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" name="Line 186">
              <a:extLst>
                <a:ext uri="{FF2B5EF4-FFF2-40B4-BE49-F238E27FC236}">
                  <a16:creationId xmlns:a16="http://schemas.microsoft.com/office/drawing/2014/main" id="{67BF8788-4B9C-4698-A4FF-DC7A823CF7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06675" y="3870326"/>
              <a:ext cx="0" cy="619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8" name="Rectangle 209">
              <a:extLst>
                <a:ext uri="{FF2B5EF4-FFF2-40B4-BE49-F238E27FC236}">
                  <a16:creationId xmlns:a16="http://schemas.microsoft.com/office/drawing/2014/main" id="{F6EEFC14-6308-4B1E-B653-BE058F77B4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7313" y="3932238"/>
              <a:ext cx="1492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.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9" name="Line 210">
              <a:extLst>
                <a:ext uri="{FF2B5EF4-FFF2-40B4-BE49-F238E27FC236}">
                  <a16:creationId xmlns:a16="http://schemas.microsoft.com/office/drawing/2014/main" id="{D8F2A706-3B01-47FA-84FD-DE9DF6929E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71925" y="3870326"/>
              <a:ext cx="0" cy="619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0" name="Rectangle 233">
              <a:extLst>
                <a:ext uri="{FF2B5EF4-FFF2-40B4-BE49-F238E27FC236}">
                  <a16:creationId xmlns:a16="http://schemas.microsoft.com/office/drawing/2014/main" id="{8E8FE0C0-0C99-429F-856F-EDF9B20AE6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2563" y="3932238"/>
              <a:ext cx="1492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.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1" name="Line 234">
              <a:extLst>
                <a:ext uri="{FF2B5EF4-FFF2-40B4-BE49-F238E27FC236}">
                  <a16:creationId xmlns:a16="http://schemas.microsoft.com/office/drawing/2014/main" id="{F4178B21-F2B6-4458-9C46-8935E7C982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37175" y="3870326"/>
              <a:ext cx="0" cy="619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2" name="Rectangle 248">
              <a:extLst>
                <a:ext uri="{FF2B5EF4-FFF2-40B4-BE49-F238E27FC236}">
                  <a16:creationId xmlns:a16="http://schemas.microsoft.com/office/drawing/2014/main" id="{ABAB53D1-E3F0-497D-8C58-16C0B9BE69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08700" y="3932238"/>
              <a:ext cx="149225" cy="136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3.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3" name="Line 249">
              <a:extLst>
                <a:ext uri="{FF2B5EF4-FFF2-40B4-BE49-F238E27FC236}">
                  <a16:creationId xmlns:a16="http://schemas.microsoft.com/office/drawing/2014/main" id="{66B95891-0BBF-43A5-A9E0-0D68EA9062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83313" y="3870326"/>
              <a:ext cx="0" cy="6191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4" name="Rectangle 250">
              <a:extLst>
                <a:ext uri="{FF2B5EF4-FFF2-40B4-BE49-F238E27FC236}">
                  <a16:creationId xmlns:a16="http://schemas.microsoft.com/office/drawing/2014/main" id="{C1F1C653-F603-4A7F-B82F-B3F6F73829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275" y="1651001"/>
              <a:ext cx="5761038" cy="2219325"/>
            </a:xfrm>
            <a:prstGeom prst="rect">
              <a:avLst/>
            </a:prstGeom>
            <a:noFill/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5" name="Rectangle 251">
              <a:extLst>
                <a:ext uri="{FF2B5EF4-FFF2-40B4-BE49-F238E27FC236}">
                  <a16:creationId xmlns:a16="http://schemas.microsoft.com/office/drawing/2014/main" id="{5662C1A0-0AC4-44DA-863D-762FCE8B41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692" y="3808413"/>
              <a:ext cx="28198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6" name="Line 252">
              <a:extLst>
                <a:ext uri="{FF2B5EF4-FFF2-40B4-BE49-F238E27FC236}">
                  <a16:creationId xmlns:a16="http://schemas.microsoft.com/office/drawing/2014/main" id="{9DACB053-0757-4610-8684-4D5904D4A5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4175" y="3870326"/>
              <a:ext cx="38100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7" name="Rectangle 259">
              <a:extLst>
                <a:ext uri="{FF2B5EF4-FFF2-40B4-BE49-F238E27FC236}">
                  <a16:creationId xmlns:a16="http://schemas.microsoft.com/office/drawing/2014/main" id="{7D1F219C-8FE2-43EC-8C5B-66DF8B7089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330" y="3160713"/>
              <a:ext cx="26134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8" name="Line 260">
              <a:extLst>
                <a:ext uri="{FF2B5EF4-FFF2-40B4-BE49-F238E27FC236}">
                  <a16:creationId xmlns:a16="http://schemas.microsoft.com/office/drawing/2014/main" id="{605E391F-C1D5-4CA2-AEFC-2D657B42FA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4175" y="3222626"/>
              <a:ext cx="38100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9" name="Rectangle 265">
              <a:extLst>
                <a:ext uri="{FF2B5EF4-FFF2-40B4-BE49-F238E27FC236}">
                  <a16:creationId xmlns:a16="http://schemas.microsoft.com/office/drawing/2014/main" id="{E561A9D1-A5A4-4800-8188-04A9C1ADF8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640" y="2698751"/>
              <a:ext cx="24849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0" name="Rectangle 271">
              <a:extLst>
                <a:ext uri="{FF2B5EF4-FFF2-40B4-BE49-F238E27FC236}">
                  <a16:creationId xmlns:a16="http://schemas.microsoft.com/office/drawing/2014/main" id="{5135F364-AEAA-4959-8432-EBB82AFD66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404" y="2235201"/>
              <a:ext cx="257697" cy="1412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1" name="Line 272">
              <a:extLst>
                <a:ext uri="{FF2B5EF4-FFF2-40B4-BE49-F238E27FC236}">
                  <a16:creationId xmlns:a16="http://schemas.microsoft.com/office/drawing/2014/main" id="{55DB94EA-EDF2-4D2A-AB3E-81C6D9509E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4175" y="2297113"/>
              <a:ext cx="38100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2" name="Rectangle 279">
              <a:extLst>
                <a:ext uri="{FF2B5EF4-FFF2-40B4-BE49-F238E27FC236}">
                  <a16:creationId xmlns:a16="http://schemas.microsoft.com/office/drawing/2014/main" id="{0B991E49-6D17-4A62-870C-4F569A5CE9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801" y="1589088"/>
              <a:ext cx="383336" cy="1412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2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3" name="Freeform 288">
              <a:extLst>
                <a:ext uri="{FF2B5EF4-FFF2-40B4-BE49-F238E27FC236}">
                  <a16:creationId xmlns:a16="http://schemas.microsoft.com/office/drawing/2014/main" id="{E3AA926C-496B-4BED-A0EC-F50DC5E46BFD}"/>
                </a:ext>
              </a:extLst>
            </p:cNvPr>
            <p:cNvSpPr>
              <a:spLocks/>
            </p:cNvSpPr>
            <p:nvPr/>
          </p:nvSpPr>
          <p:spPr bwMode="auto">
            <a:xfrm>
              <a:off x="422275" y="3649663"/>
              <a:ext cx="1231900" cy="33338"/>
            </a:xfrm>
            <a:custGeom>
              <a:avLst/>
              <a:gdLst>
                <a:gd name="T0" fmla="*/ 15 w 776"/>
                <a:gd name="T1" fmla="*/ 21 h 21"/>
                <a:gd name="T2" fmla="*/ 29 w 776"/>
                <a:gd name="T3" fmla="*/ 21 h 21"/>
                <a:gd name="T4" fmla="*/ 43 w 776"/>
                <a:gd name="T5" fmla="*/ 21 h 21"/>
                <a:gd name="T6" fmla="*/ 60 w 776"/>
                <a:gd name="T7" fmla="*/ 21 h 21"/>
                <a:gd name="T8" fmla="*/ 78 w 776"/>
                <a:gd name="T9" fmla="*/ 20 h 21"/>
                <a:gd name="T10" fmla="*/ 103 w 776"/>
                <a:gd name="T11" fmla="*/ 20 h 21"/>
                <a:gd name="T12" fmla="*/ 121 w 776"/>
                <a:gd name="T13" fmla="*/ 20 h 21"/>
                <a:gd name="T14" fmla="*/ 135 w 776"/>
                <a:gd name="T15" fmla="*/ 20 h 21"/>
                <a:gd name="T16" fmla="*/ 150 w 776"/>
                <a:gd name="T17" fmla="*/ 20 h 21"/>
                <a:gd name="T18" fmla="*/ 165 w 776"/>
                <a:gd name="T19" fmla="*/ 20 h 21"/>
                <a:gd name="T20" fmla="*/ 188 w 776"/>
                <a:gd name="T21" fmla="*/ 20 h 21"/>
                <a:gd name="T22" fmla="*/ 216 w 776"/>
                <a:gd name="T23" fmla="*/ 20 h 21"/>
                <a:gd name="T24" fmla="*/ 226 w 776"/>
                <a:gd name="T25" fmla="*/ 19 h 21"/>
                <a:gd name="T26" fmla="*/ 238 w 776"/>
                <a:gd name="T27" fmla="*/ 19 h 21"/>
                <a:gd name="T28" fmla="*/ 247 w 776"/>
                <a:gd name="T29" fmla="*/ 19 h 21"/>
                <a:gd name="T30" fmla="*/ 259 w 776"/>
                <a:gd name="T31" fmla="*/ 18 h 21"/>
                <a:gd name="T32" fmla="*/ 267 w 776"/>
                <a:gd name="T33" fmla="*/ 18 h 21"/>
                <a:gd name="T34" fmla="*/ 273 w 776"/>
                <a:gd name="T35" fmla="*/ 18 h 21"/>
                <a:gd name="T36" fmla="*/ 280 w 776"/>
                <a:gd name="T37" fmla="*/ 18 h 21"/>
                <a:gd name="T38" fmla="*/ 292 w 776"/>
                <a:gd name="T39" fmla="*/ 18 h 21"/>
                <a:gd name="T40" fmla="*/ 305 w 776"/>
                <a:gd name="T41" fmla="*/ 19 h 21"/>
                <a:gd name="T42" fmla="*/ 326 w 776"/>
                <a:gd name="T43" fmla="*/ 19 h 21"/>
                <a:gd name="T44" fmla="*/ 345 w 776"/>
                <a:gd name="T45" fmla="*/ 19 h 21"/>
                <a:gd name="T46" fmla="*/ 362 w 776"/>
                <a:gd name="T47" fmla="*/ 19 h 21"/>
                <a:gd name="T48" fmla="*/ 373 w 776"/>
                <a:gd name="T49" fmla="*/ 19 h 21"/>
                <a:gd name="T50" fmla="*/ 392 w 776"/>
                <a:gd name="T51" fmla="*/ 18 h 21"/>
                <a:gd name="T52" fmla="*/ 406 w 776"/>
                <a:gd name="T53" fmla="*/ 18 h 21"/>
                <a:gd name="T54" fmla="*/ 421 w 776"/>
                <a:gd name="T55" fmla="*/ 18 h 21"/>
                <a:gd name="T56" fmla="*/ 429 w 776"/>
                <a:gd name="T57" fmla="*/ 18 h 21"/>
                <a:gd name="T58" fmla="*/ 440 w 776"/>
                <a:gd name="T59" fmla="*/ 18 h 21"/>
                <a:gd name="T60" fmla="*/ 452 w 776"/>
                <a:gd name="T61" fmla="*/ 17 h 21"/>
                <a:gd name="T62" fmla="*/ 463 w 776"/>
                <a:gd name="T63" fmla="*/ 17 h 21"/>
                <a:gd name="T64" fmla="*/ 478 w 776"/>
                <a:gd name="T65" fmla="*/ 17 h 21"/>
                <a:gd name="T66" fmla="*/ 486 w 776"/>
                <a:gd name="T67" fmla="*/ 17 h 21"/>
                <a:gd name="T68" fmla="*/ 506 w 776"/>
                <a:gd name="T69" fmla="*/ 16 h 21"/>
                <a:gd name="T70" fmla="*/ 521 w 776"/>
                <a:gd name="T71" fmla="*/ 16 h 21"/>
                <a:gd name="T72" fmla="*/ 543 w 776"/>
                <a:gd name="T73" fmla="*/ 15 h 21"/>
                <a:gd name="T74" fmla="*/ 556 w 776"/>
                <a:gd name="T75" fmla="*/ 15 h 21"/>
                <a:gd name="T76" fmla="*/ 567 w 776"/>
                <a:gd name="T77" fmla="*/ 15 h 21"/>
                <a:gd name="T78" fmla="*/ 576 w 776"/>
                <a:gd name="T79" fmla="*/ 15 h 21"/>
                <a:gd name="T80" fmla="*/ 590 w 776"/>
                <a:gd name="T81" fmla="*/ 15 h 21"/>
                <a:gd name="T82" fmla="*/ 598 w 776"/>
                <a:gd name="T83" fmla="*/ 14 h 21"/>
                <a:gd name="T84" fmla="*/ 609 w 776"/>
                <a:gd name="T85" fmla="*/ 14 h 21"/>
                <a:gd name="T86" fmla="*/ 617 w 776"/>
                <a:gd name="T87" fmla="*/ 14 h 21"/>
                <a:gd name="T88" fmla="*/ 624 w 776"/>
                <a:gd name="T89" fmla="*/ 14 h 21"/>
                <a:gd name="T90" fmla="*/ 627 w 776"/>
                <a:gd name="T91" fmla="*/ 13 h 21"/>
                <a:gd name="T92" fmla="*/ 636 w 776"/>
                <a:gd name="T93" fmla="*/ 12 h 21"/>
                <a:gd name="T94" fmla="*/ 646 w 776"/>
                <a:gd name="T95" fmla="*/ 11 h 21"/>
                <a:gd name="T96" fmla="*/ 656 w 776"/>
                <a:gd name="T97" fmla="*/ 10 h 21"/>
                <a:gd name="T98" fmla="*/ 665 w 776"/>
                <a:gd name="T99" fmla="*/ 10 h 21"/>
                <a:gd name="T100" fmla="*/ 675 w 776"/>
                <a:gd name="T101" fmla="*/ 9 h 21"/>
                <a:gd name="T102" fmla="*/ 684 w 776"/>
                <a:gd name="T103" fmla="*/ 8 h 21"/>
                <a:gd name="T104" fmla="*/ 690 w 776"/>
                <a:gd name="T105" fmla="*/ 7 h 21"/>
                <a:gd name="T106" fmla="*/ 698 w 776"/>
                <a:gd name="T107" fmla="*/ 6 h 21"/>
                <a:gd name="T108" fmla="*/ 708 w 776"/>
                <a:gd name="T109" fmla="*/ 5 h 21"/>
                <a:gd name="T110" fmla="*/ 717 w 776"/>
                <a:gd name="T111" fmla="*/ 6 h 21"/>
                <a:gd name="T112" fmla="*/ 732 w 776"/>
                <a:gd name="T113" fmla="*/ 7 h 21"/>
                <a:gd name="T114" fmla="*/ 741 w 776"/>
                <a:gd name="T115" fmla="*/ 7 h 21"/>
                <a:gd name="T116" fmla="*/ 744 w 776"/>
                <a:gd name="T117" fmla="*/ 7 h 21"/>
                <a:gd name="T118" fmla="*/ 750 w 776"/>
                <a:gd name="T119" fmla="*/ 6 h 21"/>
                <a:gd name="T120" fmla="*/ 757 w 776"/>
                <a:gd name="T121" fmla="*/ 5 h 21"/>
                <a:gd name="T122" fmla="*/ 765 w 776"/>
                <a:gd name="T123" fmla="*/ 2 h 21"/>
                <a:gd name="T124" fmla="*/ 772 w 776"/>
                <a:gd name="T125" fmla="*/ 1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776" h="21">
                  <a:moveTo>
                    <a:pt x="0" y="21"/>
                  </a:moveTo>
                  <a:lnTo>
                    <a:pt x="2" y="21"/>
                  </a:lnTo>
                  <a:lnTo>
                    <a:pt x="5" y="21"/>
                  </a:lnTo>
                  <a:lnTo>
                    <a:pt x="7" y="21"/>
                  </a:lnTo>
                  <a:lnTo>
                    <a:pt x="9" y="21"/>
                  </a:lnTo>
                  <a:lnTo>
                    <a:pt x="12" y="21"/>
                  </a:lnTo>
                  <a:lnTo>
                    <a:pt x="14" y="21"/>
                  </a:lnTo>
                  <a:lnTo>
                    <a:pt x="15" y="21"/>
                  </a:lnTo>
                  <a:lnTo>
                    <a:pt x="16" y="21"/>
                  </a:lnTo>
                  <a:lnTo>
                    <a:pt x="18" y="21"/>
                  </a:lnTo>
                  <a:lnTo>
                    <a:pt x="19" y="21"/>
                  </a:lnTo>
                  <a:lnTo>
                    <a:pt x="20" y="21"/>
                  </a:lnTo>
                  <a:lnTo>
                    <a:pt x="22" y="21"/>
                  </a:lnTo>
                  <a:lnTo>
                    <a:pt x="24" y="21"/>
                  </a:lnTo>
                  <a:lnTo>
                    <a:pt x="26" y="21"/>
                  </a:lnTo>
                  <a:lnTo>
                    <a:pt x="29" y="21"/>
                  </a:lnTo>
                  <a:lnTo>
                    <a:pt x="31" y="21"/>
                  </a:lnTo>
                  <a:lnTo>
                    <a:pt x="34" y="21"/>
                  </a:lnTo>
                  <a:lnTo>
                    <a:pt x="37" y="21"/>
                  </a:lnTo>
                  <a:lnTo>
                    <a:pt x="39" y="21"/>
                  </a:lnTo>
                  <a:lnTo>
                    <a:pt x="40" y="21"/>
                  </a:lnTo>
                  <a:lnTo>
                    <a:pt x="40" y="21"/>
                  </a:lnTo>
                  <a:lnTo>
                    <a:pt x="41" y="21"/>
                  </a:lnTo>
                  <a:lnTo>
                    <a:pt x="43" y="21"/>
                  </a:lnTo>
                  <a:lnTo>
                    <a:pt x="45" y="21"/>
                  </a:lnTo>
                  <a:lnTo>
                    <a:pt x="46" y="21"/>
                  </a:lnTo>
                  <a:lnTo>
                    <a:pt x="48" y="21"/>
                  </a:lnTo>
                  <a:lnTo>
                    <a:pt x="50" y="21"/>
                  </a:lnTo>
                  <a:lnTo>
                    <a:pt x="52" y="21"/>
                  </a:lnTo>
                  <a:lnTo>
                    <a:pt x="54" y="21"/>
                  </a:lnTo>
                  <a:lnTo>
                    <a:pt x="57" y="21"/>
                  </a:lnTo>
                  <a:lnTo>
                    <a:pt x="60" y="21"/>
                  </a:lnTo>
                  <a:lnTo>
                    <a:pt x="63" y="21"/>
                  </a:lnTo>
                  <a:lnTo>
                    <a:pt x="66" y="21"/>
                  </a:lnTo>
                  <a:lnTo>
                    <a:pt x="68" y="20"/>
                  </a:lnTo>
                  <a:lnTo>
                    <a:pt x="70" y="20"/>
                  </a:lnTo>
                  <a:lnTo>
                    <a:pt x="71" y="20"/>
                  </a:lnTo>
                  <a:lnTo>
                    <a:pt x="72" y="20"/>
                  </a:lnTo>
                  <a:lnTo>
                    <a:pt x="75" y="20"/>
                  </a:lnTo>
                  <a:lnTo>
                    <a:pt x="78" y="20"/>
                  </a:lnTo>
                  <a:lnTo>
                    <a:pt x="83" y="20"/>
                  </a:lnTo>
                  <a:lnTo>
                    <a:pt x="87" y="20"/>
                  </a:lnTo>
                  <a:lnTo>
                    <a:pt x="90" y="20"/>
                  </a:lnTo>
                  <a:lnTo>
                    <a:pt x="92" y="20"/>
                  </a:lnTo>
                  <a:lnTo>
                    <a:pt x="95" y="20"/>
                  </a:lnTo>
                  <a:lnTo>
                    <a:pt x="98" y="20"/>
                  </a:lnTo>
                  <a:lnTo>
                    <a:pt x="101" y="20"/>
                  </a:lnTo>
                  <a:lnTo>
                    <a:pt x="103" y="20"/>
                  </a:lnTo>
                  <a:lnTo>
                    <a:pt x="105" y="20"/>
                  </a:lnTo>
                  <a:lnTo>
                    <a:pt x="108" y="20"/>
                  </a:lnTo>
                  <a:lnTo>
                    <a:pt x="110" y="20"/>
                  </a:lnTo>
                  <a:lnTo>
                    <a:pt x="112" y="20"/>
                  </a:lnTo>
                  <a:lnTo>
                    <a:pt x="114" y="20"/>
                  </a:lnTo>
                  <a:lnTo>
                    <a:pt x="116" y="20"/>
                  </a:lnTo>
                  <a:lnTo>
                    <a:pt x="118" y="20"/>
                  </a:lnTo>
                  <a:lnTo>
                    <a:pt x="121" y="20"/>
                  </a:lnTo>
                  <a:lnTo>
                    <a:pt x="123" y="20"/>
                  </a:lnTo>
                  <a:lnTo>
                    <a:pt x="126" y="20"/>
                  </a:lnTo>
                  <a:lnTo>
                    <a:pt x="127" y="20"/>
                  </a:lnTo>
                  <a:lnTo>
                    <a:pt x="129" y="20"/>
                  </a:lnTo>
                  <a:lnTo>
                    <a:pt x="130" y="20"/>
                  </a:lnTo>
                  <a:lnTo>
                    <a:pt x="131" y="20"/>
                  </a:lnTo>
                  <a:lnTo>
                    <a:pt x="133" y="20"/>
                  </a:lnTo>
                  <a:lnTo>
                    <a:pt x="135" y="20"/>
                  </a:lnTo>
                  <a:lnTo>
                    <a:pt x="137" y="20"/>
                  </a:lnTo>
                  <a:lnTo>
                    <a:pt x="138" y="20"/>
                  </a:lnTo>
                  <a:lnTo>
                    <a:pt x="140" y="20"/>
                  </a:lnTo>
                  <a:lnTo>
                    <a:pt x="142" y="20"/>
                  </a:lnTo>
                  <a:lnTo>
                    <a:pt x="143" y="20"/>
                  </a:lnTo>
                  <a:lnTo>
                    <a:pt x="145" y="20"/>
                  </a:lnTo>
                  <a:lnTo>
                    <a:pt x="148" y="20"/>
                  </a:lnTo>
                  <a:lnTo>
                    <a:pt x="150" y="20"/>
                  </a:lnTo>
                  <a:lnTo>
                    <a:pt x="153" y="20"/>
                  </a:lnTo>
                  <a:lnTo>
                    <a:pt x="156" y="20"/>
                  </a:lnTo>
                  <a:lnTo>
                    <a:pt x="158" y="20"/>
                  </a:lnTo>
                  <a:lnTo>
                    <a:pt x="159" y="20"/>
                  </a:lnTo>
                  <a:lnTo>
                    <a:pt x="160" y="20"/>
                  </a:lnTo>
                  <a:lnTo>
                    <a:pt x="161" y="20"/>
                  </a:lnTo>
                  <a:lnTo>
                    <a:pt x="163" y="20"/>
                  </a:lnTo>
                  <a:lnTo>
                    <a:pt x="165" y="20"/>
                  </a:lnTo>
                  <a:lnTo>
                    <a:pt x="167" y="20"/>
                  </a:lnTo>
                  <a:lnTo>
                    <a:pt x="169" y="20"/>
                  </a:lnTo>
                  <a:lnTo>
                    <a:pt x="171" y="20"/>
                  </a:lnTo>
                  <a:lnTo>
                    <a:pt x="175" y="20"/>
                  </a:lnTo>
                  <a:lnTo>
                    <a:pt x="180" y="20"/>
                  </a:lnTo>
                  <a:lnTo>
                    <a:pt x="184" y="20"/>
                  </a:lnTo>
                  <a:lnTo>
                    <a:pt x="186" y="20"/>
                  </a:lnTo>
                  <a:lnTo>
                    <a:pt x="188" y="20"/>
                  </a:lnTo>
                  <a:lnTo>
                    <a:pt x="191" y="20"/>
                  </a:lnTo>
                  <a:lnTo>
                    <a:pt x="195" y="20"/>
                  </a:lnTo>
                  <a:lnTo>
                    <a:pt x="199" y="20"/>
                  </a:lnTo>
                  <a:lnTo>
                    <a:pt x="203" y="20"/>
                  </a:lnTo>
                  <a:lnTo>
                    <a:pt x="207" y="20"/>
                  </a:lnTo>
                  <a:lnTo>
                    <a:pt x="211" y="20"/>
                  </a:lnTo>
                  <a:lnTo>
                    <a:pt x="214" y="20"/>
                  </a:lnTo>
                  <a:lnTo>
                    <a:pt x="216" y="20"/>
                  </a:lnTo>
                  <a:lnTo>
                    <a:pt x="217" y="20"/>
                  </a:lnTo>
                  <a:lnTo>
                    <a:pt x="218" y="20"/>
                  </a:lnTo>
                  <a:lnTo>
                    <a:pt x="219" y="20"/>
                  </a:lnTo>
                  <a:lnTo>
                    <a:pt x="220" y="20"/>
                  </a:lnTo>
                  <a:lnTo>
                    <a:pt x="222" y="20"/>
                  </a:lnTo>
                  <a:lnTo>
                    <a:pt x="223" y="20"/>
                  </a:lnTo>
                  <a:lnTo>
                    <a:pt x="224" y="20"/>
                  </a:lnTo>
                  <a:lnTo>
                    <a:pt x="226" y="19"/>
                  </a:lnTo>
                  <a:lnTo>
                    <a:pt x="228" y="19"/>
                  </a:lnTo>
                  <a:lnTo>
                    <a:pt x="229" y="19"/>
                  </a:lnTo>
                  <a:lnTo>
                    <a:pt x="231" y="19"/>
                  </a:lnTo>
                  <a:lnTo>
                    <a:pt x="232" y="19"/>
                  </a:lnTo>
                  <a:lnTo>
                    <a:pt x="234" y="19"/>
                  </a:lnTo>
                  <a:lnTo>
                    <a:pt x="235" y="19"/>
                  </a:lnTo>
                  <a:lnTo>
                    <a:pt x="237" y="19"/>
                  </a:lnTo>
                  <a:lnTo>
                    <a:pt x="238" y="19"/>
                  </a:lnTo>
                  <a:lnTo>
                    <a:pt x="240" y="19"/>
                  </a:lnTo>
                  <a:lnTo>
                    <a:pt x="241" y="19"/>
                  </a:lnTo>
                  <a:lnTo>
                    <a:pt x="243" y="19"/>
                  </a:lnTo>
                  <a:lnTo>
                    <a:pt x="244" y="19"/>
                  </a:lnTo>
                  <a:lnTo>
                    <a:pt x="245" y="19"/>
                  </a:lnTo>
                  <a:lnTo>
                    <a:pt x="245" y="19"/>
                  </a:lnTo>
                  <a:lnTo>
                    <a:pt x="246" y="19"/>
                  </a:lnTo>
                  <a:lnTo>
                    <a:pt x="247" y="19"/>
                  </a:lnTo>
                  <a:lnTo>
                    <a:pt x="247" y="19"/>
                  </a:lnTo>
                  <a:lnTo>
                    <a:pt x="249" y="18"/>
                  </a:lnTo>
                  <a:lnTo>
                    <a:pt x="251" y="18"/>
                  </a:lnTo>
                  <a:lnTo>
                    <a:pt x="252" y="18"/>
                  </a:lnTo>
                  <a:lnTo>
                    <a:pt x="254" y="18"/>
                  </a:lnTo>
                  <a:lnTo>
                    <a:pt x="256" y="18"/>
                  </a:lnTo>
                  <a:lnTo>
                    <a:pt x="257" y="18"/>
                  </a:lnTo>
                  <a:lnTo>
                    <a:pt x="259" y="18"/>
                  </a:lnTo>
                  <a:lnTo>
                    <a:pt x="260" y="18"/>
                  </a:lnTo>
                  <a:lnTo>
                    <a:pt x="261" y="18"/>
                  </a:lnTo>
                  <a:lnTo>
                    <a:pt x="262" y="18"/>
                  </a:lnTo>
                  <a:lnTo>
                    <a:pt x="263" y="18"/>
                  </a:lnTo>
                  <a:lnTo>
                    <a:pt x="264" y="18"/>
                  </a:lnTo>
                  <a:lnTo>
                    <a:pt x="265" y="18"/>
                  </a:lnTo>
                  <a:lnTo>
                    <a:pt x="266" y="18"/>
                  </a:lnTo>
                  <a:lnTo>
                    <a:pt x="267" y="18"/>
                  </a:lnTo>
                  <a:lnTo>
                    <a:pt x="267" y="18"/>
                  </a:lnTo>
                  <a:lnTo>
                    <a:pt x="268" y="18"/>
                  </a:lnTo>
                  <a:lnTo>
                    <a:pt x="269" y="18"/>
                  </a:lnTo>
                  <a:lnTo>
                    <a:pt x="270" y="18"/>
                  </a:lnTo>
                  <a:lnTo>
                    <a:pt x="271" y="18"/>
                  </a:lnTo>
                  <a:lnTo>
                    <a:pt x="272" y="18"/>
                  </a:lnTo>
                  <a:lnTo>
                    <a:pt x="273" y="18"/>
                  </a:lnTo>
                  <a:lnTo>
                    <a:pt x="273" y="18"/>
                  </a:lnTo>
                  <a:lnTo>
                    <a:pt x="274" y="18"/>
                  </a:lnTo>
                  <a:lnTo>
                    <a:pt x="274" y="18"/>
                  </a:lnTo>
                  <a:lnTo>
                    <a:pt x="275" y="18"/>
                  </a:lnTo>
                  <a:lnTo>
                    <a:pt x="275" y="18"/>
                  </a:lnTo>
                  <a:lnTo>
                    <a:pt x="276" y="18"/>
                  </a:lnTo>
                  <a:lnTo>
                    <a:pt x="277" y="18"/>
                  </a:lnTo>
                  <a:lnTo>
                    <a:pt x="279" y="18"/>
                  </a:lnTo>
                  <a:lnTo>
                    <a:pt x="280" y="18"/>
                  </a:lnTo>
                  <a:lnTo>
                    <a:pt x="281" y="18"/>
                  </a:lnTo>
                  <a:lnTo>
                    <a:pt x="282" y="18"/>
                  </a:lnTo>
                  <a:lnTo>
                    <a:pt x="284" y="18"/>
                  </a:lnTo>
                  <a:lnTo>
                    <a:pt x="286" y="18"/>
                  </a:lnTo>
                  <a:lnTo>
                    <a:pt x="288" y="18"/>
                  </a:lnTo>
                  <a:lnTo>
                    <a:pt x="289" y="18"/>
                  </a:lnTo>
                  <a:lnTo>
                    <a:pt x="290" y="18"/>
                  </a:lnTo>
                  <a:lnTo>
                    <a:pt x="292" y="18"/>
                  </a:lnTo>
                  <a:lnTo>
                    <a:pt x="293" y="18"/>
                  </a:lnTo>
                  <a:lnTo>
                    <a:pt x="295" y="18"/>
                  </a:lnTo>
                  <a:lnTo>
                    <a:pt x="297" y="18"/>
                  </a:lnTo>
                  <a:lnTo>
                    <a:pt x="299" y="18"/>
                  </a:lnTo>
                  <a:lnTo>
                    <a:pt x="301" y="18"/>
                  </a:lnTo>
                  <a:lnTo>
                    <a:pt x="302" y="19"/>
                  </a:lnTo>
                  <a:lnTo>
                    <a:pt x="304" y="19"/>
                  </a:lnTo>
                  <a:lnTo>
                    <a:pt x="305" y="19"/>
                  </a:lnTo>
                  <a:lnTo>
                    <a:pt x="306" y="19"/>
                  </a:lnTo>
                  <a:lnTo>
                    <a:pt x="307" y="19"/>
                  </a:lnTo>
                  <a:lnTo>
                    <a:pt x="310" y="19"/>
                  </a:lnTo>
                  <a:lnTo>
                    <a:pt x="313" y="19"/>
                  </a:lnTo>
                  <a:lnTo>
                    <a:pt x="317" y="19"/>
                  </a:lnTo>
                  <a:lnTo>
                    <a:pt x="321" y="19"/>
                  </a:lnTo>
                  <a:lnTo>
                    <a:pt x="324" y="19"/>
                  </a:lnTo>
                  <a:lnTo>
                    <a:pt x="326" y="19"/>
                  </a:lnTo>
                  <a:lnTo>
                    <a:pt x="330" y="19"/>
                  </a:lnTo>
                  <a:lnTo>
                    <a:pt x="332" y="19"/>
                  </a:lnTo>
                  <a:lnTo>
                    <a:pt x="334" y="19"/>
                  </a:lnTo>
                  <a:lnTo>
                    <a:pt x="337" y="19"/>
                  </a:lnTo>
                  <a:lnTo>
                    <a:pt x="339" y="19"/>
                  </a:lnTo>
                  <a:lnTo>
                    <a:pt x="341" y="19"/>
                  </a:lnTo>
                  <a:lnTo>
                    <a:pt x="343" y="19"/>
                  </a:lnTo>
                  <a:lnTo>
                    <a:pt x="345" y="19"/>
                  </a:lnTo>
                  <a:lnTo>
                    <a:pt x="347" y="19"/>
                  </a:lnTo>
                  <a:lnTo>
                    <a:pt x="349" y="19"/>
                  </a:lnTo>
                  <a:lnTo>
                    <a:pt x="351" y="19"/>
                  </a:lnTo>
                  <a:lnTo>
                    <a:pt x="354" y="19"/>
                  </a:lnTo>
                  <a:lnTo>
                    <a:pt x="357" y="19"/>
                  </a:lnTo>
                  <a:lnTo>
                    <a:pt x="359" y="19"/>
                  </a:lnTo>
                  <a:lnTo>
                    <a:pt x="361" y="19"/>
                  </a:lnTo>
                  <a:lnTo>
                    <a:pt x="362" y="19"/>
                  </a:lnTo>
                  <a:lnTo>
                    <a:pt x="363" y="19"/>
                  </a:lnTo>
                  <a:lnTo>
                    <a:pt x="364" y="19"/>
                  </a:lnTo>
                  <a:lnTo>
                    <a:pt x="365" y="19"/>
                  </a:lnTo>
                  <a:lnTo>
                    <a:pt x="366" y="19"/>
                  </a:lnTo>
                  <a:lnTo>
                    <a:pt x="368" y="19"/>
                  </a:lnTo>
                  <a:lnTo>
                    <a:pt x="369" y="19"/>
                  </a:lnTo>
                  <a:lnTo>
                    <a:pt x="371" y="19"/>
                  </a:lnTo>
                  <a:lnTo>
                    <a:pt x="373" y="19"/>
                  </a:lnTo>
                  <a:lnTo>
                    <a:pt x="375" y="19"/>
                  </a:lnTo>
                  <a:lnTo>
                    <a:pt x="378" y="19"/>
                  </a:lnTo>
                  <a:lnTo>
                    <a:pt x="381" y="19"/>
                  </a:lnTo>
                  <a:lnTo>
                    <a:pt x="384" y="19"/>
                  </a:lnTo>
                  <a:lnTo>
                    <a:pt x="387" y="18"/>
                  </a:lnTo>
                  <a:lnTo>
                    <a:pt x="389" y="18"/>
                  </a:lnTo>
                  <a:lnTo>
                    <a:pt x="391" y="18"/>
                  </a:lnTo>
                  <a:lnTo>
                    <a:pt x="392" y="18"/>
                  </a:lnTo>
                  <a:lnTo>
                    <a:pt x="394" y="18"/>
                  </a:lnTo>
                  <a:lnTo>
                    <a:pt x="396" y="18"/>
                  </a:lnTo>
                  <a:lnTo>
                    <a:pt x="397" y="18"/>
                  </a:lnTo>
                  <a:lnTo>
                    <a:pt x="398" y="18"/>
                  </a:lnTo>
                  <a:lnTo>
                    <a:pt x="400" y="18"/>
                  </a:lnTo>
                  <a:lnTo>
                    <a:pt x="401" y="18"/>
                  </a:lnTo>
                  <a:lnTo>
                    <a:pt x="403" y="18"/>
                  </a:lnTo>
                  <a:lnTo>
                    <a:pt x="406" y="18"/>
                  </a:lnTo>
                  <a:lnTo>
                    <a:pt x="410" y="18"/>
                  </a:lnTo>
                  <a:lnTo>
                    <a:pt x="412" y="18"/>
                  </a:lnTo>
                  <a:lnTo>
                    <a:pt x="414" y="18"/>
                  </a:lnTo>
                  <a:lnTo>
                    <a:pt x="416" y="19"/>
                  </a:lnTo>
                  <a:lnTo>
                    <a:pt x="417" y="19"/>
                  </a:lnTo>
                  <a:lnTo>
                    <a:pt x="419" y="19"/>
                  </a:lnTo>
                  <a:lnTo>
                    <a:pt x="420" y="19"/>
                  </a:lnTo>
                  <a:lnTo>
                    <a:pt x="421" y="18"/>
                  </a:lnTo>
                  <a:lnTo>
                    <a:pt x="422" y="18"/>
                  </a:lnTo>
                  <a:lnTo>
                    <a:pt x="423" y="18"/>
                  </a:lnTo>
                  <a:lnTo>
                    <a:pt x="423" y="18"/>
                  </a:lnTo>
                  <a:lnTo>
                    <a:pt x="424" y="18"/>
                  </a:lnTo>
                  <a:lnTo>
                    <a:pt x="426" y="18"/>
                  </a:lnTo>
                  <a:lnTo>
                    <a:pt x="427" y="18"/>
                  </a:lnTo>
                  <a:lnTo>
                    <a:pt x="428" y="18"/>
                  </a:lnTo>
                  <a:lnTo>
                    <a:pt x="429" y="18"/>
                  </a:lnTo>
                  <a:lnTo>
                    <a:pt x="430" y="18"/>
                  </a:lnTo>
                  <a:lnTo>
                    <a:pt x="432" y="18"/>
                  </a:lnTo>
                  <a:lnTo>
                    <a:pt x="433" y="18"/>
                  </a:lnTo>
                  <a:lnTo>
                    <a:pt x="434" y="18"/>
                  </a:lnTo>
                  <a:lnTo>
                    <a:pt x="436" y="18"/>
                  </a:lnTo>
                  <a:lnTo>
                    <a:pt x="437" y="18"/>
                  </a:lnTo>
                  <a:lnTo>
                    <a:pt x="439" y="18"/>
                  </a:lnTo>
                  <a:lnTo>
                    <a:pt x="440" y="18"/>
                  </a:lnTo>
                  <a:lnTo>
                    <a:pt x="442" y="18"/>
                  </a:lnTo>
                  <a:lnTo>
                    <a:pt x="443" y="18"/>
                  </a:lnTo>
                  <a:lnTo>
                    <a:pt x="446" y="18"/>
                  </a:lnTo>
                  <a:lnTo>
                    <a:pt x="448" y="17"/>
                  </a:lnTo>
                  <a:lnTo>
                    <a:pt x="449" y="17"/>
                  </a:lnTo>
                  <a:lnTo>
                    <a:pt x="450" y="17"/>
                  </a:lnTo>
                  <a:lnTo>
                    <a:pt x="451" y="17"/>
                  </a:lnTo>
                  <a:lnTo>
                    <a:pt x="452" y="17"/>
                  </a:lnTo>
                  <a:lnTo>
                    <a:pt x="453" y="17"/>
                  </a:lnTo>
                  <a:lnTo>
                    <a:pt x="453" y="17"/>
                  </a:lnTo>
                  <a:lnTo>
                    <a:pt x="455" y="17"/>
                  </a:lnTo>
                  <a:lnTo>
                    <a:pt x="456" y="17"/>
                  </a:lnTo>
                  <a:lnTo>
                    <a:pt x="458" y="17"/>
                  </a:lnTo>
                  <a:lnTo>
                    <a:pt x="460" y="17"/>
                  </a:lnTo>
                  <a:lnTo>
                    <a:pt x="461" y="17"/>
                  </a:lnTo>
                  <a:lnTo>
                    <a:pt x="463" y="17"/>
                  </a:lnTo>
                  <a:lnTo>
                    <a:pt x="465" y="17"/>
                  </a:lnTo>
                  <a:lnTo>
                    <a:pt x="466" y="17"/>
                  </a:lnTo>
                  <a:lnTo>
                    <a:pt x="468" y="17"/>
                  </a:lnTo>
                  <a:lnTo>
                    <a:pt x="471" y="17"/>
                  </a:lnTo>
                  <a:lnTo>
                    <a:pt x="473" y="17"/>
                  </a:lnTo>
                  <a:lnTo>
                    <a:pt x="475" y="17"/>
                  </a:lnTo>
                  <a:lnTo>
                    <a:pt x="477" y="17"/>
                  </a:lnTo>
                  <a:lnTo>
                    <a:pt x="478" y="17"/>
                  </a:lnTo>
                  <a:lnTo>
                    <a:pt x="479" y="17"/>
                  </a:lnTo>
                  <a:lnTo>
                    <a:pt x="480" y="17"/>
                  </a:lnTo>
                  <a:lnTo>
                    <a:pt x="481" y="17"/>
                  </a:lnTo>
                  <a:lnTo>
                    <a:pt x="482" y="17"/>
                  </a:lnTo>
                  <a:lnTo>
                    <a:pt x="482" y="17"/>
                  </a:lnTo>
                  <a:lnTo>
                    <a:pt x="483" y="17"/>
                  </a:lnTo>
                  <a:lnTo>
                    <a:pt x="485" y="17"/>
                  </a:lnTo>
                  <a:lnTo>
                    <a:pt x="486" y="17"/>
                  </a:lnTo>
                  <a:lnTo>
                    <a:pt x="489" y="17"/>
                  </a:lnTo>
                  <a:lnTo>
                    <a:pt x="493" y="16"/>
                  </a:lnTo>
                  <a:lnTo>
                    <a:pt x="497" y="16"/>
                  </a:lnTo>
                  <a:lnTo>
                    <a:pt x="499" y="16"/>
                  </a:lnTo>
                  <a:lnTo>
                    <a:pt x="501" y="16"/>
                  </a:lnTo>
                  <a:lnTo>
                    <a:pt x="503" y="16"/>
                  </a:lnTo>
                  <a:lnTo>
                    <a:pt x="505" y="16"/>
                  </a:lnTo>
                  <a:lnTo>
                    <a:pt x="506" y="16"/>
                  </a:lnTo>
                  <a:lnTo>
                    <a:pt x="508" y="16"/>
                  </a:lnTo>
                  <a:lnTo>
                    <a:pt x="510" y="16"/>
                  </a:lnTo>
                  <a:lnTo>
                    <a:pt x="511" y="16"/>
                  </a:lnTo>
                  <a:lnTo>
                    <a:pt x="513" y="16"/>
                  </a:lnTo>
                  <a:lnTo>
                    <a:pt x="514" y="16"/>
                  </a:lnTo>
                  <a:lnTo>
                    <a:pt x="517" y="16"/>
                  </a:lnTo>
                  <a:lnTo>
                    <a:pt x="519" y="16"/>
                  </a:lnTo>
                  <a:lnTo>
                    <a:pt x="521" y="16"/>
                  </a:lnTo>
                  <a:lnTo>
                    <a:pt x="524" y="16"/>
                  </a:lnTo>
                  <a:lnTo>
                    <a:pt x="526" y="16"/>
                  </a:lnTo>
                  <a:lnTo>
                    <a:pt x="528" y="16"/>
                  </a:lnTo>
                  <a:lnTo>
                    <a:pt x="531" y="16"/>
                  </a:lnTo>
                  <a:lnTo>
                    <a:pt x="535" y="15"/>
                  </a:lnTo>
                  <a:lnTo>
                    <a:pt x="538" y="15"/>
                  </a:lnTo>
                  <a:lnTo>
                    <a:pt x="541" y="15"/>
                  </a:lnTo>
                  <a:lnTo>
                    <a:pt x="543" y="15"/>
                  </a:lnTo>
                  <a:lnTo>
                    <a:pt x="545" y="15"/>
                  </a:lnTo>
                  <a:lnTo>
                    <a:pt x="547" y="15"/>
                  </a:lnTo>
                  <a:lnTo>
                    <a:pt x="549" y="15"/>
                  </a:lnTo>
                  <a:lnTo>
                    <a:pt x="550" y="15"/>
                  </a:lnTo>
                  <a:lnTo>
                    <a:pt x="551" y="15"/>
                  </a:lnTo>
                  <a:lnTo>
                    <a:pt x="553" y="15"/>
                  </a:lnTo>
                  <a:lnTo>
                    <a:pt x="555" y="15"/>
                  </a:lnTo>
                  <a:lnTo>
                    <a:pt x="556" y="15"/>
                  </a:lnTo>
                  <a:lnTo>
                    <a:pt x="558" y="15"/>
                  </a:lnTo>
                  <a:lnTo>
                    <a:pt x="560" y="15"/>
                  </a:lnTo>
                  <a:lnTo>
                    <a:pt x="562" y="15"/>
                  </a:lnTo>
                  <a:lnTo>
                    <a:pt x="563" y="15"/>
                  </a:lnTo>
                  <a:lnTo>
                    <a:pt x="565" y="15"/>
                  </a:lnTo>
                  <a:lnTo>
                    <a:pt x="566" y="15"/>
                  </a:lnTo>
                  <a:lnTo>
                    <a:pt x="567" y="15"/>
                  </a:lnTo>
                  <a:lnTo>
                    <a:pt x="567" y="15"/>
                  </a:lnTo>
                  <a:lnTo>
                    <a:pt x="568" y="15"/>
                  </a:lnTo>
                  <a:lnTo>
                    <a:pt x="569" y="15"/>
                  </a:lnTo>
                  <a:lnTo>
                    <a:pt x="569" y="15"/>
                  </a:lnTo>
                  <a:lnTo>
                    <a:pt x="571" y="15"/>
                  </a:lnTo>
                  <a:lnTo>
                    <a:pt x="572" y="15"/>
                  </a:lnTo>
                  <a:lnTo>
                    <a:pt x="573" y="15"/>
                  </a:lnTo>
                  <a:lnTo>
                    <a:pt x="575" y="15"/>
                  </a:lnTo>
                  <a:lnTo>
                    <a:pt x="576" y="15"/>
                  </a:lnTo>
                  <a:lnTo>
                    <a:pt x="578" y="15"/>
                  </a:lnTo>
                  <a:lnTo>
                    <a:pt x="580" y="15"/>
                  </a:lnTo>
                  <a:lnTo>
                    <a:pt x="582" y="15"/>
                  </a:lnTo>
                  <a:lnTo>
                    <a:pt x="583" y="15"/>
                  </a:lnTo>
                  <a:lnTo>
                    <a:pt x="585" y="15"/>
                  </a:lnTo>
                  <a:lnTo>
                    <a:pt x="587" y="15"/>
                  </a:lnTo>
                  <a:lnTo>
                    <a:pt x="589" y="15"/>
                  </a:lnTo>
                  <a:lnTo>
                    <a:pt x="590" y="15"/>
                  </a:lnTo>
                  <a:lnTo>
                    <a:pt x="591" y="14"/>
                  </a:lnTo>
                  <a:lnTo>
                    <a:pt x="592" y="14"/>
                  </a:lnTo>
                  <a:lnTo>
                    <a:pt x="593" y="14"/>
                  </a:lnTo>
                  <a:lnTo>
                    <a:pt x="594" y="14"/>
                  </a:lnTo>
                  <a:lnTo>
                    <a:pt x="596" y="14"/>
                  </a:lnTo>
                  <a:lnTo>
                    <a:pt x="597" y="14"/>
                  </a:lnTo>
                  <a:lnTo>
                    <a:pt x="597" y="14"/>
                  </a:lnTo>
                  <a:lnTo>
                    <a:pt x="598" y="14"/>
                  </a:lnTo>
                  <a:lnTo>
                    <a:pt x="600" y="14"/>
                  </a:lnTo>
                  <a:lnTo>
                    <a:pt x="601" y="14"/>
                  </a:lnTo>
                  <a:lnTo>
                    <a:pt x="602" y="14"/>
                  </a:lnTo>
                  <a:lnTo>
                    <a:pt x="603" y="14"/>
                  </a:lnTo>
                  <a:lnTo>
                    <a:pt x="605" y="14"/>
                  </a:lnTo>
                  <a:lnTo>
                    <a:pt x="606" y="14"/>
                  </a:lnTo>
                  <a:lnTo>
                    <a:pt x="608" y="14"/>
                  </a:lnTo>
                  <a:lnTo>
                    <a:pt x="609" y="14"/>
                  </a:lnTo>
                  <a:lnTo>
                    <a:pt x="611" y="14"/>
                  </a:lnTo>
                  <a:lnTo>
                    <a:pt x="612" y="14"/>
                  </a:lnTo>
                  <a:lnTo>
                    <a:pt x="613" y="14"/>
                  </a:lnTo>
                  <a:lnTo>
                    <a:pt x="614" y="14"/>
                  </a:lnTo>
                  <a:lnTo>
                    <a:pt x="615" y="14"/>
                  </a:lnTo>
                  <a:lnTo>
                    <a:pt x="616" y="14"/>
                  </a:lnTo>
                  <a:lnTo>
                    <a:pt x="617" y="14"/>
                  </a:lnTo>
                  <a:lnTo>
                    <a:pt x="617" y="14"/>
                  </a:lnTo>
                  <a:lnTo>
                    <a:pt x="618" y="14"/>
                  </a:lnTo>
                  <a:lnTo>
                    <a:pt x="619" y="14"/>
                  </a:lnTo>
                  <a:lnTo>
                    <a:pt x="620" y="14"/>
                  </a:lnTo>
                  <a:lnTo>
                    <a:pt x="621" y="14"/>
                  </a:lnTo>
                  <a:lnTo>
                    <a:pt x="622" y="14"/>
                  </a:lnTo>
                  <a:lnTo>
                    <a:pt x="622" y="14"/>
                  </a:lnTo>
                  <a:lnTo>
                    <a:pt x="623" y="14"/>
                  </a:lnTo>
                  <a:lnTo>
                    <a:pt x="624" y="14"/>
                  </a:lnTo>
                  <a:lnTo>
                    <a:pt x="625" y="13"/>
                  </a:lnTo>
                  <a:lnTo>
                    <a:pt x="625" y="13"/>
                  </a:lnTo>
                  <a:lnTo>
                    <a:pt x="626" y="13"/>
                  </a:lnTo>
                  <a:lnTo>
                    <a:pt x="626" y="13"/>
                  </a:lnTo>
                  <a:lnTo>
                    <a:pt x="626" y="13"/>
                  </a:lnTo>
                  <a:lnTo>
                    <a:pt x="627" y="13"/>
                  </a:lnTo>
                  <a:lnTo>
                    <a:pt x="627" y="13"/>
                  </a:lnTo>
                  <a:lnTo>
                    <a:pt x="627" y="13"/>
                  </a:lnTo>
                  <a:lnTo>
                    <a:pt x="627" y="13"/>
                  </a:lnTo>
                  <a:lnTo>
                    <a:pt x="628" y="13"/>
                  </a:lnTo>
                  <a:lnTo>
                    <a:pt x="628" y="13"/>
                  </a:lnTo>
                  <a:lnTo>
                    <a:pt x="629" y="13"/>
                  </a:lnTo>
                  <a:lnTo>
                    <a:pt x="630" y="13"/>
                  </a:lnTo>
                  <a:lnTo>
                    <a:pt x="632" y="12"/>
                  </a:lnTo>
                  <a:lnTo>
                    <a:pt x="634" y="12"/>
                  </a:lnTo>
                  <a:lnTo>
                    <a:pt x="636" y="12"/>
                  </a:lnTo>
                  <a:lnTo>
                    <a:pt x="638" y="12"/>
                  </a:lnTo>
                  <a:lnTo>
                    <a:pt x="639" y="11"/>
                  </a:lnTo>
                  <a:lnTo>
                    <a:pt x="640" y="11"/>
                  </a:lnTo>
                  <a:lnTo>
                    <a:pt x="642" y="11"/>
                  </a:lnTo>
                  <a:lnTo>
                    <a:pt x="643" y="11"/>
                  </a:lnTo>
                  <a:lnTo>
                    <a:pt x="644" y="11"/>
                  </a:lnTo>
                  <a:lnTo>
                    <a:pt x="645" y="11"/>
                  </a:lnTo>
                  <a:lnTo>
                    <a:pt x="646" y="11"/>
                  </a:lnTo>
                  <a:lnTo>
                    <a:pt x="647" y="11"/>
                  </a:lnTo>
                  <a:lnTo>
                    <a:pt x="648" y="10"/>
                  </a:lnTo>
                  <a:lnTo>
                    <a:pt x="650" y="10"/>
                  </a:lnTo>
                  <a:lnTo>
                    <a:pt x="651" y="10"/>
                  </a:lnTo>
                  <a:lnTo>
                    <a:pt x="652" y="10"/>
                  </a:lnTo>
                  <a:lnTo>
                    <a:pt x="654" y="10"/>
                  </a:lnTo>
                  <a:lnTo>
                    <a:pt x="655" y="10"/>
                  </a:lnTo>
                  <a:lnTo>
                    <a:pt x="656" y="10"/>
                  </a:lnTo>
                  <a:lnTo>
                    <a:pt x="657" y="10"/>
                  </a:lnTo>
                  <a:lnTo>
                    <a:pt x="657" y="10"/>
                  </a:lnTo>
                  <a:lnTo>
                    <a:pt x="659" y="10"/>
                  </a:lnTo>
                  <a:lnTo>
                    <a:pt x="660" y="10"/>
                  </a:lnTo>
                  <a:lnTo>
                    <a:pt x="661" y="10"/>
                  </a:lnTo>
                  <a:lnTo>
                    <a:pt x="663" y="10"/>
                  </a:lnTo>
                  <a:lnTo>
                    <a:pt x="664" y="10"/>
                  </a:lnTo>
                  <a:lnTo>
                    <a:pt x="665" y="10"/>
                  </a:lnTo>
                  <a:lnTo>
                    <a:pt x="666" y="10"/>
                  </a:lnTo>
                  <a:lnTo>
                    <a:pt x="667" y="10"/>
                  </a:lnTo>
                  <a:lnTo>
                    <a:pt x="669" y="10"/>
                  </a:lnTo>
                  <a:lnTo>
                    <a:pt x="670" y="10"/>
                  </a:lnTo>
                  <a:lnTo>
                    <a:pt x="671" y="10"/>
                  </a:lnTo>
                  <a:lnTo>
                    <a:pt x="672" y="10"/>
                  </a:lnTo>
                  <a:lnTo>
                    <a:pt x="674" y="10"/>
                  </a:lnTo>
                  <a:lnTo>
                    <a:pt x="675" y="9"/>
                  </a:lnTo>
                  <a:lnTo>
                    <a:pt x="676" y="9"/>
                  </a:lnTo>
                  <a:lnTo>
                    <a:pt x="677" y="9"/>
                  </a:lnTo>
                  <a:lnTo>
                    <a:pt x="678" y="9"/>
                  </a:lnTo>
                  <a:lnTo>
                    <a:pt x="680" y="9"/>
                  </a:lnTo>
                  <a:lnTo>
                    <a:pt x="681" y="8"/>
                  </a:lnTo>
                  <a:lnTo>
                    <a:pt x="683" y="8"/>
                  </a:lnTo>
                  <a:lnTo>
                    <a:pt x="684" y="8"/>
                  </a:lnTo>
                  <a:lnTo>
                    <a:pt x="684" y="8"/>
                  </a:lnTo>
                  <a:lnTo>
                    <a:pt x="685" y="8"/>
                  </a:lnTo>
                  <a:lnTo>
                    <a:pt x="685" y="8"/>
                  </a:lnTo>
                  <a:lnTo>
                    <a:pt x="685" y="8"/>
                  </a:lnTo>
                  <a:lnTo>
                    <a:pt x="686" y="8"/>
                  </a:lnTo>
                  <a:lnTo>
                    <a:pt x="687" y="7"/>
                  </a:lnTo>
                  <a:lnTo>
                    <a:pt x="688" y="7"/>
                  </a:lnTo>
                  <a:lnTo>
                    <a:pt x="689" y="7"/>
                  </a:lnTo>
                  <a:lnTo>
                    <a:pt x="690" y="7"/>
                  </a:lnTo>
                  <a:lnTo>
                    <a:pt x="692" y="7"/>
                  </a:lnTo>
                  <a:lnTo>
                    <a:pt x="693" y="6"/>
                  </a:lnTo>
                  <a:lnTo>
                    <a:pt x="694" y="6"/>
                  </a:lnTo>
                  <a:lnTo>
                    <a:pt x="695" y="6"/>
                  </a:lnTo>
                  <a:lnTo>
                    <a:pt x="696" y="6"/>
                  </a:lnTo>
                  <a:lnTo>
                    <a:pt x="696" y="6"/>
                  </a:lnTo>
                  <a:lnTo>
                    <a:pt x="697" y="6"/>
                  </a:lnTo>
                  <a:lnTo>
                    <a:pt x="698" y="6"/>
                  </a:lnTo>
                  <a:lnTo>
                    <a:pt x="699" y="6"/>
                  </a:lnTo>
                  <a:lnTo>
                    <a:pt x="701" y="6"/>
                  </a:lnTo>
                  <a:lnTo>
                    <a:pt x="702" y="6"/>
                  </a:lnTo>
                  <a:lnTo>
                    <a:pt x="703" y="6"/>
                  </a:lnTo>
                  <a:lnTo>
                    <a:pt x="704" y="6"/>
                  </a:lnTo>
                  <a:lnTo>
                    <a:pt x="705" y="5"/>
                  </a:lnTo>
                  <a:lnTo>
                    <a:pt x="706" y="5"/>
                  </a:lnTo>
                  <a:lnTo>
                    <a:pt x="708" y="5"/>
                  </a:lnTo>
                  <a:lnTo>
                    <a:pt x="709" y="6"/>
                  </a:lnTo>
                  <a:lnTo>
                    <a:pt x="711" y="6"/>
                  </a:lnTo>
                  <a:lnTo>
                    <a:pt x="713" y="6"/>
                  </a:lnTo>
                  <a:lnTo>
                    <a:pt x="714" y="6"/>
                  </a:lnTo>
                  <a:lnTo>
                    <a:pt x="715" y="6"/>
                  </a:lnTo>
                  <a:lnTo>
                    <a:pt x="715" y="6"/>
                  </a:lnTo>
                  <a:lnTo>
                    <a:pt x="716" y="6"/>
                  </a:lnTo>
                  <a:lnTo>
                    <a:pt x="717" y="6"/>
                  </a:lnTo>
                  <a:lnTo>
                    <a:pt x="720" y="6"/>
                  </a:lnTo>
                  <a:lnTo>
                    <a:pt x="722" y="6"/>
                  </a:lnTo>
                  <a:lnTo>
                    <a:pt x="723" y="6"/>
                  </a:lnTo>
                  <a:lnTo>
                    <a:pt x="725" y="6"/>
                  </a:lnTo>
                  <a:lnTo>
                    <a:pt x="726" y="6"/>
                  </a:lnTo>
                  <a:lnTo>
                    <a:pt x="728" y="6"/>
                  </a:lnTo>
                  <a:lnTo>
                    <a:pt x="730" y="6"/>
                  </a:lnTo>
                  <a:lnTo>
                    <a:pt x="732" y="7"/>
                  </a:lnTo>
                  <a:lnTo>
                    <a:pt x="734" y="7"/>
                  </a:lnTo>
                  <a:lnTo>
                    <a:pt x="735" y="7"/>
                  </a:lnTo>
                  <a:lnTo>
                    <a:pt x="736" y="7"/>
                  </a:lnTo>
                  <a:lnTo>
                    <a:pt x="738" y="7"/>
                  </a:lnTo>
                  <a:lnTo>
                    <a:pt x="739" y="7"/>
                  </a:lnTo>
                  <a:lnTo>
                    <a:pt x="740" y="7"/>
                  </a:lnTo>
                  <a:lnTo>
                    <a:pt x="740" y="7"/>
                  </a:lnTo>
                  <a:lnTo>
                    <a:pt x="741" y="7"/>
                  </a:lnTo>
                  <a:lnTo>
                    <a:pt x="742" y="7"/>
                  </a:lnTo>
                  <a:lnTo>
                    <a:pt x="742" y="7"/>
                  </a:lnTo>
                  <a:lnTo>
                    <a:pt x="743" y="7"/>
                  </a:lnTo>
                  <a:lnTo>
                    <a:pt x="743" y="7"/>
                  </a:lnTo>
                  <a:lnTo>
                    <a:pt x="744" y="7"/>
                  </a:lnTo>
                  <a:lnTo>
                    <a:pt x="744" y="7"/>
                  </a:lnTo>
                  <a:lnTo>
                    <a:pt x="744" y="7"/>
                  </a:lnTo>
                  <a:lnTo>
                    <a:pt x="744" y="7"/>
                  </a:lnTo>
                  <a:lnTo>
                    <a:pt x="745" y="7"/>
                  </a:lnTo>
                  <a:lnTo>
                    <a:pt x="746" y="7"/>
                  </a:lnTo>
                  <a:lnTo>
                    <a:pt x="746" y="7"/>
                  </a:lnTo>
                  <a:lnTo>
                    <a:pt x="747" y="7"/>
                  </a:lnTo>
                  <a:lnTo>
                    <a:pt x="748" y="7"/>
                  </a:lnTo>
                  <a:lnTo>
                    <a:pt x="749" y="7"/>
                  </a:lnTo>
                  <a:lnTo>
                    <a:pt x="749" y="6"/>
                  </a:lnTo>
                  <a:lnTo>
                    <a:pt x="750" y="6"/>
                  </a:lnTo>
                  <a:lnTo>
                    <a:pt x="751" y="6"/>
                  </a:lnTo>
                  <a:lnTo>
                    <a:pt x="752" y="6"/>
                  </a:lnTo>
                  <a:lnTo>
                    <a:pt x="753" y="6"/>
                  </a:lnTo>
                  <a:lnTo>
                    <a:pt x="754" y="6"/>
                  </a:lnTo>
                  <a:lnTo>
                    <a:pt x="754" y="5"/>
                  </a:lnTo>
                  <a:lnTo>
                    <a:pt x="755" y="5"/>
                  </a:lnTo>
                  <a:lnTo>
                    <a:pt x="756" y="5"/>
                  </a:lnTo>
                  <a:lnTo>
                    <a:pt x="757" y="5"/>
                  </a:lnTo>
                  <a:lnTo>
                    <a:pt x="758" y="5"/>
                  </a:lnTo>
                  <a:lnTo>
                    <a:pt x="759" y="4"/>
                  </a:lnTo>
                  <a:lnTo>
                    <a:pt x="760" y="4"/>
                  </a:lnTo>
                  <a:lnTo>
                    <a:pt x="762" y="3"/>
                  </a:lnTo>
                  <a:lnTo>
                    <a:pt x="763" y="3"/>
                  </a:lnTo>
                  <a:lnTo>
                    <a:pt x="763" y="3"/>
                  </a:lnTo>
                  <a:lnTo>
                    <a:pt x="764" y="2"/>
                  </a:lnTo>
                  <a:lnTo>
                    <a:pt x="765" y="2"/>
                  </a:lnTo>
                  <a:lnTo>
                    <a:pt x="766" y="2"/>
                  </a:lnTo>
                  <a:lnTo>
                    <a:pt x="766" y="2"/>
                  </a:lnTo>
                  <a:lnTo>
                    <a:pt x="767" y="2"/>
                  </a:lnTo>
                  <a:lnTo>
                    <a:pt x="769" y="2"/>
                  </a:lnTo>
                  <a:lnTo>
                    <a:pt x="770" y="2"/>
                  </a:lnTo>
                  <a:lnTo>
                    <a:pt x="771" y="1"/>
                  </a:lnTo>
                  <a:lnTo>
                    <a:pt x="772" y="1"/>
                  </a:lnTo>
                  <a:lnTo>
                    <a:pt x="772" y="1"/>
                  </a:lnTo>
                  <a:lnTo>
                    <a:pt x="773" y="1"/>
                  </a:lnTo>
                  <a:lnTo>
                    <a:pt x="773" y="1"/>
                  </a:lnTo>
                  <a:lnTo>
                    <a:pt x="773" y="1"/>
                  </a:lnTo>
                  <a:lnTo>
                    <a:pt x="774" y="1"/>
                  </a:lnTo>
                  <a:lnTo>
                    <a:pt x="774" y="1"/>
                  </a:lnTo>
                  <a:lnTo>
                    <a:pt x="775" y="1"/>
                  </a:lnTo>
                  <a:lnTo>
                    <a:pt x="776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4" name="Freeform 289">
              <a:extLst>
                <a:ext uri="{FF2B5EF4-FFF2-40B4-BE49-F238E27FC236}">
                  <a16:creationId xmlns:a16="http://schemas.microsoft.com/office/drawing/2014/main" id="{893AF319-E527-497E-BA96-D11C640479F4}"/>
                </a:ext>
              </a:extLst>
            </p:cNvPr>
            <p:cNvSpPr>
              <a:spLocks/>
            </p:cNvSpPr>
            <p:nvPr/>
          </p:nvSpPr>
          <p:spPr bwMode="auto">
            <a:xfrm>
              <a:off x="1654175" y="3505201"/>
              <a:ext cx="690563" cy="163513"/>
            </a:xfrm>
            <a:custGeom>
              <a:avLst/>
              <a:gdLst>
                <a:gd name="T0" fmla="*/ 10 w 435"/>
                <a:gd name="T1" fmla="*/ 88 h 103"/>
                <a:gd name="T2" fmla="*/ 19 w 435"/>
                <a:gd name="T3" fmla="*/ 86 h 103"/>
                <a:gd name="T4" fmla="*/ 26 w 435"/>
                <a:gd name="T5" fmla="*/ 85 h 103"/>
                <a:gd name="T6" fmla="*/ 29 w 435"/>
                <a:gd name="T7" fmla="*/ 84 h 103"/>
                <a:gd name="T8" fmla="*/ 36 w 435"/>
                <a:gd name="T9" fmla="*/ 82 h 103"/>
                <a:gd name="T10" fmla="*/ 44 w 435"/>
                <a:gd name="T11" fmla="*/ 78 h 103"/>
                <a:gd name="T12" fmla="*/ 50 w 435"/>
                <a:gd name="T13" fmla="*/ 76 h 103"/>
                <a:gd name="T14" fmla="*/ 55 w 435"/>
                <a:gd name="T15" fmla="*/ 75 h 103"/>
                <a:gd name="T16" fmla="*/ 60 w 435"/>
                <a:gd name="T17" fmla="*/ 75 h 103"/>
                <a:gd name="T18" fmla="*/ 65 w 435"/>
                <a:gd name="T19" fmla="*/ 74 h 103"/>
                <a:gd name="T20" fmla="*/ 70 w 435"/>
                <a:gd name="T21" fmla="*/ 72 h 103"/>
                <a:gd name="T22" fmla="*/ 77 w 435"/>
                <a:gd name="T23" fmla="*/ 65 h 103"/>
                <a:gd name="T24" fmla="*/ 84 w 435"/>
                <a:gd name="T25" fmla="*/ 58 h 103"/>
                <a:gd name="T26" fmla="*/ 88 w 435"/>
                <a:gd name="T27" fmla="*/ 57 h 103"/>
                <a:gd name="T28" fmla="*/ 94 w 435"/>
                <a:gd name="T29" fmla="*/ 58 h 103"/>
                <a:gd name="T30" fmla="*/ 102 w 435"/>
                <a:gd name="T31" fmla="*/ 64 h 103"/>
                <a:gd name="T32" fmla="*/ 108 w 435"/>
                <a:gd name="T33" fmla="*/ 67 h 103"/>
                <a:gd name="T34" fmla="*/ 113 w 435"/>
                <a:gd name="T35" fmla="*/ 66 h 103"/>
                <a:gd name="T36" fmla="*/ 118 w 435"/>
                <a:gd name="T37" fmla="*/ 64 h 103"/>
                <a:gd name="T38" fmla="*/ 126 w 435"/>
                <a:gd name="T39" fmla="*/ 60 h 103"/>
                <a:gd name="T40" fmla="*/ 131 w 435"/>
                <a:gd name="T41" fmla="*/ 60 h 103"/>
                <a:gd name="T42" fmla="*/ 140 w 435"/>
                <a:gd name="T43" fmla="*/ 64 h 103"/>
                <a:gd name="T44" fmla="*/ 147 w 435"/>
                <a:gd name="T45" fmla="*/ 67 h 103"/>
                <a:gd name="T46" fmla="*/ 154 w 435"/>
                <a:gd name="T47" fmla="*/ 66 h 103"/>
                <a:gd name="T48" fmla="*/ 165 w 435"/>
                <a:gd name="T49" fmla="*/ 62 h 103"/>
                <a:gd name="T50" fmla="*/ 171 w 435"/>
                <a:gd name="T51" fmla="*/ 57 h 103"/>
                <a:gd name="T52" fmla="*/ 173 w 435"/>
                <a:gd name="T53" fmla="*/ 55 h 103"/>
                <a:gd name="T54" fmla="*/ 178 w 435"/>
                <a:gd name="T55" fmla="*/ 49 h 103"/>
                <a:gd name="T56" fmla="*/ 187 w 435"/>
                <a:gd name="T57" fmla="*/ 37 h 103"/>
                <a:gd name="T58" fmla="*/ 191 w 435"/>
                <a:gd name="T59" fmla="*/ 32 h 103"/>
                <a:gd name="T60" fmla="*/ 198 w 435"/>
                <a:gd name="T61" fmla="*/ 30 h 103"/>
                <a:gd name="T62" fmla="*/ 204 w 435"/>
                <a:gd name="T63" fmla="*/ 32 h 103"/>
                <a:gd name="T64" fmla="*/ 213 w 435"/>
                <a:gd name="T65" fmla="*/ 37 h 103"/>
                <a:gd name="T66" fmla="*/ 218 w 435"/>
                <a:gd name="T67" fmla="*/ 38 h 103"/>
                <a:gd name="T68" fmla="*/ 222 w 435"/>
                <a:gd name="T69" fmla="*/ 36 h 103"/>
                <a:gd name="T70" fmla="*/ 226 w 435"/>
                <a:gd name="T71" fmla="*/ 30 h 103"/>
                <a:gd name="T72" fmla="*/ 232 w 435"/>
                <a:gd name="T73" fmla="*/ 18 h 103"/>
                <a:gd name="T74" fmla="*/ 237 w 435"/>
                <a:gd name="T75" fmla="*/ 7 h 103"/>
                <a:gd name="T76" fmla="*/ 241 w 435"/>
                <a:gd name="T77" fmla="*/ 1 h 103"/>
                <a:gd name="T78" fmla="*/ 246 w 435"/>
                <a:gd name="T79" fmla="*/ 1 h 103"/>
                <a:gd name="T80" fmla="*/ 251 w 435"/>
                <a:gd name="T81" fmla="*/ 8 h 103"/>
                <a:gd name="T82" fmla="*/ 261 w 435"/>
                <a:gd name="T83" fmla="*/ 24 h 103"/>
                <a:gd name="T84" fmla="*/ 265 w 435"/>
                <a:gd name="T85" fmla="*/ 31 h 103"/>
                <a:gd name="T86" fmla="*/ 279 w 435"/>
                <a:gd name="T87" fmla="*/ 53 h 103"/>
                <a:gd name="T88" fmla="*/ 290 w 435"/>
                <a:gd name="T89" fmla="*/ 68 h 103"/>
                <a:gd name="T90" fmla="*/ 293 w 435"/>
                <a:gd name="T91" fmla="*/ 72 h 103"/>
                <a:gd name="T92" fmla="*/ 299 w 435"/>
                <a:gd name="T93" fmla="*/ 78 h 103"/>
                <a:gd name="T94" fmla="*/ 306 w 435"/>
                <a:gd name="T95" fmla="*/ 83 h 103"/>
                <a:gd name="T96" fmla="*/ 314 w 435"/>
                <a:gd name="T97" fmla="*/ 87 h 103"/>
                <a:gd name="T98" fmla="*/ 321 w 435"/>
                <a:gd name="T99" fmla="*/ 91 h 103"/>
                <a:gd name="T100" fmla="*/ 331 w 435"/>
                <a:gd name="T101" fmla="*/ 93 h 103"/>
                <a:gd name="T102" fmla="*/ 344 w 435"/>
                <a:gd name="T103" fmla="*/ 97 h 103"/>
                <a:gd name="T104" fmla="*/ 351 w 435"/>
                <a:gd name="T105" fmla="*/ 98 h 103"/>
                <a:gd name="T106" fmla="*/ 363 w 435"/>
                <a:gd name="T107" fmla="*/ 100 h 103"/>
                <a:gd name="T108" fmla="*/ 376 w 435"/>
                <a:gd name="T109" fmla="*/ 102 h 103"/>
                <a:gd name="T110" fmla="*/ 387 w 435"/>
                <a:gd name="T111" fmla="*/ 103 h 103"/>
                <a:gd name="T112" fmla="*/ 399 w 435"/>
                <a:gd name="T113" fmla="*/ 103 h 103"/>
                <a:gd name="T114" fmla="*/ 408 w 435"/>
                <a:gd name="T115" fmla="*/ 103 h 103"/>
                <a:gd name="T116" fmla="*/ 413 w 435"/>
                <a:gd name="T117" fmla="*/ 102 h 103"/>
                <a:gd name="T118" fmla="*/ 420 w 435"/>
                <a:gd name="T119" fmla="*/ 101 h 103"/>
                <a:gd name="T120" fmla="*/ 425 w 435"/>
                <a:gd name="T121" fmla="*/ 100 h 103"/>
                <a:gd name="T122" fmla="*/ 429 w 435"/>
                <a:gd name="T123" fmla="*/ 98 h 103"/>
                <a:gd name="T124" fmla="*/ 432 w 435"/>
                <a:gd name="T125" fmla="*/ 96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435" h="103">
                  <a:moveTo>
                    <a:pt x="0" y="91"/>
                  </a:moveTo>
                  <a:lnTo>
                    <a:pt x="1" y="91"/>
                  </a:lnTo>
                  <a:lnTo>
                    <a:pt x="3" y="91"/>
                  </a:lnTo>
                  <a:lnTo>
                    <a:pt x="4" y="90"/>
                  </a:lnTo>
                  <a:lnTo>
                    <a:pt x="6" y="90"/>
                  </a:lnTo>
                  <a:lnTo>
                    <a:pt x="7" y="89"/>
                  </a:lnTo>
                  <a:lnTo>
                    <a:pt x="8" y="89"/>
                  </a:lnTo>
                  <a:lnTo>
                    <a:pt x="10" y="88"/>
                  </a:lnTo>
                  <a:lnTo>
                    <a:pt x="12" y="88"/>
                  </a:lnTo>
                  <a:lnTo>
                    <a:pt x="13" y="87"/>
                  </a:lnTo>
                  <a:lnTo>
                    <a:pt x="14" y="87"/>
                  </a:lnTo>
                  <a:lnTo>
                    <a:pt x="15" y="86"/>
                  </a:lnTo>
                  <a:lnTo>
                    <a:pt x="16" y="86"/>
                  </a:lnTo>
                  <a:lnTo>
                    <a:pt x="17" y="86"/>
                  </a:lnTo>
                  <a:lnTo>
                    <a:pt x="18" y="86"/>
                  </a:lnTo>
                  <a:lnTo>
                    <a:pt x="19" y="86"/>
                  </a:lnTo>
                  <a:lnTo>
                    <a:pt x="20" y="86"/>
                  </a:lnTo>
                  <a:lnTo>
                    <a:pt x="21" y="85"/>
                  </a:lnTo>
                  <a:lnTo>
                    <a:pt x="22" y="85"/>
                  </a:lnTo>
                  <a:lnTo>
                    <a:pt x="23" y="85"/>
                  </a:lnTo>
                  <a:lnTo>
                    <a:pt x="24" y="85"/>
                  </a:lnTo>
                  <a:lnTo>
                    <a:pt x="25" y="85"/>
                  </a:lnTo>
                  <a:lnTo>
                    <a:pt x="25" y="85"/>
                  </a:lnTo>
                  <a:lnTo>
                    <a:pt x="26" y="85"/>
                  </a:lnTo>
                  <a:lnTo>
                    <a:pt x="26" y="85"/>
                  </a:lnTo>
                  <a:lnTo>
                    <a:pt x="26" y="85"/>
                  </a:lnTo>
                  <a:lnTo>
                    <a:pt x="27" y="85"/>
                  </a:lnTo>
                  <a:lnTo>
                    <a:pt x="27" y="85"/>
                  </a:lnTo>
                  <a:lnTo>
                    <a:pt x="27" y="85"/>
                  </a:lnTo>
                  <a:lnTo>
                    <a:pt x="28" y="85"/>
                  </a:lnTo>
                  <a:lnTo>
                    <a:pt x="29" y="84"/>
                  </a:lnTo>
                  <a:lnTo>
                    <a:pt x="29" y="84"/>
                  </a:lnTo>
                  <a:lnTo>
                    <a:pt x="30" y="84"/>
                  </a:lnTo>
                  <a:lnTo>
                    <a:pt x="31" y="84"/>
                  </a:lnTo>
                  <a:lnTo>
                    <a:pt x="32" y="84"/>
                  </a:lnTo>
                  <a:lnTo>
                    <a:pt x="33" y="83"/>
                  </a:lnTo>
                  <a:lnTo>
                    <a:pt x="33" y="83"/>
                  </a:lnTo>
                  <a:lnTo>
                    <a:pt x="34" y="83"/>
                  </a:lnTo>
                  <a:lnTo>
                    <a:pt x="35" y="83"/>
                  </a:lnTo>
                  <a:lnTo>
                    <a:pt x="36" y="82"/>
                  </a:lnTo>
                  <a:lnTo>
                    <a:pt x="37" y="82"/>
                  </a:lnTo>
                  <a:lnTo>
                    <a:pt x="37" y="82"/>
                  </a:lnTo>
                  <a:lnTo>
                    <a:pt x="38" y="81"/>
                  </a:lnTo>
                  <a:lnTo>
                    <a:pt x="39" y="81"/>
                  </a:lnTo>
                  <a:lnTo>
                    <a:pt x="40" y="80"/>
                  </a:lnTo>
                  <a:lnTo>
                    <a:pt x="42" y="79"/>
                  </a:lnTo>
                  <a:lnTo>
                    <a:pt x="43" y="79"/>
                  </a:lnTo>
                  <a:lnTo>
                    <a:pt x="44" y="78"/>
                  </a:lnTo>
                  <a:lnTo>
                    <a:pt x="45" y="78"/>
                  </a:lnTo>
                  <a:lnTo>
                    <a:pt x="45" y="77"/>
                  </a:lnTo>
                  <a:lnTo>
                    <a:pt x="46" y="77"/>
                  </a:lnTo>
                  <a:lnTo>
                    <a:pt x="47" y="77"/>
                  </a:lnTo>
                  <a:lnTo>
                    <a:pt x="48" y="76"/>
                  </a:lnTo>
                  <a:lnTo>
                    <a:pt x="48" y="76"/>
                  </a:lnTo>
                  <a:lnTo>
                    <a:pt x="49" y="76"/>
                  </a:lnTo>
                  <a:lnTo>
                    <a:pt x="50" y="76"/>
                  </a:lnTo>
                  <a:lnTo>
                    <a:pt x="50" y="76"/>
                  </a:lnTo>
                  <a:lnTo>
                    <a:pt x="51" y="75"/>
                  </a:lnTo>
                  <a:lnTo>
                    <a:pt x="52" y="75"/>
                  </a:lnTo>
                  <a:lnTo>
                    <a:pt x="53" y="75"/>
                  </a:lnTo>
                  <a:lnTo>
                    <a:pt x="53" y="75"/>
                  </a:lnTo>
                  <a:lnTo>
                    <a:pt x="54" y="75"/>
                  </a:lnTo>
                  <a:lnTo>
                    <a:pt x="55" y="75"/>
                  </a:lnTo>
                  <a:lnTo>
                    <a:pt x="55" y="75"/>
                  </a:lnTo>
                  <a:lnTo>
                    <a:pt x="56" y="75"/>
                  </a:lnTo>
                  <a:lnTo>
                    <a:pt x="56" y="75"/>
                  </a:lnTo>
                  <a:lnTo>
                    <a:pt x="56" y="75"/>
                  </a:lnTo>
                  <a:lnTo>
                    <a:pt x="56" y="75"/>
                  </a:lnTo>
                  <a:lnTo>
                    <a:pt x="57" y="75"/>
                  </a:lnTo>
                  <a:lnTo>
                    <a:pt x="58" y="75"/>
                  </a:lnTo>
                  <a:lnTo>
                    <a:pt x="60" y="75"/>
                  </a:lnTo>
                  <a:lnTo>
                    <a:pt x="60" y="75"/>
                  </a:lnTo>
                  <a:lnTo>
                    <a:pt x="61" y="75"/>
                  </a:lnTo>
                  <a:lnTo>
                    <a:pt x="62" y="75"/>
                  </a:lnTo>
                  <a:lnTo>
                    <a:pt x="63" y="75"/>
                  </a:lnTo>
                  <a:lnTo>
                    <a:pt x="63" y="75"/>
                  </a:lnTo>
                  <a:lnTo>
                    <a:pt x="64" y="74"/>
                  </a:lnTo>
                  <a:lnTo>
                    <a:pt x="64" y="74"/>
                  </a:lnTo>
                  <a:lnTo>
                    <a:pt x="65" y="74"/>
                  </a:lnTo>
                  <a:lnTo>
                    <a:pt x="65" y="74"/>
                  </a:lnTo>
                  <a:lnTo>
                    <a:pt x="66" y="74"/>
                  </a:lnTo>
                  <a:lnTo>
                    <a:pt x="66" y="74"/>
                  </a:lnTo>
                  <a:lnTo>
                    <a:pt x="67" y="73"/>
                  </a:lnTo>
                  <a:lnTo>
                    <a:pt x="67" y="73"/>
                  </a:lnTo>
                  <a:lnTo>
                    <a:pt x="68" y="73"/>
                  </a:lnTo>
                  <a:lnTo>
                    <a:pt x="68" y="73"/>
                  </a:lnTo>
                  <a:lnTo>
                    <a:pt x="69" y="72"/>
                  </a:lnTo>
                  <a:lnTo>
                    <a:pt x="70" y="72"/>
                  </a:lnTo>
                  <a:lnTo>
                    <a:pt x="71" y="71"/>
                  </a:lnTo>
                  <a:lnTo>
                    <a:pt x="71" y="71"/>
                  </a:lnTo>
                  <a:lnTo>
                    <a:pt x="72" y="70"/>
                  </a:lnTo>
                  <a:lnTo>
                    <a:pt x="73" y="69"/>
                  </a:lnTo>
                  <a:lnTo>
                    <a:pt x="74" y="68"/>
                  </a:lnTo>
                  <a:lnTo>
                    <a:pt x="75" y="67"/>
                  </a:lnTo>
                  <a:lnTo>
                    <a:pt x="76" y="66"/>
                  </a:lnTo>
                  <a:lnTo>
                    <a:pt x="77" y="65"/>
                  </a:lnTo>
                  <a:lnTo>
                    <a:pt x="79" y="63"/>
                  </a:lnTo>
                  <a:lnTo>
                    <a:pt x="80" y="62"/>
                  </a:lnTo>
                  <a:lnTo>
                    <a:pt x="80" y="61"/>
                  </a:lnTo>
                  <a:lnTo>
                    <a:pt x="81" y="61"/>
                  </a:lnTo>
                  <a:lnTo>
                    <a:pt x="82" y="60"/>
                  </a:lnTo>
                  <a:lnTo>
                    <a:pt x="83" y="59"/>
                  </a:lnTo>
                  <a:lnTo>
                    <a:pt x="83" y="59"/>
                  </a:lnTo>
                  <a:lnTo>
                    <a:pt x="84" y="58"/>
                  </a:lnTo>
                  <a:lnTo>
                    <a:pt x="85" y="58"/>
                  </a:lnTo>
                  <a:lnTo>
                    <a:pt x="85" y="58"/>
                  </a:lnTo>
                  <a:lnTo>
                    <a:pt x="86" y="58"/>
                  </a:lnTo>
                  <a:lnTo>
                    <a:pt x="86" y="57"/>
                  </a:lnTo>
                  <a:lnTo>
                    <a:pt x="87" y="57"/>
                  </a:lnTo>
                  <a:lnTo>
                    <a:pt x="87" y="57"/>
                  </a:lnTo>
                  <a:lnTo>
                    <a:pt x="88" y="57"/>
                  </a:lnTo>
                  <a:lnTo>
                    <a:pt x="88" y="57"/>
                  </a:lnTo>
                  <a:lnTo>
                    <a:pt x="89" y="57"/>
                  </a:lnTo>
                  <a:lnTo>
                    <a:pt x="90" y="57"/>
                  </a:lnTo>
                  <a:lnTo>
                    <a:pt x="90" y="57"/>
                  </a:lnTo>
                  <a:lnTo>
                    <a:pt x="91" y="57"/>
                  </a:lnTo>
                  <a:lnTo>
                    <a:pt x="91" y="58"/>
                  </a:lnTo>
                  <a:lnTo>
                    <a:pt x="92" y="58"/>
                  </a:lnTo>
                  <a:lnTo>
                    <a:pt x="93" y="58"/>
                  </a:lnTo>
                  <a:lnTo>
                    <a:pt x="94" y="58"/>
                  </a:lnTo>
                  <a:lnTo>
                    <a:pt x="94" y="59"/>
                  </a:lnTo>
                  <a:lnTo>
                    <a:pt x="95" y="59"/>
                  </a:lnTo>
                  <a:lnTo>
                    <a:pt x="96" y="60"/>
                  </a:lnTo>
                  <a:lnTo>
                    <a:pt x="97" y="61"/>
                  </a:lnTo>
                  <a:lnTo>
                    <a:pt x="98" y="61"/>
                  </a:lnTo>
                  <a:lnTo>
                    <a:pt x="99" y="63"/>
                  </a:lnTo>
                  <a:lnTo>
                    <a:pt x="101" y="63"/>
                  </a:lnTo>
                  <a:lnTo>
                    <a:pt x="102" y="64"/>
                  </a:lnTo>
                  <a:lnTo>
                    <a:pt x="103" y="65"/>
                  </a:lnTo>
                  <a:lnTo>
                    <a:pt x="103" y="66"/>
                  </a:lnTo>
                  <a:lnTo>
                    <a:pt x="104" y="66"/>
                  </a:lnTo>
                  <a:lnTo>
                    <a:pt x="105" y="66"/>
                  </a:lnTo>
                  <a:lnTo>
                    <a:pt x="106" y="66"/>
                  </a:lnTo>
                  <a:lnTo>
                    <a:pt x="106" y="67"/>
                  </a:lnTo>
                  <a:lnTo>
                    <a:pt x="107" y="67"/>
                  </a:lnTo>
                  <a:lnTo>
                    <a:pt x="108" y="67"/>
                  </a:lnTo>
                  <a:lnTo>
                    <a:pt x="108" y="67"/>
                  </a:lnTo>
                  <a:lnTo>
                    <a:pt x="109" y="67"/>
                  </a:lnTo>
                  <a:lnTo>
                    <a:pt x="110" y="67"/>
                  </a:lnTo>
                  <a:lnTo>
                    <a:pt x="110" y="67"/>
                  </a:lnTo>
                  <a:lnTo>
                    <a:pt x="111" y="67"/>
                  </a:lnTo>
                  <a:lnTo>
                    <a:pt x="112" y="67"/>
                  </a:lnTo>
                  <a:lnTo>
                    <a:pt x="112" y="67"/>
                  </a:lnTo>
                  <a:lnTo>
                    <a:pt x="113" y="66"/>
                  </a:lnTo>
                  <a:lnTo>
                    <a:pt x="113" y="66"/>
                  </a:lnTo>
                  <a:lnTo>
                    <a:pt x="114" y="66"/>
                  </a:lnTo>
                  <a:lnTo>
                    <a:pt x="114" y="66"/>
                  </a:lnTo>
                  <a:lnTo>
                    <a:pt x="115" y="66"/>
                  </a:lnTo>
                  <a:lnTo>
                    <a:pt x="115" y="66"/>
                  </a:lnTo>
                  <a:lnTo>
                    <a:pt x="116" y="65"/>
                  </a:lnTo>
                  <a:lnTo>
                    <a:pt x="117" y="65"/>
                  </a:lnTo>
                  <a:lnTo>
                    <a:pt x="118" y="64"/>
                  </a:lnTo>
                  <a:lnTo>
                    <a:pt x="120" y="63"/>
                  </a:lnTo>
                  <a:lnTo>
                    <a:pt x="121" y="62"/>
                  </a:lnTo>
                  <a:lnTo>
                    <a:pt x="122" y="61"/>
                  </a:lnTo>
                  <a:lnTo>
                    <a:pt x="123" y="61"/>
                  </a:lnTo>
                  <a:lnTo>
                    <a:pt x="124" y="60"/>
                  </a:lnTo>
                  <a:lnTo>
                    <a:pt x="125" y="60"/>
                  </a:lnTo>
                  <a:lnTo>
                    <a:pt x="125" y="60"/>
                  </a:lnTo>
                  <a:lnTo>
                    <a:pt x="126" y="60"/>
                  </a:lnTo>
                  <a:lnTo>
                    <a:pt x="127" y="59"/>
                  </a:lnTo>
                  <a:lnTo>
                    <a:pt x="127" y="59"/>
                  </a:lnTo>
                  <a:lnTo>
                    <a:pt x="128" y="59"/>
                  </a:lnTo>
                  <a:lnTo>
                    <a:pt x="129" y="59"/>
                  </a:lnTo>
                  <a:lnTo>
                    <a:pt x="129" y="59"/>
                  </a:lnTo>
                  <a:lnTo>
                    <a:pt x="130" y="59"/>
                  </a:lnTo>
                  <a:lnTo>
                    <a:pt x="131" y="59"/>
                  </a:lnTo>
                  <a:lnTo>
                    <a:pt x="131" y="60"/>
                  </a:lnTo>
                  <a:lnTo>
                    <a:pt x="132" y="60"/>
                  </a:lnTo>
                  <a:lnTo>
                    <a:pt x="133" y="60"/>
                  </a:lnTo>
                  <a:lnTo>
                    <a:pt x="134" y="61"/>
                  </a:lnTo>
                  <a:lnTo>
                    <a:pt x="135" y="61"/>
                  </a:lnTo>
                  <a:lnTo>
                    <a:pt x="136" y="61"/>
                  </a:lnTo>
                  <a:lnTo>
                    <a:pt x="137" y="62"/>
                  </a:lnTo>
                  <a:lnTo>
                    <a:pt x="138" y="63"/>
                  </a:lnTo>
                  <a:lnTo>
                    <a:pt x="140" y="64"/>
                  </a:lnTo>
                  <a:lnTo>
                    <a:pt x="141" y="65"/>
                  </a:lnTo>
                  <a:lnTo>
                    <a:pt x="142" y="65"/>
                  </a:lnTo>
                  <a:lnTo>
                    <a:pt x="143" y="66"/>
                  </a:lnTo>
                  <a:lnTo>
                    <a:pt x="145" y="66"/>
                  </a:lnTo>
                  <a:lnTo>
                    <a:pt x="145" y="66"/>
                  </a:lnTo>
                  <a:lnTo>
                    <a:pt x="146" y="67"/>
                  </a:lnTo>
                  <a:lnTo>
                    <a:pt x="147" y="67"/>
                  </a:lnTo>
                  <a:lnTo>
                    <a:pt x="147" y="67"/>
                  </a:lnTo>
                  <a:lnTo>
                    <a:pt x="148" y="67"/>
                  </a:lnTo>
                  <a:lnTo>
                    <a:pt x="149" y="67"/>
                  </a:lnTo>
                  <a:lnTo>
                    <a:pt x="150" y="67"/>
                  </a:lnTo>
                  <a:lnTo>
                    <a:pt x="150" y="67"/>
                  </a:lnTo>
                  <a:lnTo>
                    <a:pt x="151" y="67"/>
                  </a:lnTo>
                  <a:lnTo>
                    <a:pt x="152" y="66"/>
                  </a:lnTo>
                  <a:lnTo>
                    <a:pt x="153" y="66"/>
                  </a:lnTo>
                  <a:lnTo>
                    <a:pt x="154" y="66"/>
                  </a:lnTo>
                  <a:lnTo>
                    <a:pt x="155" y="66"/>
                  </a:lnTo>
                  <a:lnTo>
                    <a:pt x="157" y="65"/>
                  </a:lnTo>
                  <a:lnTo>
                    <a:pt x="158" y="65"/>
                  </a:lnTo>
                  <a:lnTo>
                    <a:pt x="160" y="64"/>
                  </a:lnTo>
                  <a:lnTo>
                    <a:pt x="161" y="63"/>
                  </a:lnTo>
                  <a:lnTo>
                    <a:pt x="162" y="63"/>
                  </a:lnTo>
                  <a:lnTo>
                    <a:pt x="164" y="62"/>
                  </a:lnTo>
                  <a:lnTo>
                    <a:pt x="165" y="62"/>
                  </a:lnTo>
                  <a:lnTo>
                    <a:pt x="166" y="61"/>
                  </a:lnTo>
                  <a:lnTo>
                    <a:pt x="167" y="61"/>
                  </a:lnTo>
                  <a:lnTo>
                    <a:pt x="168" y="60"/>
                  </a:lnTo>
                  <a:lnTo>
                    <a:pt x="168" y="59"/>
                  </a:lnTo>
                  <a:lnTo>
                    <a:pt x="169" y="59"/>
                  </a:lnTo>
                  <a:lnTo>
                    <a:pt x="170" y="58"/>
                  </a:lnTo>
                  <a:lnTo>
                    <a:pt x="171" y="58"/>
                  </a:lnTo>
                  <a:lnTo>
                    <a:pt x="171" y="57"/>
                  </a:lnTo>
                  <a:lnTo>
                    <a:pt x="172" y="57"/>
                  </a:lnTo>
                  <a:lnTo>
                    <a:pt x="172" y="56"/>
                  </a:lnTo>
                  <a:lnTo>
                    <a:pt x="172" y="56"/>
                  </a:lnTo>
                  <a:lnTo>
                    <a:pt x="173" y="56"/>
                  </a:lnTo>
                  <a:lnTo>
                    <a:pt x="173" y="56"/>
                  </a:lnTo>
                  <a:lnTo>
                    <a:pt x="173" y="55"/>
                  </a:lnTo>
                  <a:lnTo>
                    <a:pt x="173" y="55"/>
                  </a:lnTo>
                  <a:lnTo>
                    <a:pt x="173" y="55"/>
                  </a:lnTo>
                  <a:lnTo>
                    <a:pt x="174" y="55"/>
                  </a:lnTo>
                  <a:lnTo>
                    <a:pt x="174" y="55"/>
                  </a:lnTo>
                  <a:lnTo>
                    <a:pt x="174" y="54"/>
                  </a:lnTo>
                  <a:lnTo>
                    <a:pt x="175" y="53"/>
                  </a:lnTo>
                  <a:lnTo>
                    <a:pt x="176" y="52"/>
                  </a:lnTo>
                  <a:lnTo>
                    <a:pt x="177" y="51"/>
                  </a:lnTo>
                  <a:lnTo>
                    <a:pt x="178" y="50"/>
                  </a:lnTo>
                  <a:lnTo>
                    <a:pt x="178" y="49"/>
                  </a:lnTo>
                  <a:lnTo>
                    <a:pt x="179" y="47"/>
                  </a:lnTo>
                  <a:lnTo>
                    <a:pt x="181" y="46"/>
                  </a:lnTo>
                  <a:lnTo>
                    <a:pt x="182" y="44"/>
                  </a:lnTo>
                  <a:lnTo>
                    <a:pt x="183" y="42"/>
                  </a:lnTo>
                  <a:lnTo>
                    <a:pt x="184" y="40"/>
                  </a:lnTo>
                  <a:lnTo>
                    <a:pt x="185" y="39"/>
                  </a:lnTo>
                  <a:lnTo>
                    <a:pt x="186" y="38"/>
                  </a:lnTo>
                  <a:lnTo>
                    <a:pt x="187" y="37"/>
                  </a:lnTo>
                  <a:lnTo>
                    <a:pt x="187" y="36"/>
                  </a:lnTo>
                  <a:lnTo>
                    <a:pt x="188" y="35"/>
                  </a:lnTo>
                  <a:lnTo>
                    <a:pt x="189" y="34"/>
                  </a:lnTo>
                  <a:lnTo>
                    <a:pt x="189" y="34"/>
                  </a:lnTo>
                  <a:lnTo>
                    <a:pt x="190" y="33"/>
                  </a:lnTo>
                  <a:lnTo>
                    <a:pt x="190" y="33"/>
                  </a:lnTo>
                  <a:lnTo>
                    <a:pt x="191" y="32"/>
                  </a:lnTo>
                  <a:lnTo>
                    <a:pt x="191" y="32"/>
                  </a:lnTo>
                  <a:lnTo>
                    <a:pt x="192" y="31"/>
                  </a:lnTo>
                  <a:lnTo>
                    <a:pt x="193" y="31"/>
                  </a:lnTo>
                  <a:lnTo>
                    <a:pt x="194" y="30"/>
                  </a:lnTo>
                  <a:lnTo>
                    <a:pt x="195" y="30"/>
                  </a:lnTo>
                  <a:lnTo>
                    <a:pt x="195" y="30"/>
                  </a:lnTo>
                  <a:lnTo>
                    <a:pt x="196" y="30"/>
                  </a:lnTo>
                  <a:lnTo>
                    <a:pt x="197" y="30"/>
                  </a:lnTo>
                  <a:lnTo>
                    <a:pt x="198" y="30"/>
                  </a:lnTo>
                  <a:lnTo>
                    <a:pt x="199" y="30"/>
                  </a:lnTo>
                  <a:lnTo>
                    <a:pt x="200" y="30"/>
                  </a:lnTo>
                  <a:lnTo>
                    <a:pt x="201" y="31"/>
                  </a:lnTo>
                  <a:lnTo>
                    <a:pt x="202" y="31"/>
                  </a:lnTo>
                  <a:lnTo>
                    <a:pt x="203" y="32"/>
                  </a:lnTo>
                  <a:lnTo>
                    <a:pt x="203" y="32"/>
                  </a:lnTo>
                  <a:lnTo>
                    <a:pt x="204" y="32"/>
                  </a:lnTo>
                  <a:lnTo>
                    <a:pt x="204" y="32"/>
                  </a:lnTo>
                  <a:lnTo>
                    <a:pt x="205" y="33"/>
                  </a:lnTo>
                  <a:lnTo>
                    <a:pt x="206" y="34"/>
                  </a:lnTo>
                  <a:lnTo>
                    <a:pt x="208" y="35"/>
                  </a:lnTo>
                  <a:lnTo>
                    <a:pt x="210" y="35"/>
                  </a:lnTo>
                  <a:lnTo>
                    <a:pt x="211" y="36"/>
                  </a:lnTo>
                  <a:lnTo>
                    <a:pt x="212" y="36"/>
                  </a:lnTo>
                  <a:lnTo>
                    <a:pt x="212" y="37"/>
                  </a:lnTo>
                  <a:lnTo>
                    <a:pt x="213" y="37"/>
                  </a:lnTo>
                  <a:lnTo>
                    <a:pt x="214" y="37"/>
                  </a:lnTo>
                  <a:lnTo>
                    <a:pt x="215" y="38"/>
                  </a:lnTo>
                  <a:lnTo>
                    <a:pt x="215" y="38"/>
                  </a:lnTo>
                  <a:lnTo>
                    <a:pt x="216" y="38"/>
                  </a:lnTo>
                  <a:lnTo>
                    <a:pt x="216" y="38"/>
                  </a:lnTo>
                  <a:lnTo>
                    <a:pt x="217" y="38"/>
                  </a:lnTo>
                  <a:lnTo>
                    <a:pt x="217" y="38"/>
                  </a:lnTo>
                  <a:lnTo>
                    <a:pt x="218" y="38"/>
                  </a:lnTo>
                  <a:lnTo>
                    <a:pt x="219" y="38"/>
                  </a:lnTo>
                  <a:lnTo>
                    <a:pt x="219" y="38"/>
                  </a:lnTo>
                  <a:lnTo>
                    <a:pt x="219" y="37"/>
                  </a:lnTo>
                  <a:lnTo>
                    <a:pt x="220" y="37"/>
                  </a:lnTo>
                  <a:lnTo>
                    <a:pt x="220" y="37"/>
                  </a:lnTo>
                  <a:lnTo>
                    <a:pt x="221" y="36"/>
                  </a:lnTo>
                  <a:lnTo>
                    <a:pt x="221" y="36"/>
                  </a:lnTo>
                  <a:lnTo>
                    <a:pt x="222" y="36"/>
                  </a:lnTo>
                  <a:lnTo>
                    <a:pt x="222" y="35"/>
                  </a:lnTo>
                  <a:lnTo>
                    <a:pt x="223" y="35"/>
                  </a:lnTo>
                  <a:lnTo>
                    <a:pt x="223" y="34"/>
                  </a:lnTo>
                  <a:lnTo>
                    <a:pt x="224" y="33"/>
                  </a:lnTo>
                  <a:lnTo>
                    <a:pt x="224" y="33"/>
                  </a:lnTo>
                  <a:lnTo>
                    <a:pt x="225" y="32"/>
                  </a:lnTo>
                  <a:lnTo>
                    <a:pt x="225" y="31"/>
                  </a:lnTo>
                  <a:lnTo>
                    <a:pt x="226" y="30"/>
                  </a:lnTo>
                  <a:lnTo>
                    <a:pt x="227" y="28"/>
                  </a:lnTo>
                  <a:lnTo>
                    <a:pt x="228" y="27"/>
                  </a:lnTo>
                  <a:lnTo>
                    <a:pt x="228" y="25"/>
                  </a:lnTo>
                  <a:lnTo>
                    <a:pt x="229" y="23"/>
                  </a:lnTo>
                  <a:lnTo>
                    <a:pt x="230" y="21"/>
                  </a:lnTo>
                  <a:lnTo>
                    <a:pt x="231" y="20"/>
                  </a:lnTo>
                  <a:lnTo>
                    <a:pt x="231" y="19"/>
                  </a:lnTo>
                  <a:lnTo>
                    <a:pt x="232" y="18"/>
                  </a:lnTo>
                  <a:lnTo>
                    <a:pt x="232" y="17"/>
                  </a:lnTo>
                  <a:lnTo>
                    <a:pt x="233" y="16"/>
                  </a:lnTo>
                  <a:lnTo>
                    <a:pt x="233" y="15"/>
                  </a:lnTo>
                  <a:lnTo>
                    <a:pt x="234" y="14"/>
                  </a:lnTo>
                  <a:lnTo>
                    <a:pt x="235" y="11"/>
                  </a:lnTo>
                  <a:lnTo>
                    <a:pt x="235" y="10"/>
                  </a:lnTo>
                  <a:lnTo>
                    <a:pt x="236" y="8"/>
                  </a:lnTo>
                  <a:lnTo>
                    <a:pt x="237" y="7"/>
                  </a:lnTo>
                  <a:lnTo>
                    <a:pt x="237" y="5"/>
                  </a:lnTo>
                  <a:lnTo>
                    <a:pt x="238" y="5"/>
                  </a:lnTo>
                  <a:lnTo>
                    <a:pt x="239" y="4"/>
                  </a:lnTo>
                  <a:lnTo>
                    <a:pt x="239" y="3"/>
                  </a:lnTo>
                  <a:lnTo>
                    <a:pt x="240" y="2"/>
                  </a:lnTo>
                  <a:lnTo>
                    <a:pt x="240" y="2"/>
                  </a:lnTo>
                  <a:lnTo>
                    <a:pt x="241" y="1"/>
                  </a:lnTo>
                  <a:lnTo>
                    <a:pt x="241" y="1"/>
                  </a:lnTo>
                  <a:lnTo>
                    <a:pt x="242" y="0"/>
                  </a:lnTo>
                  <a:lnTo>
                    <a:pt x="242" y="0"/>
                  </a:lnTo>
                  <a:lnTo>
                    <a:pt x="243" y="0"/>
                  </a:lnTo>
                  <a:lnTo>
                    <a:pt x="244" y="0"/>
                  </a:lnTo>
                  <a:lnTo>
                    <a:pt x="244" y="0"/>
                  </a:lnTo>
                  <a:lnTo>
                    <a:pt x="245" y="0"/>
                  </a:lnTo>
                  <a:lnTo>
                    <a:pt x="245" y="1"/>
                  </a:lnTo>
                  <a:lnTo>
                    <a:pt x="246" y="1"/>
                  </a:lnTo>
                  <a:lnTo>
                    <a:pt x="246" y="1"/>
                  </a:lnTo>
                  <a:lnTo>
                    <a:pt x="247" y="2"/>
                  </a:lnTo>
                  <a:lnTo>
                    <a:pt x="248" y="3"/>
                  </a:lnTo>
                  <a:lnTo>
                    <a:pt x="248" y="3"/>
                  </a:lnTo>
                  <a:lnTo>
                    <a:pt x="249" y="4"/>
                  </a:lnTo>
                  <a:lnTo>
                    <a:pt x="250" y="5"/>
                  </a:lnTo>
                  <a:lnTo>
                    <a:pt x="251" y="7"/>
                  </a:lnTo>
                  <a:lnTo>
                    <a:pt x="251" y="8"/>
                  </a:lnTo>
                  <a:lnTo>
                    <a:pt x="252" y="10"/>
                  </a:lnTo>
                  <a:lnTo>
                    <a:pt x="254" y="11"/>
                  </a:lnTo>
                  <a:lnTo>
                    <a:pt x="255" y="14"/>
                  </a:lnTo>
                  <a:lnTo>
                    <a:pt x="256" y="17"/>
                  </a:lnTo>
                  <a:lnTo>
                    <a:pt x="258" y="20"/>
                  </a:lnTo>
                  <a:lnTo>
                    <a:pt x="260" y="23"/>
                  </a:lnTo>
                  <a:lnTo>
                    <a:pt x="260" y="23"/>
                  </a:lnTo>
                  <a:lnTo>
                    <a:pt x="261" y="24"/>
                  </a:lnTo>
                  <a:lnTo>
                    <a:pt x="261" y="25"/>
                  </a:lnTo>
                  <a:lnTo>
                    <a:pt x="261" y="25"/>
                  </a:lnTo>
                  <a:lnTo>
                    <a:pt x="262" y="26"/>
                  </a:lnTo>
                  <a:lnTo>
                    <a:pt x="262" y="26"/>
                  </a:lnTo>
                  <a:lnTo>
                    <a:pt x="262" y="27"/>
                  </a:lnTo>
                  <a:lnTo>
                    <a:pt x="262" y="27"/>
                  </a:lnTo>
                  <a:lnTo>
                    <a:pt x="263" y="28"/>
                  </a:lnTo>
                  <a:lnTo>
                    <a:pt x="265" y="31"/>
                  </a:lnTo>
                  <a:lnTo>
                    <a:pt x="266" y="33"/>
                  </a:lnTo>
                  <a:lnTo>
                    <a:pt x="267" y="35"/>
                  </a:lnTo>
                  <a:lnTo>
                    <a:pt x="269" y="38"/>
                  </a:lnTo>
                  <a:lnTo>
                    <a:pt x="271" y="40"/>
                  </a:lnTo>
                  <a:lnTo>
                    <a:pt x="273" y="43"/>
                  </a:lnTo>
                  <a:lnTo>
                    <a:pt x="275" y="46"/>
                  </a:lnTo>
                  <a:lnTo>
                    <a:pt x="277" y="49"/>
                  </a:lnTo>
                  <a:lnTo>
                    <a:pt x="279" y="53"/>
                  </a:lnTo>
                  <a:lnTo>
                    <a:pt x="281" y="56"/>
                  </a:lnTo>
                  <a:lnTo>
                    <a:pt x="283" y="58"/>
                  </a:lnTo>
                  <a:lnTo>
                    <a:pt x="284" y="60"/>
                  </a:lnTo>
                  <a:lnTo>
                    <a:pt x="285" y="62"/>
                  </a:lnTo>
                  <a:lnTo>
                    <a:pt x="287" y="64"/>
                  </a:lnTo>
                  <a:lnTo>
                    <a:pt x="288" y="66"/>
                  </a:lnTo>
                  <a:lnTo>
                    <a:pt x="289" y="67"/>
                  </a:lnTo>
                  <a:lnTo>
                    <a:pt x="290" y="68"/>
                  </a:lnTo>
                  <a:lnTo>
                    <a:pt x="290" y="69"/>
                  </a:lnTo>
                  <a:lnTo>
                    <a:pt x="291" y="69"/>
                  </a:lnTo>
                  <a:lnTo>
                    <a:pt x="291" y="70"/>
                  </a:lnTo>
                  <a:lnTo>
                    <a:pt x="292" y="71"/>
                  </a:lnTo>
                  <a:lnTo>
                    <a:pt x="292" y="71"/>
                  </a:lnTo>
                  <a:lnTo>
                    <a:pt x="292" y="71"/>
                  </a:lnTo>
                  <a:lnTo>
                    <a:pt x="293" y="72"/>
                  </a:lnTo>
                  <a:lnTo>
                    <a:pt x="293" y="72"/>
                  </a:lnTo>
                  <a:lnTo>
                    <a:pt x="294" y="73"/>
                  </a:lnTo>
                  <a:lnTo>
                    <a:pt x="295" y="74"/>
                  </a:lnTo>
                  <a:lnTo>
                    <a:pt x="295" y="75"/>
                  </a:lnTo>
                  <a:lnTo>
                    <a:pt x="296" y="75"/>
                  </a:lnTo>
                  <a:lnTo>
                    <a:pt x="297" y="76"/>
                  </a:lnTo>
                  <a:lnTo>
                    <a:pt x="298" y="77"/>
                  </a:lnTo>
                  <a:lnTo>
                    <a:pt x="298" y="77"/>
                  </a:lnTo>
                  <a:lnTo>
                    <a:pt x="299" y="78"/>
                  </a:lnTo>
                  <a:lnTo>
                    <a:pt x="300" y="79"/>
                  </a:lnTo>
                  <a:lnTo>
                    <a:pt x="301" y="79"/>
                  </a:lnTo>
                  <a:lnTo>
                    <a:pt x="301" y="80"/>
                  </a:lnTo>
                  <a:lnTo>
                    <a:pt x="302" y="81"/>
                  </a:lnTo>
                  <a:lnTo>
                    <a:pt x="303" y="81"/>
                  </a:lnTo>
                  <a:lnTo>
                    <a:pt x="304" y="82"/>
                  </a:lnTo>
                  <a:lnTo>
                    <a:pt x="305" y="82"/>
                  </a:lnTo>
                  <a:lnTo>
                    <a:pt x="306" y="83"/>
                  </a:lnTo>
                  <a:lnTo>
                    <a:pt x="306" y="83"/>
                  </a:lnTo>
                  <a:lnTo>
                    <a:pt x="307" y="84"/>
                  </a:lnTo>
                  <a:lnTo>
                    <a:pt x="308" y="85"/>
                  </a:lnTo>
                  <a:lnTo>
                    <a:pt x="309" y="85"/>
                  </a:lnTo>
                  <a:lnTo>
                    <a:pt x="310" y="86"/>
                  </a:lnTo>
                  <a:lnTo>
                    <a:pt x="311" y="86"/>
                  </a:lnTo>
                  <a:lnTo>
                    <a:pt x="312" y="87"/>
                  </a:lnTo>
                  <a:lnTo>
                    <a:pt x="314" y="87"/>
                  </a:lnTo>
                  <a:lnTo>
                    <a:pt x="315" y="88"/>
                  </a:lnTo>
                  <a:lnTo>
                    <a:pt x="316" y="88"/>
                  </a:lnTo>
                  <a:lnTo>
                    <a:pt x="317" y="89"/>
                  </a:lnTo>
                  <a:lnTo>
                    <a:pt x="318" y="89"/>
                  </a:lnTo>
                  <a:lnTo>
                    <a:pt x="319" y="90"/>
                  </a:lnTo>
                  <a:lnTo>
                    <a:pt x="320" y="90"/>
                  </a:lnTo>
                  <a:lnTo>
                    <a:pt x="321" y="90"/>
                  </a:lnTo>
                  <a:lnTo>
                    <a:pt x="321" y="91"/>
                  </a:lnTo>
                  <a:lnTo>
                    <a:pt x="322" y="91"/>
                  </a:lnTo>
                  <a:lnTo>
                    <a:pt x="322" y="91"/>
                  </a:lnTo>
                  <a:lnTo>
                    <a:pt x="323" y="91"/>
                  </a:lnTo>
                  <a:lnTo>
                    <a:pt x="324" y="91"/>
                  </a:lnTo>
                  <a:lnTo>
                    <a:pt x="326" y="92"/>
                  </a:lnTo>
                  <a:lnTo>
                    <a:pt x="327" y="92"/>
                  </a:lnTo>
                  <a:lnTo>
                    <a:pt x="329" y="93"/>
                  </a:lnTo>
                  <a:lnTo>
                    <a:pt x="331" y="93"/>
                  </a:lnTo>
                  <a:lnTo>
                    <a:pt x="332" y="94"/>
                  </a:lnTo>
                  <a:lnTo>
                    <a:pt x="334" y="94"/>
                  </a:lnTo>
                  <a:lnTo>
                    <a:pt x="335" y="95"/>
                  </a:lnTo>
                  <a:lnTo>
                    <a:pt x="337" y="95"/>
                  </a:lnTo>
                  <a:lnTo>
                    <a:pt x="339" y="95"/>
                  </a:lnTo>
                  <a:lnTo>
                    <a:pt x="340" y="96"/>
                  </a:lnTo>
                  <a:lnTo>
                    <a:pt x="342" y="96"/>
                  </a:lnTo>
                  <a:lnTo>
                    <a:pt x="344" y="97"/>
                  </a:lnTo>
                  <a:lnTo>
                    <a:pt x="346" y="97"/>
                  </a:lnTo>
                  <a:lnTo>
                    <a:pt x="347" y="97"/>
                  </a:lnTo>
                  <a:lnTo>
                    <a:pt x="348" y="98"/>
                  </a:lnTo>
                  <a:lnTo>
                    <a:pt x="349" y="98"/>
                  </a:lnTo>
                  <a:lnTo>
                    <a:pt x="350" y="98"/>
                  </a:lnTo>
                  <a:lnTo>
                    <a:pt x="350" y="98"/>
                  </a:lnTo>
                  <a:lnTo>
                    <a:pt x="351" y="98"/>
                  </a:lnTo>
                  <a:lnTo>
                    <a:pt x="351" y="98"/>
                  </a:lnTo>
                  <a:lnTo>
                    <a:pt x="352" y="98"/>
                  </a:lnTo>
                  <a:lnTo>
                    <a:pt x="353" y="98"/>
                  </a:lnTo>
                  <a:lnTo>
                    <a:pt x="355" y="99"/>
                  </a:lnTo>
                  <a:lnTo>
                    <a:pt x="356" y="99"/>
                  </a:lnTo>
                  <a:lnTo>
                    <a:pt x="358" y="99"/>
                  </a:lnTo>
                  <a:lnTo>
                    <a:pt x="360" y="100"/>
                  </a:lnTo>
                  <a:lnTo>
                    <a:pt x="361" y="100"/>
                  </a:lnTo>
                  <a:lnTo>
                    <a:pt x="363" y="100"/>
                  </a:lnTo>
                  <a:lnTo>
                    <a:pt x="365" y="101"/>
                  </a:lnTo>
                  <a:lnTo>
                    <a:pt x="366" y="101"/>
                  </a:lnTo>
                  <a:lnTo>
                    <a:pt x="368" y="101"/>
                  </a:lnTo>
                  <a:lnTo>
                    <a:pt x="369" y="101"/>
                  </a:lnTo>
                  <a:lnTo>
                    <a:pt x="371" y="101"/>
                  </a:lnTo>
                  <a:lnTo>
                    <a:pt x="373" y="101"/>
                  </a:lnTo>
                  <a:lnTo>
                    <a:pt x="374" y="102"/>
                  </a:lnTo>
                  <a:lnTo>
                    <a:pt x="376" y="102"/>
                  </a:lnTo>
                  <a:lnTo>
                    <a:pt x="378" y="102"/>
                  </a:lnTo>
                  <a:lnTo>
                    <a:pt x="379" y="102"/>
                  </a:lnTo>
                  <a:lnTo>
                    <a:pt x="380" y="102"/>
                  </a:lnTo>
                  <a:lnTo>
                    <a:pt x="381" y="102"/>
                  </a:lnTo>
                  <a:lnTo>
                    <a:pt x="382" y="102"/>
                  </a:lnTo>
                  <a:lnTo>
                    <a:pt x="384" y="103"/>
                  </a:lnTo>
                  <a:lnTo>
                    <a:pt x="385" y="103"/>
                  </a:lnTo>
                  <a:lnTo>
                    <a:pt x="387" y="103"/>
                  </a:lnTo>
                  <a:lnTo>
                    <a:pt x="388" y="103"/>
                  </a:lnTo>
                  <a:lnTo>
                    <a:pt x="390" y="103"/>
                  </a:lnTo>
                  <a:lnTo>
                    <a:pt x="391" y="103"/>
                  </a:lnTo>
                  <a:lnTo>
                    <a:pt x="393" y="103"/>
                  </a:lnTo>
                  <a:lnTo>
                    <a:pt x="394" y="103"/>
                  </a:lnTo>
                  <a:lnTo>
                    <a:pt x="396" y="103"/>
                  </a:lnTo>
                  <a:lnTo>
                    <a:pt x="397" y="103"/>
                  </a:lnTo>
                  <a:lnTo>
                    <a:pt x="399" y="103"/>
                  </a:lnTo>
                  <a:lnTo>
                    <a:pt x="400" y="103"/>
                  </a:lnTo>
                  <a:lnTo>
                    <a:pt x="401" y="103"/>
                  </a:lnTo>
                  <a:lnTo>
                    <a:pt x="403" y="103"/>
                  </a:lnTo>
                  <a:lnTo>
                    <a:pt x="404" y="103"/>
                  </a:lnTo>
                  <a:lnTo>
                    <a:pt x="406" y="103"/>
                  </a:lnTo>
                  <a:lnTo>
                    <a:pt x="407" y="103"/>
                  </a:lnTo>
                  <a:lnTo>
                    <a:pt x="407" y="103"/>
                  </a:lnTo>
                  <a:lnTo>
                    <a:pt x="408" y="103"/>
                  </a:lnTo>
                  <a:lnTo>
                    <a:pt x="408" y="103"/>
                  </a:lnTo>
                  <a:lnTo>
                    <a:pt x="409" y="103"/>
                  </a:lnTo>
                  <a:lnTo>
                    <a:pt x="409" y="103"/>
                  </a:lnTo>
                  <a:lnTo>
                    <a:pt x="409" y="103"/>
                  </a:lnTo>
                  <a:lnTo>
                    <a:pt x="410" y="103"/>
                  </a:lnTo>
                  <a:lnTo>
                    <a:pt x="411" y="102"/>
                  </a:lnTo>
                  <a:lnTo>
                    <a:pt x="412" y="102"/>
                  </a:lnTo>
                  <a:lnTo>
                    <a:pt x="413" y="102"/>
                  </a:lnTo>
                  <a:lnTo>
                    <a:pt x="414" y="102"/>
                  </a:lnTo>
                  <a:lnTo>
                    <a:pt x="415" y="102"/>
                  </a:lnTo>
                  <a:lnTo>
                    <a:pt x="416" y="102"/>
                  </a:lnTo>
                  <a:lnTo>
                    <a:pt x="417" y="102"/>
                  </a:lnTo>
                  <a:lnTo>
                    <a:pt x="418" y="102"/>
                  </a:lnTo>
                  <a:lnTo>
                    <a:pt x="419" y="101"/>
                  </a:lnTo>
                  <a:lnTo>
                    <a:pt x="419" y="101"/>
                  </a:lnTo>
                  <a:lnTo>
                    <a:pt x="420" y="101"/>
                  </a:lnTo>
                  <a:lnTo>
                    <a:pt x="421" y="101"/>
                  </a:lnTo>
                  <a:lnTo>
                    <a:pt x="421" y="101"/>
                  </a:lnTo>
                  <a:lnTo>
                    <a:pt x="422" y="101"/>
                  </a:lnTo>
                  <a:lnTo>
                    <a:pt x="423" y="101"/>
                  </a:lnTo>
                  <a:lnTo>
                    <a:pt x="423" y="101"/>
                  </a:lnTo>
                  <a:lnTo>
                    <a:pt x="424" y="100"/>
                  </a:lnTo>
                  <a:lnTo>
                    <a:pt x="424" y="100"/>
                  </a:lnTo>
                  <a:lnTo>
                    <a:pt x="425" y="100"/>
                  </a:lnTo>
                  <a:lnTo>
                    <a:pt x="425" y="100"/>
                  </a:lnTo>
                  <a:lnTo>
                    <a:pt x="426" y="100"/>
                  </a:lnTo>
                  <a:lnTo>
                    <a:pt x="426" y="99"/>
                  </a:lnTo>
                  <a:lnTo>
                    <a:pt x="427" y="99"/>
                  </a:lnTo>
                  <a:lnTo>
                    <a:pt x="427" y="99"/>
                  </a:lnTo>
                  <a:lnTo>
                    <a:pt x="428" y="99"/>
                  </a:lnTo>
                  <a:lnTo>
                    <a:pt x="428" y="99"/>
                  </a:lnTo>
                  <a:lnTo>
                    <a:pt x="429" y="98"/>
                  </a:lnTo>
                  <a:lnTo>
                    <a:pt x="429" y="98"/>
                  </a:lnTo>
                  <a:lnTo>
                    <a:pt x="430" y="98"/>
                  </a:lnTo>
                  <a:lnTo>
                    <a:pt x="430" y="98"/>
                  </a:lnTo>
                  <a:lnTo>
                    <a:pt x="431" y="97"/>
                  </a:lnTo>
                  <a:lnTo>
                    <a:pt x="431" y="97"/>
                  </a:lnTo>
                  <a:lnTo>
                    <a:pt x="432" y="97"/>
                  </a:lnTo>
                  <a:lnTo>
                    <a:pt x="432" y="97"/>
                  </a:lnTo>
                  <a:lnTo>
                    <a:pt x="432" y="96"/>
                  </a:lnTo>
                  <a:lnTo>
                    <a:pt x="433" y="96"/>
                  </a:lnTo>
                  <a:lnTo>
                    <a:pt x="433" y="96"/>
                  </a:lnTo>
                  <a:lnTo>
                    <a:pt x="434" y="96"/>
                  </a:lnTo>
                  <a:lnTo>
                    <a:pt x="434" y="95"/>
                  </a:lnTo>
                  <a:lnTo>
                    <a:pt x="435" y="95"/>
                  </a:lnTo>
                  <a:lnTo>
                    <a:pt x="435" y="94"/>
                  </a:lnTo>
                  <a:lnTo>
                    <a:pt x="435" y="94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5" name="Freeform 290">
              <a:extLst>
                <a:ext uri="{FF2B5EF4-FFF2-40B4-BE49-F238E27FC236}">
                  <a16:creationId xmlns:a16="http://schemas.microsoft.com/office/drawing/2014/main" id="{7D720702-EE78-47D6-A5E3-7DA4D5C29029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4738" y="1897063"/>
              <a:ext cx="584200" cy="1757363"/>
            </a:xfrm>
            <a:custGeom>
              <a:avLst/>
              <a:gdLst>
                <a:gd name="T0" fmla="*/ 1 w 368"/>
                <a:gd name="T1" fmla="*/ 1106 h 1107"/>
                <a:gd name="T2" fmla="*/ 2 w 368"/>
                <a:gd name="T3" fmla="*/ 1105 h 1107"/>
                <a:gd name="T4" fmla="*/ 4 w 368"/>
                <a:gd name="T5" fmla="*/ 1104 h 1107"/>
                <a:gd name="T6" fmla="*/ 7 w 368"/>
                <a:gd name="T7" fmla="*/ 1099 h 1107"/>
                <a:gd name="T8" fmla="*/ 11 w 368"/>
                <a:gd name="T9" fmla="*/ 1093 h 1107"/>
                <a:gd name="T10" fmla="*/ 15 w 368"/>
                <a:gd name="T11" fmla="*/ 1085 h 1107"/>
                <a:gd name="T12" fmla="*/ 23 w 368"/>
                <a:gd name="T13" fmla="*/ 1065 h 1107"/>
                <a:gd name="T14" fmla="*/ 28 w 368"/>
                <a:gd name="T15" fmla="*/ 1052 h 1107"/>
                <a:gd name="T16" fmla="*/ 31 w 368"/>
                <a:gd name="T17" fmla="*/ 1047 h 1107"/>
                <a:gd name="T18" fmla="*/ 34 w 368"/>
                <a:gd name="T19" fmla="*/ 1043 h 1107"/>
                <a:gd name="T20" fmla="*/ 45 w 368"/>
                <a:gd name="T21" fmla="*/ 1031 h 1107"/>
                <a:gd name="T22" fmla="*/ 57 w 368"/>
                <a:gd name="T23" fmla="*/ 1021 h 1107"/>
                <a:gd name="T24" fmla="*/ 61 w 368"/>
                <a:gd name="T25" fmla="*/ 1016 h 1107"/>
                <a:gd name="T26" fmla="*/ 64 w 368"/>
                <a:gd name="T27" fmla="*/ 1008 h 1107"/>
                <a:gd name="T28" fmla="*/ 74 w 368"/>
                <a:gd name="T29" fmla="*/ 987 h 1107"/>
                <a:gd name="T30" fmla="*/ 82 w 368"/>
                <a:gd name="T31" fmla="*/ 973 h 1107"/>
                <a:gd name="T32" fmla="*/ 87 w 368"/>
                <a:gd name="T33" fmla="*/ 962 h 1107"/>
                <a:gd name="T34" fmla="*/ 90 w 368"/>
                <a:gd name="T35" fmla="*/ 954 h 1107"/>
                <a:gd name="T36" fmla="*/ 97 w 368"/>
                <a:gd name="T37" fmla="*/ 925 h 1107"/>
                <a:gd name="T38" fmla="*/ 107 w 368"/>
                <a:gd name="T39" fmla="*/ 885 h 1107"/>
                <a:gd name="T40" fmla="*/ 118 w 368"/>
                <a:gd name="T41" fmla="*/ 856 h 1107"/>
                <a:gd name="T42" fmla="*/ 122 w 368"/>
                <a:gd name="T43" fmla="*/ 846 h 1107"/>
                <a:gd name="T44" fmla="*/ 130 w 368"/>
                <a:gd name="T45" fmla="*/ 826 h 1107"/>
                <a:gd name="T46" fmla="*/ 139 w 368"/>
                <a:gd name="T47" fmla="*/ 819 h 1107"/>
                <a:gd name="T48" fmla="*/ 150 w 368"/>
                <a:gd name="T49" fmla="*/ 817 h 1107"/>
                <a:gd name="T50" fmla="*/ 158 w 368"/>
                <a:gd name="T51" fmla="*/ 819 h 1107"/>
                <a:gd name="T52" fmla="*/ 169 w 368"/>
                <a:gd name="T53" fmla="*/ 838 h 1107"/>
                <a:gd name="T54" fmla="*/ 179 w 368"/>
                <a:gd name="T55" fmla="*/ 853 h 1107"/>
                <a:gd name="T56" fmla="*/ 191 w 368"/>
                <a:gd name="T57" fmla="*/ 881 h 1107"/>
                <a:gd name="T58" fmla="*/ 202 w 368"/>
                <a:gd name="T59" fmla="*/ 904 h 1107"/>
                <a:gd name="T60" fmla="*/ 209 w 368"/>
                <a:gd name="T61" fmla="*/ 913 h 1107"/>
                <a:gd name="T62" fmla="*/ 223 w 368"/>
                <a:gd name="T63" fmla="*/ 937 h 1107"/>
                <a:gd name="T64" fmla="*/ 238 w 368"/>
                <a:gd name="T65" fmla="*/ 967 h 1107"/>
                <a:gd name="T66" fmla="*/ 243 w 368"/>
                <a:gd name="T67" fmla="*/ 973 h 1107"/>
                <a:gd name="T68" fmla="*/ 250 w 368"/>
                <a:gd name="T69" fmla="*/ 974 h 1107"/>
                <a:gd name="T70" fmla="*/ 264 w 368"/>
                <a:gd name="T71" fmla="*/ 969 h 1107"/>
                <a:gd name="T72" fmla="*/ 271 w 368"/>
                <a:gd name="T73" fmla="*/ 965 h 1107"/>
                <a:gd name="T74" fmla="*/ 292 w 368"/>
                <a:gd name="T75" fmla="*/ 942 h 1107"/>
                <a:gd name="T76" fmla="*/ 301 w 368"/>
                <a:gd name="T77" fmla="*/ 932 h 1107"/>
                <a:gd name="T78" fmla="*/ 310 w 368"/>
                <a:gd name="T79" fmla="*/ 916 h 1107"/>
                <a:gd name="T80" fmla="*/ 319 w 368"/>
                <a:gd name="T81" fmla="*/ 888 h 1107"/>
                <a:gd name="T82" fmla="*/ 324 w 368"/>
                <a:gd name="T83" fmla="*/ 867 h 1107"/>
                <a:gd name="T84" fmla="*/ 326 w 368"/>
                <a:gd name="T85" fmla="*/ 862 h 1107"/>
                <a:gd name="T86" fmla="*/ 328 w 368"/>
                <a:gd name="T87" fmla="*/ 848 h 1107"/>
                <a:gd name="T88" fmla="*/ 332 w 368"/>
                <a:gd name="T89" fmla="*/ 824 h 1107"/>
                <a:gd name="T90" fmla="*/ 335 w 368"/>
                <a:gd name="T91" fmla="*/ 799 h 1107"/>
                <a:gd name="T92" fmla="*/ 337 w 368"/>
                <a:gd name="T93" fmla="*/ 769 h 1107"/>
                <a:gd name="T94" fmla="*/ 339 w 368"/>
                <a:gd name="T95" fmla="*/ 734 h 1107"/>
                <a:gd name="T96" fmla="*/ 341 w 368"/>
                <a:gd name="T97" fmla="*/ 688 h 1107"/>
                <a:gd name="T98" fmla="*/ 343 w 368"/>
                <a:gd name="T99" fmla="*/ 630 h 1107"/>
                <a:gd name="T100" fmla="*/ 344 w 368"/>
                <a:gd name="T101" fmla="*/ 559 h 1107"/>
                <a:gd name="T102" fmla="*/ 347 w 368"/>
                <a:gd name="T103" fmla="*/ 466 h 1107"/>
                <a:gd name="T104" fmla="*/ 350 w 368"/>
                <a:gd name="T105" fmla="*/ 295 h 1107"/>
                <a:gd name="T106" fmla="*/ 353 w 368"/>
                <a:gd name="T107" fmla="*/ 190 h 1107"/>
                <a:gd name="T108" fmla="*/ 355 w 368"/>
                <a:gd name="T109" fmla="*/ 106 h 1107"/>
                <a:gd name="T110" fmla="*/ 356 w 368"/>
                <a:gd name="T111" fmla="*/ 69 h 1107"/>
                <a:gd name="T112" fmla="*/ 357 w 368"/>
                <a:gd name="T113" fmla="*/ 35 h 1107"/>
                <a:gd name="T114" fmla="*/ 359 w 368"/>
                <a:gd name="T115" fmla="*/ 12 h 1107"/>
                <a:gd name="T116" fmla="*/ 360 w 368"/>
                <a:gd name="T117" fmla="*/ 2 h 1107"/>
                <a:gd name="T118" fmla="*/ 361 w 368"/>
                <a:gd name="T119" fmla="*/ 2 h 1107"/>
                <a:gd name="T120" fmla="*/ 363 w 368"/>
                <a:gd name="T121" fmla="*/ 12 h 1107"/>
                <a:gd name="T122" fmla="*/ 364 w 368"/>
                <a:gd name="T123" fmla="*/ 34 h 1107"/>
                <a:gd name="T124" fmla="*/ 366 w 368"/>
                <a:gd name="T125" fmla="*/ 68 h 1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368" h="1107">
                  <a:moveTo>
                    <a:pt x="0" y="1107"/>
                  </a:moveTo>
                  <a:lnTo>
                    <a:pt x="1" y="1107"/>
                  </a:lnTo>
                  <a:lnTo>
                    <a:pt x="1" y="1107"/>
                  </a:lnTo>
                  <a:lnTo>
                    <a:pt x="1" y="1107"/>
                  </a:lnTo>
                  <a:lnTo>
                    <a:pt x="1" y="1106"/>
                  </a:lnTo>
                  <a:lnTo>
                    <a:pt x="1" y="1106"/>
                  </a:lnTo>
                  <a:lnTo>
                    <a:pt x="1" y="1106"/>
                  </a:lnTo>
                  <a:lnTo>
                    <a:pt x="1" y="1106"/>
                  </a:lnTo>
                  <a:lnTo>
                    <a:pt x="2" y="1106"/>
                  </a:lnTo>
                  <a:lnTo>
                    <a:pt x="2" y="1106"/>
                  </a:lnTo>
                  <a:lnTo>
                    <a:pt x="2" y="1106"/>
                  </a:lnTo>
                  <a:lnTo>
                    <a:pt x="2" y="1106"/>
                  </a:lnTo>
                  <a:lnTo>
                    <a:pt x="2" y="1106"/>
                  </a:lnTo>
                  <a:lnTo>
                    <a:pt x="2" y="1105"/>
                  </a:lnTo>
                  <a:lnTo>
                    <a:pt x="2" y="1105"/>
                  </a:lnTo>
                  <a:lnTo>
                    <a:pt x="2" y="1105"/>
                  </a:lnTo>
                  <a:lnTo>
                    <a:pt x="3" y="1105"/>
                  </a:lnTo>
                  <a:lnTo>
                    <a:pt x="3" y="1105"/>
                  </a:lnTo>
                  <a:lnTo>
                    <a:pt x="3" y="1105"/>
                  </a:lnTo>
                  <a:lnTo>
                    <a:pt x="3" y="1105"/>
                  </a:lnTo>
                  <a:lnTo>
                    <a:pt x="3" y="1105"/>
                  </a:lnTo>
                  <a:lnTo>
                    <a:pt x="3" y="1105"/>
                  </a:lnTo>
                  <a:lnTo>
                    <a:pt x="3" y="1104"/>
                  </a:lnTo>
                  <a:lnTo>
                    <a:pt x="4" y="1104"/>
                  </a:lnTo>
                  <a:lnTo>
                    <a:pt x="4" y="1103"/>
                  </a:lnTo>
                  <a:lnTo>
                    <a:pt x="5" y="1103"/>
                  </a:lnTo>
                  <a:lnTo>
                    <a:pt x="5" y="1102"/>
                  </a:lnTo>
                  <a:lnTo>
                    <a:pt x="6" y="1102"/>
                  </a:lnTo>
                  <a:lnTo>
                    <a:pt x="6" y="1101"/>
                  </a:lnTo>
                  <a:lnTo>
                    <a:pt x="6" y="1101"/>
                  </a:lnTo>
                  <a:lnTo>
                    <a:pt x="7" y="1100"/>
                  </a:lnTo>
                  <a:lnTo>
                    <a:pt x="7" y="1099"/>
                  </a:lnTo>
                  <a:lnTo>
                    <a:pt x="8" y="1099"/>
                  </a:lnTo>
                  <a:lnTo>
                    <a:pt x="8" y="1098"/>
                  </a:lnTo>
                  <a:lnTo>
                    <a:pt x="9" y="1097"/>
                  </a:lnTo>
                  <a:lnTo>
                    <a:pt x="9" y="1096"/>
                  </a:lnTo>
                  <a:lnTo>
                    <a:pt x="10" y="1096"/>
                  </a:lnTo>
                  <a:lnTo>
                    <a:pt x="10" y="1095"/>
                  </a:lnTo>
                  <a:lnTo>
                    <a:pt x="10" y="1094"/>
                  </a:lnTo>
                  <a:lnTo>
                    <a:pt x="11" y="1093"/>
                  </a:lnTo>
                  <a:lnTo>
                    <a:pt x="11" y="1092"/>
                  </a:lnTo>
                  <a:lnTo>
                    <a:pt x="12" y="1092"/>
                  </a:lnTo>
                  <a:lnTo>
                    <a:pt x="12" y="1091"/>
                  </a:lnTo>
                  <a:lnTo>
                    <a:pt x="13" y="1090"/>
                  </a:lnTo>
                  <a:lnTo>
                    <a:pt x="13" y="1089"/>
                  </a:lnTo>
                  <a:lnTo>
                    <a:pt x="13" y="1088"/>
                  </a:lnTo>
                  <a:lnTo>
                    <a:pt x="14" y="1086"/>
                  </a:lnTo>
                  <a:lnTo>
                    <a:pt x="15" y="1085"/>
                  </a:lnTo>
                  <a:lnTo>
                    <a:pt x="15" y="1083"/>
                  </a:lnTo>
                  <a:lnTo>
                    <a:pt x="16" y="1081"/>
                  </a:lnTo>
                  <a:lnTo>
                    <a:pt x="17" y="1079"/>
                  </a:lnTo>
                  <a:lnTo>
                    <a:pt x="18" y="1077"/>
                  </a:lnTo>
                  <a:lnTo>
                    <a:pt x="19" y="1074"/>
                  </a:lnTo>
                  <a:lnTo>
                    <a:pt x="20" y="1071"/>
                  </a:lnTo>
                  <a:lnTo>
                    <a:pt x="22" y="1067"/>
                  </a:lnTo>
                  <a:lnTo>
                    <a:pt x="23" y="1065"/>
                  </a:lnTo>
                  <a:lnTo>
                    <a:pt x="24" y="1063"/>
                  </a:lnTo>
                  <a:lnTo>
                    <a:pt x="24" y="1061"/>
                  </a:lnTo>
                  <a:lnTo>
                    <a:pt x="25" y="1059"/>
                  </a:lnTo>
                  <a:lnTo>
                    <a:pt x="26" y="1058"/>
                  </a:lnTo>
                  <a:lnTo>
                    <a:pt x="26" y="1056"/>
                  </a:lnTo>
                  <a:lnTo>
                    <a:pt x="27" y="1055"/>
                  </a:lnTo>
                  <a:lnTo>
                    <a:pt x="28" y="1053"/>
                  </a:lnTo>
                  <a:lnTo>
                    <a:pt x="28" y="1052"/>
                  </a:lnTo>
                  <a:lnTo>
                    <a:pt x="29" y="1051"/>
                  </a:lnTo>
                  <a:lnTo>
                    <a:pt x="29" y="1050"/>
                  </a:lnTo>
                  <a:lnTo>
                    <a:pt x="30" y="1049"/>
                  </a:lnTo>
                  <a:lnTo>
                    <a:pt x="30" y="1048"/>
                  </a:lnTo>
                  <a:lnTo>
                    <a:pt x="31" y="1048"/>
                  </a:lnTo>
                  <a:lnTo>
                    <a:pt x="31" y="1048"/>
                  </a:lnTo>
                  <a:lnTo>
                    <a:pt x="31" y="1047"/>
                  </a:lnTo>
                  <a:lnTo>
                    <a:pt x="31" y="1047"/>
                  </a:lnTo>
                  <a:lnTo>
                    <a:pt x="31" y="1046"/>
                  </a:lnTo>
                  <a:lnTo>
                    <a:pt x="32" y="1046"/>
                  </a:lnTo>
                  <a:lnTo>
                    <a:pt x="32" y="1046"/>
                  </a:lnTo>
                  <a:lnTo>
                    <a:pt x="32" y="1046"/>
                  </a:lnTo>
                  <a:lnTo>
                    <a:pt x="32" y="1046"/>
                  </a:lnTo>
                  <a:lnTo>
                    <a:pt x="32" y="1045"/>
                  </a:lnTo>
                  <a:lnTo>
                    <a:pt x="33" y="1044"/>
                  </a:lnTo>
                  <a:lnTo>
                    <a:pt x="34" y="1043"/>
                  </a:lnTo>
                  <a:lnTo>
                    <a:pt x="35" y="1041"/>
                  </a:lnTo>
                  <a:lnTo>
                    <a:pt x="36" y="1040"/>
                  </a:lnTo>
                  <a:lnTo>
                    <a:pt x="38" y="1038"/>
                  </a:lnTo>
                  <a:lnTo>
                    <a:pt x="39" y="1037"/>
                  </a:lnTo>
                  <a:lnTo>
                    <a:pt x="40" y="1036"/>
                  </a:lnTo>
                  <a:lnTo>
                    <a:pt x="42" y="1034"/>
                  </a:lnTo>
                  <a:lnTo>
                    <a:pt x="43" y="1033"/>
                  </a:lnTo>
                  <a:lnTo>
                    <a:pt x="45" y="1031"/>
                  </a:lnTo>
                  <a:lnTo>
                    <a:pt x="47" y="1030"/>
                  </a:lnTo>
                  <a:lnTo>
                    <a:pt x="49" y="1028"/>
                  </a:lnTo>
                  <a:lnTo>
                    <a:pt x="51" y="1027"/>
                  </a:lnTo>
                  <a:lnTo>
                    <a:pt x="52" y="1026"/>
                  </a:lnTo>
                  <a:lnTo>
                    <a:pt x="54" y="1025"/>
                  </a:lnTo>
                  <a:lnTo>
                    <a:pt x="55" y="1024"/>
                  </a:lnTo>
                  <a:lnTo>
                    <a:pt x="56" y="1023"/>
                  </a:lnTo>
                  <a:lnTo>
                    <a:pt x="57" y="1021"/>
                  </a:lnTo>
                  <a:lnTo>
                    <a:pt x="58" y="1020"/>
                  </a:lnTo>
                  <a:lnTo>
                    <a:pt x="58" y="1019"/>
                  </a:lnTo>
                  <a:lnTo>
                    <a:pt x="59" y="1018"/>
                  </a:lnTo>
                  <a:lnTo>
                    <a:pt x="60" y="1018"/>
                  </a:lnTo>
                  <a:lnTo>
                    <a:pt x="60" y="1017"/>
                  </a:lnTo>
                  <a:lnTo>
                    <a:pt x="60" y="1017"/>
                  </a:lnTo>
                  <a:lnTo>
                    <a:pt x="61" y="1016"/>
                  </a:lnTo>
                  <a:lnTo>
                    <a:pt x="61" y="1016"/>
                  </a:lnTo>
                  <a:lnTo>
                    <a:pt x="61" y="1016"/>
                  </a:lnTo>
                  <a:lnTo>
                    <a:pt x="61" y="1015"/>
                  </a:lnTo>
                  <a:lnTo>
                    <a:pt x="61" y="1015"/>
                  </a:lnTo>
                  <a:lnTo>
                    <a:pt x="61" y="1015"/>
                  </a:lnTo>
                  <a:lnTo>
                    <a:pt x="62" y="1014"/>
                  </a:lnTo>
                  <a:lnTo>
                    <a:pt x="63" y="1012"/>
                  </a:lnTo>
                  <a:lnTo>
                    <a:pt x="64" y="1011"/>
                  </a:lnTo>
                  <a:lnTo>
                    <a:pt x="64" y="1008"/>
                  </a:lnTo>
                  <a:lnTo>
                    <a:pt x="66" y="1006"/>
                  </a:lnTo>
                  <a:lnTo>
                    <a:pt x="67" y="1003"/>
                  </a:lnTo>
                  <a:lnTo>
                    <a:pt x="68" y="1000"/>
                  </a:lnTo>
                  <a:lnTo>
                    <a:pt x="70" y="997"/>
                  </a:lnTo>
                  <a:lnTo>
                    <a:pt x="71" y="993"/>
                  </a:lnTo>
                  <a:lnTo>
                    <a:pt x="72" y="991"/>
                  </a:lnTo>
                  <a:lnTo>
                    <a:pt x="73" y="988"/>
                  </a:lnTo>
                  <a:lnTo>
                    <a:pt x="74" y="987"/>
                  </a:lnTo>
                  <a:lnTo>
                    <a:pt x="75" y="985"/>
                  </a:lnTo>
                  <a:lnTo>
                    <a:pt x="76" y="983"/>
                  </a:lnTo>
                  <a:lnTo>
                    <a:pt x="76" y="982"/>
                  </a:lnTo>
                  <a:lnTo>
                    <a:pt x="77" y="980"/>
                  </a:lnTo>
                  <a:lnTo>
                    <a:pt x="78" y="979"/>
                  </a:lnTo>
                  <a:lnTo>
                    <a:pt x="80" y="977"/>
                  </a:lnTo>
                  <a:lnTo>
                    <a:pt x="81" y="975"/>
                  </a:lnTo>
                  <a:lnTo>
                    <a:pt x="82" y="973"/>
                  </a:lnTo>
                  <a:lnTo>
                    <a:pt x="83" y="972"/>
                  </a:lnTo>
                  <a:lnTo>
                    <a:pt x="83" y="971"/>
                  </a:lnTo>
                  <a:lnTo>
                    <a:pt x="84" y="970"/>
                  </a:lnTo>
                  <a:lnTo>
                    <a:pt x="85" y="968"/>
                  </a:lnTo>
                  <a:lnTo>
                    <a:pt x="85" y="967"/>
                  </a:lnTo>
                  <a:lnTo>
                    <a:pt x="86" y="966"/>
                  </a:lnTo>
                  <a:lnTo>
                    <a:pt x="87" y="964"/>
                  </a:lnTo>
                  <a:lnTo>
                    <a:pt x="87" y="962"/>
                  </a:lnTo>
                  <a:lnTo>
                    <a:pt x="88" y="960"/>
                  </a:lnTo>
                  <a:lnTo>
                    <a:pt x="89" y="958"/>
                  </a:lnTo>
                  <a:lnTo>
                    <a:pt x="89" y="957"/>
                  </a:lnTo>
                  <a:lnTo>
                    <a:pt x="89" y="956"/>
                  </a:lnTo>
                  <a:lnTo>
                    <a:pt x="90" y="955"/>
                  </a:lnTo>
                  <a:lnTo>
                    <a:pt x="90" y="955"/>
                  </a:lnTo>
                  <a:lnTo>
                    <a:pt x="90" y="954"/>
                  </a:lnTo>
                  <a:lnTo>
                    <a:pt x="90" y="954"/>
                  </a:lnTo>
                  <a:lnTo>
                    <a:pt x="90" y="953"/>
                  </a:lnTo>
                  <a:lnTo>
                    <a:pt x="90" y="953"/>
                  </a:lnTo>
                  <a:lnTo>
                    <a:pt x="91" y="951"/>
                  </a:lnTo>
                  <a:lnTo>
                    <a:pt x="92" y="947"/>
                  </a:lnTo>
                  <a:lnTo>
                    <a:pt x="93" y="943"/>
                  </a:lnTo>
                  <a:lnTo>
                    <a:pt x="94" y="938"/>
                  </a:lnTo>
                  <a:lnTo>
                    <a:pt x="95" y="933"/>
                  </a:lnTo>
                  <a:lnTo>
                    <a:pt x="97" y="925"/>
                  </a:lnTo>
                  <a:lnTo>
                    <a:pt x="99" y="917"/>
                  </a:lnTo>
                  <a:lnTo>
                    <a:pt x="100" y="911"/>
                  </a:lnTo>
                  <a:lnTo>
                    <a:pt x="102" y="905"/>
                  </a:lnTo>
                  <a:lnTo>
                    <a:pt x="103" y="901"/>
                  </a:lnTo>
                  <a:lnTo>
                    <a:pt x="104" y="896"/>
                  </a:lnTo>
                  <a:lnTo>
                    <a:pt x="105" y="892"/>
                  </a:lnTo>
                  <a:lnTo>
                    <a:pt x="106" y="889"/>
                  </a:lnTo>
                  <a:lnTo>
                    <a:pt x="107" y="885"/>
                  </a:lnTo>
                  <a:lnTo>
                    <a:pt x="109" y="881"/>
                  </a:lnTo>
                  <a:lnTo>
                    <a:pt x="110" y="878"/>
                  </a:lnTo>
                  <a:lnTo>
                    <a:pt x="111" y="875"/>
                  </a:lnTo>
                  <a:lnTo>
                    <a:pt x="112" y="871"/>
                  </a:lnTo>
                  <a:lnTo>
                    <a:pt x="114" y="867"/>
                  </a:lnTo>
                  <a:lnTo>
                    <a:pt x="116" y="862"/>
                  </a:lnTo>
                  <a:lnTo>
                    <a:pt x="118" y="858"/>
                  </a:lnTo>
                  <a:lnTo>
                    <a:pt x="118" y="856"/>
                  </a:lnTo>
                  <a:lnTo>
                    <a:pt x="119" y="855"/>
                  </a:lnTo>
                  <a:lnTo>
                    <a:pt x="119" y="855"/>
                  </a:lnTo>
                  <a:lnTo>
                    <a:pt x="119" y="854"/>
                  </a:lnTo>
                  <a:lnTo>
                    <a:pt x="119" y="853"/>
                  </a:lnTo>
                  <a:lnTo>
                    <a:pt x="119" y="853"/>
                  </a:lnTo>
                  <a:lnTo>
                    <a:pt x="120" y="852"/>
                  </a:lnTo>
                  <a:lnTo>
                    <a:pt x="120" y="850"/>
                  </a:lnTo>
                  <a:lnTo>
                    <a:pt x="122" y="846"/>
                  </a:lnTo>
                  <a:lnTo>
                    <a:pt x="123" y="842"/>
                  </a:lnTo>
                  <a:lnTo>
                    <a:pt x="124" y="839"/>
                  </a:lnTo>
                  <a:lnTo>
                    <a:pt x="125" y="836"/>
                  </a:lnTo>
                  <a:lnTo>
                    <a:pt x="126" y="834"/>
                  </a:lnTo>
                  <a:lnTo>
                    <a:pt x="127" y="832"/>
                  </a:lnTo>
                  <a:lnTo>
                    <a:pt x="128" y="830"/>
                  </a:lnTo>
                  <a:lnTo>
                    <a:pt x="129" y="828"/>
                  </a:lnTo>
                  <a:lnTo>
                    <a:pt x="130" y="826"/>
                  </a:lnTo>
                  <a:lnTo>
                    <a:pt x="131" y="825"/>
                  </a:lnTo>
                  <a:lnTo>
                    <a:pt x="132" y="824"/>
                  </a:lnTo>
                  <a:lnTo>
                    <a:pt x="133" y="822"/>
                  </a:lnTo>
                  <a:lnTo>
                    <a:pt x="134" y="822"/>
                  </a:lnTo>
                  <a:lnTo>
                    <a:pt x="135" y="821"/>
                  </a:lnTo>
                  <a:lnTo>
                    <a:pt x="136" y="820"/>
                  </a:lnTo>
                  <a:lnTo>
                    <a:pt x="138" y="819"/>
                  </a:lnTo>
                  <a:lnTo>
                    <a:pt x="139" y="819"/>
                  </a:lnTo>
                  <a:lnTo>
                    <a:pt x="141" y="818"/>
                  </a:lnTo>
                  <a:lnTo>
                    <a:pt x="142" y="818"/>
                  </a:lnTo>
                  <a:lnTo>
                    <a:pt x="144" y="817"/>
                  </a:lnTo>
                  <a:lnTo>
                    <a:pt x="146" y="817"/>
                  </a:lnTo>
                  <a:lnTo>
                    <a:pt x="148" y="817"/>
                  </a:lnTo>
                  <a:lnTo>
                    <a:pt x="148" y="817"/>
                  </a:lnTo>
                  <a:lnTo>
                    <a:pt x="149" y="817"/>
                  </a:lnTo>
                  <a:lnTo>
                    <a:pt x="150" y="817"/>
                  </a:lnTo>
                  <a:lnTo>
                    <a:pt x="150" y="817"/>
                  </a:lnTo>
                  <a:lnTo>
                    <a:pt x="151" y="817"/>
                  </a:lnTo>
                  <a:lnTo>
                    <a:pt x="153" y="817"/>
                  </a:lnTo>
                  <a:lnTo>
                    <a:pt x="154" y="817"/>
                  </a:lnTo>
                  <a:lnTo>
                    <a:pt x="155" y="817"/>
                  </a:lnTo>
                  <a:lnTo>
                    <a:pt x="156" y="818"/>
                  </a:lnTo>
                  <a:lnTo>
                    <a:pt x="157" y="818"/>
                  </a:lnTo>
                  <a:lnTo>
                    <a:pt x="158" y="819"/>
                  </a:lnTo>
                  <a:lnTo>
                    <a:pt x="158" y="820"/>
                  </a:lnTo>
                  <a:lnTo>
                    <a:pt x="159" y="821"/>
                  </a:lnTo>
                  <a:lnTo>
                    <a:pt x="160" y="823"/>
                  </a:lnTo>
                  <a:lnTo>
                    <a:pt x="162" y="825"/>
                  </a:lnTo>
                  <a:lnTo>
                    <a:pt x="163" y="827"/>
                  </a:lnTo>
                  <a:lnTo>
                    <a:pt x="165" y="831"/>
                  </a:lnTo>
                  <a:lnTo>
                    <a:pt x="167" y="835"/>
                  </a:lnTo>
                  <a:lnTo>
                    <a:pt x="169" y="838"/>
                  </a:lnTo>
                  <a:lnTo>
                    <a:pt x="171" y="841"/>
                  </a:lnTo>
                  <a:lnTo>
                    <a:pt x="174" y="845"/>
                  </a:lnTo>
                  <a:lnTo>
                    <a:pt x="176" y="847"/>
                  </a:lnTo>
                  <a:lnTo>
                    <a:pt x="177" y="849"/>
                  </a:lnTo>
                  <a:lnTo>
                    <a:pt x="177" y="850"/>
                  </a:lnTo>
                  <a:lnTo>
                    <a:pt x="178" y="852"/>
                  </a:lnTo>
                  <a:lnTo>
                    <a:pt x="178" y="852"/>
                  </a:lnTo>
                  <a:lnTo>
                    <a:pt x="179" y="853"/>
                  </a:lnTo>
                  <a:lnTo>
                    <a:pt x="179" y="854"/>
                  </a:lnTo>
                  <a:lnTo>
                    <a:pt x="180" y="855"/>
                  </a:lnTo>
                  <a:lnTo>
                    <a:pt x="180" y="856"/>
                  </a:lnTo>
                  <a:lnTo>
                    <a:pt x="182" y="860"/>
                  </a:lnTo>
                  <a:lnTo>
                    <a:pt x="184" y="864"/>
                  </a:lnTo>
                  <a:lnTo>
                    <a:pt x="186" y="869"/>
                  </a:lnTo>
                  <a:lnTo>
                    <a:pt x="188" y="875"/>
                  </a:lnTo>
                  <a:lnTo>
                    <a:pt x="191" y="881"/>
                  </a:lnTo>
                  <a:lnTo>
                    <a:pt x="193" y="885"/>
                  </a:lnTo>
                  <a:lnTo>
                    <a:pt x="194" y="889"/>
                  </a:lnTo>
                  <a:lnTo>
                    <a:pt x="196" y="892"/>
                  </a:lnTo>
                  <a:lnTo>
                    <a:pt x="197" y="895"/>
                  </a:lnTo>
                  <a:lnTo>
                    <a:pt x="198" y="897"/>
                  </a:lnTo>
                  <a:lnTo>
                    <a:pt x="199" y="900"/>
                  </a:lnTo>
                  <a:lnTo>
                    <a:pt x="201" y="902"/>
                  </a:lnTo>
                  <a:lnTo>
                    <a:pt x="202" y="904"/>
                  </a:lnTo>
                  <a:lnTo>
                    <a:pt x="204" y="906"/>
                  </a:lnTo>
                  <a:lnTo>
                    <a:pt x="206" y="908"/>
                  </a:lnTo>
                  <a:lnTo>
                    <a:pt x="207" y="909"/>
                  </a:lnTo>
                  <a:lnTo>
                    <a:pt x="207" y="910"/>
                  </a:lnTo>
                  <a:lnTo>
                    <a:pt x="208" y="911"/>
                  </a:lnTo>
                  <a:lnTo>
                    <a:pt x="209" y="912"/>
                  </a:lnTo>
                  <a:lnTo>
                    <a:pt x="209" y="912"/>
                  </a:lnTo>
                  <a:lnTo>
                    <a:pt x="209" y="913"/>
                  </a:lnTo>
                  <a:lnTo>
                    <a:pt x="210" y="914"/>
                  </a:lnTo>
                  <a:lnTo>
                    <a:pt x="212" y="916"/>
                  </a:lnTo>
                  <a:lnTo>
                    <a:pt x="213" y="918"/>
                  </a:lnTo>
                  <a:lnTo>
                    <a:pt x="215" y="921"/>
                  </a:lnTo>
                  <a:lnTo>
                    <a:pt x="216" y="923"/>
                  </a:lnTo>
                  <a:lnTo>
                    <a:pt x="218" y="927"/>
                  </a:lnTo>
                  <a:lnTo>
                    <a:pt x="220" y="931"/>
                  </a:lnTo>
                  <a:lnTo>
                    <a:pt x="223" y="937"/>
                  </a:lnTo>
                  <a:lnTo>
                    <a:pt x="227" y="945"/>
                  </a:lnTo>
                  <a:lnTo>
                    <a:pt x="230" y="951"/>
                  </a:lnTo>
                  <a:lnTo>
                    <a:pt x="232" y="956"/>
                  </a:lnTo>
                  <a:lnTo>
                    <a:pt x="234" y="960"/>
                  </a:lnTo>
                  <a:lnTo>
                    <a:pt x="236" y="962"/>
                  </a:lnTo>
                  <a:lnTo>
                    <a:pt x="237" y="965"/>
                  </a:lnTo>
                  <a:lnTo>
                    <a:pt x="238" y="966"/>
                  </a:lnTo>
                  <a:lnTo>
                    <a:pt x="238" y="967"/>
                  </a:lnTo>
                  <a:lnTo>
                    <a:pt x="239" y="968"/>
                  </a:lnTo>
                  <a:lnTo>
                    <a:pt x="239" y="968"/>
                  </a:lnTo>
                  <a:lnTo>
                    <a:pt x="240" y="969"/>
                  </a:lnTo>
                  <a:lnTo>
                    <a:pt x="241" y="970"/>
                  </a:lnTo>
                  <a:lnTo>
                    <a:pt x="241" y="971"/>
                  </a:lnTo>
                  <a:lnTo>
                    <a:pt x="242" y="972"/>
                  </a:lnTo>
                  <a:lnTo>
                    <a:pt x="243" y="972"/>
                  </a:lnTo>
                  <a:lnTo>
                    <a:pt x="243" y="973"/>
                  </a:lnTo>
                  <a:lnTo>
                    <a:pt x="244" y="973"/>
                  </a:lnTo>
                  <a:lnTo>
                    <a:pt x="245" y="974"/>
                  </a:lnTo>
                  <a:lnTo>
                    <a:pt x="246" y="974"/>
                  </a:lnTo>
                  <a:lnTo>
                    <a:pt x="247" y="974"/>
                  </a:lnTo>
                  <a:lnTo>
                    <a:pt x="247" y="974"/>
                  </a:lnTo>
                  <a:lnTo>
                    <a:pt x="248" y="974"/>
                  </a:lnTo>
                  <a:lnTo>
                    <a:pt x="249" y="974"/>
                  </a:lnTo>
                  <a:lnTo>
                    <a:pt x="250" y="974"/>
                  </a:lnTo>
                  <a:lnTo>
                    <a:pt x="251" y="974"/>
                  </a:lnTo>
                  <a:lnTo>
                    <a:pt x="252" y="973"/>
                  </a:lnTo>
                  <a:lnTo>
                    <a:pt x="254" y="973"/>
                  </a:lnTo>
                  <a:lnTo>
                    <a:pt x="256" y="972"/>
                  </a:lnTo>
                  <a:lnTo>
                    <a:pt x="258" y="971"/>
                  </a:lnTo>
                  <a:lnTo>
                    <a:pt x="260" y="970"/>
                  </a:lnTo>
                  <a:lnTo>
                    <a:pt x="262" y="970"/>
                  </a:lnTo>
                  <a:lnTo>
                    <a:pt x="264" y="969"/>
                  </a:lnTo>
                  <a:lnTo>
                    <a:pt x="265" y="969"/>
                  </a:lnTo>
                  <a:lnTo>
                    <a:pt x="266" y="968"/>
                  </a:lnTo>
                  <a:lnTo>
                    <a:pt x="267" y="968"/>
                  </a:lnTo>
                  <a:lnTo>
                    <a:pt x="267" y="967"/>
                  </a:lnTo>
                  <a:lnTo>
                    <a:pt x="268" y="967"/>
                  </a:lnTo>
                  <a:lnTo>
                    <a:pt x="268" y="967"/>
                  </a:lnTo>
                  <a:lnTo>
                    <a:pt x="269" y="966"/>
                  </a:lnTo>
                  <a:lnTo>
                    <a:pt x="271" y="965"/>
                  </a:lnTo>
                  <a:lnTo>
                    <a:pt x="273" y="963"/>
                  </a:lnTo>
                  <a:lnTo>
                    <a:pt x="276" y="960"/>
                  </a:lnTo>
                  <a:lnTo>
                    <a:pt x="279" y="958"/>
                  </a:lnTo>
                  <a:lnTo>
                    <a:pt x="281" y="956"/>
                  </a:lnTo>
                  <a:lnTo>
                    <a:pt x="283" y="953"/>
                  </a:lnTo>
                  <a:lnTo>
                    <a:pt x="285" y="951"/>
                  </a:lnTo>
                  <a:lnTo>
                    <a:pt x="289" y="947"/>
                  </a:lnTo>
                  <a:lnTo>
                    <a:pt x="292" y="942"/>
                  </a:lnTo>
                  <a:lnTo>
                    <a:pt x="295" y="939"/>
                  </a:lnTo>
                  <a:lnTo>
                    <a:pt x="296" y="938"/>
                  </a:lnTo>
                  <a:lnTo>
                    <a:pt x="296" y="938"/>
                  </a:lnTo>
                  <a:lnTo>
                    <a:pt x="297" y="937"/>
                  </a:lnTo>
                  <a:lnTo>
                    <a:pt x="297" y="936"/>
                  </a:lnTo>
                  <a:lnTo>
                    <a:pt x="298" y="936"/>
                  </a:lnTo>
                  <a:lnTo>
                    <a:pt x="299" y="935"/>
                  </a:lnTo>
                  <a:lnTo>
                    <a:pt x="301" y="932"/>
                  </a:lnTo>
                  <a:lnTo>
                    <a:pt x="302" y="930"/>
                  </a:lnTo>
                  <a:lnTo>
                    <a:pt x="304" y="928"/>
                  </a:lnTo>
                  <a:lnTo>
                    <a:pt x="305" y="926"/>
                  </a:lnTo>
                  <a:lnTo>
                    <a:pt x="306" y="925"/>
                  </a:lnTo>
                  <a:lnTo>
                    <a:pt x="307" y="923"/>
                  </a:lnTo>
                  <a:lnTo>
                    <a:pt x="308" y="920"/>
                  </a:lnTo>
                  <a:lnTo>
                    <a:pt x="309" y="918"/>
                  </a:lnTo>
                  <a:lnTo>
                    <a:pt x="310" y="916"/>
                  </a:lnTo>
                  <a:lnTo>
                    <a:pt x="311" y="913"/>
                  </a:lnTo>
                  <a:lnTo>
                    <a:pt x="312" y="910"/>
                  </a:lnTo>
                  <a:lnTo>
                    <a:pt x="314" y="907"/>
                  </a:lnTo>
                  <a:lnTo>
                    <a:pt x="315" y="904"/>
                  </a:lnTo>
                  <a:lnTo>
                    <a:pt x="316" y="900"/>
                  </a:lnTo>
                  <a:lnTo>
                    <a:pt x="317" y="896"/>
                  </a:lnTo>
                  <a:lnTo>
                    <a:pt x="318" y="892"/>
                  </a:lnTo>
                  <a:lnTo>
                    <a:pt x="319" y="888"/>
                  </a:lnTo>
                  <a:lnTo>
                    <a:pt x="320" y="884"/>
                  </a:lnTo>
                  <a:lnTo>
                    <a:pt x="322" y="879"/>
                  </a:lnTo>
                  <a:lnTo>
                    <a:pt x="323" y="875"/>
                  </a:lnTo>
                  <a:lnTo>
                    <a:pt x="323" y="871"/>
                  </a:lnTo>
                  <a:lnTo>
                    <a:pt x="324" y="870"/>
                  </a:lnTo>
                  <a:lnTo>
                    <a:pt x="324" y="869"/>
                  </a:lnTo>
                  <a:lnTo>
                    <a:pt x="324" y="868"/>
                  </a:lnTo>
                  <a:lnTo>
                    <a:pt x="324" y="867"/>
                  </a:lnTo>
                  <a:lnTo>
                    <a:pt x="325" y="866"/>
                  </a:lnTo>
                  <a:lnTo>
                    <a:pt x="325" y="866"/>
                  </a:lnTo>
                  <a:lnTo>
                    <a:pt x="325" y="865"/>
                  </a:lnTo>
                  <a:lnTo>
                    <a:pt x="325" y="864"/>
                  </a:lnTo>
                  <a:lnTo>
                    <a:pt x="325" y="864"/>
                  </a:lnTo>
                  <a:lnTo>
                    <a:pt x="325" y="863"/>
                  </a:lnTo>
                  <a:lnTo>
                    <a:pt x="325" y="863"/>
                  </a:lnTo>
                  <a:lnTo>
                    <a:pt x="326" y="862"/>
                  </a:lnTo>
                  <a:lnTo>
                    <a:pt x="326" y="862"/>
                  </a:lnTo>
                  <a:lnTo>
                    <a:pt x="326" y="861"/>
                  </a:lnTo>
                  <a:lnTo>
                    <a:pt x="326" y="861"/>
                  </a:lnTo>
                  <a:lnTo>
                    <a:pt x="326" y="860"/>
                  </a:lnTo>
                  <a:lnTo>
                    <a:pt x="326" y="858"/>
                  </a:lnTo>
                  <a:lnTo>
                    <a:pt x="327" y="855"/>
                  </a:lnTo>
                  <a:lnTo>
                    <a:pt x="328" y="852"/>
                  </a:lnTo>
                  <a:lnTo>
                    <a:pt x="328" y="848"/>
                  </a:lnTo>
                  <a:lnTo>
                    <a:pt x="329" y="845"/>
                  </a:lnTo>
                  <a:lnTo>
                    <a:pt x="330" y="842"/>
                  </a:lnTo>
                  <a:lnTo>
                    <a:pt x="330" y="839"/>
                  </a:lnTo>
                  <a:lnTo>
                    <a:pt x="330" y="836"/>
                  </a:lnTo>
                  <a:lnTo>
                    <a:pt x="331" y="833"/>
                  </a:lnTo>
                  <a:lnTo>
                    <a:pt x="331" y="830"/>
                  </a:lnTo>
                  <a:lnTo>
                    <a:pt x="332" y="827"/>
                  </a:lnTo>
                  <a:lnTo>
                    <a:pt x="332" y="824"/>
                  </a:lnTo>
                  <a:lnTo>
                    <a:pt x="333" y="821"/>
                  </a:lnTo>
                  <a:lnTo>
                    <a:pt x="333" y="818"/>
                  </a:lnTo>
                  <a:lnTo>
                    <a:pt x="333" y="815"/>
                  </a:lnTo>
                  <a:lnTo>
                    <a:pt x="334" y="812"/>
                  </a:lnTo>
                  <a:lnTo>
                    <a:pt x="334" y="809"/>
                  </a:lnTo>
                  <a:lnTo>
                    <a:pt x="334" y="806"/>
                  </a:lnTo>
                  <a:lnTo>
                    <a:pt x="335" y="802"/>
                  </a:lnTo>
                  <a:lnTo>
                    <a:pt x="335" y="799"/>
                  </a:lnTo>
                  <a:lnTo>
                    <a:pt x="335" y="796"/>
                  </a:lnTo>
                  <a:lnTo>
                    <a:pt x="335" y="792"/>
                  </a:lnTo>
                  <a:lnTo>
                    <a:pt x="336" y="789"/>
                  </a:lnTo>
                  <a:lnTo>
                    <a:pt x="336" y="785"/>
                  </a:lnTo>
                  <a:lnTo>
                    <a:pt x="336" y="781"/>
                  </a:lnTo>
                  <a:lnTo>
                    <a:pt x="336" y="777"/>
                  </a:lnTo>
                  <a:lnTo>
                    <a:pt x="337" y="774"/>
                  </a:lnTo>
                  <a:lnTo>
                    <a:pt x="337" y="769"/>
                  </a:lnTo>
                  <a:lnTo>
                    <a:pt x="337" y="765"/>
                  </a:lnTo>
                  <a:lnTo>
                    <a:pt x="338" y="761"/>
                  </a:lnTo>
                  <a:lnTo>
                    <a:pt x="338" y="757"/>
                  </a:lnTo>
                  <a:lnTo>
                    <a:pt x="338" y="752"/>
                  </a:lnTo>
                  <a:lnTo>
                    <a:pt x="338" y="748"/>
                  </a:lnTo>
                  <a:lnTo>
                    <a:pt x="338" y="743"/>
                  </a:lnTo>
                  <a:lnTo>
                    <a:pt x="339" y="739"/>
                  </a:lnTo>
                  <a:lnTo>
                    <a:pt x="339" y="734"/>
                  </a:lnTo>
                  <a:lnTo>
                    <a:pt x="339" y="728"/>
                  </a:lnTo>
                  <a:lnTo>
                    <a:pt x="339" y="723"/>
                  </a:lnTo>
                  <a:lnTo>
                    <a:pt x="339" y="718"/>
                  </a:lnTo>
                  <a:lnTo>
                    <a:pt x="340" y="712"/>
                  </a:lnTo>
                  <a:lnTo>
                    <a:pt x="340" y="706"/>
                  </a:lnTo>
                  <a:lnTo>
                    <a:pt x="340" y="700"/>
                  </a:lnTo>
                  <a:lnTo>
                    <a:pt x="340" y="694"/>
                  </a:lnTo>
                  <a:lnTo>
                    <a:pt x="341" y="688"/>
                  </a:lnTo>
                  <a:lnTo>
                    <a:pt x="341" y="681"/>
                  </a:lnTo>
                  <a:lnTo>
                    <a:pt x="341" y="674"/>
                  </a:lnTo>
                  <a:lnTo>
                    <a:pt x="341" y="667"/>
                  </a:lnTo>
                  <a:lnTo>
                    <a:pt x="342" y="660"/>
                  </a:lnTo>
                  <a:lnTo>
                    <a:pt x="342" y="653"/>
                  </a:lnTo>
                  <a:lnTo>
                    <a:pt x="342" y="646"/>
                  </a:lnTo>
                  <a:lnTo>
                    <a:pt x="342" y="638"/>
                  </a:lnTo>
                  <a:lnTo>
                    <a:pt x="343" y="630"/>
                  </a:lnTo>
                  <a:lnTo>
                    <a:pt x="343" y="622"/>
                  </a:lnTo>
                  <a:lnTo>
                    <a:pt x="343" y="614"/>
                  </a:lnTo>
                  <a:lnTo>
                    <a:pt x="343" y="606"/>
                  </a:lnTo>
                  <a:lnTo>
                    <a:pt x="343" y="597"/>
                  </a:lnTo>
                  <a:lnTo>
                    <a:pt x="344" y="589"/>
                  </a:lnTo>
                  <a:lnTo>
                    <a:pt x="344" y="580"/>
                  </a:lnTo>
                  <a:lnTo>
                    <a:pt x="344" y="570"/>
                  </a:lnTo>
                  <a:lnTo>
                    <a:pt x="344" y="559"/>
                  </a:lnTo>
                  <a:lnTo>
                    <a:pt x="345" y="549"/>
                  </a:lnTo>
                  <a:lnTo>
                    <a:pt x="345" y="538"/>
                  </a:lnTo>
                  <a:lnTo>
                    <a:pt x="345" y="528"/>
                  </a:lnTo>
                  <a:lnTo>
                    <a:pt x="345" y="516"/>
                  </a:lnTo>
                  <a:lnTo>
                    <a:pt x="346" y="504"/>
                  </a:lnTo>
                  <a:lnTo>
                    <a:pt x="346" y="492"/>
                  </a:lnTo>
                  <a:lnTo>
                    <a:pt x="346" y="479"/>
                  </a:lnTo>
                  <a:lnTo>
                    <a:pt x="347" y="466"/>
                  </a:lnTo>
                  <a:lnTo>
                    <a:pt x="347" y="451"/>
                  </a:lnTo>
                  <a:lnTo>
                    <a:pt x="347" y="435"/>
                  </a:lnTo>
                  <a:lnTo>
                    <a:pt x="348" y="417"/>
                  </a:lnTo>
                  <a:lnTo>
                    <a:pt x="348" y="397"/>
                  </a:lnTo>
                  <a:lnTo>
                    <a:pt x="349" y="372"/>
                  </a:lnTo>
                  <a:lnTo>
                    <a:pt x="349" y="342"/>
                  </a:lnTo>
                  <a:lnTo>
                    <a:pt x="350" y="316"/>
                  </a:lnTo>
                  <a:lnTo>
                    <a:pt x="350" y="295"/>
                  </a:lnTo>
                  <a:lnTo>
                    <a:pt x="351" y="277"/>
                  </a:lnTo>
                  <a:lnTo>
                    <a:pt x="351" y="262"/>
                  </a:lnTo>
                  <a:lnTo>
                    <a:pt x="351" y="249"/>
                  </a:lnTo>
                  <a:lnTo>
                    <a:pt x="352" y="236"/>
                  </a:lnTo>
                  <a:lnTo>
                    <a:pt x="352" y="223"/>
                  </a:lnTo>
                  <a:lnTo>
                    <a:pt x="352" y="212"/>
                  </a:lnTo>
                  <a:lnTo>
                    <a:pt x="352" y="201"/>
                  </a:lnTo>
                  <a:lnTo>
                    <a:pt x="353" y="190"/>
                  </a:lnTo>
                  <a:lnTo>
                    <a:pt x="353" y="181"/>
                  </a:lnTo>
                  <a:lnTo>
                    <a:pt x="353" y="165"/>
                  </a:lnTo>
                  <a:lnTo>
                    <a:pt x="354" y="145"/>
                  </a:lnTo>
                  <a:lnTo>
                    <a:pt x="354" y="130"/>
                  </a:lnTo>
                  <a:lnTo>
                    <a:pt x="354" y="122"/>
                  </a:lnTo>
                  <a:lnTo>
                    <a:pt x="354" y="116"/>
                  </a:lnTo>
                  <a:lnTo>
                    <a:pt x="355" y="111"/>
                  </a:lnTo>
                  <a:lnTo>
                    <a:pt x="355" y="106"/>
                  </a:lnTo>
                  <a:lnTo>
                    <a:pt x="355" y="103"/>
                  </a:lnTo>
                  <a:lnTo>
                    <a:pt x="355" y="100"/>
                  </a:lnTo>
                  <a:lnTo>
                    <a:pt x="355" y="95"/>
                  </a:lnTo>
                  <a:lnTo>
                    <a:pt x="355" y="90"/>
                  </a:lnTo>
                  <a:lnTo>
                    <a:pt x="355" y="84"/>
                  </a:lnTo>
                  <a:lnTo>
                    <a:pt x="356" y="79"/>
                  </a:lnTo>
                  <a:lnTo>
                    <a:pt x="356" y="74"/>
                  </a:lnTo>
                  <a:lnTo>
                    <a:pt x="356" y="69"/>
                  </a:lnTo>
                  <a:lnTo>
                    <a:pt x="356" y="64"/>
                  </a:lnTo>
                  <a:lnTo>
                    <a:pt x="356" y="59"/>
                  </a:lnTo>
                  <a:lnTo>
                    <a:pt x="356" y="55"/>
                  </a:lnTo>
                  <a:lnTo>
                    <a:pt x="357" y="50"/>
                  </a:lnTo>
                  <a:lnTo>
                    <a:pt x="357" y="46"/>
                  </a:lnTo>
                  <a:lnTo>
                    <a:pt x="357" y="42"/>
                  </a:lnTo>
                  <a:lnTo>
                    <a:pt x="357" y="39"/>
                  </a:lnTo>
                  <a:lnTo>
                    <a:pt x="357" y="35"/>
                  </a:lnTo>
                  <a:lnTo>
                    <a:pt x="358" y="32"/>
                  </a:lnTo>
                  <a:lnTo>
                    <a:pt x="358" y="28"/>
                  </a:lnTo>
                  <a:lnTo>
                    <a:pt x="358" y="25"/>
                  </a:lnTo>
                  <a:lnTo>
                    <a:pt x="358" y="22"/>
                  </a:lnTo>
                  <a:lnTo>
                    <a:pt x="358" y="20"/>
                  </a:lnTo>
                  <a:lnTo>
                    <a:pt x="358" y="17"/>
                  </a:lnTo>
                  <a:lnTo>
                    <a:pt x="359" y="15"/>
                  </a:lnTo>
                  <a:lnTo>
                    <a:pt x="359" y="12"/>
                  </a:lnTo>
                  <a:lnTo>
                    <a:pt x="359" y="10"/>
                  </a:lnTo>
                  <a:lnTo>
                    <a:pt x="359" y="9"/>
                  </a:lnTo>
                  <a:lnTo>
                    <a:pt x="359" y="7"/>
                  </a:lnTo>
                  <a:lnTo>
                    <a:pt x="359" y="6"/>
                  </a:lnTo>
                  <a:lnTo>
                    <a:pt x="360" y="4"/>
                  </a:lnTo>
                  <a:lnTo>
                    <a:pt x="360" y="3"/>
                  </a:lnTo>
                  <a:lnTo>
                    <a:pt x="360" y="2"/>
                  </a:lnTo>
                  <a:lnTo>
                    <a:pt x="360" y="2"/>
                  </a:lnTo>
                  <a:lnTo>
                    <a:pt x="360" y="1"/>
                  </a:lnTo>
                  <a:lnTo>
                    <a:pt x="360" y="1"/>
                  </a:lnTo>
                  <a:lnTo>
                    <a:pt x="361" y="0"/>
                  </a:lnTo>
                  <a:lnTo>
                    <a:pt x="361" y="0"/>
                  </a:lnTo>
                  <a:lnTo>
                    <a:pt x="361" y="0"/>
                  </a:lnTo>
                  <a:lnTo>
                    <a:pt x="361" y="1"/>
                  </a:lnTo>
                  <a:lnTo>
                    <a:pt x="361" y="1"/>
                  </a:lnTo>
                  <a:lnTo>
                    <a:pt x="361" y="2"/>
                  </a:lnTo>
                  <a:lnTo>
                    <a:pt x="362" y="2"/>
                  </a:lnTo>
                  <a:lnTo>
                    <a:pt x="362" y="3"/>
                  </a:lnTo>
                  <a:lnTo>
                    <a:pt x="362" y="5"/>
                  </a:lnTo>
                  <a:lnTo>
                    <a:pt x="362" y="6"/>
                  </a:lnTo>
                  <a:lnTo>
                    <a:pt x="362" y="7"/>
                  </a:lnTo>
                  <a:lnTo>
                    <a:pt x="362" y="9"/>
                  </a:lnTo>
                  <a:lnTo>
                    <a:pt x="363" y="10"/>
                  </a:lnTo>
                  <a:lnTo>
                    <a:pt x="363" y="12"/>
                  </a:lnTo>
                  <a:lnTo>
                    <a:pt x="363" y="14"/>
                  </a:lnTo>
                  <a:lnTo>
                    <a:pt x="363" y="16"/>
                  </a:lnTo>
                  <a:lnTo>
                    <a:pt x="363" y="18"/>
                  </a:lnTo>
                  <a:lnTo>
                    <a:pt x="364" y="21"/>
                  </a:lnTo>
                  <a:lnTo>
                    <a:pt x="364" y="24"/>
                  </a:lnTo>
                  <a:lnTo>
                    <a:pt x="364" y="27"/>
                  </a:lnTo>
                  <a:lnTo>
                    <a:pt x="364" y="30"/>
                  </a:lnTo>
                  <a:lnTo>
                    <a:pt x="364" y="34"/>
                  </a:lnTo>
                  <a:lnTo>
                    <a:pt x="365" y="37"/>
                  </a:lnTo>
                  <a:lnTo>
                    <a:pt x="365" y="41"/>
                  </a:lnTo>
                  <a:lnTo>
                    <a:pt x="365" y="45"/>
                  </a:lnTo>
                  <a:lnTo>
                    <a:pt x="365" y="49"/>
                  </a:lnTo>
                  <a:lnTo>
                    <a:pt x="365" y="53"/>
                  </a:lnTo>
                  <a:lnTo>
                    <a:pt x="366" y="57"/>
                  </a:lnTo>
                  <a:lnTo>
                    <a:pt x="366" y="62"/>
                  </a:lnTo>
                  <a:lnTo>
                    <a:pt x="366" y="68"/>
                  </a:lnTo>
                  <a:lnTo>
                    <a:pt x="366" y="73"/>
                  </a:lnTo>
                  <a:lnTo>
                    <a:pt x="367" y="79"/>
                  </a:lnTo>
                  <a:lnTo>
                    <a:pt x="367" y="85"/>
                  </a:lnTo>
                  <a:lnTo>
                    <a:pt x="367" y="90"/>
                  </a:lnTo>
                  <a:lnTo>
                    <a:pt x="367" y="97"/>
                  </a:lnTo>
                  <a:lnTo>
                    <a:pt x="367" y="103"/>
                  </a:lnTo>
                  <a:lnTo>
                    <a:pt x="368" y="11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6" name="Freeform 291">
              <a:extLst>
                <a:ext uri="{FF2B5EF4-FFF2-40B4-BE49-F238E27FC236}">
                  <a16:creationId xmlns:a16="http://schemas.microsoft.com/office/drawing/2014/main" id="{89C432D8-0ACD-4630-B822-46CBEADA1E5C}"/>
                </a:ext>
              </a:extLst>
            </p:cNvPr>
            <p:cNvSpPr>
              <a:spLocks/>
            </p:cNvSpPr>
            <p:nvPr/>
          </p:nvSpPr>
          <p:spPr bwMode="auto">
            <a:xfrm>
              <a:off x="2928938" y="2071688"/>
              <a:ext cx="1684338" cy="1598613"/>
            </a:xfrm>
            <a:custGeom>
              <a:avLst/>
              <a:gdLst>
                <a:gd name="T0" fmla="*/ 2 w 1061"/>
                <a:gd name="T1" fmla="*/ 58 h 1007"/>
                <a:gd name="T2" fmla="*/ 4 w 1061"/>
                <a:gd name="T3" fmla="*/ 153 h 1007"/>
                <a:gd name="T4" fmla="*/ 10 w 1061"/>
                <a:gd name="T5" fmla="*/ 346 h 1007"/>
                <a:gd name="T6" fmla="*/ 13 w 1061"/>
                <a:gd name="T7" fmla="*/ 470 h 1007"/>
                <a:gd name="T8" fmla="*/ 15 w 1061"/>
                <a:gd name="T9" fmla="*/ 528 h 1007"/>
                <a:gd name="T10" fmla="*/ 16 w 1061"/>
                <a:gd name="T11" fmla="*/ 556 h 1007"/>
                <a:gd name="T12" fmla="*/ 17 w 1061"/>
                <a:gd name="T13" fmla="*/ 577 h 1007"/>
                <a:gd name="T14" fmla="*/ 20 w 1061"/>
                <a:gd name="T15" fmla="*/ 646 h 1007"/>
                <a:gd name="T16" fmla="*/ 23 w 1061"/>
                <a:gd name="T17" fmla="*/ 705 h 1007"/>
                <a:gd name="T18" fmla="*/ 26 w 1061"/>
                <a:gd name="T19" fmla="*/ 757 h 1007"/>
                <a:gd name="T20" fmla="*/ 29 w 1061"/>
                <a:gd name="T21" fmla="*/ 802 h 1007"/>
                <a:gd name="T22" fmla="*/ 32 w 1061"/>
                <a:gd name="T23" fmla="*/ 840 h 1007"/>
                <a:gd name="T24" fmla="*/ 35 w 1061"/>
                <a:gd name="T25" fmla="*/ 867 h 1007"/>
                <a:gd name="T26" fmla="*/ 39 w 1061"/>
                <a:gd name="T27" fmla="*/ 888 h 1007"/>
                <a:gd name="T28" fmla="*/ 42 w 1061"/>
                <a:gd name="T29" fmla="*/ 906 h 1007"/>
                <a:gd name="T30" fmla="*/ 47 w 1061"/>
                <a:gd name="T31" fmla="*/ 923 h 1007"/>
                <a:gd name="T32" fmla="*/ 52 w 1061"/>
                <a:gd name="T33" fmla="*/ 935 h 1007"/>
                <a:gd name="T34" fmla="*/ 57 w 1061"/>
                <a:gd name="T35" fmla="*/ 944 h 1007"/>
                <a:gd name="T36" fmla="*/ 63 w 1061"/>
                <a:gd name="T37" fmla="*/ 953 h 1007"/>
                <a:gd name="T38" fmla="*/ 71 w 1061"/>
                <a:gd name="T39" fmla="*/ 961 h 1007"/>
                <a:gd name="T40" fmla="*/ 77 w 1061"/>
                <a:gd name="T41" fmla="*/ 965 h 1007"/>
                <a:gd name="T42" fmla="*/ 89 w 1061"/>
                <a:gd name="T43" fmla="*/ 972 h 1007"/>
                <a:gd name="T44" fmla="*/ 101 w 1061"/>
                <a:gd name="T45" fmla="*/ 977 h 1007"/>
                <a:gd name="T46" fmla="*/ 109 w 1061"/>
                <a:gd name="T47" fmla="*/ 979 h 1007"/>
                <a:gd name="T48" fmla="*/ 120 w 1061"/>
                <a:gd name="T49" fmla="*/ 981 h 1007"/>
                <a:gd name="T50" fmla="*/ 134 w 1061"/>
                <a:gd name="T51" fmla="*/ 982 h 1007"/>
                <a:gd name="T52" fmla="*/ 143 w 1061"/>
                <a:gd name="T53" fmla="*/ 983 h 1007"/>
                <a:gd name="T54" fmla="*/ 161 w 1061"/>
                <a:gd name="T55" fmla="*/ 988 h 1007"/>
                <a:gd name="T56" fmla="*/ 171 w 1061"/>
                <a:gd name="T57" fmla="*/ 991 h 1007"/>
                <a:gd name="T58" fmla="*/ 189 w 1061"/>
                <a:gd name="T59" fmla="*/ 994 h 1007"/>
                <a:gd name="T60" fmla="*/ 203 w 1061"/>
                <a:gd name="T61" fmla="*/ 996 h 1007"/>
                <a:gd name="T62" fmla="*/ 221 w 1061"/>
                <a:gd name="T63" fmla="*/ 997 h 1007"/>
                <a:gd name="T64" fmla="*/ 236 w 1061"/>
                <a:gd name="T65" fmla="*/ 998 h 1007"/>
                <a:gd name="T66" fmla="*/ 266 w 1061"/>
                <a:gd name="T67" fmla="*/ 999 h 1007"/>
                <a:gd name="T68" fmla="*/ 288 w 1061"/>
                <a:gd name="T69" fmla="*/ 999 h 1007"/>
                <a:gd name="T70" fmla="*/ 312 w 1061"/>
                <a:gd name="T71" fmla="*/ 999 h 1007"/>
                <a:gd name="T72" fmla="*/ 338 w 1061"/>
                <a:gd name="T73" fmla="*/ 1000 h 1007"/>
                <a:gd name="T74" fmla="*/ 355 w 1061"/>
                <a:gd name="T75" fmla="*/ 1001 h 1007"/>
                <a:gd name="T76" fmla="*/ 379 w 1061"/>
                <a:gd name="T77" fmla="*/ 1002 h 1007"/>
                <a:gd name="T78" fmla="*/ 401 w 1061"/>
                <a:gd name="T79" fmla="*/ 1002 h 1007"/>
                <a:gd name="T80" fmla="*/ 431 w 1061"/>
                <a:gd name="T81" fmla="*/ 1003 h 1007"/>
                <a:gd name="T82" fmla="*/ 457 w 1061"/>
                <a:gd name="T83" fmla="*/ 1004 h 1007"/>
                <a:gd name="T84" fmla="*/ 475 w 1061"/>
                <a:gd name="T85" fmla="*/ 1004 h 1007"/>
                <a:gd name="T86" fmla="*/ 497 w 1061"/>
                <a:gd name="T87" fmla="*/ 1004 h 1007"/>
                <a:gd name="T88" fmla="*/ 528 w 1061"/>
                <a:gd name="T89" fmla="*/ 1005 h 1007"/>
                <a:gd name="T90" fmla="*/ 563 w 1061"/>
                <a:gd name="T91" fmla="*/ 1005 h 1007"/>
                <a:gd name="T92" fmla="*/ 591 w 1061"/>
                <a:gd name="T93" fmla="*/ 1005 h 1007"/>
                <a:gd name="T94" fmla="*/ 622 w 1061"/>
                <a:gd name="T95" fmla="*/ 1005 h 1007"/>
                <a:gd name="T96" fmla="*/ 680 w 1061"/>
                <a:gd name="T97" fmla="*/ 1005 h 1007"/>
                <a:gd name="T98" fmla="*/ 711 w 1061"/>
                <a:gd name="T99" fmla="*/ 1005 h 1007"/>
                <a:gd name="T100" fmla="*/ 741 w 1061"/>
                <a:gd name="T101" fmla="*/ 1005 h 1007"/>
                <a:gd name="T102" fmla="*/ 769 w 1061"/>
                <a:gd name="T103" fmla="*/ 1005 h 1007"/>
                <a:gd name="T104" fmla="*/ 794 w 1061"/>
                <a:gd name="T105" fmla="*/ 1006 h 1007"/>
                <a:gd name="T106" fmla="*/ 833 w 1061"/>
                <a:gd name="T107" fmla="*/ 1006 h 1007"/>
                <a:gd name="T108" fmla="*/ 871 w 1061"/>
                <a:gd name="T109" fmla="*/ 1006 h 1007"/>
                <a:gd name="T110" fmla="*/ 909 w 1061"/>
                <a:gd name="T111" fmla="*/ 1006 h 1007"/>
                <a:gd name="T112" fmla="*/ 940 w 1061"/>
                <a:gd name="T113" fmla="*/ 1006 h 1007"/>
                <a:gd name="T114" fmla="*/ 964 w 1061"/>
                <a:gd name="T115" fmla="*/ 1006 h 1007"/>
                <a:gd name="T116" fmla="*/ 987 w 1061"/>
                <a:gd name="T117" fmla="*/ 1006 h 1007"/>
                <a:gd name="T118" fmla="*/ 1003 w 1061"/>
                <a:gd name="T119" fmla="*/ 1007 h 1007"/>
                <a:gd name="T120" fmla="*/ 1014 w 1061"/>
                <a:gd name="T121" fmla="*/ 1006 h 1007"/>
                <a:gd name="T122" fmla="*/ 1027 w 1061"/>
                <a:gd name="T123" fmla="*/ 1006 h 1007"/>
                <a:gd name="T124" fmla="*/ 1043 w 1061"/>
                <a:gd name="T125" fmla="*/ 1006 h 10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061" h="1007">
                  <a:moveTo>
                    <a:pt x="0" y="0"/>
                  </a:moveTo>
                  <a:lnTo>
                    <a:pt x="0" y="8"/>
                  </a:lnTo>
                  <a:lnTo>
                    <a:pt x="0" y="15"/>
                  </a:lnTo>
                  <a:lnTo>
                    <a:pt x="0" y="23"/>
                  </a:lnTo>
                  <a:lnTo>
                    <a:pt x="1" y="31"/>
                  </a:lnTo>
                  <a:lnTo>
                    <a:pt x="1" y="40"/>
                  </a:lnTo>
                  <a:lnTo>
                    <a:pt x="1" y="48"/>
                  </a:lnTo>
                  <a:lnTo>
                    <a:pt x="2" y="58"/>
                  </a:lnTo>
                  <a:lnTo>
                    <a:pt x="2" y="67"/>
                  </a:lnTo>
                  <a:lnTo>
                    <a:pt x="2" y="78"/>
                  </a:lnTo>
                  <a:lnTo>
                    <a:pt x="3" y="88"/>
                  </a:lnTo>
                  <a:lnTo>
                    <a:pt x="3" y="100"/>
                  </a:lnTo>
                  <a:lnTo>
                    <a:pt x="3" y="112"/>
                  </a:lnTo>
                  <a:lnTo>
                    <a:pt x="4" y="125"/>
                  </a:lnTo>
                  <a:lnTo>
                    <a:pt x="4" y="138"/>
                  </a:lnTo>
                  <a:lnTo>
                    <a:pt x="4" y="153"/>
                  </a:lnTo>
                  <a:lnTo>
                    <a:pt x="5" y="169"/>
                  </a:lnTo>
                  <a:lnTo>
                    <a:pt x="5" y="187"/>
                  </a:lnTo>
                  <a:lnTo>
                    <a:pt x="6" y="207"/>
                  </a:lnTo>
                  <a:lnTo>
                    <a:pt x="7" y="231"/>
                  </a:lnTo>
                  <a:lnTo>
                    <a:pt x="8" y="266"/>
                  </a:lnTo>
                  <a:lnTo>
                    <a:pt x="9" y="301"/>
                  </a:lnTo>
                  <a:lnTo>
                    <a:pt x="9" y="325"/>
                  </a:lnTo>
                  <a:lnTo>
                    <a:pt x="10" y="346"/>
                  </a:lnTo>
                  <a:lnTo>
                    <a:pt x="10" y="365"/>
                  </a:lnTo>
                  <a:lnTo>
                    <a:pt x="11" y="382"/>
                  </a:lnTo>
                  <a:lnTo>
                    <a:pt x="11" y="398"/>
                  </a:lnTo>
                  <a:lnTo>
                    <a:pt x="12" y="414"/>
                  </a:lnTo>
                  <a:lnTo>
                    <a:pt x="12" y="429"/>
                  </a:lnTo>
                  <a:lnTo>
                    <a:pt x="13" y="443"/>
                  </a:lnTo>
                  <a:lnTo>
                    <a:pt x="13" y="457"/>
                  </a:lnTo>
                  <a:lnTo>
                    <a:pt x="13" y="470"/>
                  </a:lnTo>
                  <a:lnTo>
                    <a:pt x="14" y="482"/>
                  </a:lnTo>
                  <a:lnTo>
                    <a:pt x="14" y="492"/>
                  </a:lnTo>
                  <a:lnTo>
                    <a:pt x="14" y="499"/>
                  </a:lnTo>
                  <a:lnTo>
                    <a:pt x="15" y="506"/>
                  </a:lnTo>
                  <a:lnTo>
                    <a:pt x="15" y="512"/>
                  </a:lnTo>
                  <a:lnTo>
                    <a:pt x="15" y="518"/>
                  </a:lnTo>
                  <a:lnTo>
                    <a:pt x="15" y="523"/>
                  </a:lnTo>
                  <a:lnTo>
                    <a:pt x="15" y="528"/>
                  </a:lnTo>
                  <a:lnTo>
                    <a:pt x="15" y="532"/>
                  </a:lnTo>
                  <a:lnTo>
                    <a:pt x="16" y="537"/>
                  </a:lnTo>
                  <a:lnTo>
                    <a:pt x="16" y="541"/>
                  </a:lnTo>
                  <a:lnTo>
                    <a:pt x="16" y="544"/>
                  </a:lnTo>
                  <a:lnTo>
                    <a:pt x="16" y="548"/>
                  </a:lnTo>
                  <a:lnTo>
                    <a:pt x="16" y="551"/>
                  </a:lnTo>
                  <a:lnTo>
                    <a:pt x="16" y="554"/>
                  </a:lnTo>
                  <a:lnTo>
                    <a:pt x="16" y="556"/>
                  </a:lnTo>
                  <a:lnTo>
                    <a:pt x="16" y="559"/>
                  </a:lnTo>
                  <a:lnTo>
                    <a:pt x="16" y="561"/>
                  </a:lnTo>
                  <a:lnTo>
                    <a:pt x="17" y="564"/>
                  </a:lnTo>
                  <a:lnTo>
                    <a:pt x="17" y="566"/>
                  </a:lnTo>
                  <a:lnTo>
                    <a:pt x="17" y="568"/>
                  </a:lnTo>
                  <a:lnTo>
                    <a:pt x="17" y="570"/>
                  </a:lnTo>
                  <a:lnTo>
                    <a:pt x="17" y="571"/>
                  </a:lnTo>
                  <a:lnTo>
                    <a:pt x="17" y="577"/>
                  </a:lnTo>
                  <a:lnTo>
                    <a:pt x="17" y="586"/>
                  </a:lnTo>
                  <a:lnTo>
                    <a:pt x="18" y="595"/>
                  </a:lnTo>
                  <a:lnTo>
                    <a:pt x="18" y="604"/>
                  </a:lnTo>
                  <a:lnTo>
                    <a:pt x="18" y="613"/>
                  </a:lnTo>
                  <a:lnTo>
                    <a:pt x="19" y="621"/>
                  </a:lnTo>
                  <a:lnTo>
                    <a:pt x="19" y="630"/>
                  </a:lnTo>
                  <a:lnTo>
                    <a:pt x="20" y="638"/>
                  </a:lnTo>
                  <a:lnTo>
                    <a:pt x="20" y="646"/>
                  </a:lnTo>
                  <a:lnTo>
                    <a:pt x="20" y="654"/>
                  </a:lnTo>
                  <a:lnTo>
                    <a:pt x="21" y="662"/>
                  </a:lnTo>
                  <a:lnTo>
                    <a:pt x="21" y="669"/>
                  </a:lnTo>
                  <a:lnTo>
                    <a:pt x="21" y="677"/>
                  </a:lnTo>
                  <a:lnTo>
                    <a:pt x="21" y="684"/>
                  </a:lnTo>
                  <a:lnTo>
                    <a:pt x="22" y="691"/>
                  </a:lnTo>
                  <a:lnTo>
                    <a:pt x="22" y="698"/>
                  </a:lnTo>
                  <a:lnTo>
                    <a:pt x="23" y="705"/>
                  </a:lnTo>
                  <a:lnTo>
                    <a:pt x="23" y="712"/>
                  </a:lnTo>
                  <a:lnTo>
                    <a:pt x="23" y="719"/>
                  </a:lnTo>
                  <a:lnTo>
                    <a:pt x="24" y="726"/>
                  </a:lnTo>
                  <a:lnTo>
                    <a:pt x="24" y="732"/>
                  </a:lnTo>
                  <a:lnTo>
                    <a:pt x="24" y="739"/>
                  </a:lnTo>
                  <a:lnTo>
                    <a:pt x="25" y="745"/>
                  </a:lnTo>
                  <a:lnTo>
                    <a:pt x="25" y="752"/>
                  </a:lnTo>
                  <a:lnTo>
                    <a:pt x="26" y="757"/>
                  </a:lnTo>
                  <a:lnTo>
                    <a:pt x="26" y="763"/>
                  </a:lnTo>
                  <a:lnTo>
                    <a:pt x="26" y="769"/>
                  </a:lnTo>
                  <a:lnTo>
                    <a:pt x="27" y="775"/>
                  </a:lnTo>
                  <a:lnTo>
                    <a:pt x="27" y="780"/>
                  </a:lnTo>
                  <a:lnTo>
                    <a:pt x="28" y="786"/>
                  </a:lnTo>
                  <a:lnTo>
                    <a:pt x="28" y="792"/>
                  </a:lnTo>
                  <a:lnTo>
                    <a:pt x="28" y="797"/>
                  </a:lnTo>
                  <a:lnTo>
                    <a:pt x="29" y="802"/>
                  </a:lnTo>
                  <a:lnTo>
                    <a:pt x="29" y="807"/>
                  </a:lnTo>
                  <a:lnTo>
                    <a:pt x="29" y="812"/>
                  </a:lnTo>
                  <a:lnTo>
                    <a:pt x="30" y="817"/>
                  </a:lnTo>
                  <a:lnTo>
                    <a:pt x="30" y="822"/>
                  </a:lnTo>
                  <a:lnTo>
                    <a:pt x="31" y="827"/>
                  </a:lnTo>
                  <a:lnTo>
                    <a:pt x="31" y="832"/>
                  </a:lnTo>
                  <a:lnTo>
                    <a:pt x="32" y="836"/>
                  </a:lnTo>
                  <a:lnTo>
                    <a:pt x="32" y="840"/>
                  </a:lnTo>
                  <a:lnTo>
                    <a:pt x="33" y="845"/>
                  </a:lnTo>
                  <a:lnTo>
                    <a:pt x="33" y="849"/>
                  </a:lnTo>
                  <a:lnTo>
                    <a:pt x="34" y="853"/>
                  </a:lnTo>
                  <a:lnTo>
                    <a:pt x="34" y="856"/>
                  </a:lnTo>
                  <a:lnTo>
                    <a:pt x="34" y="859"/>
                  </a:lnTo>
                  <a:lnTo>
                    <a:pt x="35" y="862"/>
                  </a:lnTo>
                  <a:lnTo>
                    <a:pt x="35" y="865"/>
                  </a:lnTo>
                  <a:lnTo>
                    <a:pt x="35" y="867"/>
                  </a:lnTo>
                  <a:lnTo>
                    <a:pt x="36" y="870"/>
                  </a:lnTo>
                  <a:lnTo>
                    <a:pt x="36" y="873"/>
                  </a:lnTo>
                  <a:lnTo>
                    <a:pt x="36" y="875"/>
                  </a:lnTo>
                  <a:lnTo>
                    <a:pt x="37" y="878"/>
                  </a:lnTo>
                  <a:lnTo>
                    <a:pt x="37" y="880"/>
                  </a:lnTo>
                  <a:lnTo>
                    <a:pt x="38" y="883"/>
                  </a:lnTo>
                  <a:lnTo>
                    <a:pt x="38" y="885"/>
                  </a:lnTo>
                  <a:lnTo>
                    <a:pt x="39" y="888"/>
                  </a:lnTo>
                  <a:lnTo>
                    <a:pt x="39" y="890"/>
                  </a:lnTo>
                  <a:lnTo>
                    <a:pt x="39" y="892"/>
                  </a:lnTo>
                  <a:lnTo>
                    <a:pt x="40" y="895"/>
                  </a:lnTo>
                  <a:lnTo>
                    <a:pt x="40" y="897"/>
                  </a:lnTo>
                  <a:lnTo>
                    <a:pt x="41" y="899"/>
                  </a:lnTo>
                  <a:lnTo>
                    <a:pt x="41" y="901"/>
                  </a:lnTo>
                  <a:lnTo>
                    <a:pt x="42" y="903"/>
                  </a:lnTo>
                  <a:lnTo>
                    <a:pt x="42" y="906"/>
                  </a:lnTo>
                  <a:lnTo>
                    <a:pt x="43" y="908"/>
                  </a:lnTo>
                  <a:lnTo>
                    <a:pt x="43" y="910"/>
                  </a:lnTo>
                  <a:lnTo>
                    <a:pt x="44" y="912"/>
                  </a:lnTo>
                  <a:lnTo>
                    <a:pt x="45" y="915"/>
                  </a:lnTo>
                  <a:lnTo>
                    <a:pt x="46" y="919"/>
                  </a:lnTo>
                  <a:lnTo>
                    <a:pt x="46" y="921"/>
                  </a:lnTo>
                  <a:lnTo>
                    <a:pt x="47" y="922"/>
                  </a:lnTo>
                  <a:lnTo>
                    <a:pt x="47" y="923"/>
                  </a:lnTo>
                  <a:lnTo>
                    <a:pt x="47" y="924"/>
                  </a:lnTo>
                  <a:lnTo>
                    <a:pt x="48" y="926"/>
                  </a:lnTo>
                  <a:lnTo>
                    <a:pt x="49" y="927"/>
                  </a:lnTo>
                  <a:lnTo>
                    <a:pt x="49" y="929"/>
                  </a:lnTo>
                  <a:lnTo>
                    <a:pt x="50" y="931"/>
                  </a:lnTo>
                  <a:lnTo>
                    <a:pt x="51" y="933"/>
                  </a:lnTo>
                  <a:lnTo>
                    <a:pt x="51" y="934"/>
                  </a:lnTo>
                  <a:lnTo>
                    <a:pt x="52" y="935"/>
                  </a:lnTo>
                  <a:lnTo>
                    <a:pt x="52" y="936"/>
                  </a:lnTo>
                  <a:lnTo>
                    <a:pt x="53" y="938"/>
                  </a:lnTo>
                  <a:lnTo>
                    <a:pt x="54" y="939"/>
                  </a:lnTo>
                  <a:lnTo>
                    <a:pt x="54" y="940"/>
                  </a:lnTo>
                  <a:lnTo>
                    <a:pt x="55" y="941"/>
                  </a:lnTo>
                  <a:lnTo>
                    <a:pt x="56" y="942"/>
                  </a:lnTo>
                  <a:lnTo>
                    <a:pt x="56" y="943"/>
                  </a:lnTo>
                  <a:lnTo>
                    <a:pt x="57" y="944"/>
                  </a:lnTo>
                  <a:lnTo>
                    <a:pt x="57" y="945"/>
                  </a:lnTo>
                  <a:lnTo>
                    <a:pt x="58" y="946"/>
                  </a:lnTo>
                  <a:lnTo>
                    <a:pt x="59" y="948"/>
                  </a:lnTo>
                  <a:lnTo>
                    <a:pt x="60" y="949"/>
                  </a:lnTo>
                  <a:lnTo>
                    <a:pt x="61" y="950"/>
                  </a:lnTo>
                  <a:lnTo>
                    <a:pt x="61" y="951"/>
                  </a:lnTo>
                  <a:lnTo>
                    <a:pt x="62" y="952"/>
                  </a:lnTo>
                  <a:lnTo>
                    <a:pt x="63" y="953"/>
                  </a:lnTo>
                  <a:lnTo>
                    <a:pt x="64" y="954"/>
                  </a:lnTo>
                  <a:lnTo>
                    <a:pt x="65" y="955"/>
                  </a:lnTo>
                  <a:lnTo>
                    <a:pt x="66" y="956"/>
                  </a:lnTo>
                  <a:lnTo>
                    <a:pt x="67" y="957"/>
                  </a:lnTo>
                  <a:lnTo>
                    <a:pt x="68" y="958"/>
                  </a:lnTo>
                  <a:lnTo>
                    <a:pt x="69" y="959"/>
                  </a:lnTo>
                  <a:lnTo>
                    <a:pt x="70" y="960"/>
                  </a:lnTo>
                  <a:lnTo>
                    <a:pt x="71" y="961"/>
                  </a:lnTo>
                  <a:lnTo>
                    <a:pt x="72" y="962"/>
                  </a:lnTo>
                  <a:lnTo>
                    <a:pt x="74" y="963"/>
                  </a:lnTo>
                  <a:lnTo>
                    <a:pt x="75" y="964"/>
                  </a:lnTo>
                  <a:lnTo>
                    <a:pt x="75" y="964"/>
                  </a:lnTo>
                  <a:lnTo>
                    <a:pt x="76" y="964"/>
                  </a:lnTo>
                  <a:lnTo>
                    <a:pt x="76" y="965"/>
                  </a:lnTo>
                  <a:lnTo>
                    <a:pt x="77" y="965"/>
                  </a:lnTo>
                  <a:lnTo>
                    <a:pt x="77" y="965"/>
                  </a:lnTo>
                  <a:lnTo>
                    <a:pt x="78" y="966"/>
                  </a:lnTo>
                  <a:lnTo>
                    <a:pt x="80" y="967"/>
                  </a:lnTo>
                  <a:lnTo>
                    <a:pt x="81" y="968"/>
                  </a:lnTo>
                  <a:lnTo>
                    <a:pt x="83" y="969"/>
                  </a:lnTo>
                  <a:lnTo>
                    <a:pt x="84" y="970"/>
                  </a:lnTo>
                  <a:lnTo>
                    <a:pt x="86" y="971"/>
                  </a:lnTo>
                  <a:lnTo>
                    <a:pt x="87" y="972"/>
                  </a:lnTo>
                  <a:lnTo>
                    <a:pt x="89" y="972"/>
                  </a:lnTo>
                  <a:lnTo>
                    <a:pt x="91" y="973"/>
                  </a:lnTo>
                  <a:lnTo>
                    <a:pt x="93" y="974"/>
                  </a:lnTo>
                  <a:lnTo>
                    <a:pt x="94" y="975"/>
                  </a:lnTo>
                  <a:lnTo>
                    <a:pt x="96" y="975"/>
                  </a:lnTo>
                  <a:lnTo>
                    <a:pt x="97" y="976"/>
                  </a:lnTo>
                  <a:lnTo>
                    <a:pt x="98" y="976"/>
                  </a:lnTo>
                  <a:lnTo>
                    <a:pt x="100" y="977"/>
                  </a:lnTo>
                  <a:lnTo>
                    <a:pt x="101" y="977"/>
                  </a:lnTo>
                  <a:lnTo>
                    <a:pt x="102" y="977"/>
                  </a:lnTo>
                  <a:lnTo>
                    <a:pt x="103" y="978"/>
                  </a:lnTo>
                  <a:lnTo>
                    <a:pt x="105" y="978"/>
                  </a:lnTo>
                  <a:lnTo>
                    <a:pt x="106" y="978"/>
                  </a:lnTo>
                  <a:lnTo>
                    <a:pt x="106" y="979"/>
                  </a:lnTo>
                  <a:lnTo>
                    <a:pt x="107" y="979"/>
                  </a:lnTo>
                  <a:lnTo>
                    <a:pt x="108" y="979"/>
                  </a:lnTo>
                  <a:lnTo>
                    <a:pt x="109" y="979"/>
                  </a:lnTo>
                  <a:lnTo>
                    <a:pt x="110" y="979"/>
                  </a:lnTo>
                  <a:lnTo>
                    <a:pt x="112" y="980"/>
                  </a:lnTo>
                  <a:lnTo>
                    <a:pt x="113" y="980"/>
                  </a:lnTo>
                  <a:lnTo>
                    <a:pt x="114" y="980"/>
                  </a:lnTo>
                  <a:lnTo>
                    <a:pt x="116" y="980"/>
                  </a:lnTo>
                  <a:lnTo>
                    <a:pt x="117" y="981"/>
                  </a:lnTo>
                  <a:lnTo>
                    <a:pt x="119" y="981"/>
                  </a:lnTo>
                  <a:lnTo>
                    <a:pt x="120" y="981"/>
                  </a:lnTo>
                  <a:lnTo>
                    <a:pt x="123" y="981"/>
                  </a:lnTo>
                  <a:lnTo>
                    <a:pt x="125" y="981"/>
                  </a:lnTo>
                  <a:lnTo>
                    <a:pt x="128" y="981"/>
                  </a:lnTo>
                  <a:lnTo>
                    <a:pt x="130" y="981"/>
                  </a:lnTo>
                  <a:lnTo>
                    <a:pt x="131" y="981"/>
                  </a:lnTo>
                  <a:lnTo>
                    <a:pt x="132" y="982"/>
                  </a:lnTo>
                  <a:lnTo>
                    <a:pt x="133" y="982"/>
                  </a:lnTo>
                  <a:lnTo>
                    <a:pt x="134" y="982"/>
                  </a:lnTo>
                  <a:lnTo>
                    <a:pt x="135" y="982"/>
                  </a:lnTo>
                  <a:lnTo>
                    <a:pt x="135" y="982"/>
                  </a:lnTo>
                  <a:lnTo>
                    <a:pt x="136" y="982"/>
                  </a:lnTo>
                  <a:lnTo>
                    <a:pt x="137" y="982"/>
                  </a:lnTo>
                  <a:lnTo>
                    <a:pt x="138" y="982"/>
                  </a:lnTo>
                  <a:lnTo>
                    <a:pt x="140" y="983"/>
                  </a:lnTo>
                  <a:lnTo>
                    <a:pt x="141" y="983"/>
                  </a:lnTo>
                  <a:lnTo>
                    <a:pt x="143" y="983"/>
                  </a:lnTo>
                  <a:lnTo>
                    <a:pt x="144" y="984"/>
                  </a:lnTo>
                  <a:lnTo>
                    <a:pt x="146" y="984"/>
                  </a:lnTo>
                  <a:lnTo>
                    <a:pt x="148" y="984"/>
                  </a:lnTo>
                  <a:lnTo>
                    <a:pt x="150" y="985"/>
                  </a:lnTo>
                  <a:lnTo>
                    <a:pt x="152" y="986"/>
                  </a:lnTo>
                  <a:lnTo>
                    <a:pt x="155" y="987"/>
                  </a:lnTo>
                  <a:lnTo>
                    <a:pt x="159" y="988"/>
                  </a:lnTo>
                  <a:lnTo>
                    <a:pt x="161" y="988"/>
                  </a:lnTo>
                  <a:lnTo>
                    <a:pt x="162" y="989"/>
                  </a:lnTo>
                  <a:lnTo>
                    <a:pt x="163" y="989"/>
                  </a:lnTo>
                  <a:lnTo>
                    <a:pt x="164" y="989"/>
                  </a:lnTo>
                  <a:lnTo>
                    <a:pt x="165" y="989"/>
                  </a:lnTo>
                  <a:lnTo>
                    <a:pt x="165" y="989"/>
                  </a:lnTo>
                  <a:lnTo>
                    <a:pt x="166" y="990"/>
                  </a:lnTo>
                  <a:lnTo>
                    <a:pt x="169" y="990"/>
                  </a:lnTo>
                  <a:lnTo>
                    <a:pt x="171" y="991"/>
                  </a:lnTo>
                  <a:lnTo>
                    <a:pt x="173" y="991"/>
                  </a:lnTo>
                  <a:lnTo>
                    <a:pt x="175" y="991"/>
                  </a:lnTo>
                  <a:lnTo>
                    <a:pt x="177" y="992"/>
                  </a:lnTo>
                  <a:lnTo>
                    <a:pt x="179" y="992"/>
                  </a:lnTo>
                  <a:lnTo>
                    <a:pt x="182" y="993"/>
                  </a:lnTo>
                  <a:lnTo>
                    <a:pt x="184" y="993"/>
                  </a:lnTo>
                  <a:lnTo>
                    <a:pt x="187" y="994"/>
                  </a:lnTo>
                  <a:lnTo>
                    <a:pt x="189" y="994"/>
                  </a:lnTo>
                  <a:lnTo>
                    <a:pt x="191" y="994"/>
                  </a:lnTo>
                  <a:lnTo>
                    <a:pt x="193" y="994"/>
                  </a:lnTo>
                  <a:lnTo>
                    <a:pt x="194" y="994"/>
                  </a:lnTo>
                  <a:lnTo>
                    <a:pt x="194" y="995"/>
                  </a:lnTo>
                  <a:lnTo>
                    <a:pt x="195" y="995"/>
                  </a:lnTo>
                  <a:lnTo>
                    <a:pt x="196" y="995"/>
                  </a:lnTo>
                  <a:lnTo>
                    <a:pt x="199" y="995"/>
                  </a:lnTo>
                  <a:lnTo>
                    <a:pt x="203" y="996"/>
                  </a:lnTo>
                  <a:lnTo>
                    <a:pt x="206" y="996"/>
                  </a:lnTo>
                  <a:lnTo>
                    <a:pt x="208" y="996"/>
                  </a:lnTo>
                  <a:lnTo>
                    <a:pt x="210" y="996"/>
                  </a:lnTo>
                  <a:lnTo>
                    <a:pt x="212" y="996"/>
                  </a:lnTo>
                  <a:lnTo>
                    <a:pt x="215" y="997"/>
                  </a:lnTo>
                  <a:lnTo>
                    <a:pt x="217" y="997"/>
                  </a:lnTo>
                  <a:lnTo>
                    <a:pt x="219" y="997"/>
                  </a:lnTo>
                  <a:lnTo>
                    <a:pt x="221" y="997"/>
                  </a:lnTo>
                  <a:lnTo>
                    <a:pt x="223" y="997"/>
                  </a:lnTo>
                  <a:lnTo>
                    <a:pt x="224" y="997"/>
                  </a:lnTo>
                  <a:lnTo>
                    <a:pt x="225" y="997"/>
                  </a:lnTo>
                  <a:lnTo>
                    <a:pt x="227" y="998"/>
                  </a:lnTo>
                  <a:lnTo>
                    <a:pt x="229" y="998"/>
                  </a:lnTo>
                  <a:lnTo>
                    <a:pt x="231" y="998"/>
                  </a:lnTo>
                  <a:lnTo>
                    <a:pt x="233" y="998"/>
                  </a:lnTo>
                  <a:lnTo>
                    <a:pt x="236" y="998"/>
                  </a:lnTo>
                  <a:lnTo>
                    <a:pt x="240" y="998"/>
                  </a:lnTo>
                  <a:lnTo>
                    <a:pt x="246" y="998"/>
                  </a:lnTo>
                  <a:lnTo>
                    <a:pt x="250" y="998"/>
                  </a:lnTo>
                  <a:lnTo>
                    <a:pt x="252" y="998"/>
                  </a:lnTo>
                  <a:lnTo>
                    <a:pt x="253" y="998"/>
                  </a:lnTo>
                  <a:lnTo>
                    <a:pt x="256" y="999"/>
                  </a:lnTo>
                  <a:lnTo>
                    <a:pt x="262" y="999"/>
                  </a:lnTo>
                  <a:lnTo>
                    <a:pt x="266" y="999"/>
                  </a:lnTo>
                  <a:lnTo>
                    <a:pt x="270" y="999"/>
                  </a:lnTo>
                  <a:lnTo>
                    <a:pt x="273" y="999"/>
                  </a:lnTo>
                  <a:lnTo>
                    <a:pt x="276" y="999"/>
                  </a:lnTo>
                  <a:lnTo>
                    <a:pt x="279" y="999"/>
                  </a:lnTo>
                  <a:lnTo>
                    <a:pt x="282" y="999"/>
                  </a:lnTo>
                  <a:lnTo>
                    <a:pt x="284" y="999"/>
                  </a:lnTo>
                  <a:lnTo>
                    <a:pt x="286" y="999"/>
                  </a:lnTo>
                  <a:lnTo>
                    <a:pt x="288" y="999"/>
                  </a:lnTo>
                  <a:lnTo>
                    <a:pt x="291" y="999"/>
                  </a:lnTo>
                  <a:lnTo>
                    <a:pt x="296" y="999"/>
                  </a:lnTo>
                  <a:lnTo>
                    <a:pt x="302" y="999"/>
                  </a:lnTo>
                  <a:lnTo>
                    <a:pt x="305" y="999"/>
                  </a:lnTo>
                  <a:lnTo>
                    <a:pt x="308" y="999"/>
                  </a:lnTo>
                  <a:lnTo>
                    <a:pt x="310" y="999"/>
                  </a:lnTo>
                  <a:lnTo>
                    <a:pt x="311" y="999"/>
                  </a:lnTo>
                  <a:lnTo>
                    <a:pt x="312" y="999"/>
                  </a:lnTo>
                  <a:lnTo>
                    <a:pt x="314" y="999"/>
                  </a:lnTo>
                  <a:lnTo>
                    <a:pt x="316" y="999"/>
                  </a:lnTo>
                  <a:lnTo>
                    <a:pt x="318" y="999"/>
                  </a:lnTo>
                  <a:lnTo>
                    <a:pt x="322" y="999"/>
                  </a:lnTo>
                  <a:lnTo>
                    <a:pt x="326" y="1000"/>
                  </a:lnTo>
                  <a:lnTo>
                    <a:pt x="331" y="1000"/>
                  </a:lnTo>
                  <a:lnTo>
                    <a:pt x="335" y="1000"/>
                  </a:lnTo>
                  <a:lnTo>
                    <a:pt x="338" y="1000"/>
                  </a:lnTo>
                  <a:lnTo>
                    <a:pt x="339" y="1000"/>
                  </a:lnTo>
                  <a:lnTo>
                    <a:pt x="340" y="1000"/>
                  </a:lnTo>
                  <a:lnTo>
                    <a:pt x="341" y="1000"/>
                  </a:lnTo>
                  <a:lnTo>
                    <a:pt x="342" y="1000"/>
                  </a:lnTo>
                  <a:lnTo>
                    <a:pt x="346" y="1000"/>
                  </a:lnTo>
                  <a:lnTo>
                    <a:pt x="348" y="1000"/>
                  </a:lnTo>
                  <a:lnTo>
                    <a:pt x="351" y="1001"/>
                  </a:lnTo>
                  <a:lnTo>
                    <a:pt x="355" y="1001"/>
                  </a:lnTo>
                  <a:lnTo>
                    <a:pt x="360" y="1001"/>
                  </a:lnTo>
                  <a:lnTo>
                    <a:pt x="365" y="1001"/>
                  </a:lnTo>
                  <a:lnTo>
                    <a:pt x="367" y="1001"/>
                  </a:lnTo>
                  <a:lnTo>
                    <a:pt x="369" y="1001"/>
                  </a:lnTo>
                  <a:lnTo>
                    <a:pt x="370" y="1001"/>
                  </a:lnTo>
                  <a:lnTo>
                    <a:pt x="371" y="1001"/>
                  </a:lnTo>
                  <a:lnTo>
                    <a:pt x="374" y="1001"/>
                  </a:lnTo>
                  <a:lnTo>
                    <a:pt x="379" y="1002"/>
                  </a:lnTo>
                  <a:lnTo>
                    <a:pt x="383" y="1002"/>
                  </a:lnTo>
                  <a:lnTo>
                    <a:pt x="387" y="1002"/>
                  </a:lnTo>
                  <a:lnTo>
                    <a:pt x="391" y="1002"/>
                  </a:lnTo>
                  <a:lnTo>
                    <a:pt x="395" y="1002"/>
                  </a:lnTo>
                  <a:lnTo>
                    <a:pt x="397" y="1002"/>
                  </a:lnTo>
                  <a:lnTo>
                    <a:pt x="398" y="1002"/>
                  </a:lnTo>
                  <a:lnTo>
                    <a:pt x="399" y="1002"/>
                  </a:lnTo>
                  <a:lnTo>
                    <a:pt x="401" y="1002"/>
                  </a:lnTo>
                  <a:lnTo>
                    <a:pt x="403" y="1002"/>
                  </a:lnTo>
                  <a:lnTo>
                    <a:pt x="407" y="1003"/>
                  </a:lnTo>
                  <a:lnTo>
                    <a:pt x="413" y="1003"/>
                  </a:lnTo>
                  <a:lnTo>
                    <a:pt x="420" y="1003"/>
                  </a:lnTo>
                  <a:lnTo>
                    <a:pt x="424" y="1003"/>
                  </a:lnTo>
                  <a:lnTo>
                    <a:pt x="426" y="1003"/>
                  </a:lnTo>
                  <a:lnTo>
                    <a:pt x="428" y="1003"/>
                  </a:lnTo>
                  <a:lnTo>
                    <a:pt x="431" y="1003"/>
                  </a:lnTo>
                  <a:lnTo>
                    <a:pt x="435" y="1003"/>
                  </a:lnTo>
                  <a:lnTo>
                    <a:pt x="437" y="1003"/>
                  </a:lnTo>
                  <a:lnTo>
                    <a:pt x="440" y="1003"/>
                  </a:lnTo>
                  <a:lnTo>
                    <a:pt x="443" y="1003"/>
                  </a:lnTo>
                  <a:lnTo>
                    <a:pt x="447" y="1004"/>
                  </a:lnTo>
                  <a:lnTo>
                    <a:pt x="452" y="1004"/>
                  </a:lnTo>
                  <a:lnTo>
                    <a:pt x="456" y="1004"/>
                  </a:lnTo>
                  <a:lnTo>
                    <a:pt x="457" y="1004"/>
                  </a:lnTo>
                  <a:lnTo>
                    <a:pt x="458" y="1004"/>
                  </a:lnTo>
                  <a:lnTo>
                    <a:pt x="460" y="1004"/>
                  </a:lnTo>
                  <a:lnTo>
                    <a:pt x="462" y="1004"/>
                  </a:lnTo>
                  <a:lnTo>
                    <a:pt x="464" y="1004"/>
                  </a:lnTo>
                  <a:lnTo>
                    <a:pt x="466" y="1004"/>
                  </a:lnTo>
                  <a:lnTo>
                    <a:pt x="469" y="1004"/>
                  </a:lnTo>
                  <a:lnTo>
                    <a:pt x="472" y="1004"/>
                  </a:lnTo>
                  <a:lnTo>
                    <a:pt x="475" y="1004"/>
                  </a:lnTo>
                  <a:lnTo>
                    <a:pt x="478" y="1004"/>
                  </a:lnTo>
                  <a:lnTo>
                    <a:pt x="480" y="1004"/>
                  </a:lnTo>
                  <a:lnTo>
                    <a:pt x="483" y="1004"/>
                  </a:lnTo>
                  <a:lnTo>
                    <a:pt x="485" y="1004"/>
                  </a:lnTo>
                  <a:lnTo>
                    <a:pt x="487" y="1004"/>
                  </a:lnTo>
                  <a:lnTo>
                    <a:pt x="489" y="1004"/>
                  </a:lnTo>
                  <a:lnTo>
                    <a:pt x="493" y="1004"/>
                  </a:lnTo>
                  <a:lnTo>
                    <a:pt x="497" y="1004"/>
                  </a:lnTo>
                  <a:lnTo>
                    <a:pt x="502" y="1004"/>
                  </a:lnTo>
                  <a:lnTo>
                    <a:pt x="507" y="1004"/>
                  </a:lnTo>
                  <a:lnTo>
                    <a:pt x="512" y="1004"/>
                  </a:lnTo>
                  <a:lnTo>
                    <a:pt x="515" y="1004"/>
                  </a:lnTo>
                  <a:lnTo>
                    <a:pt x="518" y="1004"/>
                  </a:lnTo>
                  <a:lnTo>
                    <a:pt x="520" y="1004"/>
                  </a:lnTo>
                  <a:lnTo>
                    <a:pt x="523" y="1004"/>
                  </a:lnTo>
                  <a:lnTo>
                    <a:pt x="528" y="1005"/>
                  </a:lnTo>
                  <a:lnTo>
                    <a:pt x="535" y="1005"/>
                  </a:lnTo>
                  <a:lnTo>
                    <a:pt x="540" y="1005"/>
                  </a:lnTo>
                  <a:lnTo>
                    <a:pt x="544" y="1005"/>
                  </a:lnTo>
                  <a:lnTo>
                    <a:pt x="547" y="1005"/>
                  </a:lnTo>
                  <a:lnTo>
                    <a:pt x="551" y="1005"/>
                  </a:lnTo>
                  <a:lnTo>
                    <a:pt x="556" y="1005"/>
                  </a:lnTo>
                  <a:lnTo>
                    <a:pt x="560" y="1005"/>
                  </a:lnTo>
                  <a:lnTo>
                    <a:pt x="563" y="1005"/>
                  </a:lnTo>
                  <a:lnTo>
                    <a:pt x="566" y="1005"/>
                  </a:lnTo>
                  <a:lnTo>
                    <a:pt x="569" y="1005"/>
                  </a:lnTo>
                  <a:lnTo>
                    <a:pt x="572" y="1005"/>
                  </a:lnTo>
                  <a:lnTo>
                    <a:pt x="575" y="1005"/>
                  </a:lnTo>
                  <a:lnTo>
                    <a:pt x="578" y="1005"/>
                  </a:lnTo>
                  <a:lnTo>
                    <a:pt x="581" y="1005"/>
                  </a:lnTo>
                  <a:lnTo>
                    <a:pt x="585" y="1005"/>
                  </a:lnTo>
                  <a:lnTo>
                    <a:pt x="591" y="1005"/>
                  </a:lnTo>
                  <a:lnTo>
                    <a:pt x="596" y="1005"/>
                  </a:lnTo>
                  <a:lnTo>
                    <a:pt x="600" y="1005"/>
                  </a:lnTo>
                  <a:lnTo>
                    <a:pt x="604" y="1005"/>
                  </a:lnTo>
                  <a:lnTo>
                    <a:pt x="606" y="1005"/>
                  </a:lnTo>
                  <a:lnTo>
                    <a:pt x="609" y="1005"/>
                  </a:lnTo>
                  <a:lnTo>
                    <a:pt x="612" y="1005"/>
                  </a:lnTo>
                  <a:lnTo>
                    <a:pt x="617" y="1005"/>
                  </a:lnTo>
                  <a:lnTo>
                    <a:pt x="622" y="1005"/>
                  </a:lnTo>
                  <a:lnTo>
                    <a:pt x="628" y="1005"/>
                  </a:lnTo>
                  <a:lnTo>
                    <a:pt x="637" y="1005"/>
                  </a:lnTo>
                  <a:lnTo>
                    <a:pt x="646" y="1005"/>
                  </a:lnTo>
                  <a:lnTo>
                    <a:pt x="655" y="1005"/>
                  </a:lnTo>
                  <a:lnTo>
                    <a:pt x="662" y="1005"/>
                  </a:lnTo>
                  <a:lnTo>
                    <a:pt x="670" y="1005"/>
                  </a:lnTo>
                  <a:lnTo>
                    <a:pt x="676" y="1005"/>
                  </a:lnTo>
                  <a:lnTo>
                    <a:pt x="680" y="1005"/>
                  </a:lnTo>
                  <a:lnTo>
                    <a:pt x="684" y="1005"/>
                  </a:lnTo>
                  <a:lnTo>
                    <a:pt x="687" y="1005"/>
                  </a:lnTo>
                  <a:lnTo>
                    <a:pt x="692" y="1005"/>
                  </a:lnTo>
                  <a:lnTo>
                    <a:pt x="697" y="1005"/>
                  </a:lnTo>
                  <a:lnTo>
                    <a:pt x="701" y="1005"/>
                  </a:lnTo>
                  <a:lnTo>
                    <a:pt x="704" y="1005"/>
                  </a:lnTo>
                  <a:lnTo>
                    <a:pt x="707" y="1005"/>
                  </a:lnTo>
                  <a:lnTo>
                    <a:pt x="711" y="1005"/>
                  </a:lnTo>
                  <a:lnTo>
                    <a:pt x="714" y="1005"/>
                  </a:lnTo>
                  <a:lnTo>
                    <a:pt x="718" y="1005"/>
                  </a:lnTo>
                  <a:lnTo>
                    <a:pt x="722" y="1005"/>
                  </a:lnTo>
                  <a:lnTo>
                    <a:pt x="726" y="1005"/>
                  </a:lnTo>
                  <a:lnTo>
                    <a:pt x="730" y="1005"/>
                  </a:lnTo>
                  <a:lnTo>
                    <a:pt x="734" y="1005"/>
                  </a:lnTo>
                  <a:lnTo>
                    <a:pt x="738" y="1005"/>
                  </a:lnTo>
                  <a:lnTo>
                    <a:pt x="741" y="1005"/>
                  </a:lnTo>
                  <a:lnTo>
                    <a:pt x="744" y="1005"/>
                  </a:lnTo>
                  <a:lnTo>
                    <a:pt x="748" y="1005"/>
                  </a:lnTo>
                  <a:lnTo>
                    <a:pt x="750" y="1005"/>
                  </a:lnTo>
                  <a:lnTo>
                    <a:pt x="753" y="1005"/>
                  </a:lnTo>
                  <a:lnTo>
                    <a:pt x="756" y="1005"/>
                  </a:lnTo>
                  <a:lnTo>
                    <a:pt x="761" y="1005"/>
                  </a:lnTo>
                  <a:lnTo>
                    <a:pt x="765" y="1005"/>
                  </a:lnTo>
                  <a:lnTo>
                    <a:pt x="769" y="1005"/>
                  </a:lnTo>
                  <a:lnTo>
                    <a:pt x="774" y="1005"/>
                  </a:lnTo>
                  <a:lnTo>
                    <a:pt x="778" y="1005"/>
                  </a:lnTo>
                  <a:lnTo>
                    <a:pt x="780" y="1005"/>
                  </a:lnTo>
                  <a:lnTo>
                    <a:pt x="782" y="1005"/>
                  </a:lnTo>
                  <a:lnTo>
                    <a:pt x="784" y="1005"/>
                  </a:lnTo>
                  <a:lnTo>
                    <a:pt x="787" y="1005"/>
                  </a:lnTo>
                  <a:lnTo>
                    <a:pt x="791" y="1005"/>
                  </a:lnTo>
                  <a:lnTo>
                    <a:pt x="794" y="1006"/>
                  </a:lnTo>
                  <a:lnTo>
                    <a:pt x="798" y="1006"/>
                  </a:lnTo>
                  <a:lnTo>
                    <a:pt x="803" y="1006"/>
                  </a:lnTo>
                  <a:lnTo>
                    <a:pt x="807" y="1006"/>
                  </a:lnTo>
                  <a:lnTo>
                    <a:pt x="811" y="1006"/>
                  </a:lnTo>
                  <a:lnTo>
                    <a:pt x="817" y="1006"/>
                  </a:lnTo>
                  <a:lnTo>
                    <a:pt x="822" y="1006"/>
                  </a:lnTo>
                  <a:lnTo>
                    <a:pt x="827" y="1006"/>
                  </a:lnTo>
                  <a:lnTo>
                    <a:pt x="833" y="1006"/>
                  </a:lnTo>
                  <a:lnTo>
                    <a:pt x="838" y="1006"/>
                  </a:lnTo>
                  <a:lnTo>
                    <a:pt x="843" y="1006"/>
                  </a:lnTo>
                  <a:lnTo>
                    <a:pt x="846" y="1006"/>
                  </a:lnTo>
                  <a:lnTo>
                    <a:pt x="851" y="1006"/>
                  </a:lnTo>
                  <a:lnTo>
                    <a:pt x="856" y="1006"/>
                  </a:lnTo>
                  <a:lnTo>
                    <a:pt x="862" y="1006"/>
                  </a:lnTo>
                  <a:lnTo>
                    <a:pt x="867" y="1006"/>
                  </a:lnTo>
                  <a:lnTo>
                    <a:pt x="871" y="1006"/>
                  </a:lnTo>
                  <a:lnTo>
                    <a:pt x="874" y="1006"/>
                  </a:lnTo>
                  <a:lnTo>
                    <a:pt x="879" y="1006"/>
                  </a:lnTo>
                  <a:lnTo>
                    <a:pt x="884" y="1006"/>
                  </a:lnTo>
                  <a:lnTo>
                    <a:pt x="890" y="1006"/>
                  </a:lnTo>
                  <a:lnTo>
                    <a:pt x="896" y="1006"/>
                  </a:lnTo>
                  <a:lnTo>
                    <a:pt x="901" y="1006"/>
                  </a:lnTo>
                  <a:lnTo>
                    <a:pt x="905" y="1006"/>
                  </a:lnTo>
                  <a:lnTo>
                    <a:pt x="909" y="1006"/>
                  </a:lnTo>
                  <a:lnTo>
                    <a:pt x="914" y="1006"/>
                  </a:lnTo>
                  <a:lnTo>
                    <a:pt x="918" y="1006"/>
                  </a:lnTo>
                  <a:lnTo>
                    <a:pt x="922" y="1006"/>
                  </a:lnTo>
                  <a:lnTo>
                    <a:pt x="926" y="1006"/>
                  </a:lnTo>
                  <a:lnTo>
                    <a:pt x="929" y="1006"/>
                  </a:lnTo>
                  <a:lnTo>
                    <a:pt x="932" y="1006"/>
                  </a:lnTo>
                  <a:lnTo>
                    <a:pt x="936" y="1006"/>
                  </a:lnTo>
                  <a:lnTo>
                    <a:pt x="940" y="1006"/>
                  </a:lnTo>
                  <a:lnTo>
                    <a:pt x="943" y="1006"/>
                  </a:lnTo>
                  <a:lnTo>
                    <a:pt x="947" y="1006"/>
                  </a:lnTo>
                  <a:lnTo>
                    <a:pt x="950" y="1006"/>
                  </a:lnTo>
                  <a:lnTo>
                    <a:pt x="954" y="1006"/>
                  </a:lnTo>
                  <a:lnTo>
                    <a:pt x="957" y="1006"/>
                  </a:lnTo>
                  <a:lnTo>
                    <a:pt x="959" y="1006"/>
                  </a:lnTo>
                  <a:lnTo>
                    <a:pt x="961" y="1006"/>
                  </a:lnTo>
                  <a:lnTo>
                    <a:pt x="964" y="1006"/>
                  </a:lnTo>
                  <a:lnTo>
                    <a:pt x="967" y="1006"/>
                  </a:lnTo>
                  <a:lnTo>
                    <a:pt x="971" y="1006"/>
                  </a:lnTo>
                  <a:lnTo>
                    <a:pt x="975" y="1006"/>
                  </a:lnTo>
                  <a:lnTo>
                    <a:pt x="978" y="1006"/>
                  </a:lnTo>
                  <a:lnTo>
                    <a:pt x="981" y="1006"/>
                  </a:lnTo>
                  <a:lnTo>
                    <a:pt x="983" y="1006"/>
                  </a:lnTo>
                  <a:lnTo>
                    <a:pt x="985" y="1006"/>
                  </a:lnTo>
                  <a:lnTo>
                    <a:pt x="987" y="1006"/>
                  </a:lnTo>
                  <a:lnTo>
                    <a:pt x="988" y="1006"/>
                  </a:lnTo>
                  <a:lnTo>
                    <a:pt x="990" y="1006"/>
                  </a:lnTo>
                  <a:lnTo>
                    <a:pt x="992" y="1006"/>
                  </a:lnTo>
                  <a:lnTo>
                    <a:pt x="995" y="1006"/>
                  </a:lnTo>
                  <a:lnTo>
                    <a:pt x="998" y="1007"/>
                  </a:lnTo>
                  <a:lnTo>
                    <a:pt x="1000" y="1007"/>
                  </a:lnTo>
                  <a:lnTo>
                    <a:pt x="1002" y="1007"/>
                  </a:lnTo>
                  <a:lnTo>
                    <a:pt x="1003" y="1007"/>
                  </a:lnTo>
                  <a:lnTo>
                    <a:pt x="1005" y="1007"/>
                  </a:lnTo>
                  <a:lnTo>
                    <a:pt x="1006" y="1007"/>
                  </a:lnTo>
                  <a:lnTo>
                    <a:pt x="1008" y="1007"/>
                  </a:lnTo>
                  <a:lnTo>
                    <a:pt x="1009" y="1007"/>
                  </a:lnTo>
                  <a:lnTo>
                    <a:pt x="1010" y="1007"/>
                  </a:lnTo>
                  <a:lnTo>
                    <a:pt x="1012" y="1007"/>
                  </a:lnTo>
                  <a:lnTo>
                    <a:pt x="1013" y="1006"/>
                  </a:lnTo>
                  <a:lnTo>
                    <a:pt x="1014" y="1006"/>
                  </a:lnTo>
                  <a:lnTo>
                    <a:pt x="1015" y="1006"/>
                  </a:lnTo>
                  <a:lnTo>
                    <a:pt x="1016" y="1006"/>
                  </a:lnTo>
                  <a:lnTo>
                    <a:pt x="1016" y="1006"/>
                  </a:lnTo>
                  <a:lnTo>
                    <a:pt x="1018" y="1006"/>
                  </a:lnTo>
                  <a:lnTo>
                    <a:pt x="1020" y="1006"/>
                  </a:lnTo>
                  <a:lnTo>
                    <a:pt x="1023" y="1006"/>
                  </a:lnTo>
                  <a:lnTo>
                    <a:pt x="1025" y="1006"/>
                  </a:lnTo>
                  <a:lnTo>
                    <a:pt x="1027" y="1006"/>
                  </a:lnTo>
                  <a:lnTo>
                    <a:pt x="1030" y="1006"/>
                  </a:lnTo>
                  <a:lnTo>
                    <a:pt x="1032" y="1006"/>
                  </a:lnTo>
                  <a:lnTo>
                    <a:pt x="1034" y="1006"/>
                  </a:lnTo>
                  <a:lnTo>
                    <a:pt x="1036" y="1006"/>
                  </a:lnTo>
                  <a:lnTo>
                    <a:pt x="1038" y="1006"/>
                  </a:lnTo>
                  <a:lnTo>
                    <a:pt x="1040" y="1006"/>
                  </a:lnTo>
                  <a:lnTo>
                    <a:pt x="1042" y="1006"/>
                  </a:lnTo>
                  <a:lnTo>
                    <a:pt x="1043" y="1006"/>
                  </a:lnTo>
                  <a:lnTo>
                    <a:pt x="1045" y="1006"/>
                  </a:lnTo>
                  <a:lnTo>
                    <a:pt x="1046" y="1006"/>
                  </a:lnTo>
                  <a:lnTo>
                    <a:pt x="1049" y="1006"/>
                  </a:lnTo>
                  <a:lnTo>
                    <a:pt x="1052" y="1006"/>
                  </a:lnTo>
                  <a:lnTo>
                    <a:pt x="1055" y="1006"/>
                  </a:lnTo>
                  <a:lnTo>
                    <a:pt x="1057" y="1006"/>
                  </a:lnTo>
                  <a:lnTo>
                    <a:pt x="1061" y="1006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7" name="Freeform 292">
              <a:extLst>
                <a:ext uri="{FF2B5EF4-FFF2-40B4-BE49-F238E27FC236}">
                  <a16:creationId xmlns:a16="http://schemas.microsoft.com/office/drawing/2014/main" id="{439D92EA-3197-481A-98DB-BFFD8ED857C3}"/>
                </a:ext>
              </a:extLst>
            </p:cNvPr>
            <p:cNvSpPr>
              <a:spLocks/>
            </p:cNvSpPr>
            <p:nvPr/>
          </p:nvSpPr>
          <p:spPr bwMode="auto">
            <a:xfrm>
              <a:off x="4613275" y="3589338"/>
              <a:ext cx="1450975" cy="93663"/>
            </a:xfrm>
            <a:custGeom>
              <a:avLst/>
              <a:gdLst>
                <a:gd name="T0" fmla="*/ 15 w 914"/>
                <a:gd name="T1" fmla="*/ 51 h 59"/>
                <a:gd name="T2" fmla="*/ 33 w 914"/>
                <a:gd name="T3" fmla="*/ 51 h 59"/>
                <a:gd name="T4" fmla="*/ 44 w 914"/>
                <a:gd name="T5" fmla="*/ 51 h 59"/>
                <a:gd name="T6" fmla="*/ 56 w 914"/>
                <a:gd name="T7" fmla="*/ 51 h 59"/>
                <a:gd name="T8" fmla="*/ 73 w 914"/>
                <a:gd name="T9" fmla="*/ 50 h 59"/>
                <a:gd name="T10" fmla="*/ 99 w 914"/>
                <a:gd name="T11" fmla="*/ 49 h 59"/>
                <a:gd name="T12" fmla="*/ 124 w 914"/>
                <a:gd name="T13" fmla="*/ 49 h 59"/>
                <a:gd name="T14" fmla="*/ 145 w 914"/>
                <a:gd name="T15" fmla="*/ 49 h 59"/>
                <a:gd name="T16" fmla="*/ 174 w 914"/>
                <a:gd name="T17" fmla="*/ 49 h 59"/>
                <a:gd name="T18" fmla="*/ 208 w 914"/>
                <a:gd name="T19" fmla="*/ 50 h 59"/>
                <a:gd name="T20" fmla="*/ 235 w 914"/>
                <a:gd name="T21" fmla="*/ 50 h 59"/>
                <a:gd name="T22" fmla="*/ 273 w 914"/>
                <a:gd name="T23" fmla="*/ 50 h 59"/>
                <a:gd name="T24" fmla="*/ 294 w 914"/>
                <a:gd name="T25" fmla="*/ 51 h 59"/>
                <a:gd name="T26" fmla="*/ 321 w 914"/>
                <a:gd name="T27" fmla="*/ 50 h 59"/>
                <a:gd name="T28" fmla="*/ 343 w 914"/>
                <a:gd name="T29" fmla="*/ 50 h 59"/>
                <a:gd name="T30" fmla="*/ 369 w 914"/>
                <a:gd name="T31" fmla="*/ 50 h 59"/>
                <a:gd name="T32" fmla="*/ 390 w 914"/>
                <a:gd name="T33" fmla="*/ 50 h 59"/>
                <a:gd name="T34" fmla="*/ 413 w 914"/>
                <a:gd name="T35" fmla="*/ 50 h 59"/>
                <a:gd name="T36" fmla="*/ 438 w 914"/>
                <a:gd name="T37" fmla="*/ 50 h 59"/>
                <a:gd name="T38" fmla="*/ 467 w 914"/>
                <a:gd name="T39" fmla="*/ 50 h 59"/>
                <a:gd name="T40" fmla="*/ 503 w 914"/>
                <a:gd name="T41" fmla="*/ 50 h 59"/>
                <a:gd name="T42" fmla="*/ 551 w 914"/>
                <a:gd name="T43" fmla="*/ 50 h 59"/>
                <a:gd name="T44" fmla="*/ 584 w 914"/>
                <a:gd name="T45" fmla="*/ 50 h 59"/>
                <a:gd name="T46" fmla="*/ 620 w 914"/>
                <a:gd name="T47" fmla="*/ 49 h 59"/>
                <a:gd name="T48" fmla="*/ 645 w 914"/>
                <a:gd name="T49" fmla="*/ 50 h 59"/>
                <a:gd name="T50" fmla="*/ 658 w 914"/>
                <a:gd name="T51" fmla="*/ 50 h 59"/>
                <a:gd name="T52" fmla="*/ 672 w 914"/>
                <a:gd name="T53" fmla="*/ 51 h 59"/>
                <a:gd name="T54" fmla="*/ 681 w 914"/>
                <a:gd name="T55" fmla="*/ 51 h 59"/>
                <a:gd name="T56" fmla="*/ 688 w 914"/>
                <a:gd name="T57" fmla="*/ 51 h 59"/>
                <a:gd name="T58" fmla="*/ 694 w 914"/>
                <a:gd name="T59" fmla="*/ 51 h 59"/>
                <a:gd name="T60" fmla="*/ 707 w 914"/>
                <a:gd name="T61" fmla="*/ 50 h 59"/>
                <a:gd name="T62" fmla="*/ 719 w 914"/>
                <a:gd name="T63" fmla="*/ 48 h 59"/>
                <a:gd name="T64" fmla="*/ 736 w 914"/>
                <a:gd name="T65" fmla="*/ 47 h 59"/>
                <a:gd name="T66" fmla="*/ 742 w 914"/>
                <a:gd name="T67" fmla="*/ 46 h 59"/>
                <a:gd name="T68" fmla="*/ 746 w 914"/>
                <a:gd name="T69" fmla="*/ 45 h 59"/>
                <a:gd name="T70" fmla="*/ 747 w 914"/>
                <a:gd name="T71" fmla="*/ 45 h 59"/>
                <a:gd name="T72" fmla="*/ 751 w 914"/>
                <a:gd name="T73" fmla="*/ 43 h 59"/>
                <a:gd name="T74" fmla="*/ 755 w 914"/>
                <a:gd name="T75" fmla="*/ 41 h 59"/>
                <a:gd name="T76" fmla="*/ 761 w 914"/>
                <a:gd name="T77" fmla="*/ 37 h 59"/>
                <a:gd name="T78" fmla="*/ 767 w 914"/>
                <a:gd name="T79" fmla="*/ 31 h 59"/>
                <a:gd name="T80" fmla="*/ 774 w 914"/>
                <a:gd name="T81" fmla="*/ 23 h 59"/>
                <a:gd name="T82" fmla="*/ 775 w 914"/>
                <a:gd name="T83" fmla="*/ 22 h 59"/>
                <a:gd name="T84" fmla="*/ 781 w 914"/>
                <a:gd name="T85" fmla="*/ 15 h 59"/>
                <a:gd name="T86" fmla="*/ 789 w 914"/>
                <a:gd name="T87" fmla="*/ 5 h 59"/>
                <a:gd name="T88" fmla="*/ 796 w 914"/>
                <a:gd name="T89" fmla="*/ 1 h 59"/>
                <a:gd name="T90" fmla="*/ 801 w 914"/>
                <a:gd name="T91" fmla="*/ 0 h 59"/>
                <a:gd name="T92" fmla="*/ 805 w 914"/>
                <a:gd name="T93" fmla="*/ 0 h 59"/>
                <a:gd name="T94" fmla="*/ 811 w 914"/>
                <a:gd name="T95" fmla="*/ 3 h 59"/>
                <a:gd name="T96" fmla="*/ 820 w 914"/>
                <a:gd name="T97" fmla="*/ 10 h 59"/>
                <a:gd name="T98" fmla="*/ 833 w 914"/>
                <a:gd name="T99" fmla="*/ 24 h 59"/>
                <a:gd name="T100" fmla="*/ 835 w 914"/>
                <a:gd name="T101" fmla="*/ 26 h 59"/>
                <a:gd name="T102" fmla="*/ 842 w 914"/>
                <a:gd name="T103" fmla="*/ 33 h 59"/>
                <a:gd name="T104" fmla="*/ 850 w 914"/>
                <a:gd name="T105" fmla="*/ 39 h 59"/>
                <a:gd name="T106" fmla="*/ 856 w 914"/>
                <a:gd name="T107" fmla="*/ 43 h 59"/>
                <a:gd name="T108" fmla="*/ 862 w 914"/>
                <a:gd name="T109" fmla="*/ 47 h 59"/>
                <a:gd name="T110" fmla="*/ 865 w 914"/>
                <a:gd name="T111" fmla="*/ 48 h 59"/>
                <a:gd name="T112" fmla="*/ 872 w 914"/>
                <a:gd name="T113" fmla="*/ 51 h 59"/>
                <a:gd name="T114" fmla="*/ 877 w 914"/>
                <a:gd name="T115" fmla="*/ 53 h 59"/>
                <a:gd name="T116" fmla="*/ 883 w 914"/>
                <a:gd name="T117" fmla="*/ 54 h 59"/>
                <a:gd name="T118" fmla="*/ 889 w 914"/>
                <a:gd name="T119" fmla="*/ 55 h 59"/>
                <a:gd name="T120" fmla="*/ 894 w 914"/>
                <a:gd name="T121" fmla="*/ 56 h 59"/>
                <a:gd name="T122" fmla="*/ 899 w 914"/>
                <a:gd name="T123" fmla="*/ 57 h 59"/>
                <a:gd name="T124" fmla="*/ 907 w 914"/>
                <a:gd name="T125" fmla="*/ 58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914" h="59">
                  <a:moveTo>
                    <a:pt x="0" y="50"/>
                  </a:moveTo>
                  <a:lnTo>
                    <a:pt x="4" y="50"/>
                  </a:lnTo>
                  <a:lnTo>
                    <a:pt x="7" y="51"/>
                  </a:lnTo>
                  <a:lnTo>
                    <a:pt x="10" y="51"/>
                  </a:lnTo>
                  <a:lnTo>
                    <a:pt x="11" y="51"/>
                  </a:lnTo>
                  <a:lnTo>
                    <a:pt x="13" y="51"/>
                  </a:lnTo>
                  <a:lnTo>
                    <a:pt x="14" y="51"/>
                  </a:lnTo>
                  <a:lnTo>
                    <a:pt x="15" y="51"/>
                  </a:lnTo>
                  <a:lnTo>
                    <a:pt x="17" y="51"/>
                  </a:lnTo>
                  <a:lnTo>
                    <a:pt x="19" y="51"/>
                  </a:lnTo>
                  <a:lnTo>
                    <a:pt x="22" y="51"/>
                  </a:lnTo>
                  <a:lnTo>
                    <a:pt x="24" y="51"/>
                  </a:lnTo>
                  <a:lnTo>
                    <a:pt x="27" y="51"/>
                  </a:lnTo>
                  <a:lnTo>
                    <a:pt x="29" y="51"/>
                  </a:lnTo>
                  <a:lnTo>
                    <a:pt x="31" y="51"/>
                  </a:lnTo>
                  <a:lnTo>
                    <a:pt x="33" y="51"/>
                  </a:lnTo>
                  <a:lnTo>
                    <a:pt x="34" y="51"/>
                  </a:lnTo>
                  <a:lnTo>
                    <a:pt x="36" y="51"/>
                  </a:lnTo>
                  <a:lnTo>
                    <a:pt x="38" y="51"/>
                  </a:lnTo>
                  <a:lnTo>
                    <a:pt x="39" y="51"/>
                  </a:lnTo>
                  <a:lnTo>
                    <a:pt x="41" y="51"/>
                  </a:lnTo>
                  <a:lnTo>
                    <a:pt x="42" y="51"/>
                  </a:lnTo>
                  <a:lnTo>
                    <a:pt x="43" y="51"/>
                  </a:lnTo>
                  <a:lnTo>
                    <a:pt x="44" y="51"/>
                  </a:lnTo>
                  <a:lnTo>
                    <a:pt x="44" y="51"/>
                  </a:lnTo>
                  <a:lnTo>
                    <a:pt x="46" y="51"/>
                  </a:lnTo>
                  <a:lnTo>
                    <a:pt x="48" y="51"/>
                  </a:lnTo>
                  <a:lnTo>
                    <a:pt x="50" y="51"/>
                  </a:lnTo>
                  <a:lnTo>
                    <a:pt x="52" y="51"/>
                  </a:lnTo>
                  <a:lnTo>
                    <a:pt x="53" y="51"/>
                  </a:lnTo>
                  <a:lnTo>
                    <a:pt x="55" y="51"/>
                  </a:lnTo>
                  <a:lnTo>
                    <a:pt x="56" y="51"/>
                  </a:lnTo>
                  <a:lnTo>
                    <a:pt x="58" y="51"/>
                  </a:lnTo>
                  <a:lnTo>
                    <a:pt x="60" y="51"/>
                  </a:lnTo>
                  <a:lnTo>
                    <a:pt x="62" y="50"/>
                  </a:lnTo>
                  <a:lnTo>
                    <a:pt x="66" y="50"/>
                  </a:lnTo>
                  <a:lnTo>
                    <a:pt x="69" y="50"/>
                  </a:lnTo>
                  <a:lnTo>
                    <a:pt x="71" y="50"/>
                  </a:lnTo>
                  <a:lnTo>
                    <a:pt x="72" y="50"/>
                  </a:lnTo>
                  <a:lnTo>
                    <a:pt x="73" y="50"/>
                  </a:lnTo>
                  <a:lnTo>
                    <a:pt x="75" y="50"/>
                  </a:lnTo>
                  <a:lnTo>
                    <a:pt x="79" y="50"/>
                  </a:lnTo>
                  <a:lnTo>
                    <a:pt x="83" y="50"/>
                  </a:lnTo>
                  <a:lnTo>
                    <a:pt x="86" y="50"/>
                  </a:lnTo>
                  <a:lnTo>
                    <a:pt x="89" y="50"/>
                  </a:lnTo>
                  <a:lnTo>
                    <a:pt x="92" y="50"/>
                  </a:lnTo>
                  <a:lnTo>
                    <a:pt x="95" y="49"/>
                  </a:lnTo>
                  <a:lnTo>
                    <a:pt x="99" y="49"/>
                  </a:lnTo>
                  <a:lnTo>
                    <a:pt x="102" y="49"/>
                  </a:lnTo>
                  <a:lnTo>
                    <a:pt x="103" y="49"/>
                  </a:lnTo>
                  <a:lnTo>
                    <a:pt x="106" y="49"/>
                  </a:lnTo>
                  <a:lnTo>
                    <a:pt x="110" y="49"/>
                  </a:lnTo>
                  <a:lnTo>
                    <a:pt x="113" y="49"/>
                  </a:lnTo>
                  <a:lnTo>
                    <a:pt x="117" y="49"/>
                  </a:lnTo>
                  <a:lnTo>
                    <a:pt x="120" y="49"/>
                  </a:lnTo>
                  <a:lnTo>
                    <a:pt x="124" y="49"/>
                  </a:lnTo>
                  <a:lnTo>
                    <a:pt x="127" y="49"/>
                  </a:lnTo>
                  <a:lnTo>
                    <a:pt x="129" y="49"/>
                  </a:lnTo>
                  <a:lnTo>
                    <a:pt x="131" y="49"/>
                  </a:lnTo>
                  <a:lnTo>
                    <a:pt x="133" y="49"/>
                  </a:lnTo>
                  <a:lnTo>
                    <a:pt x="136" y="49"/>
                  </a:lnTo>
                  <a:lnTo>
                    <a:pt x="139" y="49"/>
                  </a:lnTo>
                  <a:lnTo>
                    <a:pt x="142" y="49"/>
                  </a:lnTo>
                  <a:lnTo>
                    <a:pt x="145" y="49"/>
                  </a:lnTo>
                  <a:lnTo>
                    <a:pt x="148" y="49"/>
                  </a:lnTo>
                  <a:lnTo>
                    <a:pt x="152" y="49"/>
                  </a:lnTo>
                  <a:lnTo>
                    <a:pt x="155" y="49"/>
                  </a:lnTo>
                  <a:lnTo>
                    <a:pt x="159" y="49"/>
                  </a:lnTo>
                  <a:lnTo>
                    <a:pt x="163" y="49"/>
                  </a:lnTo>
                  <a:lnTo>
                    <a:pt x="167" y="49"/>
                  </a:lnTo>
                  <a:lnTo>
                    <a:pt x="170" y="49"/>
                  </a:lnTo>
                  <a:lnTo>
                    <a:pt x="174" y="49"/>
                  </a:lnTo>
                  <a:lnTo>
                    <a:pt x="179" y="49"/>
                  </a:lnTo>
                  <a:lnTo>
                    <a:pt x="184" y="50"/>
                  </a:lnTo>
                  <a:lnTo>
                    <a:pt x="188" y="50"/>
                  </a:lnTo>
                  <a:lnTo>
                    <a:pt x="192" y="50"/>
                  </a:lnTo>
                  <a:lnTo>
                    <a:pt x="194" y="50"/>
                  </a:lnTo>
                  <a:lnTo>
                    <a:pt x="197" y="50"/>
                  </a:lnTo>
                  <a:lnTo>
                    <a:pt x="202" y="50"/>
                  </a:lnTo>
                  <a:lnTo>
                    <a:pt x="208" y="50"/>
                  </a:lnTo>
                  <a:lnTo>
                    <a:pt x="214" y="50"/>
                  </a:lnTo>
                  <a:lnTo>
                    <a:pt x="218" y="50"/>
                  </a:lnTo>
                  <a:lnTo>
                    <a:pt x="221" y="50"/>
                  </a:lnTo>
                  <a:lnTo>
                    <a:pt x="223" y="50"/>
                  </a:lnTo>
                  <a:lnTo>
                    <a:pt x="226" y="50"/>
                  </a:lnTo>
                  <a:lnTo>
                    <a:pt x="229" y="50"/>
                  </a:lnTo>
                  <a:lnTo>
                    <a:pt x="232" y="50"/>
                  </a:lnTo>
                  <a:lnTo>
                    <a:pt x="235" y="50"/>
                  </a:lnTo>
                  <a:lnTo>
                    <a:pt x="242" y="50"/>
                  </a:lnTo>
                  <a:lnTo>
                    <a:pt x="248" y="50"/>
                  </a:lnTo>
                  <a:lnTo>
                    <a:pt x="253" y="50"/>
                  </a:lnTo>
                  <a:lnTo>
                    <a:pt x="259" y="50"/>
                  </a:lnTo>
                  <a:lnTo>
                    <a:pt x="263" y="50"/>
                  </a:lnTo>
                  <a:lnTo>
                    <a:pt x="267" y="50"/>
                  </a:lnTo>
                  <a:lnTo>
                    <a:pt x="270" y="50"/>
                  </a:lnTo>
                  <a:lnTo>
                    <a:pt x="273" y="50"/>
                  </a:lnTo>
                  <a:lnTo>
                    <a:pt x="277" y="50"/>
                  </a:lnTo>
                  <a:lnTo>
                    <a:pt x="281" y="50"/>
                  </a:lnTo>
                  <a:lnTo>
                    <a:pt x="284" y="50"/>
                  </a:lnTo>
                  <a:lnTo>
                    <a:pt x="286" y="50"/>
                  </a:lnTo>
                  <a:lnTo>
                    <a:pt x="289" y="50"/>
                  </a:lnTo>
                  <a:lnTo>
                    <a:pt x="291" y="50"/>
                  </a:lnTo>
                  <a:lnTo>
                    <a:pt x="293" y="50"/>
                  </a:lnTo>
                  <a:lnTo>
                    <a:pt x="294" y="51"/>
                  </a:lnTo>
                  <a:lnTo>
                    <a:pt x="296" y="51"/>
                  </a:lnTo>
                  <a:lnTo>
                    <a:pt x="299" y="51"/>
                  </a:lnTo>
                  <a:lnTo>
                    <a:pt x="301" y="50"/>
                  </a:lnTo>
                  <a:lnTo>
                    <a:pt x="304" y="50"/>
                  </a:lnTo>
                  <a:lnTo>
                    <a:pt x="308" y="50"/>
                  </a:lnTo>
                  <a:lnTo>
                    <a:pt x="314" y="50"/>
                  </a:lnTo>
                  <a:lnTo>
                    <a:pt x="318" y="50"/>
                  </a:lnTo>
                  <a:lnTo>
                    <a:pt x="321" y="50"/>
                  </a:lnTo>
                  <a:lnTo>
                    <a:pt x="324" y="50"/>
                  </a:lnTo>
                  <a:lnTo>
                    <a:pt x="326" y="50"/>
                  </a:lnTo>
                  <a:lnTo>
                    <a:pt x="329" y="50"/>
                  </a:lnTo>
                  <a:lnTo>
                    <a:pt x="331" y="50"/>
                  </a:lnTo>
                  <a:lnTo>
                    <a:pt x="334" y="50"/>
                  </a:lnTo>
                  <a:lnTo>
                    <a:pt x="337" y="50"/>
                  </a:lnTo>
                  <a:lnTo>
                    <a:pt x="339" y="50"/>
                  </a:lnTo>
                  <a:lnTo>
                    <a:pt x="343" y="50"/>
                  </a:lnTo>
                  <a:lnTo>
                    <a:pt x="348" y="50"/>
                  </a:lnTo>
                  <a:lnTo>
                    <a:pt x="353" y="50"/>
                  </a:lnTo>
                  <a:lnTo>
                    <a:pt x="356" y="50"/>
                  </a:lnTo>
                  <a:lnTo>
                    <a:pt x="359" y="50"/>
                  </a:lnTo>
                  <a:lnTo>
                    <a:pt x="362" y="50"/>
                  </a:lnTo>
                  <a:lnTo>
                    <a:pt x="365" y="50"/>
                  </a:lnTo>
                  <a:lnTo>
                    <a:pt x="367" y="50"/>
                  </a:lnTo>
                  <a:lnTo>
                    <a:pt x="369" y="50"/>
                  </a:lnTo>
                  <a:lnTo>
                    <a:pt x="372" y="50"/>
                  </a:lnTo>
                  <a:lnTo>
                    <a:pt x="375" y="50"/>
                  </a:lnTo>
                  <a:lnTo>
                    <a:pt x="377" y="50"/>
                  </a:lnTo>
                  <a:lnTo>
                    <a:pt x="379" y="50"/>
                  </a:lnTo>
                  <a:lnTo>
                    <a:pt x="381" y="50"/>
                  </a:lnTo>
                  <a:lnTo>
                    <a:pt x="384" y="50"/>
                  </a:lnTo>
                  <a:lnTo>
                    <a:pt x="387" y="50"/>
                  </a:lnTo>
                  <a:lnTo>
                    <a:pt x="390" y="50"/>
                  </a:lnTo>
                  <a:lnTo>
                    <a:pt x="393" y="50"/>
                  </a:lnTo>
                  <a:lnTo>
                    <a:pt x="394" y="50"/>
                  </a:lnTo>
                  <a:lnTo>
                    <a:pt x="395" y="50"/>
                  </a:lnTo>
                  <a:lnTo>
                    <a:pt x="396" y="50"/>
                  </a:lnTo>
                  <a:lnTo>
                    <a:pt x="398" y="50"/>
                  </a:lnTo>
                  <a:lnTo>
                    <a:pt x="403" y="50"/>
                  </a:lnTo>
                  <a:lnTo>
                    <a:pt x="409" y="50"/>
                  </a:lnTo>
                  <a:lnTo>
                    <a:pt x="413" y="50"/>
                  </a:lnTo>
                  <a:lnTo>
                    <a:pt x="417" y="50"/>
                  </a:lnTo>
                  <a:lnTo>
                    <a:pt x="420" y="50"/>
                  </a:lnTo>
                  <a:lnTo>
                    <a:pt x="423" y="50"/>
                  </a:lnTo>
                  <a:lnTo>
                    <a:pt x="426" y="50"/>
                  </a:lnTo>
                  <a:lnTo>
                    <a:pt x="428" y="50"/>
                  </a:lnTo>
                  <a:lnTo>
                    <a:pt x="431" y="50"/>
                  </a:lnTo>
                  <a:lnTo>
                    <a:pt x="434" y="50"/>
                  </a:lnTo>
                  <a:lnTo>
                    <a:pt x="438" y="50"/>
                  </a:lnTo>
                  <a:lnTo>
                    <a:pt x="441" y="50"/>
                  </a:lnTo>
                  <a:lnTo>
                    <a:pt x="445" y="50"/>
                  </a:lnTo>
                  <a:lnTo>
                    <a:pt x="449" y="50"/>
                  </a:lnTo>
                  <a:lnTo>
                    <a:pt x="454" y="50"/>
                  </a:lnTo>
                  <a:lnTo>
                    <a:pt x="458" y="50"/>
                  </a:lnTo>
                  <a:lnTo>
                    <a:pt x="461" y="50"/>
                  </a:lnTo>
                  <a:lnTo>
                    <a:pt x="464" y="50"/>
                  </a:lnTo>
                  <a:lnTo>
                    <a:pt x="467" y="50"/>
                  </a:lnTo>
                  <a:lnTo>
                    <a:pt x="472" y="50"/>
                  </a:lnTo>
                  <a:lnTo>
                    <a:pt x="477" y="50"/>
                  </a:lnTo>
                  <a:lnTo>
                    <a:pt x="482" y="50"/>
                  </a:lnTo>
                  <a:lnTo>
                    <a:pt x="485" y="50"/>
                  </a:lnTo>
                  <a:lnTo>
                    <a:pt x="489" y="50"/>
                  </a:lnTo>
                  <a:lnTo>
                    <a:pt x="494" y="50"/>
                  </a:lnTo>
                  <a:lnTo>
                    <a:pt x="499" y="50"/>
                  </a:lnTo>
                  <a:lnTo>
                    <a:pt x="503" y="50"/>
                  </a:lnTo>
                  <a:lnTo>
                    <a:pt x="507" y="50"/>
                  </a:lnTo>
                  <a:lnTo>
                    <a:pt x="512" y="50"/>
                  </a:lnTo>
                  <a:lnTo>
                    <a:pt x="516" y="50"/>
                  </a:lnTo>
                  <a:lnTo>
                    <a:pt x="521" y="50"/>
                  </a:lnTo>
                  <a:lnTo>
                    <a:pt x="529" y="50"/>
                  </a:lnTo>
                  <a:lnTo>
                    <a:pt x="537" y="50"/>
                  </a:lnTo>
                  <a:lnTo>
                    <a:pt x="544" y="50"/>
                  </a:lnTo>
                  <a:lnTo>
                    <a:pt x="551" y="50"/>
                  </a:lnTo>
                  <a:lnTo>
                    <a:pt x="556" y="50"/>
                  </a:lnTo>
                  <a:lnTo>
                    <a:pt x="560" y="50"/>
                  </a:lnTo>
                  <a:lnTo>
                    <a:pt x="564" y="50"/>
                  </a:lnTo>
                  <a:lnTo>
                    <a:pt x="569" y="50"/>
                  </a:lnTo>
                  <a:lnTo>
                    <a:pt x="572" y="50"/>
                  </a:lnTo>
                  <a:lnTo>
                    <a:pt x="576" y="50"/>
                  </a:lnTo>
                  <a:lnTo>
                    <a:pt x="579" y="50"/>
                  </a:lnTo>
                  <a:lnTo>
                    <a:pt x="584" y="50"/>
                  </a:lnTo>
                  <a:lnTo>
                    <a:pt x="588" y="50"/>
                  </a:lnTo>
                  <a:lnTo>
                    <a:pt x="594" y="50"/>
                  </a:lnTo>
                  <a:lnTo>
                    <a:pt x="599" y="50"/>
                  </a:lnTo>
                  <a:lnTo>
                    <a:pt x="602" y="50"/>
                  </a:lnTo>
                  <a:lnTo>
                    <a:pt x="606" y="50"/>
                  </a:lnTo>
                  <a:lnTo>
                    <a:pt x="611" y="50"/>
                  </a:lnTo>
                  <a:lnTo>
                    <a:pt x="615" y="49"/>
                  </a:lnTo>
                  <a:lnTo>
                    <a:pt x="620" y="49"/>
                  </a:lnTo>
                  <a:lnTo>
                    <a:pt x="625" y="49"/>
                  </a:lnTo>
                  <a:lnTo>
                    <a:pt x="628" y="49"/>
                  </a:lnTo>
                  <a:lnTo>
                    <a:pt x="630" y="49"/>
                  </a:lnTo>
                  <a:lnTo>
                    <a:pt x="632" y="49"/>
                  </a:lnTo>
                  <a:lnTo>
                    <a:pt x="635" y="49"/>
                  </a:lnTo>
                  <a:lnTo>
                    <a:pt x="638" y="50"/>
                  </a:lnTo>
                  <a:lnTo>
                    <a:pt x="642" y="50"/>
                  </a:lnTo>
                  <a:lnTo>
                    <a:pt x="645" y="50"/>
                  </a:lnTo>
                  <a:lnTo>
                    <a:pt x="648" y="50"/>
                  </a:lnTo>
                  <a:lnTo>
                    <a:pt x="650" y="50"/>
                  </a:lnTo>
                  <a:lnTo>
                    <a:pt x="652" y="50"/>
                  </a:lnTo>
                  <a:lnTo>
                    <a:pt x="654" y="50"/>
                  </a:lnTo>
                  <a:lnTo>
                    <a:pt x="655" y="50"/>
                  </a:lnTo>
                  <a:lnTo>
                    <a:pt x="657" y="50"/>
                  </a:lnTo>
                  <a:lnTo>
                    <a:pt x="658" y="50"/>
                  </a:lnTo>
                  <a:lnTo>
                    <a:pt x="658" y="50"/>
                  </a:lnTo>
                  <a:lnTo>
                    <a:pt x="659" y="50"/>
                  </a:lnTo>
                  <a:lnTo>
                    <a:pt x="660" y="50"/>
                  </a:lnTo>
                  <a:lnTo>
                    <a:pt x="662" y="50"/>
                  </a:lnTo>
                  <a:lnTo>
                    <a:pt x="665" y="50"/>
                  </a:lnTo>
                  <a:lnTo>
                    <a:pt x="667" y="50"/>
                  </a:lnTo>
                  <a:lnTo>
                    <a:pt x="669" y="50"/>
                  </a:lnTo>
                  <a:lnTo>
                    <a:pt x="671" y="51"/>
                  </a:lnTo>
                  <a:lnTo>
                    <a:pt x="672" y="51"/>
                  </a:lnTo>
                  <a:lnTo>
                    <a:pt x="673" y="51"/>
                  </a:lnTo>
                  <a:lnTo>
                    <a:pt x="675" y="51"/>
                  </a:lnTo>
                  <a:lnTo>
                    <a:pt x="676" y="51"/>
                  </a:lnTo>
                  <a:lnTo>
                    <a:pt x="677" y="51"/>
                  </a:lnTo>
                  <a:lnTo>
                    <a:pt x="678" y="51"/>
                  </a:lnTo>
                  <a:lnTo>
                    <a:pt x="679" y="51"/>
                  </a:lnTo>
                  <a:lnTo>
                    <a:pt x="680" y="51"/>
                  </a:lnTo>
                  <a:lnTo>
                    <a:pt x="681" y="51"/>
                  </a:lnTo>
                  <a:lnTo>
                    <a:pt x="682" y="51"/>
                  </a:lnTo>
                  <a:lnTo>
                    <a:pt x="683" y="51"/>
                  </a:lnTo>
                  <a:lnTo>
                    <a:pt x="684" y="51"/>
                  </a:lnTo>
                  <a:lnTo>
                    <a:pt x="685" y="51"/>
                  </a:lnTo>
                  <a:lnTo>
                    <a:pt x="686" y="51"/>
                  </a:lnTo>
                  <a:lnTo>
                    <a:pt x="686" y="51"/>
                  </a:lnTo>
                  <a:lnTo>
                    <a:pt x="687" y="51"/>
                  </a:lnTo>
                  <a:lnTo>
                    <a:pt x="688" y="51"/>
                  </a:lnTo>
                  <a:lnTo>
                    <a:pt x="688" y="51"/>
                  </a:lnTo>
                  <a:lnTo>
                    <a:pt x="689" y="51"/>
                  </a:lnTo>
                  <a:lnTo>
                    <a:pt x="689" y="51"/>
                  </a:lnTo>
                  <a:lnTo>
                    <a:pt x="689" y="51"/>
                  </a:lnTo>
                  <a:lnTo>
                    <a:pt x="690" y="51"/>
                  </a:lnTo>
                  <a:lnTo>
                    <a:pt x="691" y="51"/>
                  </a:lnTo>
                  <a:lnTo>
                    <a:pt x="692" y="51"/>
                  </a:lnTo>
                  <a:lnTo>
                    <a:pt x="694" y="51"/>
                  </a:lnTo>
                  <a:lnTo>
                    <a:pt x="695" y="51"/>
                  </a:lnTo>
                  <a:lnTo>
                    <a:pt x="696" y="50"/>
                  </a:lnTo>
                  <a:lnTo>
                    <a:pt x="697" y="50"/>
                  </a:lnTo>
                  <a:lnTo>
                    <a:pt x="699" y="50"/>
                  </a:lnTo>
                  <a:lnTo>
                    <a:pt x="700" y="50"/>
                  </a:lnTo>
                  <a:lnTo>
                    <a:pt x="702" y="50"/>
                  </a:lnTo>
                  <a:lnTo>
                    <a:pt x="704" y="50"/>
                  </a:lnTo>
                  <a:lnTo>
                    <a:pt x="707" y="50"/>
                  </a:lnTo>
                  <a:lnTo>
                    <a:pt x="711" y="49"/>
                  </a:lnTo>
                  <a:lnTo>
                    <a:pt x="714" y="49"/>
                  </a:lnTo>
                  <a:lnTo>
                    <a:pt x="715" y="49"/>
                  </a:lnTo>
                  <a:lnTo>
                    <a:pt x="717" y="49"/>
                  </a:lnTo>
                  <a:lnTo>
                    <a:pt x="717" y="49"/>
                  </a:lnTo>
                  <a:lnTo>
                    <a:pt x="718" y="49"/>
                  </a:lnTo>
                  <a:lnTo>
                    <a:pt x="718" y="49"/>
                  </a:lnTo>
                  <a:lnTo>
                    <a:pt x="719" y="48"/>
                  </a:lnTo>
                  <a:lnTo>
                    <a:pt x="721" y="48"/>
                  </a:lnTo>
                  <a:lnTo>
                    <a:pt x="724" y="48"/>
                  </a:lnTo>
                  <a:lnTo>
                    <a:pt x="727" y="48"/>
                  </a:lnTo>
                  <a:lnTo>
                    <a:pt x="730" y="48"/>
                  </a:lnTo>
                  <a:lnTo>
                    <a:pt x="731" y="48"/>
                  </a:lnTo>
                  <a:lnTo>
                    <a:pt x="733" y="47"/>
                  </a:lnTo>
                  <a:lnTo>
                    <a:pt x="734" y="47"/>
                  </a:lnTo>
                  <a:lnTo>
                    <a:pt x="736" y="47"/>
                  </a:lnTo>
                  <a:lnTo>
                    <a:pt x="737" y="47"/>
                  </a:lnTo>
                  <a:lnTo>
                    <a:pt x="738" y="47"/>
                  </a:lnTo>
                  <a:lnTo>
                    <a:pt x="738" y="47"/>
                  </a:lnTo>
                  <a:lnTo>
                    <a:pt x="739" y="47"/>
                  </a:lnTo>
                  <a:lnTo>
                    <a:pt x="740" y="46"/>
                  </a:lnTo>
                  <a:lnTo>
                    <a:pt x="741" y="46"/>
                  </a:lnTo>
                  <a:lnTo>
                    <a:pt x="742" y="46"/>
                  </a:lnTo>
                  <a:lnTo>
                    <a:pt x="742" y="46"/>
                  </a:lnTo>
                  <a:lnTo>
                    <a:pt x="743" y="46"/>
                  </a:lnTo>
                  <a:lnTo>
                    <a:pt x="744" y="46"/>
                  </a:lnTo>
                  <a:lnTo>
                    <a:pt x="744" y="45"/>
                  </a:lnTo>
                  <a:lnTo>
                    <a:pt x="745" y="45"/>
                  </a:lnTo>
                  <a:lnTo>
                    <a:pt x="745" y="45"/>
                  </a:lnTo>
                  <a:lnTo>
                    <a:pt x="745" y="45"/>
                  </a:lnTo>
                  <a:lnTo>
                    <a:pt x="745" y="45"/>
                  </a:lnTo>
                  <a:lnTo>
                    <a:pt x="746" y="45"/>
                  </a:lnTo>
                  <a:lnTo>
                    <a:pt x="746" y="45"/>
                  </a:lnTo>
                  <a:lnTo>
                    <a:pt x="746" y="45"/>
                  </a:lnTo>
                  <a:lnTo>
                    <a:pt x="746" y="45"/>
                  </a:lnTo>
                  <a:lnTo>
                    <a:pt x="747" y="45"/>
                  </a:lnTo>
                  <a:lnTo>
                    <a:pt x="747" y="45"/>
                  </a:lnTo>
                  <a:lnTo>
                    <a:pt x="747" y="45"/>
                  </a:lnTo>
                  <a:lnTo>
                    <a:pt x="747" y="45"/>
                  </a:lnTo>
                  <a:lnTo>
                    <a:pt x="747" y="45"/>
                  </a:lnTo>
                  <a:lnTo>
                    <a:pt x="747" y="45"/>
                  </a:lnTo>
                  <a:lnTo>
                    <a:pt x="748" y="45"/>
                  </a:lnTo>
                  <a:lnTo>
                    <a:pt x="748" y="44"/>
                  </a:lnTo>
                  <a:lnTo>
                    <a:pt x="749" y="44"/>
                  </a:lnTo>
                  <a:lnTo>
                    <a:pt x="749" y="44"/>
                  </a:lnTo>
                  <a:lnTo>
                    <a:pt x="750" y="44"/>
                  </a:lnTo>
                  <a:lnTo>
                    <a:pt x="751" y="43"/>
                  </a:lnTo>
                  <a:lnTo>
                    <a:pt x="751" y="43"/>
                  </a:lnTo>
                  <a:lnTo>
                    <a:pt x="752" y="43"/>
                  </a:lnTo>
                  <a:lnTo>
                    <a:pt x="752" y="43"/>
                  </a:lnTo>
                  <a:lnTo>
                    <a:pt x="753" y="42"/>
                  </a:lnTo>
                  <a:lnTo>
                    <a:pt x="753" y="42"/>
                  </a:lnTo>
                  <a:lnTo>
                    <a:pt x="754" y="42"/>
                  </a:lnTo>
                  <a:lnTo>
                    <a:pt x="754" y="41"/>
                  </a:lnTo>
                  <a:lnTo>
                    <a:pt x="755" y="41"/>
                  </a:lnTo>
                  <a:lnTo>
                    <a:pt x="755" y="41"/>
                  </a:lnTo>
                  <a:lnTo>
                    <a:pt x="756" y="40"/>
                  </a:lnTo>
                  <a:lnTo>
                    <a:pt x="757" y="40"/>
                  </a:lnTo>
                  <a:lnTo>
                    <a:pt x="757" y="40"/>
                  </a:lnTo>
                  <a:lnTo>
                    <a:pt x="758" y="39"/>
                  </a:lnTo>
                  <a:lnTo>
                    <a:pt x="759" y="39"/>
                  </a:lnTo>
                  <a:lnTo>
                    <a:pt x="759" y="38"/>
                  </a:lnTo>
                  <a:lnTo>
                    <a:pt x="760" y="38"/>
                  </a:lnTo>
                  <a:lnTo>
                    <a:pt x="761" y="37"/>
                  </a:lnTo>
                  <a:lnTo>
                    <a:pt x="761" y="36"/>
                  </a:lnTo>
                  <a:lnTo>
                    <a:pt x="762" y="36"/>
                  </a:lnTo>
                  <a:lnTo>
                    <a:pt x="763" y="35"/>
                  </a:lnTo>
                  <a:lnTo>
                    <a:pt x="764" y="34"/>
                  </a:lnTo>
                  <a:lnTo>
                    <a:pt x="765" y="34"/>
                  </a:lnTo>
                  <a:lnTo>
                    <a:pt x="765" y="33"/>
                  </a:lnTo>
                  <a:lnTo>
                    <a:pt x="766" y="32"/>
                  </a:lnTo>
                  <a:lnTo>
                    <a:pt x="767" y="31"/>
                  </a:lnTo>
                  <a:lnTo>
                    <a:pt x="768" y="30"/>
                  </a:lnTo>
                  <a:lnTo>
                    <a:pt x="769" y="29"/>
                  </a:lnTo>
                  <a:lnTo>
                    <a:pt x="770" y="28"/>
                  </a:lnTo>
                  <a:lnTo>
                    <a:pt x="771" y="27"/>
                  </a:lnTo>
                  <a:lnTo>
                    <a:pt x="772" y="26"/>
                  </a:lnTo>
                  <a:lnTo>
                    <a:pt x="773" y="24"/>
                  </a:lnTo>
                  <a:lnTo>
                    <a:pt x="774" y="24"/>
                  </a:lnTo>
                  <a:lnTo>
                    <a:pt x="774" y="23"/>
                  </a:lnTo>
                  <a:lnTo>
                    <a:pt x="774" y="23"/>
                  </a:lnTo>
                  <a:lnTo>
                    <a:pt x="774" y="23"/>
                  </a:lnTo>
                  <a:lnTo>
                    <a:pt x="774" y="23"/>
                  </a:lnTo>
                  <a:lnTo>
                    <a:pt x="774" y="23"/>
                  </a:lnTo>
                  <a:lnTo>
                    <a:pt x="774" y="22"/>
                  </a:lnTo>
                  <a:lnTo>
                    <a:pt x="775" y="22"/>
                  </a:lnTo>
                  <a:lnTo>
                    <a:pt x="775" y="22"/>
                  </a:lnTo>
                  <a:lnTo>
                    <a:pt x="775" y="22"/>
                  </a:lnTo>
                  <a:lnTo>
                    <a:pt x="775" y="22"/>
                  </a:lnTo>
                  <a:lnTo>
                    <a:pt x="775" y="22"/>
                  </a:lnTo>
                  <a:lnTo>
                    <a:pt x="775" y="22"/>
                  </a:lnTo>
                  <a:lnTo>
                    <a:pt x="775" y="21"/>
                  </a:lnTo>
                  <a:lnTo>
                    <a:pt x="776" y="21"/>
                  </a:lnTo>
                  <a:lnTo>
                    <a:pt x="777" y="19"/>
                  </a:lnTo>
                  <a:lnTo>
                    <a:pt x="779" y="17"/>
                  </a:lnTo>
                  <a:lnTo>
                    <a:pt x="781" y="15"/>
                  </a:lnTo>
                  <a:lnTo>
                    <a:pt x="782" y="13"/>
                  </a:lnTo>
                  <a:lnTo>
                    <a:pt x="783" y="11"/>
                  </a:lnTo>
                  <a:lnTo>
                    <a:pt x="785" y="10"/>
                  </a:lnTo>
                  <a:lnTo>
                    <a:pt x="786" y="9"/>
                  </a:lnTo>
                  <a:lnTo>
                    <a:pt x="787" y="8"/>
                  </a:lnTo>
                  <a:lnTo>
                    <a:pt x="788" y="7"/>
                  </a:lnTo>
                  <a:lnTo>
                    <a:pt x="788" y="6"/>
                  </a:lnTo>
                  <a:lnTo>
                    <a:pt x="789" y="5"/>
                  </a:lnTo>
                  <a:lnTo>
                    <a:pt x="790" y="5"/>
                  </a:lnTo>
                  <a:lnTo>
                    <a:pt x="791" y="4"/>
                  </a:lnTo>
                  <a:lnTo>
                    <a:pt x="792" y="3"/>
                  </a:lnTo>
                  <a:lnTo>
                    <a:pt x="792" y="2"/>
                  </a:lnTo>
                  <a:lnTo>
                    <a:pt x="793" y="2"/>
                  </a:lnTo>
                  <a:lnTo>
                    <a:pt x="794" y="2"/>
                  </a:lnTo>
                  <a:lnTo>
                    <a:pt x="795" y="1"/>
                  </a:lnTo>
                  <a:lnTo>
                    <a:pt x="796" y="1"/>
                  </a:lnTo>
                  <a:lnTo>
                    <a:pt x="796" y="0"/>
                  </a:lnTo>
                  <a:lnTo>
                    <a:pt x="797" y="0"/>
                  </a:lnTo>
                  <a:lnTo>
                    <a:pt x="798" y="0"/>
                  </a:lnTo>
                  <a:lnTo>
                    <a:pt x="798" y="0"/>
                  </a:lnTo>
                  <a:lnTo>
                    <a:pt x="799" y="0"/>
                  </a:lnTo>
                  <a:lnTo>
                    <a:pt x="800" y="0"/>
                  </a:lnTo>
                  <a:lnTo>
                    <a:pt x="801" y="0"/>
                  </a:lnTo>
                  <a:lnTo>
                    <a:pt x="801" y="0"/>
                  </a:lnTo>
                  <a:lnTo>
                    <a:pt x="802" y="0"/>
                  </a:lnTo>
                  <a:lnTo>
                    <a:pt x="803" y="0"/>
                  </a:lnTo>
                  <a:lnTo>
                    <a:pt x="804" y="0"/>
                  </a:lnTo>
                  <a:lnTo>
                    <a:pt x="804" y="0"/>
                  </a:lnTo>
                  <a:lnTo>
                    <a:pt x="804" y="0"/>
                  </a:lnTo>
                  <a:lnTo>
                    <a:pt x="805" y="0"/>
                  </a:lnTo>
                  <a:lnTo>
                    <a:pt x="805" y="0"/>
                  </a:lnTo>
                  <a:lnTo>
                    <a:pt x="805" y="0"/>
                  </a:lnTo>
                  <a:lnTo>
                    <a:pt x="806" y="0"/>
                  </a:lnTo>
                  <a:lnTo>
                    <a:pt x="806" y="0"/>
                  </a:lnTo>
                  <a:lnTo>
                    <a:pt x="807" y="1"/>
                  </a:lnTo>
                  <a:lnTo>
                    <a:pt x="808" y="1"/>
                  </a:lnTo>
                  <a:lnTo>
                    <a:pt x="809" y="1"/>
                  </a:lnTo>
                  <a:lnTo>
                    <a:pt x="810" y="2"/>
                  </a:lnTo>
                  <a:lnTo>
                    <a:pt x="810" y="2"/>
                  </a:lnTo>
                  <a:lnTo>
                    <a:pt x="811" y="3"/>
                  </a:lnTo>
                  <a:lnTo>
                    <a:pt x="812" y="3"/>
                  </a:lnTo>
                  <a:lnTo>
                    <a:pt x="813" y="4"/>
                  </a:lnTo>
                  <a:lnTo>
                    <a:pt x="814" y="5"/>
                  </a:lnTo>
                  <a:lnTo>
                    <a:pt x="815" y="6"/>
                  </a:lnTo>
                  <a:lnTo>
                    <a:pt x="816" y="7"/>
                  </a:lnTo>
                  <a:lnTo>
                    <a:pt x="818" y="8"/>
                  </a:lnTo>
                  <a:lnTo>
                    <a:pt x="819" y="9"/>
                  </a:lnTo>
                  <a:lnTo>
                    <a:pt x="820" y="10"/>
                  </a:lnTo>
                  <a:lnTo>
                    <a:pt x="821" y="11"/>
                  </a:lnTo>
                  <a:lnTo>
                    <a:pt x="823" y="13"/>
                  </a:lnTo>
                  <a:lnTo>
                    <a:pt x="825" y="15"/>
                  </a:lnTo>
                  <a:lnTo>
                    <a:pt x="827" y="17"/>
                  </a:lnTo>
                  <a:lnTo>
                    <a:pt x="829" y="20"/>
                  </a:lnTo>
                  <a:lnTo>
                    <a:pt x="831" y="22"/>
                  </a:lnTo>
                  <a:lnTo>
                    <a:pt x="832" y="23"/>
                  </a:lnTo>
                  <a:lnTo>
                    <a:pt x="833" y="24"/>
                  </a:lnTo>
                  <a:lnTo>
                    <a:pt x="833" y="24"/>
                  </a:lnTo>
                  <a:lnTo>
                    <a:pt x="834" y="25"/>
                  </a:lnTo>
                  <a:lnTo>
                    <a:pt x="834" y="25"/>
                  </a:lnTo>
                  <a:lnTo>
                    <a:pt x="834" y="25"/>
                  </a:lnTo>
                  <a:lnTo>
                    <a:pt x="835" y="25"/>
                  </a:lnTo>
                  <a:lnTo>
                    <a:pt x="835" y="26"/>
                  </a:lnTo>
                  <a:lnTo>
                    <a:pt x="835" y="26"/>
                  </a:lnTo>
                  <a:lnTo>
                    <a:pt x="835" y="26"/>
                  </a:lnTo>
                  <a:lnTo>
                    <a:pt x="835" y="26"/>
                  </a:lnTo>
                  <a:lnTo>
                    <a:pt x="836" y="26"/>
                  </a:lnTo>
                  <a:lnTo>
                    <a:pt x="836" y="27"/>
                  </a:lnTo>
                  <a:lnTo>
                    <a:pt x="838" y="28"/>
                  </a:lnTo>
                  <a:lnTo>
                    <a:pt x="839" y="30"/>
                  </a:lnTo>
                  <a:lnTo>
                    <a:pt x="840" y="30"/>
                  </a:lnTo>
                  <a:lnTo>
                    <a:pt x="841" y="32"/>
                  </a:lnTo>
                  <a:lnTo>
                    <a:pt x="842" y="33"/>
                  </a:lnTo>
                  <a:lnTo>
                    <a:pt x="843" y="33"/>
                  </a:lnTo>
                  <a:lnTo>
                    <a:pt x="844" y="34"/>
                  </a:lnTo>
                  <a:lnTo>
                    <a:pt x="845" y="35"/>
                  </a:lnTo>
                  <a:lnTo>
                    <a:pt x="846" y="36"/>
                  </a:lnTo>
                  <a:lnTo>
                    <a:pt x="847" y="37"/>
                  </a:lnTo>
                  <a:lnTo>
                    <a:pt x="848" y="38"/>
                  </a:lnTo>
                  <a:lnTo>
                    <a:pt x="849" y="38"/>
                  </a:lnTo>
                  <a:lnTo>
                    <a:pt x="850" y="39"/>
                  </a:lnTo>
                  <a:lnTo>
                    <a:pt x="851" y="40"/>
                  </a:lnTo>
                  <a:lnTo>
                    <a:pt x="852" y="40"/>
                  </a:lnTo>
                  <a:lnTo>
                    <a:pt x="853" y="41"/>
                  </a:lnTo>
                  <a:lnTo>
                    <a:pt x="853" y="41"/>
                  </a:lnTo>
                  <a:lnTo>
                    <a:pt x="854" y="42"/>
                  </a:lnTo>
                  <a:lnTo>
                    <a:pt x="855" y="42"/>
                  </a:lnTo>
                  <a:lnTo>
                    <a:pt x="856" y="43"/>
                  </a:lnTo>
                  <a:lnTo>
                    <a:pt x="856" y="43"/>
                  </a:lnTo>
                  <a:lnTo>
                    <a:pt x="857" y="44"/>
                  </a:lnTo>
                  <a:lnTo>
                    <a:pt x="858" y="44"/>
                  </a:lnTo>
                  <a:lnTo>
                    <a:pt x="859" y="45"/>
                  </a:lnTo>
                  <a:lnTo>
                    <a:pt x="860" y="45"/>
                  </a:lnTo>
                  <a:lnTo>
                    <a:pt x="860" y="45"/>
                  </a:lnTo>
                  <a:lnTo>
                    <a:pt x="861" y="46"/>
                  </a:lnTo>
                  <a:lnTo>
                    <a:pt x="862" y="46"/>
                  </a:lnTo>
                  <a:lnTo>
                    <a:pt x="862" y="47"/>
                  </a:lnTo>
                  <a:lnTo>
                    <a:pt x="863" y="47"/>
                  </a:lnTo>
                  <a:lnTo>
                    <a:pt x="863" y="47"/>
                  </a:lnTo>
                  <a:lnTo>
                    <a:pt x="864" y="47"/>
                  </a:lnTo>
                  <a:lnTo>
                    <a:pt x="864" y="48"/>
                  </a:lnTo>
                  <a:lnTo>
                    <a:pt x="865" y="48"/>
                  </a:lnTo>
                  <a:lnTo>
                    <a:pt x="865" y="48"/>
                  </a:lnTo>
                  <a:lnTo>
                    <a:pt x="865" y="48"/>
                  </a:lnTo>
                  <a:lnTo>
                    <a:pt x="865" y="48"/>
                  </a:lnTo>
                  <a:lnTo>
                    <a:pt x="866" y="48"/>
                  </a:lnTo>
                  <a:lnTo>
                    <a:pt x="867" y="49"/>
                  </a:lnTo>
                  <a:lnTo>
                    <a:pt x="868" y="49"/>
                  </a:lnTo>
                  <a:lnTo>
                    <a:pt x="869" y="49"/>
                  </a:lnTo>
                  <a:lnTo>
                    <a:pt x="869" y="50"/>
                  </a:lnTo>
                  <a:lnTo>
                    <a:pt x="870" y="50"/>
                  </a:lnTo>
                  <a:lnTo>
                    <a:pt x="871" y="50"/>
                  </a:lnTo>
                  <a:lnTo>
                    <a:pt x="872" y="51"/>
                  </a:lnTo>
                  <a:lnTo>
                    <a:pt x="872" y="51"/>
                  </a:lnTo>
                  <a:lnTo>
                    <a:pt x="873" y="51"/>
                  </a:lnTo>
                  <a:lnTo>
                    <a:pt x="874" y="51"/>
                  </a:lnTo>
                  <a:lnTo>
                    <a:pt x="874" y="52"/>
                  </a:lnTo>
                  <a:lnTo>
                    <a:pt x="875" y="52"/>
                  </a:lnTo>
                  <a:lnTo>
                    <a:pt x="876" y="52"/>
                  </a:lnTo>
                  <a:lnTo>
                    <a:pt x="876" y="52"/>
                  </a:lnTo>
                  <a:lnTo>
                    <a:pt x="877" y="53"/>
                  </a:lnTo>
                  <a:lnTo>
                    <a:pt x="878" y="53"/>
                  </a:lnTo>
                  <a:lnTo>
                    <a:pt x="878" y="53"/>
                  </a:lnTo>
                  <a:lnTo>
                    <a:pt x="879" y="53"/>
                  </a:lnTo>
                  <a:lnTo>
                    <a:pt x="880" y="53"/>
                  </a:lnTo>
                  <a:lnTo>
                    <a:pt x="881" y="53"/>
                  </a:lnTo>
                  <a:lnTo>
                    <a:pt x="881" y="54"/>
                  </a:lnTo>
                  <a:lnTo>
                    <a:pt x="882" y="54"/>
                  </a:lnTo>
                  <a:lnTo>
                    <a:pt x="883" y="54"/>
                  </a:lnTo>
                  <a:lnTo>
                    <a:pt x="884" y="54"/>
                  </a:lnTo>
                  <a:lnTo>
                    <a:pt x="884" y="55"/>
                  </a:lnTo>
                  <a:lnTo>
                    <a:pt x="885" y="55"/>
                  </a:lnTo>
                  <a:lnTo>
                    <a:pt x="886" y="55"/>
                  </a:lnTo>
                  <a:lnTo>
                    <a:pt x="887" y="55"/>
                  </a:lnTo>
                  <a:lnTo>
                    <a:pt x="888" y="55"/>
                  </a:lnTo>
                  <a:lnTo>
                    <a:pt x="889" y="55"/>
                  </a:lnTo>
                  <a:lnTo>
                    <a:pt x="889" y="55"/>
                  </a:lnTo>
                  <a:lnTo>
                    <a:pt x="890" y="56"/>
                  </a:lnTo>
                  <a:lnTo>
                    <a:pt x="891" y="56"/>
                  </a:lnTo>
                  <a:lnTo>
                    <a:pt x="891" y="56"/>
                  </a:lnTo>
                  <a:lnTo>
                    <a:pt x="892" y="56"/>
                  </a:lnTo>
                  <a:lnTo>
                    <a:pt x="893" y="56"/>
                  </a:lnTo>
                  <a:lnTo>
                    <a:pt x="893" y="56"/>
                  </a:lnTo>
                  <a:lnTo>
                    <a:pt x="894" y="56"/>
                  </a:lnTo>
                  <a:lnTo>
                    <a:pt x="894" y="56"/>
                  </a:lnTo>
                  <a:lnTo>
                    <a:pt x="894" y="56"/>
                  </a:lnTo>
                  <a:lnTo>
                    <a:pt x="895" y="56"/>
                  </a:lnTo>
                  <a:lnTo>
                    <a:pt x="895" y="57"/>
                  </a:lnTo>
                  <a:lnTo>
                    <a:pt x="895" y="57"/>
                  </a:lnTo>
                  <a:lnTo>
                    <a:pt x="896" y="57"/>
                  </a:lnTo>
                  <a:lnTo>
                    <a:pt x="897" y="57"/>
                  </a:lnTo>
                  <a:lnTo>
                    <a:pt x="898" y="57"/>
                  </a:lnTo>
                  <a:lnTo>
                    <a:pt x="899" y="57"/>
                  </a:lnTo>
                  <a:lnTo>
                    <a:pt x="900" y="57"/>
                  </a:lnTo>
                  <a:lnTo>
                    <a:pt x="901" y="57"/>
                  </a:lnTo>
                  <a:lnTo>
                    <a:pt x="902" y="58"/>
                  </a:lnTo>
                  <a:lnTo>
                    <a:pt x="903" y="58"/>
                  </a:lnTo>
                  <a:lnTo>
                    <a:pt x="904" y="58"/>
                  </a:lnTo>
                  <a:lnTo>
                    <a:pt x="905" y="58"/>
                  </a:lnTo>
                  <a:lnTo>
                    <a:pt x="906" y="58"/>
                  </a:lnTo>
                  <a:lnTo>
                    <a:pt x="907" y="58"/>
                  </a:lnTo>
                  <a:lnTo>
                    <a:pt x="908" y="58"/>
                  </a:lnTo>
                  <a:lnTo>
                    <a:pt x="909" y="58"/>
                  </a:lnTo>
                  <a:lnTo>
                    <a:pt x="910" y="58"/>
                  </a:lnTo>
                  <a:lnTo>
                    <a:pt x="911" y="58"/>
                  </a:lnTo>
                  <a:lnTo>
                    <a:pt x="912" y="59"/>
                  </a:lnTo>
                  <a:lnTo>
                    <a:pt x="913" y="59"/>
                  </a:lnTo>
                  <a:lnTo>
                    <a:pt x="914" y="59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8" name="Freeform 294">
              <a:extLst>
                <a:ext uri="{FF2B5EF4-FFF2-40B4-BE49-F238E27FC236}">
                  <a16:creationId xmlns:a16="http://schemas.microsoft.com/office/drawing/2014/main" id="{963E72F2-71B9-4ED3-B3C9-C6DB565E86A8}"/>
                </a:ext>
              </a:extLst>
            </p:cNvPr>
            <p:cNvSpPr>
              <a:spLocks/>
            </p:cNvSpPr>
            <p:nvPr/>
          </p:nvSpPr>
          <p:spPr bwMode="auto">
            <a:xfrm>
              <a:off x="6064250" y="3683001"/>
              <a:ext cx="119063" cy="3175"/>
            </a:xfrm>
            <a:custGeom>
              <a:avLst/>
              <a:gdLst>
                <a:gd name="T0" fmla="*/ 0 w 75"/>
                <a:gd name="T1" fmla="*/ 0 h 2"/>
                <a:gd name="T2" fmla="*/ 1 w 75"/>
                <a:gd name="T3" fmla="*/ 0 h 2"/>
                <a:gd name="T4" fmla="*/ 2 w 75"/>
                <a:gd name="T5" fmla="*/ 0 h 2"/>
                <a:gd name="T6" fmla="*/ 4 w 75"/>
                <a:gd name="T7" fmla="*/ 0 h 2"/>
                <a:gd name="T8" fmla="*/ 5 w 75"/>
                <a:gd name="T9" fmla="*/ 0 h 2"/>
                <a:gd name="T10" fmla="*/ 6 w 75"/>
                <a:gd name="T11" fmla="*/ 0 h 2"/>
                <a:gd name="T12" fmla="*/ 7 w 75"/>
                <a:gd name="T13" fmla="*/ 0 h 2"/>
                <a:gd name="T14" fmla="*/ 8 w 75"/>
                <a:gd name="T15" fmla="*/ 0 h 2"/>
                <a:gd name="T16" fmla="*/ 8 w 75"/>
                <a:gd name="T17" fmla="*/ 0 h 2"/>
                <a:gd name="T18" fmla="*/ 9 w 75"/>
                <a:gd name="T19" fmla="*/ 0 h 2"/>
                <a:gd name="T20" fmla="*/ 10 w 75"/>
                <a:gd name="T21" fmla="*/ 1 h 2"/>
                <a:gd name="T22" fmla="*/ 10 w 75"/>
                <a:gd name="T23" fmla="*/ 1 h 2"/>
                <a:gd name="T24" fmla="*/ 10 w 75"/>
                <a:gd name="T25" fmla="*/ 1 h 2"/>
                <a:gd name="T26" fmla="*/ 11 w 75"/>
                <a:gd name="T27" fmla="*/ 1 h 2"/>
                <a:gd name="T28" fmla="*/ 13 w 75"/>
                <a:gd name="T29" fmla="*/ 1 h 2"/>
                <a:gd name="T30" fmla="*/ 14 w 75"/>
                <a:gd name="T31" fmla="*/ 1 h 2"/>
                <a:gd name="T32" fmla="*/ 16 w 75"/>
                <a:gd name="T33" fmla="*/ 1 h 2"/>
                <a:gd name="T34" fmla="*/ 18 w 75"/>
                <a:gd name="T35" fmla="*/ 1 h 2"/>
                <a:gd name="T36" fmla="*/ 20 w 75"/>
                <a:gd name="T37" fmla="*/ 1 h 2"/>
                <a:gd name="T38" fmla="*/ 21 w 75"/>
                <a:gd name="T39" fmla="*/ 1 h 2"/>
                <a:gd name="T40" fmla="*/ 23 w 75"/>
                <a:gd name="T41" fmla="*/ 1 h 2"/>
                <a:gd name="T42" fmla="*/ 24 w 75"/>
                <a:gd name="T43" fmla="*/ 1 h 2"/>
                <a:gd name="T44" fmla="*/ 26 w 75"/>
                <a:gd name="T45" fmla="*/ 1 h 2"/>
                <a:gd name="T46" fmla="*/ 27 w 75"/>
                <a:gd name="T47" fmla="*/ 1 h 2"/>
                <a:gd name="T48" fmla="*/ 29 w 75"/>
                <a:gd name="T49" fmla="*/ 1 h 2"/>
                <a:gd name="T50" fmla="*/ 30 w 75"/>
                <a:gd name="T51" fmla="*/ 1 h 2"/>
                <a:gd name="T52" fmla="*/ 32 w 75"/>
                <a:gd name="T53" fmla="*/ 1 h 2"/>
                <a:gd name="T54" fmla="*/ 34 w 75"/>
                <a:gd name="T55" fmla="*/ 1 h 2"/>
                <a:gd name="T56" fmla="*/ 35 w 75"/>
                <a:gd name="T57" fmla="*/ 2 h 2"/>
                <a:gd name="T58" fmla="*/ 37 w 75"/>
                <a:gd name="T59" fmla="*/ 2 h 2"/>
                <a:gd name="T60" fmla="*/ 38 w 75"/>
                <a:gd name="T61" fmla="*/ 2 h 2"/>
                <a:gd name="T62" fmla="*/ 39 w 75"/>
                <a:gd name="T63" fmla="*/ 2 h 2"/>
                <a:gd name="T64" fmla="*/ 41 w 75"/>
                <a:gd name="T65" fmla="*/ 2 h 2"/>
                <a:gd name="T66" fmla="*/ 42 w 75"/>
                <a:gd name="T67" fmla="*/ 2 h 2"/>
                <a:gd name="T68" fmla="*/ 44 w 75"/>
                <a:gd name="T69" fmla="*/ 2 h 2"/>
                <a:gd name="T70" fmla="*/ 45 w 75"/>
                <a:gd name="T71" fmla="*/ 2 h 2"/>
                <a:gd name="T72" fmla="*/ 47 w 75"/>
                <a:gd name="T73" fmla="*/ 2 h 2"/>
                <a:gd name="T74" fmla="*/ 49 w 75"/>
                <a:gd name="T75" fmla="*/ 2 h 2"/>
                <a:gd name="T76" fmla="*/ 51 w 75"/>
                <a:gd name="T77" fmla="*/ 2 h 2"/>
                <a:gd name="T78" fmla="*/ 53 w 75"/>
                <a:gd name="T79" fmla="*/ 2 h 2"/>
                <a:gd name="T80" fmla="*/ 54 w 75"/>
                <a:gd name="T81" fmla="*/ 2 h 2"/>
                <a:gd name="T82" fmla="*/ 56 w 75"/>
                <a:gd name="T83" fmla="*/ 2 h 2"/>
                <a:gd name="T84" fmla="*/ 57 w 75"/>
                <a:gd name="T85" fmla="*/ 2 h 2"/>
                <a:gd name="T86" fmla="*/ 59 w 75"/>
                <a:gd name="T87" fmla="*/ 2 h 2"/>
                <a:gd name="T88" fmla="*/ 60 w 75"/>
                <a:gd name="T89" fmla="*/ 2 h 2"/>
                <a:gd name="T90" fmla="*/ 61 w 75"/>
                <a:gd name="T91" fmla="*/ 2 h 2"/>
                <a:gd name="T92" fmla="*/ 63 w 75"/>
                <a:gd name="T93" fmla="*/ 2 h 2"/>
                <a:gd name="T94" fmla="*/ 64 w 75"/>
                <a:gd name="T95" fmla="*/ 2 h 2"/>
                <a:gd name="T96" fmla="*/ 66 w 75"/>
                <a:gd name="T97" fmla="*/ 2 h 2"/>
                <a:gd name="T98" fmla="*/ 67 w 75"/>
                <a:gd name="T99" fmla="*/ 2 h 2"/>
                <a:gd name="T100" fmla="*/ 69 w 75"/>
                <a:gd name="T101" fmla="*/ 2 h 2"/>
                <a:gd name="T102" fmla="*/ 70 w 75"/>
                <a:gd name="T103" fmla="*/ 2 h 2"/>
                <a:gd name="T104" fmla="*/ 72 w 75"/>
                <a:gd name="T105" fmla="*/ 2 h 2"/>
                <a:gd name="T106" fmla="*/ 73 w 75"/>
                <a:gd name="T107" fmla="*/ 2 h 2"/>
                <a:gd name="T108" fmla="*/ 74 w 75"/>
                <a:gd name="T109" fmla="*/ 2 h 2"/>
                <a:gd name="T110" fmla="*/ 75 w 75"/>
                <a:gd name="T111" fmla="*/ 2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75" h="2">
                  <a:moveTo>
                    <a:pt x="0" y="0"/>
                  </a:moveTo>
                  <a:lnTo>
                    <a:pt x="1" y="0"/>
                  </a:lnTo>
                  <a:lnTo>
                    <a:pt x="2" y="0"/>
                  </a:lnTo>
                  <a:lnTo>
                    <a:pt x="4" y="0"/>
                  </a:lnTo>
                  <a:lnTo>
                    <a:pt x="5" y="0"/>
                  </a:lnTo>
                  <a:lnTo>
                    <a:pt x="6" y="0"/>
                  </a:lnTo>
                  <a:lnTo>
                    <a:pt x="7" y="0"/>
                  </a:lnTo>
                  <a:lnTo>
                    <a:pt x="8" y="0"/>
                  </a:lnTo>
                  <a:lnTo>
                    <a:pt x="8" y="0"/>
                  </a:lnTo>
                  <a:lnTo>
                    <a:pt x="9" y="0"/>
                  </a:lnTo>
                  <a:lnTo>
                    <a:pt x="10" y="1"/>
                  </a:lnTo>
                  <a:lnTo>
                    <a:pt x="10" y="1"/>
                  </a:lnTo>
                  <a:lnTo>
                    <a:pt x="10" y="1"/>
                  </a:lnTo>
                  <a:lnTo>
                    <a:pt x="11" y="1"/>
                  </a:lnTo>
                  <a:lnTo>
                    <a:pt x="13" y="1"/>
                  </a:lnTo>
                  <a:lnTo>
                    <a:pt x="14" y="1"/>
                  </a:lnTo>
                  <a:lnTo>
                    <a:pt x="16" y="1"/>
                  </a:lnTo>
                  <a:lnTo>
                    <a:pt x="18" y="1"/>
                  </a:lnTo>
                  <a:lnTo>
                    <a:pt x="20" y="1"/>
                  </a:lnTo>
                  <a:lnTo>
                    <a:pt x="21" y="1"/>
                  </a:lnTo>
                  <a:lnTo>
                    <a:pt x="23" y="1"/>
                  </a:lnTo>
                  <a:lnTo>
                    <a:pt x="24" y="1"/>
                  </a:lnTo>
                  <a:lnTo>
                    <a:pt x="26" y="1"/>
                  </a:lnTo>
                  <a:lnTo>
                    <a:pt x="27" y="1"/>
                  </a:lnTo>
                  <a:lnTo>
                    <a:pt x="29" y="1"/>
                  </a:lnTo>
                  <a:lnTo>
                    <a:pt x="30" y="1"/>
                  </a:lnTo>
                  <a:lnTo>
                    <a:pt x="32" y="1"/>
                  </a:lnTo>
                  <a:lnTo>
                    <a:pt x="34" y="1"/>
                  </a:lnTo>
                  <a:lnTo>
                    <a:pt x="35" y="2"/>
                  </a:lnTo>
                  <a:lnTo>
                    <a:pt x="37" y="2"/>
                  </a:lnTo>
                  <a:lnTo>
                    <a:pt x="38" y="2"/>
                  </a:lnTo>
                  <a:lnTo>
                    <a:pt x="39" y="2"/>
                  </a:lnTo>
                  <a:lnTo>
                    <a:pt x="41" y="2"/>
                  </a:lnTo>
                  <a:lnTo>
                    <a:pt x="42" y="2"/>
                  </a:lnTo>
                  <a:lnTo>
                    <a:pt x="44" y="2"/>
                  </a:lnTo>
                  <a:lnTo>
                    <a:pt x="45" y="2"/>
                  </a:lnTo>
                  <a:lnTo>
                    <a:pt x="47" y="2"/>
                  </a:lnTo>
                  <a:lnTo>
                    <a:pt x="49" y="2"/>
                  </a:lnTo>
                  <a:lnTo>
                    <a:pt x="51" y="2"/>
                  </a:lnTo>
                  <a:lnTo>
                    <a:pt x="53" y="2"/>
                  </a:lnTo>
                  <a:lnTo>
                    <a:pt x="54" y="2"/>
                  </a:lnTo>
                  <a:lnTo>
                    <a:pt x="56" y="2"/>
                  </a:lnTo>
                  <a:lnTo>
                    <a:pt x="57" y="2"/>
                  </a:lnTo>
                  <a:lnTo>
                    <a:pt x="59" y="2"/>
                  </a:lnTo>
                  <a:lnTo>
                    <a:pt x="60" y="2"/>
                  </a:lnTo>
                  <a:lnTo>
                    <a:pt x="61" y="2"/>
                  </a:lnTo>
                  <a:lnTo>
                    <a:pt x="63" y="2"/>
                  </a:lnTo>
                  <a:lnTo>
                    <a:pt x="64" y="2"/>
                  </a:lnTo>
                  <a:lnTo>
                    <a:pt x="66" y="2"/>
                  </a:lnTo>
                  <a:lnTo>
                    <a:pt x="67" y="2"/>
                  </a:lnTo>
                  <a:lnTo>
                    <a:pt x="69" y="2"/>
                  </a:lnTo>
                  <a:lnTo>
                    <a:pt x="70" y="2"/>
                  </a:lnTo>
                  <a:lnTo>
                    <a:pt x="72" y="2"/>
                  </a:lnTo>
                  <a:lnTo>
                    <a:pt x="73" y="2"/>
                  </a:lnTo>
                  <a:lnTo>
                    <a:pt x="74" y="2"/>
                  </a:lnTo>
                  <a:lnTo>
                    <a:pt x="75" y="2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6866D520-53BA-4589-B7DC-5364AF15FE32}"/>
                </a:ext>
              </a:extLst>
            </p:cNvPr>
            <p:cNvSpPr txBox="1"/>
            <p:nvPr/>
          </p:nvSpPr>
          <p:spPr>
            <a:xfrm rot="16200000">
              <a:off x="-814346" y="2539097"/>
              <a:ext cx="1629226" cy="3615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itchFamily="34" charset="0"/>
                  <a:cs typeface="Arial" pitchFamily="34" charset="0"/>
                </a:rPr>
                <a:t>Intensity (</a:t>
              </a:r>
              <a:r>
                <a:rPr lang="en-US" sz="1100" dirty="0" err="1">
                  <a:latin typeface="Arial" pitchFamily="34" charset="0"/>
                  <a:cs typeface="Arial" pitchFamily="34" charset="0"/>
                </a:rPr>
                <a:t>mAU</a:t>
              </a:r>
              <a:r>
                <a:rPr lang="en-US" sz="1100" dirty="0">
                  <a:latin typeface="Arial" pitchFamily="34" charset="0"/>
                  <a:cs typeface="Arial" pitchFamily="34" charset="0"/>
                </a:rPr>
                <a:t>)</a:t>
              </a: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1D25C9A3-9D47-4807-AA40-B475A1F59B28}"/>
                </a:ext>
              </a:extLst>
            </p:cNvPr>
            <p:cNvSpPr txBox="1"/>
            <p:nvPr/>
          </p:nvSpPr>
          <p:spPr>
            <a:xfrm>
              <a:off x="2108488" y="4070198"/>
              <a:ext cx="2824163" cy="3000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itchFamily="34" charset="0"/>
                  <a:cs typeface="Arial" pitchFamily="34" charset="0"/>
                </a:rPr>
                <a:t>Retention time (min)</a:t>
              </a:r>
            </a:p>
          </p:txBody>
        </p:sp>
      </p:grpSp>
      <p:sp>
        <p:nvSpPr>
          <p:cNvPr id="201" name="TextBox 200">
            <a:extLst>
              <a:ext uri="{FF2B5EF4-FFF2-40B4-BE49-F238E27FC236}">
                <a16:creationId xmlns:a16="http://schemas.microsoft.com/office/drawing/2014/main" id="{B5609F7F-E481-43E1-A240-44833E86B1C5}"/>
              </a:ext>
            </a:extLst>
          </p:cNvPr>
          <p:cNvSpPr txBox="1"/>
          <p:nvPr/>
        </p:nvSpPr>
        <p:spPr>
          <a:xfrm>
            <a:off x="1508712" y="7329264"/>
            <a:ext cx="11401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561 </a:t>
            </a:r>
            <a:r>
              <a:rPr lang="en-US" sz="1000" dirty="0" err="1">
                <a:latin typeface="Arial" pitchFamily="34" charset="0"/>
                <a:cs typeface="Arial" pitchFamily="34" charset="0"/>
              </a:rPr>
              <a:t>bp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 dsRNA </a:t>
            </a:r>
          </a:p>
        </p:txBody>
      </p:sp>
    </p:spTree>
    <p:extLst>
      <p:ext uri="{BB962C8B-B14F-4D97-AF65-F5344CB8AC3E}">
        <p14:creationId xmlns:p14="http://schemas.microsoft.com/office/powerpoint/2010/main" val="6909960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117FC27-B140-42E4-8548-49EEE2C27552}"/>
              </a:ext>
            </a:extLst>
          </p:cNvPr>
          <p:cNvSpPr/>
          <p:nvPr/>
        </p:nvSpPr>
        <p:spPr>
          <a:xfrm>
            <a:off x="404664" y="704528"/>
            <a:ext cx="5890964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itchFamily="34" charset="0"/>
                <a:cs typeface="Arial" pitchFamily="34" charset="0"/>
              </a:rPr>
              <a:t>Supplementary Fig.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1.IP RP HPLC analysis of the purified </a:t>
            </a:r>
            <a:r>
              <a:rPr lang="en-GB" sz="1200" i="1" dirty="0" smtClean="0">
                <a:latin typeface="Arial" pitchFamily="34" charset="0"/>
                <a:cs typeface="Arial" pitchFamily="34" charset="0"/>
              </a:rPr>
              <a:t>in vitro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transcribed RNA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.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A/B) IP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RP analysis of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a 521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nt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ssRN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its complement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strand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. 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P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urity based on the UV chromatogram was determined as 99. 46% and 98.81%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respectively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.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C/D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IP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RP HPLC analysis of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the 686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bp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561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p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dsRNA.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IP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RP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HPLC was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performed using Buffer A 0.1 M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triethylammonium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acetate (TEAA) pH 7.0 (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Fluka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, UK); Buffer B 0.1 M TEAA, pH 7.0 containing 25% acetonitrile (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ThermoFisher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). RNA was analysed using the following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gradient.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S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tarting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at 22% buffer B to 27% in 2 minutes, followed by a linear extension to 62% buffer B over 15 minutes, then extended to 73% buffer B over 2.5 minutes at a flow rate of 1.0 ml/min at 50 °C. </a:t>
            </a:r>
            <a:endParaRPr lang="en-GB" sz="1200" dirty="0" smtClean="0">
              <a:latin typeface="Arial" pitchFamily="34" charset="0"/>
              <a:cs typeface="Arial" pitchFamily="34" charset="0"/>
            </a:endParaRPr>
          </a:p>
          <a:p>
            <a:endParaRPr lang="en-GB" sz="1200" dirty="0">
              <a:latin typeface="Arial" pitchFamily="34" charset="0"/>
              <a:cs typeface="Arial" pitchFamily="34" charset="0"/>
            </a:endParaRPr>
          </a:p>
          <a:p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21019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Rectangle 86">
            <a:extLst>
              <a:ext uri="{FF2B5EF4-FFF2-40B4-BE49-F238E27FC236}">
                <a16:creationId xmlns:a16="http://schemas.microsoft.com/office/drawing/2014/main" id="{B117FC27-B140-42E4-8548-49EEE2C27552}"/>
              </a:ext>
            </a:extLst>
          </p:cNvPr>
          <p:cNvSpPr/>
          <p:nvPr/>
        </p:nvSpPr>
        <p:spPr>
          <a:xfrm>
            <a:off x="541601" y="4863637"/>
            <a:ext cx="5890964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GB" sz="1200" dirty="0">
              <a:latin typeface="Arial" pitchFamily="34" charset="0"/>
              <a:cs typeface="Arial" pitchFamily="34" charset="0"/>
            </a:endParaRPr>
          </a:p>
          <a:p>
            <a:endParaRPr lang="en-GB" sz="1200" dirty="0" smtClean="0">
              <a:latin typeface="Arial" pitchFamily="34" charset="0"/>
              <a:cs typeface="Arial" pitchFamily="34" charset="0"/>
            </a:endParaRPr>
          </a:p>
          <a:p>
            <a:endParaRPr lang="en-GB" sz="1200" dirty="0">
              <a:latin typeface="Arial" pitchFamily="34" charset="0"/>
              <a:cs typeface="Arial" pitchFamily="34" charset="0"/>
            </a:endParaRPr>
          </a:p>
          <a:p>
            <a:endParaRPr lang="en-GB" sz="1200" dirty="0" smtClean="0">
              <a:latin typeface="Arial" pitchFamily="34" charset="0"/>
              <a:cs typeface="Arial" pitchFamily="34" charset="0"/>
            </a:endParaRPr>
          </a:p>
          <a:p>
            <a:endParaRPr lang="en-GB" sz="1200" dirty="0">
              <a:latin typeface="Arial" pitchFamily="34" charset="0"/>
              <a:cs typeface="Arial" pitchFamily="34" charset="0"/>
            </a:endParaRPr>
          </a:p>
          <a:p>
            <a:endParaRPr lang="en-GB" sz="1200" dirty="0" smtClean="0">
              <a:latin typeface="Arial" pitchFamily="34" charset="0"/>
              <a:cs typeface="Arial" pitchFamily="34" charset="0"/>
            </a:endParaRPr>
          </a:p>
          <a:p>
            <a:endParaRPr lang="en-GB" sz="1200" dirty="0">
              <a:latin typeface="Arial" pitchFamily="34" charset="0"/>
              <a:cs typeface="Arial" pitchFamily="34" charset="0"/>
            </a:endParaRPr>
          </a:p>
          <a:p>
            <a:r>
              <a:rPr lang="en-GB" sz="1200" dirty="0">
                <a:latin typeface="Arial" pitchFamily="34" charset="0"/>
                <a:cs typeface="Arial" pitchFamily="34" charset="0"/>
              </a:rPr>
              <a:t>Supplementary Fig.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2. Analysis of 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dsRN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expressed in </a:t>
            </a:r>
            <a:r>
              <a:rPr lang="en-GB" sz="1200" i="1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en-GB" sz="1200" i="1" dirty="0">
                <a:latin typeface="Arial" pitchFamily="34" charset="0"/>
                <a:cs typeface="Arial" pitchFamily="34" charset="0"/>
              </a:rPr>
              <a:t>. </a:t>
            </a:r>
            <a:r>
              <a:rPr lang="en-GB" sz="1200" i="1" dirty="0" smtClean="0">
                <a:latin typeface="Arial" pitchFamily="34" charset="0"/>
                <a:cs typeface="Arial" pitchFamily="34" charset="0"/>
              </a:rPr>
              <a:t>coli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.  (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A) Agarose gel electrophoresis of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481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bp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dsRN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expressed in </a:t>
            </a:r>
            <a:r>
              <a:rPr lang="en-GB" sz="1200" i="1" dirty="0">
                <a:latin typeface="Arial" pitchFamily="34" charset="0"/>
                <a:cs typeface="Arial" pitchFamily="34" charset="0"/>
              </a:rPr>
              <a:t>E. </a:t>
            </a:r>
            <a:r>
              <a:rPr lang="en-GB" sz="1200" i="1" dirty="0" smtClean="0">
                <a:latin typeface="Arial" pitchFamily="34" charset="0"/>
                <a:cs typeface="Arial" pitchFamily="34" charset="0"/>
              </a:rPr>
              <a:t>coli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HT115 cells and purified using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RNASwift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. Each lane corresponds to the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dsRNA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purified from different </a:t>
            </a:r>
            <a:r>
              <a:rPr lang="en-GB" sz="1200" i="1" dirty="0" smtClean="0">
                <a:latin typeface="Arial" pitchFamily="34" charset="0"/>
                <a:cs typeface="Arial" pitchFamily="34" charset="0"/>
              </a:rPr>
              <a:t>E. coli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batches. B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) IP RP HPLC analysis of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th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urified 481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bp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dsRNA. IP RP HPLC was performed using Buffer A 0.1 M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triethylammonium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acetate (TEAA) pH 7.0 (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Fluka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, UK); Buffer B 0.1 M TEAA, pH 7.0 containing 25% acetonitrile (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ThermoFisher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). RNA was analysed using the following gradient. Starting at 22% buffer B to 27% in 2 minutes, followed by a linear extension to 62% buffer B over 15 minutes, then extended to 73% buffer B over 2.5 minutes at a flow rate of 1.0 ml/min at 50 °C. </a:t>
            </a:r>
          </a:p>
          <a:p>
            <a:endParaRPr lang="en-GB" sz="1200" dirty="0">
              <a:latin typeface="Arial" pitchFamily="34" charset="0"/>
              <a:cs typeface="Arial" pitchFamily="34" charset="0"/>
            </a:endParaRPr>
          </a:p>
          <a:p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0" name="Group 99"/>
          <p:cNvGrpSpPr/>
          <p:nvPr/>
        </p:nvGrpSpPr>
        <p:grpSpPr>
          <a:xfrm>
            <a:off x="878150" y="2360712"/>
            <a:ext cx="4753025" cy="2389832"/>
            <a:chOff x="247533" y="3335066"/>
            <a:chExt cx="5188465" cy="2333816"/>
          </a:xfrm>
        </p:grpSpPr>
        <p:sp>
          <p:nvSpPr>
            <p:cNvPr id="101" name="Rectangle 6"/>
            <p:cNvSpPr>
              <a:spLocks noChangeArrowheads="1"/>
            </p:cNvSpPr>
            <p:nvPr/>
          </p:nvSpPr>
          <p:spPr bwMode="auto">
            <a:xfrm>
              <a:off x="732509" y="5273901"/>
              <a:ext cx="157487" cy="118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0.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02" name="Line 7"/>
            <p:cNvSpPr>
              <a:spLocks noChangeShapeType="1"/>
            </p:cNvSpPr>
            <p:nvPr/>
          </p:nvSpPr>
          <p:spPr bwMode="auto">
            <a:xfrm>
              <a:off x="777164" y="5222712"/>
              <a:ext cx="0" cy="5119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" name="Rectangle 30"/>
            <p:cNvSpPr>
              <a:spLocks noChangeArrowheads="1"/>
            </p:cNvSpPr>
            <p:nvPr/>
          </p:nvSpPr>
          <p:spPr bwMode="auto">
            <a:xfrm>
              <a:off x="1705025" y="5273901"/>
              <a:ext cx="157487" cy="118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5.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04" name="Line 31"/>
            <p:cNvSpPr>
              <a:spLocks noChangeShapeType="1"/>
            </p:cNvSpPr>
            <p:nvPr/>
          </p:nvSpPr>
          <p:spPr bwMode="auto">
            <a:xfrm>
              <a:off x="1749682" y="5222712"/>
              <a:ext cx="0" cy="5119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" name="Rectangle 54"/>
            <p:cNvSpPr>
              <a:spLocks noChangeArrowheads="1"/>
            </p:cNvSpPr>
            <p:nvPr/>
          </p:nvSpPr>
          <p:spPr bwMode="auto">
            <a:xfrm>
              <a:off x="2665138" y="5273901"/>
              <a:ext cx="220482" cy="118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.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06" name="Line 55"/>
            <p:cNvSpPr>
              <a:spLocks noChangeShapeType="1"/>
            </p:cNvSpPr>
            <p:nvPr/>
          </p:nvSpPr>
          <p:spPr bwMode="auto">
            <a:xfrm>
              <a:off x="2723440" y="5222712"/>
              <a:ext cx="0" cy="5119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" name="Rectangle 78"/>
            <p:cNvSpPr>
              <a:spLocks noChangeArrowheads="1"/>
            </p:cNvSpPr>
            <p:nvPr/>
          </p:nvSpPr>
          <p:spPr bwMode="auto">
            <a:xfrm>
              <a:off x="3638897" y="5273901"/>
              <a:ext cx="220482" cy="118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5.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08" name="Line 79"/>
            <p:cNvSpPr>
              <a:spLocks noChangeShapeType="1"/>
            </p:cNvSpPr>
            <p:nvPr/>
          </p:nvSpPr>
          <p:spPr bwMode="auto">
            <a:xfrm>
              <a:off x="3697198" y="5222712"/>
              <a:ext cx="0" cy="5119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Rectangle 102"/>
            <p:cNvSpPr>
              <a:spLocks noChangeArrowheads="1"/>
            </p:cNvSpPr>
            <p:nvPr/>
          </p:nvSpPr>
          <p:spPr bwMode="auto">
            <a:xfrm>
              <a:off x="4612655" y="5273901"/>
              <a:ext cx="220482" cy="118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20.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0" name="Line 103"/>
            <p:cNvSpPr>
              <a:spLocks noChangeShapeType="1"/>
            </p:cNvSpPr>
            <p:nvPr/>
          </p:nvSpPr>
          <p:spPr bwMode="auto">
            <a:xfrm>
              <a:off x="4670956" y="5222712"/>
              <a:ext cx="0" cy="5119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Rectangle 117"/>
            <p:cNvSpPr>
              <a:spLocks noChangeArrowheads="1"/>
            </p:cNvSpPr>
            <p:nvPr/>
          </p:nvSpPr>
          <p:spPr bwMode="auto">
            <a:xfrm>
              <a:off x="5215516" y="5273901"/>
              <a:ext cx="220482" cy="118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23.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2" name="Line 118"/>
            <p:cNvSpPr>
              <a:spLocks noChangeShapeType="1"/>
            </p:cNvSpPr>
            <p:nvPr/>
          </p:nvSpPr>
          <p:spPr bwMode="auto">
            <a:xfrm>
              <a:off x="5273818" y="5222712"/>
              <a:ext cx="0" cy="5119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Rectangle 119"/>
            <p:cNvSpPr>
              <a:spLocks noChangeArrowheads="1"/>
            </p:cNvSpPr>
            <p:nvPr/>
          </p:nvSpPr>
          <p:spPr bwMode="auto">
            <a:xfrm>
              <a:off x="777164" y="3387758"/>
              <a:ext cx="4496654" cy="1834953"/>
            </a:xfrm>
            <a:prstGeom prst="rect">
              <a:avLst/>
            </a:prstGeom>
            <a:noFill/>
            <a:ln w="3175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Rectangle 120"/>
            <p:cNvSpPr>
              <a:spLocks noChangeArrowheads="1"/>
            </p:cNvSpPr>
            <p:nvPr/>
          </p:nvSpPr>
          <p:spPr bwMode="auto">
            <a:xfrm>
              <a:off x="655600" y="5171522"/>
              <a:ext cx="162738" cy="118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-2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5" name="Line 121"/>
            <p:cNvSpPr>
              <a:spLocks noChangeShapeType="1"/>
            </p:cNvSpPr>
            <p:nvPr/>
          </p:nvSpPr>
          <p:spPr bwMode="auto">
            <a:xfrm flipH="1">
              <a:off x="747393" y="5222712"/>
              <a:ext cx="29771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" name="Rectangle 128"/>
            <p:cNvSpPr>
              <a:spLocks noChangeArrowheads="1"/>
            </p:cNvSpPr>
            <p:nvPr/>
          </p:nvSpPr>
          <p:spPr bwMode="auto">
            <a:xfrm>
              <a:off x="671726" y="4368237"/>
              <a:ext cx="125990" cy="118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5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7" name="Line 129"/>
            <p:cNvSpPr>
              <a:spLocks noChangeShapeType="1"/>
            </p:cNvSpPr>
            <p:nvPr/>
          </p:nvSpPr>
          <p:spPr bwMode="auto">
            <a:xfrm flipH="1">
              <a:off x="747393" y="4419427"/>
              <a:ext cx="29771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Rectangle 134"/>
            <p:cNvSpPr>
              <a:spLocks noChangeArrowheads="1"/>
            </p:cNvSpPr>
            <p:nvPr/>
          </p:nvSpPr>
          <p:spPr bwMode="auto">
            <a:xfrm>
              <a:off x="644435" y="3794651"/>
              <a:ext cx="188984" cy="118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19" name="Line 135"/>
            <p:cNvSpPr>
              <a:spLocks noChangeShapeType="1"/>
            </p:cNvSpPr>
            <p:nvPr/>
          </p:nvSpPr>
          <p:spPr bwMode="auto">
            <a:xfrm flipH="1">
              <a:off x="747393" y="3845840"/>
              <a:ext cx="29771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Freeform 148"/>
            <p:cNvSpPr>
              <a:spLocks/>
            </p:cNvSpPr>
            <p:nvPr/>
          </p:nvSpPr>
          <p:spPr bwMode="auto">
            <a:xfrm>
              <a:off x="777164" y="4906385"/>
              <a:ext cx="192271" cy="110255"/>
            </a:xfrm>
            <a:custGeom>
              <a:avLst/>
              <a:gdLst>
                <a:gd name="T0" fmla="*/ 8 w 155"/>
                <a:gd name="T1" fmla="*/ 79 h 84"/>
                <a:gd name="T2" fmla="*/ 26 w 155"/>
                <a:gd name="T3" fmla="*/ 79 h 84"/>
                <a:gd name="T4" fmla="*/ 39 w 155"/>
                <a:gd name="T5" fmla="*/ 80 h 84"/>
                <a:gd name="T6" fmla="*/ 49 w 155"/>
                <a:gd name="T7" fmla="*/ 80 h 84"/>
                <a:gd name="T8" fmla="*/ 62 w 155"/>
                <a:gd name="T9" fmla="*/ 80 h 84"/>
                <a:gd name="T10" fmla="*/ 83 w 155"/>
                <a:gd name="T11" fmla="*/ 80 h 84"/>
                <a:gd name="T12" fmla="*/ 97 w 155"/>
                <a:gd name="T13" fmla="*/ 80 h 84"/>
                <a:gd name="T14" fmla="*/ 100 w 155"/>
                <a:gd name="T15" fmla="*/ 80 h 84"/>
                <a:gd name="T16" fmla="*/ 102 w 155"/>
                <a:gd name="T17" fmla="*/ 79 h 84"/>
                <a:gd name="T18" fmla="*/ 103 w 155"/>
                <a:gd name="T19" fmla="*/ 79 h 84"/>
                <a:gd name="T20" fmla="*/ 104 w 155"/>
                <a:gd name="T21" fmla="*/ 78 h 84"/>
                <a:gd name="T22" fmla="*/ 105 w 155"/>
                <a:gd name="T23" fmla="*/ 76 h 84"/>
                <a:gd name="T24" fmla="*/ 105 w 155"/>
                <a:gd name="T25" fmla="*/ 74 h 84"/>
                <a:gd name="T26" fmla="*/ 106 w 155"/>
                <a:gd name="T27" fmla="*/ 73 h 84"/>
                <a:gd name="T28" fmla="*/ 106 w 155"/>
                <a:gd name="T29" fmla="*/ 70 h 84"/>
                <a:gd name="T30" fmla="*/ 106 w 155"/>
                <a:gd name="T31" fmla="*/ 68 h 84"/>
                <a:gd name="T32" fmla="*/ 107 w 155"/>
                <a:gd name="T33" fmla="*/ 64 h 84"/>
                <a:gd name="T34" fmla="*/ 107 w 155"/>
                <a:gd name="T35" fmla="*/ 60 h 84"/>
                <a:gd name="T36" fmla="*/ 108 w 155"/>
                <a:gd name="T37" fmla="*/ 56 h 84"/>
                <a:gd name="T38" fmla="*/ 108 w 155"/>
                <a:gd name="T39" fmla="*/ 51 h 84"/>
                <a:gd name="T40" fmla="*/ 109 w 155"/>
                <a:gd name="T41" fmla="*/ 42 h 84"/>
                <a:gd name="T42" fmla="*/ 110 w 155"/>
                <a:gd name="T43" fmla="*/ 24 h 84"/>
                <a:gd name="T44" fmla="*/ 111 w 155"/>
                <a:gd name="T45" fmla="*/ 14 h 84"/>
                <a:gd name="T46" fmla="*/ 111 w 155"/>
                <a:gd name="T47" fmla="*/ 7 h 84"/>
                <a:gd name="T48" fmla="*/ 112 w 155"/>
                <a:gd name="T49" fmla="*/ 2 h 84"/>
                <a:gd name="T50" fmla="*/ 113 w 155"/>
                <a:gd name="T51" fmla="*/ 0 h 84"/>
                <a:gd name="T52" fmla="*/ 114 w 155"/>
                <a:gd name="T53" fmla="*/ 3 h 84"/>
                <a:gd name="T54" fmla="*/ 115 w 155"/>
                <a:gd name="T55" fmla="*/ 8 h 84"/>
                <a:gd name="T56" fmla="*/ 115 w 155"/>
                <a:gd name="T57" fmla="*/ 15 h 84"/>
                <a:gd name="T58" fmla="*/ 116 w 155"/>
                <a:gd name="T59" fmla="*/ 27 h 84"/>
                <a:gd name="T60" fmla="*/ 118 w 155"/>
                <a:gd name="T61" fmla="*/ 43 h 84"/>
                <a:gd name="T62" fmla="*/ 118 w 155"/>
                <a:gd name="T63" fmla="*/ 51 h 84"/>
                <a:gd name="T64" fmla="*/ 119 w 155"/>
                <a:gd name="T65" fmla="*/ 55 h 84"/>
                <a:gd name="T66" fmla="*/ 119 w 155"/>
                <a:gd name="T67" fmla="*/ 59 h 84"/>
                <a:gd name="T68" fmla="*/ 120 w 155"/>
                <a:gd name="T69" fmla="*/ 62 h 84"/>
                <a:gd name="T70" fmla="*/ 120 w 155"/>
                <a:gd name="T71" fmla="*/ 65 h 84"/>
                <a:gd name="T72" fmla="*/ 120 w 155"/>
                <a:gd name="T73" fmla="*/ 68 h 84"/>
                <a:gd name="T74" fmla="*/ 121 w 155"/>
                <a:gd name="T75" fmla="*/ 70 h 84"/>
                <a:gd name="T76" fmla="*/ 121 w 155"/>
                <a:gd name="T77" fmla="*/ 72 h 84"/>
                <a:gd name="T78" fmla="*/ 122 w 155"/>
                <a:gd name="T79" fmla="*/ 74 h 84"/>
                <a:gd name="T80" fmla="*/ 122 w 155"/>
                <a:gd name="T81" fmla="*/ 75 h 84"/>
                <a:gd name="T82" fmla="*/ 123 w 155"/>
                <a:gd name="T83" fmla="*/ 77 h 84"/>
                <a:gd name="T84" fmla="*/ 124 w 155"/>
                <a:gd name="T85" fmla="*/ 78 h 84"/>
                <a:gd name="T86" fmla="*/ 125 w 155"/>
                <a:gd name="T87" fmla="*/ 79 h 84"/>
                <a:gd name="T88" fmla="*/ 126 w 155"/>
                <a:gd name="T89" fmla="*/ 80 h 84"/>
                <a:gd name="T90" fmla="*/ 127 w 155"/>
                <a:gd name="T91" fmla="*/ 81 h 84"/>
                <a:gd name="T92" fmla="*/ 131 w 155"/>
                <a:gd name="T93" fmla="*/ 82 h 84"/>
                <a:gd name="T94" fmla="*/ 134 w 155"/>
                <a:gd name="T95" fmla="*/ 83 h 84"/>
                <a:gd name="T96" fmla="*/ 135 w 155"/>
                <a:gd name="T97" fmla="*/ 83 h 84"/>
                <a:gd name="T98" fmla="*/ 137 w 155"/>
                <a:gd name="T99" fmla="*/ 84 h 84"/>
                <a:gd name="T100" fmla="*/ 138 w 155"/>
                <a:gd name="T101" fmla="*/ 84 h 84"/>
                <a:gd name="T102" fmla="*/ 140 w 155"/>
                <a:gd name="T103" fmla="*/ 83 h 84"/>
                <a:gd name="T104" fmla="*/ 141 w 155"/>
                <a:gd name="T105" fmla="*/ 82 h 84"/>
                <a:gd name="T106" fmla="*/ 142 w 155"/>
                <a:gd name="T107" fmla="*/ 80 h 84"/>
                <a:gd name="T108" fmla="*/ 143 w 155"/>
                <a:gd name="T109" fmla="*/ 78 h 84"/>
                <a:gd name="T110" fmla="*/ 144 w 155"/>
                <a:gd name="T111" fmla="*/ 75 h 84"/>
                <a:gd name="T112" fmla="*/ 145 w 155"/>
                <a:gd name="T113" fmla="*/ 72 h 84"/>
                <a:gd name="T114" fmla="*/ 146 w 155"/>
                <a:gd name="T115" fmla="*/ 68 h 84"/>
                <a:gd name="T116" fmla="*/ 148 w 155"/>
                <a:gd name="T117" fmla="*/ 61 h 84"/>
                <a:gd name="T118" fmla="*/ 149 w 155"/>
                <a:gd name="T119" fmla="*/ 54 h 84"/>
                <a:gd name="T120" fmla="*/ 151 w 155"/>
                <a:gd name="T121" fmla="*/ 49 h 84"/>
                <a:gd name="T122" fmla="*/ 152 w 155"/>
                <a:gd name="T123" fmla="*/ 45 h 84"/>
                <a:gd name="T124" fmla="*/ 154 w 155"/>
                <a:gd name="T125" fmla="*/ 42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55" h="84">
                  <a:moveTo>
                    <a:pt x="0" y="79"/>
                  </a:moveTo>
                  <a:lnTo>
                    <a:pt x="0" y="79"/>
                  </a:lnTo>
                  <a:lnTo>
                    <a:pt x="2" y="79"/>
                  </a:lnTo>
                  <a:lnTo>
                    <a:pt x="3" y="79"/>
                  </a:lnTo>
                  <a:lnTo>
                    <a:pt x="4" y="79"/>
                  </a:lnTo>
                  <a:lnTo>
                    <a:pt x="6" y="79"/>
                  </a:lnTo>
                  <a:lnTo>
                    <a:pt x="7" y="79"/>
                  </a:lnTo>
                  <a:lnTo>
                    <a:pt x="8" y="79"/>
                  </a:lnTo>
                  <a:lnTo>
                    <a:pt x="10" y="79"/>
                  </a:lnTo>
                  <a:lnTo>
                    <a:pt x="11" y="79"/>
                  </a:lnTo>
                  <a:lnTo>
                    <a:pt x="12" y="79"/>
                  </a:lnTo>
                  <a:lnTo>
                    <a:pt x="14" y="79"/>
                  </a:lnTo>
                  <a:lnTo>
                    <a:pt x="17" y="79"/>
                  </a:lnTo>
                  <a:lnTo>
                    <a:pt x="20" y="79"/>
                  </a:lnTo>
                  <a:lnTo>
                    <a:pt x="23" y="79"/>
                  </a:lnTo>
                  <a:lnTo>
                    <a:pt x="26" y="79"/>
                  </a:lnTo>
                  <a:lnTo>
                    <a:pt x="28" y="80"/>
                  </a:lnTo>
                  <a:lnTo>
                    <a:pt x="29" y="80"/>
                  </a:lnTo>
                  <a:lnTo>
                    <a:pt x="30" y="80"/>
                  </a:lnTo>
                  <a:lnTo>
                    <a:pt x="32" y="80"/>
                  </a:lnTo>
                  <a:lnTo>
                    <a:pt x="34" y="80"/>
                  </a:lnTo>
                  <a:lnTo>
                    <a:pt x="36" y="80"/>
                  </a:lnTo>
                  <a:lnTo>
                    <a:pt x="38" y="80"/>
                  </a:lnTo>
                  <a:lnTo>
                    <a:pt x="39" y="80"/>
                  </a:lnTo>
                  <a:lnTo>
                    <a:pt x="40" y="80"/>
                  </a:lnTo>
                  <a:lnTo>
                    <a:pt x="41" y="80"/>
                  </a:lnTo>
                  <a:lnTo>
                    <a:pt x="42" y="80"/>
                  </a:lnTo>
                  <a:lnTo>
                    <a:pt x="43" y="80"/>
                  </a:lnTo>
                  <a:lnTo>
                    <a:pt x="44" y="80"/>
                  </a:lnTo>
                  <a:lnTo>
                    <a:pt x="46" y="80"/>
                  </a:lnTo>
                  <a:lnTo>
                    <a:pt x="47" y="80"/>
                  </a:lnTo>
                  <a:lnTo>
                    <a:pt x="49" y="80"/>
                  </a:lnTo>
                  <a:lnTo>
                    <a:pt x="51" y="80"/>
                  </a:lnTo>
                  <a:lnTo>
                    <a:pt x="52" y="80"/>
                  </a:lnTo>
                  <a:lnTo>
                    <a:pt x="54" y="80"/>
                  </a:lnTo>
                  <a:lnTo>
                    <a:pt x="55" y="80"/>
                  </a:lnTo>
                  <a:lnTo>
                    <a:pt x="57" y="80"/>
                  </a:lnTo>
                  <a:lnTo>
                    <a:pt x="58" y="80"/>
                  </a:lnTo>
                  <a:lnTo>
                    <a:pt x="60" y="80"/>
                  </a:lnTo>
                  <a:lnTo>
                    <a:pt x="62" y="80"/>
                  </a:lnTo>
                  <a:lnTo>
                    <a:pt x="63" y="80"/>
                  </a:lnTo>
                  <a:lnTo>
                    <a:pt x="65" y="80"/>
                  </a:lnTo>
                  <a:lnTo>
                    <a:pt x="67" y="80"/>
                  </a:lnTo>
                  <a:lnTo>
                    <a:pt x="71" y="80"/>
                  </a:lnTo>
                  <a:lnTo>
                    <a:pt x="75" y="80"/>
                  </a:lnTo>
                  <a:lnTo>
                    <a:pt x="79" y="80"/>
                  </a:lnTo>
                  <a:lnTo>
                    <a:pt x="81" y="80"/>
                  </a:lnTo>
                  <a:lnTo>
                    <a:pt x="83" y="80"/>
                  </a:lnTo>
                  <a:lnTo>
                    <a:pt x="85" y="80"/>
                  </a:lnTo>
                  <a:lnTo>
                    <a:pt x="87" y="80"/>
                  </a:lnTo>
                  <a:lnTo>
                    <a:pt x="90" y="80"/>
                  </a:lnTo>
                  <a:lnTo>
                    <a:pt x="92" y="80"/>
                  </a:lnTo>
                  <a:lnTo>
                    <a:pt x="94" y="80"/>
                  </a:lnTo>
                  <a:lnTo>
                    <a:pt x="95" y="80"/>
                  </a:lnTo>
                  <a:lnTo>
                    <a:pt x="96" y="80"/>
                  </a:lnTo>
                  <a:lnTo>
                    <a:pt x="97" y="80"/>
                  </a:lnTo>
                  <a:lnTo>
                    <a:pt x="98" y="80"/>
                  </a:lnTo>
                  <a:lnTo>
                    <a:pt x="98" y="80"/>
                  </a:lnTo>
                  <a:lnTo>
                    <a:pt x="99" y="80"/>
                  </a:lnTo>
                  <a:lnTo>
                    <a:pt x="99" y="80"/>
                  </a:lnTo>
                  <a:lnTo>
                    <a:pt x="100" y="80"/>
                  </a:lnTo>
                  <a:lnTo>
                    <a:pt x="100" y="80"/>
                  </a:lnTo>
                  <a:lnTo>
                    <a:pt x="100" y="80"/>
                  </a:lnTo>
                  <a:lnTo>
                    <a:pt x="100" y="80"/>
                  </a:lnTo>
                  <a:lnTo>
                    <a:pt x="101" y="79"/>
                  </a:lnTo>
                  <a:lnTo>
                    <a:pt x="101" y="79"/>
                  </a:lnTo>
                  <a:lnTo>
                    <a:pt x="101" y="79"/>
                  </a:lnTo>
                  <a:lnTo>
                    <a:pt x="101" y="79"/>
                  </a:lnTo>
                  <a:lnTo>
                    <a:pt x="102" y="79"/>
                  </a:lnTo>
                  <a:lnTo>
                    <a:pt x="102" y="79"/>
                  </a:lnTo>
                  <a:lnTo>
                    <a:pt x="102" y="79"/>
                  </a:lnTo>
                  <a:lnTo>
                    <a:pt x="102" y="79"/>
                  </a:lnTo>
                  <a:lnTo>
                    <a:pt x="102" y="79"/>
                  </a:lnTo>
                  <a:lnTo>
                    <a:pt x="102" y="79"/>
                  </a:lnTo>
                  <a:lnTo>
                    <a:pt x="102" y="79"/>
                  </a:lnTo>
                  <a:lnTo>
                    <a:pt x="102" y="79"/>
                  </a:lnTo>
                  <a:lnTo>
                    <a:pt x="103" y="79"/>
                  </a:lnTo>
                  <a:lnTo>
                    <a:pt x="103" y="79"/>
                  </a:lnTo>
                  <a:lnTo>
                    <a:pt x="103" y="79"/>
                  </a:lnTo>
                  <a:lnTo>
                    <a:pt x="103" y="79"/>
                  </a:lnTo>
                  <a:lnTo>
                    <a:pt x="103" y="79"/>
                  </a:lnTo>
                  <a:lnTo>
                    <a:pt x="103" y="79"/>
                  </a:lnTo>
                  <a:lnTo>
                    <a:pt x="103" y="79"/>
                  </a:lnTo>
                  <a:lnTo>
                    <a:pt x="103" y="78"/>
                  </a:lnTo>
                  <a:lnTo>
                    <a:pt x="103" y="78"/>
                  </a:lnTo>
                  <a:lnTo>
                    <a:pt x="103" y="78"/>
                  </a:lnTo>
                  <a:lnTo>
                    <a:pt x="104" y="78"/>
                  </a:lnTo>
                  <a:lnTo>
                    <a:pt x="104" y="78"/>
                  </a:lnTo>
                  <a:lnTo>
                    <a:pt x="104" y="78"/>
                  </a:lnTo>
                  <a:lnTo>
                    <a:pt x="104" y="77"/>
                  </a:lnTo>
                  <a:lnTo>
                    <a:pt x="104" y="77"/>
                  </a:lnTo>
                  <a:lnTo>
                    <a:pt x="104" y="77"/>
                  </a:lnTo>
                  <a:lnTo>
                    <a:pt x="104" y="77"/>
                  </a:lnTo>
                  <a:lnTo>
                    <a:pt x="104" y="77"/>
                  </a:lnTo>
                  <a:lnTo>
                    <a:pt x="104" y="77"/>
                  </a:lnTo>
                  <a:lnTo>
                    <a:pt x="105" y="76"/>
                  </a:lnTo>
                  <a:lnTo>
                    <a:pt x="105" y="76"/>
                  </a:lnTo>
                  <a:lnTo>
                    <a:pt x="105" y="76"/>
                  </a:lnTo>
                  <a:lnTo>
                    <a:pt x="105" y="76"/>
                  </a:lnTo>
                  <a:lnTo>
                    <a:pt x="105" y="75"/>
                  </a:lnTo>
                  <a:lnTo>
                    <a:pt x="105" y="75"/>
                  </a:lnTo>
                  <a:lnTo>
                    <a:pt x="105" y="75"/>
                  </a:lnTo>
                  <a:lnTo>
                    <a:pt x="105" y="75"/>
                  </a:lnTo>
                  <a:lnTo>
                    <a:pt x="105" y="74"/>
                  </a:lnTo>
                  <a:lnTo>
                    <a:pt x="105" y="74"/>
                  </a:lnTo>
                  <a:lnTo>
                    <a:pt x="105" y="74"/>
                  </a:lnTo>
                  <a:lnTo>
                    <a:pt x="105" y="74"/>
                  </a:lnTo>
                  <a:lnTo>
                    <a:pt x="105" y="74"/>
                  </a:lnTo>
                  <a:lnTo>
                    <a:pt x="105" y="73"/>
                  </a:lnTo>
                  <a:lnTo>
                    <a:pt x="105" y="73"/>
                  </a:lnTo>
                  <a:lnTo>
                    <a:pt x="106" y="73"/>
                  </a:lnTo>
                  <a:lnTo>
                    <a:pt x="106" y="73"/>
                  </a:lnTo>
                  <a:lnTo>
                    <a:pt x="106" y="72"/>
                  </a:lnTo>
                  <a:lnTo>
                    <a:pt x="106" y="72"/>
                  </a:lnTo>
                  <a:lnTo>
                    <a:pt x="106" y="72"/>
                  </a:lnTo>
                  <a:lnTo>
                    <a:pt x="106" y="72"/>
                  </a:lnTo>
                  <a:lnTo>
                    <a:pt x="106" y="71"/>
                  </a:lnTo>
                  <a:lnTo>
                    <a:pt x="106" y="71"/>
                  </a:lnTo>
                  <a:lnTo>
                    <a:pt x="106" y="71"/>
                  </a:lnTo>
                  <a:lnTo>
                    <a:pt x="106" y="70"/>
                  </a:lnTo>
                  <a:lnTo>
                    <a:pt x="106" y="70"/>
                  </a:lnTo>
                  <a:lnTo>
                    <a:pt x="106" y="70"/>
                  </a:lnTo>
                  <a:lnTo>
                    <a:pt x="106" y="69"/>
                  </a:lnTo>
                  <a:lnTo>
                    <a:pt x="106" y="69"/>
                  </a:lnTo>
                  <a:lnTo>
                    <a:pt x="106" y="69"/>
                  </a:lnTo>
                  <a:lnTo>
                    <a:pt x="106" y="68"/>
                  </a:lnTo>
                  <a:lnTo>
                    <a:pt x="106" y="68"/>
                  </a:lnTo>
                  <a:lnTo>
                    <a:pt x="106" y="68"/>
                  </a:lnTo>
                  <a:lnTo>
                    <a:pt x="106" y="67"/>
                  </a:lnTo>
                  <a:lnTo>
                    <a:pt x="107" y="67"/>
                  </a:lnTo>
                  <a:lnTo>
                    <a:pt x="107" y="66"/>
                  </a:lnTo>
                  <a:lnTo>
                    <a:pt x="107" y="66"/>
                  </a:lnTo>
                  <a:lnTo>
                    <a:pt x="107" y="66"/>
                  </a:lnTo>
                  <a:lnTo>
                    <a:pt x="107" y="65"/>
                  </a:lnTo>
                  <a:lnTo>
                    <a:pt x="107" y="65"/>
                  </a:lnTo>
                  <a:lnTo>
                    <a:pt x="107" y="64"/>
                  </a:lnTo>
                  <a:lnTo>
                    <a:pt x="107" y="64"/>
                  </a:lnTo>
                  <a:lnTo>
                    <a:pt x="107" y="64"/>
                  </a:lnTo>
                  <a:lnTo>
                    <a:pt x="107" y="63"/>
                  </a:lnTo>
                  <a:lnTo>
                    <a:pt x="107" y="62"/>
                  </a:lnTo>
                  <a:lnTo>
                    <a:pt x="107" y="62"/>
                  </a:lnTo>
                  <a:lnTo>
                    <a:pt x="107" y="61"/>
                  </a:lnTo>
                  <a:lnTo>
                    <a:pt x="107" y="61"/>
                  </a:lnTo>
                  <a:lnTo>
                    <a:pt x="107" y="60"/>
                  </a:lnTo>
                  <a:lnTo>
                    <a:pt x="107" y="59"/>
                  </a:lnTo>
                  <a:lnTo>
                    <a:pt x="107" y="59"/>
                  </a:lnTo>
                  <a:lnTo>
                    <a:pt x="107" y="59"/>
                  </a:lnTo>
                  <a:lnTo>
                    <a:pt x="108" y="58"/>
                  </a:lnTo>
                  <a:lnTo>
                    <a:pt x="108" y="57"/>
                  </a:lnTo>
                  <a:lnTo>
                    <a:pt x="108" y="57"/>
                  </a:lnTo>
                  <a:lnTo>
                    <a:pt x="108" y="56"/>
                  </a:lnTo>
                  <a:lnTo>
                    <a:pt x="108" y="56"/>
                  </a:lnTo>
                  <a:lnTo>
                    <a:pt x="108" y="55"/>
                  </a:lnTo>
                  <a:lnTo>
                    <a:pt x="108" y="54"/>
                  </a:lnTo>
                  <a:lnTo>
                    <a:pt x="108" y="54"/>
                  </a:lnTo>
                  <a:lnTo>
                    <a:pt x="108" y="53"/>
                  </a:lnTo>
                  <a:lnTo>
                    <a:pt x="108" y="53"/>
                  </a:lnTo>
                  <a:lnTo>
                    <a:pt x="108" y="52"/>
                  </a:lnTo>
                  <a:lnTo>
                    <a:pt x="108" y="51"/>
                  </a:lnTo>
                  <a:lnTo>
                    <a:pt x="108" y="51"/>
                  </a:lnTo>
                  <a:lnTo>
                    <a:pt x="108" y="50"/>
                  </a:lnTo>
                  <a:lnTo>
                    <a:pt x="108" y="49"/>
                  </a:lnTo>
                  <a:lnTo>
                    <a:pt x="108" y="48"/>
                  </a:lnTo>
                  <a:lnTo>
                    <a:pt x="108" y="47"/>
                  </a:lnTo>
                  <a:lnTo>
                    <a:pt x="109" y="46"/>
                  </a:lnTo>
                  <a:lnTo>
                    <a:pt x="109" y="45"/>
                  </a:lnTo>
                  <a:lnTo>
                    <a:pt x="109" y="44"/>
                  </a:lnTo>
                  <a:lnTo>
                    <a:pt x="109" y="42"/>
                  </a:lnTo>
                  <a:lnTo>
                    <a:pt x="109" y="41"/>
                  </a:lnTo>
                  <a:lnTo>
                    <a:pt x="109" y="39"/>
                  </a:lnTo>
                  <a:lnTo>
                    <a:pt x="109" y="38"/>
                  </a:lnTo>
                  <a:lnTo>
                    <a:pt x="109" y="36"/>
                  </a:lnTo>
                  <a:lnTo>
                    <a:pt x="109" y="32"/>
                  </a:lnTo>
                  <a:lnTo>
                    <a:pt x="110" y="29"/>
                  </a:lnTo>
                  <a:lnTo>
                    <a:pt x="110" y="26"/>
                  </a:lnTo>
                  <a:lnTo>
                    <a:pt x="110" y="24"/>
                  </a:lnTo>
                  <a:lnTo>
                    <a:pt x="110" y="23"/>
                  </a:lnTo>
                  <a:lnTo>
                    <a:pt x="110" y="21"/>
                  </a:lnTo>
                  <a:lnTo>
                    <a:pt x="110" y="20"/>
                  </a:lnTo>
                  <a:lnTo>
                    <a:pt x="110" y="19"/>
                  </a:lnTo>
                  <a:lnTo>
                    <a:pt x="111" y="17"/>
                  </a:lnTo>
                  <a:lnTo>
                    <a:pt x="111" y="16"/>
                  </a:lnTo>
                  <a:lnTo>
                    <a:pt x="111" y="15"/>
                  </a:lnTo>
                  <a:lnTo>
                    <a:pt x="111" y="14"/>
                  </a:lnTo>
                  <a:lnTo>
                    <a:pt x="111" y="13"/>
                  </a:lnTo>
                  <a:lnTo>
                    <a:pt x="111" y="12"/>
                  </a:lnTo>
                  <a:lnTo>
                    <a:pt x="111" y="11"/>
                  </a:lnTo>
                  <a:lnTo>
                    <a:pt x="111" y="10"/>
                  </a:lnTo>
                  <a:lnTo>
                    <a:pt x="111" y="9"/>
                  </a:lnTo>
                  <a:lnTo>
                    <a:pt x="111" y="9"/>
                  </a:lnTo>
                  <a:lnTo>
                    <a:pt x="111" y="8"/>
                  </a:lnTo>
                  <a:lnTo>
                    <a:pt x="111" y="7"/>
                  </a:lnTo>
                  <a:lnTo>
                    <a:pt x="112" y="6"/>
                  </a:lnTo>
                  <a:lnTo>
                    <a:pt x="112" y="6"/>
                  </a:lnTo>
                  <a:lnTo>
                    <a:pt x="112" y="5"/>
                  </a:lnTo>
                  <a:lnTo>
                    <a:pt x="112" y="4"/>
                  </a:lnTo>
                  <a:lnTo>
                    <a:pt x="112" y="4"/>
                  </a:lnTo>
                  <a:lnTo>
                    <a:pt x="112" y="3"/>
                  </a:lnTo>
                  <a:lnTo>
                    <a:pt x="112" y="2"/>
                  </a:lnTo>
                  <a:lnTo>
                    <a:pt x="112" y="2"/>
                  </a:lnTo>
                  <a:lnTo>
                    <a:pt x="112" y="1"/>
                  </a:lnTo>
                  <a:lnTo>
                    <a:pt x="112" y="1"/>
                  </a:lnTo>
                  <a:lnTo>
                    <a:pt x="113" y="1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4" y="0"/>
                  </a:lnTo>
                  <a:lnTo>
                    <a:pt x="114" y="1"/>
                  </a:lnTo>
                  <a:lnTo>
                    <a:pt x="114" y="1"/>
                  </a:lnTo>
                  <a:lnTo>
                    <a:pt x="114" y="1"/>
                  </a:lnTo>
                  <a:lnTo>
                    <a:pt x="114" y="2"/>
                  </a:lnTo>
                  <a:lnTo>
                    <a:pt x="114" y="3"/>
                  </a:lnTo>
                  <a:lnTo>
                    <a:pt x="114" y="3"/>
                  </a:lnTo>
                  <a:lnTo>
                    <a:pt x="114" y="4"/>
                  </a:lnTo>
                  <a:lnTo>
                    <a:pt x="114" y="5"/>
                  </a:lnTo>
                  <a:lnTo>
                    <a:pt x="114" y="5"/>
                  </a:lnTo>
                  <a:lnTo>
                    <a:pt x="115" y="6"/>
                  </a:lnTo>
                  <a:lnTo>
                    <a:pt x="115" y="7"/>
                  </a:lnTo>
                  <a:lnTo>
                    <a:pt x="115" y="7"/>
                  </a:lnTo>
                  <a:lnTo>
                    <a:pt x="115" y="8"/>
                  </a:lnTo>
                  <a:lnTo>
                    <a:pt x="115" y="9"/>
                  </a:lnTo>
                  <a:lnTo>
                    <a:pt x="115" y="9"/>
                  </a:lnTo>
                  <a:lnTo>
                    <a:pt x="115" y="10"/>
                  </a:lnTo>
                  <a:lnTo>
                    <a:pt x="115" y="11"/>
                  </a:lnTo>
                  <a:lnTo>
                    <a:pt x="115" y="12"/>
                  </a:lnTo>
                  <a:lnTo>
                    <a:pt x="115" y="13"/>
                  </a:lnTo>
                  <a:lnTo>
                    <a:pt x="115" y="14"/>
                  </a:lnTo>
                  <a:lnTo>
                    <a:pt x="115" y="15"/>
                  </a:lnTo>
                  <a:lnTo>
                    <a:pt x="116" y="16"/>
                  </a:lnTo>
                  <a:lnTo>
                    <a:pt x="116" y="17"/>
                  </a:lnTo>
                  <a:lnTo>
                    <a:pt x="116" y="19"/>
                  </a:lnTo>
                  <a:lnTo>
                    <a:pt x="116" y="20"/>
                  </a:lnTo>
                  <a:lnTo>
                    <a:pt x="116" y="22"/>
                  </a:lnTo>
                  <a:lnTo>
                    <a:pt x="116" y="24"/>
                  </a:lnTo>
                  <a:lnTo>
                    <a:pt x="116" y="25"/>
                  </a:lnTo>
                  <a:lnTo>
                    <a:pt x="116" y="27"/>
                  </a:lnTo>
                  <a:lnTo>
                    <a:pt x="117" y="31"/>
                  </a:lnTo>
                  <a:lnTo>
                    <a:pt x="117" y="34"/>
                  </a:lnTo>
                  <a:lnTo>
                    <a:pt x="117" y="36"/>
                  </a:lnTo>
                  <a:lnTo>
                    <a:pt x="117" y="38"/>
                  </a:lnTo>
                  <a:lnTo>
                    <a:pt x="117" y="39"/>
                  </a:lnTo>
                  <a:lnTo>
                    <a:pt x="117" y="41"/>
                  </a:lnTo>
                  <a:lnTo>
                    <a:pt x="118" y="42"/>
                  </a:lnTo>
                  <a:lnTo>
                    <a:pt x="118" y="43"/>
                  </a:lnTo>
                  <a:lnTo>
                    <a:pt x="118" y="45"/>
                  </a:lnTo>
                  <a:lnTo>
                    <a:pt x="118" y="46"/>
                  </a:lnTo>
                  <a:lnTo>
                    <a:pt x="118" y="46"/>
                  </a:lnTo>
                  <a:lnTo>
                    <a:pt x="118" y="47"/>
                  </a:lnTo>
                  <a:lnTo>
                    <a:pt x="118" y="48"/>
                  </a:lnTo>
                  <a:lnTo>
                    <a:pt x="118" y="49"/>
                  </a:lnTo>
                  <a:lnTo>
                    <a:pt x="118" y="50"/>
                  </a:lnTo>
                  <a:lnTo>
                    <a:pt x="118" y="51"/>
                  </a:lnTo>
                  <a:lnTo>
                    <a:pt x="118" y="51"/>
                  </a:lnTo>
                  <a:lnTo>
                    <a:pt x="118" y="52"/>
                  </a:lnTo>
                  <a:lnTo>
                    <a:pt x="118" y="52"/>
                  </a:lnTo>
                  <a:lnTo>
                    <a:pt x="119" y="53"/>
                  </a:lnTo>
                  <a:lnTo>
                    <a:pt x="119" y="54"/>
                  </a:lnTo>
                  <a:lnTo>
                    <a:pt x="119" y="54"/>
                  </a:lnTo>
                  <a:lnTo>
                    <a:pt x="119" y="55"/>
                  </a:lnTo>
                  <a:lnTo>
                    <a:pt x="119" y="55"/>
                  </a:lnTo>
                  <a:lnTo>
                    <a:pt x="119" y="56"/>
                  </a:lnTo>
                  <a:lnTo>
                    <a:pt x="119" y="56"/>
                  </a:lnTo>
                  <a:lnTo>
                    <a:pt x="119" y="57"/>
                  </a:lnTo>
                  <a:lnTo>
                    <a:pt x="119" y="57"/>
                  </a:lnTo>
                  <a:lnTo>
                    <a:pt x="119" y="58"/>
                  </a:lnTo>
                  <a:lnTo>
                    <a:pt x="119" y="58"/>
                  </a:lnTo>
                  <a:lnTo>
                    <a:pt x="119" y="59"/>
                  </a:lnTo>
                  <a:lnTo>
                    <a:pt x="119" y="59"/>
                  </a:lnTo>
                  <a:lnTo>
                    <a:pt x="119" y="59"/>
                  </a:lnTo>
                  <a:lnTo>
                    <a:pt x="119" y="60"/>
                  </a:lnTo>
                  <a:lnTo>
                    <a:pt x="119" y="60"/>
                  </a:lnTo>
                  <a:lnTo>
                    <a:pt x="119" y="61"/>
                  </a:lnTo>
                  <a:lnTo>
                    <a:pt x="119" y="61"/>
                  </a:lnTo>
                  <a:lnTo>
                    <a:pt x="119" y="62"/>
                  </a:lnTo>
                  <a:lnTo>
                    <a:pt x="120" y="62"/>
                  </a:lnTo>
                  <a:lnTo>
                    <a:pt x="120" y="62"/>
                  </a:lnTo>
                  <a:lnTo>
                    <a:pt x="120" y="63"/>
                  </a:lnTo>
                  <a:lnTo>
                    <a:pt x="120" y="63"/>
                  </a:lnTo>
                  <a:lnTo>
                    <a:pt x="120" y="64"/>
                  </a:lnTo>
                  <a:lnTo>
                    <a:pt x="120" y="64"/>
                  </a:lnTo>
                  <a:lnTo>
                    <a:pt x="120" y="64"/>
                  </a:lnTo>
                  <a:lnTo>
                    <a:pt x="120" y="65"/>
                  </a:lnTo>
                  <a:lnTo>
                    <a:pt x="120" y="65"/>
                  </a:lnTo>
                  <a:lnTo>
                    <a:pt x="120" y="65"/>
                  </a:lnTo>
                  <a:lnTo>
                    <a:pt x="120" y="66"/>
                  </a:lnTo>
                  <a:lnTo>
                    <a:pt x="120" y="66"/>
                  </a:lnTo>
                  <a:lnTo>
                    <a:pt x="120" y="66"/>
                  </a:lnTo>
                  <a:lnTo>
                    <a:pt x="120" y="67"/>
                  </a:lnTo>
                  <a:lnTo>
                    <a:pt x="120" y="67"/>
                  </a:lnTo>
                  <a:lnTo>
                    <a:pt x="120" y="67"/>
                  </a:lnTo>
                  <a:lnTo>
                    <a:pt x="120" y="68"/>
                  </a:lnTo>
                  <a:lnTo>
                    <a:pt x="120" y="68"/>
                  </a:lnTo>
                  <a:lnTo>
                    <a:pt x="120" y="68"/>
                  </a:lnTo>
                  <a:lnTo>
                    <a:pt x="121" y="69"/>
                  </a:lnTo>
                  <a:lnTo>
                    <a:pt x="121" y="69"/>
                  </a:lnTo>
                  <a:lnTo>
                    <a:pt x="121" y="69"/>
                  </a:lnTo>
                  <a:lnTo>
                    <a:pt x="121" y="69"/>
                  </a:lnTo>
                  <a:lnTo>
                    <a:pt x="121" y="70"/>
                  </a:lnTo>
                  <a:lnTo>
                    <a:pt x="121" y="70"/>
                  </a:lnTo>
                  <a:lnTo>
                    <a:pt x="121" y="70"/>
                  </a:lnTo>
                  <a:lnTo>
                    <a:pt x="121" y="70"/>
                  </a:lnTo>
                  <a:lnTo>
                    <a:pt x="121" y="71"/>
                  </a:lnTo>
                  <a:lnTo>
                    <a:pt x="121" y="71"/>
                  </a:lnTo>
                  <a:lnTo>
                    <a:pt x="121" y="71"/>
                  </a:lnTo>
                  <a:lnTo>
                    <a:pt x="121" y="72"/>
                  </a:lnTo>
                  <a:lnTo>
                    <a:pt x="121" y="72"/>
                  </a:lnTo>
                  <a:lnTo>
                    <a:pt x="121" y="72"/>
                  </a:lnTo>
                  <a:lnTo>
                    <a:pt x="121" y="72"/>
                  </a:lnTo>
                  <a:lnTo>
                    <a:pt x="121" y="72"/>
                  </a:lnTo>
                  <a:lnTo>
                    <a:pt x="121" y="72"/>
                  </a:lnTo>
                  <a:lnTo>
                    <a:pt x="121" y="73"/>
                  </a:lnTo>
                  <a:lnTo>
                    <a:pt x="122" y="73"/>
                  </a:lnTo>
                  <a:lnTo>
                    <a:pt x="122" y="73"/>
                  </a:lnTo>
                  <a:lnTo>
                    <a:pt x="122" y="73"/>
                  </a:lnTo>
                  <a:lnTo>
                    <a:pt x="122" y="73"/>
                  </a:lnTo>
                  <a:lnTo>
                    <a:pt x="122" y="74"/>
                  </a:lnTo>
                  <a:lnTo>
                    <a:pt x="122" y="74"/>
                  </a:lnTo>
                  <a:lnTo>
                    <a:pt x="122" y="74"/>
                  </a:lnTo>
                  <a:lnTo>
                    <a:pt x="122" y="74"/>
                  </a:lnTo>
                  <a:lnTo>
                    <a:pt x="122" y="74"/>
                  </a:lnTo>
                  <a:lnTo>
                    <a:pt x="122" y="75"/>
                  </a:lnTo>
                  <a:lnTo>
                    <a:pt x="122" y="75"/>
                  </a:lnTo>
                  <a:lnTo>
                    <a:pt x="122" y="75"/>
                  </a:lnTo>
                  <a:lnTo>
                    <a:pt x="122" y="75"/>
                  </a:lnTo>
                  <a:lnTo>
                    <a:pt x="122" y="75"/>
                  </a:lnTo>
                  <a:lnTo>
                    <a:pt x="122" y="76"/>
                  </a:lnTo>
                  <a:lnTo>
                    <a:pt x="122" y="76"/>
                  </a:lnTo>
                  <a:lnTo>
                    <a:pt x="122" y="76"/>
                  </a:lnTo>
                  <a:lnTo>
                    <a:pt x="123" y="76"/>
                  </a:lnTo>
                  <a:lnTo>
                    <a:pt x="123" y="76"/>
                  </a:lnTo>
                  <a:lnTo>
                    <a:pt x="123" y="77"/>
                  </a:lnTo>
                  <a:lnTo>
                    <a:pt x="123" y="77"/>
                  </a:lnTo>
                  <a:lnTo>
                    <a:pt x="123" y="77"/>
                  </a:lnTo>
                  <a:lnTo>
                    <a:pt x="123" y="77"/>
                  </a:lnTo>
                  <a:lnTo>
                    <a:pt x="123" y="77"/>
                  </a:lnTo>
                  <a:lnTo>
                    <a:pt x="123" y="77"/>
                  </a:lnTo>
                  <a:lnTo>
                    <a:pt x="123" y="77"/>
                  </a:lnTo>
                  <a:lnTo>
                    <a:pt x="123" y="78"/>
                  </a:lnTo>
                  <a:lnTo>
                    <a:pt x="124" y="78"/>
                  </a:lnTo>
                  <a:lnTo>
                    <a:pt x="124" y="78"/>
                  </a:lnTo>
                  <a:lnTo>
                    <a:pt x="124" y="78"/>
                  </a:lnTo>
                  <a:lnTo>
                    <a:pt x="124" y="78"/>
                  </a:lnTo>
                  <a:lnTo>
                    <a:pt x="124" y="78"/>
                  </a:lnTo>
                  <a:lnTo>
                    <a:pt x="124" y="79"/>
                  </a:lnTo>
                  <a:lnTo>
                    <a:pt x="124" y="79"/>
                  </a:lnTo>
                  <a:lnTo>
                    <a:pt x="124" y="79"/>
                  </a:lnTo>
                  <a:lnTo>
                    <a:pt x="124" y="79"/>
                  </a:lnTo>
                  <a:lnTo>
                    <a:pt x="125" y="79"/>
                  </a:lnTo>
                  <a:lnTo>
                    <a:pt x="125" y="79"/>
                  </a:lnTo>
                  <a:lnTo>
                    <a:pt x="125" y="79"/>
                  </a:lnTo>
                  <a:lnTo>
                    <a:pt x="125" y="79"/>
                  </a:lnTo>
                  <a:lnTo>
                    <a:pt x="125" y="79"/>
                  </a:lnTo>
                  <a:lnTo>
                    <a:pt x="125" y="79"/>
                  </a:lnTo>
                  <a:lnTo>
                    <a:pt x="125" y="80"/>
                  </a:lnTo>
                  <a:lnTo>
                    <a:pt x="126" y="80"/>
                  </a:lnTo>
                  <a:lnTo>
                    <a:pt x="126" y="80"/>
                  </a:lnTo>
                  <a:lnTo>
                    <a:pt x="126" y="80"/>
                  </a:lnTo>
                  <a:lnTo>
                    <a:pt x="126" y="80"/>
                  </a:lnTo>
                  <a:lnTo>
                    <a:pt x="126" y="80"/>
                  </a:lnTo>
                  <a:lnTo>
                    <a:pt x="127" y="80"/>
                  </a:lnTo>
                  <a:lnTo>
                    <a:pt x="127" y="80"/>
                  </a:lnTo>
                  <a:lnTo>
                    <a:pt x="127" y="80"/>
                  </a:lnTo>
                  <a:lnTo>
                    <a:pt x="127" y="80"/>
                  </a:lnTo>
                  <a:lnTo>
                    <a:pt x="127" y="81"/>
                  </a:lnTo>
                  <a:lnTo>
                    <a:pt x="128" y="81"/>
                  </a:lnTo>
                  <a:lnTo>
                    <a:pt x="128" y="81"/>
                  </a:lnTo>
                  <a:lnTo>
                    <a:pt x="128" y="81"/>
                  </a:lnTo>
                  <a:lnTo>
                    <a:pt x="129" y="81"/>
                  </a:lnTo>
                  <a:lnTo>
                    <a:pt x="129" y="81"/>
                  </a:lnTo>
                  <a:lnTo>
                    <a:pt x="130" y="81"/>
                  </a:lnTo>
                  <a:lnTo>
                    <a:pt x="130" y="81"/>
                  </a:lnTo>
                  <a:lnTo>
                    <a:pt x="131" y="82"/>
                  </a:lnTo>
                  <a:lnTo>
                    <a:pt x="131" y="82"/>
                  </a:lnTo>
                  <a:lnTo>
                    <a:pt x="132" y="82"/>
                  </a:lnTo>
                  <a:lnTo>
                    <a:pt x="132" y="82"/>
                  </a:lnTo>
                  <a:lnTo>
                    <a:pt x="133" y="82"/>
                  </a:lnTo>
                  <a:lnTo>
                    <a:pt x="134" y="83"/>
                  </a:lnTo>
                  <a:lnTo>
                    <a:pt x="134" y="83"/>
                  </a:lnTo>
                  <a:lnTo>
                    <a:pt x="134" y="83"/>
                  </a:lnTo>
                  <a:lnTo>
                    <a:pt x="134" y="83"/>
                  </a:lnTo>
                  <a:lnTo>
                    <a:pt x="134" y="83"/>
                  </a:lnTo>
                  <a:lnTo>
                    <a:pt x="134" y="83"/>
                  </a:lnTo>
                  <a:lnTo>
                    <a:pt x="134" y="83"/>
                  </a:lnTo>
                  <a:lnTo>
                    <a:pt x="134" y="83"/>
                  </a:lnTo>
                  <a:lnTo>
                    <a:pt x="134" y="83"/>
                  </a:lnTo>
                  <a:lnTo>
                    <a:pt x="135" y="83"/>
                  </a:lnTo>
                  <a:lnTo>
                    <a:pt x="135" y="83"/>
                  </a:lnTo>
                  <a:lnTo>
                    <a:pt x="135" y="83"/>
                  </a:lnTo>
                  <a:lnTo>
                    <a:pt x="135" y="83"/>
                  </a:lnTo>
                  <a:lnTo>
                    <a:pt x="135" y="83"/>
                  </a:lnTo>
                  <a:lnTo>
                    <a:pt x="135" y="84"/>
                  </a:lnTo>
                  <a:lnTo>
                    <a:pt x="136" y="84"/>
                  </a:lnTo>
                  <a:lnTo>
                    <a:pt x="136" y="84"/>
                  </a:lnTo>
                  <a:lnTo>
                    <a:pt x="136" y="84"/>
                  </a:lnTo>
                  <a:lnTo>
                    <a:pt x="136" y="84"/>
                  </a:lnTo>
                  <a:lnTo>
                    <a:pt x="137" y="84"/>
                  </a:lnTo>
                  <a:lnTo>
                    <a:pt x="137" y="84"/>
                  </a:lnTo>
                  <a:lnTo>
                    <a:pt x="137" y="84"/>
                  </a:lnTo>
                  <a:lnTo>
                    <a:pt x="137" y="84"/>
                  </a:lnTo>
                  <a:lnTo>
                    <a:pt x="137" y="84"/>
                  </a:lnTo>
                  <a:lnTo>
                    <a:pt x="138" y="84"/>
                  </a:lnTo>
                  <a:lnTo>
                    <a:pt x="138" y="84"/>
                  </a:lnTo>
                  <a:lnTo>
                    <a:pt x="138" y="84"/>
                  </a:lnTo>
                  <a:lnTo>
                    <a:pt x="138" y="84"/>
                  </a:lnTo>
                  <a:lnTo>
                    <a:pt x="138" y="84"/>
                  </a:lnTo>
                  <a:lnTo>
                    <a:pt x="139" y="84"/>
                  </a:lnTo>
                  <a:lnTo>
                    <a:pt x="139" y="84"/>
                  </a:lnTo>
                  <a:lnTo>
                    <a:pt x="139" y="84"/>
                  </a:lnTo>
                  <a:lnTo>
                    <a:pt x="139" y="84"/>
                  </a:lnTo>
                  <a:lnTo>
                    <a:pt x="139" y="84"/>
                  </a:lnTo>
                  <a:lnTo>
                    <a:pt x="140" y="84"/>
                  </a:lnTo>
                  <a:lnTo>
                    <a:pt x="140" y="83"/>
                  </a:lnTo>
                  <a:lnTo>
                    <a:pt x="140" y="83"/>
                  </a:lnTo>
                  <a:lnTo>
                    <a:pt x="140" y="83"/>
                  </a:lnTo>
                  <a:lnTo>
                    <a:pt x="140" y="83"/>
                  </a:lnTo>
                  <a:lnTo>
                    <a:pt x="140" y="83"/>
                  </a:lnTo>
                  <a:lnTo>
                    <a:pt x="141" y="82"/>
                  </a:lnTo>
                  <a:lnTo>
                    <a:pt x="141" y="82"/>
                  </a:lnTo>
                  <a:lnTo>
                    <a:pt x="141" y="82"/>
                  </a:lnTo>
                  <a:lnTo>
                    <a:pt x="141" y="82"/>
                  </a:lnTo>
                  <a:lnTo>
                    <a:pt x="141" y="82"/>
                  </a:lnTo>
                  <a:lnTo>
                    <a:pt x="141" y="82"/>
                  </a:lnTo>
                  <a:lnTo>
                    <a:pt x="141" y="81"/>
                  </a:lnTo>
                  <a:lnTo>
                    <a:pt x="141" y="81"/>
                  </a:lnTo>
                  <a:lnTo>
                    <a:pt x="142" y="81"/>
                  </a:lnTo>
                  <a:lnTo>
                    <a:pt x="142" y="81"/>
                  </a:lnTo>
                  <a:lnTo>
                    <a:pt x="142" y="80"/>
                  </a:lnTo>
                  <a:lnTo>
                    <a:pt x="142" y="80"/>
                  </a:lnTo>
                  <a:lnTo>
                    <a:pt x="142" y="80"/>
                  </a:lnTo>
                  <a:lnTo>
                    <a:pt x="142" y="80"/>
                  </a:lnTo>
                  <a:lnTo>
                    <a:pt x="142" y="79"/>
                  </a:lnTo>
                  <a:lnTo>
                    <a:pt x="142" y="79"/>
                  </a:lnTo>
                  <a:lnTo>
                    <a:pt x="142" y="79"/>
                  </a:lnTo>
                  <a:lnTo>
                    <a:pt x="143" y="79"/>
                  </a:lnTo>
                  <a:lnTo>
                    <a:pt x="143" y="79"/>
                  </a:lnTo>
                  <a:lnTo>
                    <a:pt x="143" y="78"/>
                  </a:lnTo>
                  <a:lnTo>
                    <a:pt x="143" y="78"/>
                  </a:lnTo>
                  <a:lnTo>
                    <a:pt x="143" y="78"/>
                  </a:lnTo>
                  <a:lnTo>
                    <a:pt x="143" y="77"/>
                  </a:lnTo>
                  <a:lnTo>
                    <a:pt x="143" y="77"/>
                  </a:lnTo>
                  <a:lnTo>
                    <a:pt x="143" y="77"/>
                  </a:lnTo>
                  <a:lnTo>
                    <a:pt x="143" y="76"/>
                  </a:lnTo>
                  <a:lnTo>
                    <a:pt x="143" y="76"/>
                  </a:lnTo>
                  <a:lnTo>
                    <a:pt x="144" y="75"/>
                  </a:lnTo>
                  <a:lnTo>
                    <a:pt x="144" y="75"/>
                  </a:lnTo>
                  <a:lnTo>
                    <a:pt x="144" y="74"/>
                  </a:lnTo>
                  <a:lnTo>
                    <a:pt x="144" y="74"/>
                  </a:lnTo>
                  <a:lnTo>
                    <a:pt x="144" y="74"/>
                  </a:lnTo>
                  <a:lnTo>
                    <a:pt x="144" y="73"/>
                  </a:lnTo>
                  <a:lnTo>
                    <a:pt x="144" y="73"/>
                  </a:lnTo>
                  <a:lnTo>
                    <a:pt x="145" y="73"/>
                  </a:lnTo>
                  <a:lnTo>
                    <a:pt x="145" y="72"/>
                  </a:lnTo>
                  <a:lnTo>
                    <a:pt x="145" y="72"/>
                  </a:lnTo>
                  <a:lnTo>
                    <a:pt x="145" y="71"/>
                  </a:lnTo>
                  <a:lnTo>
                    <a:pt x="145" y="71"/>
                  </a:lnTo>
                  <a:lnTo>
                    <a:pt x="145" y="70"/>
                  </a:lnTo>
                  <a:lnTo>
                    <a:pt x="145" y="70"/>
                  </a:lnTo>
                  <a:lnTo>
                    <a:pt x="145" y="69"/>
                  </a:lnTo>
                  <a:lnTo>
                    <a:pt x="146" y="69"/>
                  </a:lnTo>
                  <a:lnTo>
                    <a:pt x="146" y="68"/>
                  </a:lnTo>
                  <a:lnTo>
                    <a:pt x="146" y="68"/>
                  </a:lnTo>
                  <a:lnTo>
                    <a:pt x="146" y="67"/>
                  </a:lnTo>
                  <a:lnTo>
                    <a:pt x="146" y="66"/>
                  </a:lnTo>
                  <a:lnTo>
                    <a:pt x="146" y="66"/>
                  </a:lnTo>
                  <a:lnTo>
                    <a:pt x="147" y="65"/>
                  </a:lnTo>
                  <a:lnTo>
                    <a:pt x="147" y="64"/>
                  </a:lnTo>
                  <a:lnTo>
                    <a:pt x="147" y="62"/>
                  </a:lnTo>
                  <a:lnTo>
                    <a:pt x="148" y="61"/>
                  </a:lnTo>
                  <a:lnTo>
                    <a:pt x="148" y="60"/>
                  </a:lnTo>
                  <a:lnTo>
                    <a:pt x="148" y="59"/>
                  </a:lnTo>
                  <a:lnTo>
                    <a:pt x="148" y="58"/>
                  </a:lnTo>
                  <a:lnTo>
                    <a:pt x="149" y="57"/>
                  </a:lnTo>
                  <a:lnTo>
                    <a:pt x="149" y="56"/>
                  </a:lnTo>
                  <a:lnTo>
                    <a:pt x="149" y="56"/>
                  </a:lnTo>
                  <a:lnTo>
                    <a:pt x="149" y="55"/>
                  </a:lnTo>
                  <a:lnTo>
                    <a:pt x="149" y="54"/>
                  </a:lnTo>
                  <a:lnTo>
                    <a:pt x="150" y="54"/>
                  </a:lnTo>
                  <a:lnTo>
                    <a:pt x="150" y="53"/>
                  </a:lnTo>
                  <a:lnTo>
                    <a:pt x="150" y="52"/>
                  </a:lnTo>
                  <a:lnTo>
                    <a:pt x="150" y="52"/>
                  </a:lnTo>
                  <a:lnTo>
                    <a:pt x="150" y="51"/>
                  </a:lnTo>
                  <a:lnTo>
                    <a:pt x="150" y="51"/>
                  </a:lnTo>
                  <a:lnTo>
                    <a:pt x="151" y="50"/>
                  </a:lnTo>
                  <a:lnTo>
                    <a:pt x="151" y="49"/>
                  </a:lnTo>
                  <a:lnTo>
                    <a:pt x="151" y="49"/>
                  </a:lnTo>
                  <a:lnTo>
                    <a:pt x="151" y="48"/>
                  </a:lnTo>
                  <a:lnTo>
                    <a:pt x="151" y="47"/>
                  </a:lnTo>
                  <a:lnTo>
                    <a:pt x="152" y="47"/>
                  </a:lnTo>
                  <a:lnTo>
                    <a:pt x="152" y="46"/>
                  </a:lnTo>
                  <a:lnTo>
                    <a:pt x="152" y="46"/>
                  </a:lnTo>
                  <a:lnTo>
                    <a:pt x="152" y="46"/>
                  </a:lnTo>
                  <a:lnTo>
                    <a:pt x="152" y="45"/>
                  </a:lnTo>
                  <a:lnTo>
                    <a:pt x="153" y="45"/>
                  </a:lnTo>
                  <a:lnTo>
                    <a:pt x="153" y="44"/>
                  </a:lnTo>
                  <a:lnTo>
                    <a:pt x="153" y="44"/>
                  </a:lnTo>
                  <a:lnTo>
                    <a:pt x="153" y="43"/>
                  </a:lnTo>
                  <a:lnTo>
                    <a:pt x="153" y="43"/>
                  </a:lnTo>
                  <a:lnTo>
                    <a:pt x="153" y="43"/>
                  </a:lnTo>
                  <a:lnTo>
                    <a:pt x="154" y="42"/>
                  </a:lnTo>
                  <a:lnTo>
                    <a:pt x="154" y="42"/>
                  </a:lnTo>
                  <a:lnTo>
                    <a:pt x="154" y="41"/>
                  </a:lnTo>
                  <a:lnTo>
                    <a:pt x="154" y="41"/>
                  </a:lnTo>
                  <a:lnTo>
                    <a:pt x="154" y="41"/>
                  </a:lnTo>
                  <a:lnTo>
                    <a:pt x="155" y="41"/>
                  </a:lnTo>
                  <a:lnTo>
                    <a:pt x="155" y="41"/>
                  </a:lnTo>
                  <a:lnTo>
                    <a:pt x="155" y="40"/>
                  </a:lnTo>
                  <a:lnTo>
                    <a:pt x="155" y="4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Freeform 149"/>
            <p:cNvSpPr>
              <a:spLocks/>
            </p:cNvSpPr>
            <p:nvPr/>
          </p:nvSpPr>
          <p:spPr bwMode="auto">
            <a:xfrm>
              <a:off x="969435" y="4957575"/>
              <a:ext cx="955151" cy="52502"/>
            </a:xfrm>
            <a:custGeom>
              <a:avLst/>
              <a:gdLst>
                <a:gd name="T0" fmla="*/ 1 w 770"/>
                <a:gd name="T1" fmla="*/ 0 h 40"/>
                <a:gd name="T2" fmla="*/ 2 w 770"/>
                <a:gd name="T3" fmla="*/ 0 h 40"/>
                <a:gd name="T4" fmla="*/ 3 w 770"/>
                <a:gd name="T5" fmla="*/ 0 h 40"/>
                <a:gd name="T6" fmla="*/ 4 w 770"/>
                <a:gd name="T7" fmla="*/ 2 h 40"/>
                <a:gd name="T8" fmla="*/ 5 w 770"/>
                <a:gd name="T9" fmla="*/ 5 h 40"/>
                <a:gd name="T10" fmla="*/ 6 w 770"/>
                <a:gd name="T11" fmla="*/ 7 h 40"/>
                <a:gd name="T12" fmla="*/ 6 w 770"/>
                <a:gd name="T13" fmla="*/ 9 h 40"/>
                <a:gd name="T14" fmla="*/ 8 w 770"/>
                <a:gd name="T15" fmla="*/ 14 h 40"/>
                <a:gd name="T16" fmla="*/ 9 w 770"/>
                <a:gd name="T17" fmla="*/ 18 h 40"/>
                <a:gd name="T18" fmla="*/ 10 w 770"/>
                <a:gd name="T19" fmla="*/ 21 h 40"/>
                <a:gd name="T20" fmla="*/ 11 w 770"/>
                <a:gd name="T21" fmla="*/ 24 h 40"/>
                <a:gd name="T22" fmla="*/ 12 w 770"/>
                <a:gd name="T23" fmla="*/ 27 h 40"/>
                <a:gd name="T24" fmla="*/ 13 w 770"/>
                <a:gd name="T25" fmla="*/ 29 h 40"/>
                <a:gd name="T26" fmla="*/ 14 w 770"/>
                <a:gd name="T27" fmla="*/ 31 h 40"/>
                <a:gd name="T28" fmla="*/ 15 w 770"/>
                <a:gd name="T29" fmla="*/ 33 h 40"/>
                <a:gd name="T30" fmla="*/ 16 w 770"/>
                <a:gd name="T31" fmla="*/ 34 h 40"/>
                <a:gd name="T32" fmla="*/ 17 w 770"/>
                <a:gd name="T33" fmla="*/ 35 h 40"/>
                <a:gd name="T34" fmla="*/ 18 w 770"/>
                <a:gd name="T35" fmla="*/ 35 h 40"/>
                <a:gd name="T36" fmla="*/ 20 w 770"/>
                <a:gd name="T37" fmla="*/ 36 h 40"/>
                <a:gd name="T38" fmla="*/ 22 w 770"/>
                <a:gd name="T39" fmla="*/ 35 h 40"/>
                <a:gd name="T40" fmla="*/ 27 w 770"/>
                <a:gd name="T41" fmla="*/ 35 h 40"/>
                <a:gd name="T42" fmla="*/ 32 w 770"/>
                <a:gd name="T43" fmla="*/ 35 h 40"/>
                <a:gd name="T44" fmla="*/ 39 w 770"/>
                <a:gd name="T45" fmla="*/ 35 h 40"/>
                <a:gd name="T46" fmla="*/ 54 w 770"/>
                <a:gd name="T47" fmla="*/ 36 h 40"/>
                <a:gd name="T48" fmla="*/ 64 w 770"/>
                <a:gd name="T49" fmla="*/ 36 h 40"/>
                <a:gd name="T50" fmla="*/ 78 w 770"/>
                <a:gd name="T51" fmla="*/ 37 h 40"/>
                <a:gd name="T52" fmla="*/ 93 w 770"/>
                <a:gd name="T53" fmla="*/ 38 h 40"/>
                <a:gd name="T54" fmla="*/ 117 w 770"/>
                <a:gd name="T55" fmla="*/ 38 h 40"/>
                <a:gd name="T56" fmla="*/ 145 w 770"/>
                <a:gd name="T57" fmla="*/ 39 h 40"/>
                <a:gd name="T58" fmla="*/ 171 w 770"/>
                <a:gd name="T59" fmla="*/ 39 h 40"/>
                <a:gd name="T60" fmla="*/ 199 w 770"/>
                <a:gd name="T61" fmla="*/ 40 h 40"/>
                <a:gd name="T62" fmla="*/ 227 w 770"/>
                <a:gd name="T63" fmla="*/ 40 h 40"/>
                <a:gd name="T64" fmla="*/ 245 w 770"/>
                <a:gd name="T65" fmla="*/ 40 h 40"/>
                <a:gd name="T66" fmla="*/ 264 w 770"/>
                <a:gd name="T67" fmla="*/ 39 h 40"/>
                <a:gd name="T68" fmla="*/ 289 w 770"/>
                <a:gd name="T69" fmla="*/ 39 h 40"/>
                <a:gd name="T70" fmla="*/ 315 w 770"/>
                <a:gd name="T71" fmla="*/ 39 h 40"/>
                <a:gd name="T72" fmla="*/ 331 w 770"/>
                <a:gd name="T73" fmla="*/ 39 h 40"/>
                <a:gd name="T74" fmla="*/ 347 w 770"/>
                <a:gd name="T75" fmla="*/ 38 h 40"/>
                <a:gd name="T76" fmla="*/ 360 w 770"/>
                <a:gd name="T77" fmla="*/ 38 h 40"/>
                <a:gd name="T78" fmla="*/ 373 w 770"/>
                <a:gd name="T79" fmla="*/ 38 h 40"/>
                <a:gd name="T80" fmla="*/ 388 w 770"/>
                <a:gd name="T81" fmla="*/ 38 h 40"/>
                <a:gd name="T82" fmla="*/ 410 w 770"/>
                <a:gd name="T83" fmla="*/ 37 h 40"/>
                <a:gd name="T84" fmla="*/ 426 w 770"/>
                <a:gd name="T85" fmla="*/ 36 h 40"/>
                <a:gd name="T86" fmla="*/ 444 w 770"/>
                <a:gd name="T87" fmla="*/ 36 h 40"/>
                <a:gd name="T88" fmla="*/ 467 w 770"/>
                <a:gd name="T89" fmla="*/ 36 h 40"/>
                <a:gd name="T90" fmla="*/ 484 w 770"/>
                <a:gd name="T91" fmla="*/ 36 h 40"/>
                <a:gd name="T92" fmla="*/ 496 w 770"/>
                <a:gd name="T93" fmla="*/ 36 h 40"/>
                <a:gd name="T94" fmla="*/ 517 w 770"/>
                <a:gd name="T95" fmla="*/ 35 h 40"/>
                <a:gd name="T96" fmla="*/ 531 w 770"/>
                <a:gd name="T97" fmla="*/ 35 h 40"/>
                <a:gd name="T98" fmla="*/ 549 w 770"/>
                <a:gd name="T99" fmla="*/ 36 h 40"/>
                <a:gd name="T100" fmla="*/ 572 w 770"/>
                <a:gd name="T101" fmla="*/ 36 h 40"/>
                <a:gd name="T102" fmla="*/ 592 w 770"/>
                <a:gd name="T103" fmla="*/ 36 h 40"/>
                <a:gd name="T104" fmla="*/ 609 w 770"/>
                <a:gd name="T105" fmla="*/ 36 h 40"/>
                <a:gd name="T106" fmla="*/ 632 w 770"/>
                <a:gd name="T107" fmla="*/ 36 h 40"/>
                <a:gd name="T108" fmla="*/ 649 w 770"/>
                <a:gd name="T109" fmla="*/ 36 h 40"/>
                <a:gd name="T110" fmla="*/ 663 w 770"/>
                <a:gd name="T111" fmla="*/ 36 h 40"/>
                <a:gd name="T112" fmla="*/ 675 w 770"/>
                <a:gd name="T113" fmla="*/ 36 h 40"/>
                <a:gd name="T114" fmla="*/ 689 w 770"/>
                <a:gd name="T115" fmla="*/ 36 h 40"/>
                <a:gd name="T116" fmla="*/ 705 w 770"/>
                <a:gd name="T117" fmla="*/ 35 h 40"/>
                <a:gd name="T118" fmla="*/ 720 w 770"/>
                <a:gd name="T119" fmla="*/ 34 h 40"/>
                <a:gd name="T120" fmla="*/ 734 w 770"/>
                <a:gd name="T121" fmla="*/ 33 h 40"/>
                <a:gd name="T122" fmla="*/ 751 w 770"/>
                <a:gd name="T123" fmla="*/ 33 h 40"/>
                <a:gd name="T124" fmla="*/ 761 w 770"/>
                <a:gd name="T125" fmla="*/ 33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770" h="40">
                  <a:moveTo>
                    <a:pt x="0" y="1"/>
                  </a:moveTo>
                  <a:lnTo>
                    <a:pt x="0" y="1"/>
                  </a:lnTo>
                  <a:lnTo>
                    <a:pt x="0" y="1"/>
                  </a:lnTo>
                  <a:lnTo>
                    <a:pt x="1" y="0"/>
                  </a:lnTo>
                  <a:lnTo>
                    <a:pt x="1" y="0"/>
                  </a:lnTo>
                  <a:lnTo>
                    <a:pt x="1" y="0"/>
                  </a:lnTo>
                  <a:lnTo>
                    <a:pt x="1" y="0"/>
                  </a:lnTo>
                  <a:lnTo>
                    <a:pt x="1" y="0"/>
                  </a:lnTo>
                  <a:lnTo>
                    <a:pt x="1" y="0"/>
                  </a:lnTo>
                  <a:lnTo>
                    <a:pt x="1" y="0"/>
                  </a:lnTo>
                  <a:lnTo>
                    <a:pt x="2" y="0"/>
                  </a:lnTo>
                  <a:lnTo>
                    <a:pt x="2" y="0"/>
                  </a:lnTo>
                  <a:lnTo>
                    <a:pt x="2" y="0"/>
                  </a:lnTo>
                  <a:lnTo>
                    <a:pt x="2" y="0"/>
                  </a:lnTo>
                  <a:lnTo>
                    <a:pt x="2" y="0"/>
                  </a:lnTo>
                  <a:lnTo>
                    <a:pt x="2" y="0"/>
                  </a:lnTo>
                  <a:lnTo>
                    <a:pt x="2" y="0"/>
                  </a:lnTo>
                  <a:lnTo>
                    <a:pt x="2" y="0"/>
                  </a:lnTo>
                  <a:lnTo>
                    <a:pt x="3" y="0"/>
                  </a:lnTo>
                  <a:lnTo>
                    <a:pt x="3" y="0"/>
                  </a:lnTo>
                  <a:lnTo>
                    <a:pt x="3" y="0"/>
                  </a:lnTo>
                  <a:lnTo>
                    <a:pt x="3" y="0"/>
                  </a:lnTo>
                  <a:lnTo>
                    <a:pt x="3" y="0"/>
                  </a:lnTo>
                  <a:lnTo>
                    <a:pt x="3" y="0"/>
                  </a:lnTo>
                  <a:lnTo>
                    <a:pt x="3" y="0"/>
                  </a:lnTo>
                  <a:lnTo>
                    <a:pt x="3" y="0"/>
                  </a:lnTo>
                  <a:lnTo>
                    <a:pt x="3" y="1"/>
                  </a:lnTo>
                  <a:lnTo>
                    <a:pt x="4" y="1"/>
                  </a:lnTo>
                  <a:lnTo>
                    <a:pt x="4" y="1"/>
                  </a:lnTo>
                  <a:lnTo>
                    <a:pt x="4" y="1"/>
                  </a:lnTo>
                  <a:lnTo>
                    <a:pt x="4" y="1"/>
                  </a:lnTo>
                  <a:lnTo>
                    <a:pt x="4" y="2"/>
                  </a:lnTo>
                  <a:lnTo>
                    <a:pt x="4" y="2"/>
                  </a:lnTo>
                  <a:lnTo>
                    <a:pt x="4" y="2"/>
                  </a:lnTo>
                  <a:lnTo>
                    <a:pt x="4" y="2"/>
                  </a:lnTo>
                  <a:lnTo>
                    <a:pt x="5" y="3"/>
                  </a:lnTo>
                  <a:lnTo>
                    <a:pt x="5" y="3"/>
                  </a:lnTo>
                  <a:lnTo>
                    <a:pt x="5" y="4"/>
                  </a:lnTo>
                  <a:lnTo>
                    <a:pt x="5" y="4"/>
                  </a:lnTo>
                  <a:lnTo>
                    <a:pt x="5" y="5"/>
                  </a:lnTo>
                  <a:lnTo>
                    <a:pt x="5" y="5"/>
                  </a:lnTo>
                  <a:lnTo>
                    <a:pt x="5" y="5"/>
                  </a:lnTo>
                  <a:lnTo>
                    <a:pt x="5" y="6"/>
                  </a:lnTo>
                  <a:lnTo>
                    <a:pt x="6" y="6"/>
                  </a:lnTo>
                  <a:lnTo>
                    <a:pt x="6" y="6"/>
                  </a:lnTo>
                  <a:lnTo>
                    <a:pt x="6" y="7"/>
                  </a:lnTo>
                  <a:lnTo>
                    <a:pt x="6" y="7"/>
                  </a:lnTo>
                  <a:lnTo>
                    <a:pt x="6" y="7"/>
                  </a:lnTo>
                  <a:lnTo>
                    <a:pt x="6" y="7"/>
                  </a:lnTo>
                  <a:lnTo>
                    <a:pt x="6" y="7"/>
                  </a:lnTo>
                  <a:lnTo>
                    <a:pt x="6" y="8"/>
                  </a:lnTo>
                  <a:lnTo>
                    <a:pt x="6" y="8"/>
                  </a:lnTo>
                  <a:lnTo>
                    <a:pt x="6" y="8"/>
                  </a:lnTo>
                  <a:lnTo>
                    <a:pt x="6" y="8"/>
                  </a:lnTo>
                  <a:lnTo>
                    <a:pt x="6" y="9"/>
                  </a:lnTo>
                  <a:lnTo>
                    <a:pt x="6" y="9"/>
                  </a:lnTo>
                  <a:lnTo>
                    <a:pt x="6" y="9"/>
                  </a:lnTo>
                  <a:lnTo>
                    <a:pt x="6" y="9"/>
                  </a:lnTo>
                  <a:lnTo>
                    <a:pt x="7" y="10"/>
                  </a:lnTo>
                  <a:lnTo>
                    <a:pt x="7" y="11"/>
                  </a:lnTo>
                  <a:lnTo>
                    <a:pt x="7" y="12"/>
                  </a:lnTo>
                  <a:lnTo>
                    <a:pt x="7" y="13"/>
                  </a:lnTo>
                  <a:lnTo>
                    <a:pt x="8" y="14"/>
                  </a:lnTo>
                  <a:lnTo>
                    <a:pt x="8" y="14"/>
                  </a:lnTo>
                  <a:lnTo>
                    <a:pt x="8" y="15"/>
                  </a:lnTo>
                  <a:lnTo>
                    <a:pt x="8" y="15"/>
                  </a:lnTo>
                  <a:lnTo>
                    <a:pt x="8" y="16"/>
                  </a:lnTo>
                  <a:lnTo>
                    <a:pt x="8" y="16"/>
                  </a:lnTo>
                  <a:lnTo>
                    <a:pt x="8" y="17"/>
                  </a:lnTo>
                  <a:lnTo>
                    <a:pt x="9" y="17"/>
                  </a:lnTo>
                  <a:lnTo>
                    <a:pt x="9" y="18"/>
                  </a:lnTo>
                  <a:lnTo>
                    <a:pt x="9" y="18"/>
                  </a:lnTo>
                  <a:lnTo>
                    <a:pt x="9" y="18"/>
                  </a:lnTo>
                  <a:lnTo>
                    <a:pt x="9" y="19"/>
                  </a:lnTo>
                  <a:lnTo>
                    <a:pt x="9" y="19"/>
                  </a:lnTo>
                  <a:lnTo>
                    <a:pt x="9" y="20"/>
                  </a:lnTo>
                  <a:lnTo>
                    <a:pt x="9" y="20"/>
                  </a:lnTo>
                  <a:lnTo>
                    <a:pt x="9" y="20"/>
                  </a:lnTo>
                  <a:lnTo>
                    <a:pt x="10" y="21"/>
                  </a:lnTo>
                  <a:lnTo>
                    <a:pt x="10" y="21"/>
                  </a:lnTo>
                  <a:lnTo>
                    <a:pt x="10" y="22"/>
                  </a:lnTo>
                  <a:lnTo>
                    <a:pt x="10" y="22"/>
                  </a:lnTo>
                  <a:lnTo>
                    <a:pt x="10" y="22"/>
                  </a:lnTo>
                  <a:lnTo>
                    <a:pt x="10" y="23"/>
                  </a:lnTo>
                  <a:lnTo>
                    <a:pt x="10" y="23"/>
                  </a:lnTo>
                  <a:lnTo>
                    <a:pt x="10" y="23"/>
                  </a:lnTo>
                  <a:lnTo>
                    <a:pt x="11" y="24"/>
                  </a:lnTo>
                  <a:lnTo>
                    <a:pt x="11" y="24"/>
                  </a:lnTo>
                  <a:lnTo>
                    <a:pt x="11" y="24"/>
                  </a:lnTo>
                  <a:lnTo>
                    <a:pt x="11" y="25"/>
                  </a:lnTo>
                  <a:lnTo>
                    <a:pt x="11" y="25"/>
                  </a:lnTo>
                  <a:lnTo>
                    <a:pt x="11" y="25"/>
                  </a:lnTo>
                  <a:lnTo>
                    <a:pt x="11" y="26"/>
                  </a:lnTo>
                  <a:lnTo>
                    <a:pt x="12" y="26"/>
                  </a:lnTo>
                  <a:lnTo>
                    <a:pt x="12" y="26"/>
                  </a:lnTo>
                  <a:lnTo>
                    <a:pt x="12" y="27"/>
                  </a:lnTo>
                  <a:lnTo>
                    <a:pt x="12" y="27"/>
                  </a:lnTo>
                  <a:lnTo>
                    <a:pt x="12" y="27"/>
                  </a:lnTo>
                  <a:lnTo>
                    <a:pt x="12" y="27"/>
                  </a:lnTo>
                  <a:lnTo>
                    <a:pt x="12" y="28"/>
                  </a:lnTo>
                  <a:lnTo>
                    <a:pt x="12" y="28"/>
                  </a:lnTo>
                  <a:lnTo>
                    <a:pt x="13" y="28"/>
                  </a:lnTo>
                  <a:lnTo>
                    <a:pt x="13" y="29"/>
                  </a:lnTo>
                  <a:lnTo>
                    <a:pt x="13" y="29"/>
                  </a:lnTo>
                  <a:lnTo>
                    <a:pt x="13" y="29"/>
                  </a:lnTo>
                  <a:lnTo>
                    <a:pt x="13" y="30"/>
                  </a:lnTo>
                  <a:lnTo>
                    <a:pt x="13" y="30"/>
                  </a:lnTo>
                  <a:lnTo>
                    <a:pt x="13" y="30"/>
                  </a:lnTo>
                  <a:lnTo>
                    <a:pt x="13" y="30"/>
                  </a:lnTo>
                  <a:lnTo>
                    <a:pt x="14" y="30"/>
                  </a:lnTo>
                  <a:lnTo>
                    <a:pt x="14" y="31"/>
                  </a:lnTo>
                  <a:lnTo>
                    <a:pt x="14" y="31"/>
                  </a:lnTo>
                  <a:lnTo>
                    <a:pt x="14" y="31"/>
                  </a:lnTo>
                  <a:lnTo>
                    <a:pt x="14" y="31"/>
                  </a:lnTo>
                  <a:lnTo>
                    <a:pt x="14" y="32"/>
                  </a:lnTo>
                  <a:lnTo>
                    <a:pt x="14" y="32"/>
                  </a:lnTo>
                  <a:lnTo>
                    <a:pt x="15" y="32"/>
                  </a:lnTo>
                  <a:lnTo>
                    <a:pt x="15" y="32"/>
                  </a:lnTo>
                  <a:lnTo>
                    <a:pt x="15" y="33"/>
                  </a:lnTo>
                  <a:lnTo>
                    <a:pt x="15" y="33"/>
                  </a:lnTo>
                  <a:lnTo>
                    <a:pt x="15" y="33"/>
                  </a:lnTo>
                  <a:lnTo>
                    <a:pt x="15" y="33"/>
                  </a:lnTo>
                  <a:lnTo>
                    <a:pt x="15" y="33"/>
                  </a:lnTo>
                  <a:lnTo>
                    <a:pt x="15" y="33"/>
                  </a:lnTo>
                  <a:lnTo>
                    <a:pt x="16" y="34"/>
                  </a:lnTo>
                  <a:lnTo>
                    <a:pt x="16" y="34"/>
                  </a:lnTo>
                  <a:lnTo>
                    <a:pt x="16" y="34"/>
                  </a:lnTo>
                  <a:lnTo>
                    <a:pt x="16" y="34"/>
                  </a:lnTo>
                  <a:lnTo>
                    <a:pt x="16" y="34"/>
                  </a:lnTo>
                  <a:lnTo>
                    <a:pt x="16" y="34"/>
                  </a:lnTo>
                  <a:lnTo>
                    <a:pt x="16" y="34"/>
                  </a:lnTo>
                  <a:lnTo>
                    <a:pt x="16" y="35"/>
                  </a:lnTo>
                  <a:lnTo>
                    <a:pt x="17" y="35"/>
                  </a:lnTo>
                  <a:lnTo>
                    <a:pt x="17" y="35"/>
                  </a:lnTo>
                  <a:lnTo>
                    <a:pt x="17" y="35"/>
                  </a:lnTo>
                  <a:lnTo>
                    <a:pt x="17" y="35"/>
                  </a:lnTo>
                  <a:lnTo>
                    <a:pt x="17" y="35"/>
                  </a:lnTo>
                  <a:lnTo>
                    <a:pt x="17" y="35"/>
                  </a:lnTo>
                  <a:lnTo>
                    <a:pt x="17" y="35"/>
                  </a:lnTo>
                  <a:lnTo>
                    <a:pt x="18" y="35"/>
                  </a:lnTo>
                  <a:lnTo>
                    <a:pt x="18" y="35"/>
                  </a:lnTo>
                  <a:lnTo>
                    <a:pt x="18" y="35"/>
                  </a:lnTo>
                  <a:lnTo>
                    <a:pt x="18" y="35"/>
                  </a:lnTo>
                  <a:lnTo>
                    <a:pt x="18" y="35"/>
                  </a:lnTo>
                  <a:lnTo>
                    <a:pt x="18" y="35"/>
                  </a:lnTo>
                  <a:lnTo>
                    <a:pt x="19" y="35"/>
                  </a:lnTo>
                  <a:lnTo>
                    <a:pt x="19" y="35"/>
                  </a:lnTo>
                  <a:lnTo>
                    <a:pt x="19" y="35"/>
                  </a:lnTo>
                  <a:lnTo>
                    <a:pt x="19" y="36"/>
                  </a:lnTo>
                  <a:lnTo>
                    <a:pt x="19" y="36"/>
                  </a:lnTo>
                  <a:lnTo>
                    <a:pt x="20" y="36"/>
                  </a:lnTo>
                  <a:lnTo>
                    <a:pt x="20" y="36"/>
                  </a:lnTo>
                  <a:lnTo>
                    <a:pt x="20" y="36"/>
                  </a:lnTo>
                  <a:lnTo>
                    <a:pt x="20" y="35"/>
                  </a:lnTo>
                  <a:lnTo>
                    <a:pt x="21" y="35"/>
                  </a:lnTo>
                  <a:lnTo>
                    <a:pt x="21" y="35"/>
                  </a:lnTo>
                  <a:lnTo>
                    <a:pt x="21" y="35"/>
                  </a:lnTo>
                  <a:lnTo>
                    <a:pt x="21" y="35"/>
                  </a:lnTo>
                  <a:lnTo>
                    <a:pt x="22" y="35"/>
                  </a:lnTo>
                  <a:lnTo>
                    <a:pt x="22" y="35"/>
                  </a:lnTo>
                  <a:lnTo>
                    <a:pt x="23" y="35"/>
                  </a:lnTo>
                  <a:lnTo>
                    <a:pt x="23" y="35"/>
                  </a:lnTo>
                  <a:lnTo>
                    <a:pt x="24" y="35"/>
                  </a:lnTo>
                  <a:lnTo>
                    <a:pt x="25" y="35"/>
                  </a:lnTo>
                  <a:lnTo>
                    <a:pt x="25" y="35"/>
                  </a:lnTo>
                  <a:lnTo>
                    <a:pt x="26" y="35"/>
                  </a:lnTo>
                  <a:lnTo>
                    <a:pt x="27" y="35"/>
                  </a:lnTo>
                  <a:lnTo>
                    <a:pt x="27" y="35"/>
                  </a:lnTo>
                  <a:lnTo>
                    <a:pt x="28" y="35"/>
                  </a:lnTo>
                  <a:lnTo>
                    <a:pt x="28" y="35"/>
                  </a:lnTo>
                  <a:lnTo>
                    <a:pt x="29" y="35"/>
                  </a:lnTo>
                  <a:lnTo>
                    <a:pt x="30" y="35"/>
                  </a:lnTo>
                  <a:lnTo>
                    <a:pt x="30" y="35"/>
                  </a:lnTo>
                  <a:lnTo>
                    <a:pt x="31" y="35"/>
                  </a:lnTo>
                  <a:lnTo>
                    <a:pt x="32" y="35"/>
                  </a:lnTo>
                  <a:lnTo>
                    <a:pt x="32" y="35"/>
                  </a:lnTo>
                  <a:lnTo>
                    <a:pt x="33" y="35"/>
                  </a:lnTo>
                  <a:lnTo>
                    <a:pt x="33" y="35"/>
                  </a:lnTo>
                  <a:lnTo>
                    <a:pt x="34" y="35"/>
                  </a:lnTo>
                  <a:lnTo>
                    <a:pt x="34" y="35"/>
                  </a:lnTo>
                  <a:lnTo>
                    <a:pt x="35" y="35"/>
                  </a:lnTo>
                  <a:lnTo>
                    <a:pt x="35" y="35"/>
                  </a:lnTo>
                  <a:lnTo>
                    <a:pt x="37" y="35"/>
                  </a:lnTo>
                  <a:lnTo>
                    <a:pt x="39" y="35"/>
                  </a:lnTo>
                  <a:lnTo>
                    <a:pt x="42" y="35"/>
                  </a:lnTo>
                  <a:lnTo>
                    <a:pt x="44" y="35"/>
                  </a:lnTo>
                  <a:lnTo>
                    <a:pt x="46" y="35"/>
                  </a:lnTo>
                  <a:lnTo>
                    <a:pt x="47" y="35"/>
                  </a:lnTo>
                  <a:lnTo>
                    <a:pt x="49" y="35"/>
                  </a:lnTo>
                  <a:lnTo>
                    <a:pt x="50" y="35"/>
                  </a:lnTo>
                  <a:lnTo>
                    <a:pt x="52" y="36"/>
                  </a:lnTo>
                  <a:lnTo>
                    <a:pt x="54" y="36"/>
                  </a:lnTo>
                  <a:lnTo>
                    <a:pt x="56" y="36"/>
                  </a:lnTo>
                  <a:lnTo>
                    <a:pt x="58" y="36"/>
                  </a:lnTo>
                  <a:lnTo>
                    <a:pt x="60" y="36"/>
                  </a:lnTo>
                  <a:lnTo>
                    <a:pt x="61" y="36"/>
                  </a:lnTo>
                  <a:lnTo>
                    <a:pt x="62" y="36"/>
                  </a:lnTo>
                  <a:lnTo>
                    <a:pt x="62" y="36"/>
                  </a:lnTo>
                  <a:lnTo>
                    <a:pt x="63" y="36"/>
                  </a:lnTo>
                  <a:lnTo>
                    <a:pt x="64" y="36"/>
                  </a:lnTo>
                  <a:lnTo>
                    <a:pt x="67" y="37"/>
                  </a:lnTo>
                  <a:lnTo>
                    <a:pt x="68" y="37"/>
                  </a:lnTo>
                  <a:lnTo>
                    <a:pt x="70" y="37"/>
                  </a:lnTo>
                  <a:lnTo>
                    <a:pt x="72" y="37"/>
                  </a:lnTo>
                  <a:lnTo>
                    <a:pt x="73" y="37"/>
                  </a:lnTo>
                  <a:lnTo>
                    <a:pt x="75" y="37"/>
                  </a:lnTo>
                  <a:lnTo>
                    <a:pt x="76" y="37"/>
                  </a:lnTo>
                  <a:lnTo>
                    <a:pt x="78" y="37"/>
                  </a:lnTo>
                  <a:lnTo>
                    <a:pt x="79" y="37"/>
                  </a:lnTo>
                  <a:lnTo>
                    <a:pt x="81" y="37"/>
                  </a:lnTo>
                  <a:lnTo>
                    <a:pt x="83" y="37"/>
                  </a:lnTo>
                  <a:lnTo>
                    <a:pt x="85" y="37"/>
                  </a:lnTo>
                  <a:lnTo>
                    <a:pt x="87" y="37"/>
                  </a:lnTo>
                  <a:lnTo>
                    <a:pt x="88" y="38"/>
                  </a:lnTo>
                  <a:lnTo>
                    <a:pt x="91" y="38"/>
                  </a:lnTo>
                  <a:lnTo>
                    <a:pt x="93" y="38"/>
                  </a:lnTo>
                  <a:lnTo>
                    <a:pt x="96" y="38"/>
                  </a:lnTo>
                  <a:lnTo>
                    <a:pt x="100" y="38"/>
                  </a:lnTo>
                  <a:lnTo>
                    <a:pt x="103" y="38"/>
                  </a:lnTo>
                  <a:lnTo>
                    <a:pt x="107" y="38"/>
                  </a:lnTo>
                  <a:lnTo>
                    <a:pt x="111" y="38"/>
                  </a:lnTo>
                  <a:lnTo>
                    <a:pt x="114" y="38"/>
                  </a:lnTo>
                  <a:lnTo>
                    <a:pt x="116" y="38"/>
                  </a:lnTo>
                  <a:lnTo>
                    <a:pt x="117" y="38"/>
                  </a:lnTo>
                  <a:lnTo>
                    <a:pt x="119" y="38"/>
                  </a:lnTo>
                  <a:lnTo>
                    <a:pt x="121" y="38"/>
                  </a:lnTo>
                  <a:lnTo>
                    <a:pt x="123" y="38"/>
                  </a:lnTo>
                  <a:lnTo>
                    <a:pt x="127" y="38"/>
                  </a:lnTo>
                  <a:lnTo>
                    <a:pt x="133" y="39"/>
                  </a:lnTo>
                  <a:lnTo>
                    <a:pt x="138" y="39"/>
                  </a:lnTo>
                  <a:lnTo>
                    <a:pt x="141" y="39"/>
                  </a:lnTo>
                  <a:lnTo>
                    <a:pt x="145" y="39"/>
                  </a:lnTo>
                  <a:lnTo>
                    <a:pt x="147" y="39"/>
                  </a:lnTo>
                  <a:lnTo>
                    <a:pt x="153" y="39"/>
                  </a:lnTo>
                  <a:lnTo>
                    <a:pt x="159" y="39"/>
                  </a:lnTo>
                  <a:lnTo>
                    <a:pt x="162" y="39"/>
                  </a:lnTo>
                  <a:lnTo>
                    <a:pt x="164" y="39"/>
                  </a:lnTo>
                  <a:lnTo>
                    <a:pt x="167" y="39"/>
                  </a:lnTo>
                  <a:lnTo>
                    <a:pt x="169" y="39"/>
                  </a:lnTo>
                  <a:lnTo>
                    <a:pt x="171" y="39"/>
                  </a:lnTo>
                  <a:lnTo>
                    <a:pt x="173" y="39"/>
                  </a:lnTo>
                  <a:lnTo>
                    <a:pt x="176" y="39"/>
                  </a:lnTo>
                  <a:lnTo>
                    <a:pt x="180" y="39"/>
                  </a:lnTo>
                  <a:lnTo>
                    <a:pt x="186" y="39"/>
                  </a:lnTo>
                  <a:lnTo>
                    <a:pt x="191" y="39"/>
                  </a:lnTo>
                  <a:lnTo>
                    <a:pt x="195" y="40"/>
                  </a:lnTo>
                  <a:lnTo>
                    <a:pt x="197" y="40"/>
                  </a:lnTo>
                  <a:lnTo>
                    <a:pt x="199" y="40"/>
                  </a:lnTo>
                  <a:lnTo>
                    <a:pt x="202" y="40"/>
                  </a:lnTo>
                  <a:lnTo>
                    <a:pt x="205" y="40"/>
                  </a:lnTo>
                  <a:lnTo>
                    <a:pt x="208" y="40"/>
                  </a:lnTo>
                  <a:lnTo>
                    <a:pt x="212" y="40"/>
                  </a:lnTo>
                  <a:lnTo>
                    <a:pt x="217" y="40"/>
                  </a:lnTo>
                  <a:lnTo>
                    <a:pt x="221" y="40"/>
                  </a:lnTo>
                  <a:lnTo>
                    <a:pt x="224" y="40"/>
                  </a:lnTo>
                  <a:lnTo>
                    <a:pt x="227" y="40"/>
                  </a:lnTo>
                  <a:lnTo>
                    <a:pt x="230" y="40"/>
                  </a:lnTo>
                  <a:lnTo>
                    <a:pt x="232" y="40"/>
                  </a:lnTo>
                  <a:lnTo>
                    <a:pt x="234" y="40"/>
                  </a:lnTo>
                  <a:lnTo>
                    <a:pt x="236" y="40"/>
                  </a:lnTo>
                  <a:lnTo>
                    <a:pt x="238" y="40"/>
                  </a:lnTo>
                  <a:lnTo>
                    <a:pt x="240" y="40"/>
                  </a:lnTo>
                  <a:lnTo>
                    <a:pt x="242" y="40"/>
                  </a:lnTo>
                  <a:lnTo>
                    <a:pt x="245" y="40"/>
                  </a:lnTo>
                  <a:lnTo>
                    <a:pt x="247" y="40"/>
                  </a:lnTo>
                  <a:lnTo>
                    <a:pt x="249" y="40"/>
                  </a:lnTo>
                  <a:lnTo>
                    <a:pt x="250" y="40"/>
                  </a:lnTo>
                  <a:lnTo>
                    <a:pt x="252" y="40"/>
                  </a:lnTo>
                  <a:lnTo>
                    <a:pt x="256" y="40"/>
                  </a:lnTo>
                  <a:lnTo>
                    <a:pt x="259" y="39"/>
                  </a:lnTo>
                  <a:lnTo>
                    <a:pt x="261" y="39"/>
                  </a:lnTo>
                  <a:lnTo>
                    <a:pt x="264" y="39"/>
                  </a:lnTo>
                  <a:lnTo>
                    <a:pt x="267" y="39"/>
                  </a:lnTo>
                  <a:lnTo>
                    <a:pt x="270" y="39"/>
                  </a:lnTo>
                  <a:lnTo>
                    <a:pt x="273" y="39"/>
                  </a:lnTo>
                  <a:lnTo>
                    <a:pt x="277" y="39"/>
                  </a:lnTo>
                  <a:lnTo>
                    <a:pt x="281" y="39"/>
                  </a:lnTo>
                  <a:lnTo>
                    <a:pt x="284" y="39"/>
                  </a:lnTo>
                  <a:lnTo>
                    <a:pt x="286" y="39"/>
                  </a:lnTo>
                  <a:lnTo>
                    <a:pt x="289" y="39"/>
                  </a:lnTo>
                  <a:lnTo>
                    <a:pt x="292" y="39"/>
                  </a:lnTo>
                  <a:lnTo>
                    <a:pt x="295" y="39"/>
                  </a:lnTo>
                  <a:lnTo>
                    <a:pt x="299" y="39"/>
                  </a:lnTo>
                  <a:lnTo>
                    <a:pt x="303" y="39"/>
                  </a:lnTo>
                  <a:lnTo>
                    <a:pt x="305" y="39"/>
                  </a:lnTo>
                  <a:lnTo>
                    <a:pt x="308" y="39"/>
                  </a:lnTo>
                  <a:lnTo>
                    <a:pt x="310" y="39"/>
                  </a:lnTo>
                  <a:lnTo>
                    <a:pt x="315" y="39"/>
                  </a:lnTo>
                  <a:lnTo>
                    <a:pt x="319" y="39"/>
                  </a:lnTo>
                  <a:lnTo>
                    <a:pt x="323" y="39"/>
                  </a:lnTo>
                  <a:lnTo>
                    <a:pt x="325" y="39"/>
                  </a:lnTo>
                  <a:lnTo>
                    <a:pt x="327" y="39"/>
                  </a:lnTo>
                  <a:lnTo>
                    <a:pt x="328" y="39"/>
                  </a:lnTo>
                  <a:lnTo>
                    <a:pt x="329" y="39"/>
                  </a:lnTo>
                  <a:lnTo>
                    <a:pt x="330" y="39"/>
                  </a:lnTo>
                  <a:lnTo>
                    <a:pt x="331" y="39"/>
                  </a:lnTo>
                  <a:lnTo>
                    <a:pt x="332" y="39"/>
                  </a:lnTo>
                  <a:lnTo>
                    <a:pt x="333" y="39"/>
                  </a:lnTo>
                  <a:lnTo>
                    <a:pt x="334" y="39"/>
                  </a:lnTo>
                  <a:lnTo>
                    <a:pt x="336" y="39"/>
                  </a:lnTo>
                  <a:lnTo>
                    <a:pt x="338" y="38"/>
                  </a:lnTo>
                  <a:lnTo>
                    <a:pt x="342" y="38"/>
                  </a:lnTo>
                  <a:lnTo>
                    <a:pt x="345" y="38"/>
                  </a:lnTo>
                  <a:lnTo>
                    <a:pt x="347" y="38"/>
                  </a:lnTo>
                  <a:lnTo>
                    <a:pt x="349" y="38"/>
                  </a:lnTo>
                  <a:lnTo>
                    <a:pt x="351" y="38"/>
                  </a:lnTo>
                  <a:lnTo>
                    <a:pt x="352" y="38"/>
                  </a:lnTo>
                  <a:lnTo>
                    <a:pt x="354" y="38"/>
                  </a:lnTo>
                  <a:lnTo>
                    <a:pt x="356" y="38"/>
                  </a:lnTo>
                  <a:lnTo>
                    <a:pt x="358" y="38"/>
                  </a:lnTo>
                  <a:lnTo>
                    <a:pt x="359" y="38"/>
                  </a:lnTo>
                  <a:lnTo>
                    <a:pt x="360" y="38"/>
                  </a:lnTo>
                  <a:lnTo>
                    <a:pt x="361" y="38"/>
                  </a:lnTo>
                  <a:lnTo>
                    <a:pt x="362" y="38"/>
                  </a:lnTo>
                  <a:lnTo>
                    <a:pt x="364" y="38"/>
                  </a:lnTo>
                  <a:lnTo>
                    <a:pt x="366" y="38"/>
                  </a:lnTo>
                  <a:lnTo>
                    <a:pt x="367" y="38"/>
                  </a:lnTo>
                  <a:lnTo>
                    <a:pt x="369" y="38"/>
                  </a:lnTo>
                  <a:lnTo>
                    <a:pt x="371" y="38"/>
                  </a:lnTo>
                  <a:lnTo>
                    <a:pt x="373" y="38"/>
                  </a:lnTo>
                  <a:lnTo>
                    <a:pt x="376" y="38"/>
                  </a:lnTo>
                  <a:lnTo>
                    <a:pt x="378" y="38"/>
                  </a:lnTo>
                  <a:lnTo>
                    <a:pt x="380" y="38"/>
                  </a:lnTo>
                  <a:lnTo>
                    <a:pt x="381" y="38"/>
                  </a:lnTo>
                  <a:lnTo>
                    <a:pt x="383" y="38"/>
                  </a:lnTo>
                  <a:lnTo>
                    <a:pt x="384" y="38"/>
                  </a:lnTo>
                  <a:lnTo>
                    <a:pt x="385" y="38"/>
                  </a:lnTo>
                  <a:lnTo>
                    <a:pt x="388" y="38"/>
                  </a:lnTo>
                  <a:lnTo>
                    <a:pt x="391" y="38"/>
                  </a:lnTo>
                  <a:lnTo>
                    <a:pt x="394" y="38"/>
                  </a:lnTo>
                  <a:lnTo>
                    <a:pt x="398" y="37"/>
                  </a:lnTo>
                  <a:lnTo>
                    <a:pt x="402" y="37"/>
                  </a:lnTo>
                  <a:lnTo>
                    <a:pt x="405" y="37"/>
                  </a:lnTo>
                  <a:lnTo>
                    <a:pt x="407" y="37"/>
                  </a:lnTo>
                  <a:lnTo>
                    <a:pt x="409" y="37"/>
                  </a:lnTo>
                  <a:lnTo>
                    <a:pt x="410" y="37"/>
                  </a:lnTo>
                  <a:lnTo>
                    <a:pt x="412" y="37"/>
                  </a:lnTo>
                  <a:lnTo>
                    <a:pt x="414" y="37"/>
                  </a:lnTo>
                  <a:lnTo>
                    <a:pt x="415" y="37"/>
                  </a:lnTo>
                  <a:lnTo>
                    <a:pt x="417" y="37"/>
                  </a:lnTo>
                  <a:lnTo>
                    <a:pt x="420" y="37"/>
                  </a:lnTo>
                  <a:lnTo>
                    <a:pt x="422" y="37"/>
                  </a:lnTo>
                  <a:lnTo>
                    <a:pt x="424" y="37"/>
                  </a:lnTo>
                  <a:lnTo>
                    <a:pt x="426" y="36"/>
                  </a:lnTo>
                  <a:lnTo>
                    <a:pt x="429" y="36"/>
                  </a:lnTo>
                  <a:lnTo>
                    <a:pt x="431" y="36"/>
                  </a:lnTo>
                  <a:lnTo>
                    <a:pt x="433" y="36"/>
                  </a:lnTo>
                  <a:lnTo>
                    <a:pt x="435" y="36"/>
                  </a:lnTo>
                  <a:lnTo>
                    <a:pt x="437" y="36"/>
                  </a:lnTo>
                  <a:lnTo>
                    <a:pt x="438" y="36"/>
                  </a:lnTo>
                  <a:lnTo>
                    <a:pt x="440" y="36"/>
                  </a:lnTo>
                  <a:lnTo>
                    <a:pt x="444" y="36"/>
                  </a:lnTo>
                  <a:lnTo>
                    <a:pt x="448" y="36"/>
                  </a:lnTo>
                  <a:lnTo>
                    <a:pt x="452" y="36"/>
                  </a:lnTo>
                  <a:lnTo>
                    <a:pt x="456" y="36"/>
                  </a:lnTo>
                  <a:lnTo>
                    <a:pt x="460" y="36"/>
                  </a:lnTo>
                  <a:lnTo>
                    <a:pt x="463" y="36"/>
                  </a:lnTo>
                  <a:lnTo>
                    <a:pt x="464" y="36"/>
                  </a:lnTo>
                  <a:lnTo>
                    <a:pt x="465" y="36"/>
                  </a:lnTo>
                  <a:lnTo>
                    <a:pt x="467" y="36"/>
                  </a:lnTo>
                  <a:lnTo>
                    <a:pt x="469" y="36"/>
                  </a:lnTo>
                  <a:lnTo>
                    <a:pt x="471" y="36"/>
                  </a:lnTo>
                  <a:lnTo>
                    <a:pt x="474" y="36"/>
                  </a:lnTo>
                  <a:lnTo>
                    <a:pt x="476" y="36"/>
                  </a:lnTo>
                  <a:lnTo>
                    <a:pt x="478" y="36"/>
                  </a:lnTo>
                  <a:lnTo>
                    <a:pt x="480" y="36"/>
                  </a:lnTo>
                  <a:lnTo>
                    <a:pt x="482" y="36"/>
                  </a:lnTo>
                  <a:lnTo>
                    <a:pt x="484" y="36"/>
                  </a:lnTo>
                  <a:lnTo>
                    <a:pt x="486" y="36"/>
                  </a:lnTo>
                  <a:lnTo>
                    <a:pt x="488" y="36"/>
                  </a:lnTo>
                  <a:lnTo>
                    <a:pt x="490" y="36"/>
                  </a:lnTo>
                  <a:lnTo>
                    <a:pt x="492" y="36"/>
                  </a:lnTo>
                  <a:lnTo>
                    <a:pt x="493" y="36"/>
                  </a:lnTo>
                  <a:lnTo>
                    <a:pt x="494" y="36"/>
                  </a:lnTo>
                  <a:lnTo>
                    <a:pt x="495" y="36"/>
                  </a:lnTo>
                  <a:lnTo>
                    <a:pt x="496" y="36"/>
                  </a:lnTo>
                  <a:lnTo>
                    <a:pt x="498" y="36"/>
                  </a:lnTo>
                  <a:lnTo>
                    <a:pt x="500" y="36"/>
                  </a:lnTo>
                  <a:lnTo>
                    <a:pt x="502" y="36"/>
                  </a:lnTo>
                  <a:lnTo>
                    <a:pt x="504" y="36"/>
                  </a:lnTo>
                  <a:lnTo>
                    <a:pt x="508" y="36"/>
                  </a:lnTo>
                  <a:lnTo>
                    <a:pt x="512" y="35"/>
                  </a:lnTo>
                  <a:lnTo>
                    <a:pt x="515" y="35"/>
                  </a:lnTo>
                  <a:lnTo>
                    <a:pt x="517" y="35"/>
                  </a:lnTo>
                  <a:lnTo>
                    <a:pt x="519" y="35"/>
                  </a:lnTo>
                  <a:lnTo>
                    <a:pt x="520" y="35"/>
                  </a:lnTo>
                  <a:lnTo>
                    <a:pt x="521" y="35"/>
                  </a:lnTo>
                  <a:lnTo>
                    <a:pt x="523" y="35"/>
                  </a:lnTo>
                  <a:lnTo>
                    <a:pt x="525" y="35"/>
                  </a:lnTo>
                  <a:lnTo>
                    <a:pt x="527" y="35"/>
                  </a:lnTo>
                  <a:lnTo>
                    <a:pt x="528" y="35"/>
                  </a:lnTo>
                  <a:lnTo>
                    <a:pt x="531" y="35"/>
                  </a:lnTo>
                  <a:lnTo>
                    <a:pt x="534" y="35"/>
                  </a:lnTo>
                  <a:lnTo>
                    <a:pt x="537" y="35"/>
                  </a:lnTo>
                  <a:lnTo>
                    <a:pt x="540" y="35"/>
                  </a:lnTo>
                  <a:lnTo>
                    <a:pt x="542" y="35"/>
                  </a:lnTo>
                  <a:lnTo>
                    <a:pt x="544" y="35"/>
                  </a:lnTo>
                  <a:lnTo>
                    <a:pt x="545" y="35"/>
                  </a:lnTo>
                  <a:lnTo>
                    <a:pt x="547" y="36"/>
                  </a:lnTo>
                  <a:lnTo>
                    <a:pt x="549" y="36"/>
                  </a:lnTo>
                  <a:lnTo>
                    <a:pt x="551" y="36"/>
                  </a:lnTo>
                  <a:lnTo>
                    <a:pt x="553" y="36"/>
                  </a:lnTo>
                  <a:lnTo>
                    <a:pt x="556" y="36"/>
                  </a:lnTo>
                  <a:lnTo>
                    <a:pt x="560" y="36"/>
                  </a:lnTo>
                  <a:lnTo>
                    <a:pt x="565" y="36"/>
                  </a:lnTo>
                  <a:lnTo>
                    <a:pt x="568" y="36"/>
                  </a:lnTo>
                  <a:lnTo>
                    <a:pt x="571" y="36"/>
                  </a:lnTo>
                  <a:lnTo>
                    <a:pt x="572" y="36"/>
                  </a:lnTo>
                  <a:lnTo>
                    <a:pt x="574" y="36"/>
                  </a:lnTo>
                  <a:lnTo>
                    <a:pt x="576" y="36"/>
                  </a:lnTo>
                  <a:lnTo>
                    <a:pt x="578" y="36"/>
                  </a:lnTo>
                  <a:lnTo>
                    <a:pt x="580" y="36"/>
                  </a:lnTo>
                  <a:lnTo>
                    <a:pt x="582" y="36"/>
                  </a:lnTo>
                  <a:lnTo>
                    <a:pt x="585" y="36"/>
                  </a:lnTo>
                  <a:lnTo>
                    <a:pt x="588" y="36"/>
                  </a:lnTo>
                  <a:lnTo>
                    <a:pt x="592" y="36"/>
                  </a:lnTo>
                  <a:lnTo>
                    <a:pt x="596" y="36"/>
                  </a:lnTo>
                  <a:lnTo>
                    <a:pt x="598" y="36"/>
                  </a:lnTo>
                  <a:lnTo>
                    <a:pt x="599" y="36"/>
                  </a:lnTo>
                  <a:lnTo>
                    <a:pt x="601" y="36"/>
                  </a:lnTo>
                  <a:lnTo>
                    <a:pt x="603" y="36"/>
                  </a:lnTo>
                  <a:lnTo>
                    <a:pt x="605" y="36"/>
                  </a:lnTo>
                  <a:lnTo>
                    <a:pt x="607" y="36"/>
                  </a:lnTo>
                  <a:lnTo>
                    <a:pt x="609" y="36"/>
                  </a:lnTo>
                  <a:lnTo>
                    <a:pt x="611" y="36"/>
                  </a:lnTo>
                  <a:lnTo>
                    <a:pt x="615" y="36"/>
                  </a:lnTo>
                  <a:lnTo>
                    <a:pt x="618" y="36"/>
                  </a:lnTo>
                  <a:lnTo>
                    <a:pt x="621" y="36"/>
                  </a:lnTo>
                  <a:lnTo>
                    <a:pt x="624" y="36"/>
                  </a:lnTo>
                  <a:lnTo>
                    <a:pt x="627" y="36"/>
                  </a:lnTo>
                  <a:lnTo>
                    <a:pt x="629" y="36"/>
                  </a:lnTo>
                  <a:lnTo>
                    <a:pt x="632" y="36"/>
                  </a:lnTo>
                  <a:lnTo>
                    <a:pt x="635" y="36"/>
                  </a:lnTo>
                  <a:lnTo>
                    <a:pt x="638" y="36"/>
                  </a:lnTo>
                  <a:lnTo>
                    <a:pt x="640" y="36"/>
                  </a:lnTo>
                  <a:lnTo>
                    <a:pt x="641" y="36"/>
                  </a:lnTo>
                  <a:lnTo>
                    <a:pt x="643" y="36"/>
                  </a:lnTo>
                  <a:lnTo>
                    <a:pt x="645" y="36"/>
                  </a:lnTo>
                  <a:lnTo>
                    <a:pt x="647" y="36"/>
                  </a:lnTo>
                  <a:lnTo>
                    <a:pt x="649" y="36"/>
                  </a:lnTo>
                  <a:lnTo>
                    <a:pt x="650" y="36"/>
                  </a:lnTo>
                  <a:lnTo>
                    <a:pt x="651" y="36"/>
                  </a:lnTo>
                  <a:lnTo>
                    <a:pt x="654" y="36"/>
                  </a:lnTo>
                  <a:lnTo>
                    <a:pt x="656" y="36"/>
                  </a:lnTo>
                  <a:lnTo>
                    <a:pt x="658" y="36"/>
                  </a:lnTo>
                  <a:lnTo>
                    <a:pt x="660" y="36"/>
                  </a:lnTo>
                  <a:lnTo>
                    <a:pt x="661" y="36"/>
                  </a:lnTo>
                  <a:lnTo>
                    <a:pt x="663" y="36"/>
                  </a:lnTo>
                  <a:lnTo>
                    <a:pt x="665" y="36"/>
                  </a:lnTo>
                  <a:lnTo>
                    <a:pt x="667" y="36"/>
                  </a:lnTo>
                  <a:lnTo>
                    <a:pt x="668" y="36"/>
                  </a:lnTo>
                  <a:lnTo>
                    <a:pt x="670" y="36"/>
                  </a:lnTo>
                  <a:lnTo>
                    <a:pt x="671" y="36"/>
                  </a:lnTo>
                  <a:lnTo>
                    <a:pt x="672" y="36"/>
                  </a:lnTo>
                  <a:lnTo>
                    <a:pt x="674" y="36"/>
                  </a:lnTo>
                  <a:lnTo>
                    <a:pt x="675" y="36"/>
                  </a:lnTo>
                  <a:lnTo>
                    <a:pt x="676" y="36"/>
                  </a:lnTo>
                  <a:lnTo>
                    <a:pt x="677" y="36"/>
                  </a:lnTo>
                  <a:lnTo>
                    <a:pt x="678" y="36"/>
                  </a:lnTo>
                  <a:lnTo>
                    <a:pt x="678" y="36"/>
                  </a:lnTo>
                  <a:lnTo>
                    <a:pt x="679" y="36"/>
                  </a:lnTo>
                  <a:lnTo>
                    <a:pt x="680" y="36"/>
                  </a:lnTo>
                  <a:lnTo>
                    <a:pt x="685" y="36"/>
                  </a:lnTo>
                  <a:lnTo>
                    <a:pt x="689" y="36"/>
                  </a:lnTo>
                  <a:lnTo>
                    <a:pt x="692" y="35"/>
                  </a:lnTo>
                  <a:lnTo>
                    <a:pt x="695" y="35"/>
                  </a:lnTo>
                  <a:lnTo>
                    <a:pt x="699" y="35"/>
                  </a:lnTo>
                  <a:lnTo>
                    <a:pt x="702" y="35"/>
                  </a:lnTo>
                  <a:lnTo>
                    <a:pt x="703" y="35"/>
                  </a:lnTo>
                  <a:lnTo>
                    <a:pt x="704" y="35"/>
                  </a:lnTo>
                  <a:lnTo>
                    <a:pt x="705" y="35"/>
                  </a:lnTo>
                  <a:lnTo>
                    <a:pt x="705" y="35"/>
                  </a:lnTo>
                  <a:lnTo>
                    <a:pt x="706" y="35"/>
                  </a:lnTo>
                  <a:lnTo>
                    <a:pt x="708" y="35"/>
                  </a:lnTo>
                  <a:lnTo>
                    <a:pt x="710" y="35"/>
                  </a:lnTo>
                  <a:lnTo>
                    <a:pt x="712" y="35"/>
                  </a:lnTo>
                  <a:lnTo>
                    <a:pt x="713" y="34"/>
                  </a:lnTo>
                  <a:lnTo>
                    <a:pt x="715" y="34"/>
                  </a:lnTo>
                  <a:lnTo>
                    <a:pt x="718" y="34"/>
                  </a:lnTo>
                  <a:lnTo>
                    <a:pt x="720" y="34"/>
                  </a:lnTo>
                  <a:lnTo>
                    <a:pt x="721" y="34"/>
                  </a:lnTo>
                  <a:lnTo>
                    <a:pt x="724" y="34"/>
                  </a:lnTo>
                  <a:lnTo>
                    <a:pt x="727" y="34"/>
                  </a:lnTo>
                  <a:lnTo>
                    <a:pt x="729" y="34"/>
                  </a:lnTo>
                  <a:lnTo>
                    <a:pt x="730" y="34"/>
                  </a:lnTo>
                  <a:lnTo>
                    <a:pt x="732" y="34"/>
                  </a:lnTo>
                  <a:lnTo>
                    <a:pt x="732" y="34"/>
                  </a:lnTo>
                  <a:lnTo>
                    <a:pt x="734" y="33"/>
                  </a:lnTo>
                  <a:lnTo>
                    <a:pt x="735" y="33"/>
                  </a:lnTo>
                  <a:lnTo>
                    <a:pt x="737" y="33"/>
                  </a:lnTo>
                  <a:lnTo>
                    <a:pt x="738" y="33"/>
                  </a:lnTo>
                  <a:lnTo>
                    <a:pt x="740" y="33"/>
                  </a:lnTo>
                  <a:lnTo>
                    <a:pt x="742" y="33"/>
                  </a:lnTo>
                  <a:lnTo>
                    <a:pt x="745" y="33"/>
                  </a:lnTo>
                  <a:lnTo>
                    <a:pt x="748" y="33"/>
                  </a:lnTo>
                  <a:lnTo>
                    <a:pt x="751" y="33"/>
                  </a:lnTo>
                  <a:lnTo>
                    <a:pt x="753" y="33"/>
                  </a:lnTo>
                  <a:lnTo>
                    <a:pt x="755" y="33"/>
                  </a:lnTo>
                  <a:lnTo>
                    <a:pt x="756" y="33"/>
                  </a:lnTo>
                  <a:lnTo>
                    <a:pt x="758" y="33"/>
                  </a:lnTo>
                  <a:lnTo>
                    <a:pt x="759" y="33"/>
                  </a:lnTo>
                  <a:lnTo>
                    <a:pt x="759" y="33"/>
                  </a:lnTo>
                  <a:lnTo>
                    <a:pt x="760" y="33"/>
                  </a:lnTo>
                  <a:lnTo>
                    <a:pt x="761" y="33"/>
                  </a:lnTo>
                  <a:lnTo>
                    <a:pt x="762" y="33"/>
                  </a:lnTo>
                  <a:lnTo>
                    <a:pt x="764" y="33"/>
                  </a:lnTo>
                  <a:lnTo>
                    <a:pt x="765" y="33"/>
                  </a:lnTo>
                  <a:lnTo>
                    <a:pt x="766" y="33"/>
                  </a:lnTo>
                  <a:lnTo>
                    <a:pt x="768" y="33"/>
                  </a:lnTo>
                  <a:lnTo>
                    <a:pt x="769" y="33"/>
                  </a:lnTo>
                  <a:lnTo>
                    <a:pt x="770" y="33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Freeform 150"/>
            <p:cNvSpPr>
              <a:spLocks/>
            </p:cNvSpPr>
            <p:nvPr/>
          </p:nvSpPr>
          <p:spPr bwMode="auto">
            <a:xfrm>
              <a:off x="1924587" y="4973326"/>
              <a:ext cx="434160" cy="27564"/>
            </a:xfrm>
            <a:custGeom>
              <a:avLst/>
              <a:gdLst>
                <a:gd name="T0" fmla="*/ 9 w 350"/>
                <a:gd name="T1" fmla="*/ 20 h 21"/>
                <a:gd name="T2" fmla="*/ 14 w 350"/>
                <a:gd name="T3" fmla="*/ 20 h 21"/>
                <a:gd name="T4" fmla="*/ 18 w 350"/>
                <a:gd name="T5" fmla="*/ 19 h 21"/>
                <a:gd name="T6" fmla="*/ 22 w 350"/>
                <a:gd name="T7" fmla="*/ 19 h 21"/>
                <a:gd name="T8" fmla="*/ 25 w 350"/>
                <a:gd name="T9" fmla="*/ 18 h 21"/>
                <a:gd name="T10" fmla="*/ 31 w 350"/>
                <a:gd name="T11" fmla="*/ 16 h 21"/>
                <a:gd name="T12" fmla="*/ 34 w 350"/>
                <a:gd name="T13" fmla="*/ 15 h 21"/>
                <a:gd name="T14" fmla="*/ 37 w 350"/>
                <a:gd name="T15" fmla="*/ 15 h 21"/>
                <a:gd name="T16" fmla="*/ 41 w 350"/>
                <a:gd name="T17" fmla="*/ 15 h 21"/>
                <a:gd name="T18" fmla="*/ 45 w 350"/>
                <a:gd name="T19" fmla="*/ 14 h 21"/>
                <a:gd name="T20" fmla="*/ 51 w 350"/>
                <a:gd name="T21" fmla="*/ 14 h 21"/>
                <a:gd name="T22" fmla="*/ 57 w 350"/>
                <a:gd name="T23" fmla="*/ 13 h 21"/>
                <a:gd name="T24" fmla="*/ 62 w 350"/>
                <a:gd name="T25" fmla="*/ 12 h 21"/>
                <a:gd name="T26" fmla="*/ 66 w 350"/>
                <a:gd name="T27" fmla="*/ 10 h 21"/>
                <a:gd name="T28" fmla="*/ 68 w 350"/>
                <a:gd name="T29" fmla="*/ 10 h 21"/>
                <a:gd name="T30" fmla="*/ 69 w 350"/>
                <a:gd name="T31" fmla="*/ 10 h 21"/>
                <a:gd name="T32" fmla="*/ 74 w 350"/>
                <a:gd name="T33" fmla="*/ 8 h 21"/>
                <a:gd name="T34" fmla="*/ 80 w 350"/>
                <a:gd name="T35" fmla="*/ 5 h 21"/>
                <a:gd name="T36" fmla="*/ 85 w 350"/>
                <a:gd name="T37" fmla="*/ 2 h 21"/>
                <a:gd name="T38" fmla="*/ 88 w 350"/>
                <a:gd name="T39" fmla="*/ 1 h 21"/>
                <a:gd name="T40" fmla="*/ 91 w 350"/>
                <a:gd name="T41" fmla="*/ 0 h 21"/>
                <a:gd name="T42" fmla="*/ 94 w 350"/>
                <a:gd name="T43" fmla="*/ 0 h 21"/>
                <a:gd name="T44" fmla="*/ 99 w 350"/>
                <a:gd name="T45" fmla="*/ 0 h 21"/>
                <a:gd name="T46" fmla="*/ 107 w 350"/>
                <a:gd name="T47" fmla="*/ 1 h 21"/>
                <a:gd name="T48" fmla="*/ 114 w 350"/>
                <a:gd name="T49" fmla="*/ 3 h 21"/>
                <a:gd name="T50" fmla="*/ 121 w 350"/>
                <a:gd name="T51" fmla="*/ 4 h 21"/>
                <a:gd name="T52" fmla="*/ 123 w 350"/>
                <a:gd name="T53" fmla="*/ 5 h 21"/>
                <a:gd name="T54" fmla="*/ 133 w 350"/>
                <a:gd name="T55" fmla="*/ 8 h 21"/>
                <a:gd name="T56" fmla="*/ 139 w 350"/>
                <a:gd name="T57" fmla="*/ 9 h 21"/>
                <a:gd name="T58" fmla="*/ 144 w 350"/>
                <a:gd name="T59" fmla="*/ 10 h 21"/>
                <a:gd name="T60" fmla="*/ 150 w 350"/>
                <a:gd name="T61" fmla="*/ 10 h 21"/>
                <a:gd name="T62" fmla="*/ 156 w 350"/>
                <a:gd name="T63" fmla="*/ 10 h 21"/>
                <a:gd name="T64" fmla="*/ 161 w 350"/>
                <a:gd name="T65" fmla="*/ 10 h 21"/>
                <a:gd name="T66" fmla="*/ 167 w 350"/>
                <a:gd name="T67" fmla="*/ 11 h 21"/>
                <a:gd name="T68" fmla="*/ 174 w 350"/>
                <a:gd name="T69" fmla="*/ 12 h 21"/>
                <a:gd name="T70" fmla="*/ 179 w 350"/>
                <a:gd name="T71" fmla="*/ 13 h 21"/>
                <a:gd name="T72" fmla="*/ 186 w 350"/>
                <a:gd name="T73" fmla="*/ 13 h 21"/>
                <a:gd name="T74" fmla="*/ 192 w 350"/>
                <a:gd name="T75" fmla="*/ 14 h 21"/>
                <a:gd name="T76" fmla="*/ 198 w 350"/>
                <a:gd name="T77" fmla="*/ 14 h 21"/>
                <a:gd name="T78" fmla="*/ 206 w 350"/>
                <a:gd name="T79" fmla="*/ 13 h 21"/>
                <a:gd name="T80" fmla="*/ 218 w 350"/>
                <a:gd name="T81" fmla="*/ 13 h 21"/>
                <a:gd name="T82" fmla="*/ 227 w 350"/>
                <a:gd name="T83" fmla="*/ 13 h 21"/>
                <a:gd name="T84" fmla="*/ 232 w 350"/>
                <a:gd name="T85" fmla="*/ 13 h 21"/>
                <a:gd name="T86" fmla="*/ 238 w 350"/>
                <a:gd name="T87" fmla="*/ 13 h 21"/>
                <a:gd name="T88" fmla="*/ 241 w 350"/>
                <a:gd name="T89" fmla="*/ 13 h 21"/>
                <a:gd name="T90" fmla="*/ 245 w 350"/>
                <a:gd name="T91" fmla="*/ 13 h 21"/>
                <a:gd name="T92" fmla="*/ 253 w 350"/>
                <a:gd name="T93" fmla="*/ 14 h 21"/>
                <a:gd name="T94" fmla="*/ 256 w 350"/>
                <a:gd name="T95" fmla="*/ 14 h 21"/>
                <a:gd name="T96" fmla="*/ 263 w 350"/>
                <a:gd name="T97" fmla="*/ 15 h 21"/>
                <a:gd name="T98" fmla="*/ 271 w 350"/>
                <a:gd name="T99" fmla="*/ 16 h 21"/>
                <a:gd name="T100" fmla="*/ 279 w 350"/>
                <a:gd name="T101" fmla="*/ 16 h 21"/>
                <a:gd name="T102" fmla="*/ 283 w 350"/>
                <a:gd name="T103" fmla="*/ 16 h 21"/>
                <a:gd name="T104" fmla="*/ 290 w 350"/>
                <a:gd name="T105" fmla="*/ 15 h 21"/>
                <a:gd name="T106" fmla="*/ 297 w 350"/>
                <a:gd name="T107" fmla="*/ 15 h 21"/>
                <a:gd name="T108" fmla="*/ 305 w 350"/>
                <a:gd name="T109" fmla="*/ 14 h 21"/>
                <a:gd name="T110" fmla="*/ 309 w 350"/>
                <a:gd name="T111" fmla="*/ 13 h 21"/>
                <a:gd name="T112" fmla="*/ 312 w 350"/>
                <a:gd name="T113" fmla="*/ 13 h 21"/>
                <a:gd name="T114" fmla="*/ 319 w 350"/>
                <a:gd name="T115" fmla="*/ 11 h 21"/>
                <a:gd name="T116" fmla="*/ 327 w 350"/>
                <a:gd name="T117" fmla="*/ 9 h 21"/>
                <a:gd name="T118" fmla="*/ 333 w 350"/>
                <a:gd name="T119" fmla="*/ 7 h 21"/>
                <a:gd name="T120" fmla="*/ 336 w 350"/>
                <a:gd name="T121" fmla="*/ 6 h 21"/>
                <a:gd name="T122" fmla="*/ 339 w 350"/>
                <a:gd name="T123" fmla="*/ 4 h 21"/>
                <a:gd name="T124" fmla="*/ 345 w 350"/>
                <a:gd name="T125" fmla="*/ 3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350" h="21">
                  <a:moveTo>
                    <a:pt x="0" y="21"/>
                  </a:moveTo>
                  <a:lnTo>
                    <a:pt x="1" y="21"/>
                  </a:lnTo>
                  <a:lnTo>
                    <a:pt x="2" y="21"/>
                  </a:lnTo>
                  <a:lnTo>
                    <a:pt x="4" y="21"/>
                  </a:lnTo>
                  <a:lnTo>
                    <a:pt x="5" y="21"/>
                  </a:lnTo>
                  <a:lnTo>
                    <a:pt x="6" y="20"/>
                  </a:lnTo>
                  <a:lnTo>
                    <a:pt x="7" y="20"/>
                  </a:lnTo>
                  <a:lnTo>
                    <a:pt x="9" y="20"/>
                  </a:lnTo>
                  <a:lnTo>
                    <a:pt x="11" y="20"/>
                  </a:lnTo>
                  <a:lnTo>
                    <a:pt x="12" y="20"/>
                  </a:lnTo>
                  <a:lnTo>
                    <a:pt x="13" y="20"/>
                  </a:lnTo>
                  <a:lnTo>
                    <a:pt x="13" y="20"/>
                  </a:lnTo>
                  <a:lnTo>
                    <a:pt x="13" y="20"/>
                  </a:lnTo>
                  <a:lnTo>
                    <a:pt x="14" y="20"/>
                  </a:lnTo>
                  <a:lnTo>
                    <a:pt x="14" y="20"/>
                  </a:lnTo>
                  <a:lnTo>
                    <a:pt x="14" y="20"/>
                  </a:lnTo>
                  <a:lnTo>
                    <a:pt x="14" y="20"/>
                  </a:lnTo>
                  <a:lnTo>
                    <a:pt x="15" y="20"/>
                  </a:lnTo>
                  <a:lnTo>
                    <a:pt x="15" y="20"/>
                  </a:lnTo>
                  <a:lnTo>
                    <a:pt x="15" y="20"/>
                  </a:lnTo>
                  <a:lnTo>
                    <a:pt x="16" y="19"/>
                  </a:lnTo>
                  <a:lnTo>
                    <a:pt x="17" y="19"/>
                  </a:lnTo>
                  <a:lnTo>
                    <a:pt x="18" y="19"/>
                  </a:lnTo>
                  <a:lnTo>
                    <a:pt x="18" y="19"/>
                  </a:lnTo>
                  <a:lnTo>
                    <a:pt x="19" y="19"/>
                  </a:lnTo>
                  <a:lnTo>
                    <a:pt x="19" y="19"/>
                  </a:lnTo>
                  <a:lnTo>
                    <a:pt x="20" y="19"/>
                  </a:lnTo>
                  <a:lnTo>
                    <a:pt x="20" y="19"/>
                  </a:lnTo>
                  <a:lnTo>
                    <a:pt x="21" y="19"/>
                  </a:lnTo>
                  <a:lnTo>
                    <a:pt x="21" y="19"/>
                  </a:lnTo>
                  <a:lnTo>
                    <a:pt x="22" y="19"/>
                  </a:lnTo>
                  <a:lnTo>
                    <a:pt x="22" y="19"/>
                  </a:lnTo>
                  <a:lnTo>
                    <a:pt x="22" y="19"/>
                  </a:lnTo>
                  <a:lnTo>
                    <a:pt x="23" y="18"/>
                  </a:lnTo>
                  <a:lnTo>
                    <a:pt x="23" y="18"/>
                  </a:lnTo>
                  <a:lnTo>
                    <a:pt x="24" y="18"/>
                  </a:lnTo>
                  <a:lnTo>
                    <a:pt x="24" y="18"/>
                  </a:lnTo>
                  <a:lnTo>
                    <a:pt x="25" y="18"/>
                  </a:lnTo>
                  <a:lnTo>
                    <a:pt x="25" y="18"/>
                  </a:lnTo>
                  <a:lnTo>
                    <a:pt x="25" y="18"/>
                  </a:lnTo>
                  <a:lnTo>
                    <a:pt x="26" y="18"/>
                  </a:lnTo>
                  <a:lnTo>
                    <a:pt x="26" y="18"/>
                  </a:lnTo>
                  <a:lnTo>
                    <a:pt x="27" y="17"/>
                  </a:lnTo>
                  <a:lnTo>
                    <a:pt x="28" y="17"/>
                  </a:lnTo>
                  <a:lnTo>
                    <a:pt x="29" y="17"/>
                  </a:lnTo>
                  <a:lnTo>
                    <a:pt x="29" y="16"/>
                  </a:lnTo>
                  <a:lnTo>
                    <a:pt x="30" y="16"/>
                  </a:lnTo>
                  <a:lnTo>
                    <a:pt x="31" y="16"/>
                  </a:lnTo>
                  <a:lnTo>
                    <a:pt x="31" y="16"/>
                  </a:lnTo>
                  <a:lnTo>
                    <a:pt x="32" y="16"/>
                  </a:lnTo>
                  <a:lnTo>
                    <a:pt x="32" y="16"/>
                  </a:lnTo>
                  <a:lnTo>
                    <a:pt x="32" y="15"/>
                  </a:lnTo>
                  <a:lnTo>
                    <a:pt x="33" y="15"/>
                  </a:lnTo>
                  <a:lnTo>
                    <a:pt x="33" y="15"/>
                  </a:lnTo>
                  <a:lnTo>
                    <a:pt x="34" y="15"/>
                  </a:lnTo>
                  <a:lnTo>
                    <a:pt x="34" y="15"/>
                  </a:lnTo>
                  <a:lnTo>
                    <a:pt x="34" y="15"/>
                  </a:lnTo>
                  <a:lnTo>
                    <a:pt x="35" y="15"/>
                  </a:lnTo>
                  <a:lnTo>
                    <a:pt x="35" y="15"/>
                  </a:lnTo>
                  <a:lnTo>
                    <a:pt x="36" y="15"/>
                  </a:lnTo>
                  <a:lnTo>
                    <a:pt x="36" y="15"/>
                  </a:lnTo>
                  <a:lnTo>
                    <a:pt x="36" y="15"/>
                  </a:lnTo>
                  <a:lnTo>
                    <a:pt x="37" y="15"/>
                  </a:lnTo>
                  <a:lnTo>
                    <a:pt x="37" y="15"/>
                  </a:lnTo>
                  <a:lnTo>
                    <a:pt x="38" y="15"/>
                  </a:lnTo>
                  <a:lnTo>
                    <a:pt x="38" y="15"/>
                  </a:lnTo>
                  <a:lnTo>
                    <a:pt x="39" y="15"/>
                  </a:lnTo>
                  <a:lnTo>
                    <a:pt x="40" y="15"/>
                  </a:lnTo>
                  <a:lnTo>
                    <a:pt x="40" y="15"/>
                  </a:lnTo>
                  <a:lnTo>
                    <a:pt x="40" y="15"/>
                  </a:lnTo>
                  <a:lnTo>
                    <a:pt x="41" y="15"/>
                  </a:lnTo>
                  <a:lnTo>
                    <a:pt x="41" y="15"/>
                  </a:lnTo>
                  <a:lnTo>
                    <a:pt x="41" y="15"/>
                  </a:lnTo>
                  <a:lnTo>
                    <a:pt x="41" y="15"/>
                  </a:lnTo>
                  <a:lnTo>
                    <a:pt x="42" y="14"/>
                  </a:lnTo>
                  <a:lnTo>
                    <a:pt x="43" y="14"/>
                  </a:lnTo>
                  <a:lnTo>
                    <a:pt x="43" y="14"/>
                  </a:lnTo>
                  <a:lnTo>
                    <a:pt x="44" y="14"/>
                  </a:lnTo>
                  <a:lnTo>
                    <a:pt x="45" y="14"/>
                  </a:lnTo>
                  <a:lnTo>
                    <a:pt x="45" y="14"/>
                  </a:lnTo>
                  <a:lnTo>
                    <a:pt x="46" y="14"/>
                  </a:lnTo>
                  <a:lnTo>
                    <a:pt x="47" y="14"/>
                  </a:lnTo>
                  <a:lnTo>
                    <a:pt x="47" y="14"/>
                  </a:lnTo>
                  <a:lnTo>
                    <a:pt x="48" y="14"/>
                  </a:lnTo>
                  <a:lnTo>
                    <a:pt x="49" y="14"/>
                  </a:lnTo>
                  <a:lnTo>
                    <a:pt x="50" y="14"/>
                  </a:lnTo>
                  <a:lnTo>
                    <a:pt x="50" y="14"/>
                  </a:lnTo>
                  <a:lnTo>
                    <a:pt x="51" y="14"/>
                  </a:lnTo>
                  <a:lnTo>
                    <a:pt x="52" y="13"/>
                  </a:lnTo>
                  <a:lnTo>
                    <a:pt x="53" y="13"/>
                  </a:lnTo>
                  <a:lnTo>
                    <a:pt x="54" y="13"/>
                  </a:lnTo>
                  <a:lnTo>
                    <a:pt x="54" y="13"/>
                  </a:lnTo>
                  <a:lnTo>
                    <a:pt x="55" y="13"/>
                  </a:lnTo>
                  <a:lnTo>
                    <a:pt x="56" y="13"/>
                  </a:lnTo>
                  <a:lnTo>
                    <a:pt x="56" y="13"/>
                  </a:lnTo>
                  <a:lnTo>
                    <a:pt x="57" y="13"/>
                  </a:lnTo>
                  <a:lnTo>
                    <a:pt x="58" y="13"/>
                  </a:lnTo>
                  <a:lnTo>
                    <a:pt x="58" y="13"/>
                  </a:lnTo>
                  <a:lnTo>
                    <a:pt x="59" y="12"/>
                  </a:lnTo>
                  <a:lnTo>
                    <a:pt x="60" y="12"/>
                  </a:lnTo>
                  <a:lnTo>
                    <a:pt x="60" y="12"/>
                  </a:lnTo>
                  <a:lnTo>
                    <a:pt x="61" y="12"/>
                  </a:lnTo>
                  <a:lnTo>
                    <a:pt x="61" y="12"/>
                  </a:lnTo>
                  <a:lnTo>
                    <a:pt x="62" y="12"/>
                  </a:lnTo>
                  <a:lnTo>
                    <a:pt x="62" y="12"/>
                  </a:lnTo>
                  <a:lnTo>
                    <a:pt x="63" y="11"/>
                  </a:lnTo>
                  <a:lnTo>
                    <a:pt x="63" y="11"/>
                  </a:lnTo>
                  <a:lnTo>
                    <a:pt x="64" y="11"/>
                  </a:lnTo>
                  <a:lnTo>
                    <a:pt x="64" y="11"/>
                  </a:lnTo>
                  <a:lnTo>
                    <a:pt x="65" y="11"/>
                  </a:lnTo>
                  <a:lnTo>
                    <a:pt x="66" y="11"/>
                  </a:lnTo>
                  <a:lnTo>
                    <a:pt x="66" y="10"/>
                  </a:lnTo>
                  <a:lnTo>
                    <a:pt x="66" y="10"/>
                  </a:lnTo>
                  <a:lnTo>
                    <a:pt x="66" y="10"/>
                  </a:lnTo>
                  <a:lnTo>
                    <a:pt x="67" y="10"/>
                  </a:lnTo>
                  <a:lnTo>
                    <a:pt x="67" y="10"/>
                  </a:lnTo>
                  <a:lnTo>
                    <a:pt x="67" y="10"/>
                  </a:lnTo>
                  <a:lnTo>
                    <a:pt x="67" y="10"/>
                  </a:lnTo>
                  <a:lnTo>
                    <a:pt x="67" y="10"/>
                  </a:lnTo>
                  <a:lnTo>
                    <a:pt x="68" y="10"/>
                  </a:lnTo>
                  <a:lnTo>
                    <a:pt x="68" y="10"/>
                  </a:lnTo>
                  <a:lnTo>
                    <a:pt x="68" y="10"/>
                  </a:lnTo>
                  <a:lnTo>
                    <a:pt x="68" y="10"/>
                  </a:lnTo>
                  <a:lnTo>
                    <a:pt x="68" y="10"/>
                  </a:lnTo>
                  <a:lnTo>
                    <a:pt x="68" y="10"/>
                  </a:lnTo>
                  <a:lnTo>
                    <a:pt x="68" y="10"/>
                  </a:lnTo>
                  <a:lnTo>
                    <a:pt x="69" y="10"/>
                  </a:lnTo>
                  <a:lnTo>
                    <a:pt x="69" y="10"/>
                  </a:lnTo>
                  <a:lnTo>
                    <a:pt x="69" y="9"/>
                  </a:lnTo>
                  <a:lnTo>
                    <a:pt x="70" y="9"/>
                  </a:lnTo>
                  <a:lnTo>
                    <a:pt x="71" y="9"/>
                  </a:lnTo>
                  <a:lnTo>
                    <a:pt x="71" y="8"/>
                  </a:lnTo>
                  <a:lnTo>
                    <a:pt x="72" y="8"/>
                  </a:lnTo>
                  <a:lnTo>
                    <a:pt x="73" y="8"/>
                  </a:lnTo>
                  <a:lnTo>
                    <a:pt x="73" y="8"/>
                  </a:lnTo>
                  <a:lnTo>
                    <a:pt x="74" y="8"/>
                  </a:lnTo>
                  <a:lnTo>
                    <a:pt x="75" y="7"/>
                  </a:lnTo>
                  <a:lnTo>
                    <a:pt x="75" y="7"/>
                  </a:lnTo>
                  <a:lnTo>
                    <a:pt x="76" y="7"/>
                  </a:lnTo>
                  <a:lnTo>
                    <a:pt x="76" y="6"/>
                  </a:lnTo>
                  <a:lnTo>
                    <a:pt x="77" y="6"/>
                  </a:lnTo>
                  <a:lnTo>
                    <a:pt x="78" y="5"/>
                  </a:lnTo>
                  <a:lnTo>
                    <a:pt x="79" y="5"/>
                  </a:lnTo>
                  <a:lnTo>
                    <a:pt x="80" y="5"/>
                  </a:lnTo>
                  <a:lnTo>
                    <a:pt x="81" y="4"/>
                  </a:lnTo>
                  <a:lnTo>
                    <a:pt x="82" y="4"/>
                  </a:lnTo>
                  <a:lnTo>
                    <a:pt x="82" y="3"/>
                  </a:lnTo>
                  <a:lnTo>
                    <a:pt x="83" y="3"/>
                  </a:lnTo>
                  <a:lnTo>
                    <a:pt x="83" y="3"/>
                  </a:lnTo>
                  <a:lnTo>
                    <a:pt x="84" y="2"/>
                  </a:lnTo>
                  <a:lnTo>
                    <a:pt x="84" y="2"/>
                  </a:lnTo>
                  <a:lnTo>
                    <a:pt x="85" y="2"/>
                  </a:lnTo>
                  <a:lnTo>
                    <a:pt x="85" y="2"/>
                  </a:lnTo>
                  <a:lnTo>
                    <a:pt x="86" y="2"/>
                  </a:lnTo>
                  <a:lnTo>
                    <a:pt x="86" y="1"/>
                  </a:lnTo>
                  <a:lnTo>
                    <a:pt x="86" y="1"/>
                  </a:lnTo>
                  <a:lnTo>
                    <a:pt x="87" y="1"/>
                  </a:lnTo>
                  <a:lnTo>
                    <a:pt x="87" y="1"/>
                  </a:lnTo>
                  <a:lnTo>
                    <a:pt x="88" y="1"/>
                  </a:lnTo>
                  <a:lnTo>
                    <a:pt x="88" y="1"/>
                  </a:lnTo>
                  <a:lnTo>
                    <a:pt x="88" y="1"/>
                  </a:lnTo>
                  <a:lnTo>
                    <a:pt x="89" y="0"/>
                  </a:lnTo>
                  <a:lnTo>
                    <a:pt x="89" y="0"/>
                  </a:lnTo>
                  <a:lnTo>
                    <a:pt x="90" y="0"/>
                  </a:lnTo>
                  <a:lnTo>
                    <a:pt x="90" y="0"/>
                  </a:lnTo>
                  <a:lnTo>
                    <a:pt x="90" y="0"/>
                  </a:lnTo>
                  <a:lnTo>
                    <a:pt x="91" y="0"/>
                  </a:lnTo>
                  <a:lnTo>
                    <a:pt x="91" y="0"/>
                  </a:lnTo>
                  <a:lnTo>
                    <a:pt x="92" y="0"/>
                  </a:lnTo>
                  <a:lnTo>
                    <a:pt x="92" y="0"/>
                  </a:lnTo>
                  <a:lnTo>
                    <a:pt x="93" y="0"/>
                  </a:lnTo>
                  <a:lnTo>
                    <a:pt x="93" y="0"/>
                  </a:lnTo>
                  <a:lnTo>
                    <a:pt x="93" y="0"/>
                  </a:lnTo>
                  <a:lnTo>
                    <a:pt x="94" y="0"/>
                  </a:lnTo>
                  <a:lnTo>
                    <a:pt x="94" y="0"/>
                  </a:lnTo>
                  <a:lnTo>
                    <a:pt x="94" y="0"/>
                  </a:lnTo>
                  <a:lnTo>
                    <a:pt x="95" y="0"/>
                  </a:lnTo>
                  <a:lnTo>
                    <a:pt x="95" y="0"/>
                  </a:lnTo>
                  <a:lnTo>
                    <a:pt x="95" y="0"/>
                  </a:lnTo>
                  <a:lnTo>
                    <a:pt x="96" y="0"/>
                  </a:lnTo>
                  <a:lnTo>
                    <a:pt x="97" y="0"/>
                  </a:lnTo>
                  <a:lnTo>
                    <a:pt x="97" y="0"/>
                  </a:lnTo>
                  <a:lnTo>
                    <a:pt x="98" y="0"/>
                  </a:lnTo>
                  <a:lnTo>
                    <a:pt x="99" y="0"/>
                  </a:lnTo>
                  <a:lnTo>
                    <a:pt x="100" y="0"/>
                  </a:lnTo>
                  <a:lnTo>
                    <a:pt x="101" y="0"/>
                  </a:lnTo>
                  <a:lnTo>
                    <a:pt x="102" y="0"/>
                  </a:lnTo>
                  <a:lnTo>
                    <a:pt x="103" y="1"/>
                  </a:lnTo>
                  <a:lnTo>
                    <a:pt x="104" y="1"/>
                  </a:lnTo>
                  <a:lnTo>
                    <a:pt x="105" y="1"/>
                  </a:lnTo>
                  <a:lnTo>
                    <a:pt x="106" y="1"/>
                  </a:lnTo>
                  <a:lnTo>
                    <a:pt x="107" y="1"/>
                  </a:lnTo>
                  <a:lnTo>
                    <a:pt x="108" y="1"/>
                  </a:lnTo>
                  <a:lnTo>
                    <a:pt x="109" y="1"/>
                  </a:lnTo>
                  <a:lnTo>
                    <a:pt x="109" y="2"/>
                  </a:lnTo>
                  <a:lnTo>
                    <a:pt x="110" y="2"/>
                  </a:lnTo>
                  <a:lnTo>
                    <a:pt x="111" y="2"/>
                  </a:lnTo>
                  <a:lnTo>
                    <a:pt x="112" y="2"/>
                  </a:lnTo>
                  <a:lnTo>
                    <a:pt x="113" y="2"/>
                  </a:lnTo>
                  <a:lnTo>
                    <a:pt x="114" y="3"/>
                  </a:lnTo>
                  <a:lnTo>
                    <a:pt x="116" y="3"/>
                  </a:lnTo>
                  <a:lnTo>
                    <a:pt x="117" y="3"/>
                  </a:lnTo>
                  <a:lnTo>
                    <a:pt x="118" y="4"/>
                  </a:lnTo>
                  <a:lnTo>
                    <a:pt x="119" y="4"/>
                  </a:lnTo>
                  <a:lnTo>
                    <a:pt x="120" y="4"/>
                  </a:lnTo>
                  <a:lnTo>
                    <a:pt x="120" y="4"/>
                  </a:lnTo>
                  <a:lnTo>
                    <a:pt x="121" y="4"/>
                  </a:lnTo>
                  <a:lnTo>
                    <a:pt x="121" y="4"/>
                  </a:lnTo>
                  <a:lnTo>
                    <a:pt x="121" y="4"/>
                  </a:lnTo>
                  <a:lnTo>
                    <a:pt x="121" y="4"/>
                  </a:lnTo>
                  <a:lnTo>
                    <a:pt x="122" y="4"/>
                  </a:lnTo>
                  <a:lnTo>
                    <a:pt x="122" y="4"/>
                  </a:lnTo>
                  <a:lnTo>
                    <a:pt x="122" y="4"/>
                  </a:lnTo>
                  <a:lnTo>
                    <a:pt x="122" y="4"/>
                  </a:lnTo>
                  <a:lnTo>
                    <a:pt x="123" y="5"/>
                  </a:lnTo>
                  <a:lnTo>
                    <a:pt x="123" y="5"/>
                  </a:lnTo>
                  <a:lnTo>
                    <a:pt x="124" y="5"/>
                  </a:lnTo>
                  <a:lnTo>
                    <a:pt x="125" y="5"/>
                  </a:lnTo>
                  <a:lnTo>
                    <a:pt x="126" y="6"/>
                  </a:lnTo>
                  <a:lnTo>
                    <a:pt x="128" y="6"/>
                  </a:lnTo>
                  <a:lnTo>
                    <a:pt x="130" y="7"/>
                  </a:lnTo>
                  <a:lnTo>
                    <a:pt x="131" y="7"/>
                  </a:lnTo>
                  <a:lnTo>
                    <a:pt x="132" y="7"/>
                  </a:lnTo>
                  <a:lnTo>
                    <a:pt x="133" y="8"/>
                  </a:lnTo>
                  <a:lnTo>
                    <a:pt x="134" y="8"/>
                  </a:lnTo>
                  <a:lnTo>
                    <a:pt x="135" y="8"/>
                  </a:lnTo>
                  <a:lnTo>
                    <a:pt x="136" y="8"/>
                  </a:lnTo>
                  <a:lnTo>
                    <a:pt x="136" y="8"/>
                  </a:lnTo>
                  <a:lnTo>
                    <a:pt x="137" y="8"/>
                  </a:lnTo>
                  <a:lnTo>
                    <a:pt x="138" y="9"/>
                  </a:lnTo>
                  <a:lnTo>
                    <a:pt x="139" y="9"/>
                  </a:lnTo>
                  <a:lnTo>
                    <a:pt x="139" y="9"/>
                  </a:lnTo>
                  <a:lnTo>
                    <a:pt x="140" y="9"/>
                  </a:lnTo>
                  <a:lnTo>
                    <a:pt x="141" y="9"/>
                  </a:lnTo>
                  <a:lnTo>
                    <a:pt x="141" y="9"/>
                  </a:lnTo>
                  <a:lnTo>
                    <a:pt x="142" y="9"/>
                  </a:lnTo>
                  <a:lnTo>
                    <a:pt x="143" y="10"/>
                  </a:lnTo>
                  <a:lnTo>
                    <a:pt x="143" y="10"/>
                  </a:lnTo>
                  <a:lnTo>
                    <a:pt x="144" y="10"/>
                  </a:lnTo>
                  <a:lnTo>
                    <a:pt x="144" y="10"/>
                  </a:lnTo>
                  <a:lnTo>
                    <a:pt x="145" y="10"/>
                  </a:lnTo>
                  <a:lnTo>
                    <a:pt x="146" y="10"/>
                  </a:lnTo>
                  <a:lnTo>
                    <a:pt x="146" y="10"/>
                  </a:lnTo>
                  <a:lnTo>
                    <a:pt x="147" y="10"/>
                  </a:lnTo>
                  <a:lnTo>
                    <a:pt x="148" y="10"/>
                  </a:lnTo>
                  <a:lnTo>
                    <a:pt x="148" y="10"/>
                  </a:lnTo>
                  <a:lnTo>
                    <a:pt x="149" y="10"/>
                  </a:lnTo>
                  <a:lnTo>
                    <a:pt x="150" y="10"/>
                  </a:lnTo>
                  <a:lnTo>
                    <a:pt x="150" y="10"/>
                  </a:lnTo>
                  <a:lnTo>
                    <a:pt x="151" y="10"/>
                  </a:lnTo>
                  <a:lnTo>
                    <a:pt x="151" y="10"/>
                  </a:lnTo>
                  <a:lnTo>
                    <a:pt x="152" y="10"/>
                  </a:lnTo>
                  <a:lnTo>
                    <a:pt x="153" y="10"/>
                  </a:lnTo>
                  <a:lnTo>
                    <a:pt x="154" y="10"/>
                  </a:lnTo>
                  <a:lnTo>
                    <a:pt x="155" y="10"/>
                  </a:lnTo>
                  <a:lnTo>
                    <a:pt x="156" y="10"/>
                  </a:lnTo>
                  <a:lnTo>
                    <a:pt x="157" y="10"/>
                  </a:lnTo>
                  <a:lnTo>
                    <a:pt x="158" y="10"/>
                  </a:lnTo>
                  <a:lnTo>
                    <a:pt x="158" y="10"/>
                  </a:lnTo>
                  <a:lnTo>
                    <a:pt x="159" y="10"/>
                  </a:lnTo>
                  <a:lnTo>
                    <a:pt x="159" y="10"/>
                  </a:lnTo>
                  <a:lnTo>
                    <a:pt x="160" y="10"/>
                  </a:lnTo>
                  <a:lnTo>
                    <a:pt x="161" y="10"/>
                  </a:lnTo>
                  <a:lnTo>
                    <a:pt x="161" y="10"/>
                  </a:lnTo>
                  <a:lnTo>
                    <a:pt x="162" y="10"/>
                  </a:lnTo>
                  <a:lnTo>
                    <a:pt x="163" y="10"/>
                  </a:lnTo>
                  <a:lnTo>
                    <a:pt x="163" y="10"/>
                  </a:lnTo>
                  <a:lnTo>
                    <a:pt x="164" y="10"/>
                  </a:lnTo>
                  <a:lnTo>
                    <a:pt x="165" y="10"/>
                  </a:lnTo>
                  <a:lnTo>
                    <a:pt x="166" y="11"/>
                  </a:lnTo>
                  <a:lnTo>
                    <a:pt x="166" y="11"/>
                  </a:lnTo>
                  <a:lnTo>
                    <a:pt x="167" y="11"/>
                  </a:lnTo>
                  <a:lnTo>
                    <a:pt x="168" y="11"/>
                  </a:lnTo>
                  <a:lnTo>
                    <a:pt x="169" y="11"/>
                  </a:lnTo>
                  <a:lnTo>
                    <a:pt x="170" y="11"/>
                  </a:lnTo>
                  <a:lnTo>
                    <a:pt x="171" y="11"/>
                  </a:lnTo>
                  <a:lnTo>
                    <a:pt x="172" y="12"/>
                  </a:lnTo>
                  <a:lnTo>
                    <a:pt x="173" y="12"/>
                  </a:lnTo>
                  <a:lnTo>
                    <a:pt x="174" y="12"/>
                  </a:lnTo>
                  <a:lnTo>
                    <a:pt x="174" y="12"/>
                  </a:lnTo>
                  <a:lnTo>
                    <a:pt x="175" y="12"/>
                  </a:lnTo>
                  <a:lnTo>
                    <a:pt x="175" y="12"/>
                  </a:lnTo>
                  <a:lnTo>
                    <a:pt x="176" y="12"/>
                  </a:lnTo>
                  <a:lnTo>
                    <a:pt x="176" y="12"/>
                  </a:lnTo>
                  <a:lnTo>
                    <a:pt x="176" y="12"/>
                  </a:lnTo>
                  <a:lnTo>
                    <a:pt x="177" y="12"/>
                  </a:lnTo>
                  <a:lnTo>
                    <a:pt x="178" y="13"/>
                  </a:lnTo>
                  <a:lnTo>
                    <a:pt x="179" y="13"/>
                  </a:lnTo>
                  <a:lnTo>
                    <a:pt x="180" y="13"/>
                  </a:lnTo>
                  <a:lnTo>
                    <a:pt x="181" y="13"/>
                  </a:lnTo>
                  <a:lnTo>
                    <a:pt x="182" y="13"/>
                  </a:lnTo>
                  <a:lnTo>
                    <a:pt x="183" y="13"/>
                  </a:lnTo>
                  <a:lnTo>
                    <a:pt x="184" y="13"/>
                  </a:lnTo>
                  <a:lnTo>
                    <a:pt x="185" y="13"/>
                  </a:lnTo>
                  <a:lnTo>
                    <a:pt x="185" y="13"/>
                  </a:lnTo>
                  <a:lnTo>
                    <a:pt x="186" y="13"/>
                  </a:lnTo>
                  <a:lnTo>
                    <a:pt x="187" y="13"/>
                  </a:lnTo>
                  <a:lnTo>
                    <a:pt x="187" y="14"/>
                  </a:lnTo>
                  <a:lnTo>
                    <a:pt x="188" y="14"/>
                  </a:lnTo>
                  <a:lnTo>
                    <a:pt x="189" y="14"/>
                  </a:lnTo>
                  <a:lnTo>
                    <a:pt x="189" y="14"/>
                  </a:lnTo>
                  <a:lnTo>
                    <a:pt x="190" y="14"/>
                  </a:lnTo>
                  <a:lnTo>
                    <a:pt x="191" y="14"/>
                  </a:lnTo>
                  <a:lnTo>
                    <a:pt x="192" y="14"/>
                  </a:lnTo>
                  <a:lnTo>
                    <a:pt x="192" y="14"/>
                  </a:lnTo>
                  <a:lnTo>
                    <a:pt x="193" y="14"/>
                  </a:lnTo>
                  <a:lnTo>
                    <a:pt x="194" y="14"/>
                  </a:lnTo>
                  <a:lnTo>
                    <a:pt x="194" y="14"/>
                  </a:lnTo>
                  <a:lnTo>
                    <a:pt x="195" y="14"/>
                  </a:lnTo>
                  <a:lnTo>
                    <a:pt x="196" y="14"/>
                  </a:lnTo>
                  <a:lnTo>
                    <a:pt x="197" y="14"/>
                  </a:lnTo>
                  <a:lnTo>
                    <a:pt x="198" y="14"/>
                  </a:lnTo>
                  <a:lnTo>
                    <a:pt x="199" y="14"/>
                  </a:lnTo>
                  <a:lnTo>
                    <a:pt x="200" y="14"/>
                  </a:lnTo>
                  <a:lnTo>
                    <a:pt x="201" y="14"/>
                  </a:lnTo>
                  <a:lnTo>
                    <a:pt x="202" y="14"/>
                  </a:lnTo>
                  <a:lnTo>
                    <a:pt x="203" y="14"/>
                  </a:lnTo>
                  <a:lnTo>
                    <a:pt x="204" y="14"/>
                  </a:lnTo>
                  <a:lnTo>
                    <a:pt x="205" y="14"/>
                  </a:lnTo>
                  <a:lnTo>
                    <a:pt x="206" y="13"/>
                  </a:lnTo>
                  <a:lnTo>
                    <a:pt x="209" y="13"/>
                  </a:lnTo>
                  <a:lnTo>
                    <a:pt x="211" y="13"/>
                  </a:lnTo>
                  <a:lnTo>
                    <a:pt x="212" y="13"/>
                  </a:lnTo>
                  <a:lnTo>
                    <a:pt x="213" y="13"/>
                  </a:lnTo>
                  <a:lnTo>
                    <a:pt x="214" y="13"/>
                  </a:lnTo>
                  <a:lnTo>
                    <a:pt x="215" y="13"/>
                  </a:lnTo>
                  <a:lnTo>
                    <a:pt x="217" y="13"/>
                  </a:lnTo>
                  <a:lnTo>
                    <a:pt x="218" y="13"/>
                  </a:lnTo>
                  <a:lnTo>
                    <a:pt x="219" y="13"/>
                  </a:lnTo>
                  <a:lnTo>
                    <a:pt x="221" y="13"/>
                  </a:lnTo>
                  <a:lnTo>
                    <a:pt x="222" y="13"/>
                  </a:lnTo>
                  <a:lnTo>
                    <a:pt x="224" y="13"/>
                  </a:lnTo>
                  <a:lnTo>
                    <a:pt x="225" y="13"/>
                  </a:lnTo>
                  <a:lnTo>
                    <a:pt x="226" y="13"/>
                  </a:lnTo>
                  <a:lnTo>
                    <a:pt x="227" y="13"/>
                  </a:lnTo>
                  <a:lnTo>
                    <a:pt x="227" y="13"/>
                  </a:lnTo>
                  <a:lnTo>
                    <a:pt x="228" y="13"/>
                  </a:lnTo>
                  <a:lnTo>
                    <a:pt x="228" y="13"/>
                  </a:lnTo>
                  <a:lnTo>
                    <a:pt x="229" y="13"/>
                  </a:lnTo>
                  <a:lnTo>
                    <a:pt x="230" y="13"/>
                  </a:lnTo>
                  <a:lnTo>
                    <a:pt x="230" y="13"/>
                  </a:lnTo>
                  <a:lnTo>
                    <a:pt x="231" y="13"/>
                  </a:lnTo>
                  <a:lnTo>
                    <a:pt x="232" y="13"/>
                  </a:lnTo>
                  <a:lnTo>
                    <a:pt x="232" y="13"/>
                  </a:lnTo>
                  <a:lnTo>
                    <a:pt x="233" y="13"/>
                  </a:lnTo>
                  <a:lnTo>
                    <a:pt x="234" y="13"/>
                  </a:lnTo>
                  <a:lnTo>
                    <a:pt x="234" y="13"/>
                  </a:lnTo>
                  <a:lnTo>
                    <a:pt x="235" y="13"/>
                  </a:lnTo>
                  <a:lnTo>
                    <a:pt x="236" y="13"/>
                  </a:lnTo>
                  <a:lnTo>
                    <a:pt x="237" y="13"/>
                  </a:lnTo>
                  <a:lnTo>
                    <a:pt x="237" y="13"/>
                  </a:lnTo>
                  <a:lnTo>
                    <a:pt x="238" y="13"/>
                  </a:lnTo>
                  <a:lnTo>
                    <a:pt x="238" y="13"/>
                  </a:lnTo>
                  <a:lnTo>
                    <a:pt x="239" y="13"/>
                  </a:lnTo>
                  <a:lnTo>
                    <a:pt x="239" y="13"/>
                  </a:lnTo>
                  <a:lnTo>
                    <a:pt x="240" y="13"/>
                  </a:lnTo>
                  <a:lnTo>
                    <a:pt x="240" y="13"/>
                  </a:lnTo>
                  <a:lnTo>
                    <a:pt x="241" y="13"/>
                  </a:lnTo>
                  <a:lnTo>
                    <a:pt x="241" y="13"/>
                  </a:lnTo>
                  <a:lnTo>
                    <a:pt x="241" y="13"/>
                  </a:lnTo>
                  <a:lnTo>
                    <a:pt x="242" y="13"/>
                  </a:lnTo>
                  <a:lnTo>
                    <a:pt x="242" y="13"/>
                  </a:lnTo>
                  <a:lnTo>
                    <a:pt x="243" y="13"/>
                  </a:lnTo>
                  <a:lnTo>
                    <a:pt x="243" y="13"/>
                  </a:lnTo>
                  <a:lnTo>
                    <a:pt x="244" y="13"/>
                  </a:lnTo>
                  <a:lnTo>
                    <a:pt x="244" y="13"/>
                  </a:lnTo>
                  <a:lnTo>
                    <a:pt x="245" y="13"/>
                  </a:lnTo>
                  <a:lnTo>
                    <a:pt x="245" y="13"/>
                  </a:lnTo>
                  <a:lnTo>
                    <a:pt x="246" y="13"/>
                  </a:lnTo>
                  <a:lnTo>
                    <a:pt x="247" y="13"/>
                  </a:lnTo>
                  <a:lnTo>
                    <a:pt x="247" y="13"/>
                  </a:lnTo>
                  <a:lnTo>
                    <a:pt x="248" y="13"/>
                  </a:lnTo>
                  <a:lnTo>
                    <a:pt x="249" y="13"/>
                  </a:lnTo>
                  <a:lnTo>
                    <a:pt x="250" y="14"/>
                  </a:lnTo>
                  <a:lnTo>
                    <a:pt x="251" y="14"/>
                  </a:lnTo>
                  <a:lnTo>
                    <a:pt x="253" y="14"/>
                  </a:lnTo>
                  <a:lnTo>
                    <a:pt x="254" y="14"/>
                  </a:lnTo>
                  <a:lnTo>
                    <a:pt x="254" y="14"/>
                  </a:lnTo>
                  <a:lnTo>
                    <a:pt x="255" y="14"/>
                  </a:lnTo>
                  <a:lnTo>
                    <a:pt x="255" y="14"/>
                  </a:lnTo>
                  <a:lnTo>
                    <a:pt x="255" y="14"/>
                  </a:lnTo>
                  <a:lnTo>
                    <a:pt x="256" y="14"/>
                  </a:lnTo>
                  <a:lnTo>
                    <a:pt x="256" y="14"/>
                  </a:lnTo>
                  <a:lnTo>
                    <a:pt x="256" y="14"/>
                  </a:lnTo>
                  <a:lnTo>
                    <a:pt x="257" y="15"/>
                  </a:lnTo>
                  <a:lnTo>
                    <a:pt x="258" y="15"/>
                  </a:lnTo>
                  <a:lnTo>
                    <a:pt x="259" y="15"/>
                  </a:lnTo>
                  <a:lnTo>
                    <a:pt x="260" y="15"/>
                  </a:lnTo>
                  <a:lnTo>
                    <a:pt x="261" y="15"/>
                  </a:lnTo>
                  <a:lnTo>
                    <a:pt x="262" y="15"/>
                  </a:lnTo>
                  <a:lnTo>
                    <a:pt x="263" y="15"/>
                  </a:lnTo>
                  <a:lnTo>
                    <a:pt x="263" y="15"/>
                  </a:lnTo>
                  <a:lnTo>
                    <a:pt x="264" y="15"/>
                  </a:lnTo>
                  <a:lnTo>
                    <a:pt x="265" y="15"/>
                  </a:lnTo>
                  <a:lnTo>
                    <a:pt x="266" y="15"/>
                  </a:lnTo>
                  <a:lnTo>
                    <a:pt x="267" y="15"/>
                  </a:lnTo>
                  <a:lnTo>
                    <a:pt x="268" y="15"/>
                  </a:lnTo>
                  <a:lnTo>
                    <a:pt x="268" y="16"/>
                  </a:lnTo>
                  <a:lnTo>
                    <a:pt x="270" y="16"/>
                  </a:lnTo>
                  <a:lnTo>
                    <a:pt x="271" y="16"/>
                  </a:lnTo>
                  <a:lnTo>
                    <a:pt x="272" y="16"/>
                  </a:lnTo>
                  <a:lnTo>
                    <a:pt x="273" y="16"/>
                  </a:lnTo>
                  <a:lnTo>
                    <a:pt x="274" y="16"/>
                  </a:lnTo>
                  <a:lnTo>
                    <a:pt x="275" y="16"/>
                  </a:lnTo>
                  <a:lnTo>
                    <a:pt x="276" y="16"/>
                  </a:lnTo>
                  <a:lnTo>
                    <a:pt x="277" y="16"/>
                  </a:lnTo>
                  <a:lnTo>
                    <a:pt x="278" y="16"/>
                  </a:lnTo>
                  <a:lnTo>
                    <a:pt x="279" y="16"/>
                  </a:lnTo>
                  <a:lnTo>
                    <a:pt x="280" y="16"/>
                  </a:lnTo>
                  <a:lnTo>
                    <a:pt x="281" y="16"/>
                  </a:lnTo>
                  <a:lnTo>
                    <a:pt x="281" y="16"/>
                  </a:lnTo>
                  <a:lnTo>
                    <a:pt x="282" y="16"/>
                  </a:lnTo>
                  <a:lnTo>
                    <a:pt x="282" y="16"/>
                  </a:lnTo>
                  <a:lnTo>
                    <a:pt x="283" y="16"/>
                  </a:lnTo>
                  <a:lnTo>
                    <a:pt x="283" y="16"/>
                  </a:lnTo>
                  <a:lnTo>
                    <a:pt x="283" y="16"/>
                  </a:lnTo>
                  <a:lnTo>
                    <a:pt x="284" y="16"/>
                  </a:lnTo>
                  <a:lnTo>
                    <a:pt x="285" y="16"/>
                  </a:lnTo>
                  <a:lnTo>
                    <a:pt x="286" y="16"/>
                  </a:lnTo>
                  <a:lnTo>
                    <a:pt x="287" y="16"/>
                  </a:lnTo>
                  <a:lnTo>
                    <a:pt x="288" y="16"/>
                  </a:lnTo>
                  <a:lnTo>
                    <a:pt x="289" y="16"/>
                  </a:lnTo>
                  <a:lnTo>
                    <a:pt x="289" y="16"/>
                  </a:lnTo>
                  <a:lnTo>
                    <a:pt x="290" y="15"/>
                  </a:lnTo>
                  <a:lnTo>
                    <a:pt x="291" y="15"/>
                  </a:lnTo>
                  <a:lnTo>
                    <a:pt x="292" y="15"/>
                  </a:lnTo>
                  <a:lnTo>
                    <a:pt x="293" y="15"/>
                  </a:lnTo>
                  <a:lnTo>
                    <a:pt x="293" y="15"/>
                  </a:lnTo>
                  <a:lnTo>
                    <a:pt x="294" y="15"/>
                  </a:lnTo>
                  <a:lnTo>
                    <a:pt x="295" y="15"/>
                  </a:lnTo>
                  <a:lnTo>
                    <a:pt x="296" y="15"/>
                  </a:lnTo>
                  <a:lnTo>
                    <a:pt x="297" y="15"/>
                  </a:lnTo>
                  <a:lnTo>
                    <a:pt x="298" y="15"/>
                  </a:lnTo>
                  <a:lnTo>
                    <a:pt x="299" y="15"/>
                  </a:lnTo>
                  <a:lnTo>
                    <a:pt x="300" y="15"/>
                  </a:lnTo>
                  <a:lnTo>
                    <a:pt x="301" y="14"/>
                  </a:lnTo>
                  <a:lnTo>
                    <a:pt x="302" y="14"/>
                  </a:lnTo>
                  <a:lnTo>
                    <a:pt x="303" y="14"/>
                  </a:lnTo>
                  <a:lnTo>
                    <a:pt x="304" y="14"/>
                  </a:lnTo>
                  <a:lnTo>
                    <a:pt x="305" y="14"/>
                  </a:lnTo>
                  <a:lnTo>
                    <a:pt x="306" y="14"/>
                  </a:lnTo>
                  <a:lnTo>
                    <a:pt x="307" y="14"/>
                  </a:lnTo>
                  <a:lnTo>
                    <a:pt x="307" y="13"/>
                  </a:lnTo>
                  <a:lnTo>
                    <a:pt x="308" y="13"/>
                  </a:lnTo>
                  <a:lnTo>
                    <a:pt x="308" y="13"/>
                  </a:lnTo>
                  <a:lnTo>
                    <a:pt x="309" y="13"/>
                  </a:lnTo>
                  <a:lnTo>
                    <a:pt x="309" y="13"/>
                  </a:lnTo>
                  <a:lnTo>
                    <a:pt x="309" y="13"/>
                  </a:lnTo>
                  <a:lnTo>
                    <a:pt x="310" y="13"/>
                  </a:lnTo>
                  <a:lnTo>
                    <a:pt x="310" y="13"/>
                  </a:lnTo>
                  <a:lnTo>
                    <a:pt x="310" y="13"/>
                  </a:lnTo>
                  <a:lnTo>
                    <a:pt x="310" y="13"/>
                  </a:lnTo>
                  <a:lnTo>
                    <a:pt x="310" y="13"/>
                  </a:lnTo>
                  <a:lnTo>
                    <a:pt x="311" y="13"/>
                  </a:lnTo>
                  <a:lnTo>
                    <a:pt x="311" y="13"/>
                  </a:lnTo>
                  <a:lnTo>
                    <a:pt x="312" y="13"/>
                  </a:lnTo>
                  <a:lnTo>
                    <a:pt x="313" y="13"/>
                  </a:lnTo>
                  <a:lnTo>
                    <a:pt x="314" y="12"/>
                  </a:lnTo>
                  <a:lnTo>
                    <a:pt x="315" y="12"/>
                  </a:lnTo>
                  <a:lnTo>
                    <a:pt x="316" y="12"/>
                  </a:lnTo>
                  <a:lnTo>
                    <a:pt x="316" y="12"/>
                  </a:lnTo>
                  <a:lnTo>
                    <a:pt x="317" y="11"/>
                  </a:lnTo>
                  <a:lnTo>
                    <a:pt x="318" y="11"/>
                  </a:lnTo>
                  <a:lnTo>
                    <a:pt x="319" y="11"/>
                  </a:lnTo>
                  <a:lnTo>
                    <a:pt x="320" y="11"/>
                  </a:lnTo>
                  <a:lnTo>
                    <a:pt x="321" y="10"/>
                  </a:lnTo>
                  <a:lnTo>
                    <a:pt x="322" y="10"/>
                  </a:lnTo>
                  <a:lnTo>
                    <a:pt x="323" y="10"/>
                  </a:lnTo>
                  <a:lnTo>
                    <a:pt x="324" y="10"/>
                  </a:lnTo>
                  <a:lnTo>
                    <a:pt x="325" y="10"/>
                  </a:lnTo>
                  <a:lnTo>
                    <a:pt x="326" y="9"/>
                  </a:lnTo>
                  <a:lnTo>
                    <a:pt x="327" y="9"/>
                  </a:lnTo>
                  <a:lnTo>
                    <a:pt x="327" y="9"/>
                  </a:lnTo>
                  <a:lnTo>
                    <a:pt x="328" y="9"/>
                  </a:lnTo>
                  <a:lnTo>
                    <a:pt x="329" y="8"/>
                  </a:lnTo>
                  <a:lnTo>
                    <a:pt x="330" y="8"/>
                  </a:lnTo>
                  <a:lnTo>
                    <a:pt x="330" y="8"/>
                  </a:lnTo>
                  <a:lnTo>
                    <a:pt x="331" y="8"/>
                  </a:lnTo>
                  <a:lnTo>
                    <a:pt x="332" y="7"/>
                  </a:lnTo>
                  <a:lnTo>
                    <a:pt x="333" y="7"/>
                  </a:lnTo>
                  <a:lnTo>
                    <a:pt x="333" y="7"/>
                  </a:lnTo>
                  <a:lnTo>
                    <a:pt x="334" y="7"/>
                  </a:lnTo>
                  <a:lnTo>
                    <a:pt x="334" y="7"/>
                  </a:lnTo>
                  <a:lnTo>
                    <a:pt x="335" y="6"/>
                  </a:lnTo>
                  <a:lnTo>
                    <a:pt x="335" y="6"/>
                  </a:lnTo>
                  <a:lnTo>
                    <a:pt x="335" y="6"/>
                  </a:lnTo>
                  <a:lnTo>
                    <a:pt x="335" y="6"/>
                  </a:lnTo>
                  <a:lnTo>
                    <a:pt x="336" y="6"/>
                  </a:lnTo>
                  <a:lnTo>
                    <a:pt x="336" y="6"/>
                  </a:lnTo>
                  <a:lnTo>
                    <a:pt x="336" y="6"/>
                  </a:lnTo>
                  <a:lnTo>
                    <a:pt x="336" y="6"/>
                  </a:lnTo>
                  <a:lnTo>
                    <a:pt x="336" y="6"/>
                  </a:lnTo>
                  <a:lnTo>
                    <a:pt x="336" y="6"/>
                  </a:lnTo>
                  <a:lnTo>
                    <a:pt x="337" y="5"/>
                  </a:lnTo>
                  <a:lnTo>
                    <a:pt x="338" y="5"/>
                  </a:lnTo>
                  <a:lnTo>
                    <a:pt x="339" y="4"/>
                  </a:lnTo>
                  <a:lnTo>
                    <a:pt x="340" y="4"/>
                  </a:lnTo>
                  <a:lnTo>
                    <a:pt x="341" y="4"/>
                  </a:lnTo>
                  <a:lnTo>
                    <a:pt x="342" y="3"/>
                  </a:lnTo>
                  <a:lnTo>
                    <a:pt x="342" y="3"/>
                  </a:lnTo>
                  <a:lnTo>
                    <a:pt x="343" y="3"/>
                  </a:lnTo>
                  <a:lnTo>
                    <a:pt x="344" y="3"/>
                  </a:lnTo>
                  <a:lnTo>
                    <a:pt x="344" y="3"/>
                  </a:lnTo>
                  <a:lnTo>
                    <a:pt x="345" y="3"/>
                  </a:lnTo>
                  <a:lnTo>
                    <a:pt x="345" y="2"/>
                  </a:lnTo>
                  <a:lnTo>
                    <a:pt x="346" y="2"/>
                  </a:lnTo>
                  <a:lnTo>
                    <a:pt x="347" y="2"/>
                  </a:lnTo>
                  <a:lnTo>
                    <a:pt x="347" y="2"/>
                  </a:lnTo>
                  <a:lnTo>
                    <a:pt x="348" y="2"/>
                  </a:lnTo>
                  <a:lnTo>
                    <a:pt x="349" y="1"/>
                  </a:lnTo>
                  <a:lnTo>
                    <a:pt x="350" y="1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3" name="Freeform 151"/>
            <p:cNvSpPr>
              <a:spLocks/>
            </p:cNvSpPr>
            <p:nvPr/>
          </p:nvSpPr>
          <p:spPr bwMode="auto">
            <a:xfrm>
              <a:off x="2358746" y="4911635"/>
              <a:ext cx="584255" cy="72191"/>
            </a:xfrm>
            <a:custGeom>
              <a:avLst/>
              <a:gdLst>
                <a:gd name="T0" fmla="*/ 7 w 471"/>
                <a:gd name="T1" fmla="*/ 47 h 55"/>
                <a:gd name="T2" fmla="*/ 15 w 471"/>
                <a:gd name="T3" fmla="*/ 46 h 55"/>
                <a:gd name="T4" fmla="*/ 26 w 471"/>
                <a:gd name="T5" fmla="*/ 45 h 55"/>
                <a:gd name="T6" fmla="*/ 34 w 471"/>
                <a:gd name="T7" fmla="*/ 46 h 55"/>
                <a:gd name="T8" fmla="*/ 40 w 471"/>
                <a:gd name="T9" fmla="*/ 47 h 55"/>
                <a:gd name="T10" fmla="*/ 49 w 471"/>
                <a:gd name="T11" fmla="*/ 49 h 55"/>
                <a:gd name="T12" fmla="*/ 60 w 471"/>
                <a:gd name="T13" fmla="*/ 52 h 55"/>
                <a:gd name="T14" fmla="*/ 67 w 471"/>
                <a:gd name="T15" fmla="*/ 53 h 55"/>
                <a:gd name="T16" fmla="*/ 75 w 471"/>
                <a:gd name="T17" fmla="*/ 54 h 55"/>
                <a:gd name="T18" fmla="*/ 84 w 471"/>
                <a:gd name="T19" fmla="*/ 55 h 55"/>
                <a:gd name="T20" fmla="*/ 93 w 471"/>
                <a:gd name="T21" fmla="*/ 55 h 55"/>
                <a:gd name="T22" fmla="*/ 101 w 471"/>
                <a:gd name="T23" fmla="*/ 55 h 55"/>
                <a:gd name="T24" fmla="*/ 109 w 471"/>
                <a:gd name="T25" fmla="*/ 55 h 55"/>
                <a:gd name="T26" fmla="*/ 117 w 471"/>
                <a:gd name="T27" fmla="*/ 54 h 55"/>
                <a:gd name="T28" fmla="*/ 120 w 471"/>
                <a:gd name="T29" fmla="*/ 54 h 55"/>
                <a:gd name="T30" fmla="*/ 124 w 471"/>
                <a:gd name="T31" fmla="*/ 53 h 55"/>
                <a:gd name="T32" fmla="*/ 129 w 471"/>
                <a:gd name="T33" fmla="*/ 52 h 55"/>
                <a:gd name="T34" fmla="*/ 132 w 471"/>
                <a:gd name="T35" fmla="*/ 51 h 55"/>
                <a:gd name="T36" fmla="*/ 136 w 471"/>
                <a:gd name="T37" fmla="*/ 50 h 55"/>
                <a:gd name="T38" fmla="*/ 138 w 471"/>
                <a:gd name="T39" fmla="*/ 48 h 55"/>
                <a:gd name="T40" fmla="*/ 142 w 471"/>
                <a:gd name="T41" fmla="*/ 45 h 55"/>
                <a:gd name="T42" fmla="*/ 145 w 471"/>
                <a:gd name="T43" fmla="*/ 41 h 55"/>
                <a:gd name="T44" fmla="*/ 146 w 471"/>
                <a:gd name="T45" fmla="*/ 40 h 55"/>
                <a:gd name="T46" fmla="*/ 147 w 471"/>
                <a:gd name="T47" fmla="*/ 38 h 55"/>
                <a:gd name="T48" fmla="*/ 151 w 471"/>
                <a:gd name="T49" fmla="*/ 32 h 55"/>
                <a:gd name="T50" fmla="*/ 160 w 471"/>
                <a:gd name="T51" fmla="*/ 17 h 55"/>
                <a:gd name="T52" fmla="*/ 165 w 471"/>
                <a:gd name="T53" fmla="*/ 9 h 55"/>
                <a:gd name="T54" fmla="*/ 170 w 471"/>
                <a:gd name="T55" fmla="*/ 4 h 55"/>
                <a:gd name="T56" fmla="*/ 174 w 471"/>
                <a:gd name="T57" fmla="*/ 1 h 55"/>
                <a:gd name="T58" fmla="*/ 180 w 471"/>
                <a:gd name="T59" fmla="*/ 1 h 55"/>
                <a:gd name="T60" fmla="*/ 185 w 471"/>
                <a:gd name="T61" fmla="*/ 3 h 55"/>
                <a:gd name="T62" fmla="*/ 192 w 471"/>
                <a:gd name="T63" fmla="*/ 8 h 55"/>
                <a:gd name="T64" fmla="*/ 199 w 471"/>
                <a:gd name="T65" fmla="*/ 16 h 55"/>
                <a:gd name="T66" fmla="*/ 201 w 471"/>
                <a:gd name="T67" fmla="*/ 19 h 55"/>
                <a:gd name="T68" fmla="*/ 213 w 471"/>
                <a:gd name="T69" fmla="*/ 31 h 55"/>
                <a:gd name="T70" fmla="*/ 219 w 471"/>
                <a:gd name="T71" fmla="*/ 37 h 55"/>
                <a:gd name="T72" fmla="*/ 225 w 471"/>
                <a:gd name="T73" fmla="*/ 42 h 55"/>
                <a:gd name="T74" fmla="*/ 228 w 471"/>
                <a:gd name="T75" fmla="*/ 44 h 55"/>
                <a:gd name="T76" fmla="*/ 236 w 471"/>
                <a:gd name="T77" fmla="*/ 47 h 55"/>
                <a:gd name="T78" fmla="*/ 241 w 471"/>
                <a:gd name="T79" fmla="*/ 49 h 55"/>
                <a:gd name="T80" fmla="*/ 247 w 471"/>
                <a:gd name="T81" fmla="*/ 51 h 55"/>
                <a:gd name="T82" fmla="*/ 254 w 471"/>
                <a:gd name="T83" fmla="*/ 52 h 55"/>
                <a:gd name="T84" fmla="*/ 260 w 471"/>
                <a:gd name="T85" fmla="*/ 53 h 55"/>
                <a:gd name="T86" fmla="*/ 271 w 471"/>
                <a:gd name="T87" fmla="*/ 55 h 55"/>
                <a:gd name="T88" fmla="*/ 281 w 471"/>
                <a:gd name="T89" fmla="*/ 55 h 55"/>
                <a:gd name="T90" fmla="*/ 292 w 471"/>
                <a:gd name="T91" fmla="*/ 55 h 55"/>
                <a:gd name="T92" fmla="*/ 301 w 471"/>
                <a:gd name="T93" fmla="*/ 55 h 55"/>
                <a:gd name="T94" fmla="*/ 307 w 471"/>
                <a:gd name="T95" fmla="*/ 55 h 55"/>
                <a:gd name="T96" fmla="*/ 318 w 471"/>
                <a:gd name="T97" fmla="*/ 54 h 55"/>
                <a:gd name="T98" fmla="*/ 334 w 471"/>
                <a:gd name="T99" fmla="*/ 53 h 55"/>
                <a:gd name="T100" fmla="*/ 346 w 471"/>
                <a:gd name="T101" fmla="*/ 53 h 55"/>
                <a:gd name="T102" fmla="*/ 361 w 471"/>
                <a:gd name="T103" fmla="*/ 53 h 55"/>
                <a:gd name="T104" fmla="*/ 370 w 471"/>
                <a:gd name="T105" fmla="*/ 53 h 55"/>
                <a:gd name="T106" fmla="*/ 382 w 471"/>
                <a:gd name="T107" fmla="*/ 52 h 55"/>
                <a:gd name="T108" fmla="*/ 389 w 471"/>
                <a:gd name="T109" fmla="*/ 51 h 55"/>
                <a:gd name="T110" fmla="*/ 401 w 471"/>
                <a:gd name="T111" fmla="*/ 50 h 55"/>
                <a:gd name="T112" fmla="*/ 413 w 471"/>
                <a:gd name="T113" fmla="*/ 49 h 55"/>
                <a:gd name="T114" fmla="*/ 416 w 471"/>
                <a:gd name="T115" fmla="*/ 49 h 55"/>
                <a:gd name="T116" fmla="*/ 423 w 471"/>
                <a:gd name="T117" fmla="*/ 48 h 55"/>
                <a:gd name="T118" fmla="*/ 431 w 471"/>
                <a:gd name="T119" fmla="*/ 46 h 55"/>
                <a:gd name="T120" fmla="*/ 441 w 471"/>
                <a:gd name="T121" fmla="*/ 43 h 55"/>
                <a:gd name="T122" fmla="*/ 448 w 471"/>
                <a:gd name="T123" fmla="*/ 40 h 55"/>
                <a:gd name="T124" fmla="*/ 466 w 471"/>
                <a:gd name="T125" fmla="*/ 34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471" h="55">
                  <a:moveTo>
                    <a:pt x="0" y="48"/>
                  </a:moveTo>
                  <a:lnTo>
                    <a:pt x="0" y="48"/>
                  </a:lnTo>
                  <a:lnTo>
                    <a:pt x="1" y="48"/>
                  </a:lnTo>
                  <a:lnTo>
                    <a:pt x="2" y="48"/>
                  </a:lnTo>
                  <a:lnTo>
                    <a:pt x="3" y="47"/>
                  </a:lnTo>
                  <a:lnTo>
                    <a:pt x="4" y="47"/>
                  </a:lnTo>
                  <a:lnTo>
                    <a:pt x="5" y="47"/>
                  </a:lnTo>
                  <a:lnTo>
                    <a:pt x="7" y="47"/>
                  </a:lnTo>
                  <a:lnTo>
                    <a:pt x="8" y="47"/>
                  </a:lnTo>
                  <a:lnTo>
                    <a:pt x="9" y="46"/>
                  </a:lnTo>
                  <a:lnTo>
                    <a:pt x="10" y="46"/>
                  </a:lnTo>
                  <a:lnTo>
                    <a:pt x="12" y="46"/>
                  </a:lnTo>
                  <a:lnTo>
                    <a:pt x="12" y="46"/>
                  </a:lnTo>
                  <a:lnTo>
                    <a:pt x="13" y="46"/>
                  </a:lnTo>
                  <a:lnTo>
                    <a:pt x="14" y="46"/>
                  </a:lnTo>
                  <a:lnTo>
                    <a:pt x="15" y="46"/>
                  </a:lnTo>
                  <a:lnTo>
                    <a:pt x="16" y="45"/>
                  </a:lnTo>
                  <a:lnTo>
                    <a:pt x="18" y="45"/>
                  </a:lnTo>
                  <a:lnTo>
                    <a:pt x="19" y="45"/>
                  </a:lnTo>
                  <a:lnTo>
                    <a:pt x="21" y="45"/>
                  </a:lnTo>
                  <a:lnTo>
                    <a:pt x="22" y="45"/>
                  </a:lnTo>
                  <a:lnTo>
                    <a:pt x="24" y="45"/>
                  </a:lnTo>
                  <a:lnTo>
                    <a:pt x="25" y="45"/>
                  </a:lnTo>
                  <a:lnTo>
                    <a:pt x="26" y="45"/>
                  </a:lnTo>
                  <a:lnTo>
                    <a:pt x="27" y="45"/>
                  </a:lnTo>
                  <a:lnTo>
                    <a:pt x="28" y="45"/>
                  </a:lnTo>
                  <a:lnTo>
                    <a:pt x="29" y="45"/>
                  </a:lnTo>
                  <a:lnTo>
                    <a:pt x="30" y="45"/>
                  </a:lnTo>
                  <a:lnTo>
                    <a:pt x="31" y="45"/>
                  </a:lnTo>
                  <a:lnTo>
                    <a:pt x="32" y="45"/>
                  </a:lnTo>
                  <a:lnTo>
                    <a:pt x="33" y="46"/>
                  </a:lnTo>
                  <a:lnTo>
                    <a:pt x="34" y="46"/>
                  </a:lnTo>
                  <a:lnTo>
                    <a:pt x="35" y="46"/>
                  </a:lnTo>
                  <a:lnTo>
                    <a:pt x="36" y="46"/>
                  </a:lnTo>
                  <a:lnTo>
                    <a:pt x="37" y="46"/>
                  </a:lnTo>
                  <a:lnTo>
                    <a:pt x="38" y="46"/>
                  </a:lnTo>
                  <a:lnTo>
                    <a:pt x="38" y="47"/>
                  </a:lnTo>
                  <a:lnTo>
                    <a:pt x="39" y="47"/>
                  </a:lnTo>
                  <a:lnTo>
                    <a:pt x="39" y="47"/>
                  </a:lnTo>
                  <a:lnTo>
                    <a:pt x="40" y="47"/>
                  </a:lnTo>
                  <a:lnTo>
                    <a:pt x="40" y="47"/>
                  </a:lnTo>
                  <a:lnTo>
                    <a:pt x="40" y="47"/>
                  </a:lnTo>
                  <a:lnTo>
                    <a:pt x="40" y="47"/>
                  </a:lnTo>
                  <a:lnTo>
                    <a:pt x="41" y="47"/>
                  </a:lnTo>
                  <a:lnTo>
                    <a:pt x="41" y="47"/>
                  </a:lnTo>
                  <a:lnTo>
                    <a:pt x="43" y="48"/>
                  </a:lnTo>
                  <a:lnTo>
                    <a:pt x="45" y="48"/>
                  </a:lnTo>
                  <a:lnTo>
                    <a:pt x="49" y="49"/>
                  </a:lnTo>
                  <a:lnTo>
                    <a:pt x="51" y="50"/>
                  </a:lnTo>
                  <a:lnTo>
                    <a:pt x="52" y="50"/>
                  </a:lnTo>
                  <a:lnTo>
                    <a:pt x="54" y="50"/>
                  </a:lnTo>
                  <a:lnTo>
                    <a:pt x="55" y="51"/>
                  </a:lnTo>
                  <a:lnTo>
                    <a:pt x="56" y="51"/>
                  </a:lnTo>
                  <a:lnTo>
                    <a:pt x="57" y="51"/>
                  </a:lnTo>
                  <a:lnTo>
                    <a:pt x="58" y="52"/>
                  </a:lnTo>
                  <a:lnTo>
                    <a:pt x="60" y="52"/>
                  </a:lnTo>
                  <a:lnTo>
                    <a:pt x="61" y="52"/>
                  </a:lnTo>
                  <a:lnTo>
                    <a:pt x="62" y="52"/>
                  </a:lnTo>
                  <a:lnTo>
                    <a:pt x="63" y="52"/>
                  </a:lnTo>
                  <a:lnTo>
                    <a:pt x="64" y="52"/>
                  </a:lnTo>
                  <a:lnTo>
                    <a:pt x="65" y="53"/>
                  </a:lnTo>
                  <a:lnTo>
                    <a:pt x="66" y="53"/>
                  </a:lnTo>
                  <a:lnTo>
                    <a:pt x="66" y="53"/>
                  </a:lnTo>
                  <a:lnTo>
                    <a:pt x="67" y="53"/>
                  </a:lnTo>
                  <a:lnTo>
                    <a:pt x="67" y="53"/>
                  </a:lnTo>
                  <a:lnTo>
                    <a:pt x="68" y="53"/>
                  </a:lnTo>
                  <a:lnTo>
                    <a:pt x="69" y="53"/>
                  </a:lnTo>
                  <a:lnTo>
                    <a:pt x="70" y="53"/>
                  </a:lnTo>
                  <a:lnTo>
                    <a:pt x="71" y="54"/>
                  </a:lnTo>
                  <a:lnTo>
                    <a:pt x="72" y="54"/>
                  </a:lnTo>
                  <a:lnTo>
                    <a:pt x="74" y="54"/>
                  </a:lnTo>
                  <a:lnTo>
                    <a:pt x="75" y="54"/>
                  </a:lnTo>
                  <a:lnTo>
                    <a:pt x="76" y="54"/>
                  </a:lnTo>
                  <a:lnTo>
                    <a:pt x="77" y="54"/>
                  </a:lnTo>
                  <a:lnTo>
                    <a:pt x="78" y="55"/>
                  </a:lnTo>
                  <a:lnTo>
                    <a:pt x="79" y="55"/>
                  </a:lnTo>
                  <a:lnTo>
                    <a:pt x="80" y="55"/>
                  </a:lnTo>
                  <a:lnTo>
                    <a:pt x="81" y="55"/>
                  </a:lnTo>
                  <a:lnTo>
                    <a:pt x="82" y="55"/>
                  </a:lnTo>
                  <a:lnTo>
                    <a:pt x="84" y="55"/>
                  </a:lnTo>
                  <a:lnTo>
                    <a:pt x="85" y="55"/>
                  </a:lnTo>
                  <a:lnTo>
                    <a:pt x="86" y="55"/>
                  </a:lnTo>
                  <a:lnTo>
                    <a:pt x="87" y="55"/>
                  </a:lnTo>
                  <a:lnTo>
                    <a:pt x="89" y="55"/>
                  </a:lnTo>
                  <a:lnTo>
                    <a:pt x="90" y="55"/>
                  </a:lnTo>
                  <a:lnTo>
                    <a:pt x="91" y="55"/>
                  </a:lnTo>
                  <a:lnTo>
                    <a:pt x="92" y="55"/>
                  </a:lnTo>
                  <a:lnTo>
                    <a:pt x="93" y="55"/>
                  </a:lnTo>
                  <a:lnTo>
                    <a:pt x="94" y="55"/>
                  </a:lnTo>
                  <a:lnTo>
                    <a:pt x="95" y="55"/>
                  </a:lnTo>
                  <a:lnTo>
                    <a:pt x="96" y="55"/>
                  </a:lnTo>
                  <a:lnTo>
                    <a:pt x="97" y="55"/>
                  </a:lnTo>
                  <a:lnTo>
                    <a:pt x="98" y="55"/>
                  </a:lnTo>
                  <a:lnTo>
                    <a:pt x="99" y="55"/>
                  </a:lnTo>
                  <a:lnTo>
                    <a:pt x="100" y="55"/>
                  </a:lnTo>
                  <a:lnTo>
                    <a:pt x="101" y="55"/>
                  </a:lnTo>
                  <a:lnTo>
                    <a:pt x="102" y="55"/>
                  </a:lnTo>
                  <a:lnTo>
                    <a:pt x="103" y="55"/>
                  </a:lnTo>
                  <a:lnTo>
                    <a:pt x="104" y="55"/>
                  </a:lnTo>
                  <a:lnTo>
                    <a:pt x="105" y="55"/>
                  </a:lnTo>
                  <a:lnTo>
                    <a:pt x="106" y="55"/>
                  </a:lnTo>
                  <a:lnTo>
                    <a:pt x="107" y="55"/>
                  </a:lnTo>
                  <a:lnTo>
                    <a:pt x="108" y="55"/>
                  </a:lnTo>
                  <a:lnTo>
                    <a:pt x="109" y="55"/>
                  </a:lnTo>
                  <a:lnTo>
                    <a:pt x="110" y="55"/>
                  </a:lnTo>
                  <a:lnTo>
                    <a:pt x="111" y="55"/>
                  </a:lnTo>
                  <a:lnTo>
                    <a:pt x="112" y="55"/>
                  </a:lnTo>
                  <a:lnTo>
                    <a:pt x="113" y="55"/>
                  </a:lnTo>
                  <a:lnTo>
                    <a:pt x="114" y="55"/>
                  </a:lnTo>
                  <a:lnTo>
                    <a:pt x="116" y="55"/>
                  </a:lnTo>
                  <a:lnTo>
                    <a:pt x="117" y="55"/>
                  </a:lnTo>
                  <a:lnTo>
                    <a:pt x="117" y="54"/>
                  </a:lnTo>
                  <a:lnTo>
                    <a:pt x="118" y="54"/>
                  </a:lnTo>
                  <a:lnTo>
                    <a:pt x="118" y="54"/>
                  </a:lnTo>
                  <a:lnTo>
                    <a:pt x="119" y="54"/>
                  </a:lnTo>
                  <a:lnTo>
                    <a:pt x="119" y="54"/>
                  </a:lnTo>
                  <a:lnTo>
                    <a:pt x="119" y="54"/>
                  </a:lnTo>
                  <a:lnTo>
                    <a:pt x="119" y="54"/>
                  </a:lnTo>
                  <a:lnTo>
                    <a:pt x="120" y="54"/>
                  </a:lnTo>
                  <a:lnTo>
                    <a:pt x="120" y="54"/>
                  </a:lnTo>
                  <a:lnTo>
                    <a:pt x="120" y="54"/>
                  </a:lnTo>
                  <a:lnTo>
                    <a:pt x="120" y="54"/>
                  </a:lnTo>
                  <a:lnTo>
                    <a:pt x="121" y="54"/>
                  </a:lnTo>
                  <a:lnTo>
                    <a:pt x="121" y="54"/>
                  </a:lnTo>
                  <a:lnTo>
                    <a:pt x="122" y="54"/>
                  </a:lnTo>
                  <a:lnTo>
                    <a:pt x="123" y="54"/>
                  </a:lnTo>
                  <a:lnTo>
                    <a:pt x="124" y="54"/>
                  </a:lnTo>
                  <a:lnTo>
                    <a:pt x="124" y="53"/>
                  </a:lnTo>
                  <a:lnTo>
                    <a:pt x="125" y="53"/>
                  </a:lnTo>
                  <a:lnTo>
                    <a:pt x="125" y="53"/>
                  </a:lnTo>
                  <a:lnTo>
                    <a:pt x="126" y="53"/>
                  </a:lnTo>
                  <a:lnTo>
                    <a:pt x="127" y="53"/>
                  </a:lnTo>
                  <a:lnTo>
                    <a:pt x="127" y="53"/>
                  </a:lnTo>
                  <a:lnTo>
                    <a:pt x="128" y="53"/>
                  </a:lnTo>
                  <a:lnTo>
                    <a:pt x="128" y="52"/>
                  </a:lnTo>
                  <a:lnTo>
                    <a:pt x="129" y="52"/>
                  </a:lnTo>
                  <a:lnTo>
                    <a:pt x="129" y="52"/>
                  </a:lnTo>
                  <a:lnTo>
                    <a:pt x="130" y="52"/>
                  </a:lnTo>
                  <a:lnTo>
                    <a:pt x="130" y="52"/>
                  </a:lnTo>
                  <a:lnTo>
                    <a:pt x="131" y="52"/>
                  </a:lnTo>
                  <a:lnTo>
                    <a:pt x="131" y="52"/>
                  </a:lnTo>
                  <a:lnTo>
                    <a:pt x="132" y="52"/>
                  </a:lnTo>
                  <a:lnTo>
                    <a:pt x="132" y="51"/>
                  </a:lnTo>
                  <a:lnTo>
                    <a:pt x="132" y="51"/>
                  </a:lnTo>
                  <a:lnTo>
                    <a:pt x="133" y="51"/>
                  </a:lnTo>
                  <a:lnTo>
                    <a:pt x="133" y="51"/>
                  </a:lnTo>
                  <a:lnTo>
                    <a:pt x="134" y="51"/>
                  </a:lnTo>
                  <a:lnTo>
                    <a:pt x="134" y="50"/>
                  </a:lnTo>
                  <a:lnTo>
                    <a:pt x="134" y="50"/>
                  </a:lnTo>
                  <a:lnTo>
                    <a:pt x="135" y="50"/>
                  </a:lnTo>
                  <a:lnTo>
                    <a:pt x="135" y="50"/>
                  </a:lnTo>
                  <a:lnTo>
                    <a:pt x="136" y="50"/>
                  </a:lnTo>
                  <a:lnTo>
                    <a:pt x="136" y="49"/>
                  </a:lnTo>
                  <a:lnTo>
                    <a:pt x="136" y="49"/>
                  </a:lnTo>
                  <a:lnTo>
                    <a:pt x="137" y="49"/>
                  </a:lnTo>
                  <a:lnTo>
                    <a:pt x="137" y="49"/>
                  </a:lnTo>
                  <a:lnTo>
                    <a:pt x="137" y="48"/>
                  </a:lnTo>
                  <a:lnTo>
                    <a:pt x="138" y="48"/>
                  </a:lnTo>
                  <a:lnTo>
                    <a:pt x="138" y="48"/>
                  </a:lnTo>
                  <a:lnTo>
                    <a:pt x="138" y="48"/>
                  </a:lnTo>
                  <a:lnTo>
                    <a:pt x="139" y="47"/>
                  </a:lnTo>
                  <a:lnTo>
                    <a:pt x="139" y="47"/>
                  </a:lnTo>
                  <a:lnTo>
                    <a:pt x="139" y="47"/>
                  </a:lnTo>
                  <a:lnTo>
                    <a:pt x="140" y="46"/>
                  </a:lnTo>
                  <a:lnTo>
                    <a:pt x="140" y="46"/>
                  </a:lnTo>
                  <a:lnTo>
                    <a:pt x="141" y="45"/>
                  </a:lnTo>
                  <a:lnTo>
                    <a:pt x="141" y="45"/>
                  </a:lnTo>
                  <a:lnTo>
                    <a:pt x="142" y="45"/>
                  </a:lnTo>
                  <a:lnTo>
                    <a:pt x="142" y="44"/>
                  </a:lnTo>
                  <a:lnTo>
                    <a:pt x="143" y="44"/>
                  </a:lnTo>
                  <a:lnTo>
                    <a:pt x="143" y="43"/>
                  </a:lnTo>
                  <a:lnTo>
                    <a:pt x="144" y="43"/>
                  </a:lnTo>
                  <a:lnTo>
                    <a:pt x="144" y="42"/>
                  </a:lnTo>
                  <a:lnTo>
                    <a:pt x="144" y="42"/>
                  </a:lnTo>
                  <a:lnTo>
                    <a:pt x="145" y="42"/>
                  </a:lnTo>
                  <a:lnTo>
                    <a:pt x="145" y="41"/>
                  </a:lnTo>
                  <a:lnTo>
                    <a:pt x="145" y="41"/>
                  </a:lnTo>
                  <a:lnTo>
                    <a:pt x="145" y="41"/>
                  </a:lnTo>
                  <a:lnTo>
                    <a:pt x="145" y="41"/>
                  </a:lnTo>
                  <a:lnTo>
                    <a:pt x="145" y="41"/>
                  </a:lnTo>
                  <a:lnTo>
                    <a:pt x="146" y="40"/>
                  </a:lnTo>
                  <a:lnTo>
                    <a:pt x="146" y="40"/>
                  </a:lnTo>
                  <a:lnTo>
                    <a:pt x="146" y="40"/>
                  </a:lnTo>
                  <a:lnTo>
                    <a:pt x="146" y="40"/>
                  </a:lnTo>
                  <a:lnTo>
                    <a:pt x="146" y="40"/>
                  </a:lnTo>
                  <a:lnTo>
                    <a:pt x="146" y="40"/>
                  </a:lnTo>
                  <a:lnTo>
                    <a:pt x="146" y="40"/>
                  </a:lnTo>
                  <a:lnTo>
                    <a:pt x="146" y="39"/>
                  </a:lnTo>
                  <a:lnTo>
                    <a:pt x="146" y="39"/>
                  </a:lnTo>
                  <a:lnTo>
                    <a:pt x="147" y="39"/>
                  </a:lnTo>
                  <a:lnTo>
                    <a:pt x="147" y="39"/>
                  </a:lnTo>
                  <a:lnTo>
                    <a:pt x="147" y="38"/>
                  </a:lnTo>
                  <a:lnTo>
                    <a:pt x="148" y="37"/>
                  </a:lnTo>
                  <a:lnTo>
                    <a:pt x="148" y="37"/>
                  </a:lnTo>
                  <a:lnTo>
                    <a:pt x="149" y="36"/>
                  </a:lnTo>
                  <a:lnTo>
                    <a:pt x="149" y="35"/>
                  </a:lnTo>
                  <a:lnTo>
                    <a:pt x="150" y="34"/>
                  </a:lnTo>
                  <a:lnTo>
                    <a:pt x="150" y="34"/>
                  </a:lnTo>
                  <a:lnTo>
                    <a:pt x="151" y="33"/>
                  </a:lnTo>
                  <a:lnTo>
                    <a:pt x="151" y="32"/>
                  </a:lnTo>
                  <a:lnTo>
                    <a:pt x="152" y="31"/>
                  </a:lnTo>
                  <a:lnTo>
                    <a:pt x="153" y="29"/>
                  </a:lnTo>
                  <a:lnTo>
                    <a:pt x="154" y="27"/>
                  </a:lnTo>
                  <a:lnTo>
                    <a:pt x="155" y="25"/>
                  </a:lnTo>
                  <a:lnTo>
                    <a:pt x="157" y="22"/>
                  </a:lnTo>
                  <a:lnTo>
                    <a:pt x="158" y="20"/>
                  </a:lnTo>
                  <a:lnTo>
                    <a:pt x="159" y="18"/>
                  </a:lnTo>
                  <a:lnTo>
                    <a:pt x="160" y="17"/>
                  </a:lnTo>
                  <a:lnTo>
                    <a:pt x="161" y="15"/>
                  </a:lnTo>
                  <a:lnTo>
                    <a:pt x="161" y="14"/>
                  </a:lnTo>
                  <a:lnTo>
                    <a:pt x="162" y="13"/>
                  </a:lnTo>
                  <a:lnTo>
                    <a:pt x="163" y="12"/>
                  </a:lnTo>
                  <a:lnTo>
                    <a:pt x="163" y="11"/>
                  </a:lnTo>
                  <a:lnTo>
                    <a:pt x="164" y="10"/>
                  </a:lnTo>
                  <a:lnTo>
                    <a:pt x="165" y="9"/>
                  </a:lnTo>
                  <a:lnTo>
                    <a:pt x="165" y="9"/>
                  </a:lnTo>
                  <a:lnTo>
                    <a:pt x="166" y="8"/>
                  </a:lnTo>
                  <a:lnTo>
                    <a:pt x="167" y="7"/>
                  </a:lnTo>
                  <a:lnTo>
                    <a:pt x="167" y="6"/>
                  </a:lnTo>
                  <a:lnTo>
                    <a:pt x="168" y="6"/>
                  </a:lnTo>
                  <a:lnTo>
                    <a:pt x="168" y="5"/>
                  </a:lnTo>
                  <a:lnTo>
                    <a:pt x="169" y="5"/>
                  </a:lnTo>
                  <a:lnTo>
                    <a:pt x="169" y="4"/>
                  </a:lnTo>
                  <a:lnTo>
                    <a:pt x="170" y="4"/>
                  </a:lnTo>
                  <a:lnTo>
                    <a:pt x="170" y="3"/>
                  </a:lnTo>
                  <a:lnTo>
                    <a:pt x="171" y="3"/>
                  </a:lnTo>
                  <a:lnTo>
                    <a:pt x="172" y="2"/>
                  </a:lnTo>
                  <a:lnTo>
                    <a:pt x="172" y="2"/>
                  </a:lnTo>
                  <a:lnTo>
                    <a:pt x="173" y="2"/>
                  </a:lnTo>
                  <a:lnTo>
                    <a:pt x="173" y="2"/>
                  </a:lnTo>
                  <a:lnTo>
                    <a:pt x="174" y="1"/>
                  </a:lnTo>
                  <a:lnTo>
                    <a:pt x="174" y="1"/>
                  </a:lnTo>
                  <a:lnTo>
                    <a:pt x="174" y="1"/>
                  </a:lnTo>
                  <a:lnTo>
                    <a:pt x="175" y="1"/>
                  </a:lnTo>
                  <a:lnTo>
                    <a:pt x="176" y="0"/>
                  </a:lnTo>
                  <a:lnTo>
                    <a:pt x="177" y="0"/>
                  </a:lnTo>
                  <a:lnTo>
                    <a:pt x="178" y="0"/>
                  </a:lnTo>
                  <a:lnTo>
                    <a:pt x="178" y="0"/>
                  </a:lnTo>
                  <a:lnTo>
                    <a:pt x="179" y="0"/>
                  </a:lnTo>
                  <a:lnTo>
                    <a:pt x="180" y="1"/>
                  </a:lnTo>
                  <a:lnTo>
                    <a:pt x="181" y="1"/>
                  </a:lnTo>
                  <a:lnTo>
                    <a:pt x="181" y="1"/>
                  </a:lnTo>
                  <a:lnTo>
                    <a:pt x="182" y="1"/>
                  </a:lnTo>
                  <a:lnTo>
                    <a:pt x="182" y="2"/>
                  </a:lnTo>
                  <a:lnTo>
                    <a:pt x="183" y="2"/>
                  </a:lnTo>
                  <a:lnTo>
                    <a:pt x="184" y="2"/>
                  </a:lnTo>
                  <a:lnTo>
                    <a:pt x="184" y="3"/>
                  </a:lnTo>
                  <a:lnTo>
                    <a:pt x="185" y="3"/>
                  </a:lnTo>
                  <a:lnTo>
                    <a:pt x="186" y="4"/>
                  </a:lnTo>
                  <a:lnTo>
                    <a:pt x="187" y="4"/>
                  </a:lnTo>
                  <a:lnTo>
                    <a:pt x="187" y="5"/>
                  </a:lnTo>
                  <a:lnTo>
                    <a:pt x="188" y="5"/>
                  </a:lnTo>
                  <a:lnTo>
                    <a:pt x="189" y="6"/>
                  </a:lnTo>
                  <a:lnTo>
                    <a:pt x="190" y="7"/>
                  </a:lnTo>
                  <a:lnTo>
                    <a:pt x="191" y="7"/>
                  </a:lnTo>
                  <a:lnTo>
                    <a:pt x="192" y="8"/>
                  </a:lnTo>
                  <a:lnTo>
                    <a:pt x="193" y="9"/>
                  </a:lnTo>
                  <a:lnTo>
                    <a:pt x="194" y="10"/>
                  </a:lnTo>
                  <a:lnTo>
                    <a:pt x="195" y="11"/>
                  </a:lnTo>
                  <a:lnTo>
                    <a:pt x="196" y="13"/>
                  </a:lnTo>
                  <a:lnTo>
                    <a:pt x="197" y="14"/>
                  </a:lnTo>
                  <a:lnTo>
                    <a:pt x="198" y="15"/>
                  </a:lnTo>
                  <a:lnTo>
                    <a:pt x="198" y="16"/>
                  </a:lnTo>
                  <a:lnTo>
                    <a:pt x="199" y="16"/>
                  </a:lnTo>
                  <a:lnTo>
                    <a:pt x="199" y="17"/>
                  </a:lnTo>
                  <a:lnTo>
                    <a:pt x="200" y="17"/>
                  </a:lnTo>
                  <a:lnTo>
                    <a:pt x="200" y="17"/>
                  </a:lnTo>
                  <a:lnTo>
                    <a:pt x="200" y="17"/>
                  </a:lnTo>
                  <a:lnTo>
                    <a:pt x="200" y="18"/>
                  </a:lnTo>
                  <a:lnTo>
                    <a:pt x="201" y="18"/>
                  </a:lnTo>
                  <a:lnTo>
                    <a:pt x="201" y="18"/>
                  </a:lnTo>
                  <a:lnTo>
                    <a:pt x="201" y="19"/>
                  </a:lnTo>
                  <a:lnTo>
                    <a:pt x="202" y="20"/>
                  </a:lnTo>
                  <a:lnTo>
                    <a:pt x="205" y="23"/>
                  </a:lnTo>
                  <a:lnTo>
                    <a:pt x="206" y="24"/>
                  </a:lnTo>
                  <a:lnTo>
                    <a:pt x="208" y="26"/>
                  </a:lnTo>
                  <a:lnTo>
                    <a:pt x="209" y="27"/>
                  </a:lnTo>
                  <a:lnTo>
                    <a:pt x="210" y="29"/>
                  </a:lnTo>
                  <a:lnTo>
                    <a:pt x="212" y="30"/>
                  </a:lnTo>
                  <a:lnTo>
                    <a:pt x="213" y="31"/>
                  </a:lnTo>
                  <a:lnTo>
                    <a:pt x="214" y="32"/>
                  </a:lnTo>
                  <a:lnTo>
                    <a:pt x="215" y="33"/>
                  </a:lnTo>
                  <a:lnTo>
                    <a:pt x="215" y="34"/>
                  </a:lnTo>
                  <a:lnTo>
                    <a:pt x="216" y="35"/>
                  </a:lnTo>
                  <a:lnTo>
                    <a:pt x="217" y="35"/>
                  </a:lnTo>
                  <a:lnTo>
                    <a:pt x="218" y="36"/>
                  </a:lnTo>
                  <a:lnTo>
                    <a:pt x="218" y="37"/>
                  </a:lnTo>
                  <a:lnTo>
                    <a:pt x="219" y="37"/>
                  </a:lnTo>
                  <a:lnTo>
                    <a:pt x="220" y="38"/>
                  </a:lnTo>
                  <a:lnTo>
                    <a:pt x="221" y="38"/>
                  </a:lnTo>
                  <a:lnTo>
                    <a:pt x="221" y="39"/>
                  </a:lnTo>
                  <a:lnTo>
                    <a:pt x="222" y="40"/>
                  </a:lnTo>
                  <a:lnTo>
                    <a:pt x="223" y="40"/>
                  </a:lnTo>
                  <a:lnTo>
                    <a:pt x="223" y="41"/>
                  </a:lnTo>
                  <a:lnTo>
                    <a:pt x="224" y="41"/>
                  </a:lnTo>
                  <a:lnTo>
                    <a:pt x="225" y="42"/>
                  </a:lnTo>
                  <a:lnTo>
                    <a:pt x="226" y="42"/>
                  </a:lnTo>
                  <a:lnTo>
                    <a:pt x="226" y="42"/>
                  </a:lnTo>
                  <a:lnTo>
                    <a:pt x="227" y="43"/>
                  </a:lnTo>
                  <a:lnTo>
                    <a:pt x="227" y="43"/>
                  </a:lnTo>
                  <a:lnTo>
                    <a:pt x="228" y="43"/>
                  </a:lnTo>
                  <a:lnTo>
                    <a:pt x="228" y="43"/>
                  </a:lnTo>
                  <a:lnTo>
                    <a:pt x="228" y="43"/>
                  </a:lnTo>
                  <a:lnTo>
                    <a:pt x="228" y="44"/>
                  </a:lnTo>
                  <a:lnTo>
                    <a:pt x="229" y="44"/>
                  </a:lnTo>
                  <a:lnTo>
                    <a:pt x="230" y="44"/>
                  </a:lnTo>
                  <a:lnTo>
                    <a:pt x="231" y="45"/>
                  </a:lnTo>
                  <a:lnTo>
                    <a:pt x="232" y="45"/>
                  </a:lnTo>
                  <a:lnTo>
                    <a:pt x="233" y="46"/>
                  </a:lnTo>
                  <a:lnTo>
                    <a:pt x="234" y="46"/>
                  </a:lnTo>
                  <a:lnTo>
                    <a:pt x="235" y="47"/>
                  </a:lnTo>
                  <a:lnTo>
                    <a:pt x="236" y="47"/>
                  </a:lnTo>
                  <a:lnTo>
                    <a:pt x="236" y="47"/>
                  </a:lnTo>
                  <a:lnTo>
                    <a:pt x="237" y="47"/>
                  </a:lnTo>
                  <a:lnTo>
                    <a:pt x="237" y="48"/>
                  </a:lnTo>
                  <a:lnTo>
                    <a:pt x="238" y="48"/>
                  </a:lnTo>
                  <a:lnTo>
                    <a:pt x="239" y="48"/>
                  </a:lnTo>
                  <a:lnTo>
                    <a:pt x="240" y="49"/>
                  </a:lnTo>
                  <a:lnTo>
                    <a:pt x="240" y="49"/>
                  </a:lnTo>
                  <a:lnTo>
                    <a:pt x="241" y="49"/>
                  </a:lnTo>
                  <a:lnTo>
                    <a:pt x="242" y="49"/>
                  </a:lnTo>
                  <a:lnTo>
                    <a:pt x="242" y="50"/>
                  </a:lnTo>
                  <a:lnTo>
                    <a:pt x="243" y="50"/>
                  </a:lnTo>
                  <a:lnTo>
                    <a:pt x="244" y="50"/>
                  </a:lnTo>
                  <a:lnTo>
                    <a:pt x="245" y="50"/>
                  </a:lnTo>
                  <a:lnTo>
                    <a:pt x="246" y="50"/>
                  </a:lnTo>
                  <a:lnTo>
                    <a:pt x="247" y="51"/>
                  </a:lnTo>
                  <a:lnTo>
                    <a:pt x="247" y="51"/>
                  </a:lnTo>
                  <a:lnTo>
                    <a:pt x="248" y="51"/>
                  </a:lnTo>
                  <a:lnTo>
                    <a:pt x="249" y="51"/>
                  </a:lnTo>
                  <a:lnTo>
                    <a:pt x="250" y="51"/>
                  </a:lnTo>
                  <a:lnTo>
                    <a:pt x="251" y="52"/>
                  </a:lnTo>
                  <a:lnTo>
                    <a:pt x="252" y="52"/>
                  </a:lnTo>
                  <a:lnTo>
                    <a:pt x="253" y="52"/>
                  </a:lnTo>
                  <a:lnTo>
                    <a:pt x="254" y="52"/>
                  </a:lnTo>
                  <a:lnTo>
                    <a:pt x="254" y="52"/>
                  </a:lnTo>
                  <a:lnTo>
                    <a:pt x="255" y="52"/>
                  </a:lnTo>
                  <a:lnTo>
                    <a:pt x="255" y="52"/>
                  </a:lnTo>
                  <a:lnTo>
                    <a:pt x="255" y="52"/>
                  </a:lnTo>
                  <a:lnTo>
                    <a:pt x="256" y="52"/>
                  </a:lnTo>
                  <a:lnTo>
                    <a:pt x="257" y="53"/>
                  </a:lnTo>
                  <a:lnTo>
                    <a:pt x="258" y="53"/>
                  </a:lnTo>
                  <a:lnTo>
                    <a:pt x="259" y="53"/>
                  </a:lnTo>
                  <a:lnTo>
                    <a:pt x="260" y="53"/>
                  </a:lnTo>
                  <a:lnTo>
                    <a:pt x="262" y="53"/>
                  </a:lnTo>
                  <a:lnTo>
                    <a:pt x="263" y="54"/>
                  </a:lnTo>
                  <a:lnTo>
                    <a:pt x="265" y="54"/>
                  </a:lnTo>
                  <a:lnTo>
                    <a:pt x="266" y="54"/>
                  </a:lnTo>
                  <a:lnTo>
                    <a:pt x="267" y="54"/>
                  </a:lnTo>
                  <a:lnTo>
                    <a:pt x="269" y="54"/>
                  </a:lnTo>
                  <a:lnTo>
                    <a:pt x="270" y="54"/>
                  </a:lnTo>
                  <a:lnTo>
                    <a:pt x="271" y="55"/>
                  </a:lnTo>
                  <a:lnTo>
                    <a:pt x="272" y="55"/>
                  </a:lnTo>
                  <a:lnTo>
                    <a:pt x="274" y="55"/>
                  </a:lnTo>
                  <a:lnTo>
                    <a:pt x="275" y="55"/>
                  </a:lnTo>
                  <a:lnTo>
                    <a:pt x="276" y="55"/>
                  </a:lnTo>
                  <a:lnTo>
                    <a:pt x="277" y="55"/>
                  </a:lnTo>
                  <a:lnTo>
                    <a:pt x="278" y="55"/>
                  </a:lnTo>
                  <a:lnTo>
                    <a:pt x="280" y="55"/>
                  </a:lnTo>
                  <a:lnTo>
                    <a:pt x="281" y="55"/>
                  </a:lnTo>
                  <a:lnTo>
                    <a:pt x="282" y="55"/>
                  </a:lnTo>
                  <a:lnTo>
                    <a:pt x="284" y="55"/>
                  </a:lnTo>
                  <a:lnTo>
                    <a:pt x="285" y="55"/>
                  </a:lnTo>
                  <a:lnTo>
                    <a:pt x="286" y="55"/>
                  </a:lnTo>
                  <a:lnTo>
                    <a:pt x="287" y="55"/>
                  </a:lnTo>
                  <a:lnTo>
                    <a:pt x="289" y="55"/>
                  </a:lnTo>
                  <a:lnTo>
                    <a:pt x="290" y="55"/>
                  </a:lnTo>
                  <a:lnTo>
                    <a:pt x="292" y="55"/>
                  </a:lnTo>
                  <a:lnTo>
                    <a:pt x="293" y="55"/>
                  </a:lnTo>
                  <a:lnTo>
                    <a:pt x="294" y="55"/>
                  </a:lnTo>
                  <a:lnTo>
                    <a:pt x="296" y="55"/>
                  </a:lnTo>
                  <a:lnTo>
                    <a:pt x="297" y="55"/>
                  </a:lnTo>
                  <a:lnTo>
                    <a:pt x="298" y="55"/>
                  </a:lnTo>
                  <a:lnTo>
                    <a:pt x="299" y="55"/>
                  </a:lnTo>
                  <a:lnTo>
                    <a:pt x="300" y="55"/>
                  </a:lnTo>
                  <a:lnTo>
                    <a:pt x="301" y="55"/>
                  </a:lnTo>
                  <a:lnTo>
                    <a:pt x="302" y="55"/>
                  </a:lnTo>
                  <a:lnTo>
                    <a:pt x="303" y="55"/>
                  </a:lnTo>
                  <a:lnTo>
                    <a:pt x="304" y="55"/>
                  </a:lnTo>
                  <a:lnTo>
                    <a:pt x="305" y="55"/>
                  </a:lnTo>
                  <a:lnTo>
                    <a:pt x="305" y="55"/>
                  </a:lnTo>
                  <a:lnTo>
                    <a:pt x="306" y="55"/>
                  </a:lnTo>
                  <a:lnTo>
                    <a:pt x="307" y="55"/>
                  </a:lnTo>
                  <a:lnTo>
                    <a:pt x="307" y="55"/>
                  </a:lnTo>
                  <a:lnTo>
                    <a:pt x="308" y="55"/>
                  </a:lnTo>
                  <a:lnTo>
                    <a:pt x="308" y="55"/>
                  </a:lnTo>
                  <a:lnTo>
                    <a:pt x="309" y="55"/>
                  </a:lnTo>
                  <a:lnTo>
                    <a:pt x="311" y="55"/>
                  </a:lnTo>
                  <a:lnTo>
                    <a:pt x="313" y="54"/>
                  </a:lnTo>
                  <a:lnTo>
                    <a:pt x="315" y="54"/>
                  </a:lnTo>
                  <a:lnTo>
                    <a:pt x="316" y="54"/>
                  </a:lnTo>
                  <a:lnTo>
                    <a:pt x="318" y="54"/>
                  </a:lnTo>
                  <a:lnTo>
                    <a:pt x="320" y="54"/>
                  </a:lnTo>
                  <a:lnTo>
                    <a:pt x="323" y="54"/>
                  </a:lnTo>
                  <a:lnTo>
                    <a:pt x="326" y="53"/>
                  </a:lnTo>
                  <a:lnTo>
                    <a:pt x="328" y="53"/>
                  </a:lnTo>
                  <a:lnTo>
                    <a:pt x="330" y="53"/>
                  </a:lnTo>
                  <a:lnTo>
                    <a:pt x="331" y="53"/>
                  </a:lnTo>
                  <a:lnTo>
                    <a:pt x="332" y="53"/>
                  </a:lnTo>
                  <a:lnTo>
                    <a:pt x="334" y="53"/>
                  </a:lnTo>
                  <a:lnTo>
                    <a:pt x="335" y="53"/>
                  </a:lnTo>
                  <a:lnTo>
                    <a:pt x="336" y="53"/>
                  </a:lnTo>
                  <a:lnTo>
                    <a:pt x="337" y="53"/>
                  </a:lnTo>
                  <a:lnTo>
                    <a:pt x="339" y="53"/>
                  </a:lnTo>
                  <a:lnTo>
                    <a:pt x="340" y="53"/>
                  </a:lnTo>
                  <a:lnTo>
                    <a:pt x="341" y="53"/>
                  </a:lnTo>
                  <a:lnTo>
                    <a:pt x="343" y="53"/>
                  </a:lnTo>
                  <a:lnTo>
                    <a:pt x="346" y="53"/>
                  </a:lnTo>
                  <a:lnTo>
                    <a:pt x="349" y="53"/>
                  </a:lnTo>
                  <a:lnTo>
                    <a:pt x="351" y="53"/>
                  </a:lnTo>
                  <a:lnTo>
                    <a:pt x="353" y="53"/>
                  </a:lnTo>
                  <a:lnTo>
                    <a:pt x="356" y="53"/>
                  </a:lnTo>
                  <a:lnTo>
                    <a:pt x="357" y="53"/>
                  </a:lnTo>
                  <a:lnTo>
                    <a:pt x="359" y="53"/>
                  </a:lnTo>
                  <a:lnTo>
                    <a:pt x="360" y="53"/>
                  </a:lnTo>
                  <a:lnTo>
                    <a:pt x="361" y="53"/>
                  </a:lnTo>
                  <a:lnTo>
                    <a:pt x="362" y="53"/>
                  </a:lnTo>
                  <a:lnTo>
                    <a:pt x="362" y="53"/>
                  </a:lnTo>
                  <a:lnTo>
                    <a:pt x="363" y="53"/>
                  </a:lnTo>
                  <a:lnTo>
                    <a:pt x="365" y="53"/>
                  </a:lnTo>
                  <a:lnTo>
                    <a:pt x="366" y="53"/>
                  </a:lnTo>
                  <a:lnTo>
                    <a:pt x="367" y="53"/>
                  </a:lnTo>
                  <a:lnTo>
                    <a:pt x="368" y="53"/>
                  </a:lnTo>
                  <a:lnTo>
                    <a:pt x="370" y="53"/>
                  </a:lnTo>
                  <a:lnTo>
                    <a:pt x="371" y="53"/>
                  </a:lnTo>
                  <a:lnTo>
                    <a:pt x="372" y="53"/>
                  </a:lnTo>
                  <a:lnTo>
                    <a:pt x="374" y="53"/>
                  </a:lnTo>
                  <a:lnTo>
                    <a:pt x="375" y="52"/>
                  </a:lnTo>
                  <a:lnTo>
                    <a:pt x="377" y="52"/>
                  </a:lnTo>
                  <a:lnTo>
                    <a:pt x="379" y="52"/>
                  </a:lnTo>
                  <a:lnTo>
                    <a:pt x="380" y="52"/>
                  </a:lnTo>
                  <a:lnTo>
                    <a:pt x="382" y="52"/>
                  </a:lnTo>
                  <a:lnTo>
                    <a:pt x="383" y="52"/>
                  </a:lnTo>
                  <a:lnTo>
                    <a:pt x="385" y="52"/>
                  </a:lnTo>
                  <a:lnTo>
                    <a:pt x="386" y="52"/>
                  </a:lnTo>
                  <a:lnTo>
                    <a:pt x="387" y="52"/>
                  </a:lnTo>
                  <a:lnTo>
                    <a:pt x="387" y="51"/>
                  </a:lnTo>
                  <a:lnTo>
                    <a:pt x="388" y="51"/>
                  </a:lnTo>
                  <a:lnTo>
                    <a:pt x="388" y="51"/>
                  </a:lnTo>
                  <a:lnTo>
                    <a:pt x="389" y="51"/>
                  </a:lnTo>
                  <a:lnTo>
                    <a:pt x="389" y="51"/>
                  </a:lnTo>
                  <a:lnTo>
                    <a:pt x="391" y="51"/>
                  </a:lnTo>
                  <a:lnTo>
                    <a:pt x="393" y="51"/>
                  </a:lnTo>
                  <a:lnTo>
                    <a:pt x="395" y="50"/>
                  </a:lnTo>
                  <a:lnTo>
                    <a:pt x="397" y="50"/>
                  </a:lnTo>
                  <a:lnTo>
                    <a:pt x="398" y="50"/>
                  </a:lnTo>
                  <a:lnTo>
                    <a:pt x="400" y="50"/>
                  </a:lnTo>
                  <a:lnTo>
                    <a:pt x="401" y="50"/>
                  </a:lnTo>
                  <a:lnTo>
                    <a:pt x="403" y="50"/>
                  </a:lnTo>
                  <a:lnTo>
                    <a:pt x="404" y="50"/>
                  </a:lnTo>
                  <a:lnTo>
                    <a:pt x="405" y="49"/>
                  </a:lnTo>
                  <a:lnTo>
                    <a:pt x="407" y="49"/>
                  </a:lnTo>
                  <a:lnTo>
                    <a:pt x="409" y="49"/>
                  </a:lnTo>
                  <a:lnTo>
                    <a:pt x="411" y="49"/>
                  </a:lnTo>
                  <a:lnTo>
                    <a:pt x="412" y="49"/>
                  </a:lnTo>
                  <a:lnTo>
                    <a:pt x="413" y="49"/>
                  </a:lnTo>
                  <a:lnTo>
                    <a:pt x="414" y="49"/>
                  </a:lnTo>
                  <a:lnTo>
                    <a:pt x="414" y="49"/>
                  </a:lnTo>
                  <a:lnTo>
                    <a:pt x="415" y="49"/>
                  </a:lnTo>
                  <a:lnTo>
                    <a:pt x="415" y="49"/>
                  </a:lnTo>
                  <a:lnTo>
                    <a:pt x="415" y="49"/>
                  </a:lnTo>
                  <a:lnTo>
                    <a:pt x="416" y="49"/>
                  </a:lnTo>
                  <a:lnTo>
                    <a:pt x="416" y="49"/>
                  </a:lnTo>
                  <a:lnTo>
                    <a:pt x="416" y="49"/>
                  </a:lnTo>
                  <a:lnTo>
                    <a:pt x="417" y="49"/>
                  </a:lnTo>
                  <a:lnTo>
                    <a:pt x="418" y="48"/>
                  </a:lnTo>
                  <a:lnTo>
                    <a:pt x="419" y="48"/>
                  </a:lnTo>
                  <a:lnTo>
                    <a:pt x="420" y="48"/>
                  </a:lnTo>
                  <a:lnTo>
                    <a:pt x="421" y="48"/>
                  </a:lnTo>
                  <a:lnTo>
                    <a:pt x="421" y="48"/>
                  </a:lnTo>
                  <a:lnTo>
                    <a:pt x="422" y="48"/>
                  </a:lnTo>
                  <a:lnTo>
                    <a:pt x="423" y="48"/>
                  </a:lnTo>
                  <a:lnTo>
                    <a:pt x="424" y="47"/>
                  </a:lnTo>
                  <a:lnTo>
                    <a:pt x="424" y="47"/>
                  </a:lnTo>
                  <a:lnTo>
                    <a:pt x="425" y="47"/>
                  </a:lnTo>
                  <a:lnTo>
                    <a:pt x="426" y="47"/>
                  </a:lnTo>
                  <a:lnTo>
                    <a:pt x="427" y="47"/>
                  </a:lnTo>
                  <a:lnTo>
                    <a:pt x="428" y="47"/>
                  </a:lnTo>
                  <a:lnTo>
                    <a:pt x="429" y="46"/>
                  </a:lnTo>
                  <a:lnTo>
                    <a:pt x="431" y="46"/>
                  </a:lnTo>
                  <a:lnTo>
                    <a:pt x="432" y="45"/>
                  </a:lnTo>
                  <a:lnTo>
                    <a:pt x="434" y="45"/>
                  </a:lnTo>
                  <a:lnTo>
                    <a:pt x="435" y="45"/>
                  </a:lnTo>
                  <a:lnTo>
                    <a:pt x="437" y="44"/>
                  </a:lnTo>
                  <a:lnTo>
                    <a:pt x="438" y="44"/>
                  </a:lnTo>
                  <a:lnTo>
                    <a:pt x="439" y="43"/>
                  </a:lnTo>
                  <a:lnTo>
                    <a:pt x="440" y="43"/>
                  </a:lnTo>
                  <a:lnTo>
                    <a:pt x="441" y="43"/>
                  </a:lnTo>
                  <a:lnTo>
                    <a:pt x="441" y="43"/>
                  </a:lnTo>
                  <a:lnTo>
                    <a:pt x="441" y="42"/>
                  </a:lnTo>
                  <a:lnTo>
                    <a:pt x="442" y="42"/>
                  </a:lnTo>
                  <a:lnTo>
                    <a:pt x="442" y="42"/>
                  </a:lnTo>
                  <a:lnTo>
                    <a:pt x="442" y="42"/>
                  </a:lnTo>
                  <a:lnTo>
                    <a:pt x="443" y="42"/>
                  </a:lnTo>
                  <a:lnTo>
                    <a:pt x="445" y="41"/>
                  </a:lnTo>
                  <a:lnTo>
                    <a:pt x="448" y="40"/>
                  </a:lnTo>
                  <a:lnTo>
                    <a:pt x="450" y="39"/>
                  </a:lnTo>
                  <a:lnTo>
                    <a:pt x="453" y="38"/>
                  </a:lnTo>
                  <a:lnTo>
                    <a:pt x="456" y="37"/>
                  </a:lnTo>
                  <a:lnTo>
                    <a:pt x="458" y="36"/>
                  </a:lnTo>
                  <a:lnTo>
                    <a:pt x="460" y="36"/>
                  </a:lnTo>
                  <a:lnTo>
                    <a:pt x="463" y="35"/>
                  </a:lnTo>
                  <a:lnTo>
                    <a:pt x="465" y="34"/>
                  </a:lnTo>
                  <a:lnTo>
                    <a:pt x="466" y="34"/>
                  </a:lnTo>
                  <a:lnTo>
                    <a:pt x="467" y="33"/>
                  </a:lnTo>
                  <a:lnTo>
                    <a:pt x="468" y="33"/>
                  </a:lnTo>
                  <a:lnTo>
                    <a:pt x="468" y="33"/>
                  </a:lnTo>
                  <a:lnTo>
                    <a:pt x="469" y="33"/>
                  </a:lnTo>
                  <a:lnTo>
                    <a:pt x="469" y="33"/>
                  </a:lnTo>
                  <a:lnTo>
                    <a:pt x="469" y="33"/>
                  </a:lnTo>
                  <a:lnTo>
                    <a:pt x="471" y="32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Freeform 152"/>
            <p:cNvSpPr>
              <a:spLocks/>
            </p:cNvSpPr>
            <p:nvPr/>
          </p:nvSpPr>
          <p:spPr bwMode="auto">
            <a:xfrm>
              <a:off x="2943001" y="3600392"/>
              <a:ext cx="539599" cy="1353246"/>
            </a:xfrm>
            <a:custGeom>
              <a:avLst/>
              <a:gdLst>
                <a:gd name="T0" fmla="*/ 19 w 435"/>
                <a:gd name="T1" fmla="*/ 1026 h 1031"/>
                <a:gd name="T2" fmla="*/ 29 w 435"/>
                <a:gd name="T3" fmla="*/ 1024 h 1031"/>
                <a:gd name="T4" fmla="*/ 45 w 435"/>
                <a:gd name="T5" fmla="*/ 1024 h 1031"/>
                <a:gd name="T6" fmla="*/ 58 w 435"/>
                <a:gd name="T7" fmla="*/ 1022 h 1031"/>
                <a:gd name="T8" fmla="*/ 75 w 435"/>
                <a:gd name="T9" fmla="*/ 1019 h 1031"/>
                <a:gd name="T10" fmla="*/ 82 w 435"/>
                <a:gd name="T11" fmla="*/ 1016 h 1031"/>
                <a:gd name="T12" fmla="*/ 90 w 435"/>
                <a:gd name="T13" fmla="*/ 1014 h 1031"/>
                <a:gd name="T14" fmla="*/ 98 w 435"/>
                <a:gd name="T15" fmla="*/ 1014 h 1031"/>
                <a:gd name="T16" fmla="*/ 104 w 435"/>
                <a:gd name="T17" fmla="*/ 1016 h 1031"/>
                <a:gd name="T18" fmla="*/ 112 w 435"/>
                <a:gd name="T19" fmla="*/ 1020 h 1031"/>
                <a:gd name="T20" fmla="*/ 121 w 435"/>
                <a:gd name="T21" fmla="*/ 1024 h 1031"/>
                <a:gd name="T22" fmla="*/ 131 w 435"/>
                <a:gd name="T23" fmla="*/ 1025 h 1031"/>
                <a:gd name="T24" fmla="*/ 145 w 435"/>
                <a:gd name="T25" fmla="*/ 1024 h 1031"/>
                <a:gd name="T26" fmla="*/ 159 w 435"/>
                <a:gd name="T27" fmla="*/ 1024 h 1031"/>
                <a:gd name="T28" fmla="*/ 173 w 435"/>
                <a:gd name="T29" fmla="*/ 1021 h 1031"/>
                <a:gd name="T30" fmla="*/ 185 w 435"/>
                <a:gd name="T31" fmla="*/ 1020 h 1031"/>
                <a:gd name="T32" fmla="*/ 195 w 435"/>
                <a:gd name="T33" fmla="*/ 1020 h 1031"/>
                <a:gd name="T34" fmla="*/ 202 w 435"/>
                <a:gd name="T35" fmla="*/ 1018 h 1031"/>
                <a:gd name="T36" fmla="*/ 210 w 435"/>
                <a:gd name="T37" fmla="*/ 1014 h 1031"/>
                <a:gd name="T38" fmla="*/ 217 w 435"/>
                <a:gd name="T39" fmla="*/ 1010 h 1031"/>
                <a:gd name="T40" fmla="*/ 226 w 435"/>
                <a:gd name="T41" fmla="*/ 1008 h 1031"/>
                <a:gd name="T42" fmla="*/ 235 w 435"/>
                <a:gd name="T43" fmla="*/ 1007 h 1031"/>
                <a:gd name="T44" fmla="*/ 248 w 435"/>
                <a:gd name="T45" fmla="*/ 1007 h 1031"/>
                <a:gd name="T46" fmla="*/ 264 w 435"/>
                <a:gd name="T47" fmla="*/ 1006 h 1031"/>
                <a:gd name="T48" fmla="*/ 272 w 435"/>
                <a:gd name="T49" fmla="*/ 1006 h 1031"/>
                <a:gd name="T50" fmla="*/ 282 w 435"/>
                <a:gd name="T51" fmla="*/ 1003 h 1031"/>
                <a:gd name="T52" fmla="*/ 289 w 435"/>
                <a:gd name="T53" fmla="*/ 1001 h 1031"/>
                <a:gd name="T54" fmla="*/ 295 w 435"/>
                <a:gd name="T55" fmla="*/ 1003 h 1031"/>
                <a:gd name="T56" fmla="*/ 306 w 435"/>
                <a:gd name="T57" fmla="*/ 1005 h 1031"/>
                <a:gd name="T58" fmla="*/ 317 w 435"/>
                <a:gd name="T59" fmla="*/ 1006 h 1031"/>
                <a:gd name="T60" fmla="*/ 325 w 435"/>
                <a:gd name="T61" fmla="*/ 1008 h 1031"/>
                <a:gd name="T62" fmla="*/ 333 w 435"/>
                <a:gd name="T63" fmla="*/ 1009 h 1031"/>
                <a:gd name="T64" fmla="*/ 338 w 435"/>
                <a:gd name="T65" fmla="*/ 1009 h 1031"/>
                <a:gd name="T66" fmla="*/ 344 w 435"/>
                <a:gd name="T67" fmla="*/ 1006 h 1031"/>
                <a:gd name="T68" fmla="*/ 347 w 435"/>
                <a:gd name="T69" fmla="*/ 1004 h 1031"/>
                <a:gd name="T70" fmla="*/ 356 w 435"/>
                <a:gd name="T71" fmla="*/ 996 h 1031"/>
                <a:gd name="T72" fmla="*/ 365 w 435"/>
                <a:gd name="T73" fmla="*/ 985 h 1031"/>
                <a:gd name="T74" fmla="*/ 370 w 435"/>
                <a:gd name="T75" fmla="*/ 975 h 1031"/>
                <a:gd name="T76" fmla="*/ 372 w 435"/>
                <a:gd name="T77" fmla="*/ 971 h 1031"/>
                <a:gd name="T78" fmla="*/ 378 w 435"/>
                <a:gd name="T79" fmla="*/ 957 h 1031"/>
                <a:gd name="T80" fmla="*/ 383 w 435"/>
                <a:gd name="T81" fmla="*/ 945 h 1031"/>
                <a:gd name="T82" fmla="*/ 386 w 435"/>
                <a:gd name="T83" fmla="*/ 931 h 1031"/>
                <a:gd name="T84" fmla="*/ 390 w 435"/>
                <a:gd name="T85" fmla="*/ 911 h 1031"/>
                <a:gd name="T86" fmla="*/ 393 w 435"/>
                <a:gd name="T87" fmla="*/ 886 h 1031"/>
                <a:gd name="T88" fmla="*/ 395 w 435"/>
                <a:gd name="T89" fmla="*/ 855 h 1031"/>
                <a:gd name="T90" fmla="*/ 397 w 435"/>
                <a:gd name="T91" fmla="*/ 830 h 1031"/>
                <a:gd name="T92" fmla="*/ 398 w 435"/>
                <a:gd name="T93" fmla="*/ 819 h 1031"/>
                <a:gd name="T94" fmla="*/ 398 w 435"/>
                <a:gd name="T95" fmla="*/ 809 h 1031"/>
                <a:gd name="T96" fmla="*/ 401 w 435"/>
                <a:gd name="T97" fmla="*/ 756 h 1031"/>
                <a:gd name="T98" fmla="*/ 406 w 435"/>
                <a:gd name="T99" fmla="*/ 665 h 1031"/>
                <a:gd name="T100" fmla="*/ 409 w 435"/>
                <a:gd name="T101" fmla="*/ 572 h 1031"/>
                <a:gd name="T102" fmla="*/ 412 w 435"/>
                <a:gd name="T103" fmla="*/ 484 h 1031"/>
                <a:gd name="T104" fmla="*/ 415 w 435"/>
                <a:gd name="T105" fmla="*/ 386 h 1031"/>
                <a:gd name="T106" fmla="*/ 419 w 435"/>
                <a:gd name="T107" fmla="*/ 222 h 1031"/>
                <a:gd name="T108" fmla="*/ 422 w 435"/>
                <a:gd name="T109" fmla="*/ 121 h 1031"/>
                <a:gd name="T110" fmla="*/ 423 w 435"/>
                <a:gd name="T111" fmla="*/ 63 h 1031"/>
                <a:gd name="T112" fmla="*/ 425 w 435"/>
                <a:gd name="T113" fmla="*/ 36 h 1031"/>
                <a:gd name="T114" fmla="*/ 426 w 435"/>
                <a:gd name="T115" fmla="*/ 11 h 1031"/>
                <a:gd name="T116" fmla="*/ 428 w 435"/>
                <a:gd name="T117" fmla="*/ 0 h 1031"/>
                <a:gd name="T118" fmla="*/ 429 w 435"/>
                <a:gd name="T119" fmla="*/ 5 h 1031"/>
                <a:gd name="T120" fmla="*/ 430 w 435"/>
                <a:gd name="T121" fmla="*/ 23 h 1031"/>
                <a:gd name="T122" fmla="*/ 432 w 435"/>
                <a:gd name="T123" fmla="*/ 57 h 1031"/>
                <a:gd name="T124" fmla="*/ 434 w 435"/>
                <a:gd name="T125" fmla="*/ 108 h 10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435" h="1031">
                  <a:moveTo>
                    <a:pt x="0" y="1031"/>
                  </a:moveTo>
                  <a:lnTo>
                    <a:pt x="2" y="1031"/>
                  </a:lnTo>
                  <a:lnTo>
                    <a:pt x="4" y="1030"/>
                  </a:lnTo>
                  <a:lnTo>
                    <a:pt x="7" y="1029"/>
                  </a:lnTo>
                  <a:lnTo>
                    <a:pt x="9" y="1028"/>
                  </a:lnTo>
                  <a:lnTo>
                    <a:pt x="13" y="1028"/>
                  </a:lnTo>
                  <a:lnTo>
                    <a:pt x="16" y="1027"/>
                  </a:lnTo>
                  <a:lnTo>
                    <a:pt x="19" y="1026"/>
                  </a:lnTo>
                  <a:lnTo>
                    <a:pt x="21" y="1026"/>
                  </a:lnTo>
                  <a:lnTo>
                    <a:pt x="22" y="1025"/>
                  </a:lnTo>
                  <a:lnTo>
                    <a:pt x="24" y="1025"/>
                  </a:lnTo>
                  <a:lnTo>
                    <a:pt x="25" y="1025"/>
                  </a:lnTo>
                  <a:lnTo>
                    <a:pt x="25" y="1025"/>
                  </a:lnTo>
                  <a:lnTo>
                    <a:pt x="27" y="1024"/>
                  </a:lnTo>
                  <a:lnTo>
                    <a:pt x="28" y="1024"/>
                  </a:lnTo>
                  <a:lnTo>
                    <a:pt x="29" y="1024"/>
                  </a:lnTo>
                  <a:lnTo>
                    <a:pt x="30" y="1024"/>
                  </a:lnTo>
                  <a:lnTo>
                    <a:pt x="32" y="1024"/>
                  </a:lnTo>
                  <a:lnTo>
                    <a:pt x="34" y="1024"/>
                  </a:lnTo>
                  <a:lnTo>
                    <a:pt x="36" y="1024"/>
                  </a:lnTo>
                  <a:lnTo>
                    <a:pt x="39" y="1024"/>
                  </a:lnTo>
                  <a:lnTo>
                    <a:pt x="41" y="1024"/>
                  </a:lnTo>
                  <a:lnTo>
                    <a:pt x="43" y="1024"/>
                  </a:lnTo>
                  <a:lnTo>
                    <a:pt x="45" y="1024"/>
                  </a:lnTo>
                  <a:lnTo>
                    <a:pt x="47" y="1024"/>
                  </a:lnTo>
                  <a:lnTo>
                    <a:pt x="48" y="1023"/>
                  </a:lnTo>
                  <a:lnTo>
                    <a:pt x="50" y="1023"/>
                  </a:lnTo>
                  <a:lnTo>
                    <a:pt x="51" y="1023"/>
                  </a:lnTo>
                  <a:lnTo>
                    <a:pt x="52" y="1023"/>
                  </a:lnTo>
                  <a:lnTo>
                    <a:pt x="53" y="1023"/>
                  </a:lnTo>
                  <a:lnTo>
                    <a:pt x="55" y="1022"/>
                  </a:lnTo>
                  <a:lnTo>
                    <a:pt x="58" y="1022"/>
                  </a:lnTo>
                  <a:lnTo>
                    <a:pt x="62" y="1021"/>
                  </a:lnTo>
                  <a:lnTo>
                    <a:pt x="66" y="1021"/>
                  </a:lnTo>
                  <a:lnTo>
                    <a:pt x="68" y="1020"/>
                  </a:lnTo>
                  <a:lnTo>
                    <a:pt x="70" y="1020"/>
                  </a:lnTo>
                  <a:lnTo>
                    <a:pt x="71" y="1020"/>
                  </a:lnTo>
                  <a:lnTo>
                    <a:pt x="73" y="1019"/>
                  </a:lnTo>
                  <a:lnTo>
                    <a:pt x="74" y="1019"/>
                  </a:lnTo>
                  <a:lnTo>
                    <a:pt x="75" y="1019"/>
                  </a:lnTo>
                  <a:lnTo>
                    <a:pt x="76" y="1019"/>
                  </a:lnTo>
                  <a:lnTo>
                    <a:pt x="76" y="1018"/>
                  </a:lnTo>
                  <a:lnTo>
                    <a:pt x="77" y="1018"/>
                  </a:lnTo>
                  <a:lnTo>
                    <a:pt x="78" y="1018"/>
                  </a:lnTo>
                  <a:lnTo>
                    <a:pt x="78" y="1018"/>
                  </a:lnTo>
                  <a:lnTo>
                    <a:pt x="79" y="1017"/>
                  </a:lnTo>
                  <a:lnTo>
                    <a:pt x="81" y="1017"/>
                  </a:lnTo>
                  <a:lnTo>
                    <a:pt x="82" y="1016"/>
                  </a:lnTo>
                  <a:lnTo>
                    <a:pt x="83" y="1016"/>
                  </a:lnTo>
                  <a:lnTo>
                    <a:pt x="85" y="1015"/>
                  </a:lnTo>
                  <a:lnTo>
                    <a:pt x="86" y="1015"/>
                  </a:lnTo>
                  <a:lnTo>
                    <a:pt x="87" y="1015"/>
                  </a:lnTo>
                  <a:lnTo>
                    <a:pt x="88" y="1014"/>
                  </a:lnTo>
                  <a:lnTo>
                    <a:pt x="89" y="1014"/>
                  </a:lnTo>
                  <a:lnTo>
                    <a:pt x="90" y="1014"/>
                  </a:lnTo>
                  <a:lnTo>
                    <a:pt x="90" y="1014"/>
                  </a:lnTo>
                  <a:lnTo>
                    <a:pt x="91" y="1014"/>
                  </a:lnTo>
                  <a:lnTo>
                    <a:pt x="92" y="1014"/>
                  </a:lnTo>
                  <a:lnTo>
                    <a:pt x="93" y="1014"/>
                  </a:lnTo>
                  <a:lnTo>
                    <a:pt x="94" y="1014"/>
                  </a:lnTo>
                  <a:lnTo>
                    <a:pt x="95" y="1014"/>
                  </a:lnTo>
                  <a:lnTo>
                    <a:pt x="96" y="1014"/>
                  </a:lnTo>
                  <a:lnTo>
                    <a:pt x="97" y="1014"/>
                  </a:lnTo>
                  <a:lnTo>
                    <a:pt x="98" y="1014"/>
                  </a:lnTo>
                  <a:lnTo>
                    <a:pt x="99" y="1014"/>
                  </a:lnTo>
                  <a:lnTo>
                    <a:pt x="100" y="1014"/>
                  </a:lnTo>
                  <a:lnTo>
                    <a:pt x="101" y="1015"/>
                  </a:lnTo>
                  <a:lnTo>
                    <a:pt x="102" y="1015"/>
                  </a:lnTo>
                  <a:lnTo>
                    <a:pt x="102" y="1015"/>
                  </a:lnTo>
                  <a:lnTo>
                    <a:pt x="103" y="1015"/>
                  </a:lnTo>
                  <a:lnTo>
                    <a:pt x="103" y="1016"/>
                  </a:lnTo>
                  <a:lnTo>
                    <a:pt x="104" y="1016"/>
                  </a:lnTo>
                  <a:lnTo>
                    <a:pt x="104" y="1016"/>
                  </a:lnTo>
                  <a:lnTo>
                    <a:pt x="104" y="1016"/>
                  </a:lnTo>
                  <a:lnTo>
                    <a:pt x="105" y="1016"/>
                  </a:lnTo>
                  <a:lnTo>
                    <a:pt x="105" y="1016"/>
                  </a:lnTo>
                  <a:lnTo>
                    <a:pt x="107" y="1017"/>
                  </a:lnTo>
                  <a:lnTo>
                    <a:pt x="108" y="1018"/>
                  </a:lnTo>
                  <a:lnTo>
                    <a:pt x="110" y="1019"/>
                  </a:lnTo>
                  <a:lnTo>
                    <a:pt x="112" y="1020"/>
                  </a:lnTo>
                  <a:lnTo>
                    <a:pt x="113" y="1020"/>
                  </a:lnTo>
                  <a:lnTo>
                    <a:pt x="114" y="1021"/>
                  </a:lnTo>
                  <a:lnTo>
                    <a:pt x="116" y="1021"/>
                  </a:lnTo>
                  <a:lnTo>
                    <a:pt x="117" y="1022"/>
                  </a:lnTo>
                  <a:lnTo>
                    <a:pt x="118" y="1022"/>
                  </a:lnTo>
                  <a:lnTo>
                    <a:pt x="119" y="1023"/>
                  </a:lnTo>
                  <a:lnTo>
                    <a:pt x="120" y="1023"/>
                  </a:lnTo>
                  <a:lnTo>
                    <a:pt x="121" y="1024"/>
                  </a:lnTo>
                  <a:lnTo>
                    <a:pt x="122" y="1024"/>
                  </a:lnTo>
                  <a:lnTo>
                    <a:pt x="123" y="1024"/>
                  </a:lnTo>
                  <a:lnTo>
                    <a:pt x="124" y="1024"/>
                  </a:lnTo>
                  <a:lnTo>
                    <a:pt x="126" y="1024"/>
                  </a:lnTo>
                  <a:lnTo>
                    <a:pt x="127" y="1024"/>
                  </a:lnTo>
                  <a:lnTo>
                    <a:pt x="128" y="1025"/>
                  </a:lnTo>
                  <a:lnTo>
                    <a:pt x="130" y="1025"/>
                  </a:lnTo>
                  <a:lnTo>
                    <a:pt x="131" y="1025"/>
                  </a:lnTo>
                  <a:lnTo>
                    <a:pt x="132" y="1025"/>
                  </a:lnTo>
                  <a:lnTo>
                    <a:pt x="134" y="1025"/>
                  </a:lnTo>
                  <a:lnTo>
                    <a:pt x="136" y="1025"/>
                  </a:lnTo>
                  <a:lnTo>
                    <a:pt x="137" y="1025"/>
                  </a:lnTo>
                  <a:lnTo>
                    <a:pt x="139" y="1025"/>
                  </a:lnTo>
                  <a:lnTo>
                    <a:pt x="141" y="1025"/>
                  </a:lnTo>
                  <a:lnTo>
                    <a:pt x="143" y="1025"/>
                  </a:lnTo>
                  <a:lnTo>
                    <a:pt x="145" y="1024"/>
                  </a:lnTo>
                  <a:lnTo>
                    <a:pt x="148" y="1024"/>
                  </a:lnTo>
                  <a:lnTo>
                    <a:pt x="152" y="1024"/>
                  </a:lnTo>
                  <a:lnTo>
                    <a:pt x="155" y="1024"/>
                  </a:lnTo>
                  <a:lnTo>
                    <a:pt x="156" y="1024"/>
                  </a:lnTo>
                  <a:lnTo>
                    <a:pt x="157" y="1024"/>
                  </a:lnTo>
                  <a:lnTo>
                    <a:pt x="158" y="1024"/>
                  </a:lnTo>
                  <a:lnTo>
                    <a:pt x="158" y="1024"/>
                  </a:lnTo>
                  <a:lnTo>
                    <a:pt x="159" y="1024"/>
                  </a:lnTo>
                  <a:lnTo>
                    <a:pt x="160" y="1023"/>
                  </a:lnTo>
                  <a:lnTo>
                    <a:pt x="162" y="1023"/>
                  </a:lnTo>
                  <a:lnTo>
                    <a:pt x="164" y="1023"/>
                  </a:lnTo>
                  <a:lnTo>
                    <a:pt x="165" y="1023"/>
                  </a:lnTo>
                  <a:lnTo>
                    <a:pt x="167" y="1023"/>
                  </a:lnTo>
                  <a:lnTo>
                    <a:pt x="169" y="1022"/>
                  </a:lnTo>
                  <a:lnTo>
                    <a:pt x="170" y="1022"/>
                  </a:lnTo>
                  <a:lnTo>
                    <a:pt x="173" y="1021"/>
                  </a:lnTo>
                  <a:lnTo>
                    <a:pt x="175" y="1021"/>
                  </a:lnTo>
                  <a:lnTo>
                    <a:pt x="177" y="1021"/>
                  </a:lnTo>
                  <a:lnTo>
                    <a:pt x="178" y="1021"/>
                  </a:lnTo>
                  <a:lnTo>
                    <a:pt x="180" y="1020"/>
                  </a:lnTo>
                  <a:lnTo>
                    <a:pt x="181" y="1020"/>
                  </a:lnTo>
                  <a:lnTo>
                    <a:pt x="182" y="1020"/>
                  </a:lnTo>
                  <a:lnTo>
                    <a:pt x="184" y="1020"/>
                  </a:lnTo>
                  <a:lnTo>
                    <a:pt x="185" y="1020"/>
                  </a:lnTo>
                  <a:lnTo>
                    <a:pt x="186" y="1020"/>
                  </a:lnTo>
                  <a:lnTo>
                    <a:pt x="187" y="1020"/>
                  </a:lnTo>
                  <a:lnTo>
                    <a:pt x="189" y="1020"/>
                  </a:lnTo>
                  <a:lnTo>
                    <a:pt x="191" y="1020"/>
                  </a:lnTo>
                  <a:lnTo>
                    <a:pt x="192" y="1020"/>
                  </a:lnTo>
                  <a:lnTo>
                    <a:pt x="193" y="1020"/>
                  </a:lnTo>
                  <a:lnTo>
                    <a:pt x="194" y="1020"/>
                  </a:lnTo>
                  <a:lnTo>
                    <a:pt x="195" y="1020"/>
                  </a:lnTo>
                  <a:lnTo>
                    <a:pt x="196" y="1020"/>
                  </a:lnTo>
                  <a:lnTo>
                    <a:pt x="197" y="1020"/>
                  </a:lnTo>
                  <a:lnTo>
                    <a:pt x="198" y="1020"/>
                  </a:lnTo>
                  <a:lnTo>
                    <a:pt x="199" y="1020"/>
                  </a:lnTo>
                  <a:lnTo>
                    <a:pt x="200" y="1019"/>
                  </a:lnTo>
                  <a:lnTo>
                    <a:pt x="200" y="1019"/>
                  </a:lnTo>
                  <a:lnTo>
                    <a:pt x="201" y="1019"/>
                  </a:lnTo>
                  <a:lnTo>
                    <a:pt x="202" y="1018"/>
                  </a:lnTo>
                  <a:lnTo>
                    <a:pt x="203" y="1018"/>
                  </a:lnTo>
                  <a:lnTo>
                    <a:pt x="204" y="1018"/>
                  </a:lnTo>
                  <a:lnTo>
                    <a:pt x="205" y="1017"/>
                  </a:lnTo>
                  <a:lnTo>
                    <a:pt x="207" y="1016"/>
                  </a:lnTo>
                  <a:lnTo>
                    <a:pt x="208" y="1016"/>
                  </a:lnTo>
                  <a:lnTo>
                    <a:pt x="209" y="1015"/>
                  </a:lnTo>
                  <a:lnTo>
                    <a:pt x="210" y="1014"/>
                  </a:lnTo>
                  <a:lnTo>
                    <a:pt x="210" y="1014"/>
                  </a:lnTo>
                  <a:lnTo>
                    <a:pt x="211" y="1014"/>
                  </a:lnTo>
                  <a:lnTo>
                    <a:pt x="211" y="1014"/>
                  </a:lnTo>
                  <a:lnTo>
                    <a:pt x="212" y="1013"/>
                  </a:lnTo>
                  <a:lnTo>
                    <a:pt x="212" y="1013"/>
                  </a:lnTo>
                  <a:lnTo>
                    <a:pt x="213" y="1013"/>
                  </a:lnTo>
                  <a:lnTo>
                    <a:pt x="215" y="1012"/>
                  </a:lnTo>
                  <a:lnTo>
                    <a:pt x="216" y="1011"/>
                  </a:lnTo>
                  <a:lnTo>
                    <a:pt x="217" y="1010"/>
                  </a:lnTo>
                  <a:lnTo>
                    <a:pt x="218" y="1010"/>
                  </a:lnTo>
                  <a:lnTo>
                    <a:pt x="220" y="1009"/>
                  </a:lnTo>
                  <a:lnTo>
                    <a:pt x="221" y="1009"/>
                  </a:lnTo>
                  <a:lnTo>
                    <a:pt x="221" y="1009"/>
                  </a:lnTo>
                  <a:lnTo>
                    <a:pt x="223" y="1008"/>
                  </a:lnTo>
                  <a:lnTo>
                    <a:pt x="224" y="1008"/>
                  </a:lnTo>
                  <a:lnTo>
                    <a:pt x="225" y="1008"/>
                  </a:lnTo>
                  <a:lnTo>
                    <a:pt x="226" y="1008"/>
                  </a:lnTo>
                  <a:lnTo>
                    <a:pt x="227" y="1007"/>
                  </a:lnTo>
                  <a:lnTo>
                    <a:pt x="228" y="1007"/>
                  </a:lnTo>
                  <a:lnTo>
                    <a:pt x="228" y="1007"/>
                  </a:lnTo>
                  <a:lnTo>
                    <a:pt x="229" y="1007"/>
                  </a:lnTo>
                  <a:lnTo>
                    <a:pt x="231" y="1007"/>
                  </a:lnTo>
                  <a:lnTo>
                    <a:pt x="232" y="1007"/>
                  </a:lnTo>
                  <a:lnTo>
                    <a:pt x="233" y="1007"/>
                  </a:lnTo>
                  <a:lnTo>
                    <a:pt x="235" y="1007"/>
                  </a:lnTo>
                  <a:lnTo>
                    <a:pt x="237" y="1007"/>
                  </a:lnTo>
                  <a:lnTo>
                    <a:pt x="239" y="1007"/>
                  </a:lnTo>
                  <a:lnTo>
                    <a:pt x="241" y="1008"/>
                  </a:lnTo>
                  <a:lnTo>
                    <a:pt x="242" y="1008"/>
                  </a:lnTo>
                  <a:lnTo>
                    <a:pt x="243" y="1008"/>
                  </a:lnTo>
                  <a:lnTo>
                    <a:pt x="245" y="1007"/>
                  </a:lnTo>
                  <a:lnTo>
                    <a:pt x="247" y="1007"/>
                  </a:lnTo>
                  <a:lnTo>
                    <a:pt x="248" y="1007"/>
                  </a:lnTo>
                  <a:lnTo>
                    <a:pt x="251" y="1007"/>
                  </a:lnTo>
                  <a:lnTo>
                    <a:pt x="253" y="1007"/>
                  </a:lnTo>
                  <a:lnTo>
                    <a:pt x="255" y="1007"/>
                  </a:lnTo>
                  <a:lnTo>
                    <a:pt x="257" y="1006"/>
                  </a:lnTo>
                  <a:lnTo>
                    <a:pt x="260" y="1006"/>
                  </a:lnTo>
                  <a:lnTo>
                    <a:pt x="262" y="1006"/>
                  </a:lnTo>
                  <a:lnTo>
                    <a:pt x="263" y="1006"/>
                  </a:lnTo>
                  <a:lnTo>
                    <a:pt x="264" y="1006"/>
                  </a:lnTo>
                  <a:lnTo>
                    <a:pt x="265" y="1006"/>
                  </a:lnTo>
                  <a:lnTo>
                    <a:pt x="266" y="1006"/>
                  </a:lnTo>
                  <a:lnTo>
                    <a:pt x="266" y="1006"/>
                  </a:lnTo>
                  <a:lnTo>
                    <a:pt x="267" y="1006"/>
                  </a:lnTo>
                  <a:lnTo>
                    <a:pt x="268" y="1006"/>
                  </a:lnTo>
                  <a:lnTo>
                    <a:pt x="269" y="1006"/>
                  </a:lnTo>
                  <a:lnTo>
                    <a:pt x="270" y="1006"/>
                  </a:lnTo>
                  <a:lnTo>
                    <a:pt x="272" y="1006"/>
                  </a:lnTo>
                  <a:lnTo>
                    <a:pt x="273" y="1006"/>
                  </a:lnTo>
                  <a:lnTo>
                    <a:pt x="274" y="1006"/>
                  </a:lnTo>
                  <a:lnTo>
                    <a:pt x="275" y="1005"/>
                  </a:lnTo>
                  <a:lnTo>
                    <a:pt x="276" y="1005"/>
                  </a:lnTo>
                  <a:lnTo>
                    <a:pt x="277" y="1004"/>
                  </a:lnTo>
                  <a:lnTo>
                    <a:pt x="279" y="1004"/>
                  </a:lnTo>
                  <a:lnTo>
                    <a:pt x="280" y="1003"/>
                  </a:lnTo>
                  <a:lnTo>
                    <a:pt x="282" y="1003"/>
                  </a:lnTo>
                  <a:lnTo>
                    <a:pt x="283" y="1002"/>
                  </a:lnTo>
                  <a:lnTo>
                    <a:pt x="284" y="1002"/>
                  </a:lnTo>
                  <a:lnTo>
                    <a:pt x="285" y="1002"/>
                  </a:lnTo>
                  <a:lnTo>
                    <a:pt x="285" y="1002"/>
                  </a:lnTo>
                  <a:lnTo>
                    <a:pt x="286" y="1002"/>
                  </a:lnTo>
                  <a:lnTo>
                    <a:pt x="287" y="1001"/>
                  </a:lnTo>
                  <a:lnTo>
                    <a:pt x="288" y="1001"/>
                  </a:lnTo>
                  <a:lnTo>
                    <a:pt x="289" y="1001"/>
                  </a:lnTo>
                  <a:lnTo>
                    <a:pt x="290" y="1002"/>
                  </a:lnTo>
                  <a:lnTo>
                    <a:pt x="290" y="1002"/>
                  </a:lnTo>
                  <a:lnTo>
                    <a:pt x="291" y="1002"/>
                  </a:lnTo>
                  <a:lnTo>
                    <a:pt x="291" y="1002"/>
                  </a:lnTo>
                  <a:lnTo>
                    <a:pt x="292" y="1002"/>
                  </a:lnTo>
                  <a:lnTo>
                    <a:pt x="293" y="1002"/>
                  </a:lnTo>
                  <a:lnTo>
                    <a:pt x="294" y="1002"/>
                  </a:lnTo>
                  <a:lnTo>
                    <a:pt x="295" y="1003"/>
                  </a:lnTo>
                  <a:lnTo>
                    <a:pt x="297" y="1003"/>
                  </a:lnTo>
                  <a:lnTo>
                    <a:pt x="298" y="1004"/>
                  </a:lnTo>
                  <a:lnTo>
                    <a:pt x="300" y="1004"/>
                  </a:lnTo>
                  <a:lnTo>
                    <a:pt x="301" y="1004"/>
                  </a:lnTo>
                  <a:lnTo>
                    <a:pt x="302" y="1004"/>
                  </a:lnTo>
                  <a:lnTo>
                    <a:pt x="303" y="1005"/>
                  </a:lnTo>
                  <a:lnTo>
                    <a:pt x="304" y="1005"/>
                  </a:lnTo>
                  <a:lnTo>
                    <a:pt x="306" y="1005"/>
                  </a:lnTo>
                  <a:lnTo>
                    <a:pt x="307" y="1005"/>
                  </a:lnTo>
                  <a:lnTo>
                    <a:pt x="309" y="1005"/>
                  </a:lnTo>
                  <a:lnTo>
                    <a:pt x="311" y="1005"/>
                  </a:lnTo>
                  <a:lnTo>
                    <a:pt x="312" y="1005"/>
                  </a:lnTo>
                  <a:lnTo>
                    <a:pt x="314" y="1005"/>
                  </a:lnTo>
                  <a:lnTo>
                    <a:pt x="315" y="1005"/>
                  </a:lnTo>
                  <a:lnTo>
                    <a:pt x="316" y="1005"/>
                  </a:lnTo>
                  <a:lnTo>
                    <a:pt x="317" y="1006"/>
                  </a:lnTo>
                  <a:lnTo>
                    <a:pt x="318" y="1006"/>
                  </a:lnTo>
                  <a:lnTo>
                    <a:pt x="318" y="1006"/>
                  </a:lnTo>
                  <a:lnTo>
                    <a:pt x="319" y="1006"/>
                  </a:lnTo>
                  <a:lnTo>
                    <a:pt x="320" y="1006"/>
                  </a:lnTo>
                  <a:lnTo>
                    <a:pt x="321" y="1006"/>
                  </a:lnTo>
                  <a:lnTo>
                    <a:pt x="322" y="1007"/>
                  </a:lnTo>
                  <a:lnTo>
                    <a:pt x="323" y="1007"/>
                  </a:lnTo>
                  <a:lnTo>
                    <a:pt x="325" y="1008"/>
                  </a:lnTo>
                  <a:lnTo>
                    <a:pt x="326" y="1008"/>
                  </a:lnTo>
                  <a:lnTo>
                    <a:pt x="327" y="1008"/>
                  </a:lnTo>
                  <a:lnTo>
                    <a:pt x="328" y="1009"/>
                  </a:lnTo>
                  <a:lnTo>
                    <a:pt x="329" y="1009"/>
                  </a:lnTo>
                  <a:lnTo>
                    <a:pt x="330" y="1009"/>
                  </a:lnTo>
                  <a:lnTo>
                    <a:pt x="331" y="1009"/>
                  </a:lnTo>
                  <a:lnTo>
                    <a:pt x="332" y="1009"/>
                  </a:lnTo>
                  <a:lnTo>
                    <a:pt x="333" y="1009"/>
                  </a:lnTo>
                  <a:lnTo>
                    <a:pt x="333" y="1009"/>
                  </a:lnTo>
                  <a:lnTo>
                    <a:pt x="334" y="1009"/>
                  </a:lnTo>
                  <a:lnTo>
                    <a:pt x="335" y="1009"/>
                  </a:lnTo>
                  <a:lnTo>
                    <a:pt x="336" y="1009"/>
                  </a:lnTo>
                  <a:lnTo>
                    <a:pt x="336" y="1009"/>
                  </a:lnTo>
                  <a:lnTo>
                    <a:pt x="337" y="1009"/>
                  </a:lnTo>
                  <a:lnTo>
                    <a:pt x="338" y="1009"/>
                  </a:lnTo>
                  <a:lnTo>
                    <a:pt x="338" y="1009"/>
                  </a:lnTo>
                  <a:lnTo>
                    <a:pt x="339" y="1008"/>
                  </a:lnTo>
                  <a:lnTo>
                    <a:pt x="340" y="1008"/>
                  </a:lnTo>
                  <a:lnTo>
                    <a:pt x="341" y="1008"/>
                  </a:lnTo>
                  <a:lnTo>
                    <a:pt x="342" y="1007"/>
                  </a:lnTo>
                  <a:lnTo>
                    <a:pt x="342" y="1007"/>
                  </a:lnTo>
                  <a:lnTo>
                    <a:pt x="343" y="1007"/>
                  </a:lnTo>
                  <a:lnTo>
                    <a:pt x="344" y="1006"/>
                  </a:lnTo>
                  <a:lnTo>
                    <a:pt x="344" y="1006"/>
                  </a:lnTo>
                  <a:lnTo>
                    <a:pt x="345" y="1006"/>
                  </a:lnTo>
                  <a:lnTo>
                    <a:pt x="345" y="1005"/>
                  </a:lnTo>
                  <a:lnTo>
                    <a:pt x="345" y="1005"/>
                  </a:lnTo>
                  <a:lnTo>
                    <a:pt x="346" y="1005"/>
                  </a:lnTo>
                  <a:lnTo>
                    <a:pt x="346" y="1005"/>
                  </a:lnTo>
                  <a:lnTo>
                    <a:pt x="346" y="1004"/>
                  </a:lnTo>
                  <a:lnTo>
                    <a:pt x="346" y="1004"/>
                  </a:lnTo>
                  <a:lnTo>
                    <a:pt x="347" y="1004"/>
                  </a:lnTo>
                  <a:lnTo>
                    <a:pt x="347" y="1004"/>
                  </a:lnTo>
                  <a:lnTo>
                    <a:pt x="348" y="1003"/>
                  </a:lnTo>
                  <a:lnTo>
                    <a:pt x="349" y="1002"/>
                  </a:lnTo>
                  <a:lnTo>
                    <a:pt x="350" y="1001"/>
                  </a:lnTo>
                  <a:lnTo>
                    <a:pt x="351" y="1000"/>
                  </a:lnTo>
                  <a:lnTo>
                    <a:pt x="352" y="999"/>
                  </a:lnTo>
                  <a:lnTo>
                    <a:pt x="354" y="998"/>
                  </a:lnTo>
                  <a:lnTo>
                    <a:pt x="356" y="996"/>
                  </a:lnTo>
                  <a:lnTo>
                    <a:pt x="357" y="995"/>
                  </a:lnTo>
                  <a:lnTo>
                    <a:pt x="358" y="993"/>
                  </a:lnTo>
                  <a:lnTo>
                    <a:pt x="359" y="992"/>
                  </a:lnTo>
                  <a:lnTo>
                    <a:pt x="361" y="991"/>
                  </a:lnTo>
                  <a:lnTo>
                    <a:pt x="362" y="989"/>
                  </a:lnTo>
                  <a:lnTo>
                    <a:pt x="363" y="988"/>
                  </a:lnTo>
                  <a:lnTo>
                    <a:pt x="364" y="987"/>
                  </a:lnTo>
                  <a:lnTo>
                    <a:pt x="365" y="985"/>
                  </a:lnTo>
                  <a:lnTo>
                    <a:pt x="365" y="984"/>
                  </a:lnTo>
                  <a:lnTo>
                    <a:pt x="366" y="983"/>
                  </a:lnTo>
                  <a:lnTo>
                    <a:pt x="367" y="981"/>
                  </a:lnTo>
                  <a:lnTo>
                    <a:pt x="368" y="979"/>
                  </a:lnTo>
                  <a:lnTo>
                    <a:pt x="369" y="978"/>
                  </a:lnTo>
                  <a:lnTo>
                    <a:pt x="370" y="976"/>
                  </a:lnTo>
                  <a:lnTo>
                    <a:pt x="370" y="976"/>
                  </a:lnTo>
                  <a:lnTo>
                    <a:pt x="370" y="975"/>
                  </a:lnTo>
                  <a:lnTo>
                    <a:pt x="371" y="974"/>
                  </a:lnTo>
                  <a:lnTo>
                    <a:pt x="371" y="974"/>
                  </a:lnTo>
                  <a:lnTo>
                    <a:pt x="371" y="973"/>
                  </a:lnTo>
                  <a:lnTo>
                    <a:pt x="372" y="973"/>
                  </a:lnTo>
                  <a:lnTo>
                    <a:pt x="372" y="972"/>
                  </a:lnTo>
                  <a:lnTo>
                    <a:pt x="372" y="972"/>
                  </a:lnTo>
                  <a:lnTo>
                    <a:pt x="372" y="971"/>
                  </a:lnTo>
                  <a:lnTo>
                    <a:pt x="372" y="971"/>
                  </a:lnTo>
                  <a:lnTo>
                    <a:pt x="373" y="971"/>
                  </a:lnTo>
                  <a:lnTo>
                    <a:pt x="373" y="970"/>
                  </a:lnTo>
                  <a:lnTo>
                    <a:pt x="373" y="969"/>
                  </a:lnTo>
                  <a:lnTo>
                    <a:pt x="374" y="966"/>
                  </a:lnTo>
                  <a:lnTo>
                    <a:pt x="376" y="963"/>
                  </a:lnTo>
                  <a:lnTo>
                    <a:pt x="377" y="961"/>
                  </a:lnTo>
                  <a:lnTo>
                    <a:pt x="378" y="959"/>
                  </a:lnTo>
                  <a:lnTo>
                    <a:pt x="378" y="957"/>
                  </a:lnTo>
                  <a:lnTo>
                    <a:pt x="379" y="956"/>
                  </a:lnTo>
                  <a:lnTo>
                    <a:pt x="380" y="954"/>
                  </a:lnTo>
                  <a:lnTo>
                    <a:pt x="380" y="952"/>
                  </a:lnTo>
                  <a:lnTo>
                    <a:pt x="381" y="951"/>
                  </a:lnTo>
                  <a:lnTo>
                    <a:pt x="381" y="949"/>
                  </a:lnTo>
                  <a:lnTo>
                    <a:pt x="382" y="948"/>
                  </a:lnTo>
                  <a:lnTo>
                    <a:pt x="382" y="947"/>
                  </a:lnTo>
                  <a:lnTo>
                    <a:pt x="383" y="945"/>
                  </a:lnTo>
                  <a:lnTo>
                    <a:pt x="383" y="944"/>
                  </a:lnTo>
                  <a:lnTo>
                    <a:pt x="384" y="942"/>
                  </a:lnTo>
                  <a:lnTo>
                    <a:pt x="384" y="941"/>
                  </a:lnTo>
                  <a:lnTo>
                    <a:pt x="384" y="939"/>
                  </a:lnTo>
                  <a:lnTo>
                    <a:pt x="385" y="938"/>
                  </a:lnTo>
                  <a:lnTo>
                    <a:pt x="385" y="936"/>
                  </a:lnTo>
                  <a:lnTo>
                    <a:pt x="386" y="934"/>
                  </a:lnTo>
                  <a:lnTo>
                    <a:pt x="386" y="931"/>
                  </a:lnTo>
                  <a:lnTo>
                    <a:pt x="387" y="929"/>
                  </a:lnTo>
                  <a:lnTo>
                    <a:pt x="387" y="927"/>
                  </a:lnTo>
                  <a:lnTo>
                    <a:pt x="387" y="924"/>
                  </a:lnTo>
                  <a:lnTo>
                    <a:pt x="388" y="922"/>
                  </a:lnTo>
                  <a:lnTo>
                    <a:pt x="388" y="919"/>
                  </a:lnTo>
                  <a:lnTo>
                    <a:pt x="389" y="917"/>
                  </a:lnTo>
                  <a:lnTo>
                    <a:pt x="389" y="914"/>
                  </a:lnTo>
                  <a:lnTo>
                    <a:pt x="390" y="911"/>
                  </a:lnTo>
                  <a:lnTo>
                    <a:pt x="390" y="908"/>
                  </a:lnTo>
                  <a:lnTo>
                    <a:pt x="390" y="906"/>
                  </a:lnTo>
                  <a:lnTo>
                    <a:pt x="391" y="903"/>
                  </a:lnTo>
                  <a:lnTo>
                    <a:pt x="391" y="900"/>
                  </a:lnTo>
                  <a:lnTo>
                    <a:pt x="391" y="896"/>
                  </a:lnTo>
                  <a:lnTo>
                    <a:pt x="392" y="893"/>
                  </a:lnTo>
                  <a:lnTo>
                    <a:pt x="392" y="890"/>
                  </a:lnTo>
                  <a:lnTo>
                    <a:pt x="393" y="886"/>
                  </a:lnTo>
                  <a:lnTo>
                    <a:pt x="393" y="883"/>
                  </a:lnTo>
                  <a:lnTo>
                    <a:pt x="393" y="879"/>
                  </a:lnTo>
                  <a:lnTo>
                    <a:pt x="393" y="875"/>
                  </a:lnTo>
                  <a:lnTo>
                    <a:pt x="394" y="871"/>
                  </a:lnTo>
                  <a:lnTo>
                    <a:pt x="394" y="868"/>
                  </a:lnTo>
                  <a:lnTo>
                    <a:pt x="394" y="863"/>
                  </a:lnTo>
                  <a:lnTo>
                    <a:pt x="395" y="859"/>
                  </a:lnTo>
                  <a:lnTo>
                    <a:pt x="395" y="855"/>
                  </a:lnTo>
                  <a:lnTo>
                    <a:pt x="396" y="850"/>
                  </a:lnTo>
                  <a:lnTo>
                    <a:pt x="396" y="846"/>
                  </a:lnTo>
                  <a:lnTo>
                    <a:pt x="396" y="841"/>
                  </a:lnTo>
                  <a:lnTo>
                    <a:pt x="396" y="837"/>
                  </a:lnTo>
                  <a:lnTo>
                    <a:pt x="397" y="835"/>
                  </a:lnTo>
                  <a:lnTo>
                    <a:pt x="397" y="833"/>
                  </a:lnTo>
                  <a:lnTo>
                    <a:pt x="397" y="832"/>
                  </a:lnTo>
                  <a:lnTo>
                    <a:pt x="397" y="830"/>
                  </a:lnTo>
                  <a:lnTo>
                    <a:pt x="397" y="828"/>
                  </a:lnTo>
                  <a:lnTo>
                    <a:pt x="397" y="827"/>
                  </a:lnTo>
                  <a:lnTo>
                    <a:pt x="397" y="825"/>
                  </a:lnTo>
                  <a:lnTo>
                    <a:pt x="397" y="824"/>
                  </a:lnTo>
                  <a:lnTo>
                    <a:pt x="398" y="823"/>
                  </a:lnTo>
                  <a:lnTo>
                    <a:pt x="398" y="821"/>
                  </a:lnTo>
                  <a:lnTo>
                    <a:pt x="398" y="820"/>
                  </a:lnTo>
                  <a:lnTo>
                    <a:pt x="398" y="819"/>
                  </a:lnTo>
                  <a:lnTo>
                    <a:pt x="398" y="818"/>
                  </a:lnTo>
                  <a:lnTo>
                    <a:pt x="398" y="817"/>
                  </a:lnTo>
                  <a:lnTo>
                    <a:pt x="398" y="815"/>
                  </a:lnTo>
                  <a:lnTo>
                    <a:pt x="398" y="814"/>
                  </a:lnTo>
                  <a:lnTo>
                    <a:pt x="398" y="812"/>
                  </a:lnTo>
                  <a:lnTo>
                    <a:pt x="398" y="811"/>
                  </a:lnTo>
                  <a:lnTo>
                    <a:pt x="398" y="810"/>
                  </a:lnTo>
                  <a:lnTo>
                    <a:pt x="398" y="809"/>
                  </a:lnTo>
                  <a:lnTo>
                    <a:pt x="398" y="807"/>
                  </a:lnTo>
                  <a:lnTo>
                    <a:pt x="399" y="807"/>
                  </a:lnTo>
                  <a:lnTo>
                    <a:pt x="399" y="802"/>
                  </a:lnTo>
                  <a:lnTo>
                    <a:pt x="399" y="794"/>
                  </a:lnTo>
                  <a:lnTo>
                    <a:pt x="400" y="785"/>
                  </a:lnTo>
                  <a:lnTo>
                    <a:pt x="400" y="775"/>
                  </a:lnTo>
                  <a:lnTo>
                    <a:pt x="401" y="765"/>
                  </a:lnTo>
                  <a:lnTo>
                    <a:pt x="401" y="756"/>
                  </a:lnTo>
                  <a:lnTo>
                    <a:pt x="402" y="745"/>
                  </a:lnTo>
                  <a:lnTo>
                    <a:pt x="402" y="735"/>
                  </a:lnTo>
                  <a:lnTo>
                    <a:pt x="403" y="724"/>
                  </a:lnTo>
                  <a:lnTo>
                    <a:pt x="403" y="712"/>
                  </a:lnTo>
                  <a:lnTo>
                    <a:pt x="404" y="700"/>
                  </a:lnTo>
                  <a:lnTo>
                    <a:pt x="405" y="689"/>
                  </a:lnTo>
                  <a:lnTo>
                    <a:pt x="405" y="677"/>
                  </a:lnTo>
                  <a:lnTo>
                    <a:pt x="406" y="665"/>
                  </a:lnTo>
                  <a:lnTo>
                    <a:pt x="406" y="653"/>
                  </a:lnTo>
                  <a:lnTo>
                    <a:pt x="407" y="641"/>
                  </a:lnTo>
                  <a:lnTo>
                    <a:pt x="407" y="629"/>
                  </a:lnTo>
                  <a:lnTo>
                    <a:pt x="408" y="617"/>
                  </a:lnTo>
                  <a:lnTo>
                    <a:pt x="408" y="606"/>
                  </a:lnTo>
                  <a:lnTo>
                    <a:pt x="409" y="594"/>
                  </a:lnTo>
                  <a:lnTo>
                    <a:pt x="409" y="583"/>
                  </a:lnTo>
                  <a:lnTo>
                    <a:pt x="409" y="572"/>
                  </a:lnTo>
                  <a:lnTo>
                    <a:pt x="410" y="561"/>
                  </a:lnTo>
                  <a:lnTo>
                    <a:pt x="410" y="550"/>
                  </a:lnTo>
                  <a:lnTo>
                    <a:pt x="411" y="539"/>
                  </a:lnTo>
                  <a:lnTo>
                    <a:pt x="411" y="528"/>
                  </a:lnTo>
                  <a:lnTo>
                    <a:pt x="411" y="517"/>
                  </a:lnTo>
                  <a:lnTo>
                    <a:pt x="412" y="506"/>
                  </a:lnTo>
                  <a:lnTo>
                    <a:pt x="412" y="495"/>
                  </a:lnTo>
                  <a:lnTo>
                    <a:pt x="412" y="484"/>
                  </a:lnTo>
                  <a:lnTo>
                    <a:pt x="413" y="473"/>
                  </a:lnTo>
                  <a:lnTo>
                    <a:pt x="413" y="462"/>
                  </a:lnTo>
                  <a:lnTo>
                    <a:pt x="413" y="450"/>
                  </a:lnTo>
                  <a:lnTo>
                    <a:pt x="414" y="438"/>
                  </a:lnTo>
                  <a:lnTo>
                    <a:pt x="414" y="426"/>
                  </a:lnTo>
                  <a:lnTo>
                    <a:pt x="414" y="413"/>
                  </a:lnTo>
                  <a:lnTo>
                    <a:pt x="415" y="400"/>
                  </a:lnTo>
                  <a:lnTo>
                    <a:pt x="415" y="386"/>
                  </a:lnTo>
                  <a:lnTo>
                    <a:pt x="415" y="372"/>
                  </a:lnTo>
                  <a:lnTo>
                    <a:pt x="416" y="357"/>
                  </a:lnTo>
                  <a:lnTo>
                    <a:pt x="416" y="340"/>
                  </a:lnTo>
                  <a:lnTo>
                    <a:pt x="417" y="323"/>
                  </a:lnTo>
                  <a:lnTo>
                    <a:pt x="417" y="302"/>
                  </a:lnTo>
                  <a:lnTo>
                    <a:pt x="418" y="271"/>
                  </a:lnTo>
                  <a:lnTo>
                    <a:pt x="419" y="242"/>
                  </a:lnTo>
                  <a:lnTo>
                    <a:pt x="419" y="222"/>
                  </a:lnTo>
                  <a:lnTo>
                    <a:pt x="420" y="204"/>
                  </a:lnTo>
                  <a:lnTo>
                    <a:pt x="420" y="189"/>
                  </a:lnTo>
                  <a:lnTo>
                    <a:pt x="420" y="176"/>
                  </a:lnTo>
                  <a:lnTo>
                    <a:pt x="421" y="163"/>
                  </a:lnTo>
                  <a:lnTo>
                    <a:pt x="421" y="151"/>
                  </a:lnTo>
                  <a:lnTo>
                    <a:pt x="421" y="141"/>
                  </a:lnTo>
                  <a:lnTo>
                    <a:pt x="421" y="130"/>
                  </a:lnTo>
                  <a:lnTo>
                    <a:pt x="422" y="121"/>
                  </a:lnTo>
                  <a:lnTo>
                    <a:pt x="422" y="112"/>
                  </a:lnTo>
                  <a:lnTo>
                    <a:pt x="422" y="103"/>
                  </a:lnTo>
                  <a:lnTo>
                    <a:pt x="422" y="96"/>
                  </a:lnTo>
                  <a:lnTo>
                    <a:pt x="423" y="88"/>
                  </a:lnTo>
                  <a:lnTo>
                    <a:pt x="423" y="81"/>
                  </a:lnTo>
                  <a:lnTo>
                    <a:pt x="423" y="73"/>
                  </a:lnTo>
                  <a:lnTo>
                    <a:pt x="423" y="68"/>
                  </a:lnTo>
                  <a:lnTo>
                    <a:pt x="423" y="63"/>
                  </a:lnTo>
                  <a:lnTo>
                    <a:pt x="424" y="59"/>
                  </a:lnTo>
                  <a:lnTo>
                    <a:pt x="424" y="55"/>
                  </a:lnTo>
                  <a:lnTo>
                    <a:pt x="424" y="52"/>
                  </a:lnTo>
                  <a:lnTo>
                    <a:pt x="424" y="49"/>
                  </a:lnTo>
                  <a:lnTo>
                    <a:pt x="424" y="45"/>
                  </a:lnTo>
                  <a:lnTo>
                    <a:pt x="424" y="43"/>
                  </a:lnTo>
                  <a:lnTo>
                    <a:pt x="424" y="40"/>
                  </a:lnTo>
                  <a:lnTo>
                    <a:pt x="425" y="36"/>
                  </a:lnTo>
                  <a:lnTo>
                    <a:pt x="425" y="32"/>
                  </a:lnTo>
                  <a:lnTo>
                    <a:pt x="425" y="28"/>
                  </a:lnTo>
                  <a:lnTo>
                    <a:pt x="425" y="25"/>
                  </a:lnTo>
                  <a:lnTo>
                    <a:pt x="425" y="22"/>
                  </a:lnTo>
                  <a:lnTo>
                    <a:pt x="426" y="19"/>
                  </a:lnTo>
                  <a:lnTo>
                    <a:pt x="426" y="16"/>
                  </a:lnTo>
                  <a:lnTo>
                    <a:pt x="426" y="13"/>
                  </a:lnTo>
                  <a:lnTo>
                    <a:pt x="426" y="11"/>
                  </a:lnTo>
                  <a:lnTo>
                    <a:pt x="426" y="9"/>
                  </a:lnTo>
                  <a:lnTo>
                    <a:pt x="427" y="7"/>
                  </a:lnTo>
                  <a:lnTo>
                    <a:pt x="427" y="5"/>
                  </a:lnTo>
                  <a:lnTo>
                    <a:pt x="427" y="4"/>
                  </a:lnTo>
                  <a:lnTo>
                    <a:pt x="427" y="3"/>
                  </a:lnTo>
                  <a:lnTo>
                    <a:pt x="427" y="2"/>
                  </a:lnTo>
                  <a:lnTo>
                    <a:pt x="427" y="1"/>
                  </a:lnTo>
                  <a:lnTo>
                    <a:pt x="428" y="0"/>
                  </a:lnTo>
                  <a:lnTo>
                    <a:pt x="428" y="0"/>
                  </a:lnTo>
                  <a:lnTo>
                    <a:pt x="428" y="0"/>
                  </a:lnTo>
                  <a:lnTo>
                    <a:pt x="428" y="0"/>
                  </a:lnTo>
                  <a:lnTo>
                    <a:pt x="428" y="1"/>
                  </a:lnTo>
                  <a:lnTo>
                    <a:pt x="428" y="1"/>
                  </a:lnTo>
                  <a:lnTo>
                    <a:pt x="429" y="2"/>
                  </a:lnTo>
                  <a:lnTo>
                    <a:pt x="429" y="3"/>
                  </a:lnTo>
                  <a:lnTo>
                    <a:pt x="429" y="5"/>
                  </a:lnTo>
                  <a:lnTo>
                    <a:pt x="429" y="6"/>
                  </a:lnTo>
                  <a:lnTo>
                    <a:pt x="429" y="8"/>
                  </a:lnTo>
                  <a:lnTo>
                    <a:pt x="430" y="10"/>
                  </a:lnTo>
                  <a:lnTo>
                    <a:pt x="430" y="12"/>
                  </a:lnTo>
                  <a:lnTo>
                    <a:pt x="430" y="15"/>
                  </a:lnTo>
                  <a:lnTo>
                    <a:pt x="430" y="17"/>
                  </a:lnTo>
                  <a:lnTo>
                    <a:pt x="430" y="20"/>
                  </a:lnTo>
                  <a:lnTo>
                    <a:pt x="430" y="23"/>
                  </a:lnTo>
                  <a:lnTo>
                    <a:pt x="431" y="27"/>
                  </a:lnTo>
                  <a:lnTo>
                    <a:pt x="431" y="30"/>
                  </a:lnTo>
                  <a:lnTo>
                    <a:pt x="431" y="34"/>
                  </a:lnTo>
                  <a:lnTo>
                    <a:pt x="431" y="38"/>
                  </a:lnTo>
                  <a:lnTo>
                    <a:pt x="431" y="42"/>
                  </a:lnTo>
                  <a:lnTo>
                    <a:pt x="432" y="47"/>
                  </a:lnTo>
                  <a:lnTo>
                    <a:pt x="432" y="52"/>
                  </a:lnTo>
                  <a:lnTo>
                    <a:pt x="432" y="57"/>
                  </a:lnTo>
                  <a:lnTo>
                    <a:pt x="432" y="62"/>
                  </a:lnTo>
                  <a:lnTo>
                    <a:pt x="432" y="67"/>
                  </a:lnTo>
                  <a:lnTo>
                    <a:pt x="433" y="73"/>
                  </a:lnTo>
                  <a:lnTo>
                    <a:pt x="433" y="79"/>
                  </a:lnTo>
                  <a:lnTo>
                    <a:pt x="433" y="86"/>
                  </a:lnTo>
                  <a:lnTo>
                    <a:pt x="433" y="93"/>
                  </a:lnTo>
                  <a:lnTo>
                    <a:pt x="433" y="101"/>
                  </a:lnTo>
                  <a:lnTo>
                    <a:pt x="434" y="108"/>
                  </a:lnTo>
                  <a:lnTo>
                    <a:pt x="434" y="116"/>
                  </a:lnTo>
                  <a:lnTo>
                    <a:pt x="434" y="124"/>
                  </a:lnTo>
                  <a:lnTo>
                    <a:pt x="434" y="133"/>
                  </a:lnTo>
                  <a:lnTo>
                    <a:pt x="434" y="142"/>
                  </a:lnTo>
                  <a:lnTo>
                    <a:pt x="435" y="152"/>
                  </a:lnTo>
                  <a:lnTo>
                    <a:pt x="435" y="162"/>
                  </a:lnTo>
                  <a:lnTo>
                    <a:pt x="435" y="173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" name="Freeform 153"/>
            <p:cNvSpPr>
              <a:spLocks/>
            </p:cNvSpPr>
            <p:nvPr/>
          </p:nvSpPr>
          <p:spPr bwMode="auto">
            <a:xfrm>
              <a:off x="3482599" y="3827464"/>
              <a:ext cx="475095" cy="1169488"/>
            </a:xfrm>
            <a:custGeom>
              <a:avLst/>
              <a:gdLst>
                <a:gd name="T0" fmla="*/ 2 w 383"/>
                <a:gd name="T1" fmla="*/ 95 h 891"/>
                <a:gd name="T2" fmla="*/ 6 w 383"/>
                <a:gd name="T3" fmla="*/ 294 h 891"/>
                <a:gd name="T4" fmla="*/ 8 w 383"/>
                <a:gd name="T5" fmla="*/ 409 h 891"/>
                <a:gd name="T6" fmla="*/ 10 w 383"/>
                <a:gd name="T7" fmla="*/ 492 h 891"/>
                <a:gd name="T8" fmla="*/ 12 w 383"/>
                <a:gd name="T9" fmla="*/ 555 h 891"/>
                <a:gd name="T10" fmla="*/ 14 w 383"/>
                <a:gd name="T11" fmla="*/ 607 h 891"/>
                <a:gd name="T12" fmla="*/ 16 w 383"/>
                <a:gd name="T13" fmla="*/ 641 h 891"/>
                <a:gd name="T14" fmla="*/ 17 w 383"/>
                <a:gd name="T15" fmla="*/ 649 h 891"/>
                <a:gd name="T16" fmla="*/ 18 w 383"/>
                <a:gd name="T17" fmla="*/ 669 h 891"/>
                <a:gd name="T18" fmla="*/ 21 w 383"/>
                <a:gd name="T19" fmla="*/ 691 h 891"/>
                <a:gd name="T20" fmla="*/ 24 w 383"/>
                <a:gd name="T21" fmla="*/ 710 h 891"/>
                <a:gd name="T22" fmla="*/ 28 w 383"/>
                <a:gd name="T23" fmla="*/ 727 h 891"/>
                <a:gd name="T24" fmla="*/ 32 w 383"/>
                <a:gd name="T25" fmla="*/ 738 h 891"/>
                <a:gd name="T26" fmla="*/ 39 w 383"/>
                <a:gd name="T27" fmla="*/ 744 h 891"/>
                <a:gd name="T28" fmla="*/ 50 w 383"/>
                <a:gd name="T29" fmla="*/ 745 h 891"/>
                <a:gd name="T30" fmla="*/ 63 w 383"/>
                <a:gd name="T31" fmla="*/ 740 h 891"/>
                <a:gd name="T32" fmla="*/ 71 w 383"/>
                <a:gd name="T33" fmla="*/ 733 h 891"/>
                <a:gd name="T34" fmla="*/ 75 w 383"/>
                <a:gd name="T35" fmla="*/ 735 h 891"/>
                <a:gd name="T36" fmla="*/ 81 w 383"/>
                <a:gd name="T37" fmla="*/ 746 h 891"/>
                <a:gd name="T38" fmla="*/ 95 w 383"/>
                <a:gd name="T39" fmla="*/ 778 h 891"/>
                <a:gd name="T40" fmla="*/ 99 w 383"/>
                <a:gd name="T41" fmla="*/ 786 h 891"/>
                <a:gd name="T42" fmla="*/ 107 w 383"/>
                <a:gd name="T43" fmla="*/ 799 h 891"/>
                <a:gd name="T44" fmla="*/ 113 w 383"/>
                <a:gd name="T45" fmla="*/ 806 h 891"/>
                <a:gd name="T46" fmla="*/ 119 w 383"/>
                <a:gd name="T47" fmla="*/ 808 h 891"/>
                <a:gd name="T48" fmla="*/ 127 w 383"/>
                <a:gd name="T49" fmla="*/ 806 h 891"/>
                <a:gd name="T50" fmla="*/ 140 w 383"/>
                <a:gd name="T51" fmla="*/ 803 h 891"/>
                <a:gd name="T52" fmla="*/ 152 w 383"/>
                <a:gd name="T53" fmla="*/ 797 h 891"/>
                <a:gd name="T54" fmla="*/ 161 w 383"/>
                <a:gd name="T55" fmla="*/ 798 h 891"/>
                <a:gd name="T56" fmla="*/ 169 w 383"/>
                <a:gd name="T57" fmla="*/ 802 h 891"/>
                <a:gd name="T58" fmla="*/ 176 w 383"/>
                <a:gd name="T59" fmla="*/ 810 h 891"/>
                <a:gd name="T60" fmla="*/ 180 w 383"/>
                <a:gd name="T61" fmla="*/ 815 h 891"/>
                <a:gd name="T62" fmla="*/ 193 w 383"/>
                <a:gd name="T63" fmla="*/ 835 h 891"/>
                <a:gd name="T64" fmla="*/ 203 w 383"/>
                <a:gd name="T65" fmla="*/ 849 h 891"/>
                <a:gd name="T66" fmla="*/ 206 w 383"/>
                <a:gd name="T67" fmla="*/ 853 h 891"/>
                <a:gd name="T68" fmla="*/ 212 w 383"/>
                <a:gd name="T69" fmla="*/ 859 h 891"/>
                <a:gd name="T70" fmla="*/ 218 w 383"/>
                <a:gd name="T71" fmla="*/ 863 h 891"/>
                <a:gd name="T72" fmla="*/ 224 w 383"/>
                <a:gd name="T73" fmla="*/ 867 h 891"/>
                <a:gd name="T74" fmla="*/ 230 w 383"/>
                <a:gd name="T75" fmla="*/ 869 h 891"/>
                <a:gd name="T76" fmla="*/ 236 w 383"/>
                <a:gd name="T77" fmla="*/ 871 h 891"/>
                <a:gd name="T78" fmla="*/ 247 w 383"/>
                <a:gd name="T79" fmla="*/ 873 h 891"/>
                <a:gd name="T80" fmla="*/ 255 w 383"/>
                <a:gd name="T81" fmla="*/ 875 h 891"/>
                <a:gd name="T82" fmla="*/ 261 w 383"/>
                <a:gd name="T83" fmla="*/ 876 h 891"/>
                <a:gd name="T84" fmla="*/ 268 w 383"/>
                <a:gd name="T85" fmla="*/ 876 h 891"/>
                <a:gd name="T86" fmla="*/ 279 w 383"/>
                <a:gd name="T87" fmla="*/ 876 h 891"/>
                <a:gd name="T88" fmla="*/ 290 w 383"/>
                <a:gd name="T89" fmla="*/ 876 h 891"/>
                <a:gd name="T90" fmla="*/ 297 w 383"/>
                <a:gd name="T91" fmla="*/ 876 h 891"/>
                <a:gd name="T92" fmla="*/ 304 w 383"/>
                <a:gd name="T93" fmla="*/ 876 h 891"/>
                <a:gd name="T94" fmla="*/ 312 w 383"/>
                <a:gd name="T95" fmla="*/ 877 h 891"/>
                <a:gd name="T96" fmla="*/ 317 w 383"/>
                <a:gd name="T97" fmla="*/ 877 h 891"/>
                <a:gd name="T98" fmla="*/ 322 w 383"/>
                <a:gd name="T99" fmla="*/ 877 h 891"/>
                <a:gd name="T100" fmla="*/ 336 w 383"/>
                <a:gd name="T101" fmla="*/ 876 h 891"/>
                <a:gd name="T102" fmla="*/ 339 w 383"/>
                <a:gd name="T103" fmla="*/ 875 h 891"/>
                <a:gd name="T104" fmla="*/ 341 w 383"/>
                <a:gd name="T105" fmla="*/ 875 h 891"/>
                <a:gd name="T106" fmla="*/ 344 w 383"/>
                <a:gd name="T107" fmla="*/ 876 h 891"/>
                <a:gd name="T108" fmla="*/ 347 w 383"/>
                <a:gd name="T109" fmla="*/ 877 h 891"/>
                <a:gd name="T110" fmla="*/ 350 w 383"/>
                <a:gd name="T111" fmla="*/ 878 h 891"/>
                <a:gd name="T112" fmla="*/ 354 w 383"/>
                <a:gd name="T113" fmla="*/ 880 h 891"/>
                <a:gd name="T114" fmla="*/ 359 w 383"/>
                <a:gd name="T115" fmla="*/ 884 h 891"/>
                <a:gd name="T116" fmla="*/ 362 w 383"/>
                <a:gd name="T117" fmla="*/ 886 h 891"/>
                <a:gd name="T118" fmla="*/ 365 w 383"/>
                <a:gd name="T119" fmla="*/ 887 h 891"/>
                <a:gd name="T120" fmla="*/ 367 w 383"/>
                <a:gd name="T121" fmla="*/ 888 h 891"/>
                <a:gd name="T122" fmla="*/ 372 w 383"/>
                <a:gd name="T123" fmla="*/ 889 h 891"/>
                <a:gd name="T124" fmla="*/ 377 w 383"/>
                <a:gd name="T125" fmla="*/ 890 h 8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383" h="891">
                  <a:moveTo>
                    <a:pt x="0" y="0"/>
                  </a:moveTo>
                  <a:lnTo>
                    <a:pt x="0" y="11"/>
                  </a:lnTo>
                  <a:lnTo>
                    <a:pt x="1" y="23"/>
                  </a:lnTo>
                  <a:lnTo>
                    <a:pt x="1" y="36"/>
                  </a:lnTo>
                  <a:lnTo>
                    <a:pt x="1" y="49"/>
                  </a:lnTo>
                  <a:lnTo>
                    <a:pt x="1" y="63"/>
                  </a:lnTo>
                  <a:lnTo>
                    <a:pt x="2" y="78"/>
                  </a:lnTo>
                  <a:lnTo>
                    <a:pt x="2" y="95"/>
                  </a:lnTo>
                  <a:lnTo>
                    <a:pt x="2" y="113"/>
                  </a:lnTo>
                  <a:lnTo>
                    <a:pt x="3" y="133"/>
                  </a:lnTo>
                  <a:lnTo>
                    <a:pt x="3" y="156"/>
                  </a:lnTo>
                  <a:lnTo>
                    <a:pt x="4" y="185"/>
                  </a:lnTo>
                  <a:lnTo>
                    <a:pt x="4" y="221"/>
                  </a:lnTo>
                  <a:lnTo>
                    <a:pt x="5" y="252"/>
                  </a:lnTo>
                  <a:lnTo>
                    <a:pt x="6" y="275"/>
                  </a:lnTo>
                  <a:lnTo>
                    <a:pt x="6" y="294"/>
                  </a:lnTo>
                  <a:lnTo>
                    <a:pt x="6" y="312"/>
                  </a:lnTo>
                  <a:lnTo>
                    <a:pt x="7" y="329"/>
                  </a:lnTo>
                  <a:lnTo>
                    <a:pt x="7" y="344"/>
                  </a:lnTo>
                  <a:lnTo>
                    <a:pt x="7" y="358"/>
                  </a:lnTo>
                  <a:lnTo>
                    <a:pt x="7" y="372"/>
                  </a:lnTo>
                  <a:lnTo>
                    <a:pt x="8" y="385"/>
                  </a:lnTo>
                  <a:lnTo>
                    <a:pt x="8" y="397"/>
                  </a:lnTo>
                  <a:lnTo>
                    <a:pt x="8" y="409"/>
                  </a:lnTo>
                  <a:lnTo>
                    <a:pt x="8" y="420"/>
                  </a:lnTo>
                  <a:lnTo>
                    <a:pt x="9" y="432"/>
                  </a:lnTo>
                  <a:lnTo>
                    <a:pt x="9" y="443"/>
                  </a:lnTo>
                  <a:lnTo>
                    <a:pt x="9" y="453"/>
                  </a:lnTo>
                  <a:lnTo>
                    <a:pt x="10" y="464"/>
                  </a:lnTo>
                  <a:lnTo>
                    <a:pt x="10" y="474"/>
                  </a:lnTo>
                  <a:lnTo>
                    <a:pt x="10" y="483"/>
                  </a:lnTo>
                  <a:lnTo>
                    <a:pt x="10" y="492"/>
                  </a:lnTo>
                  <a:lnTo>
                    <a:pt x="10" y="500"/>
                  </a:lnTo>
                  <a:lnTo>
                    <a:pt x="11" y="509"/>
                  </a:lnTo>
                  <a:lnTo>
                    <a:pt x="11" y="516"/>
                  </a:lnTo>
                  <a:lnTo>
                    <a:pt x="11" y="524"/>
                  </a:lnTo>
                  <a:lnTo>
                    <a:pt x="11" y="532"/>
                  </a:lnTo>
                  <a:lnTo>
                    <a:pt x="12" y="540"/>
                  </a:lnTo>
                  <a:lnTo>
                    <a:pt x="12" y="547"/>
                  </a:lnTo>
                  <a:lnTo>
                    <a:pt x="12" y="555"/>
                  </a:lnTo>
                  <a:lnTo>
                    <a:pt x="12" y="562"/>
                  </a:lnTo>
                  <a:lnTo>
                    <a:pt x="13" y="569"/>
                  </a:lnTo>
                  <a:lnTo>
                    <a:pt x="13" y="576"/>
                  </a:lnTo>
                  <a:lnTo>
                    <a:pt x="13" y="583"/>
                  </a:lnTo>
                  <a:lnTo>
                    <a:pt x="14" y="589"/>
                  </a:lnTo>
                  <a:lnTo>
                    <a:pt x="14" y="595"/>
                  </a:lnTo>
                  <a:lnTo>
                    <a:pt x="14" y="601"/>
                  </a:lnTo>
                  <a:lnTo>
                    <a:pt x="14" y="607"/>
                  </a:lnTo>
                  <a:lnTo>
                    <a:pt x="14" y="613"/>
                  </a:lnTo>
                  <a:lnTo>
                    <a:pt x="15" y="619"/>
                  </a:lnTo>
                  <a:lnTo>
                    <a:pt x="15" y="624"/>
                  </a:lnTo>
                  <a:lnTo>
                    <a:pt x="15" y="629"/>
                  </a:lnTo>
                  <a:lnTo>
                    <a:pt x="16" y="633"/>
                  </a:lnTo>
                  <a:lnTo>
                    <a:pt x="16" y="636"/>
                  </a:lnTo>
                  <a:lnTo>
                    <a:pt x="16" y="639"/>
                  </a:lnTo>
                  <a:lnTo>
                    <a:pt x="16" y="641"/>
                  </a:lnTo>
                  <a:lnTo>
                    <a:pt x="16" y="643"/>
                  </a:lnTo>
                  <a:lnTo>
                    <a:pt x="16" y="644"/>
                  </a:lnTo>
                  <a:lnTo>
                    <a:pt x="16" y="645"/>
                  </a:lnTo>
                  <a:lnTo>
                    <a:pt x="16" y="646"/>
                  </a:lnTo>
                  <a:lnTo>
                    <a:pt x="16" y="646"/>
                  </a:lnTo>
                  <a:lnTo>
                    <a:pt x="17" y="647"/>
                  </a:lnTo>
                  <a:lnTo>
                    <a:pt x="17" y="648"/>
                  </a:lnTo>
                  <a:lnTo>
                    <a:pt x="17" y="649"/>
                  </a:lnTo>
                  <a:lnTo>
                    <a:pt x="17" y="649"/>
                  </a:lnTo>
                  <a:lnTo>
                    <a:pt x="17" y="651"/>
                  </a:lnTo>
                  <a:lnTo>
                    <a:pt x="17" y="654"/>
                  </a:lnTo>
                  <a:lnTo>
                    <a:pt x="17" y="657"/>
                  </a:lnTo>
                  <a:lnTo>
                    <a:pt x="18" y="660"/>
                  </a:lnTo>
                  <a:lnTo>
                    <a:pt x="18" y="663"/>
                  </a:lnTo>
                  <a:lnTo>
                    <a:pt x="18" y="666"/>
                  </a:lnTo>
                  <a:lnTo>
                    <a:pt x="18" y="669"/>
                  </a:lnTo>
                  <a:lnTo>
                    <a:pt x="19" y="672"/>
                  </a:lnTo>
                  <a:lnTo>
                    <a:pt x="19" y="675"/>
                  </a:lnTo>
                  <a:lnTo>
                    <a:pt x="19" y="678"/>
                  </a:lnTo>
                  <a:lnTo>
                    <a:pt x="19" y="681"/>
                  </a:lnTo>
                  <a:lnTo>
                    <a:pt x="20" y="683"/>
                  </a:lnTo>
                  <a:lnTo>
                    <a:pt x="20" y="686"/>
                  </a:lnTo>
                  <a:lnTo>
                    <a:pt x="20" y="689"/>
                  </a:lnTo>
                  <a:lnTo>
                    <a:pt x="21" y="691"/>
                  </a:lnTo>
                  <a:lnTo>
                    <a:pt x="21" y="694"/>
                  </a:lnTo>
                  <a:lnTo>
                    <a:pt x="21" y="696"/>
                  </a:lnTo>
                  <a:lnTo>
                    <a:pt x="22" y="699"/>
                  </a:lnTo>
                  <a:lnTo>
                    <a:pt x="22" y="701"/>
                  </a:lnTo>
                  <a:lnTo>
                    <a:pt x="22" y="704"/>
                  </a:lnTo>
                  <a:lnTo>
                    <a:pt x="23" y="706"/>
                  </a:lnTo>
                  <a:lnTo>
                    <a:pt x="23" y="708"/>
                  </a:lnTo>
                  <a:lnTo>
                    <a:pt x="24" y="710"/>
                  </a:lnTo>
                  <a:lnTo>
                    <a:pt x="24" y="713"/>
                  </a:lnTo>
                  <a:lnTo>
                    <a:pt x="24" y="715"/>
                  </a:lnTo>
                  <a:lnTo>
                    <a:pt x="25" y="717"/>
                  </a:lnTo>
                  <a:lnTo>
                    <a:pt x="25" y="719"/>
                  </a:lnTo>
                  <a:lnTo>
                    <a:pt x="26" y="721"/>
                  </a:lnTo>
                  <a:lnTo>
                    <a:pt x="26" y="723"/>
                  </a:lnTo>
                  <a:lnTo>
                    <a:pt x="27" y="725"/>
                  </a:lnTo>
                  <a:lnTo>
                    <a:pt x="28" y="727"/>
                  </a:lnTo>
                  <a:lnTo>
                    <a:pt x="28" y="728"/>
                  </a:lnTo>
                  <a:lnTo>
                    <a:pt x="29" y="730"/>
                  </a:lnTo>
                  <a:lnTo>
                    <a:pt x="29" y="732"/>
                  </a:lnTo>
                  <a:lnTo>
                    <a:pt x="30" y="733"/>
                  </a:lnTo>
                  <a:lnTo>
                    <a:pt x="30" y="735"/>
                  </a:lnTo>
                  <a:lnTo>
                    <a:pt x="31" y="736"/>
                  </a:lnTo>
                  <a:lnTo>
                    <a:pt x="32" y="737"/>
                  </a:lnTo>
                  <a:lnTo>
                    <a:pt x="32" y="738"/>
                  </a:lnTo>
                  <a:lnTo>
                    <a:pt x="33" y="739"/>
                  </a:lnTo>
                  <a:lnTo>
                    <a:pt x="34" y="740"/>
                  </a:lnTo>
                  <a:lnTo>
                    <a:pt x="35" y="741"/>
                  </a:lnTo>
                  <a:lnTo>
                    <a:pt x="35" y="742"/>
                  </a:lnTo>
                  <a:lnTo>
                    <a:pt x="36" y="743"/>
                  </a:lnTo>
                  <a:lnTo>
                    <a:pt x="37" y="743"/>
                  </a:lnTo>
                  <a:lnTo>
                    <a:pt x="38" y="744"/>
                  </a:lnTo>
                  <a:lnTo>
                    <a:pt x="39" y="744"/>
                  </a:lnTo>
                  <a:lnTo>
                    <a:pt x="40" y="745"/>
                  </a:lnTo>
                  <a:lnTo>
                    <a:pt x="41" y="745"/>
                  </a:lnTo>
                  <a:lnTo>
                    <a:pt x="43" y="745"/>
                  </a:lnTo>
                  <a:lnTo>
                    <a:pt x="44" y="745"/>
                  </a:lnTo>
                  <a:lnTo>
                    <a:pt x="45" y="746"/>
                  </a:lnTo>
                  <a:lnTo>
                    <a:pt x="46" y="746"/>
                  </a:lnTo>
                  <a:lnTo>
                    <a:pt x="48" y="746"/>
                  </a:lnTo>
                  <a:lnTo>
                    <a:pt x="50" y="745"/>
                  </a:lnTo>
                  <a:lnTo>
                    <a:pt x="52" y="745"/>
                  </a:lnTo>
                  <a:lnTo>
                    <a:pt x="54" y="745"/>
                  </a:lnTo>
                  <a:lnTo>
                    <a:pt x="56" y="744"/>
                  </a:lnTo>
                  <a:lnTo>
                    <a:pt x="57" y="744"/>
                  </a:lnTo>
                  <a:lnTo>
                    <a:pt x="59" y="743"/>
                  </a:lnTo>
                  <a:lnTo>
                    <a:pt x="60" y="742"/>
                  </a:lnTo>
                  <a:lnTo>
                    <a:pt x="62" y="741"/>
                  </a:lnTo>
                  <a:lnTo>
                    <a:pt x="63" y="740"/>
                  </a:lnTo>
                  <a:lnTo>
                    <a:pt x="65" y="739"/>
                  </a:lnTo>
                  <a:lnTo>
                    <a:pt x="66" y="737"/>
                  </a:lnTo>
                  <a:lnTo>
                    <a:pt x="68" y="736"/>
                  </a:lnTo>
                  <a:lnTo>
                    <a:pt x="68" y="735"/>
                  </a:lnTo>
                  <a:lnTo>
                    <a:pt x="69" y="735"/>
                  </a:lnTo>
                  <a:lnTo>
                    <a:pt x="70" y="734"/>
                  </a:lnTo>
                  <a:lnTo>
                    <a:pt x="70" y="734"/>
                  </a:lnTo>
                  <a:lnTo>
                    <a:pt x="71" y="733"/>
                  </a:lnTo>
                  <a:lnTo>
                    <a:pt x="71" y="733"/>
                  </a:lnTo>
                  <a:lnTo>
                    <a:pt x="71" y="733"/>
                  </a:lnTo>
                  <a:lnTo>
                    <a:pt x="72" y="733"/>
                  </a:lnTo>
                  <a:lnTo>
                    <a:pt x="73" y="733"/>
                  </a:lnTo>
                  <a:lnTo>
                    <a:pt x="73" y="733"/>
                  </a:lnTo>
                  <a:lnTo>
                    <a:pt x="74" y="734"/>
                  </a:lnTo>
                  <a:lnTo>
                    <a:pt x="74" y="734"/>
                  </a:lnTo>
                  <a:lnTo>
                    <a:pt x="75" y="735"/>
                  </a:lnTo>
                  <a:lnTo>
                    <a:pt x="76" y="735"/>
                  </a:lnTo>
                  <a:lnTo>
                    <a:pt x="76" y="736"/>
                  </a:lnTo>
                  <a:lnTo>
                    <a:pt x="77" y="737"/>
                  </a:lnTo>
                  <a:lnTo>
                    <a:pt x="78" y="738"/>
                  </a:lnTo>
                  <a:lnTo>
                    <a:pt x="78" y="740"/>
                  </a:lnTo>
                  <a:lnTo>
                    <a:pt x="79" y="741"/>
                  </a:lnTo>
                  <a:lnTo>
                    <a:pt x="80" y="743"/>
                  </a:lnTo>
                  <a:lnTo>
                    <a:pt x="81" y="746"/>
                  </a:lnTo>
                  <a:lnTo>
                    <a:pt x="82" y="749"/>
                  </a:lnTo>
                  <a:lnTo>
                    <a:pt x="85" y="755"/>
                  </a:lnTo>
                  <a:lnTo>
                    <a:pt x="87" y="761"/>
                  </a:lnTo>
                  <a:lnTo>
                    <a:pt x="90" y="766"/>
                  </a:lnTo>
                  <a:lnTo>
                    <a:pt x="91" y="769"/>
                  </a:lnTo>
                  <a:lnTo>
                    <a:pt x="93" y="773"/>
                  </a:lnTo>
                  <a:lnTo>
                    <a:pt x="94" y="775"/>
                  </a:lnTo>
                  <a:lnTo>
                    <a:pt x="95" y="778"/>
                  </a:lnTo>
                  <a:lnTo>
                    <a:pt x="96" y="780"/>
                  </a:lnTo>
                  <a:lnTo>
                    <a:pt x="97" y="781"/>
                  </a:lnTo>
                  <a:lnTo>
                    <a:pt x="97" y="782"/>
                  </a:lnTo>
                  <a:lnTo>
                    <a:pt x="98" y="783"/>
                  </a:lnTo>
                  <a:lnTo>
                    <a:pt x="98" y="784"/>
                  </a:lnTo>
                  <a:lnTo>
                    <a:pt x="98" y="785"/>
                  </a:lnTo>
                  <a:lnTo>
                    <a:pt x="99" y="785"/>
                  </a:lnTo>
                  <a:lnTo>
                    <a:pt x="99" y="786"/>
                  </a:lnTo>
                  <a:lnTo>
                    <a:pt x="100" y="787"/>
                  </a:lnTo>
                  <a:lnTo>
                    <a:pt x="101" y="789"/>
                  </a:lnTo>
                  <a:lnTo>
                    <a:pt x="102" y="791"/>
                  </a:lnTo>
                  <a:lnTo>
                    <a:pt x="103" y="793"/>
                  </a:lnTo>
                  <a:lnTo>
                    <a:pt x="104" y="794"/>
                  </a:lnTo>
                  <a:lnTo>
                    <a:pt x="105" y="796"/>
                  </a:lnTo>
                  <a:lnTo>
                    <a:pt x="106" y="798"/>
                  </a:lnTo>
                  <a:lnTo>
                    <a:pt x="107" y="799"/>
                  </a:lnTo>
                  <a:lnTo>
                    <a:pt x="108" y="800"/>
                  </a:lnTo>
                  <a:lnTo>
                    <a:pt x="109" y="801"/>
                  </a:lnTo>
                  <a:lnTo>
                    <a:pt x="110" y="802"/>
                  </a:lnTo>
                  <a:lnTo>
                    <a:pt x="110" y="803"/>
                  </a:lnTo>
                  <a:lnTo>
                    <a:pt x="111" y="804"/>
                  </a:lnTo>
                  <a:lnTo>
                    <a:pt x="112" y="805"/>
                  </a:lnTo>
                  <a:lnTo>
                    <a:pt x="112" y="805"/>
                  </a:lnTo>
                  <a:lnTo>
                    <a:pt x="113" y="806"/>
                  </a:lnTo>
                  <a:lnTo>
                    <a:pt x="114" y="807"/>
                  </a:lnTo>
                  <a:lnTo>
                    <a:pt x="115" y="807"/>
                  </a:lnTo>
                  <a:lnTo>
                    <a:pt x="115" y="808"/>
                  </a:lnTo>
                  <a:lnTo>
                    <a:pt x="116" y="808"/>
                  </a:lnTo>
                  <a:lnTo>
                    <a:pt x="117" y="808"/>
                  </a:lnTo>
                  <a:lnTo>
                    <a:pt x="118" y="808"/>
                  </a:lnTo>
                  <a:lnTo>
                    <a:pt x="118" y="808"/>
                  </a:lnTo>
                  <a:lnTo>
                    <a:pt x="119" y="808"/>
                  </a:lnTo>
                  <a:lnTo>
                    <a:pt x="120" y="808"/>
                  </a:lnTo>
                  <a:lnTo>
                    <a:pt x="121" y="808"/>
                  </a:lnTo>
                  <a:lnTo>
                    <a:pt x="122" y="808"/>
                  </a:lnTo>
                  <a:lnTo>
                    <a:pt x="123" y="807"/>
                  </a:lnTo>
                  <a:lnTo>
                    <a:pt x="124" y="807"/>
                  </a:lnTo>
                  <a:lnTo>
                    <a:pt x="125" y="807"/>
                  </a:lnTo>
                  <a:lnTo>
                    <a:pt x="126" y="806"/>
                  </a:lnTo>
                  <a:lnTo>
                    <a:pt x="127" y="806"/>
                  </a:lnTo>
                  <a:lnTo>
                    <a:pt x="128" y="805"/>
                  </a:lnTo>
                  <a:lnTo>
                    <a:pt x="130" y="805"/>
                  </a:lnTo>
                  <a:lnTo>
                    <a:pt x="132" y="805"/>
                  </a:lnTo>
                  <a:lnTo>
                    <a:pt x="134" y="804"/>
                  </a:lnTo>
                  <a:lnTo>
                    <a:pt x="135" y="804"/>
                  </a:lnTo>
                  <a:lnTo>
                    <a:pt x="137" y="804"/>
                  </a:lnTo>
                  <a:lnTo>
                    <a:pt x="138" y="803"/>
                  </a:lnTo>
                  <a:lnTo>
                    <a:pt x="140" y="803"/>
                  </a:lnTo>
                  <a:lnTo>
                    <a:pt x="142" y="802"/>
                  </a:lnTo>
                  <a:lnTo>
                    <a:pt x="144" y="801"/>
                  </a:lnTo>
                  <a:lnTo>
                    <a:pt x="146" y="800"/>
                  </a:lnTo>
                  <a:lnTo>
                    <a:pt x="148" y="799"/>
                  </a:lnTo>
                  <a:lnTo>
                    <a:pt x="149" y="798"/>
                  </a:lnTo>
                  <a:lnTo>
                    <a:pt x="150" y="798"/>
                  </a:lnTo>
                  <a:lnTo>
                    <a:pt x="152" y="797"/>
                  </a:lnTo>
                  <a:lnTo>
                    <a:pt x="152" y="797"/>
                  </a:lnTo>
                  <a:lnTo>
                    <a:pt x="153" y="797"/>
                  </a:lnTo>
                  <a:lnTo>
                    <a:pt x="154" y="797"/>
                  </a:lnTo>
                  <a:lnTo>
                    <a:pt x="156" y="797"/>
                  </a:lnTo>
                  <a:lnTo>
                    <a:pt x="157" y="797"/>
                  </a:lnTo>
                  <a:lnTo>
                    <a:pt x="158" y="797"/>
                  </a:lnTo>
                  <a:lnTo>
                    <a:pt x="159" y="797"/>
                  </a:lnTo>
                  <a:lnTo>
                    <a:pt x="160" y="797"/>
                  </a:lnTo>
                  <a:lnTo>
                    <a:pt x="161" y="798"/>
                  </a:lnTo>
                  <a:lnTo>
                    <a:pt x="162" y="798"/>
                  </a:lnTo>
                  <a:lnTo>
                    <a:pt x="163" y="798"/>
                  </a:lnTo>
                  <a:lnTo>
                    <a:pt x="164" y="799"/>
                  </a:lnTo>
                  <a:lnTo>
                    <a:pt x="165" y="799"/>
                  </a:lnTo>
                  <a:lnTo>
                    <a:pt x="166" y="800"/>
                  </a:lnTo>
                  <a:lnTo>
                    <a:pt x="167" y="800"/>
                  </a:lnTo>
                  <a:lnTo>
                    <a:pt x="168" y="801"/>
                  </a:lnTo>
                  <a:lnTo>
                    <a:pt x="169" y="802"/>
                  </a:lnTo>
                  <a:lnTo>
                    <a:pt x="170" y="803"/>
                  </a:lnTo>
                  <a:lnTo>
                    <a:pt x="171" y="803"/>
                  </a:lnTo>
                  <a:lnTo>
                    <a:pt x="172" y="804"/>
                  </a:lnTo>
                  <a:lnTo>
                    <a:pt x="173" y="805"/>
                  </a:lnTo>
                  <a:lnTo>
                    <a:pt x="174" y="806"/>
                  </a:lnTo>
                  <a:lnTo>
                    <a:pt x="175" y="808"/>
                  </a:lnTo>
                  <a:lnTo>
                    <a:pt x="176" y="809"/>
                  </a:lnTo>
                  <a:lnTo>
                    <a:pt x="176" y="810"/>
                  </a:lnTo>
                  <a:lnTo>
                    <a:pt x="177" y="811"/>
                  </a:lnTo>
                  <a:lnTo>
                    <a:pt x="177" y="811"/>
                  </a:lnTo>
                  <a:lnTo>
                    <a:pt x="178" y="812"/>
                  </a:lnTo>
                  <a:lnTo>
                    <a:pt x="178" y="812"/>
                  </a:lnTo>
                  <a:lnTo>
                    <a:pt x="178" y="813"/>
                  </a:lnTo>
                  <a:lnTo>
                    <a:pt x="179" y="813"/>
                  </a:lnTo>
                  <a:lnTo>
                    <a:pt x="179" y="814"/>
                  </a:lnTo>
                  <a:lnTo>
                    <a:pt x="180" y="815"/>
                  </a:lnTo>
                  <a:lnTo>
                    <a:pt x="182" y="818"/>
                  </a:lnTo>
                  <a:lnTo>
                    <a:pt x="183" y="820"/>
                  </a:lnTo>
                  <a:lnTo>
                    <a:pt x="185" y="822"/>
                  </a:lnTo>
                  <a:lnTo>
                    <a:pt x="186" y="825"/>
                  </a:lnTo>
                  <a:lnTo>
                    <a:pt x="188" y="827"/>
                  </a:lnTo>
                  <a:lnTo>
                    <a:pt x="190" y="830"/>
                  </a:lnTo>
                  <a:lnTo>
                    <a:pt x="192" y="832"/>
                  </a:lnTo>
                  <a:lnTo>
                    <a:pt x="193" y="835"/>
                  </a:lnTo>
                  <a:lnTo>
                    <a:pt x="195" y="838"/>
                  </a:lnTo>
                  <a:lnTo>
                    <a:pt x="197" y="840"/>
                  </a:lnTo>
                  <a:lnTo>
                    <a:pt x="199" y="842"/>
                  </a:lnTo>
                  <a:lnTo>
                    <a:pt x="200" y="844"/>
                  </a:lnTo>
                  <a:lnTo>
                    <a:pt x="201" y="846"/>
                  </a:lnTo>
                  <a:lnTo>
                    <a:pt x="202" y="847"/>
                  </a:lnTo>
                  <a:lnTo>
                    <a:pt x="203" y="848"/>
                  </a:lnTo>
                  <a:lnTo>
                    <a:pt x="203" y="849"/>
                  </a:lnTo>
                  <a:lnTo>
                    <a:pt x="204" y="850"/>
                  </a:lnTo>
                  <a:lnTo>
                    <a:pt x="204" y="851"/>
                  </a:lnTo>
                  <a:lnTo>
                    <a:pt x="205" y="851"/>
                  </a:lnTo>
                  <a:lnTo>
                    <a:pt x="205" y="852"/>
                  </a:lnTo>
                  <a:lnTo>
                    <a:pt x="206" y="852"/>
                  </a:lnTo>
                  <a:lnTo>
                    <a:pt x="206" y="852"/>
                  </a:lnTo>
                  <a:lnTo>
                    <a:pt x="206" y="853"/>
                  </a:lnTo>
                  <a:lnTo>
                    <a:pt x="206" y="853"/>
                  </a:lnTo>
                  <a:lnTo>
                    <a:pt x="207" y="853"/>
                  </a:lnTo>
                  <a:lnTo>
                    <a:pt x="208" y="854"/>
                  </a:lnTo>
                  <a:lnTo>
                    <a:pt x="209" y="855"/>
                  </a:lnTo>
                  <a:lnTo>
                    <a:pt x="209" y="856"/>
                  </a:lnTo>
                  <a:lnTo>
                    <a:pt x="210" y="857"/>
                  </a:lnTo>
                  <a:lnTo>
                    <a:pt x="211" y="858"/>
                  </a:lnTo>
                  <a:lnTo>
                    <a:pt x="212" y="858"/>
                  </a:lnTo>
                  <a:lnTo>
                    <a:pt x="212" y="859"/>
                  </a:lnTo>
                  <a:lnTo>
                    <a:pt x="213" y="859"/>
                  </a:lnTo>
                  <a:lnTo>
                    <a:pt x="214" y="860"/>
                  </a:lnTo>
                  <a:lnTo>
                    <a:pt x="214" y="861"/>
                  </a:lnTo>
                  <a:lnTo>
                    <a:pt x="215" y="861"/>
                  </a:lnTo>
                  <a:lnTo>
                    <a:pt x="216" y="862"/>
                  </a:lnTo>
                  <a:lnTo>
                    <a:pt x="216" y="862"/>
                  </a:lnTo>
                  <a:lnTo>
                    <a:pt x="217" y="863"/>
                  </a:lnTo>
                  <a:lnTo>
                    <a:pt x="218" y="863"/>
                  </a:lnTo>
                  <a:lnTo>
                    <a:pt x="219" y="864"/>
                  </a:lnTo>
                  <a:lnTo>
                    <a:pt x="219" y="864"/>
                  </a:lnTo>
                  <a:lnTo>
                    <a:pt x="220" y="865"/>
                  </a:lnTo>
                  <a:lnTo>
                    <a:pt x="221" y="865"/>
                  </a:lnTo>
                  <a:lnTo>
                    <a:pt x="222" y="866"/>
                  </a:lnTo>
                  <a:lnTo>
                    <a:pt x="222" y="866"/>
                  </a:lnTo>
                  <a:lnTo>
                    <a:pt x="223" y="866"/>
                  </a:lnTo>
                  <a:lnTo>
                    <a:pt x="224" y="867"/>
                  </a:lnTo>
                  <a:lnTo>
                    <a:pt x="225" y="867"/>
                  </a:lnTo>
                  <a:lnTo>
                    <a:pt x="225" y="868"/>
                  </a:lnTo>
                  <a:lnTo>
                    <a:pt x="226" y="868"/>
                  </a:lnTo>
                  <a:lnTo>
                    <a:pt x="227" y="868"/>
                  </a:lnTo>
                  <a:lnTo>
                    <a:pt x="228" y="868"/>
                  </a:lnTo>
                  <a:lnTo>
                    <a:pt x="228" y="869"/>
                  </a:lnTo>
                  <a:lnTo>
                    <a:pt x="229" y="869"/>
                  </a:lnTo>
                  <a:lnTo>
                    <a:pt x="230" y="869"/>
                  </a:lnTo>
                  <a:lnTo>
                    <a:pt x="231" y="870"/>
                  </a:lnTo>
                  <a:lnTo>
                    <a:pt x="232" y="870"/>
                  </a:lnTo>
                  <a:lnTo>
                    <a:pt x="233" y="870"/>
                  </a:lnTo>
                  <a:lnTo>
                    <a:pt x="233" y="870"/>
                  </a:lnTo>
                  <a:lnTo>
                    <a:pt x="233" y="870"/>
                  </a:lnTo>
                  <a:lnTo>
                    <a:pt x="234" y="871"/>
                  </a:lnTo>
                  <a:lnTo>
                    <a:pt x="235" y="871"/>
                  </a:lnTo>
                  <a:lnTo>
                    <a:pt x="236" y="871"/>
                  </a:lnTo>
                  <a:lnTo>
                    <a:pt x="237" y="871"/>
                  </a:lnTo>
                  <a:lnTo>
                    <a:pt x="239" y="871"/>
                  </a:lnTo>
                  <a:lnTo>
                    <a:pt x="241" y="872"/>
                  </a:lnTo>
                  <a:lnTo>
                    <a:pt x="242" y="872"/>
                  </a:lnTo>
                  <a:lnTo>
                    <a:pt x="243" y="872"/>
                  </a:lnTo>
                  <a:lnTo>
                    <a:pt x="244" y="873"/>
                  </a:lnTo>
                  <a:lnTo>
                    <a:pt x="246" y="873"/>
                  </a:lnTo>
                  <a:lnTo>
                    <a:pt x="247" y="873"/>
                  </a:lnTo>
                  <a:lnTo>
                    <a:pt x="248" y="873"/>
                  </a:lnTo>
                  <a:lnTo>
                    <a:pt x="249" y="874"/>
                  </a:lnTo>
                  <a:lnTo>
                    <a:pt x="251" y="874"/>
                  </a:lnTo>
                  <a:lnTo>
                    <a:pt x="252" y="875"/>
                  </a:lnTo>
                  <a:lnTo>
                    <a:pt x="252" y="875"/>
                  </a:lnTo>
                  <a:lnTo>
                    <a:pt x="253" y="875"/>
                  </a:lnTo>
                  <a:lnTo>
                    <a:pt x="254" y="875"/>
                  </a:lnTo>
                  <a:lnTo>
                    <a:pt x="255" y="875"/>
                  </a:lnTo>
                  <a:lnTo>
                    <a:pt x="255" y="876"/>
                  </a:lnTo>
                  <a:lnTo>
                    <a:pt x="256" y="876"/>
                  </a:lnTo>
                  <a:lnTo>
                    <a:pt x="257" y="876"/>
                  </a:lnTo>
                  <a:lnTo>
                    <a:pt x="258" y="876"/>
                  </a:lnTo>
                  <a:lnTo>
                    <a:pt x="259" y="876"/>
                  </a:lnTo>
                  <a:lnTo>
                    <a:pt x="260" y="876"/>
                  </a:lnTo>
                  <a:lnTo>
                    <a:pt x="261" y="876"/>
                  </a:lnTo>
                  <a:lnTo>
                    <a:pt x="261" y="876"/>
                  </a:lnTo>
                  <a:lnTo>
                    <a:pt x="262" y="876"/>
                  </a:lnTo>
                  <a:lnTo>
                    <a:pt x="263" y="876"/>
                  </a:lnTo>
                  <a:lnTo>
                    <a:pt x="264" y="876"/>
                  </a:lnTo>
                  <a:lnTo>
                    <a:pt x="264" y="876"/>
                  </a:lnTo>
                  <a:lnTo>
                    <a:pt x="265" y="876"/>
                  </a:lnTo>
                  <a:lnTo>
                    <a:pt x="266" y="876"/>
                  </a:lnTo>
                  <a:lnTo>
                    <a:pt x="267" y="876"/>
                  </a:lnTo>
                  <a:lnTo>
                    <a:pt x="268" y="876"/>
                  </a:lnTo>
                  <a:lnTo>
                    <a:pt x="269" y="876"/>
                  </a:lnTo>
                  <a:lnTo>
                    <a:pt x="271" y="876"/>
                  </a:lnTo>
                  <a:lnTo>
                    <a:pt x="272" y="876"/>
                  </a:lnTo>
                  <a:lnTo>
                    <a:pt x="273" y="876"/>
                  </a:lnTo>
                  <a:lnTo>
                    <a:pt x="275" y="876"/>
                  </a:lnTo>
                  <a:lnTo>
                    <a:pt x="276" y="876"/>
                  </a:lnTo>
                  <a:lnTo>
                    <a:pt x="277" y="876"/>
                  </a:lnTo>
                  <a:lnTo>
                    <a:pt x="279" y="876"/>
                  </a:lnTo>
                  <a:lnTo>
                    <a:pt x="280" y="876"/>
                  </a:lnTo>
                  <a:lnTo>
                    <a:pt x="282" y="876"/>
                  </a:lnTo>
                  <a:lnTo>
                    <a:pt x="283" y="876"/>
                  </a:lnTo>
                  <a:lnTo>
                    <a:pt x="285" y="876"/>
                  </a:lnTo>
                  <a:lnTo>
                    <a:pt x="287" y="876"/>
                  </a:lnTo>
                  <a:lnTo>
                    <a:pt x="288" y="876"/>
                  </a:lnTo>
                  <a:lnTo>
                    <a:pt x="289" y="876"/>
                  </a:lnTo>
                  <a:lnTo>
                    <a:pt x="290" y="876"/>
                  </a:lnTo>
                  <a:lnTo>
                    <a:pt x="291" y="876"/>
                  </a:lnTo>
                  <a:lnTo>
                    <a:pt x="292" y="876"/>
                  </a:lnTo>
                  <a:lnTo>
                    <a:pt x="293" y="876"/>
                  </a:lnTo>
                  <a:lnTo>
                    <a:pt x="294" y="876"/>
                  </a:lnTo>
                  <a:lnTo>
                    <a:pt x="295" y="875"/>
                  </a:lnTo>
                  <a:lnTo>
                    <a:pt x="296" y="875"/>
                  </a:lnTo>
                  <a:lnTo>
                    <a:pt x="296" y="875"/>
                  </a:lnTo>
                  <a:lnTo>
                    <a:pt x="297" y="876"/>
                  </a:lnTo>
                  <a:lnTo>
                    <a:pt x="298" y="876"/>
                  </a:lnTo>
                  <a:lnTo>
                    <a:pt x="299" y="876"/>
                  </a:lnTo>
                  <a:lnTo>
                    <a:pt x="299" y="876"/>
                  </a:lnTo>
                  <a:lnTo>
                    <a:pt x="300" y="876"/>
                  </a:lnTo>
                  <a:lnTo>
                    <a:pt x="301" y="876"/>
                  </a:lnTo>
                  <a:lnTo>
                    <a:pt x="302" y="876"/>
                  </a:lnTo>
                  <a:lnTo>
                    <a:pt x="303" y="876"/>
                  </a:lnTo>
                  <a:lnTo>
                    <a:pt x="304" y="876"/>
                  </a:lnTo>
                  <a:lnTo>
                    <a:pt x="305" y="876"/>
                  </a:lnTo>
                  <a:lnTo>
                    <a:pt x="306" y="876"/>
                  </a:lnTo>
                  <a:lnTo>
                    <a:pt x="307" y="876"/>
                  </a:lnTo>
                  <a:lnTo>
                    <a:pt x="309" y="877"/>
                  </a:lnTo>
                  <a:lnTo>
                    <a:pt x="310" y="877"/>
                  </a:lnTo>
                  <a:lnTo>
                    <a:pt x="311" y="877"/>
                  </a:lnTo>
                  <a:lnTo>
                    <a:pt x="311" y="877"/>
                  </a:lnTo>
                  <a:lnTo>
                    <a:pt x="312" y="877"/>
                  </a:lnTo>
                  <a:lnTo>
                    <a:pt x="313" y="877"/>
                  </a:lnTo>
                  <a:lnTo>
                    <a:pt x="314" y="877"/>
                  </a:lnTo>
                  <a:lnTo>
                    <a:pt x="314" y="877"/>
                  </a:lnTo>
                  <a:lnTo>
                    <a:pt x="315" y="877"/>
                  </a:lnTo>
                  <a:lnTo>
                    <a:pt x="315" y="877"/>
                  </a:lnTo>
                  <a:lnTo>
                    <a:pt x="316" y="877"/>
                  </a:lnTo>
                  <a:lnTo>
                    <a:pt x="316" y="877"/>
                  </a:lnTo>
                  <a:lnTo>
                    <a:pt x="317" y="877"/>
                  </a:lnTo>
                  <a:lnTo>
                    <a:pt x="318" y="877"/>
                  </a:lnTo>
                  <a:lnTo>
                    <a:pt x="318" y="877"/>
                  </a:lnTo>
                  <a:lnTo>
                    <a:pt x="319" y="877"/>
                  </a:lnTo>
                  <a:lnTo>
                    <a:pt x="319" y="877"/>
                  </a:lnTo>
                  <a:lnTo>
                    <a:pt x="320" y="877"/>
                  </a:lnTo>
                  <a:lnTo>
                    <a:pt x="321" y="877"/>
                  </a:lnTo>
                  <a:lnTo>
                    <a:pt x="321" y="877"/>
                  </a:lnTo>
                  <a:lnTo>
                    <a:pt x="322" y="877"/>
                  </a:lnTo>
                  <a:lnTo>
                    <a:pt x="324" y="877"/>
                  </a:lnTo>
                  <a:lnTo>
                    <a:pt x="325" y="877"/>
                  </a:lnTo>
                  <a:lnTo>
                    <a:pt x="329" y="876"/>
                  </a:lnTo>
                  <a:lnTo>
                    <a:pt x="332" y="876"/>
                  </a:lnTo>
                  <a:lnTo>
                    <a:pt x="333" y="876"/>
                  </a:lnTo>
                  <a:lnTo>
                    <a:pt x="334" y="876"/>
                  </a:lnTo>
                  <a:lnTo>
                    <a:pt x="335" y="876"/>
                  </a:lnTo>
                  <a:lnTo>
                    <a:pt x="336" y="876"/>
                  </a:lnTo>
                  <a:lnTo>
                    <a:pt x="336" y="876"/>
                  </a:lnTo>
                  <a:lnTo>
                    <a:pt x="337" y="876"/>
                  </a:lnTo>
                  <a:lnTo>
                    <a:pt x="337" y="876"/>
                  </a:lnTo>
                  <a:lnTo>
                    <a:pt x="338" y="876"/>
                  </a:lnTo>
                  <a:lnTo>
                    <a:pt x="338" y="876"/>
                  </a:lnTo>
                  <a:lnTo>
                    <a:pt x="338" y="876"/>
                  </a:lnTo>
                  <a:lnTo>
                    <a:pt x="338" y="875"/>
                  </a:lnTo>
                  <a:lnTo>
                    <a:pt x="339" y="875"/>
                  </a:lnTo>
                  <a:lnTo>
                    <a:pt x="339" y="875"/>
                  </a:lnTo>
                  <a:lnTo>
                    <a:pt x="339" y="875"/>
                  </a:lnTo>
                  <a:lnTo>
                    <a:pt x="339" y="875"/>
                  </a:lnTo>
                  <a:lnTo>
                    <a:pt x="340" y="875"/>
                  </a:lnTo>
                  <a:lnTo>
                    <a:pt x="340" y="875"/>
                  </a:lnTo>
                  <a:lnTo>
                    <a:pt x="340" y="875"/>
                  </a:lnTo>
                  <a:lnTo>
                    <a:pt x="341" y="875"/>
                  </a:lnTo>
                  <a:lnTo>
                    <a:pt x="341" y="875"/>
                  </a:lnTo>
                  <a:lnTo>
                    <a:pt x="341" y="876"/>
                  </a:lnTo>
                  <a:lnTo>
                    <a:pt x="342" y="876"/>
                  </a:lnTo>
                  <a:lnTo>
                    <a:pt x="342" y="876"/>
                  </a:lnTo>
                  <a:lnTo>
                    <a:pt x="343" y="876"/>
                  </a:lnTo>
                  <a:lnTo>
                    <a:pt x="343" y="876"/>
                  </a:lnTo>
                  <a:lnTo>
                    <a:pt x="343" y="876"/>
                  </a:lnTo>
                  <a:lnTo>
                    <a:pt x="344" y="876"/>
                  </a:lnTo>
                  <a:lnTo>
                    <a:pt x="344" y="876"/>
                  </a:lnTo>
                  <a:lnTo>
                    <a:pt x="345" y="876"/>
                  </a:lnTo>
                  <a:lnTo>
                    <a:pt x="345" y="876"/>
                  </a:lnTo>
                  <a:lnTo>
                    <a:pt x="345" y="876"/>
                  </a:lnTo>
                  <a:lnTo>
                    <a:pt x="346" y="876"/>
                  </a:lnTo>
                  <a:lnTo>
                    <a:pt x="346" y="876"/>
                  </a:lnTo>
                  <a:lnTo>
                    <a:pt x="347" y="876"/>
                  </a:lnTo>
                  <a:lnTo>
                    <a:pt x="347" y="877"/>
                  </a:lnTo>
                  <a:lnTo>
                    <a:pt x="347" y="877"/>
                  </a:lnTo>
                  <a:lnTo>
                    <a:pt x="348" y="877"/>
                  </a:lnTo>
                  <a:lnTo>
                    <a:pt x="348" y="877"/>
                  </a:lnTo>
                  <a:lnTo>
                    <a:pt x="349" y="877"/>
                  </a:lnTo>
                  <a:lnTo>
                    <a:pt x="349" y="877"/>
                  </a:lnTo>
                  <a:lnTo>
                    <a:pt x="349" y="877"/>
                  </a:lnTo>
                  <a:lnTo>
                    <a:pt x="350" y="878"/>
                  </a:lnTo>
                  <a:lnTo>
                    <a:pt x="350" y="878"/>
                  </a:lnTo>
                  <a:lnTo>
                    <a:pt x="350" y="878"/>
                  </a:lnTo>
                  <a:lnTo>
                    <a:pt x="351" y="878"/>
                  </a:lnTo>
                  <a:lnTo>
                    <a:pt x="351" y="878"/>
                  </a:lnTo>
                  <a:lnTo>
                    <a:pt x="352" y="879"/>
                  </a:lnTo>
                  <a:lnTo>
                    <a:pt x="352" y="879"/>
                  </a:lnTo>
                  <a:lnTo>
                    <a:pt x="352" y="879"/>
                  </a:lnTo>
                  <a:lnTo>
                    <a:pt x="353" y="880"/>
                  </a:lnTo>
                  <a:lnTo>
                    <a:pt x="353" y="880"/>
                  </a:lnTo>
                  <a:lnTo>
                    <a:pt x="354" y="880"/>
                  </a:lnTo>
                  <a:lnTo>
                    <a:pt x="355" y="881"/>
                  </a:lnTo>
                  <a:lnTo>
                    <a:pt x="355" y="881"/>
                  </a:lnTo>
                  <a:lnTo>
                    <a:pt x="356" y="882"/>
                  </a:lnTo>
                  <a:lnTo>
                    <a:pt x="357" y="883"/>
                  </a:lnTo>
                  <a:lnTo>
                    <a:pt x="358" y="883"/>
                  </a:lnTo>
                  <a:lnTo>
                    <a:pt x="358" y="883"/>
                  </a:lnTo>
                  <a:lnTo>
                    <a:pt x="359" y="884"/>
                  </a:lnTo>
                  <a:lnTo>
                    <a:pt x="359" y="884"/>
                  </a:lnTo>
                  <a:lnTo>
                    <a:pt x="359" y="884"/>
                  </a:lnTo>
                  <a:lnTo>
                    <a:pt x="360" y="884"/>
                  </a:lnTo>
                  <a:lnTo>
                    <a:pt x="360" y="885"/>
                  </a:lnTo>
                  <a:lnTo>
                    <a:pt x="361" y="885"/>
                  </a:lnTo>
                  <a:lnTo>
                    <a:pt x="361" y="885"/>
                  </a:lnTo>
                  <a:lnTo>
                    <a:pt x="361" y="885"/>
                  </a:lnTo>
                  <a:lnTo>
                    <a:pt x="362" y="886"/>
                  </a:lnTo>
                  <a:lnTo>
                    <a:pt x="362" y="886"/>
                  </a:lnTo>
                  <a:lnTo>
                    <a:pt x="362" y="886"/>
                  </a:lnTo>
                  <a:lnTo>
                    <a:pt x="363" y="886"/>
                  </a:lnTo>
                  <a:lnTo>
                    <a:pt x="363" y="886"/>
                  </a:lnTo>
                  <a:lnTo>
                    <a:pt x="364" y="886"/>
                  </a:lnTo>
                  <a:lnTo>
                    <a:pt x="364" y="887"/>
                  </a:lnTo>
                  <a:lnTo>
                    <a:pt x="365" y="887"/>
                  </a:lnTo>
                  <a:lnTo>
                    <a:pt x="365" y="887"/>
                  </a:lnTo>
                  <a:lnTo>
                    <a:pt x="365" y="887"/>
                  </a:lnTo>
                  <a:lnTo>
                    <a:pt x="365" y="887"/>
                  </a:lnTo>
                  <a:lnTo>
                    <a:pt x="366" y="887"/>
                  </a:lnTo>
                  <a:lnTo>
                    <a:pt x="366" y="887"/>
                  </a:lnTo>
                  <a:lnTo>
                    <a:pt x="366" y="887"/>
                  </a:lnTo>
                  <a:lnTo>
                    <a:pt x="366" y="887"/>
                  </a:lnTo>
                  <a:lnTo>
                    <a:pt x="366" y="888"/>
                  </a:lnTo>
                  <a:lnTo>
                    <a:pt x="367" y="888"/>
                  </a:lnTo>
                  <a:lnTo>
                    <a:pt x="367" y="888"/>
                  </a:lnTo>
                  <a:lnTo>
                    <a:pt x="368" y="888"/>
                  </a:lnTo>
                  <a:lnTo>
                    <a:pt x="368" y="888"/>
                  </a:lnTo>
                  <a:lnTo>
                    <a:pt x="369" y="888"/>
                  </a:lnTo>
                  <a:lnTo>
                    <a:pt x="369" y="888"/>
                  </a:lnTo>
                  <a:lnTo>
                    <a:pt x="370" y="888"/>
                  </a:lnTo>
                  <a:lnTo>
                    <a:pt x="370" y="889"/>
                  </a:lnTo>
                  <a:lnTo>
                    <a:pt x="371" y="889"/>
                  </a:lnTo>
                  <a:lnTo>
                    <a:pt x="372" y="889"/>
                  </a:lnTo>
                  <a:lnTo>
                    <a:pt x="372" y="889"/>
                  </a:lnTo>
                  <a:lnTo>
                    <a:pt x="373" y="889"/>
                  </a:lnTo>
                  <a:lnTo>
                    <a:pt x="373" y="889"/>
                  </a:lnTo>
                  <a:lnTo>
                    <a:pt x="374" y="890"/>
                  </a:lnTo>
                  <a:lnTo>
                    <a:pt x="374" y="890"/>
                  </a:lnTo>
                  <a:lnTo>
                    <a:pt x="375" y="890"/>
                  </a:lnTo>
                  <a:lnTo>
                    <a:pt x="376" y="890"/>
                  </a:lnTo>
                  <a:lnTo>
                    <a:pt x="377" y="890"/>
                  </a:lnTo>
                  <a:lnTo>
                    <a:pt x="378" y="891"/>
                  </a:lnTo>
                  <a:lnTo>
                    <a:pt x="379" y="891"/>
                  </a:lnTo>
                  <a:lnTo>
                    <a:pt x="380" y="891"/>
                  </a:lnTo>
                  <a:lnTo>
                    <a:pt x="381" y="891"/>
                  </a:lnTo>
                  <a:lnTo>
                    <a:pt x="381" y="891"/>
                  </a:lnTo>
                  <a:lnTo>
                    <a:pt x="382" y="891"/>
                  </a:lnTo>
                  <a:lnTo>
                    <a:pt x="383" y="891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" name="Freeform 154"/>
            <p:cNvSpPr>
              <a:spLocks/>
            </p:cNvSpPr>
            <p:nvPr/>
          </p:nvSpPr>
          <p:spPr bwMode="auto">
            <a:xfrm>
              <a:off x="3957694" y="4954950"/>
              <a:ext cx="1072995" cy="55127"/>
            </a:xfrm>
            <a:custGeom>
              <a:avLst/>
              <a:gdLst>
                <a:gd name="T0" fmla="*/ 4 w 865"/>
                <a:gd name="T1" fmla="*/ 34 h 42"/>
                <a:gd name="T2" fmla="*/ 10 w 865"/>
                <a:gd name="T3" fmla="*/ 36 h 42"/>
                <a:gd name="T4" fmla="*/ 13 w 865"/>
                <a:gd name="T5" fmla="*/ 37 h 42"/>
                <a:gd name="T6" fmla="*/ 17 w 865"/>
                <a:gd name="T7" fmla="*/ 38 h 42"/>
                <a:gd name="T8" fmla="*/ 23 w 865"/>
                <a:gd name="T9" fmla="*/ 38 h 42"/>
                <a:gd name="T10" fmla="*/ 32 w 865"/>
                <a:gd name="T11" fmla="*/ 38 h 42"/>
                <a:gd name="T12" fmla="*/ 46 w 865"/>
                <a:gd name="T13" fmla="*/ 39 h 42"/>
                <a:gd name="T14" fmla="*/ 67 w 865"/>
                <a:gd name="T15" fmla="*/ 39 h 42"/>
                <a:gd name="T16" fmla="*/ 96 w 865"/>
                <a:gd name="T17" fmla="*/ 39 h 42"/>
                <a:gd name="T18" fmla="*/ 111 w 865"/>
                <a:gd name="T19" fmla="*/ 39 h 42"/>
                <a:gd name="T20" fmla="*/ 123 w 865"/>
                <a:gd name="T21" fmla="*/ 39 h 42"/>
                <a:gd name="T22" fmla="*/ 139 w 865"/>
                <a:gd name="T23" fmla="*/ 39 h 42"/>
                <a:gd name="T24" fmla="*/ 161 w 865"/>
                <a:gd name="T25" fmla="*/ 40 h 42"/>
                <a:gd name="T26" fmla="*/ 179 w 865"/>
                <a:gd name="T27" fmla="*/ 40 h 42"/>
                <a:gd name="T28" fmla="*/ 195 w 865"/>
                <a:gd name="T29" fmla="*/ 40 h 42"/>
                <a:gd name="T30" fmla="*/ 205 w 865"/>
                <a:gd name="T31" fmla="*/ 40 h 42"/>
                <a:gd name="T32" fmla="*/ 216 w 865"/>
                <a:gd name="T33" fmla="*/ 40 h 42"/>
                <a:gd name="T34" fmla="*/ 229 w 865"/>
                <a:gd name="T35" fmla="*/ 39 h 42"/>
                <a:gd name="T36" fmla="*/ 240 w 865"/>
                <a:gd name="T37" fmla="*/ 39 h 42"/>
                <a:gd name="T38" fmla="*/ 254 w 865"/>
                <a:gd name="T39" fmla="*/ 39 h 42"/>
                <a:gd name="T40" fmla="*/ 276 w 865"/>
                <a:gd name="T41" fmla="*/ 40 h 42"/>
                <a:gd name="T42" fmla="*/ 288 w 865"/>
                <a:gd name="T43" fmla="*/ 40 h 42"/>
                <a:gd name="T44" fmla="*/ 311 w 865"/>
                <a:gd name="T45" fmla="*/ 40 h 42"/>
                <a:gd name="T46" fmla="*/ 331 w 865"/>
                <a:gd name="T47" fmla="*/ 40 h 42"/>
                <a:gd name="T48" fmla="*/ 349 w 865"/>
                <a:gd name="T49" fmla="*/ 41 h 42"/>
                <a:gd name="T50" fmla="*/ 368 w 865"/>
                <a:gd name="T51" fmla="*/ 41 h 42"/>
                <a:gd name="T52" fmla="*/ 397 w 865"/>
                <a:gd name="T53" fmla="*/ 41 h 42"/>
                <a:gd name="T54" fmla="*/ 421 w 865"/>
                <a:gd name="T55" fmla="*/ 40 h 42"/>
                <a:gd name="T56" fmla="*/ 445 w 865"/>
                <a:gd name="T57" fmla="*/ 40 h 42"/>
                <a:gd name="T58" fmla="*/ 481 w 865"/>
                <a:gd name="T59" fmla="*/ 40 h 42"/>
                <a:gd name="T60" fmla="*/ 509 w 865"/>
                <a:gd name="T61" fmla="*/ 40 h 42"/>
                <a:gd name="T62" fmla="*/ 533 w 865"/>
                <a:gd name="T63" fmla="*/ 40 h 42"/>
                <a:gd name="T64" fmla="*/ 564 w 865"/>
                <a:gd name="T65" fmla="*/ 40 h 42"/>
                <a:gd name="T66" fmla="*/ 592 w 865"/>
                <a:gd name="T67" fmla="*/ 40 h 42"/>
                <a:gd name="T68" fmla="*/ 624 w 865"/>
                <a:gd name="T69" fmla="*/ 40 h 42"/>
                <a:gd name="T70" fmla="*/ 662 w 865"/>
                <a:gd name="T71" fmla="*/ 40 h 42"/>
                <a:gd name="T72" fmla="*/ 699 w 865"/>
                <a:gd name="T73" fmla="*/ 40 h 42"/>
                <a:gd name="T74" fmla="*/ 713 w 865"/>
                <a:gd name="T75" fmla="*/ 40 h 42"/>
                <a:gd name="T76" fmla="*/ 735 w 865"/>
                <a:gd name="T77" fmla="*/ 40 h 42"/>
                <a:gd name="T78" fmla="*/ 750 w 865"/>
                <a:gd name="T79" fmla="*/ 40 h 42"/>
                <a:gd name="T80" fmla="*/ 759 w 865"/>
                <a:gd name="T81" fmla="*/ 40 h 42"/>
                <a:gd name="T82" fmla="*/ 766 w 865"/>
                <a:gd name="T83" fmla="*/ 40 h 42"/>
                <a:gd name="T84" fmla="*/ 777 w 865"/>
                <a:gd name="T85" fmla="*/ 42 h 42"/>
                <a:gd name="T86" fmla="*/ 784 w 865"/>
                <a:gd name="T87" fmla="*/ 42 h 42"/>
                <a:gd name="T88" fmla="*/ 790 w 865"/>
                <a:gd name="T89" fmla="*/ 42 h 42"/>
                <a:gd name="T90" fmla="*/ 801 w 865"/>
                <a:gd name="T91" fmla="*/ 41 h 42"/>
                <a:gd name="T92" fmla="*/ 813 w 865"/>
                <a:gd name="T93" fmla="*/ 40 h 42"/>
                <a:gd name="T94" fmla="*/ 821 w 865"/>
                <a:gd name="T95" fmla="*/ 39 h 42"/>
                <a:gd name="T96" fmla="*/ 829 w 865"/>
                <a:gd name="T97" fmla="*/ 38 h 42"/>
                <a:gd name="T98" fmla="*/ 834 w 865"/>
                <a:gd name="T99" fmla="*/ 38 h 42"/>
                <a:gd name="T100" fmla="*/ 837 w 865"/>
                <a:gd name="T101" fmla="*/ 37 h 42"/>
                <a:gd name="T102" fmla="*/ 839 w 865"/>
                <a:gd name="T103" fmla="*/ 36 h 42"/>
                <a:gd name="T104" fmla="*/ 840 w 865"/>
                <a:gd name="T105" fmla="*/ 36 h 42"/>
                <a:gd name="T106" fmla="*/ 841 w 865"/>
                <a:gd name="T107" fmla="*/ 35 h 42"/>
                <a:gd name="T108" fmla="*/ 843 w 865"/>
                <a:gd name="T109" fmla="*/ 34 h 42"/>
                <a:gd name="T110" fmla="*/ 845 w 865"/>
                <a:gd name="T111" fmla="*/ 32 h 42"/>
                <a:gd name="T112" fmla="*/ 847 w 865"/>
                <a:gd name="T113" fmla="*/ 30 h 42"/>
                <a:gd name="T114" fmla="*/ 849 w 865"/>
                <a:gd name="T115" fmla="*/ 28 h 42"/>
                <a:gd name="T116" fmla="*/ 851 w 865"/>
                <a:gd name="T117" fmla="*/ 25 h 42"/>
                <a:gd name="T118" fmla="*/ 853 w 865"/>
                <a:gd name="T119" fmla="*/ 22 h 42"/>
                <a:gd name="T120" fmla="*/ 856 w 865"/>
                <a:gd name="T121" fmla="*/ 18 h 42"/>
                <a:gd name="T122" fmla="*/ 859 w 865"/>
                <a:gd name="T123" fmla="*/ 12 h 42"/>
                <a:gd name="T124" fmla="*/ 864 w 865"/>
                <a:gd name="T125" fmla="*/ 4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865" h="42">
                  <a:moveTo>
                    <a:pt x="0" y="32"/>
                  </a:moveTo>
                  <a:lnTo>
                    <a:pt x="0" y="33"/>
                  </a:lnTo>
                  <a:lnTo>
                    <a:pt x="1" y="33"/>
                  </a:lnTo>
                  <a:lnTo>
                    <a:pt x="1" y="33"/>
                  </a:lnTo>
                  <a:lnTo>
                    <a:pt x="2" y="33"/>
                  </a:lnTo>
                  <a:lnTo>
                    <a:pt x="3" y="33"/>
                  </a:lnTo>
                  <a:lnTo>
                    <a:pt x="4" y="34"/>
                  </a:lnTo>
                  <a:lnTo>
                    <a:pt x="4" y="34"/>
                  </a:lnTo>
                  <a:lnTo>
                    <a:pt x="6" y="34"/>
                  </a:lnTo>
                  <a:lnTo>
                    <a:pt x="7" y="35"/>
                  </a:lnTo>
                  <a:lnTo>
                    <a:pt x="8" y="35"/>
                  </a:lnTo>
                  <a:lnTo>
                    <a:pt x="8" y="35"/>
                  </a:lnTo>
                  <a:lnTo>
                    <a:pt x="9" y="35"/>
                  </a:lnTo>
                  <a:lnTo>
                    <a:pt x="9" y="36"/>
                  </a:lnTo>
                  <a:lnTo>
                    <a:pt x="10" y="36"/>
                  </a:lnTo>
                  <a:lnTo>
                    <a:pt x="10" y="36"/>
                  </a:lnTo>
                  <a:lnTo>
                    <a:pt x="10" y="36"/>
                  </a:lnTo>
                  <a:lnTo>
                    <a:pt x="10" y="36"/>
                  </a:lnTo>
                  <a:lnTo>
                    <a:pt x="11" y="36"/>
                  </a:lnTo>
                  <a:lnTo>
                    <a:pt x="11" y="36"/>
                  </a:lnTo>
                  <a:lnTo>
                    <a:pt x="11" y="36"/>
                  </a:lnTo>
                  <a:lnTo>
                    <a:pt x="12" y="36"/>
                  </a:lnTo>
                  <a:lnTo>
                    <a:pt x="12" y="37"/>
                  </a:lnTo>
                  <a:lnTo>
                    <a:pt x="13" y="37"/>
                  </a:lnTo>
                  <a:lnTo>
                    <a:pt x="13" y="37"/>
                  </a:lnTo>
                  <a:lnTo>
                    <a:pt x="14" y="37"/>
                  </a:lnTo>
                  <a:lnTo>
                    <a:pt x="14" y="37"/>
                  </a:lnTo>
                  <a:lnTo>
                    <a:pt x="15" y="37"/>
                  </a:lnTo>
                  <a:lnTo>
                    <a:pt x="15" y="37"/>
                  </a:lnTo>
                  <a:lnTo>
                    <a:pt x="16" y="37"/>
                  </a:lnTo>
                  <a:lnTo>
                    <a:pt x="17" y="37"/>
                  </a:lnTo>
                  <a:lnTo>
                    <a:pt x="17" y="38"/>
                  </a:lnTo>
                  <a:lnTo>
                    <a:pt x="18" y="38"/>
                  </a:lnTo>
                  <a:lnTo>
                    <a:pt x="18" y="38"/>
                  </a:lnTo>
                  <a:lnTo>
                    <a:pt x="19" y="38"/>
                  </a:lnTo>
                  <a:lnTo>
                    <a:pt x="20" y="38"/>
                  </a:lnTo>
                  <a:lnTo>
                    <a:pt x="20" y="38"/>
                  </a:lnTo>
                  <a:lnTo>
                    <a:pt x="21" y="38"/>
                  </a:lnTo>
                  <a:lnTo>
                    <a:pt x="22" y="38"/>
                  </a:lnTo>
                  <a:lnTo>
                    <a:pt x="23" y="38"/>
                  </a:lnTo>
                  <a:lnTo>
                    <a:pt x="24" y="38"/>
                  </a:lnTo>
                  <a:lnTo>
                    <a:pt x="24" y="38"/>
                  </a:lnTo>
                  <a:lnTo>
                    <a:pt x="25" y="38"/>
                  </a:lnTo>
                  <a:lnTo>
                    <a:pt x="27" y="38"/>
                  </a:lnTo>
                  <a:lnTo>
                    <a:pt x="28" y="38"/>
                  </a:lnTo>
                  <a:lnTo>
                    <a:pt x="29" y="38"/>
                  </a:lnTo>
                  <a:lnTo>
                    <a:pt x="31" y="38"/>
                  </a:lnTo>
                  <a:lnTo>
                    <a:pt x="32" y="38"/>
                  </a:lnTo>
                  <a:lnTo>
                    <a:pt x="35" y="38"/>
                  </a:lnTo>
                  <a:lnTo>
                    <a:pt x="37" y="38"/>
                  </a:lnTo>
                  <a:lnTo>
                    <a:pt x="38" y="38"/>
                  </a:lnTo>
                  <a:lnTo>
                    <a:pt x="40" y="38"/>
                  </a:lnTo>
                  <a:lnTo>
                    <a:pt x="41" y="38"/>
                  </a:lnTo>
                  <a:lnTo>
                    <a:pt x="43" y="39"/>
                  </a:lnTo>
                  <a:lnTo>
                    <a:pt x="45" y="39"/>
                  </a:lnTo>
                  <a:lnTo>
                    <a:pt x="46" y="39"/>
                  </a:lnTo>
                  <a:lnTo>
                    <a:pt x="49" y="39"/>
                  </a:lnTo>
                  <a:lnTo>
                    <a:pt x="53" y="39"/>
                  </a:lnTo>
                  <a:lnTo>
                    <a:pt x="58" y="39"/>
                  </a:lnTo>
                  <a:lnTo>
                    <a:pt x="61" y="39"/>
                  </a:lnTo>
                  <a:lnTo>
                    <a:pt x="63" y="39"/>
                  </a:lnTo>
                  <a:lnTo>
                    <a:pt x="65" y="39"/>
                  </a:lnTo>
                  <a:lnTo>
                    <a:pt x="66" y="39"/>
                  </a:lnTo>
                  <a:lnTo>
                    <a:pt x="67" y="39"/>
                  </a:lnTo>
                  <a:lnTo>
                    <a:pt x="70" y="39"/>
                  </a:lnTo>
                  <a:lnTo>
                    <a:pt x="73" y="39"/>
                  </a:lnTo>
                  <a:lnTo>
                    <a:pt x="77" y="39"/>
                  </a:lnTo>
                  <a:lnTo>
                    <a:pt x="81" y="39"/>
                  </a:lnTo>
                  <a:lnTo>
                    <a:pt x="85" y="39"/>
                  </a:lnTo>
                  <a:lnTo>
                    <a:pt x="90" y="39"/>
                  </a:lnTo>
                  <a:lnTo>
                    <a:pt x="94" y="39"/>
                  </a:lnTo>
                  <a:lnTo>
                    <a:pt x="96" y="39"/>
                  </a:lnTo>
                  <a:lnTo>
                    <a:pt x="98" y="39"/>
                  </a:lnTo>
                  <a:lnTo>
                    <a:pt x="100" y="39"/>
                  </a:lnTo>
                  <a:lnTo>
                    <a:pt x="102" y="39"/>
                  </a:lnTo>
                  <a:lnTo>
                    <a:pt x="104" y="39"/>
                  </a:lnTo>
                  <a:lnTo>
                    <a:pt x="105" y="39"/>
                  </a:lnTo>
                  <a:lnTo>
                    <a:pt x="107" y="39"/>
                  </a:lnTo>
                  <a:lnTo>
                    <a:pt x="109" y="39"/>
                  </a:lnTo>
                  <a:lnTo>
                    <a:pt x="111" y="39"/>
                  </a:lnTo>
                  <a:lnTo>
                    <a:pt x="113" y="39"/>
                  </a:lnTo>
                  <a:lnTo>
                    <a:pt x="115" y="39"/>
                  </a:lnTo>
                  <a:lnTo>
                    <a:pt x="117" y="39"/>
                  </a:lnTo>
                  <a:lnTo>
                    <a:pt x="118" y="39"/>
                  </a:lnTo>
                  <a:lnTo>
                    <a:pt x="119" y="39"/>
                  </a:lnTo>
                  <a:lnTo>
                    <a:pt x="121" y="39"/>
                  </a:lnTo>
                  <a:lnTo>
                    <a:pt x="121" y="39"/>
                  </a:lnTo>
                  <a:lnTo>
                    <a:pt x="123" y="39"/>
                  </a:lnTo>
                  <a:lnTo>
                    <a:pt x="125" y="39"/>
                  </a:lnTo>
                  <a:lnTo>
                    <a:pt x="126" y="39"/>
                  </a:lnTo>
                  <a:lnTo>
                    <a:pt x="129" y="39"/>
                  </a:lnTo>
                  <a:lnTo>
                    <a:pt x="131" y="39"/>
                  </a:lnTo>
                  <a:lnTo>
                    <a:pt x="133" y="39"/>
                  </a:lnTo>
                  <a:lnTo>
                    <a:pt x="135" y="39"/>
                  </a:lnTo>
                  <a:lnTo>
                    <a:pt x="137" y="39"/>
                  </a:lnTo>
                  <a:lnTo>
                    <a:pt x="139" y="39"/>
                  </a:lnTo>
                  <a:lnTo>
                    <a:pt x="141" y="39"/>
                  </a:lnTo>
                  <a:lnTo>
                    <a:pt x="143" y="39"/>
                  </a:lnTo>
                  <a:lnTo>
                    <a:pt x="145" y="39"/>
                  </a:lnTo>
                  <a:lnTo>
                    <a:pt x="146" y="39"/>
                  </a:lnTo>
                  <a:lnTo>
                    <a:pt x="149" y="39"/>
                  </a:lnTo>
                  <a:lnTo>
                    <a:pt x="155" y="39"/>
                  </a:lnTo>
                  <a:lnTo>
                    <a:pt x="158" y="39"/>
                  </a:lnTo>
                  <a:lnTo>
                    <a:pt x="161" y="40"/>
                  </a:lnTo>
                  <a:lnTo>
                    <a:pt x="163" y="40"/>
                  </a:lnTo>
                  <a:lnTo>
                    <a:pt x="166" y="40"/>
                  </a:lnTo>
                  <a:lnTo>
                    <a:pt x="168" y="40"/>
                  </a:lnTo>
                  <a:lnTo>
                    <a:pt x="171" y="40"/>
                  </a:lnTo>
                  <a:lnTo>
                    <a:pt x="172" y="40"/>
                  </a:lnTo>
                  <a:lnTo>
                    <a:pt x="175" y="40"/>
                  </a:lnTo>
                  <a:lnTo>
                    <a:pt x="177" y="40"/>
                  </a:lnTo>
                  <a:lnTo>
                    <a:pt x="179" y="40"/>
                  </a:lnTo>
                  <a:lnTo>
                    <a:pt x="181" y="40"/>
                  </a:lnTo>
                  <a:lnTo>
                    <a:pt x="183" y="40"/>
                  </a:lnTo>
                  <a:lnTo>
                    <a:pt x="185" y="40"/>
                  </a:lnTo>
                  <a:lnTo>
                    <a:pt x="187" y="40"/>
                  </a:lnTo>
                  <a:lnTo>
                    <a:pt x="189" y="40"/>
                  </a:lnTo>
                  <a:lnTo>
                    <a:pt x="191" y="40"/>
                  </a:lnTo>
                  <a:lnTo>
                    <a:pt x="193" y="40"/>
                  </a:lnTo>
                  <a:lnTo>
                    <a:pt x="195" y="40"/>
                  </a:lnTo>
                  <a:lnTo>
                    <a:pt x="197" y="40"/>
                  </a:lnTo>
                  <a:lnTo>
                    <a:pt x="198" y="40"/>
                  </a:lnTo>
                  <a:lnTo>
                    <a:pt x="200" y="40"/>
                  </a:lnTo>
                  <a:lnTo>
                    <a:pt x="201" y="40"/>
                  </a:lnTo>
                  <a:lnTo>
                    <a:pt x="202" y="40"/>
                  </a:lnTo>
                  <a:lnTo>
                    <a:pt x="203" y="40"/>
                  </a:lnTo>
                  <a:lnTo>
                    <a:pt x="204" y="40"/>
                  </a:lnTo>
                  <a:lnTo>
                    <a:pt x="205" y="40"/>
                  </a:lnTo>
                  <a:lnTo>
                    <a:pt x="206" y="40"/>
                  </a:lnTo>
                  <a:lnTo>
                    <a:pt x="208" y="40"/>
                  </a:lnTo>
                  <a:lnTo>
                    <a:pt x="209" y="40"/>
                  </a:lnTo>
                  <a:lnTo>
                    <a:pt x="210" y="40"/>
                  </a:lnTo>
                  <a:lnTo>
                    <a:pt x="211" y="40"/>
                  </a:lnTo>
                  <a:lnTo>
                    <a:pt x="213" y="40"/>
                  </a:lnTo>
                  <a:lnTo>
                    <a:pt x="214" y="40"/>
                  </a:lnTo>
                  <a:lnTo>
                    <a:pt x="216" y="40"/>
                  </a:lnTo>
                  <a:lnTo>
                    <a:pt x="219" y="39"/>
                  </a:lnTo>
                  <a:lnTo>
                    <a:pt x="221" y="39"/>
                  </a:lnTo>
                  <a:lnTo>
                    <a:pt x="224" y="39"/>
                  </a:lnTo>
                  <a:lnTo>
                    <a:pt x="225" y="39"/>
                  </a:lnTo>
                  <a:lnTo>
                    <a:pt x="226" y="39"/>
                  </a:lnTo>
                  <a:lnTo>
                    <a:pt x="227" y="39"/>
                  </a:lnTo>
                  <a:lnTo>
                    <a:pt x="228" y="39"/>
                  </a:lnTo>
                  <a:lnTo>
                    <a:pt x="229" y="39"/>
                  </a:lnTo>
                  <a:lnTo>
                    <a:pt x="231" y="39"/>
                  </a:lnTo>
                  <a:lnTo>
                    <a:pt x="232" y="39"/>
                  </a:lnTo>
                  <a:lnTo>
                    <a:pt x="233" y="39"/>
                  </a:lnTo>
                  <a:lnTo>
                    <a:pt x="234" y="39"/>
                  </a:lnTo>
                  <a:lnTo>
                    <a:pt x="235" y="39"/>
                  </a:lnTo>
                  <a:lnTo>
                    <a:pt x="237" y="39"/>
                  </a:lnTo>
                  <a:lnTo>
                    <a:pt x="238" y="39"/>
                  </a:lnTo>
                  <a:lnTo>
                    <a:pt x="240" y="39"/>
                  </a:lnTo>
                  <a:lnTo>
                    <a:pt x="242" y="39"/>
                  </a:lnTo>
                  <a:lnTo>
                    <a:pt x="244" y="39"/>
                  </a:lnTo>
                  <a:lnTo>
                    <a:pt x="246" y="39"/>
                  </a:lnTo>
                  <a:lnTo>
                    <a:pt x="248" y="39"/>
                  </a:lnTo>
                  <a:lnTo>
                    <a:pt x="250" y="39"/>
                  </a:lnTo>
                  <a:lnTo>
                    <a:pt x="251" y="39"/>
                  </a:lnTo>
                  <a:lnTo>
                    <a:pt x="252" y="39"/>
                  </a:lnTo>
                  <a:lnTo>
                    <a:pt x="254" y="39"/>
                  </a:lnTo>
                  <a:lnTo>
                    <a:pt x="257" y="39"/>
                  </a:lnTo>
                  <a:lnTo>
                    <a:pt x="259" y="39"/>
                  </a:lnTo>
                  <a:lnTo>
                    <a:pt x="262" y="40"/>
                  </a:lnTo>
                  <a:lnTo>
                    <a:pt x="264" y="40"/>
                  </a:lnTo>
                  <a:lnTo>
                    <a:pt x="267" y="40"/>
                  </a:lnTo>
                  <a:lnTo>
                    <a:pt x="270" y="40"/>
                  </a:lnTo>
                  <a:lnTo>
                    <a:pt x="273" y="40"/>
                  </a:lnTo>
                  <a:lnTo>
                    <a:pt x="276" y="40"/>
                  </a:lnTo>
                  <a:lnTo>
                    <a:pt x="278" y="40"/>
                  </a:lnTo>
                  <a:lnTo>
                    <a:pt x="279" y="40"/>
                  </a:lnTo>
                  <a:lnTo>
                    <a:pt x="280" y="40"/>
                  </a:lnTo>
                  <a:lnTo>
                    <a:pt x="282" y="40"/>
                  </a:lnTo>
                  <a:lnTo>
                    <a:pt x="283" y="40"/>
                  </a:lnTo>
                  <a:lnTo>
                    <a:pt x="285" y="40"/>
                  </a:lnTo>
                  <a:lnTo>
                    <a:pt x="287" y="40"/>
                  </a:lnTo>
                  <a:lnTo>
                    <a:pt x="288" y="40"/>
                  </a:lnTo>
                  <a:lnTo>
                    <a:pt x="290" y="40"/>
                  </a:lnTo>
                  <a:lnTo>
                    <a:pt x="292" y="40"/>
                  </a:lnTo>
                  <a:lnTo>
                    <a:pt x="296" y="40"/>
                  </a:lnTo>
                  <a:lnTo>
                    <a:pt x="300" y="40"/>
                  </a:lnTo>
                  <a:lnTo>
                    <a:pt x="303" y="40"/>
                  </a:lnTo>
                  <a:lnTo>
                    <a:pt x="306" y="40"/>
                  </a:lnTo>
                  <a:lnTo>
                    <a:pt x="308" y="40"/>
                  </a:lnTo>
                  <a:lnTo>
                    <a:pt x="311" y="40"/>
                  </a:lnTo>
                  <a:lnTo>
                    <a:pt x="314" y="40"/>
                  </a:lnTo>
                  <a:lnTo>
                    <a:pt x="318" y="40"/>
                  </a:lnTo>
                  <a:lnTo>
                    <a:pt x="321" y="40"/>
                  </a:lnTo>
                  <a:lnTo>
                    <a:pt x="324" y="40"/>
                  </a:lnTo>
                  <a:lnTo>
                    <a:pt x="326" y="40"/>
                  </a:lnTo>
                  <a:lnTo>
                    <a:pt x="328" y="40"/>
                  </a:lnTo>
                  <a:lnTo>
                    <a:pt x="330" y="40"/>
                  </a:lnTo>
                  <a:lnTo>
                    <a:pt x="331" y="40"/>
                  </a:lnTo>
                  <a:lnTo>
                    <a:pt x="332" y="40"/>
                  </a:lnTo>
                  <a:lnTo>
                    <a:pt x="334" y="40"/>
                  </a:lnTo>
                  <a:lnTo>
                    <a:pt x="336" y="40"/>
                  </a:lnTo>
                  <a:lnTo>
                    <a:pt x="339" y="40"/>
                  </a:lnTo>
                  <a:lnTo>
                    <a:pt x="341" y="40"/>
                  </a:lnTo>
                  <a:lnTo>
                    <a:pt x="343" y="40"/>
                  </a:lnTo>
                  <a:lnTo>
                    <a:pt x="346" y="41"/>
                  </a:lnTo>
                  <a:lnTo>
                    <a:pt x="349" y="41"/>
                  </a:lnTo>
                  <a:lnTo>
                    <a:pt x="352" y="41"/>
                  </a:lnTo>
                  <a:lnTo>
                    <a:pt x="354" y="41"/>
                  </a:lnTo>
                  <a:lnTo>
                    <a:pt x="357" y="41"/>
                  </a:lnTo>
                  <a:lnTo>
                    <a:pt x="360" y="41"/>
                  </a:lnTo>
                  <a:lnTo>
                    <a:pt x="363" y="41"/>
                  </a:lnTo>
                  <a:lnTo>
                    <a:pt x="365" y="41"/>
                  </a:lnTo>
                  <a:lnTo>
                    <a:pt x="366" y="41"/>
                  </a:lnTo>
                  <a:lnTo>
                    <a:pt x="368" y="41"/>
                  </a:lnTo>
                  <a:lnTo>
                    <a:pt x="369" y="41"/>
                  </a:lnTo>
                  <a:lnTo>
                    <a:pt x="371" y="41"/>
                  </a:lnTo>
                  <a:lnTo>
                    <a:pt x="374" y="41"/>
                  </a:lnTo>
                  <a:lnTo>
                    <a:pt x="378" y="41"/>
                  </a:lnTo>
                  <a:lnTo>
                    <a:pt x="383" y="41"/>
                  </a:lnTo>
                  <a:lnTo>
                    <a:pt x="388" y="41"/>
                  </a:lnTo>
                  <a:lnTo>
                    <a:pt x="392" y="41"/>
                  </a:lnTo>
                  <a:lnTo>
                    <a:pt x="397" y="41"/>
                  </a:lnTo>
                  <a:lnTo>
                    <a:pt x="401" y="41"/>
                  </a:lnTo>
                  <a:lnTo>
                    <a:pt x="404" y="41"/>
                  </a:lnTo>
                  <a:lnTo>
                    <a:pt x="406" y="41"/>
                  </a:lnTo>
                  <a:lnTo>
                    <a:pt x="409" y="41"/>
                  </a:lnTo>
                  <a:lnTo>
                    <a:pt x="412" y="41"/>
                  </a:lnTo>
                  <a:lnTo>
                    <a:pt x="415" y="41"/>
                  </a:lnTo>
                  <a:lnTo>
                    <a:pt x="417" y="41"/>
                  </a:lnTo>
                  <a:lnTo>
                    <a:pt x="421" y="40"/>
                  </a:lnTo>
                  <a:lnTo>
                    <a:pt x="425" y="40"/>
                  </a:lnTo>
                  <a:lnTo>
                    <a:pt x="428" y="40"/>
                  </a:lnTo>
                  <a:lnTo>
                    <a:pt x="431" y="40"/>
                  </a:lnTo>
                  <a:lnTo>
                    <a:pt x="433" y="40"/>
                  </a:lnTo>
                  <a:lnTo>
                    <a:pt x="435" y="40"/>
                  </a:lnTo>
                  <a:lnTo>
                    <a:pt x="438" y="40"/>
                  </a:lnTo>
                  <a:lnTo>
                    <a:pt x="441" y="40"/>
                  </a:lnTo>
                  <a:lnTo>
                    <a:pt x="445" y="40"/>
                  </a:lnTo>
                  <a:lnTo>
                    <a:pt x="449" y="40"/>
                  </a:lnTo>
                  <a:lnTo>
                    <a:pt x="453" y="40"/>
                  </a:lnTo>
                  <a:lnTo>
                    <a:pt x="457" y="40"/>
                  </a:lnTo>
                  <a:lnTo>
                    <a:pt x="462" y="40"/>
                  </a:lnTo>
                  <a:lnTo>
                    <a:pt x="468" y="40"/>
                  </a:lnTo>
                  <a:lnTo>
                    <a:pt x="472" y="40"/>
                  </a:lnTo>
                  <a:lnTo>
                    <a:pt x="477" y="40"/>
                  </a:lnTo>
                  <a:lnTo>
                    <a:pt x="481" y="40"/>
                  </a:lnTo>
                  <a:lnTo>
                    <a:pt x="486" y="40"/>
                  </a:lnTo>
                  <a:lnTo>
                    <a:pt x="489" y="40"/>
                  </a:lnTo>
                  <a:lnTo>
                    <a:pt x="493" y="40"/>
                  </a:lnTo>
                  <a:lnTo>
                    <a:pt x="496" y="40"/>
                  </a:lnTo>
                  <a:lnTo>
                    <a:pt x="498" y="40"/>
                  </a:lnTo>
                  <a:lnTo>
                    <a:pt x="501" y="40"/>
                  </a:lnTo>
                  <a:lnTo>
                    <a:pt x="505" y="40"/>
                  </a:lnTo>
                  <a:lnTo>
                    <a:pt x="509" y="40"/>
                  </a:lnTo>
                  <a:lnTo>
                    <a:pt x="513" y="40"/>
                  </a:lnTo>
                  <a:lnTo>
                    <a:pt x="516" y="40"/>
                  </a:lnTo>
                  <a:lnTo>
                    <a:pt x="519" y="40"/>
                  </a:lnTo>
                  <a:lnTo>
                    <a:pt x="521" y="40"/>
                  </a:lnTo>
                  <a:lnTo>
                    <a:pt x="524" y="40"/>
                  </a:lnTo>
                  <a:lnTo>
                    <a:pt x="527" y="40"/>
                  </a:lnTo>
                  <a:lnTo>
                    <a:pt x="530" y="40"/>
                  </a:lnTo>
                  <a:lnTo>
                    <a:pt x="533" y="40"/>
                  </a:lnTo>
                  <a:lnTo>
                    <a:pt x="537" y="40"/>
                  </a:lnTo>
                  <a:lnTo>
                    <a:pt x="543" y="40"/>
                  </a:lnTo>
                  <a:lnTo>
                    <a:pt x="547" y="40"/>
                  </a:lnTo>
                  <a:lnTo>
                    <a:pt x="550" y="40"/>
                  </a:lnTo>
                  <a:lnTo>
                    <a:pt x="553" y="40"/>
                  </a:lnTo>
                  <a:lnTo>
                    <a:pt x="556" y="40"/>
                  </a:lnTo>
                  <a:lnTo>
                    <a:pt x="559" y="40"/>
                  </a:lnTo>
                  <a:lnTo>
                    <a:pt x="564" y="40"/>
                  </a:lnTo>
                  <a:lnTo>
                    <a:pt x="570" y="40"/>
                  </a:lnTo>
                  <a:lnTo>
                    <a:pt x="574" y="40"/>
                  </a:lnTo>
                  <a:lnTo>
                    <a:pt x="577" y="40"/>
                  </a:lnTo>
                  <a:lnTo>
                    <a:pt x="579" y="40"/>
                  </a:lnTo>
                  <a:lnTo>
                    <a:pt x="582" y="40"/>
                  </a:lnTo>
                  <a:lnTo>
                    <a:pt x="585" y="40"/>
                  </a:lnTo>
                  <a:lnTo>
                    <a:pt x="589" y="40"/>
                  </a:lnTo>
                  <a:lnTo>
                    <a:pt x="592" y="40"/>
                  </a:lnTo>
                  <a:lnTo>
                    <a:pt x="596" y="40"/>
                  </a:lnTo>
                  <a:lnTo>
                    <a:pt x="599" y="40"/>
                  </a:lnTo>
                  <a:lnTo>
                    <a:pt x="603" y="40"/>
                  </a:lnTo>
                  <a:lnTo>
                    <a:pt x="606" y="40"/>
                  </a:lnTo>
                  <a:lnTo>
                    <a:pt x="610" y="40"/>
                  </a:lnTo>
                  <a:lnTo>
                    <a:pt x="614" y="40"/>
                  </a:lnTo>
                  <a:lnTo>
                    <a:pt x="619" y="40"/>
                  </a:lnTo>
                  <a:lnTo>
                    <a:pt x="624" y="40"/>
                  </a:lnTo>
                  <a:lnTo>
                    <a:pt x="628" y="40"/>
                  </a:lnTo>
                  <a:lnTo>
                    <a:pt x="631" y="40"/>
                  </a:lnTo>
                  <a:lnTo>
                    <a:pt x="634" y="40"/>
                  </a:lnTo>
                  <a:lnTo>
                    <a:pt x="638" y="40"/>
                  </a:lnTo>
                  <a:lnTo>
                    <a:pt x="643" y="40"/>
                  </a:lnTo>
                  <a:lnTo>
                    <a:pt x="648" y="40"/>
                  </a:lnTo>
                  <a:lnTo>
                    <a:pt x="654" y="40"/>
                  </a:lnTo>
                  <a:lnTo>
                    <a:pt x="662" y="40"/>
                  </a:lnTo>
                  <a:lnTo>
                    <a:pt x="666" y="40"/>
                  </a:lnTo>
                  <a:lnTo>
                    <a:pt x="671" y="40"/>
                  </a:lnTo>
                  <a:lnTo>
                    <a:pt x="676" y="40"/>
                  </a:lnTo>
                  <a:lnTo>
                    <a:pt x="681" y="40"/>
                  </a:lnTo>
                  <a:lnTo>
                    <a:pt x="687" y="40"/>
                  </a:lnTo>
                  <a:lnTo>
                    <a:pt x="692" y="40"/>
                  </a:lnTo>
                  <a:lnTo>
                    <a:pt x="695" y="40"/>
                  </a:lnTo>
                  <a:lnTo>
                    <a:pt x="699" y="40"/>
                  </a:lnTo>
                  <a:lnTo>
                    <a:pt x="701" y="40"/>
                  </a:lnTo>
                  <a:lnTo>
                    <a:pt x="703" y="40"/>
                  </a:lnTo>
                  <a:lnTo>
                    <a:pt x="705" y="40"/>
                  </a:lnTo>
                  <a:lnTo>
                    <a:pt x="707" y="40"/>
                  </a:lnTo>
                  <a:lnTo>
                    <a:pt x="708" y="40"/>
                  </a:lnTo>
                  <a:lnTo>
                    <a:pt x="709" y="40"/>
                  </a:lnTo>
                  <a:lnTo>
                    <a:pt x="711" y="40"/>
                  </a:lnTo>
                  <a:lnTo>
                    <a:pt x="713" y="40"/>
                  </a:lnTo>
                  <a:lnTo>
                    <a:pt x="715" y="40"/>
                  </a:lnTo>
                  <a:lnTo>
                    <a:pt x="718" y="40"/>
                  </a:lnTo>
                  <a:lnTo>
                    <a:pt x="722" y="40"/>
                  </a:lnTo>
                  <a:lnTo>
                    <a:pt x="726" y="40"/>
                  </a:lnTo>
                  <a:lnTo>
                    <a:pt x="729" y="40"/>
                  </a:lnTo>
                  <a:lnTo>
                    <a:pt x="731" y="40"/>
                  </a:lnTo>
                  <a:lnTo>
                    <a:pt x="733" y="40"/>
                  </a:lnTo>
                  <a:lnTo>
                    <a:pt x="735" y="40"/>
                  </a:lnTo>
                  <a:lnTo>
                    <a:pt x="737" y="40"/>
                  </a:lnTo>
                  <a:lnTo>
                    <a:pt x="740" y="40"/>
                  </a:lnTo>
                  <a:lnTo>
                    <a:pt x="743" y="40"/>
                  </a:lnTo>
                  <a:lnTo>
                    <a:pt x="744" y="40"/>
                  </a:lnTo>
                  <a:lnTo>
                    <a:pt x="746" y="40"/>
                  </a:lnTo>
                  <a:lnTo>
                    <a:pt x="747" y="40"/>
                  </a:lnTo>
                  <a:lnTo>
                    <a:pt x="748" y="40"/>
                  </a:lnTo>
                  <a:lnTo>
                    <a:pt x="750" y="40"/>
                  </a:lnTo>
                  <a:lnTo>
                    <a:pt x="751" y="40"/>
                  </a:lnTo>
                  <a:lnTo>
                    <a:pt x="752" y="40"/>
                  </a:lnTo>
                  <a:lnTo>
                    <a:pt x="754" y="40"/>
                  </a:lnTo>
                  <a:lnTo>
                    <a:pt x="755" y="40"/>
                  </a:lnTo>
                  <a:lnTo>
                    <a:pt x="756" y="40"/>
                  </a:lnTo>
                  <a:lnTo>
                    <a:pt x="757" y="40"/>
                  </a:lnTo>
                  <a:lnTo>
                    <a:pt x="758" y="40"/>
                  </a:lnTo>
                  <a:lnTo>
                    <a:pt x="759" y="40"/>
                  </a:lnTo>
                  <a:lnTo>
                    <a:pt x="760" y="40"/>
                  </a:lnTo>
                  <a:lnTo>
                    <a:pt x="760" y="40"/>
                  </a:lnTo>
                  <a:lnTo>
                    <a:pt x="761" y="40"/>
                  </a:lnTo>
                  <a:lnTo>
                    <a:pt x="761" y="40"/>
                  </a:lnTo>
                  <a:lnTo>
                    <a:pt x="762" y="40"/>
                  </a:lnTo>
                  <a:lnTo>
                    <a:pt x="763" y="40"/>
                  </a:lnTo>
                  <a:lnTo>
                    <a:pt x="765" y="40"/>
                  </a:lnTo>
                  <a:lnTo>
                    <a:pt x="766" y="40"/>
                  </a:lnTo>
                  <a:lnTo>
                    <a:pt x="767" y="41"/>
                  </a:lnTo>
                  <a:lnTo>
                    <a:pt x="769" y="41"/>
                  </a:lnTo>
                  <a:lnTo>
                    <a:pt x="770" y="41"/>
                  </a:lnTo>
                  <a:lnTo>
                    <a:pt x="772" y="41"/>
                  </a:lnTo>
                  <a:lnTo>
                    <a:pt x="773" y="41"/>
                  </a:lnTo>
                  <a:lnTo>
                    <a:pt x="774" y="41"/>
                  </a:lnTo>
                  <a:lnTo>
                    <a:pt x="775" y="42"/>
                  </a:lnTo>
                  <a:lnTo>
                    <a:pt x="777" y="42"/>
                  </a:lnTo>
                  <a:lnTo>
                    <a:pt x="777" y="42"/>
                  </a:lnTo>
                  <a:lnTo>
                    <a:pt x="778" y="42"/>
                  </a:lnTo>
                  <a:lnTo>
                    <a:pt x="779" y="42"/>
                  </a:lnTo>
                  <a:lnTo>
                    <a:pt x="780" y="42"/>
                  </a:lnTo>
                  <a:lnTo>
                    <a:pt x="781" y="42"/>
                  </a:lnTo>
                  <a:lnTo>
                    <a:pt x="782" y="42"/>
                  </a:lnTo>
                  <a:lnTo>
                    <a:pt x="783" y="42"/>
                  </a:lnTo>
                  <a:lnTo>
                    <a:pt x="784" y="42"/>
                  </a:lnTo>
                  <a:lnTo>
                    <a:pt x="785" y="42"/>
                  </a:lnTo>
                  <a:lnTo>
                    <a:pt x="786" y="42"/>
                  </a:lnTo>
                  <a:lnTo>
                    <a:pt x="786" y="42"/>
                  </a:lnTo>
                  <a:lnTo>
                    <a:pt x="787" y="42"/>
                  </a:lnTo>
                  <a:lnTo>
                    <a:pt x="788" y="42"/>
                  </a:lnTo>
                  <a:lnTo>
                    <a:pt x="788" y="42"/>
                  </a:lnTo>
                  <a:lnTo>
                    <a:pt x="789" y="42"/>
                  </a:lnTo>
                  <a:lnTo>
                    <a:pt x="790" y="42"/>
                  </a:lnTo>
                  <a:lnTo>
                    <a:pt x="791" y="42"/>
                  </a:lnTo>
                  <a:lnTo>
                    <a:pt x="793" y="42"/>
                  </a:lnTo>
                  <a:lnTo>
                    <a:pt x="794" y="41"/>
                  </a:lnTo>
                  <a:lnTo>
                    <a:pt x="796" y="41"/>
                  </a:lnTo>
                  <a:lnTo>
                    <a:pt x="797" y="41"/>
                  </a:lnTo>
                  <a:lnTo>
                    <a:pt x="799" y="41"/>
                  </a:lnTo>
                  <a:lnTo>
                    <a:pt x="800" y="41"/>
                  </a:lnTo>
                  <a:lnTo>
                    <a:pt x="801" y="41"/>
                  </a:lnTo>
                  <a:lnTo>
                    <a:pt x="803" y="41"/>
                  </a:lnTo>
                  <a:lnTo>
                    <a:pt x="805" y="40"/>
                  </a:lnTo>
                  <a:lnTo>
                    <a:pt x="807" y="40"/>
                  </a:lnTo>
                  <a:lnTo>
                    <a:pt x="809" y="40"/>
                  </a:lnTo>
                  <a:lnTo>
                    <a:pt x="810" y="40"/>
                  </a:lnTo>
                  <a:lnTo>
                    <a:pt x="811" y="40"/>
                  </a:lnTo>
                  <a:lnTo>
                    <a:pt x="812" y="40"/>
                  </a:lnTo>
                  <a:lnTo>
                    <a:pt x="813" y="40"/>
                  </a:lnTo>
                  <a:lnTo>
                    <a:pt x="813" y="40"/>
                  </a:lnTo>
                  <a:lnTo>
                    <a:pt x="813" y="39"/>
                  </a:lnTo>
                  <a:lnTo>
                    <a:pt x="815" y="39"/>
                  </a:lnTo>
                  <a:lnTo>
                    <a:pt x="816" y="39"/>
                  </a:lnTo>
                  <a:lnTo>
                    <a:pt x="818" y="39"/>
                  </a:lnTo>
                  <a:lnTo>
                    <a:pt x="819" y="39"/>
                  </a:lnTo>
                  <a:lnTo>
                    <a:pt x="820" y="39"/>
                  </a:lnTo>
                  <a:lnTo>
                    <a:pt x="821" y="39"/>
                  </a:lnTo>
                  <a:lnTo>
                    <a:pt x="822" y="39"/>
                  </a:lnTo>
                  <a:lnTo>
                    <a:pt x="824" y="39"/>
                  </a:lnTo>
                  <a:lnTo>
                    <a:pt x="825" y="39"/>
                  </a:lnTo>
                  <a:lnTo>
                    <a:pt x="826" y="39"/>
                  </a:lnTo>
                  <a:lnTo>
                    <a:pt x="827" y="38"/>
                  </a:lnTo>
                  <a:lnTo>
                    <a:pt x="828" y="38"/>
                  </a:lnTo>
                  <a:lnTo>
                    <a:pt x="829" y="38"/>
                  </a:lnTo>
                  <a:lnTo>
                    <a:pt x="829" y="38"/>
                  </a:lnTo>
                  <a:lnTo>
                    <a:pt x="830" y="38"/>
                  </a:lnTo>
                  <a:lnTo>
                    <a:pt x="831" y="38"/>
                  </a:lnTo>
                  <a:lnTo>
                    <a:pt x="831" y="38"/>
                  </a:lnTo>
                  <a:lnTo>
                    <a:pt x="832" y="38"/>
                  </a:lnTo>
                  <a:lnTo>
                    <a:pt x="832" y="38"/>
                  </a:lnTo>
                  <a:lnTo>
                    <a:pt x="833" y="38"/>
                  </a:lnTo>
                  <a:lnTo>
                    <a:pt x="833" y="38"/>
                  </a:lnTo>
                  <a:lnTo>
                    <a:pt x="834" y="38"/>
                  </a:lnTo>
                  <a:lnTo>
                    <a:pt x="834" y="38"/>
                  </a:lnTo>
                  <a:lnTo>
                    <a:pt x="835" y="37"/>
                  </a:lnTo>
                  <a:lnTo>
                    <a:pt x="835" y="37"/>
                  </a:lnTo>
                  <a:lnTo>
                    <a:pt x="835" y="37"/>
                  </a:lnTo>
                  <a:lnTo>
                    <a:pt x="836" y="37"/>
                  </a:lnTo>
                  <a:lnTo>
                    <a:pt x="836" y="37"/>
                  </a:lnTo>
                  <a:lnTo>
                    <a:pt x="837" y="37"/>
                  </a:lnTo>
                  <a:lnTo>
                    <a:pt x="837" y="37"/>
                  </a:lnTo>
                  <a:lnTo>
                    <a:pt x="837" y="37"/>
                  </a:lnTo>
                  <a:lnTo>
                    <a:pt x="838" y="37"/>
                  </a:lnTo>
                  <a:lnTo>
                    <a:pt x="838" y="37"/>
                  </a:lnTo>
                  <a:lnTo>
                    <a:pt x="838" y="36"/>
                  </a:lnTo>
                  <a:lnTo>
                    <a:pt x="838" y="36"/>
                  </a:lnTo>
                  <a:lnTo>
                    <a:pt x="838" y="36"/>
                  </a:lnTo>
                  <a:lnTo>
                    <a:pt x="839" y="36"/>
                  </a:lnTo>
                  <a:lnTo>
                    <a:pt x="839" y="36"/>
                  </a:lnTo>
                  <a:lnTo>
                    <a:pt x="839" y="36"/>
                  </a:lnTo>
                  <a:lnTo>
                    <a:pt x="839" y="36"/>
                  </a:lnTo>
                  <a:lnTo>
                    <a:pt x="839" y="36"/>
                  </a:lnTo>
                  <a:lnTo>
                    <a:pt x="839" y="36"/>
                  </a:lnTo>
                  <a:lnTo>
                    <a:pt x="839" y="36"/>
                  </a:lnTo>
                  <a:lnTo>
                    <a:pt x="840" y="36"/>
                  </a:lnTo>
                  <a:lnTo>
                    <a:pt x="840" y="36"/>
                  </a:lnTo>
                  <a:lnTo>
                    <a:pt x="840" y="36"/>
                  </a:lnTo>
                  <a:lnTo>
                    <a:pt x="840" y="35"/>
                  </a:lnTo>
                  <a:lnTo>
                    <a:pt x="840" y="35"/>
                  </a:lnTo>
                  <a:lnTo>
                    <a:pt x="840" y="35"/>
                  </a:lnTo>
                  <a:lnTo>
                    <a:pt x="840" y="35"/>
                  </a:lnTo>
                  <a:lnTo>
                    <a:pt x="840" y="35"/>
                  </a:lnTo>
                  <a:lnTo>
                    <a:pt x="840" y="35"/>
                  </a:lnTo>
                  <a:lnTo>
                    <a:pt x="841" y="35"/>
                  </a:lnTo>
                  <a:lnTo>
                    <a:pt x="841" y="35"/>
                  </a:lnTo>
                  <a:lnTo>
                    <a:pt x="841" y="35"/>
                  </a:lnTo>
                  <a:lnTo>
                    <a:pt x="841" y="35"/>
                  </a:lnTo>
                  <a:lnTo>
                    <a:pt x="841" y="35"/>
                  </a:lnTo>
                  <a:lnTo>
                    <a:pt x="841" y="35"/>
                  </a:lnTo>
                  <a:lnTo>
                    <a:pt x="842" y="34"/>
                  </a:lnTo>
                  <a:lnTo>
                    <a:pt x="842" y="34"/>
                  </a:lnTo>
                  <a:lnTo>
                    <a:pt x="842" y="34"/>
                  </a:lnTo>
                  <a:lnTo>
                    <a:pt x="843" y="34"/>
                  </a:lnTo>
                  <a:lnTo>
                    <a:pt x="843" y="34"/>
                  </a:lnTo>
                  <a:lnTo>
                    <a:pt x="843" y="33"/>
                  </a:lnTo>
                  <a:lnTo>
                    <a:pt x="844" y="33"/>
                  </a:lnTo>
                  <a:lnTo>
                    <a:pt x="844" y="33"/>
                  </a:lnTo>
                  <a:lnTo>
                    <a:pt x="844" y="33"/>
                  </a:lnTo>
                  <a:lnTo>
                    <a:pt x="844" y="32"/>
                  </a:lnTo>
                  <a:lnTo>
                    <a:pt x="845" y="32"/>
                  </a:lnTo>
                  <a:lnTo>
                    <a:pt x="845" y="32"/>
                  </a:lnTo>
                  <a:lnTo>
                    <a:pt x="845" y="32"/>
                  </a:lnTo>
                  <a:lnTo>
                    <a:pt x="845" y="32"/>
                  </a:lnTo>
                  <a:lnTo>
                    <a:pt x="846" y="31"/>
                  </a:lnTo>
                  <a:lnTo>
                    <a:pt x="846" y="31"/>
                  </a:lnTo>
                  <a:lnTo>
                    <a:pt x="846" y="31"/>
                  </a:lnTo>
                  <a:lnTo>
                    <a:pt x="846" y="31"/>
                  </a:lnTo>
                  <a:lnTo>
                    <a:pt x="847" y="30"/>
                  </a:lnTo>
                  <a:lnTo>
                    <a:pt x="847" y="30"/>
                  </a:lnTo>
                  <a:lnTo>
                    <a:pt x="847" y="30"/>
                  </a:lnTo>
                  <a:lnTo>
                    <a:pt x="847" y="29"/>
                  </a:lnTo>
                  <a:lnTo>
                    <a:pt x="848" y="29"/>
                  </a:lnTo>
                  <a:lnTo>
                    <a:pt x="848" y="29"/>
                  </a:lnTo>
                  <a:lnTo>
                    <a:pt x="848" y="29"/>
                  </a:lnTo>
                  <a:lnTo>
                    <a:pt x="848" y="28"/>
                  </a:lnTo>
                  <a:lnTo>
                    <a:pt x="849" y="28"/>
                  </a:lnTo>
                  <a:lnTo>
                    <a:pt x="849" y="28"/>
                  </a:lnTo>
                  <a:lnTo>
                    <a:pt x="849" y="27"/>
                  </a:lnTo>
                  <a:lnTo>
                    <a:pt x="850" y="27"/>
                  </a:lnTo>
                  <a:lnTo>
                    <a:pt x="850" y="27"/>
                  </a:lnTo>
                  <a:lnTo>
                    <a:pt x="850" y="27"/>
                  </a:lnTo>
                  <a:lnTo>
                    <a:pt x="850" y="26"/>
                  </a:lnTo>
                  <a:lnTo>
                    <a:pt x="851" y="26"/>
                  </a:lnTo>
                  <a:lnTo>
                    <a:pt x="851" y="26"/>
                  </a:lnTo>
                  <a:lnTo>
                    <a:pt x="851" y="25"/>
                  </a:lnTo>
                  <a:lnTo>
                    <a:pt x="851" y="25"/>
                  </a:lnTo>
                  <a:lnTo>
                    <a:pt x="852" y="24"/>
                  </a:lnTo>
                  <a:lnTo>
                    <a:pt x="852" y="24"/>
                  </a:lnTo>
                  <a:lnTo>
                    <a:pt x="852" y="24"/>
                  </a:lnTo>
                  <a:lnTo>
                    <a:pt x="853" y="23"/>
                  </a:lnTo>
                  <a:lnTo>
                    <a:pt x="853" y="23"/>
                  </a:lnTo>
                  <a:lnTo>
                    <a:pt x="853" y="22"/>
                  </a:lnTo>
                  <a:lnTo>
                    <a:pt x="853" y="22"/>
                  </a:lnTo>
                  <a:lnTo>
                    <a:pt x="854" y="22"/>
                  </a:lnTo>
                  <a:lnTo>
                    <a:pt x="854" y="21"/>
                  </a:lnTo>
                  <a:lnTo>
                    <a:pt x="854" y="21"/>
                  </a:lnTo>
                  <a:lnTo>
                    <a:pt x="855" y="20"/>
                  </a:lnTo>
                  <a:lnTo>
                    <a:pt x="855" y="19"/>
                  </a:lnTo>
                  <a:lnTo>
                    <a:pt x="855" y="19"/>
                  </a:lnTo>
                  <a:lnTo>
                    <a:pt x="856" y="18"/>
                  </a:lnTo>
                  <a:lnTo>
                    <a:pt x="856" y="18"/>
                  </a:lnTo>
                  <a:lnTo>
                    <a:pt x="856" y="17"/>
                  </a:lnTo>
                  <a:lnTo>
                    <a:pt x="857" y="17"/>
                  </a:lnTo>
                  <a:lnTo>
                    <a:pt x="857" y="16"/>
                  </a:lnTo>
                  <a:lnTo>
                    <a:pt x="858" y="15"/>
                  </a:lnTo>
                  <a:lnTo>
                    <a:pt x="858" y="15"/>
                  </a:lnTo>
                  <a:lnTo>
                    <a:pt x="858" y="14"/>
                  </a:lnTo>
                  <a:lnTo>
                    <a:pt x="859" y="13"/>
                  </a:lnTo>
                  <a:lnTo>
                    <a:pt x="859" y="12"/>
                  </a:lnTo>
                  <a:lnTo>
                    <a:pt x="860" y="11"/>
                  </a:lnTo>
                  <a:lnTo>
                    <a:pt x="860" y="10"/>
                  </a:lnTo>
                  <a:lnTo>
                    <a:pt x="861" y="9"/>
                  </a:lnTo>
                  <a:lnTo>
                    <a:pt x="861" y="8"/>
                  </a:lnTo>
                  <a:lnTo>
                    <a:pt x="862" y="7"/>
                  </a:lnTo>
                  <a:lnTo>
                    <a:pt x="863" y="6"/>
                  </a:lnTo>
                  <a:lnTo>
                    <a:pt x="863" y="5"/>
                  </a:lnTo>
                  <a:lnTo>
                    <a:pt x="864" y="4"/>
                  </a:lnTo>
                  <a:lnTo>
                    <a:pt x="864" y="2"/>
                  </a:lnTo>
                  <a:lnTo>
                    <a:pt x="864" y="2"/>
                  </a:lnTo>
                  <a:lnTo>
                    <a:pt x="865" y="2"/>
                  </a:lnTo>
                  <a:lnTo>
                    <a:pt x="865" y="1"/>
                  </a:lnTo>
                  <a:lnTo>
                    <a:pt x="865" y="1"/>
                  </a:lnTo>
                  <a:lnTo>
                    <a:pt x="865" y="1"/>
                  </a:lnTo>
                  <a:lnTo>
                    <a:pt x="865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Freeform 156"/>
            <p:cNvSpPr>
              <a:spLocks/>
            </p:cNvSpPr>
            <p:nvPr/>
          </p:nvSpPr>
          <p:spPr bwMode="auto">
            <a:xfrm>
              <a:off x="5030689" y="4906385"/>
              <a:ext cx="243129" cy="105004"/>
            </a:xfrm>
            <a:custGeom>
              <a:avLst/>
              <a:gdLst>
                <a:gd name="T0" fmla="*/ 1 w 196"/>
                <a:gd name="T1" fmla="*/ 36 h 80"/>
                <a:gd name="T2" fmla="*/ 1 w 196"/>
                <a:gd name="T3" fmla="*/ 35 h 80"/>
                <a:gd name="T4" fmla="*/ 2 w 196"/>
                <a:gd name="T5" fmla="*/ 34 h 80"/>
                <a:gd name="T6" fmla="*/ 8 w 196"/>
                <a:gd name="T7" fmla="*/ 21 h 80"/>
                <a:gd name="T8" fmla="*/ 11 w 196"/>
                <a:gd name="T9" fmla="*/ 14 h 80"/>
                <a:gd name="T10" fmla="*/ 14 w 196"/>
                <a:gd name="T11" fmla="*/ 9 h 80"/>
                <a:gd name="T12" fmla="*/ 16 w 196"/>
                <a:gd name="T13" fmla="*/ 6 h 80"/>
                <a:gd name="T14" fmla="*/ 19 w 196"/>
                <a:gd name="T15" fmla="*/ 2 h 80"/>
                <a:gd name="T16" fmla="*/ 22 w 196"/>
                <a:gd name="T17" fmla="*/ 0 h 80"/>
                <a:gd name="T18" fmla="*/ 26 w 196"/>
                <a:gd name="T19" fmla="*/ 0 h 80"/>
                <a:gd name="T20" fmla="*/ 28 w 196"/>
                <a:gd name="T21" fmla="*/ 1 h 80"/>
                <a:gd name="T22" fmla="*/ 30 w 196"/>
                <a:gd name="T23" fmla="*/ 2 h 80"/>
                <a:gd name="T24" fmla="*/ 35 w 196"/>
                <a:gd name="T25" fmla="*/ 5 h 80"/>
                <a:gd name="T26" fmla="*/ 38 w 196"/>
                <a:gd name="T27" fmla="*/ 9 h 80"/>
                <a:gd name="T28" fmla="*/ 43 w 196"/>
                <a:gd name="T29" fmla="*/ 16 h 80"/>
                <a:gd name="T30" fmla="*/ 51 w 196"/>
                <a:gd name="T31" fmla="*/ 28 h 80"/>
                <a:gd name="T32" fmla="*/ 54 w 196"/>
                <a:gd name="T33" fmla="*/ 32 h 80"/>
                <a:gd name="T34" fmla="*/ 55 w 196"/>
                <a:gd name="T35" fmla="*/ 34 h 80"/>
                <a:gd name="T36" fmla="*/ 58 w 196"/>
                <a:gd name="T37" fmla="*/ 37 h 80"/>
                <a:gd name="T38" fmla="*/ 62 w 196"/>
                <a:gd name="T39" fmla="*/ 42 h 80"/>
                <a:gd name="T40" fmla="*/ 66 w 196"/>
                <a:gd name="T41" fmla="*/ 46 h 80"/>
                <a:gd name="T42" fmla="*/ 69 w 196"/>
                <a:gd name="T43" fmla="*/ 50 h 80"/>
                <a:gd name="T44" fmla="*/ 72 w 196"/>
                <a:gd name="T45" fmla="*/ 53 h 80"/>
                <a:gd name="T46" fmla="*/ 75 w 196"/>
                <a:gd name="T47" fmla="*/ 55 h 80"/>
                <a:gd name="T48" fmla="*/ 78 w 196"/>
                <a:gd name="T49" fmla="*/ 58 h 80"/>
                <a:gd name="T50" fmla="*/ 80 w 196"/>
                <a:gd name="T51" fmla="*/ 59 h 80"/>
                <a:gd name="T52" fmla="*/ 82 w 196"/>
                <a:gd name="T53" fmla="*/ 60 h 80"/>
                <a:gd name="T54" fmla="*/ 83 w 196"/>
                <a:gd name="T55" fmla="*/ 61 h 80"/>
                <a:gd name="T56" fmla="*/ 84 w 196"/>
                <a:gd name="T57" fmla="*/ 62 h 80"/>
                <a:gd name="T58" fmla="*/ 87 w 196"/>
                <a:gd name="T59" fmla="*/ 63 h 80"/>
                <a:gd name="T60" fmla="*/ 89 w 196"/>
                <a:gd name="T61" fmla="*/ 65 h 80"/>
                <a:gd name="T62" fmla="*/ 92 w 196"/>
                <a:gd name="T63" fmla="*/ 66 h 80"/>
                <a:gd name="T64" fmla="*/ 95 w 196"/>
                <a:gd name="T65" fmla="*/ 67 h 80"/>
                <a:gd name="T66" fmla="*/ 98 w 196"/>
                <a:gd name="T67" fmla="*/ 69 h 80"/>
                <a:gd name="T68" fmla="*/ 101 w 196"/>
                <a:gd name="T69" fmla="*/ 70 h 80"/>
                <a:gd name="T70" fmla="*/ 104 w 196"/>
                <a:gd name="T71" fmla="*/ 71 h 80"/>
                <a:gd name="T72" fmla="*/ 108 w 196"/>
                <a:gd name="T73" fmla="*/ 72 h 80"/>
                <a:gd name="T74" fmla="*/ 110 w 196"/>
                <a:gd name="T75" fmla="*/ 73 h 80"/>
                <a:gd name="T76" fmla="*/ 112 w 196"/>
                <a:gd name="T77" fmla="*/ 73 h 80"/>
                <a:gd name="T78" fmla="*/ 116 w 196"/>
                <a:gd name="T79" fmla="*/ 74 h 80"/>
                <a:gd name="T80" fmla="*/ 122 w 196"/>
                <a:gd name="T81" fmla="*/ 75 h 80"/>
                <a:gd name="T82" fmla="*/ 128 w 196"/>
                <a:gd name="T83" fmla="*/ 77 h 80"/>
                <a:gd name="T84" fmla="*/ 134 w 196"/>
                <a:gd name="T85" fmla="*/ 77 h 80"/>
                <a:gd name="T86" fmla="*/ 138 w 196"/>
                <a:gd name="T87" fmla="*/ 78 h 80"/>
                <a:gd name="T88" fmla="*/ 144 w 196"/>
                <a:gd name="T89" fmla="*/ 78 h 80"/>
                <a:gd name="T90" fmla="*/ 154 w 196"/>
                <a:gd name="T91" fmla="*/ 79 h 80"/>
                <a:gd name="T92" fmla="*/ 163 w 196"/>
                <a:gd name="T93" fmla="*/ 79 h 80"/>
                <a:gd name="T94" fmla="*/ 170 w 196"/>
                <a:gd name="T95" fmla="*/ 79 h 80"/>
                <a:gd name="T96" fmla="*/ 177 w 196"/>
                <a:gd name="T97" fmla="*/ 80 h 80"/>
                <a:gd name="T98" fmla="*/ 184 w 196"/>
                <a:gd name="T99" fmla="*/ 80 h 80"/>
                <a:gd name="T100" fmla="*/ 191 w 196"/>
                <a:gd name="T101" fmla="*/ 8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96" h="80">
                  <a:moveTo>
                    <a:pt x="0" y="37"/>
                  </a:moveTo>
                  <a:lnTo>
                    <a:pt x="0" y="37"/>
                  </a:lnTo>
                  <a:lnTo>
                    <a:pt x="0" y="37"/>
                  </a:lnTo>
                  <a:lnTo>
                    <a:pt x="1" y="37"/>
                  </a:lnTo>
                  <a:lnTo>
                    <a:pt x="1" y="36"/>
                  </a:lnTo>
                  <a:lnTo>
                    <a:pt x="1" y="36"/>
                  </a:lnTo>
                  <a:lnTo>
                    <a:pt x="1" y="36"/>
                  </a:lnTo>
                  <a:lnTo>
                    <a:pt x="1" y="36"/>
                  </a:lnTo>
                  <a:lnTo>
                    <a:pt x="1" y="36"/>
                  </a:lnTo>
                  <a:lnTo>
                    <a:pt x="1" y="35"/>
                  </a:lnTo>
                  <a:lnTo>
                    <a:pt x="1" y="35"/>
                  </a:lnTo>
                  <a:lnTo>
                    <a:pt x="1" y="35"/>
                  </a:lnTo>
                  <a:lnTo>
                    <a:pt x="2" y="35"/>
                  </a:lnTo>
                  <a:lnTo>
                    <a:pt x="2" y="34"/>
                  </a:lnTo>
                  <a:lnTo>
                    <a:pt x="2" y="34"/>
                  </a:lnTo>
                  <a:lnTo>
                    <a:pt x="3" y="31"/>
                  </a:lnTo>
                  <a:lnTo>
                    <a:pt x="4" y="29"/>
                  </a:lnTo>
                  <a:lnTo>
                    <a:pt x="5" y="26"/>
                  </a:lnTo>
                  <a:lnTo>
                    <a:pt x="7" y="23"/>
                  </a:lnTo>
                  <a:lnTo>
                    <a:pt x="8" y="21"/>
                  </a:lnTo>
                  <a:lnTo>
                    <a:pt x="8" y="19"/>
                  </a:lnTo>
                  <a:lnTo>
                    <a:pt x="9" y="18"/>
                  </a:lnTo>
                  <a:lnTo>
                    <a:pt x="10" y="16"/>
                  </a:lnTo>
                  <a:lnTo>
                    <a:pt x="10" y="15"/>
                  </a:lnTo>
                  <a:lnTo>
                    <a:pt x="11" y="14"/>
                  </a:lnTo>
                  <a:lnTo>
                    <a:pt x="12" y="13"/>
                  </a:lnTo>
                  <a:lnTo>
                    <a:pt x="12" y="12"/>
                  </a:lnTo>
                  <a:lnTo>
                    <a:pt x="13" y="11"/>
                  </a:lnTo>
                  <a:lnTo>
                    <a:pt x="13" y="10"/>
                  </a:lnTo>
                  <a:lnTo>
                    <a:pt x="14" y="9"/>
                  </a:lnTo>
                  <a:lnTo>
                    <a:pt x="14" y="8"/>
                  </a:lnTo>
                  <a:lnTo>
                    <a:pt x="15" y="8"/>
                  </a:lnTo>
                  <a:lnTo>
                    <a:pt x="15" y="7"/>
                  </a:lnTo>
                  <a:lnTo>
                    <a:pt x="16" y="6"/>
                  </a:lnTo>
                  <a:lnTo>
                    <a:pt x="16" y="6"/>
                  </a:lnTo>
                  <a:lnTo>
                    <a:pt x="16" y="5"/>
                  </a:lnTo>
                  <a:lnTo>
                    <a:pt x="17" y="4"/>
                  </a:lnTo>
                  <a:lnTo>
                    <a:pt x="18" y="4"/>
                  </a:lnTo>
                  <a:lnTo>
                    <a:pt x="18" y="3"/>
                  </a:lnTo>
                  <a:lnTo>
                    <a:pt x="19" y="2"/>
                  </a:lnTo>
                  <a:lnTo>
                    <a:pt x="20" y="2"/>
                  </a:lnTo>
                  <a:lnTo>
                    <a:pt x="20" y="1"/>
                  </a:lnTo>
                  <a:lnTo>
                    <a:pt x="21" y="1"/>
                  </a:lnTo>
                  <a:lnTo>
                    <a:pt x="22" y="1"/>
                  </a:lnTo>
                  <a:lnTo>
                    <a:pt x="22" y="0"/>
                  </a:lnTo>
                  <a:lnTo>
                    <a:pt x="23" y="0"/>
                  </a:lnTo>
                  <a:lnTo>
                    <a:pt x="24" y="0"/>
                  </a:lnTo>
                  <a:lnTo>
                    <a:pt x="24" y="0"/>
                  </a:lnTo>
                  <a:lnTo>
                    <a:pt x="25" y="0"/>
                  </a:lnTo>
                  <a:lnTo>
                    <a:pt x="26" y="0"/>
                  </a:lnTo>
                  <a:lnTo>
                    <a:pt x="26" y="0"/>
                  </a:lnTo>
                  <a:lnTo>
                    <a:pt x="27" y="0"/>
                  </a:lnTo>
                  <a:lnTo>
                    <a:pt x="27" y="0"/>
                  </a:lnTo>
                  <a:lnTo>
                    <a:pt x="28" y="0"/>
                  </a:lnTo>
                  <a:lnTo>
                    <a:pt x="28" y="1"/>
                  </a:lnTo>
                  <a:lnTo>
                    <a:pt x="28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29" y="1"/>
                  </a:lnTo>
                  <a:lnTo>
                    <a:pt x="30" y="2"/>
                  </a:lnTo>
                  <a:lnTo>
                    <a:pt x="31" y="2"/>
                  </a:lnTo>
                  <a:lnTo>
                    <a:pt x="32" y="3"/>
                  </a:lnTo>
                  <a:lnTo>
                    <a:pt x="33" y="4"/>
                  </a:lnTo>
                  <a:lnTo>
                    <a:pt x="34" y="4"/>
                  </a:lnTo>
                  <a:lnTo>
                    <a:pt x="35" y="5"/>
                  </a:lnTo>
                  <a:lnTo>
                    <a:pt x="35" y="6"/>
                  </a:lnTo>
                  <a:lnTo>
                    <a:pt x="36" y="7"/>
                  </a:lnTo>
                  <a:lnTo>
                    <a:pt x="37" y="8"/>
                  </a:lnTo>
                  <a:lnTo>
                    <a:pt x="37" y="9"/>
                  </a:lnTo>
                  <a:lnTo>
                    <a:pt x="38" y="9"/>
                  </a:lnTo>
                  <a:lnTo>
                    <a:pt x="39" y="11"/>
                  </a:lnTo>
                  <a:lnTo>
                    <a:pt x="40" y="12"/>
                  </a:lnTo>
                  <a:lnTo>
                    <a:pt x="41" y="13"/>
                  </a:lnTo>
                  <a:lnTo>
                    <a:pt x="42" y="14"/>
                  </a:lnTo>
                  <a:lnTo>
                    <a:pt x="43" y="16"/>
                  </a:lnTo>
                  <a:lnTo>
                    <a:pt x="44" y="17"/>
                  </a:lnTo>
                  <a:lnTo>
                    <a:pt x="45" y="19"/>
                  </a:lnTo>
                  <a:lnTo>
                    <a:pt x="47" y="22"/>
                  </a:lnTo>
                  <a:lnTo>
                    <a:pt x="49" y="25"/>
                  </a:lnTo>
                  <a:lnTo>
                    <a:pt x="51" y="28"/>
                  </a:lnTo>
                  <a:lnTo>
                    <a:pt x="53" y="30"/>
                  </a:lnTo>
                  <a:lnTo>
                    <a:pt x="53" y="31"/>
                  </a:lnTo>
                  <a:lnTo>
                    <a:pt x="54" y="31"/>
                  </a:lnTo>
                  <a:lnTo>
                    <a:pt x="54" y="32"/>
                  </a:lnTo>
                  <a:lnTo>
                    <a:pt x="54" y="32"/>
                  </a:lnTo>
                  <a:lnTo>
                    <a:pt x="55" y="32"/>
                  </a:lnTo>
                  <a:lnTo>
                    <a:pt x="55" y="33"/>
                  </a:lnTo>
                  <a:lnTo>
                    <a:pt x="55" y="33"/>
                  </a:lnTo>
                  <a:lnTo>
                    <a:pt x="55" y="33"/>
                  </a:lnTo>
                  <a:lnTo>
                    <a:pt x="55" y="34"/>
                  </a:lnTo>
                  <a:lnTo>
                    <a:pt x="56" y="34"/>
                  </a:lnTo>
                  <a:lnTo>
                    <a:pt x="56" y="34"/>
                  </a:lnTo>
                  <a:lnTo>
                    <a:pt x="56" y="35"/>
                  </a:lnTo>
                  <a:lnTo>
                    <a:pt x="57" y="36"/>
                  </a:lnTo>
                  <a:lnTo>
                    <a:pt x="58" y="37"/>
                  </a:lnTo>
                  <a:lnTo>
                    <a:pt x="59" y="39"/>
                  </a:lnTo>
                  <a:lnTo>
                    <a:pt x="60" y="39"/>
                  </a:lnTo>
                  <a:lnTo>
                    <a:pt x="61" y="40"/>
                  </a:lnTo>
                  <a:lnTo>
                    <a:pt x="61" y="41"/>
                  </a:lnTo>
                  <a:lnTo>
                    <a:pt x="62" y="42"/>
                  </a:lnTo>
                  <a:lnTo>
                    <a:pt x="63" y="43"/>
                  </a:lnTo>
                  <a:lnTo>
                    <a:pt x="64" y="44"/>
                  </a:lnTo>
                  <a:lnTo>
                    <a:pt x="64" y="45"/>
                  </a:lnTo>
                  <a:lnTo>
                    <a:pt x="65" y="46"/>
                  </a:lnTo>
                  <a:lnTo>
                    <a:pt x="66" y="46"/>
                  </a:lnTo>
                  <a:lnTo>
                    <a:pt x="66" y="47"/>
                  </a:lnTo>
                  <a:lnTo>
                    <a:pt x="67" y="48"/>
                  </a:lnTo>
                  <a:lnTo>
                    <a:pt x="68" y="49"/>
                  </a:lnTo>
                  <a:lnTo>
                    <a:pt x="69" y="49"/>
                  </a:lnTo>
                  <a:lnTo>
                    <a:pt x="69" y="50"/>
                  </a:lnTo>
                  <a:lnTo>
                    <a:pt x="70" y="51"/>
                  </a:lnTo>
                  <a:lnTo>
                    <a:pt x="71" y="51"/>
                  </a:lnTo>
                  <a:lnTo>
                    <a:pt x="71" y="52"/>
                  </a:lnTo>
                  <a:lnTo>
                    <a:pt x="72" y="52"/>
                  </a:lnTo>
                  <a:lnTo>
                    <a:pt x="72" y="53"/>
                  </a:lnTo>
                  <a:lnTo>
                    <a:pt x="73" y="53"/>
                  </a:lnTo>
                  <a:lnTo>
                    <a:pt x="73" y="54"/>
                  </a:lnTo>
                  <a:lnTo>
                    <a:pt x="74" y="54"/>
                  </a:lnTo>
                  <a:lnTo>
                    <a:pt x="75" y="55"/>
                  </a:lnTo>
                  <a:lnTo>
                    <a:pt x="75" y="55"/>
                  </a:lnTo>
                  <a:lnTo>
                    <a:pt x="76" y="56"/>
                  </a:lnTo>
                  <a:lnTo>
                    <a:pt x="76" y="56"/>
                  </a:lnTo>
                  <a:lnTo>
                    <a:pt x="77" y="57"/>
                  </a:lnTo>
                  <a:lnTo>
                    <a:pt x="77" y="57"/>
                  </a:lnTo>
                  <a:lnTo>
                    <a:pt x="78" y="58"/>
                  </a:lnTo>
                  <a:lnTo>
                    <a:pt x="79" y="58"/>
                  </a:lnTo>
                  <a:lnTo>
                    <a:pt x="79" y="59"/>
                  </a:lnTo>
                  <a:lnTo>
                    <a:pt x="80" y="59"/>
                  </a:lnTo>
                  <a:lnTo>
                    <a:pt x="80" y="59"/>
                  </a:lnTo>
                  <a:lnTo>
                    <a:pt x="80" y="59"/>
                  </a:lnTo>
                  <a:lnTo>
                    <a:pt x="81" y="60"/>
                  </a:lnTo>
                  <a:lnTo>
                    <a:pt x="81" y="60"/>
                  </a:lnTo>
                  <a:lnTo>
                    <a:pt x="81" y="60"/>
                  </a:lnTo>
                  <a:lnTo>
                    <a:pt x="82" y="60"/>
                  </a:lnTo>
                  <a:lnTo>
                    <a:pt x="82" y="60"/>
                  </a:lnTo>
                  <a:lnTo>
                    <a:pt x="82" y="60"/>
                  </a:lnTo>
                  <a:lnTo>
                    <a:pt x="82" y="61"/>
                  </a:lnTo>
                  <a:lnTo>
                    <a:pt x="82" y="61"/>
                  </a:lnTo>
                  <a:lnTo>
                    <a:pt x="83" y="61"/>
                  </a:lnTo>
                  <a:lnTo>
                    <a:pt x="83" y="61"/>
                  </a:lnTo>
                  <a:lnTo>
                    <a:pt x="83" y="61"/>
                  </a:lnTo>
                  <a:lnTo>
                    <a:pt x="83" y="61"/>
                  </a:lnTo>
                  <a:lnTo>
                    <a:pt x="83" y="61"/>
                  </a:lnTo>
                  <a:lnTo>
                    <a:pt x="84" y="61"/>
                  </a:lnTo>
                  <a:lnTo>
                    <a:pt x="84" y="62"/>
                  </a:lnTo>
                  <a:lnTo>
                    <a:pt x="85" y="62"/>
                  </a:lnTo>
                  <a:lnTo>
                    <a:pt x="85" y="62"/>
                  </a:lnTo>
                  <a:lnTo>
                    <a:pt x="86" y="63"/>
                  </a:lnTo>
                  <a:lnTo>
                    <a:pt x="86" y="63"/>
                  </a:lnTo>
                  <a:lnTo>
                    <a:pt x="87" y="63"/>
                  </a:lnTo>
                  <a:lnTo>
                    <a:pt x="87" y="64"/>
                  </a:lnTo>
                  <a:lnTo>
                    <a:pt x="88" y="64"/>
                  </a:lnTo>
                  <a:lnTo>
                    <a:pt x="88" y="64"/>
                  </a:lnTo>
                  <a:lnTo>
                    <a:pt x="89" y="64"/>
                  </a:lnTo>
                  <a:lnTo>
                    <a:pt x="89" y="65"/>
                  </a:lnTo>
                  <a:lnTo>
                    <a:pt x="90" y="65"/>
                  </a:lnTo>
                  <a:lnTo>
                    <a:pt x="90" y="65"/>
                  </a:lnTo>
                  <a:lnTo>
                    <a:pt x="91" y="66"/>
                  </a:lnTo>
                  <a:lnTo>
                    <a:pt x="91" y="66"/>
                  </a:lnTo>
                  <a:lnTo>
                    <a:pt x="92" y="66"/>
                  </a:lnTo>
                  <a:lnTo>
                    <a:pt x="92" y="66"/>
                  </a:lnTo>
                  <a:lnTo>
                    <a:pt x="93" y="67"/>
                  </a:lnTo>
                  <a:lnTo>
                    <a:pt x="94" y="67"/>
                  </a:lnTo>
                  <a:lnTo>
                    <a:pt x="94" y="67"/>
                  </a:lnTo>
                  <a:lnTo>
                    <a:pt x="95" y="67"/>
                  </a:lnTo>
                  <a:lnTo>
                    <a:pt x="95" y="68"/>
                  </a:lnTo>
                  <a:lnTo>
                    <a:pt x="96" y="68"/>
                  </a:lnTo>
                  <a:lnTo>
                    <a:pt x="97" y="68"/>
                  </a:lnTo>
                  <a:lnTo>
                    <a:pt x="97" y="69"/>
                  </a:lnTo>
                  <a:lnTo>
                    <a:pt x="98" y="69"/>
                  </a:lnTo>
                  <a:lnTo>
                    <a:pt x="98" y="69"/>
                  </a:lnTo>
                  <a:lnTo>
                    <a:pt x="99" y="69"/>
                  </a:lnTo>
                  <a:lnTo>
                    <a:pt x="99" y="69"/>
                  </a:lnTo>
                  <a:lnTo>
                    <a:pt x="100" y="70"/>
                  </a:lnTo>
                  <a:lnTo>
                    <a:pt x="101" y="70"/>
                  </a:lnTo>
                  <a:lnTo>
                    <a:pt x="101" y="70"/>
                  </a:lnTo>
                  <a:lnTo>
                    <a:pt x="102" y="70"/>
                  </a:lnTo>
                  <a:lnTo>
                    <a:pt x="103" y="71"/>
                  </a:lnTo>
                  <a:lnTo>
                    <a:pt x="103" y="71"/>
                  </a:lnTo>
                  <a:lnTo>
                    <a:pt x="104" y="71"/>
                  </a:lnTo>
                  <a:lnTo>
                    <a:pt x="105" y="71"/>
                  </a:lnTo>
                  <a:lnTo>
                    <a:pt x="106" y="72"/>
                  </a:lnTo>
                  <a:lnTo>
                    <a:pt x="106" y="72"/>
                  </a:lnTo>
                  <a:lnTo>
                    <a:pt x="107" y="72"/>
                  </a:lnTo>
                  <a:lnTo>
                    <a:pt x="108" y="72"/>
                  </a:lnTo>
                  <a:lnTo>
                    <a:pt x="108" y="72"/>
                  </a:lnTo>
                  <a:lnTo>
                    <a:pt x="109" y="72"/>
                  </a:lnTo>
                  <a:lnTo>
                    <a:pt x="109" y="72"/>
                  </a:lnTo>
                  <a:lnTo>
                    <a:pt x="109" y="73"/>
                  </a:lnTo>
                  <a:lnTo>
                    <a:pt x="110" y="73"/>
                  </a:lnTo>
                  <a:lnTo>
                    <a:pt x="110" y="73"/>
                  </a:lnTo>
                  <a:lnTo>
                    <a:pt x="110" y="73"/>
                  </a:lnTo>
                  <a:lnTo>
                    <a:pt x="110" y="73"/>
                  </a:lnTo>
                  <a:lnTo>
                    <a:pt x="111" y="73"/>
                  </a:lnTo>
                  <a:lnTo>
                    <a:pt x="112" y="73"/>
                  </a:lnTo>
                  <a:lnTo>
                    <a:pt x="113" y="73"/>
                  </a:lnTo>
                  <a:lnTo>
                    <a:pt x="113" y="74"/>
                  </a:lnTo>
                  <a:lnTo>
                    <a:pt x="114" y="74"/>
                  </a:lnTo>
                  <a:lnTo>
                    <a:pt x="115" y="74"/>
                  </a:lnTo>
                  <a:lnTo>
                    <a:pt x="116" y="74"/>
                  </a:lnTo>
                  <a:lnTo>
                    <a:pt x="117" y="74"/>
                  </a:lnTo>
                  <a:lnTo>
                    <a:pt x="118" y="75"/>
                  </a:lnTo>
                  <a:lnTo>
                    <a:pt x="120" y="75"/>
                  </a:lnTo>
                  <a:lnTo>
                    <a:pt x="121" y="75"/>
                  </a:lnTo>
                  <a:lnTo>
                    <a:pt x="122" y="75"/>
                  </a:lnTo>
                  <a:lnTo>
                    <a:pt x="123" y="76"/>
                  </a:lnTo>
                  <a:lnTo>
                    <a:pt x="124" y="76"/>
                  </a:lnTo>
                  <a:lnTo>
                    <a:pt x="126" y="76"/>
                  </a:lnTo>
                  <a:lnTo>
                    <a:pt x="127" y="76"/>
                  </a:lnTo>
                  <a:lnTo>
                    <a:pt x="128" y="77"/>
                  </a:lnTo>
                  <a:lnTo>
                    <a:pt x="129" y="77"/>
                  </a:lnTo>
                  <a:lnTo>
                    <a:pt x="130" y="77"/>
                  </a:lnTo>
                  <a:lnTo>
                    <a:pt x="132" y="77"/>
                  </a:lnTo>
                  <a:lnTo>
                    <a:pt x="133" y="77"/>
                  </a:lnTo>
                  <a:lnTo>
                    <a:pt x="134" y="77"/>
                  </a:lnTo>
                  <a:lnTo>
                    <a:pt x="136" y="77"/>
                  </a:lnTo>
                  <a:lnTo>
                    <a:pt x="136" y="77"/>
                  </a:lnTo>
                  <a:lnTo>
                    <a:pt x="137" y="77"/>
                  </a:lnTo>
                  <a:lnTo>
                    <a:pt x="137" y="77"/>
                  </a:lnTo>
                  <a:lnTo>
                    <a:pt x="138" y="78"/>
                  </a:lnTo>
                  <a:lnTo>
                    <a:pt x="140" y="78"/>
                  </a:lnTo>
                  <a:lnTo>
                    <a:pt x="141" y="78"/>
                  </a:lnTo>
                  <a:lnTo>
                    <a:pt x="142" y="78"/>
                  </a:lnTo>
                  <a:lnTo>
                    <a:pt x="143" y="78"/>
                  </a:lnTo>
                  <a:lnTo>
                    <a:pt x="144" y="78"/>
                  </a:lnTo>
                  <a:lnTo>
                    <a:pt x="146" y="78"/>
                  </a:lnTo>
                  <a:lnTo>
                    <a:pt x="147" y="78"/>
                  </a:lnTo>
                  <a:lnTo>
                    <a:pt x="149" y="78"/>
                  </a:lnTo>
                  <a:lnTo>
                    <a:pt x="151" y="79"/>
                  </a:lnTo>
                  <a:lnTo>
                    <a:pt x="154" y="79"/>
                  </a:lnTo>
                  <a:lnTo>
                    <a:pt x="158" y="79"/>
                  </a:lnTo>
                  <a:lnTo>
                    <a:pt x="160" y="79"/>
                  </a:lnTo>
                  <a:lnTo>
                    <a:pt x="161" y="79"/>
                  </a:lnTo>
                  <a:lnTo>
                    <a:pt x="163" y="79"/>
                  </a:lnTo>
                  <a:lnTo>
                    <a:pt x="163" y="79"/>
                  </a:lnTo>
                  <a:lnTo>
                    <a:pt x="164" y="79"/>
                  </a:lnTo>
                  <a:lnTo>
                    <a:pt x="165" y="79"/>
                  </a:lnTo>
                  <a:lnTo>
                    <a:pt x="167" y="79"/>
                  </a:lnTo>
                  <a:lnTo>
                    <a:pt x="168" y="79"/>
                  </a:lnTo>
                  <a:lnTo>
                    <a:pt x="170" y="79"/>
                  </a:lnTo>
                  <a:lnTo>
                    <a:pt x="172" y="79"/>
                  </a:lnTo>
                  <a:lnTo>
                    <a:pt x="173" y="79"/>
                  </a:lnTo>
                  <a:lnTo>
                    <a:pt x="175" y="80"/>
                  </a:lnTo>
                  <a:lnTo>
                    <a:pt x="176" y="80"/>
                  </a:lnTo>
                  <a:lnTo>
                    <a:pt x="177" y="80"/>
                  </a:lnTo>
                  <a:lnTo>
                    <a:pt x="179" y="80"/>
                  </a:lnTo>
                  <a:lnTo>
                    <a:pt x="180" y="80"/>
                  </a:lnTo>
                  <a:lnTo>
                    <a:pt x="181" y="80"/>
                  </a:lnTo>
                  <a:lnTo>
                    <a:pt x="183" y="80"/>
                  </a:lnTo>
                  <a:lnTo>
                    <a:pt x="184" y="80"/>
                  </a:lnTo>
                  <a:lnTo>
                    <a:pt x="185" y="80"/>
                  </a:lnTo>
                  <a:lnTo>
                    <a:pt x="187" y="80"/>
                  </a:lnTo>
                  <a:lnTo>
                    <a:pt x="188" y="80"/>
                  </a:lnTo>
                  <a:lnTo>
                    <a:pt x="189" y="80"/>
                  </a:lnTo>
                  <a:lnTo>
                    <a:pt x="191" y="80"/>
                  </a:lnTo>
                  <a:lnTo>
                    <a:pt x="192" y="80"/>
                  </a:lnTo>
                  <a:lnTo>
                    <a:pt x="194" y="80"/>
                  </a:lnTo>
                  <a:lnTo>
                    <a:pt x="195" y="80"/>
                  </a:lnTo>
                  <a:lnTo>
                    <a:pt x="196" y="8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854364" y="3430292"/>
              <a:ext cx="1947294" cy="236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481 </a:t>
              </a:r>
              <a:r>
                <a:rPr lang="en-US" sz="1000" dirty="0" err="1">
                  <a:latin typeface="Arial" pitchFamily="34" charset="0"/>
                  <a:cs typeface="Arial" pitchFamily="34" charset="0"/>
                </a:rPr>
                <a:t>bp</a:t>
              </a:r>
              <a:r>
                <a:rPr lang="en-US" sz="1000" dirty="0">
                  <a:latin typeface="Arial" pitchFamily="34" charset="0"/>
                  <a:cs typeface="Arial" pitchFamily="34" charset="0"/>
                </a:rPr>
                <a:t> dsRNA 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 rot="16200000">
              <a:off x="-384097" y="3966696"/>
              <a:ext cx="1565636" cy="3023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itchFamily="34" charset="0"/>
                  <a:cs typeface="Arial" pitchFamily="34" charset="0"/>
                </a:rPr>
                <a:t>Intensity (</a:t>
              </a:r>
              <a:r>
                <a:rPr lang="en-US" sz="1200" dirty="0" err="1">
                  <a:latin typeface="Arial" pitchFamily="34" charset="0"/>
                  <a:cs typeface="Arial" pitchFamily="34" charset="0"/>
                </a:rPr>
                <a:t>mAU</a:t>
              </a:r>
              <a:r>
                <a:rPr lang="en-US" sz="1200" dirty="0">
                  <a:latin typeface="Arial" pitchFamily="34" charset="0"/>
                  <a:cs typeface="Arial" pitchFamily="34" charset="0"/>
                </a:rPr>
                <a:t>)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2141668" y="5402694"/>
              <a:ext cx="1907623" cy="2661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itchFamily="34" charset="0"/>
                  <a:cs typeface="Arial" pitchFamily="34" charset="0"/>
                </a:rPr>
                <a:t>Retention time (min)</a:t>
              </a:r>
            </a:p>
          </p:txBody>
        </p:sp>
      </p:grpSp>
      <p:pic>
        <p:nvPicPr>
          <p:cNvPr id="131" name="Picture 130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61" t="25306" r="38047" b="16260"/>
          <a:stretch/>
        </p:blipFill>
        <p:spPr>
          <a:xfrm>
            <a:off x="1983181" y="385715"/>
            <a:ext cx="2219353" cy="1168652"/>
          </a:xfrm>
          <a:prstGeom prst="rect">
            <a:avLst/>
          </a:prstGeom>
        </p:spPr>
      </p:pic>
      <p:sp>
        <p:nvSpPr>
          <p:cNvPr id="133" name="TextBox 132"/>
          <p:cNvSpPr txBox="1"/>
          <p:nvPr/>
        </p:nvSpPr>
        <p:spPr>
          <a:xfrm>
            <a:off x="4360846" y="646299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 481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bp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dsRNA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692696" y="1185035"/>
            <a:ext cx="338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E29A2650-A234-4E0C-8B48-EB01EDB1AEE9}"/>
              </a:ext>
            </a:extLst>
          </p:cNvPr>
          <p:cNvSpPr txBox="1"/>
          <p:nvPr/>
        </p:nvSpPr>
        <p:spPr>
          <a:xfrm>
            <a:off x="1863800" y="9453009"/>
            <a:ext cx="28620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2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78600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2CB80D77-5DDA-43AB-9BC3-539D73A841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2882784"/>
              </p:ext>
            </p:extLst>
          </p:nvPr>
        </p:nvGraphicFramePr>
        <p:xfrm>
          <a:off x="1196752" y="1424608"/>
          <a:ext cx="4491567" cy="2376194"/>
        </p:xfrm>
        <a:graphic>
          <a:graphicData uri="http://schemas.openxmlformats.org/drawingml/2006/table">
            <a:tbl>
              <a:tblPr/>
              <a:tblGrid>
                <a:gridCol w="1591379">
                  <a:extLst>
                    <a:ext uri="{9D8B030D-6E8A-4147-A177-3AD203B41FA5}">
                      <a16:colId xmlns:a16="http://schemas.microsoft.com/office/drawing/2014/main" val="1809871994"/>
                    </a:ext>
                  </a:extLst>
                </a:gridCol>
                <a:gridCol w="2900188">
                  <a:extLst>
                    <a:ext uri="{9D8B030D-6E8A-4147-A177-3AD203B41FA5}">
                      <a16:colId xmlns:a16="http://schemas.microsoft.com/office/drawing/2014/main" val="2467690909"/>
                    </a:ext>
                  </a:extLst>
                </a:gridCol>
              </a:tblGrid>
              <a:tr h="504056">
                <a:tc>
                  <a:txBody>
                    <a:bodyPr/>
                    <a:lstStyle/>
                    <a:p>
                      <a:pPr fontAlgn="b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ucleic </a:t>
                      </a:r>
                      <a:r>
                        <a:rPr lang="en-US" sz="1100" b="1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id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9" marR="6539" marT="653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Sequence/Composition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9" marR="6539" marT="653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3718531"/>
                  </a:ext>
                </a:extLst>
              </a:tr>
              <a:tr h="360040">
                <a:tc>
                  <a:txBody>
                    <a:bodyPr/>
                    <a:lstStyle/>
                    <a:p>
                      <a:pPr fontAlgn="b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RNA1 (521 </a:t>
                      </a:r>
                      <a:r>
                        <a:rPr lang="en-US" sz="1100" kern="1200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t</a:t>
                      </a: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 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9" marR="6539" marT="653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:131; C:144; G102; U:144)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9" marR="6539" marT="653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7264006"/>
                  </a:ext>
                </a:extLst>
              </a:tr>
              <a:tr h="380915">
                <a:tc>
                  <a:txBody>
                    <a:bodyPr/>
                    <a:lstStyle/>
                    <a:p>
                      <a:pPr fontAlgn="b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sRNA2 (521 </a:t>
                      </a:r>
                      <a:r>
                        <a:rPr lang="en-US" sz="1100" kern="1200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t</a:t>
                      </a: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9" marR="6539" marT="653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A:144; C:102; G:144; U:131) </a:t>
                      </a:r>
                    </a:p>
                  </a:txBody>
                  <a:tcPr marL="6539" marR="6539" marT="653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6558495"/>
                  </a:ext>
                </a:extLst>
              </a:tr>
              <a:tr h="377061">
                <a:tc>
                  <a:txBody>
                    <a:bodyPr/>
                    <a:lstStyle/>
                    <a:p>
                      <a:pPr fontAlgn="b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sRNA (561 </a:t>
                      </a:r>
                      <a:r>
                        <a:rPr lang="en-US" sz="1100" kern="12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p</a:t>
                      </a:r>
                      <a:r>
                        <a:rPr lang="en-US" sz="1100" kern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9" marR="6539" marT="653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 kern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A:205; C:356; G:356; U:205)</a:t>
                      </a:r>
                    </a:p>
                  </a:txBody>
                  <a:tcPr marL="6539" marR="6539" marT="653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5959852"/>
                  </a:ext>
                </a:extLst>
              </a:tr>
              <a:tr h="377061">
                <a:tc>
                  <a:txBody>
                    <a:bodyPr/>
                    <a:lstStyle/>
                    <a:p>
                      <a:pPr fontAlgn="b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sRNA (686 bp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9" marR="6539" marT="653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A:261; C:425; G:425; U:261)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9" marR="6539" marT="653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206515"/>
                  </a:ext>
                </a:extLst>
              </a:tr>
              <a:tr h="377061">
                <a:tc>
                  <a:txBody>
                    <a:bodyPr/>
                    <a:lstStyle/>
                    <a:p>
                      <a:pPr fontAlgn="b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sRNA (481 bp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9" marR="6539" marT="653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A:190;C:291;G:291;U:190)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39" marR="6539" marT="6539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436175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2EB8A3EB-2A16-4DA4-828D-FA2A6FFE4EE0}"/>
              </a:ext>
            </a:extLst>
          </p:cNvPr>
          <p:cNvSpPr/>
          <p:nvPr/>
        </p:nvSpPr>
        <p:spPr>
          <a:xfrm>
            <a:off x="483518" y="689084"/>
            <a:ext cx="589096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itchFamily="34" charset="0"/>
                <a:cs typeface="Arial" pitchFamily="34" charset="0"/>
              </a:rPr>
              <a:t>Supplementary Table 1.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Composition of RNA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sequences used in the study.</a:t>
            </a:r>
          </a:p>
        </p:txBody>
      </p:sp>
    </p:spTree>
    <p:extLst>
      <p:ext uri="{BB962C8B-B14F-4D97-AF65-F5344CB8AC3E}">
        <p14:creationId xmlns:p14="http://schemas.microsoft.com/office/powerpoint/2010/main" val="35775766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746</TotalTime>
  <Words>533</Words>
  <Application>Microsoft Office PowerPoint</Application>
  <PresentationFormat>A4 Paper (210x297 mm)</PresentationFormat>
  <Paragraphs>9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Dickman</dc:creator>
  <cp:lastModifiedBy>Mark Dickman</cp:lastModifiedBy>
  <cp:revision>34</cp:revision>
  <cp:lastPrinted>2018-05-02T11:02:11Z</cp:lastPrinted>
  <dcterms:created xsi:type="dcterms:W3CDTF">2017-05-17T16:57:58Z</dcterms:created>
  <dcterms:modified xsi:type="dcterms:W3CDTF">2018-11-23T15:59:06Z</dcterms:modified>
</cp:coreProperties>
</file>